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1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2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3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4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5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6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7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71" r:id="rId2"/>
    <p:sldId id="272" r:id="rId3"/>
    <p:sldId id="269" r:id="rId4"/>
    <p:sldId id="273" r:id="rId5"/>
    <p:sldId id="268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300" autoAdjust="0"/>
    <p:restoredTop sz="94660"/>
  </p:normalViewPr>
  <p:slideViewPr>
    <p:cSldViewPr snapToGrid="0">
      <p:cViewPr>
        <p:scale>
          <a:sx n="100" d="100"/>
          <a:sy n="100" d="100"/>
        </p:scale>
        <p:origin x="1696" y="-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paper-&#21407;&#22987;&#25968;&#25454;excel\paper2\PNC&#26354;&#32447;\WS&#21560;&#20809;&#26354;&#3244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paper-&#21407;&#22987;&#25968;&#25454;excel\paper2\PNC&#26354;&#32447;\WS&#21560;&#20809;&#26354;&#3244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D:\&#30805;&#22763;&#26399;&#38388;\A&#30805;&#22763;&#23454;&#39564;\&#23454;&#39564;2PNC&#23545;&#27833;&#33756;&#38048;&#38078;&#38041;&#31163;&#23376;&#31283;&#24577;\&#34920;&#22411;&#25968;&#25454;\&#24418;&#24577;&#25351;&#26631;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D:\&#30805;&#22763;&#26399;&#38388;\A&#30805;&#22763;&#23454;&#39564;\&#23454;&#39564;2PNC&#23545;&#27833;&#33756;&#38048;&#38078;&#38041;&#31163;&#23376;&#31283;&#24577;\&#34920;&#22411;&#25968;&#25454;\&#26032;&#24418;&#24577;&#25351;&#26631;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D:\&#30805;&#22763;&#26399;&#38388;\A&#30805;&#22763;&#23454;&#39564;\&#23454;&#39564;1PNC&#25552;&#21319;&#27833;&#33756;&#21516;&#24037;&#37238;&#19982;LOX\DAB%20NBT\&#31532;&#19977;&#27425;\DAB&#24378;&#24230;&#38754;&#31215;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D:\&#30805;&#22763;&#26399;&#38388;\A&#30805;&#22763;&#23454;&#39564;\&#23454;&#39564;2PNC&#23545;&#27833;&#33756;&#38048;&#38078;&#38041;&#31163;&#23376;&#31283;&#24577;\&#27963;&#24615;&#27687;&#28165;&#38500;\&#27963;&#24615;&#27687;&#21547;&#37327;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D:\&#30805;&#22763;&#26399;&#38388;\A&#30805;&#22763;&#23454;&#39564;\&#23454;&#39564;2PNC&#23545;&#27833;&#33756;&#38048;&#38078;&#38041;&#31163;&#23376;&#31283;&#24577;\&#27963;&#24615;&#27687;&#28165;&#38500;\&#27963;&#24615;&#27687;&#21547;&#37327;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D:\&#30805;&#22763;&#26399;&#38388;\A&#30805;&#22763;&#23454;&#39564;\&#23454;&#39564;1PNC&#25552;&#21319;&#27833;&#33756;&#21516;&#24037;&#37238;&#19982;LOX\&#31532;&#19968;&#25209;&#38750;&#30416;&#26465;&#20214;&#19979;&#65288;2020.11.4&#65289;\&#24418;&#24577;&#25351;&#26631;.xls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D:\&#30805;&#22763;&#26399;&#38388;\A&#30805;&#22763;&#23454;&#39564;\&#23454;&#39564;1PNC&#25552;&#21319;&#27833;&#33756;&#21516;&#24037;&#37238;&#19982;LOX\&#31532;&#19968;&#25209;&#38750;&#30416;&#26465;&#20214;&#19979;&#65288;2020.11.4&#65289;\&#24418;&#24577;&#25351;&#26631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8783323162109467E-2"/>
          <c:y val="3.0497594050743659E-2"/>
          <c:w val="0.87835290673731947"/>
          <c:h val="0.87667067658209386"/>
        </c:manualLayout>
      </c:layout>
      <c:scatterChart>
        <c:scatterStyle val="lineMarker"/>
        <c:varyColors val="0"/>
        <c:ser>
          <c:idx val="3"/>
          <c:order val="2"/>
          <c:tx>
            <c:strRef>
              <c:f>文章选用!$E$1</c:f>
              <c:strCache>
                <c:ptCount val="1"/>
                <c:pt idx="0">
                  <c:v>PNC</c:v>
                </c:pt>
              </c:strCache>
            </c:strRef>
          </c:tx>
          <c:spPr>
            <a:ln w="254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文章选用!$A$2:$A$482</c:f>
              <c:numCache>
                <c:formatCode>General</c:formatCode>
                <c:ptCount val="481"/>
                <c:pt idx="0">
                  <c:v>700</c:v>
                </c:pt>
                <c:pt idx="1">
                  <c:v>699</c:v>
                </c:pt>
                <c:pt idx="2">
                  <c:v>698</c:v>
                </c:pt>
                <c:pt idx="3">
                  <c:v>697</c:v>
                </c:pt>
                <c:pt idx="4">
                  <c:v>696</c:v>
                </c:pt>
                <c:pt idx="5">
                  <c:v>695</c:v>
                </c:pt>
                <c:pt idx="6">
                  <c:v>694</c:v>
                </c:pt>
                <c:pt idx="7">
                  <c:v>693</c:v>
                </c:pt>
                <c:pt idx="8">
                  <c:v>692</c:v>
                </c:pt>
                <c:pt idx="9">
                  <c:v>691</c:v>
                </c:pt>
                <c:pt idx="10">
                  <c:v>690</c:v>
                </c:pt>
                <c:pt idx="11">
                  <c:v>689</c:v>
                </c:pt>
                <c:pt idx="12">
                  <c:v>688</c:v>
                </c:pt>
                <c:pt idx="13">
                  <c:v>687</c:v>
                </c:pt>
                <c:pt idx="14">
                  <c:v>686</c:v>
                </c:pt>
                <c:pt idx="15">
                  <c:v>685</c:v>
                </c:pt>
                <c:pt idx="16">
                  <c:v>684</c:v>
                </c:pt>
                <c:pt idx="17">
                  <c:v>683</c:v>
                </c:pt>
                <c:pt idx="18">
                  <c:v>682</c:v>
                </c:pt>
                <c:pt idx="19">
                  <c:v>681</c:v>
                </c:pt>
                <c:pt idx="20">
                  <c:v>680</c:v>
                </c:pt>
                <c:pt idx="21">
                  <c:v>679</c:v>
                </c:pt>
                <c:pt idx="22">
                  <c:v>678</c:v>
                </c:pt>
                <c:pt idx="23">
                  <c:v>677</c:v>
                </c:pt>
                <c:pt idx="24">
                  <c:v>676</c:v>
                </c:pt>
                <c:pt idx="25">
                  <c:v>675</c:v>
                </c:pt>
                <c:pt idx="26">
                  <c:v>674</c:v>
                </c:pt>
                <c:pt idx="27">
                  <c:v>673</c:v>
                </c:pt>
                <c:pt idx="28">
                  <c:v>672</c:v>
                </c:pt>
                <c:pt idx="29">
                  <c:v>671</c:v>
                </c:pt>
                <c:pt idx="30">
                  <c:v>670</c:v>
                </c:pt>
                <c:pt idx="31">
                  <c:v>669</c:v>
                </c:pt>
                <c:pt idx="32">
                  <c:v>668</c:v>
                </c:pt>
                <c:pt idx="33">
                  <c:v>667</c:v>
                </c:pt>
                <c:pt idx="34">
                  <c:v>666</c:v>
                </c:pt>
                <c:pt idx="35">
                  <c:v>665</c:v>
                </c:pt>
                <c:pt idx="36">
                  <c:v>664</c:v>
                </c:pt>
                <c:pt idx="37">
                  <c:v>663</c:v>
                </c:pt>
                <c:pt idx="38">
                  <c:v>662</c:v>
                </c:pt>
                <c:pt idx="39">
                  <c:v>661</c:v>
                </c:pt>
                <c:pt idx="40">
                  <c:v>660</c:v>
                </c:pt>
                <c:pt idx="41">
                  <c:v>659</c:v>
                </c:pt>
                <c:pt idx="42">
                  <c:v>658</c:v>
                </c:pt>
                <c:pt idx="43">
                  <c:v>657</c:v>
                </c:pt>
                <c:pt idx="44">
                  <c:v>656</c:v>
                </c:pt>
                <c:pt idx="45">
                  <c:v>655</c:v>
                </c:pt>
                <c:pt idx="46">
                  <c:v>654</c:v>
                </c:pt>
                <c:pt idx="47">
                  <c:v>653</c:v>
                </c:pt>
                <c:pt idx="48">
                  <c:v>652</c:v>
                </c:pt>
                <c:pt idx="49">
                  <c:v>651</c:v>
                </c:pt>
                <c:pt idx="50">
                  <c:v>650</c:v>
                </c:pt>
                <c:pt idx="51">
                  <c:v>649</c:v>
                </c:pt>
                <c:pt idx="52">
                  <c:v>648</c:v>
                </c:pt>
                <c:pt idx="53">
                  <c:v>647</c:v>
                </c:pt>
                <c:pt idx="54">
                  <c:v>646</c:v>
                </c:pt>
                <c:pt idx="55">
                  <c:v>645</c:v>
                </c:pt>
                <c:pt idx="56">
                  <c:v>644</c:v>
                </c:pt>
                <c:pt idx="57">
                  <c:v>643</c:v>
                </c:pt>
                <c:pt idx="58">
                  <c:v>642</c:v>
                </c:pt>
                <c:pt idx="59">
                  <c:v>641</c:v>
                </c:pt>
                <c:pt idx="60">
                  <c:v>640</c:v>
                </c:pt>
                <c:pt idx="61">
                  <c:v>639</c:v>
                </c:pt>
                <c:pt idx="62">
                  <c:v>638</c:v>
                </c:pt>
                <c:pt idx="63">
                  <c:v>637</c:v>
                </c:pt>
                <c:pt idx="64">
                  <c:v>636</c:v>
                </c:pt>
                <c:pt idx="65">
                  <c:v>635</c:v>
                </c:pt>
                <c:pt idx="66">
                  <c:v>634</c:v>
                </c:pt>
                <c:pt idx="67">
                  <c:v>633</c:v>
                </c:pt>
                <c:pt idx="68">
                  <c:v>632</c:v>
                </c:pt>
                <c:pt idx="69">
                  <c:v>631</c:v>
                </c:pt>
                <c:pt idx="70">
                  <c:v>630</c:v>
                </c:pt>
                <c:pt idx="71">
                  <c:v>629</c:v>
                </c:pt>
                <c:pt idx="72">
                  <c:v>628</c:v>
                </c:pt>
                <c:pt idx="73">
                  <c:v>627</c:v>
                </c:pt>
                <c:pt idx="74">
                  <c:v>626</c:v>
                </c:pt>
                <c:pt idx="75">
                  <c:v>625</c:v>
                </c:pt>
                <c:pt idx="76">
                  <c:v>624</c:v>
                </c:pt>
                <c:pt idx="77">
                  <c:v>623</c:v>
                </c:pt>
                <c:pt idx="78">
                  <c:v>622</c:v>
                </c:pt>
                <c:pt idx="79">
                  <c:v>621</c:v>
                </c:pt>
                <c:pt idx="80">
                  <c:v>620</c:v>
                </c:pt>
                <c:pt idx="81">
                  <c:v>619</c:v>
                </c:pt>
                <c:pt idx="82">
                  <c:v>618</c:v>
                </c:pt>
                <c:pt idx="83">
                  <c:v>617</c:v>
                </c:pt>
                <c:pt idx="84">
                  <c:v>616</c:v>
                </c:pt>
                <c:pt idx="85">
                  <c:v>615</c:v>
                </c:pt>
                <c:pt idx="86">
                  <c:v>614</c:v>
                </c:pt>
                <c:pt idx="87">
                  <c:v>613</c:v>
                </c:pt>
                <c:pt idx="88">
                  <c:v>612</c:v>
                </c:pt>
                <c:pt idx="89">
                  <c:v>611</c:v>
                </c:pt>
                <c:pt idx="90">
                  <c:v>610</c:v>
                </c:pt>
                <c:pt idx="91">
                  <c:v>609</c:v>
                </c:pt>
                <c:pt idx="92">
                  <c:v>608</c:v>
                </c:pt>
                <c:pt idx="93">
                  <c:v>607</c:v>
                </c:pt>
                <c:pt idx="94">
                  <c:v>606</c:v>
                </c:pt>
                <c:pt idx="95">
                  <c:v>605</c:v>
                </c:pt>
                <c:pt idx="96">
                  <c:v>604</c:v>
                </c:pt>
                <c:pt idx="97">
                  <c:v>603</c:v>
                </c:pt>
                <c:pt idx="98">
                  <c:v>602</c:v>
                </c:pt>
                <c:pt idx="99">
                  <c:v>601</c:v>
                </c:pt>
                <c:pt idx="100">
                  <c:v>600</c:v>
                </c:pt>
                <c:pt idx="101">
                  <c:v>599</c:v>
                </c:pt>
                <c:pt idx="102">
                  <c:v>598</c:v>
                </c:pt>
                <c:pt idx="103">
                  <c:v>597</c:v>
                </c:pt>
                <c:pt idx="104">
                  <c:v>596</c:v>
                </c:pt>
                <c:pt idx="105">
                  <c:v>595</c:v>
                </c:pt>
                <c:pt idx="106">
                  <c:v>594</c:v>
                </c:pt>
                <c:pt idx="107">
                  <c:v>593</c:v>
                </c:pt>
                <c:pt idx="108">
                  <c:v>592</c:v>
                </c:pt>
                <c:pt idx="109">
                  <c:v>591</c:v>
                </c:pt>
                <c:pt idx="110">
                  <c:v>590</c:v>
                </c:pt>
                <c:pt idx="111">
                  <c:v>589</c:v>
                </c:pt>
                <c:pt idx="112">
                  <c:v>588</c:v>
                </c:pt>
                <c:pt idx="113">
                  <c:v>587</c:v>
                </c:pt>
                <c:pt idx="114">
                  <c:v>586</c:v>
                </c:pt>
                <c:pt idx="115">
                  <c:v>585</c:v>
                </c:pt>
                <c:pt idx="116">
                  <c:v>584</c:v>
                </c:pt>
                <c:pt idx="117">
                  <c:v>583</c:v>
                </c:pt>
                <c:pt idx="118">
                  <c:v>582</c:v>
                </c:pt>
                <c:pt idx="119">
                  <c:v>581</c:v>
                </c:pt>
                <c:pt idx="120">
                  <c:v>580</c:v>
                </c:pt>
                <c:pt idx="121">
                  <c:v>579</c:v>
                </c:pt>
                <c:pt idx="122">
                  <c:v>578</c:v>
                </c:pt>
                <c:pt idx="123">
                  <c:v>577</c:v>
                </c:pt>
                <c:pt idx="124">
                  <c:v>576</c:v>
                </c:pt>
                <c:pt idx="125">
                  <c:v>575</c:v>
                </c:pt>
                <c:pt idx="126">
                  <c:v>574</c:v>
                </c:pt>
                <c:pt idx="127">
                  <c:v>573</c:v>
                </c:pt>
                <c:pt idx="128">
                  <c:v>572</c:v>
                </c:pt>
                <c:pt idx="129">
                  <c:v>571</c:v>
                </c:pt>
                <c:pt idx="130">
                  <c:v>570</c:v>
                </c:pt>
                <c:pt idx="131">
                  <c:v>569</c:v>
                </c:pt>
                <c:pt idx="132">
                  <c:v>568</c:v>
                </c:pt>
                <c:pt idx="133">
                  <c:v>567</c:v>
                </c:pt>
                <c:pt idx="134">
                  <c:v>566</c:v>
                </c:pt>
                <c:pt idx="135">
                  <c:v>565</c:v>
                </c:pt>
                <c:pt idx="136">
                  <c:v>564</c:v>
                </c:pt>
                <c:pt idx="137">
                  <c:v>563</c:v>
                </c:pt>
                <c:pt idx="138">
                  <c:v>562</c:v>
                </c:pt>
                <c:pt idx="139">
                  <c:v>561</c:v>
                </c:pt>
                <c:pt idx="140">
                  <c:v>560</c:v>
                </c:pt>
                <c:pt idx="141">
                  <c:v>559</c:v>
                </c:pt>
                <c:pt idx="142">
                  <c:v>558</c:v>
                </c:pt>
                <c:pt idx="143">
                  <c:v>557</c:v>
                </c:pt>
                <c:pt idx="144">
                  <c:v>556</c:v>
                </c:pt>
                <c:pt idx="145">
                  <c:v>555</c:v>
                </c:pt>
                <c:pt idx="146">
                  <c:v>554</c:v>
                </c:pt>
                <c:pt idx="147">
                  <c:v>553</c:v>
                </c:pt>
                <c:pt idx="148">
                  <c:v>552</c:v>
                </c:pt>
                <c:pt idx="149">
                  <c:v>551</c:v>
                </c:pt>
                <c:pt idx="150">
                  <c:v>550</c:v>
                </c:pt>
                <c:pt idx="151">
                  <c:v>549</c:v>
                </c:pt>
                <c:pt idx="152">
                  <c:v>548</c:v>
                </c:pt>
                <c:pt idx="153">
                  <c:v>547</c:v>
                </c:pt>
                <c:pt idx="154">
                  <c:v>546</c:v>
                </c:pt>
                <c:pt idx="155">
                  <c:v>545</c:v>
                </c:pt>
                <c:pt idx="156">
                  <c:v>544</c:v>
                </c:pt>
                <c:pt idx="157">
                  <c:v>543</c:v>
                </c:pt>
                <c:pt idx="158">
                  <c:v>542</c:v>
                </c:pt>
                <c:pt idx="159">
                  <c:v>541</c:v>
                </c:pt>
                <c:pt idx="160">
                  <c:v>540</c:v>
                </c:pt>
                <c:pt idx="161">
                  <c:v>539</c:v>
                </c:pt>
                <c:pt idx="162">
                  <c:v>538</c:v>
                </c:pt>
                <c:pt idx="163">
                  <c:v>537</c:v>
                </c:pt>
                <c:pt idx="164">
                  <c:v>536</c:v>
                </c:pt>
                <c:pt idx="165">
                  <c:v>535</c:v>
                </c:pt>
                <c:pt idx="166">
                  <c:v>534</c:v>
                </c:pt>
                <c:pt idx="167">
                  <c:v>533</c:v>
                </c:pt>
                <c:pt idx="168">
                  <c:v>532</c:v>
                </c:pt>
                <c:pt idx="169">
                  <c:v>531</c:v>
                </c:pt>
                <c:pt idx="170">
                  <c:v>530</c:v>
                </c:pt>
                <c:pt idx="171">
                  <c:v>529</c:v>
                </c:pt>
                <c:pt idx="172">
                  <c:v>528</c:v>
                </c:pt>
                <c:pt idx="173">
                  <c:v>527</c:v>
                </c:pt>
                <c:pt idx="174">
                  <c:v>526</c:v>
                </c:pt>
                <c:pt idx="175">
                  <c:v>525</c:v>
                </c:pt>
                <c:pt idx="176">
                  <c:v>524</c:v>
                </c:pt>
                <c:pt idx="177">
                  <c:v>523</c:v>
                </c:pt>
                <c:pt idx="178">
                  <c:v>522</c:v>
                </c:pt>
                <c:pt idx="179">
                  <c:v>521</c:v>
                </c:pt>
                <c:pt idx="180">
                  <c:v>520</c:v>
                </c:pt>
                <c:pt idx="181">
                  <c:v>519</c:v>
                </c:pt>
                <c:pt idx="182">
                  <c:v>518</c:v>
                </c:pt>
                <c:pt idx="183">
                  <c:v>517</c:v>
                </c:pt>
                <c:pt idx="184">
                  <c:v>516</c:v>
                </c:pt>
                <c:pt idx="185">
                  <c:v>515</c:v>
                </c:pt>
                <c:pt idx="186">
                  <c:v>514</c:v>
                </c:pt>
                <c:pt idx="187">
                  <c:v>513</c:v>
                </c:pt>
                <c:pt idx="188">
                  <c:v>512</c:v>
                </c:pt>
                <c:pt idx="189">
                  <c:v>511</c:v>
                </c:pt>
                <c:pt idx="190">
                  <c:v>510</c:v>
                </c:pt>
                <c:pt idx="191">
                  <c:v>509</c:v>
                </c:pt>
                <c:pt idx="192">
                  <c:v>508</c:v>
                </c:pt>
                <c:pt idx="193">
                  <c:v>507</c:v>
                </c:pt>
                <c:pt idx="194">
                  <c:v>506</c:v>
                </c:pt>
                <c:pt idx="195">
                  <c:v>505</c:v>
                </c:pt>
                <c:pt idx="196">
                  <c:v>504</c:v>
                </c:pt>
                <c:pt idx="197">
                  <c:v>503</c:v>
                </c:pt>
                <c:pt idx="198">
                  <c:v>502</c:v>
                </c:pt>
                <c:pt idx="199">
                  <c:v>501</c:v>
                </c:pt>
                <c:pt idx="200">
                  <c:v>500</c:v>
                </c:pt>
                <c:pt idx="201">
                  <c:v>499</c:v>
                </c:pt>
                <c:pt idx="202">
                  <c:v>498</c:v>
                </c:pt>
                <c:pt idx="203">
                  <c:v>497</c:v>
                </c:pt>
                <c:pt idx="204">
                  <c:v>496</c:v>
                </c:pt>
                <c:pt idx="205">
                  <c:v>495</c:v>
                </c:pt>
                <c:pt idx="206">
                  <c:v>494</c:v>
                </c:pt>
                <c:pt idx="207">
                  <c:v>493</c:v>
                </c:pt>
                <c:pt idx="208">
                  <c:v>492</c:v>
                </c:pt>
                <c:pt idx="209">
                  <c:v>491</c:v>
                </c:pt>
                <c:pt idx="210">
                  <c:v>490</c:v>
                </c:pt>
                <c:pt idx="211">
                  <c:v>489</c:v>
                </c:pt>
                <c:pt idx="212">
                  <c:v>488</c:v>
                </c:pt>
                <c:pt idx="213">
                  <c:v>487</c:v>
                </c:pt>
                <c:pt idx="214">
                  <c:v>486</c:v>
                </c:pt>
                <c:pt idx="215">
                  <c:v>485</c:v>
                </c:pt>
                <c:pt idx="216">
                  <c:v>484</c:v>
                </c:pt>
                <c:pt idx="217">
                  <c:v>483</c:v>
                </c:pt>
                <c:pt idx="218">
                  <c:v>482</c:v>
                </c:pt>
                <c:pt idx="219">
                  <c:v>481</c:v>
                </c:pt>
                <c:pt idx="220">
                  <c:v>480</c:v>
                </c:pt>
                <c:pt idx="221">
                  <c:v>479</c:v>
                </c:pt>
                <c:pt idx="222">
                  <c:v>478</c:v>
                </c:pt>
                <c:pt idx="223">
                  <c:v>477</c:v>
                </c:pt>
                <c:pt idx="224">
                  <c:v>476</c:v>
                </c:pt>
                <c:pt idx="225">
                  <c:v>475</c:v>
                </c:pt>
                <c:pt idx="226">
                  <c:v>474</c:v>
                </c:pt>
                <c:pt idx="227">
                  <c:v>473</c:v>
                </c:pt>
                <c:pt idx="228">
                  <c:v>472</c:v>
                </c:pt>
                <c:pt idx="229">
                  <c:v>471</c:v>
                </c:pt>
                <c:pt idx="230">
                  <c:v>470</c:v>
                </c:pt>
                <c:pt idx="231">
                  <c:v>469</c:v>
                </c:pt>
                <c:pt idx="232">
                  <c:v>468</c:v>
                </c:pt>
                <c:pt idx="233">
                  <c:v>467</c:v>
                </c:pt>
                <c:pt idx="234">
                  <c:v>466</c:v>
                </c:pt>
                <c:pt idx="235">
                  <c:v>465</c:v>
                </c:pt>
                <c:pt idx="236">
                  <c:v>464</c:v>
                </c:pt>
                <c:pt idx="237">
                  <c:v>463</c:v>
                </c:pt>
                <c:pt idx="238">
                  <c:v>462</c:v>
                </c:pt>
                <c:pt idx="239">
                  <c:v>461</c:v>
                </c:pt>
                <c:pt idx="240">
                  <c:v>460</c:v>
                </c:pt>
                <c:pt idx="241">
                  <c:v>459</c:v>
                </c:pt>
                <c:pt idx="242">
                  <c:v>458</c:v>
                </c:pt>
                <c:pt idx="243">
                  <c:v>457</c:v>
                </c:pt>
                <c:pt idx="244">
                  <c:v>456</c:v>
                </c:pt>
                <c:pt idx="245">
                  <c:v>455</c:v>
                </c:pt>
                <c:pt idx="246">
                  <c:v>454</c:v>
                </c:pt>
                <c:pt idx="247">
                  <c:v>453</c:v>
                </c:pt>
                <c:pt idx="248">
                  <c:v>452</c:v>
                </c:pt>
                <c:pt idx="249">
                  <c:v>451</c:v>
                </c:pt>
                <c:pt idx="250">
                  <c:v>450</c:v>
                </c:pt>
                <c:pt idx="251">
                  <c:v>449</c:v>
                </c:pt>
                <c:pt idx="252">
                  <c:v>448</c:v>
                </c:pt>
                <c:pt idx="253">
                  <c:v>447</c:v>
                </c:pt>
                <c:pt idx="254">
                  <c:v>446</c:v>
                </c:pt>
                <c:pt idx="255">
                  <c:v>445</c:v>
                </c:pt>
                <c:pt idx="256">
                  <c:v>444</c:v>
                </c:pt>
                <c:pt idx="257">
                  <c:v>443</c:v>
                </c:pt>
                <c:pt idx="258">
                  <c:v>442</c:v>
                </c:pt>
                <c:pt idx="259">
                  <c:v>441</c:v>
                </c:pt>
                <c:pt idx="260">
                  <c:v>440</c:v>
                </c:pt>
                <c:pt idx="261">
                  <c:v>439</c:v>
                </c:pt>
                <c:pt idx="262">
                  <c:v>438</c:v>
                </c:pt>
                <c:pt idx="263">
                  <c:v>437</c:v>
                </c:pt>
                <c:pt idx="264">
                  <c:v>436</c:v>
                </c:pt>
                <c:pt idx="265">
                  <c:v>435</c:v>
                </c:pt>
                <c:pt idx="266">
                  <c:v>434</c:v>
                </c:pt>
                <c:pt idx="267">
                  <c:v>433</c:v>
                </c:pt>
                <c:pt idx="268">
                  <c:v>432</c:v>
                </c:pt>
                <c:pt idx="269">
                  <c:v>431</c:v>
                </c:pt>
                <c:pt idx="270">
                  <c:v>430</c:v>
                </c:pt>
                <c:pt idx="271">
                  <c:v>429</c:v>
                </c:pt>
                <c:pt idx="272">
                  <c:v>428</c:v>
                </c:pt>
                <c:pt idx="273">
                  <c:v>427</c:v>
                </c:pt>
                <c:pt idx="274">
                  <c:v>426</c:v>
                </c:pt>
                <c:pt idx="275">
                  <c:v>425</c:v>
                </c:pt>
                <c:pt idx="276">
                  <c:v>424</c:v>
                </c:pt>
                <c:pt idx="277">
                  <c:v>423</c:v>
                </c:pt>
                <c:pt idx="278">
                  <c:v>422</c:v>
                </c:pt>
                <c:pt idx="279">
                  <c:v>421</c:v>
                </c:pt>
                <c:pt idx="280">
                  <c:v>420</c:v>
                </c:pt>
                <c:pt idx="281">
                  <c:v>419</c:v>
                </c:pt>
                <c:pt idx="282">
                  <c:v>418</c:v>
                </c:pt>
                <c:pt idx="283">
                  <c:v>417</c:v>
                </c:pt>
                <c:pt idx="284">
                  <c:v>416</c:v>
                </c:pt>
                <c:pt idx="285">
                  <c:v>415</c:v>
                </c:pt>
                <c:pt idx="286">
                  <c:v>414</c:v>
                </c:pt>
                <c:pt idx="287">
                  <c:v>413</c:v>
                </c:pt>
                <c:pt idx="288">
                  <c:v>412</c:v>
                </c:pt>
                <c:pt idx="289">
                  <c:v>411</c:v>
                </c:pt>
                <c:pt idx="290">
                  <c:v>410</c:v>
                </c:pt>
                <c:pt idx="291">
                  <c:v>409</c:v>
                </c:pt>
                <c:pt idx="292">
                  <c:v>408</c:v>
                </c:pt>
                <c:pt idx="293">
                  <c:v>407</c:v>
                </c:pt>
                <c:pt idx="294">
                  <c:v>406</c:v>
                </c:pt>
                <c:pt idx="295">
                  <c:v>405</c:v>
                </c:pt>
                <c:pt idx="296">
                  <c:v>404</c:v>
                </c:pt>
                <c:pt idx="297">
                  <c:v>403</c:v>
                </c:pt>
                <c:pt idx="298">
                  <c:v>402</c:v>
                </c:pt>
                <c:pt idx="299">
                  <c:v>401</c:v>
                </c:pt>
                <c:pt idx="300">
                  <c:v>400</c:v>
                </c:pt>
                <c:pt idx="301">
                  <c:v>399</c:v>
                </c:pt>
                <c:pt idx="302">
                  <c:v>398</c:v>
                </c:pt>
                <c:pt idx="303">
                  <c:v>397</c:v>
                </c:pt>
                <c:pt idx="304">
                  <c:v>396</c:v>
                </c:pt>
                <c:pt idx="305">
                  <c:v>395</c:v>
                </c:pt>
                <c:pt idx="306">
                  <c:v>394</c:v>
                </c:pt>
                <c:pt idx="307">
                  <c:v>393</c:v>
                </c:pt>
                <c:pt idx="308">
                  <c:v>392</c:v>
                </c:pt>
                <c:pt idx="309">
                  <c:v>391</c:v>
                </c:pt>
                <c:pt idx="310">
                  <c:v>390</c:v>
                </c:pt>
                <c:pt idx="311">
                  <c:v>389</c:v>
                </c:pt>
                <c:pt idx="312">
                  <c:v>388</c:v>
                </c:pt>
                <c:pt idx="313">
                  <c:v>387</c:v>
                </c:pt>
                <c:pt idx="314">
                  <c:v>386</c:v>
                </c:pt>
                <c:pt idx="315">
                  <c:v>385</c:v>
                </c:pt>
                <c:pt idx="316">
                  <c:v>384</c:v>
                </c:pt>
                <c:pt idx="317">
                  <c:v>383</c:v>
                </c:pt>
                <c:pt idx="318">
                  <c:v>382</c:v>
                </c:pt>
                <c:pt idx="319">
                  <c:v>381</c:v>
                </c:pt>
                <c:pt idx="320">
                  <c:v>380</c:v>
                </c:pt>
                <c:pt idx="321">
                  <c:v>379</c:v>
                </c:pt>
                <c:pt idx="322">
                  <c:v>378</c:v>
                </c:pt>
                <c:pt idx="323">
                  <c:v>377</c:v>
                </c:pt>
                <c:pt idx="324">
                  <c:v>376</c:v>
                </c:pt>
                <c:pt idx="325">
                  <c:v>375</c:v>
                </c:pt>
                <c:pt idx="326">
                  <c:v>374</c:v>
                </c:pt>
                <c:pt idx="327">
                  <c:v>373</c:v>
                </c:pt>
                <c:pt idx="328">
                  <c:v>372</c:v>
                </c:pt>
                <c:pt idx="329">
                  <c:v>371</c:v>
                </c:pt>
                <c:pt idx="330">
                  <c:v>370</c:v>
                </c:pt>
                <c:pt idx="331">
                  <c:v>369</c:v>
                </c:pt>
                <c:pt idx="332">
                  <c:v>368</c:v>
                </c:pt>
                <c:pt idx="333">
                  <c:v>367</c:v>
                </c:pt>
                <c:pt idx="334">
                  <c:v>366</c:v>
                </c:pt>
                <c:pt idx="335">
                  <c:v>365</c:v>
                </c:pt>
                <c:pt idx="336">
                  <c:v>364</c:v>
                </c:pt>
                <c:pt idx="337">
                  <c:v>363</c:v>
                </c:pt>
                <c:pt idx="338">
                  <c:v>362</c:v>
                </c:pt>
                <c:pt idx="339">
                  <c:v>361</c:v>
                </c:pt>
                <c:pt idx="340">
                  <c:v>360</c:v>
                </c:pt>
                <c:pt idx="341">
                  <c:v>359</c:v>
                </c:pt>
                <c:pt idx="342">
                  <c:v>358</c:v>
                </c:pt>
                <c:pt idx="343">
                  <c:v>357</c:v>
                </c:pt>
                <c:pt idx="344">
                  <c:v>356</c:v>
                </c:pt>
                <c:pt idx="345">
                  <c:v>355</c:v>
                </c:pt>
                <c:pt idx="346">
                  <c:v>354</c:v>
                </c:pt>
                <c:pt idx="347">
                  <c:v>353</c:v>
                </c:pt>
                <c:pt idx="348">
                  <c:v>352</c:v>
                </c:pt>
                <c:pt idx="349">
                  <c:v>351</c:v>
                </c:pt>
                <c:pt idx="350">
                  <c:v>350</c:v>
                </c:pt>
                <c:pt idx="351">
                  <c:v>349</c:v>
                </c:pt>
                <c:pt idx="352">
                  <c:v>348</c:v>
                </c:pt>
                <c:pt idx="353">
                  <c:v>347</c:v>
                </c:pt>
                <c:pt idx="354">
                  <c:v>346</c:v>
                </c:pt>
                <c:pt idx="355">
                  <c:v>345</c:v>
                </c:pt>
                <c:pt idx="356">
                  <c:v>344</c:v>
                </c:pt>
                <c:pt idx="357">
                  <c:v>343</c:v>
                </c:pt>
                <c:pt idx="358">
                  <c:v>342</c:v>
                </c:pt>
                <c:pt idx="359">
                  <c:v>341</c:v>
                </c:pt>
                <c:pt idx="360">
                  <c:v>340</c:v>
                </c:pt>
                <c:pt idx="361">
                  <c:v>339</c:v>
                </c:pt>
                <c:pt idx="362">
                  <c:v>338</c:v>
                </c:pt>
                <c:pt idx="363">
                  <c:v>337</c:v>
                </c:pt>
                <c:pt idx="364">
                  <c:v>336</c:v>
                </c:pt>
                <c:pt idx="365">
                  <c:v>335</c:v>
                </c:pt>
                <c:pt idx="366">
                  <c:v>334</c:v>
                </c:pt>
                <c:pt idx="367">
                  <c:v>333</c:v>
                </c:pt>
                <c:pt idx="368">
                  <c:v>332</c:v>
                </c:pt>
                <c:pt idx="369">
                  <c:v>331</c:v>
                </c:pt>
                <c:pt idx="370">
                  <c:v>330</c:v>
                </c:pt>
                <c:pt idx="371">
                  <c:v>329</c:v>
                </c:pt>
                <c:pt idx="372">
                  <c:v>328</c:v>
                </c:pt>
                <c:pt idx="373">
                  <c:v>327</c:v>
                </c:pt>
                <c:pt idx="374">
                  <c:v>326</c:v>
                </c:pt>
                <c:pt idx="375">
                  <c:v>325</c:v>
                </c:pt>
                <c:pt idx="376">
                  <c:v>324</c:v>
                </c:pt>
                <c:pt idx="377">
                  <c:v>323</c:v>
                </c:pt>
                <c:pt idx="378">
                  <c:v>322</c:v>
                </c:pt>
                <c:pt idx="379">
                  <c:v>321</c:v>
                </c:pt>
                <c:pt idx="380">
                  <c:v>320</c:v>
                </c:pt>
                <c:pt idx="381">
                  <c:v>319</c:v>
                </c:pt>
                <c:pt idx="382">
                  <c:v>318</c:v>
                </c:pt>
                <c:pt idx="383">
                  <c:v>317</c:v>
                </c:pt>
                <c:pt idx="384">
                  <c:v>316</c:v>
                </c:pt>
                <c:pt idx="385">
                  <c:v>315</c:v>
                </c:pt>
                <c:pt idx="386">
                  <c:v>314</c:v>
                </c:pt>
                <c:pt idx="387">
                  <c:v>313</c:v>
                </c:pt>
                <c:pt idx="388">
                  <c:v>312</c:v>
                </c:pt>
                <c:pt idx="389">
                  <c:v>311</c:v>
                </c:pt>
                <c:pt idx="390">
                  <c:v>310</c:v>
                </c:pt>
                <c:pt idx="391">
                  <c:v>309</c:v>
                </c:pt>
                <c:pt idx="392">
                  <c:v>308</c:v>
                </c:pt>
                <c:pt idx="393">
                  <c:v>307</c:v>
                </c:pt>
                <c:pt idx="394">
                  <c:v>306</c:v>
                </c:pt>
                <c:pt idx="395">
                  <c:v>305</c:v>
                </c:pt>
                <c:pt idx="396">
                  <c:v>304</c:v>
                </c:pt>
                <c:pt idx="397">
                  <c:v>303</c:v>
                </c:pt>
                <c:pt idx="398">
                  <c:v>302</c:v>
                </c:pt>
                <c:pt idx="399">
                  <c:v>301</c:v>
                </c:pt>
                <c:pt idx="400">
                  <c:v>300</c:v>
                </c:pt>
                <c:pt idx="401">
                  <c:v>299</c:v>
                </c:pt>
                <c:pt idx="402">
                  <c:v>298</c:v>
                </c:pt>
                <c:pt idx="403">
                  <c:v>297</c:v>
                </c:pt>
                <c:pt idx="404">
                  <c:v>296</c:v>
                </c:pt>
                <c:pt idx="405">
                  <c:v>295</c:v>
                </c:pt>
                <c:pt idx="406">
                  <c:v>294</c:v>
                </c:pt>
                <c:pt idx="407">
                  <c:v>293</c:v>
                </c:pt>
                <c:pt idx="408">
                  <c:v>292</c:v>
                </c:pt>
                <c:pt idx="409">
                  <c:v>291</c:v>
                </c:pt>
                <c:pt idx="410">
                  <c:v>290</c:v>
                </c:pt>
                <c:pt idx="411">
                  <c:v>289</c:v>
                </c:pt>
                <c:pt idx="412">
                  <c:v>288</c:v>
                </c:pt>
                <c:pt idx="413">
                  <c:v>287</c:v>
                </c:pt>
                <c:pt idx="414">
                  <c:v>286</c:v>
                </c:pt>
                <c:pt idx="415">
                  <c:v>285</c:v>
                </c:pt>
                <c:pt idx="416">
                  <c:v>284</c:v>
                </c:pt>
                <c:pt idx="417">
                  <c:v>283</c:v>
                </c:pt>
                <c:pt idx="418">
                  <c:v>282</c:v>
                </c:pt>
                <c:pt idx="419">
                  <c:v>281</c:v>
                </c:pt>
                <c:pt idx="420">
                  <c:v>280</c:v>
                </c:pt>
                <c:pt idx="421">
                  <c:v>279</c:v>
                </c:pt>
                <c:pt idx="422">
                  <c:v>278</c:v>
                </c:pt>
                <c:pt idx="423">
                  <c:v>277</c:v>
                </c:pt>
                <c:pt idx="424">
                  <c:v>276</c:v>
                </c:pt>
                <c:pt idx="425">
                  <c:v>275</c:v>
                </c:pt>
                <c:pt idx="426">
                  <c:v>274</c:v>
                </c:pt>
                <c:pt idx="427">
                  <c:v>273</c:v>
                </c:pt>
                <c:pt idx="428">
                  <c:v>272</c:v>
                </c:pt>
                <c:pt idx="429">
                  <c:v>271</c:v>
                </c:pt>
                <c:pt idx="430">
                  <c:v>270</c:v>
                </c:pt>
                <c:pt idx="431">
                  <c:v>269</c:v>
                </c:pt>
                <c:pt idx="432">
                  <c:v>268</c:v>
                </c:pt>
                <c:pt idx="433">
                  <c:v>267</c:v>
                </c:pt>
                <c:pt idx="434">
                  <c:v>266</c:v>
                </c:pt>
                <c:pt idx="435">
                  <c:v>265</c:v>
                </c:pt>
                <c:pt idx="436">
                  <c:v>264</c:v>
                </c:pt>
                <c:pt idx="437">
                  <c:v>263</c:v>
                </c:pt>
                <c:pt idx="438">
                  <c:v>262</c:v>
                </c:pt>
                <c:pt idx="439">
                  <c:v>261</c:v>
                </c:pt>
                <c:pt idx="440">
                  <c:v>260</c:v>
                </c:pt>
                <c:pt idx="441">
                  <c:v>259</c:v>
                </c:pt>
                <c:pt idx="442">
                  <c:v>258</c:v>
                </c:pt>
                <c:pt idx="443">
                  <c:v>257</c:v>
                </c:pt>
                <c:pt idx="444">
                  <c:v>256</c:v>
                </c:pt>
                <c:pt idx="445">
                  <c:v>255</c:v>
                </c:pt>
                <c:pt idx="446">
                  <c:v>254</c:v>
                </c:pt>
                <c:pt idx="447">
                  <c:v>253</c:v>
                </c:pt>
                <c:pt idx="448">
                  <c:v>252</c:v>
                </c:pt>
                <c:pt idx="449">
                  <c:v>251</c:v>
                </c:pt>
                <c:pt idx="450">
                  <c:v>250</c:v>
                </c:pt>
                <c:pt idx="451">
                  <c:v>249</c:v>
                </c:pt>
                <c:pt idx="452">
                  <c:v>248</c:v>
                </c:pt>
                <c:pt idx="453">
                  <c:v>247</c:v>
                </c:pt>
                <c:pt idx="454">
                  <c:v>246</c:v>
                </c:pt>
                <c:pt idx="455">
                  <c:v>245</c:v>
                </c:pt>
                <c:pt idx="456">
                  <c:v>244</c:v>
                </c:pt>
                <c:pt idx="457">
                  <c:v>243</c:v>
                </c:pt>
                <c:pt idx="458">
                  <c:v>242</c:v>
                </c:pt>
                <c:pt idx="459">
                  <c:v>241</c:v>
                </c:pt>
                <c:pt idx="460">
                  <c:v>240</c:v>
                </c:pt>
                <c:pt idx="461">
                  <c:v>239</c:v>
                </c:pt>
                <c:pt idx="462">
                  <c:v>238</c:v>
                </c:pt>
                <c:pt idx="463">
                  <c:v>237</c:v>
                </c:pt>
                <c:pt idx="464">
                  <c:v>236</c:v>
                </c:pt>
                <c:pt idx="465">
                  <c:v>235</c:v>
                </c:pt>
                <c:pt idx="466">
                  <c:v>234</c:v>
                </c:pt>
                <c:pt idx="467">
                  <c:v>233</c:v>
                </c:pt>
                <c:pt idx="468">
                  <c:v>232</c:v>
                </c:pt>
                <c:pt idx="469">
                  <c:v>231</c:v>
                </c:pt>
                <c:pt idx="470">
                  <c:v>230</c:v>
                </c:pt>
                <c:pt idx="471">
                  <c:v>229</c:v>
                </c:pt>
                <c:pt idx="472">
                  <c:v>228</c:v>
                </c:pt>
                <c:pt idx="473">
                  <c:v>227</c:v>
                </c:pt>
                <c:pt idx="474">
                  <c:v>226</c:v>
                </c:pt>
                <c:pt idx="475">
                  <c:v>225</c:v>
                </c:pt>
                <c:pt idx="476">
                  <c:v>224</c:v>
                </c:pt>
                <c:pt idx="477">
                  <c:v>223</c:v>
                </c:pt>
                <c:pt idx="478">
                  <c:v>222</c:v>
                </c:pt>
                <c:pt idx="479">
                  <c:v>221</c:v>
                </c:pt>
                <c:pt idx="480">
                  <c:v>220</c:v>
                </c:pt>
              </c:numCache>
            </c:numRef>
          </c:xVal>
          <c:yVal>
            <c:numRef>
              <c:f>文章选用!$E$2:$E$482</c:f>
              <c:numCache>
                <c:formatCode>General</c:formatCode>
                <c:ptCount val="481"/>
                <c:pt idx="0">
                  <c:v>-1E-3</c:v>
                </c:pt>
                <c:pt idx="1">
                  <c:v>-1E-3</c:v>
                </c:pt>
                <c:pt idx="2">
                  <c:v>-1E-3</c:v>
                </c:pt>
                <c:pt idx="3">
                  <c:v>-1E-3</c:v>
                </c:pt>
                <c:pt idx="4">
                  <c:v>-1E-3</c:v>
                </c:pt>
                <c:pt idx="5">
                  <c:v>-1E-3</c:v>
                </c:pt>
                <c:pt idx="6">
                  <c:v>-1E-3</c:v>
                </c:pt>
                <c:pt idx="7">
                  <c:v>-1E-3</c:v>
                </c:pt>
                <c:pt idx="8">
                  <c:v>-1E-3</c:v>
                </c:pt>
                <c:pt idx="9">
                  <c:v>-1E-3</c:v>
                </c:pt>
                <c:pt idx="10">
                  <c:v>-1E-3</c:v>
                </c:pt>
                <c:pt idx="11">
                  <c:v>-1E-3</c:v>
                </c:pt>
                <c:pt idx="12">
                  <c:v>-1E-3</c:v>
                </c:pt>
                <c:pt idx="13">
                  <c:v>-1E-3</c:v>
                </c:pt>
                <c:pt idx="14">
                  <c:v>-1E-3</c:v>
                </c:pt>
                <c:pt idx="15">
                  <c:v>-1E-3</c:v>
                </c:pt>
                <c:pt idx="16">
                  <c:v>-1E-3</c:v>
                </c:pt>
                <c:pt idx="17">
                  <c:v>-1E-3</c:v>
                </c:pt>
                <c:pt idx="18">
                  <c:v>-1E-3</c:v>
                </c:pt>
                <c:pt idx="19">
                  <c:v>-1E-3</c:v>
                </c:pt>
                <c:pt idx="20">
                  <c:v>-1E-3</c:v>
                </c:pt>
                <c:pt idx="21">
                  <c:v>-1E-3</c:v>
                </c:pt>
                <c:pt idx="22">
                  <c:v>-1E-3</c:v>
                </c:pt>
                <c:pt idx="23">
                  <c:v>-1E-3</c:v>
                </c:pt>
                <c:pt idx="24">
                  <c:v>-1E-3</c:v>
                </c:pt>
                <c:pt idx="25">
                  <c:v>-1E-3</c:v>
                </c:pt>
                <c:pt idx="26">
                  <c:v>-1E-3</c:v>
                </c:pt>
                <c:pt idx="27">
                  <c:v>-1E-3</c:v>
                </c:pt>
                <c:pt idx="28">
                  <c:v>-1E-3</c:v>
                </c:pt>
                <c:pt idx="29">
                  <c:v>-1E-3</c:v>
                </c:pt>
                <c:pt idx="30">
                  <c:v>-1E-3</c:v>
                </c:pt>
                <c:pt idx="31">
                  <c:v>-1E-3</c:v>
                </c:pt>
                <c:pt idx="32">
                  <c:v>-1E-3</c:v>
                </c:pt>
                <c:pt idx="33">
                  <c:v>-1E-3</c:v>
                </c:pt>
                <c:pt idx="34">
                  <c:v>-1E-3</c:v>
                </c:pt>
                <c:pt idx="35">
                  <c:v>-1E-3</c:v>
                </c:pt>
                <c:pt idx="36">
                  <c:v>-1E-3</c:v>
                </c:pt>
                <c:pt idx="37">
                  <c:v>-1E-3</c:v>
                </c:pt>
                <c:pt idx="38">
                  <c:v>-1E-3</c:v>
                </c:pt>
                <c:pt idx="39">
                  <c:v>-1E-3</c:v>
                </c:pt>
                <c:pt idx="40">
                  <c:v>-1E-3</c:v>
                </c:pt>
                <c:pt idx="41">
                  <c:v>-1E-3</c:v>
                </c:pt>
                <c:pt idx="42">
                  <c:v>-1E-3</c:v>
                </c:pt>
                <c:pt idx="43">
                  <c:v>-1E-3</c:v>
                </c:pt>
                <c:pt idx="44">
                  <c:v>-1E-3</c:v>
                </c:pt>
                <c:pt idx="45">
                  <c:v>-1E-3</c:v>
                </c:pt>
                <c:pt idx="46">
                  <c:v>-1E-3</c:v>
                </c:pt>
                <c:pt idx="47">
                  <c:v>-1E-3</c:v>
                </c:pt>
                <c:pt idx="48">
                  <c:v>-1E-3</c:v>
                </c:pt>
                <c:pt idx="49">
                  <c:v>-1E-3</c:v>
                </c:pt>
                <c:pt idx="50">
                  <c:v>-1E-3</c:v>
                </c:pt>
                <c:pt idx="51">
                  <c:v>-1E-3</c:v>
                </c:pt>
                <c:pt idx="52">
                  <c:v>-1E-3</c:v>
                </c:pt>
                <c:pt idx="53">
                  <c:v>-1E-3</c:v>
                </c:pt>
                <c:pt idx="54">
                  <c:v>-1E-3</c:v>
                </c:pt>
                <c:pt idx="55">
                  <c:v>-1E-3</c:v>
                </c:pt>
                <c:pt idx="56">
                  <c:v>-1E-3</c:v>
                </c:pt>
                <c:pt idx="57">
                  <c:v>-1E-3</c:v>
                </c:pt>
                <c:pt idx="58">
                  <c:v>-1E-3</c:v>
                </c:pt>
                <c:pt idx="59">
                  <c:v>-1E-3</c:v>
                </c:pt>
                <c:pt idx="60">
                  <c:v>-1E-3</c:v>
                </c:pt>
                <c:pt idx="61">
                  <c:v>-1E-3</c:v>
                </c:pt>
                <c:pt idx="62">
                  <c:v>-1E-3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-1E-3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1E-3</c:v>
                </c:pt>
                <c:pt idx="252">
                  <c:v>1E-3</c:v>
                </c:pt>
                <c:pt idx="253">
                  <c:v>1E-3</c:v>
                </c:pt>
                <c:pt idx="254">
                  <c:v>1E-3</c:v>
                </c:pt>
                <c:pt idx="255">
                  <c:v>1E-3</c:v>
                </c:pt>
                <c:pt idx="256">
                  <c:v>1E-3</c:v>
                </c:pt>
                <c:pt idx="257">
                  <c:v>1E-3</c:v>
                </c:pt>
                <c:pt idx="258">
                  <c:v>1E-3</c:v>
                </c:pt>
                <c:pt idx="259">
                  <c:v>1E-3</c:v>
                </c:pt>
                <c:pt idx="260">
                  <c:v>1E-3</c:v>
                </c:pt>
                <c:pt idx="261">
                  <c:v>1E-3</c:v>
                </c:pt>
                <c:pt idx="262">
                  <c:v>1E-3</c:v>
                </c:pt>
                <c:pt idx="263">
                  <c:v>1E-3</c:v>
                </c:pt>
                <c:pt idx="264">
                  <c:v>1E-3</c:v>
                </c:pt>
                <c:pt idx="265">
                  <c:v>1E-3</c:v>
                </c:pt>
                <c:pt idx="266">
                  <c:v>1E-3</c:v>
                </c:pt>
                <c:pt idx="267">
                  <c:v>1E-3</c:v>
                </c:pt>
                <c:pt idx="268">
                  <c:v>2E-3</c:v>
                </c:pt>
                <c:pt idx="269">
                  <c:v>2E-3</c:v>
                </c:pt>
                <c:pt idx="270">
                  <c:v>2E-3</c:v>
                </c:pt>
                <c:pt idx="271">
                  <c:v>2E-3</c:v>
                </c:pt>
                <c:pt idx="272">
                  <c:v>2E-3</c:v>
                </c:pt>
                <c:pt idx="273">
                  <c:v>2E-3</c:v>
                </c:pt>
                <c:pt idx="274">
                  <c:v>2E-3</c:v>
                </c:pt>
                <c:pt idx="275">
                  <c:v>2E-3</c:v>
                </c:pt>
                <c:pt idx="276">
                  <c:v>2E-3</c:v>
                </c:pt>
                <c:pt idx="277">
                  <c:v>3.0000000000000001E-3</c:v>
                </c:pt>
                <c:pt idx="278">
                  <c:v>3.0000000000000001E-3</c:v>
                </c:pt>
                <c:pt idx="279">
                  <c:v>3.0000000000000001E-3</c:v>
                </c:pt>
                <c:pt idx="280">
                  <c:v>3.0000000000000001E-3</c:v>
                </c:pt>
                <c:pt idx="281">
                  <c:v>3.0000000000000001E-3</c:v>
                </c:pt>
                <c:pt idx="282">
                  <c:v>4.0000000000000001E-3</c:v>
                </c:pt>
                <c:pt idx="283">
                  <c:v>4.0000000000000001E-3</c:v>
                </c:pt>
                <c:pt idx="284">
                  <c:v>4.0000000000000001E-3</c:v>
                </c:pt>
                <c:pt idx="285">
                  <c:v>4.0000000000000001E-3</c:v>
                </c:pt>
                <c:pt idx="286">
                  <c:v>4.0000000000000001E-3</c:v>
                </c:pt>
                <c:pt idx="287">
                  <c:v>5.0000000000000001E-3</c:v>
                </c:pt>
                <c:pt idx="288">
                  <c:v>5.0000000000000001E-3</c:v>
                </c:pt>
                <c:pt idx="289">
                  <c:v>5.0000000000000001E-3</c:v>
                </c:pt>
                <c:pt idx="290">
                  <c:v>6.0000000000000001E-3</c:v>
                </c:pt>
                <c:pt idx="291">
                  <c:v>6.0000000000000001E-3</c:v>
                </c:pt>
                <c:pt idx="292">
                  <c:v>6.0000000000000001E-3</c:v>
                </c:pt>
                <c:pt idx="293">
                  <c:v>7.0000000000000001E-3</c:v>
                </c:pt>
                <c:pt idx="294">
                  <c:v>7.0000000000000001E-3</c:v>
                </c:pt>
                <c:pt idx="295">
                  <c:v>8.0000000000000002E-3</c:v>
                </c:pt>
                <c:pt idx="296">
                  <c:v>8.0000000000000002E-3</c:v>
                </c:pt>
                <c:pt idx="297">
                  <c:v>8.9999999999999993E-3</c:v>
                </c:pt>
                <c:pt idx="298">
                  <c:v>8.9999999999999993E-3</c:v>
                </c:pt>
                <c:pt idx="299">
                  <c:v>0.01</c:v>
                </c:pt>
                <c:pt idx="300">
                  <c:v>0.01</c:v>
                </c:pt>
                <c:pt idx="301">
                  <c:v>1.0999999999999999E-2</c:v>
                </c:pt>
                <c:pt idx="302">
                  <c:v>1.2E-2</c:v>
                </c:pt>
                <c:pt idx="303">
                  <c:v>1.2E-2</c:v>
                </c:pt>
                <c:pt idx="304">
                  <c:v>1.2999999999999999E-2</c:v>
                </c:pt>
                <c:pt idx="305">
                  <c:v>1.4E-2</c:v>
                </c:pt>
                <c:pt idx="306">
                  <c:v>1.4999999999999999E-2</c:v>
                </c:pt>
                <c:pt idx="307">
                  <c:v>1.4999999999999999E-2</c:v>
                </c:pt>
                <c:pt idx="308">
                  <c:v>1.6E-2</c:v>
                </c:pt>
                <c:pt idx="309">
                  <c:v>1.7000000000000001E-2</c:v>
                </c:pt>
                <c:pt idx="310">
                  <c:v>1.7999999999999999E-2</c:v>
                </c:pt>
                <c:pt idx="311">
                  <c:v>1.9E-2</c:v>
                </c:pt>
                <c:pt idx="312">
                  <c:v>0.02</c:v>
                </c:pt>
                <c:pt idx="313">
                  <c:v>2.1000000000000001E-2</c:v>
                </c:pt>
                <c:pt idx="314">
                  <c:v>2.1999999999999999E-2</c:v>
                </c:pt>
                <c:pt idx="315">
                  <c:v>2.4E-2</c:v>
                </c:pt>
                <c:pt idx="316">
                  <c:v>2.5000000000000001E-2</c:v>
                </c:pt>
                <c:pt idx="317">
                  <c:v>2.5999999999999999E-2</c:v>
                </c:pt>
                <c:pt idx="318">
                  <c:v>2.8000000000000001E-2</c:v>
                </c:pt>
                <c:pt idx="319">
                  <c:v>2.9000000000000001E-2</c:v>
                </c:pt>
                <c:pt idx="320">
                  <c:v>0.03</c:v>
                </c:pt>
                <c:pt idx="321">
                  <c:v>3.2000000000000001E-2</c:v>
                </c:pt>
                <c:pt idx="322">
                  <c:v>3.3000000000000002E-2</c:v>
                </c:pt>
                <c:pt idx="323">
                  <c:v>3.5000000000000003E-2</c:v>
                </c:pt>
                <c:pt idx="324">
                  <c:v>3.6999999999999998E-2</c:v>
                </c:pt>
                <c:pt idx="325">
                  <c:v>3.7999999999999999E-2</c:v>
                </c:pt>
                <c:pt idx="326">
                  <c:v>0.04</c:v>
                </c:pt>
                <c:pt idx="327">
                  <c:v>4.2000000000000003E-2</c:v>
                </c:pt>
                <c:pt idx="328">
                  <c:v>4.3999999999999997E-2</c:v>
                </c:pt>
                <c:pt idx="329">
                  <c:v>4.5999999999999999E-2</c:v>
                </c:pt>
                <c:pt idx="330">
                  <c:v>4.8000000000000001E-2</c:v>
                </c:pt>
                <c:pt idx="331">
                  <c:v>0.05</c:v>
                </c:pt>
                <c:pt idx="332">
                  <c:v>5.1999999999999998E-2</c:v>
                </c:pt>
                <c:pt idx="333">
                  <c:v>5.5E-2</c:v>
                </c:pt>
                <c:pt idx="334">
                  <c:v>5.7000000000000002E-2</c:v>
                </c:pt>
                <c:pt idx="335">
                  <c:v>5.8999999999999997E-2</c:v>
                </c:pt>
                <c:pt idx="336">
                  <c:v>6.0999999999999999E-2</c:v>
                </c:pt>
                <c:pt idx="337">
                  <c:v>6.3E-2</c:v>
                </c:pt>
                <c:pt idx="338">
                  <c:v>6.6000000000000003E-2</c:v>
                </c:pt>
                <c:pt idx="339">
                  <c:v>6.8000000000000005E-2</c:v>
                </c:pt>
                <c:pt idx="340">
                  <c:v>7.0999999999999994E-2</c:v>
                </c:pt>
                <c:pt idx="341">
                  <c:v>7.2999999999999995E-2</c:v>
                </c:pt>
                <c:pt idx="342">
                  <c:v>7.5999999999999998E-2</c:v>
                </c:pt>
                <c:pt idx="343">
                  <c:v>7.8E-2</c:v>
                </c:pt>
                <c:pt idx="344">
                  <c:v>8.1000000000000003E-2</c:v>
                </c:pt>
                <c:pt idx="345">
                  <c:v>8.4000000000000005E-2</c:v>
                </c:pt>
                <c:pt idx="346">
                  <c:v>8.5999999999999993E-2</c:v>
                </c:pt>
                <c:pt idx="347">
                  <c:v>8.8999999999999996E-2</c:v>
                </c:pt>
                <c:pt idx="348">
                  <c:v>9.1999999999999998E-2</c:v>
                </c:pt>
                <c:pt idx="349">
                  <c:v>9.5000000000000001E-2</c:v>
                </c:pt>
                <c:pt idx="350">
                  <c:v>9.8000000000000004E-2</c:v>
                </c:pt>
                <c:pt idx="351">
                  <c:v>0.1</c:v>
                </c:pt>
                <c:pt idx="352">
                  <c:v>0.10299999999999999</c:v>
                </c:pt>
                <c:pt idx="353">
                  <c:v>0.106</c:v>
                </c:pt>
                <c:pt idx="354">
                  <c:v>0.11</c:v>
                </c:pt>
                <c:pt idx="355">
                  <c:v>0.113</c:v>
                </c:pt>
                <c:pt idx="356">
                  <c:v>0.11600000000000001</c:v>
                </c:pt>
                <c:pt idx="357">
                  <c:v>0.11899999999999999</c:v>
                </c:pt>
                <c:pt idx="358">
                  <c:v>0.123</c:v>
                </c:pt>
                <c:pt idx="359">
                  <c:v>0.126</c:v>
                </c:pt>
                <c:pt idx="360">
                  <c:v>0.129</c:v>
                </c:pt>
                <c:pt idx="361">
                  <c:v>0.13300000000000001</c:v>
                </c:pt>
                <c:pt idx="362">
                  <c:v>0.13600000000000001</c:v>
                </c:pt>
                <c:pt idx="363">
                  <c:v>0.13900000000000001</c:v>
                </c:pt>
                <c:pt idx="364">
                  <c:v>0.14299999999999999</c:v>
                </c:pt>
                <c:pt idx="365">
                  <c:v>0.14699999999999999</c:v>
                </c:pt>
                <c:pt idx="366">
                  <c:v>0.151</c:v>
                </c:pt>
                <c:pt idx="367">
                  <c:v>0.155</c:v>
                </c:pt>
                <c:pt idx="368">
                  <c:v>0.159</c:v>
                </c:pt>
                <c:pt idx="369">
                  <c:v>0.16300000000000001</c:v>
                </c:pt>
                <c:pt idx="370">
                  <c:v>0.16700000000000001</c:v>
                </c:pt>
                <c:pt idx="371">
                  <c:v>0.17199999999999999</c:v>
                </c:pt>
                <c:pt idx="372">
                  <c:v>0.17699999999999999</c:v>
                </c:pt>
                <c:pt idx="373">
                  <c:v>0.18099999999999999</c:v>
                </c:pt>
                <c:pt idx="374">
                  <c:v>0.186</c:v>
                </c:pt>
                <c:pt idx="375">
                  <c:v>0.19</c:v>
                </c:pt>
                <c:pt idx="376">
                  <c:v>0.19600000000000001</c:v>
                </c:pt>
                <c:pt idx="377">
                  <c:v>0.20100000000000001</c:v>
                </c:pt>
                <c:pt idx="378">
                  <c:v>0.20699999999999999</c:v>
                </c:pt>
                <c:pt idx="379">
                  <c:v>0.21199999999999999</c:v>
                </c:pt>
                <c:pt idx="380">
                  <c:v>0.218</c:v>
                </c:pt>
                <c:pt idx="381">
                  <c:v>0.224</c:v>
                </c:pt>
                <c:pt idx="382">
                  <c:v>0.23</c:v>
                </c:pt>
                <c:pt idx="383">
                  <c:v>0.23499999999999999</c:v>
                </c:pt>
                <c:pt idx="384">
                  <c:v>0.24099999999999999</c:v>
                </c:pt>
                <c:pt idx="385">
                  <c:v>0.247</c:v>
                </c:pt>
                <c:pt idx="386">
                  <c:v>0.254</c:v>
                </c:pt>
                <c:pt idx="387">
                  <c:v>0.26</c:v>
                </c:pt>
                <c:pt idx="388">
                  <c:v>0.26600000000000001</c:v>
                </c:pt>
                <c:pt idx="389">
                  <c:v>0.27200000000000002</c:v>
                </c:pt>
                <c:pt idx="390">
                  <c:v>0.27900000000000003</c:v>
                </c:pt>
                <c:pt idx="391">
                  <c:v>0.28499999999999998</c:v>
                </c:pt>
                <c:pt idx="392">
                  <c:v>0.29199999999999998</c:v>
                </c:pt>
                <c:pt idx="393">
                  <c:v>0.29799999999999999</c:v>
                </c:pt>
                <c:pt idx="394">
                  <c:v>0.30399999999999999</c:v>
                </c:pt>
                <c:pt idx="395">
                  <c:v>0.31</c:v>
                </c:pt>
                <c:pt idx="396">
                  <c:v>0.317</c:v>
                </c:pt>
                <c:pt idx="397">
                  <c:v>0.32300000000000001</c:v>
                </c:pt>
                <c:pt idx="398">
                  <c:v>0.32900000000000001</c:v>
                </c:pt>
                <c:pt idx="399">
                  <c:v>0.33600000000000002</c:v>
                </c:pt>
                <c:pt idx="400">
                  <c:v>0.34300000000000003</c:v>
                </c:pt>
                <c:pt idx="401">
                  <c:v>0.35099999999999998</c:v>
                </c:pt>
                <c:pt idx="402">
                  <c:v>0.35899999999999999</c:v>
                </c:pt>
                <c:pt idx="403">
                  <c:v>0.36699999999999999</c:v>
                </c:pt>
                <c:pt idx="404">
                  <c:v>0.376</c:v>
                </c:pt>
                <c:pt idx="405">
                  <c:v>0.38500000000000001</c:v>
                </c:pt>
                <c:pt idx="406">
                  <c:v>0.39400000000000002</c:v>
                </c:pt>
                <c:pt idx="407">
                  <c:v>0.40400000000000003</c:v>
                </c:pt>
                <c:pt idx="408">
                  <c:v>0.41399999999999998</c:v>
                </c:pt>
                <c:pt idx="409">
                  <c:v>0.42499999999999999</c:v>
                </c:pt>
                <c:pt idx="410">
                  <c:v>0.436</c:v>
                </c:pt>
                <c:pt idx="411">
                  <c:v>0.44700000000000001</c:v>
                </c:pt>
                <c:pt idx="412">
                  <c:v>0.45900000000000002</c:v>
                </c:pt>
                <c:pt idx="413">
                  <c:v>0.47099999999999997</c:v>
                </c:pt>
                <c:pt idx="414">
                  <c:v>0.48299999999999998</c:v>
                </c:pt>
                <c:pt idx="415">
                  <c:v>0.495</c:v>
                </c:pt>
                <c:pt idx="416">
                  <c:v>0.50700000000000001</c:v>
                </c:pt>
                <c:pt idx="417">
                  <c:v>0.51800000000000002</c:v>
                </c:pt>
                <c:pt idx="418">
                  <c:v>0.52800000000000002</c:v>
                </c:pt>
                <c:pt idx="419">
                  <c:v>0.53800000000000003</c:v>
                </c:pt>
                <c:pt idx="420">
                  <c:v>0.54700000000000004</c:v>
                </c:pt>
                <c:pt idx="421">
                  <c:v>0.55400000000000005</c:v>
                </c:pt>
                <c:pt idx="422">
                  <c:v>0.56100000000000005</c:v>
                </c:pt>
                <c:pt idx="423">
                  <c:v>0.56699999999999995</c:v>
                </c:pt>
                <c:pt idx="424">
                  <c:v>0.57199999999999995</c:v>
                </c:pt>
                <c:pt idx="425">
                  <c:v>0.57499999999999996</c:v>
                </c:pt>
                <c:pt idx="426">
                  <c:v>0.57799999999999996</c:v>
                </c:pt>
                <c:pt idx="427">
                  <c:v>0.57999999999999996</c:v>
                </c:pt>
                <c:pt idx="428">
                  <c:v>0.58099999999999996</c:v>
                </c:pt>
                <c:pt idx="429">
                  <c:v>0.58099999999999996</c:v>
                </c:pt>
                <c:pt idx="430">
                  <c:v>0.58099999999999996</c:v>
                </c:pt>
                <c:pt idx="431">
                  <c:v>0.57999999999999996</c:v>
                </c:pt>
                <c:pt idx="432">
                  <c:v>0.57899999999999996</c:v>
                </c:pt>
                <c:pt idx="433">
                  <c:v>0.57799999999999996</c:v>
                </c:pt>
                <c:pt idx="434">
                  <c:v>0.57699999999999996</c:v>
                </c:pt>
                <c:pt idx="435">
                  <c:v>0.57499999999999996</c:v>
                </c:pt>
                <c:pt idx="436">
                  <c:v>0.57299999999999995</c:v>
                </c:pt>
                <c:pt idx="437">
                  <c:v>0.57099999999999995</c:v>
                </c:pt>
                <c:pt idx="438">
                  <c:v>0.56899999999999995</c:v>
                </c:pt>
                <c:pt idx="439">
                  <c:v>0.56599999999999995</c:v>
                </c:pt>
                <c:pt idx="440">
                  <c:v>0.56299999999999994</c:v>
                </c:pt>
                <c:pt idx="441">
                  <c:v>0.56000000000000005</c:v>
                </c:pt>
                <c:pt idx="442">
                  <c:v>0.55600000000000005</c:v>
                </c:pt>
                <c:pt idx="443">
                  <c:v>0.55200000000000005</c:v>
                </c:pt>
                <c:pt idx="444">
                  <c:v>0.54600000000000004</c:v>
                </c:pt>
                <c:pt idx="445">
                  <c:v>0.54100000000000004</c:v>
                </c:pt>
                <c:pt idx="446">
                  <c:v>0.53500000000000003</c:v>
                </c:pt>
                <c:pt idx="447">
                  <c:v>0.52800000000000002</c:v>
                </c:pt>
                <c:pt idx="448">
                  <c:v>0.52100000000000002</c:v>
                </c:pt>
                <c:pt idx="449">
                  <c:v>0.51400000000000001</c:v>
                </c:pt>
                <c:pt idx="450">
                  <c:v>0.50700000000000001</c:v>
                </c:pt>
                <c:pt idx="451">
                  <c:v>0.5</c:v>
                </c:pt>
                <c:pt idx="452">
                  <c:v>0.49399999999999999</c:v>
                </c:pt>
                <c:pt idx="453">
                  <c:v>0.48899999999999999</c:v>
                </c:pt>
                <c:pt idx="454">
                  <c:v>0.48599999999999999</c:v>
                </c:pt>
                <c:pt idx="455">
                  <c:v>0.48299999999999998</c:v>
                </c:pt>
                <c:pt idx="456">
                  <c:v>0.48199999999999998</c:v>
                </c:pt>
                <c:pt idx="457">
                  <c:v>0.48299999999999998</c:v>
                </c:pt>
                <c:pt idx="458">
                  <c:v>0.48499999999999999</c:v>
                </c:pt>
                <c:pt idx="459">
                  <c:v>0.48899999999999999</c:v>
                </c:pt>
                <c:pt idx="460">
                  <c:v>0.495</c:v>
                </c:pt>
                <c:pt idx="461">
                  <c:v>0.503</c:v>
                </c:pt>
                <c:pt idx="462">
                  <c:v>0.51300000000000001</c:v>
                </c:pt>
                <c:pt idx="463">
                  <c:v>0.52500000000000002</c:v>
                </c:pt>
                <c:pt idx="464">
                  <c:v>0.53900000000000003</c:v>
                </c:pt>
                <c:pt idx="465">
                  <c:v>0.55500000000000005</c:v>
                </c:pt>
                <c:pt idx="466">
                  <c:v>0.57399999999999995</c:v>
                </c:pt>
                <c:pt idx="467">
                  <c:v>0.59599999999999997</c:v>
                </c:pt>
                <c:pt idx="468">
                  <c:v>0.622</c:v>
                </c:pt>
                <c:pt idx="469">
                  <c:v>0.65300000000000002</c:v>
                </c:pt>
                <c:pt idx="470">
                  <c:v>0.68700000000000006</c:v>
                </c:pt>
                <c:pt idx="471">
                  <c:v>0.72799999999999998</c:v>
                </c:pt>
                <c:pt idx="472">
                  <c:v>0.77500000000000002</c:v>
                </c:pt>
                <c:pt idx="473">
                  <c:v>0.83</c:v>
                </c:pt>
                <c:pt idx="474">
                  <c:v>0.89400000000000002</c:v>
                </c:pt>
                <c:pt idx="475">
                  <c:v>0.96499999999999997</c:v>
                </c:pt>
                <c:pt idx="476">
                  <c:v>1.044</c:v>
                </c:pt>
                <c:pt idx="477">
                  <c:v>1.1299999999999999</c:v>
                </c:pt>
                <c:pt idx="478">
                  <c:v>1.2250000000000001</c:v>
                </c:pt>
                <c:pt idx="479">
                  <c:v>1.3009999999999999</c:v>
                </c:pt>
                <c:pt idx="480">
                  <c:v>1.375</c:v>
                </c:pt>
              </c:numCache>
            </c:numRef>
          </c:yVal>
          <c:smooth val="1"/>
          <c:extLst xmlns:c15="http://schemas.microsoft.com/office/drawing/2012/chart">
            <c:ext xmlns:c16="http://schemas.microsoft.com/office/drawing/2014/chart" uri="{C3380CC4-5D6E-409C-BE32-E72D297353CC}">
              <c16:uniqueId val="{00000000-AF63-4D21-8E9E-8ED987C04AD3}"/>
            </c:ext>
          </c:extLst>
        </c:ser>
        <c:ser>
          <c:idx val="2"/>
          <c:order val="3"/>
          <c:tx>
            <c:strRef>
              <c:f>文章选用!$D$1</c:f>
              <c:strCache>
                <c:ptCount val="1"/>
                <c:pt idx="0">
                  <c:v>Dil-PNC</c:v>
                </c:pt>
              </c:strCache>
            </c:strRef>
          </c:tx>
          <c:spPr>
            <a:ln w="25400" cap="rnd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xVal>
            <c:numRef>
              <c:f>文章选用!$A$2:$A$482</c:f>
              <c:numCache>
                <c:formatCode>General</c:formatCode>
                <c:ptCount val="481"/>
                <c:pt idx="0">
                  <c:v>700</c:v>
                </c:pt>
                <c:pt idx="1">
                  <c:v>699</c:v>
                </c:pt>
                <c:pt idx="2">
                  <c:v>698</c:v>
                </c:pt>
                <c:pt idx="3">
                  <c:v>697</c:v>
                </c:pt>
                <c:pt idx="4">
                  <c:v>696</c:v>
                </c:pt>
                <c:pt idx="5">
                  <c:v>695</c:v>
                </c:pt>
                <c:pt idx="6">
                  <c:v>694</c:v>
                </c:pt>
                <c:pt idx="7">
                  <c:v>693</c:v>
                </c:pt>
                <c:pt idx="8">
                  <c:v>692</c:v>
                </c:pt>
                <c:pt idx="9">
                  <c:v>691</c:v>
                </c:pt>
                <c:pt idx="10">
                  <c:v>690</c:v>
                </c:pt>
                <c:pt idx="11">
                  <c:v>689</c:v>
                </c:pt>
                <c:pt idx="12">
                  <c:v>688</c:v>
                </c:pt>
                <c:pt idx="13">
                  <c:v>687</c:v>
                </c:pt>
                <c:pt idx="14">
                  <c:v>686</c:v>
                </c:pt>
                <c:pt idx="15">
                  <c:v>685</c:v>
                </c:pt>
                <c:pt idx="16">
                  <c:v>684</c:v>
                </c:pt>
                <c:pt idx="17">
                  <c:v>683</c:v>
                </c:pt>
                <c:pt idx="18">
                  <c:v>682</c:v>
                </c:pt>
                <c:pt idx="19">
                  <c:v>681</c:v>
                </c:pt>
                <c:pt idx="20">
                  <c:v>680</c:v>
                </c:pt>
                <c:pt idx="21">
                  <c:v>679</c:v>
                </c:pt>
                <c:pt idx="22">
                  <c:v>678</c:v>
                </c:pt>
                <c:pt idx="23">
                  <c:v>677</c:v>
                </c:pt>
                <c:pt idx="24">
                  <c:v>676</c:v>
                </c:pt>
                <c:pt idx="25">
                  <c:v>675</c:v>
                </c:pt>
                <c:pt idx="26">
                  <c:v>674</c:v>
                </c:pt>
                <c:pt idx="27">
                  <c:v>673</c:v>
                </c:pt>
                <c:pt idx="28">
                  <c:v>672</c:v>
                </c:pt>
                <c:pt idx="29">
                  <c:v>671</c:v>
                </c:pt>
                <c:pt idx="30">
                  <c:v>670</c:v>
                </c:pt>
                <c:pt idx="31">
                  <c:v>669</c:v>
                </c:pt>
                <c:pt idx="32">
                  <c:v>668</c:v>
                </c:pt>
                <c:pt idx="33">
                  <c:v>667</c:v>
                </c:pt>
                <c:pt idx="34">
                  <c:v>666</c:v>
                </c:pt>
                <c:pt idx="35">
                  <c:v>665</c:v>
                </c:pt>
                <c:pt idx="36">
                  <c:v>664</c:v>
                </c:pt>
                <c:pt idx="37">
                  <c:v>663</c:v>
                </c:pt>
                <c:pt idx="38">
                  <c:v>662</c:v>
                </c:pt>
                <c:pt idx="39">
                  <c:v>661</c:v>
                </c:pt>
                <c:pt idx="40">
                  <c:v>660</c:v>
                </c:pt>
                <c:pt idx="41">
                  <c:v>659</c:v>
                </c:pt>
                <c:pt idx="42">
                  <c:v>658</c:v>
                </c:pt>
                <c:pt idx="43">
                  <c:v>657</c:v>
                </c:pt>
                <c:pt idx="44">
                  <c:v>656</c:v>
                </c:pt>
                <c:pt idx="45">
                  <c:v>655</c:v>
                </c:pt>
                <c:pt idx="46">
                  <c:v>654</c:v>
                </c:pt>
                <c:pt idx="47">
                  <c:v>653</c:v>
                </c:pt>
                <c:pt idx="48">
                  <c:v>652</c:v>
                </c:pt>
                <c:pt idx="49">
                  <c:v>651</c:v>
                </c:pt>
                <c:pt idx="50">
                  <c:v>650</c:v>
                </c:pt>
                <c:pt idx="51">
                  <c:v>649</c:v>
                </c:pt>
                <c:pt idx="52">
                  <c:v>648</c:v>
                </c:pt>
                <c:pt idx="53">
                  <c:v>647</c:v>
                </c:pt>
                <c:pt idx="54">
                  <c:v>646</c:v>
                </c:pt>
                <c:pt idx="55">
                  <c:v>645</c:v>
                </c:pt>
                <c:pt idx="56">
                  <c:v>644</c:v>
                </c:pt>
                <c:pt idx="57">
                  <c:v>643</c:v>
                </c:pt>
                <c:pt idx="58">
                  <c:v>642</c:v>
                </c:pt>
                <c:pt idx="59">
                  <c:v>641</c:v>
                </c:pt>
                <c:pt idx="60">
                  <c:v>640</c:v>
                </c:pt>
                <c:pt idx="61">
                  <c:v>639</c:v>
                </c:pt>
                <c:pt idx="62">
                  <c:v>638</c:v>
                </c:pt>
                <c:pt idx="63">
                  <c:v>637</c:v>
                </c:pt>
                <c:pt idx="64">
                  <c:v>636</c:v>
                </c:pt>
                <c:pt idx="65">
                  <c:v>635</c:v>
                </c:pt>
                <c:pt idx="66">
                  <c:v>634</c:v>
                </c:pt>
                <c:pt idx="67">
                  <c:v>633</c:v>
                </c:pt>
                <c:pt idx="68">
                  <c:v>632</c:v>
                </c:pt>
                <c:pt idx="69">
                  <c:v>631</c:v>
                </c:pt>
                <c:pt idx="70">
                  <c:v>630</c:v>
                </c:pt>
                <c:pt idx="71">
                  <c:v>629</c:v>
                </c:pt>
                <c:pt idx="72">
                  <c:v>628</c:v>
                </c:pt>
                <c:pt idx="73">
                  <c:v>627</c:v>
                </c:pt>
                <c:pt idx="74">
                  <c:v>626</c:v>
                </c:pt>
                <c:pt idx="75">
                  <c:v>625</c:v>
                </c:pt>
                <c:pt idx="76">
                  <c:v>624</c:v>
                </c:pt>
                <c:pt idx="77">
                  <c:v>623</c:v>
                </c:pt>
                <c:pt idx="78">
                  <c:v>622</c:v>
                </c:pt>
                <c:pt idx="79">
                  <c:v>621</c:v>
                </c:pt>
                <c:pt idx="80">
                  <c:v>620</c:v>
                </c:pt>
                <c:pt idx="81">
                  <c:v>619</c:v>
                </c:pt>
                <c:pt idx="82">
                  <c:v>618</c:v>
                </c:pt>
                <c:pt idx="83">
                  <c:v>617</c:v>
                </c:pt>
                <c:pt idx="84">
                  <c:v>616</c:v>
                </c:pt>
                <c:pt idx="85">
                  <c:v>615</c:v>
                </c:pt>
                <c:pt idx="86">
                  <c:v>614</c:v>
                </c:pt>
                <c:pt idx="87">
                  <c:v>613</c:v>
                </c:pt>
                <c:pt idx="88">
                  <c:v>612</c:v>
                </c:pt>
                <c:pt idx="89">
                  <c:v>611</c:v>
                </c:pt>
                <c:pt idx="90">
                  <c:v>610</c:v>
                </c:pt>
                <c:pt idx="91">
                  <c:v>609</c:v>
                </c:pt>
                <c:pt idx="92">
                  <c:v>608</c:v>
                </c:pt>
                <c:pt idx="93">
                  <c:v>607</c:v>
                </c:pt>
                <c:pt idx="94">
                  <c:v>606</c:v>
                </c:pt>
                <c:pt idx="95">
                  <c:v>605</c:v>
                </c:pt>
                <c:pt idx="96">
                  <c:v>604</c:v>
                </c:pt>
                <c:pt idx="97">
                  <c:v>603</c:v>
                </c:pt>
                <c:pt idx="98">
                  <c:v>602</c:v>
                </c:pt>
                <c:pt idx="99">
                  <c:v>601</c:v>
                </c:pt>
                <c:pt idx="100">
                  <c:v>600</c:v>
                </c:pt>
                <c:pt idx="101">
                  <c:v>599</c:v>
                </c:pt>
                <c:pt idx="102">
                  <c:v>598</c:v>
                </c:pt>
                <c:pt idx="103">
                  <c:v>597</c:v>
                </c:pt>
                <c:pt idx="104">
                  <c:v>596</c:v>
                </c:pt>
                <c:pt idx="105">
                  <c:v>595</c:v>
                </c:pt>
                <c:pt idx="106">
                  <c:v>594</c:v>
                </c:pt>
                <c:pt idx="107">
                  <c:v>593</c:v>
                </c:pt>
                <c:pt idx="108">
                  <c:v>592</c:v>
                </c:pt>
                <c:pt idx="109">
                  <c:v>591</c:v>
                </c:pt>
                <c:pt idx="110">
                  <c:v>590</c:v>
                </c:pt>
                <c:pt idx="111">
                  <c:v>589</c:v>
                </c:pt>
                <c:pt idx="112">
                  <c:v>588</c:v>
                </c:pt>
                <c:pt idx="113">
                  <c:v>587</c:v>
                </c:pt>
                <c:pt idx="114">
                  <c:v>586</c:v>
                </c:pt>
                <c:pt idx="115">
                  <c:v>585</c:v>
                </c:pt>
                <c:pt idx="116">
                  <c:v>584</c:v>
                </c:pt>
                <c:pt idx="117">
                  <c:v>583</c:v>
                </c:pt>
                <c:pt idx="118">
                  <c:v>582</c:v>
                </c:pt>
                <c:pt idx="119">
                  <c:v>581</c:v>
                </c:pt>
                <c:pt idx="120">
                  <c:v>580</c:v>
                </c:pt>
                <c:pt idx="121">
                  <c:v>579</c:v>
                </c:pt>
                <c:pt idx="122">
                  <c:v>578</c:v>
                </c:pt>
                <c:pt idx="123">
                  <c:v>577</c:v>
                </c:pt>
                <c:pt idx="124">
                  <c:v>576</c:v>
                </c:pt>
                <c:pt idx="125">
                  <c:v>575</c:v>
                </c:pt>
                <c:pt idx="126">
                  <c:v>574</c:v>
                </c:pt>
                <c:pt idx="127">
                  <c:v>573</c:v>
                </c:pt>
                <c:pt idx="128">
                  <c:v>572</c:v>
                </c:pt>
                <c:pt idx="129">
                  <c:v>571</c:v>
                </c:pt>
                <c:pt idx="130">
                  <c:v>570</c:v>
                </c:pt>
                <c:pt idx="131">
                  <c:v>569</c:v>
                </c:pt>
                <c:pt idx="132">
                  <c:v>568</c:v>
                </c:pt>
                <c:pt idx="133">
                  <c:v>567</c:v>
                </c:pt>
                <c:pt idx="134">
                  <c:v>566</c:v>
                </c:pt>
                <c:pt idx="135">
                  <c:v>565</c:v>
                </c:pt>
                <c:pt idx="136">
                  <c:v>564</c:v>
                </c:pt>
                <c:pt idx="137">
                  <c:v>563</c:v>
                </c:pt>
                <c:pt idx="138">
                  <c:v>562</c:v>
                </c:pt>
                <c:pt idx="139">
                  <c:v>561</c:v>
                </c:pt>
                <c:pt idx="140">
                  <c:v>560</c:v>
                </c:pt>
                <c:pt idx="141">
                  <c:v>559</c:v>
                </c:pt>
                <c:pt idx="142">
                  <c:v>558</c:v>
                </c:pt>
                <c:pt idx="143">
                  <c:v>557</c:v>
                </c:pt>
                <c:pt idx="144">
                  <c:v>556</c:v>
                </c:pt>
                <c:pt idx="145">
                  <c:v>555</c:v>
                </c:pt>
                <c:pt idx="146">
                  <c:v>554</c:v>
                </c:pt>
                <c:pt idx="147">
                  <c:v>553</c:v>
                </c:pt>
                <c:pt idx="148">
                  <c:v>552</c:v>
                </c:pt>
                <c:pt idx="149">
                  <c:v>551</c:v>
                </c:pt>
                <c:pt idx="150">
                  <c:v>550</c:v>
                </c:pt>
                <c:pt idx="151">
                  <c:v>549</c:v>
                </c:pt>
                <c:pt idx="152">
                  <c:v>548</c:v>
                </c:pt>
                <c:pt idx="153">
                  <c:v>547</c:v>
                </c:pt>
                <c:pt idx="154">
                  <c:v>546</c:v>
                </c:pt>
                <c:pt idx="155">
                  <c:v>545</c:v>
                </c:pt>
                <c:pt idx="156">
                  <c:v>544</c:v>
                </c:pt>
                <c:pt idx="157">
                  <c:v>543</c:v>
                </c:pt>
                <c:pt idx="158">
                  <c:v>542</c:v>
                </c:pt>
                <c:pt idx="159">
                  <c:v>541</c:v>
                </c:pt>
                <c:pt idx="160">
                  <c:v>540</c:v>
                </c:pt>
                <c:pt idx="161">
                  <c:v>539</c:v>
                </c:pt>
                <c:pt idx="162">
                  <c:v>538</c:v>
                </c:pt>
                <c:pt idx="163">
                  <c:v>537</c:v>
                </c:pt>
                <c:pt idx="164">
                  <c:v>536</c:v>
                </c:pt>
                <c:pt idx="165">
                  <c:v>535</c:v>
                </c:pt>
                <c:pt idx="166">
                  <c:v>534</c:v>
                </c:pt>
                <c:pt idx="167">
                  <c:v>533</c:v>
                </c:pt>
                <c:pt idx="168">
                  <c:v>532</c:v>
                </c:pt>
                <c:pt idx="169">
                  <c:v>531</c:v>
                </c:pt>
                <c:pt idx="170">
                  <c:v>530</c:v>
                </c:pt>
                <c:pt idx="171">
                  <c:v>529</c:v>
                </c:pt>
                <c:pt idx="172">
                  <c:v>528</c:v>
                </c:pt>
                <c:pt idx="173">
                  <c:v>527</c:v>
                </c:pt>
                <c:pt idx="174">
                  <c:v>526</c:v>
                </c:pt>
                <c:pt idx="175">
                  <c:v>525</c:v>
                </c:pt>
                <c:pt idx="176">
                  <c:v>524</c:v>
                </c:pt>
                <c:pt idx="177">
                  <c:v>523</c:v>
                </c:pt>
                <c:pt idx="178">
                  <c:v>522</c:v>
                </c:pt>
                <c:pt idx="179">
                  <c:v>521</c:v>
                </c:pt>
                <c:pt idx="180">
                  <c:v>520</c:v>
                </c:pt>
                <c:pt idx="181">
                  <c:v>519</c:v>
                </c:pt>
                <c:pt idx="182">
                  <c:v>518</c:v>
                </c:pt>
                <c:pt idx="183">
                  <c:v>517</c:v>
                </c:pt>
                <c:pt idx="184">
                  <c:v>516</c:v>
                </c:pt>
                <c:pt idx="185">
                  <c:v>515</c:v>
                </c:pt>
                <c:pt idx="186">
                  <c:v>514</c:v>
                </c:pt>
                <c:pt idx="187">
                  <c:v>513</c:v>
                </c:pt>
                <c:pt idx="188">
                  <c:v>512</c:v>
                </c:pt>
                <c:pt idx="189">
                  <c:v>511</c:v>
                </c:pt>
                <c:pt idx="190">
                  <c:v>510</c:v>
                </c:pt>
                <c:pt idx="191">
                  <c:v>509</c:v>
                </c:pt>
                <c:pt idx="192">
                  <c:v>508</c:v>
                </c:pt>
                <c:pt idx="193">
                  <c:v>507</c:v>
                </c:pt>
                <c:pt idx="194">
                  <c:v>506</c:v>
                </c:pt>
                <c:pt idx="195">
                  <c:v>505</c:v>
                </c:pt>
                <c:pt idx="196">
                  <c:v>504</c:v>
                </c:pt>
                <c:pt idx="197">
                  <c:v>503</c:v>
                </c:pt>
                <c:pt idx="198">
                  <c:v>502</c:v>
                </c:pt>
                <c:pt idx="199">
                  <c:v>501</c:v>
                </c:pt>
                <c:pt idx="200">
                  <c:v>500</c:v>
                </c:pt>
                <c:pt idx="201">
                  <c:v>499</c:v>
                </c:pt>
                <c:pt idx="202">
                  <c:v>498</c:v>
                </c:pt>
                <c:pt idx="203">
                  <c:v>497</c:v>
                </c:pt>
                <c:pt idx="204">
                  <c:v>496</c:v>
                </c:pt>
                <c:pt idx="205">
                  <c:v>495</c:v>
                </c:pt>
                <c:pt idx="206">
                  <c:v>494</c:v>
                </c:pt>
                <c:pt idx="207">
                  <c:v>493</c:v>
                </c:pt>
                <c:pt idx="208">
                  <c:v>492</c:v>
                </c:pt>
                <c:pt idx="209">
                  <c:v>491</c:v>
                </c:pt>
                <c:pt idx="210">
                  <c:v>490</c:v>
                </c:pt>
                <c:pt idx="211">
                  <c:v>489</c:v>
                </c:pt>
                <c:pt idx="212">
                  <c:v>488</c:v>
                </c:pt>
                <c:pt idx="213">
                  <c:v>487</c:v>
                </c:pt>
                <c:pt idx="214">
                  <c:v>486</c:v>
                </c:pt>
                <c:pt idx="215">
                  <c:v>485</c:v>
                </c:pt>
                <c:pt idx="216">
                  <c:v>484</c:v>
                </c:pt>
                <c:pt idx="217">
                  <c:v>483</c:v>
                </c:pt>
                <c:pt idx="218">
                  <c:v>482</c:v>
                </c:pt>
                <c:pt idx="219">
                  <c:v>481</c:v>
                </c:pt>
                <c:pt idx="220">
                  <c:v>480</c:v>
                </c:pt>
                <c:pt idx="221">
                  <c:v>479</c:v>
                </c:pt>
                <c:pt idx="222">
                  <c:v>478</c:v>
                </c:pt>
                <c:pt idx="223">
                  <c:v>477</c:v>
                </c:pt>
                <c:pt idx="224">
                  <c:v>476</c:v>
                </c:pt>
                <c:pt idx="225">
                  <c:v>475</c:v>
                </c:pt>
                <c:pt idx="226">
                  <c:v>474</c:v>
                </c:pt>
                <c:pt idx="227">
                  <c:v>473</c:v>
                </c:pt>
                <c:pt idx="228">
                  <c:v>472</c:v>
                </c:pt>
                <c:pt idx="229">
                  <c:v>471</c:v>
                </c:pt>
                <c:pt idx="230">
                  <c:v>470</c:v>
                </c:pt>
                <c:pt idx="231">
                  <c:v>469</c:v>
                </c:pt>
                <c:pt idx="232">
                  <c:v>468</c:v>
                </c:pt>
                <c:pt idx="233">
                  <c:v>467</c:v>
                </c:pt>
                <c:pt idx="234">
                  <c:v>466</c:v>
                </c:pt>
                <c:pt idx="235">
                  <c:v>465</c:v>
                </c:pt>
                <c:pt idx="236">
                  <c:v>464</c:v>
                </c:pt>
                <c:pt idx="237">
                  <c:v>463</c:v>
                </c:pt>
                <c:pt idx="238">
                  <c:v>462</c:v>
                </c:pt>
                <c:pt idx="239">
                  <c:v>461</c:v>
                </c:pt>
                <c:pt idx="240">
                  <c:v>460</c:v>
                </c:pt>
                <c:pt idx="241">
                  <c:v>459</c:v>
                </c:pt>
                <c:pt idx="242">
                  <c:v>458</c:v>
                </c:pt>
                <c:pt idx="243">
                  <c:v>457</c:v>
                </c:pt>
                <c:pt idx="244">
                  <c:v>456</c:v>
                </c:pt>
                <c:pt idx="245">
                  <c:v>455</c:v>
                </c:pt>
                <c:pt idx="246">
                  <c:v>454</c:v>
                </c:pt>
                <c:pt idx="247">
                  <c:v>453</c:v>
                </c:pt>
                <c:pt idx="248">
                  <c:v>452</c:v>
                </c:pt>
                <c:pt idx="249">
                  <c:v>451</c:v>
                </c:pt>
                <c:pt idx="250">
                  <c:v>450</c:v>
                </c:pt>
                <c:pt idx="251">
                  <c:v>449</c:v>
                </c:pt>
                <c:pt idx="252">
                  <c:v>448</c:v>
                </c:pt>
                <c:pt idx="253">
                  <c:v>447</c:v>
                </c:pt>
                <c:pt idx="254">
                  <c:v>446</c:v>
                </c:pt>
                <c:pt idx="255">
                  <c:v>445</c:v>
                </c:pt>
                <c:pt idx="256">
                  <c:v>444</c:v>
                </c:pt>
                <c:pt idx="257">
                  <c:v>443</c:v>
                </c:pt>
                <c:pt idx="258">
                  <c:v>442</c:v>
                </c:pt>
                <c:pt idx="259">
                  <c:v>441</c:v>
                </c:pt>
                <c:pt idx="260">
                  <c:v>440</c:v>
                </c:pt>
                <c:pt idx="261">
                  <c:v>439</c:v>
                </c:pt>
                <c:pt idx="262">
                  <c:v>438</c:v>
                </c:pt>
                <c:pt idx="263">
                  <c:v>437</c:v>
                </c:pt>
                <c:pt idx="264">
                  <c:v>436</c:v>
                </c:pt>
                <c:pt idx="265">
                  <c:v>435</c:v>
                </c:pt>
                <c:pt idx="266">
                  <c:v>434</c:v>
                </c:pt>
                <c:pt idx="267">
                  <c:v>433</c:v>
                </c:pt>
                <c:pt idx="268">
                  <c:v>432</c:v>
                </c:pt>
                <c:pt idx="269">
                  <c:v>431</c:v>
                </c:pt>
                <c:pt idx="270">
                  <c:v>430</c:v>
                </c:pt>
                <c:pt idx="271">
                  <c:v>429</c:v>
                </c:pt>
                <c:pt idx="272">
                  <c:v>428</c:v>
                </c:pt>
                <c:pt idx="273">
                  <c:v>427</c:v>
                </c:pt>
                <c:pt idx="274">
                  <c:v>426</c:v>
                </c:pt>
                <c:pt idx="275">
                  <c:v>425</c:v>
                </c:pt>
                <c:pt idx="276">
                  <c:v>424</c:v>
                </c:pt>
                <c:pt idx="277">
                  <c:v>423</c:v>
                </c:pt>
                <c:pt idx="278">
                  <c:v>422</c:v>
                </c:pt>
                <c:pt idx="279">
                  <c:v>421</c:v>
                </c:pt>
                <c:pt idx="280">
                  <c:v>420</c:v>
                </c:pt>
                <c:pt idx="281">
                  <c:v>419</c:v>
                </c:pt>
                <c:pt idx="282">
                  <c:v>418</c:v>
                </c:pt>
                <c:pt idx="283">
                  <c:v>417</c:v>
                </c:pt>
                <c:pt idx="284">
                  <c:v>416</c:v>
                </c:pt>
                <c:pt idx="285">
                  <c:v>415</c:v>
                </c:pt>
                <c:pt idx="286">
                  <c:v>414</c:v>
                </c:pt>
                <c:pt idx="287">
                  <c:v>413</c:v>
                </c:pt>
                <c:pt idx="288">
                  <c:v>412</c:v>
                </c:pt>
                <c:pt idx="289">
                  <c:v>411</c:v>
                </c:pt>
                <c:pt idx="290">
                  <c:v>410</c:v>
                </c:pt>
                <c:pt idx="291">
                  <c:v>409</c:v>
                </c:pt>
                <c:pt idx="292">
                  <c:v>408</c:v>
                </c:pt>
                <c:pt idx="293">
                  <c:v>407</c:v>
                </c:pt>
                <c:pt idx="294">
                  <c:v>406</c:v>
                </c:pt>
                <c:pt idx="295">
                  <c:v>405</c:v>
                </c:pt>
                <c:pt idx="296">
                  <c:v>404</c:v>
                </c:pt>
                <c:pt idx="297">
                  <c:v>403</c:v>
                </c:pt>
                <c:pt idx="298">
                  <c:v>402</c:v>
                </c:pt>
                <c:pt idx="299">
                  <c:v>401</c:v>
                </c:pt>
                <c:pt idx="300">
                  <c:v>400</c:v>
                </c:pt>
                <c:pt idx="301">
                  <c:v>399</c:v>
                </c:pt>
                <c:pt idx="302">
                  <c:v>398</c:v>
                </c:pt>
                <c:pt idx="303">
                  <c:v>397</c:v>
                </c:pt>
                <c:pt idx="304">
                  <c:v>396</c:v>
                </c:pt>
                <c:pt idx="305">
                  <c:v>395</c:v>
                </c:pt>
                <c:pt idx="306">
                  <c:v>394</c:v>
                </c:pt>
                <c:pt idx="307">
                  <c:v>393</c:v>
                </c:pt>
                <c:pt idx="308">
                  <c:v>392</c:v>
                </c:pt>
                <c:pt idx="309">
                  <c:v>391</c:v>
                </c:pt>
                <c:pt idx="310">
                  <c:v>390</c:v>
                </c:pt>
                <c:pt idx="311">
                  <c:v>389</c:v>
                </c:pt>
                <c:pt idx="312">
                  <c:v>388</c:v>
                </c:pt>
                <c:pt idx="313">
                  <c:v>387</c:v>
                </c:pt>
                <c:pt idx="314">
                  <c:v>386</c:v>
                </c:pt>
                <c:pt idx="315">
                  <c:v>385</c:v>
                </c:pt>
                <c:pt idx="316">
                  <c:v>384</c:v>
                </c:pt>
                <c:pt idx="317">
                  <c:v>383</c:v>
                </c:pt>
                <c:pt idx="318">
                  <c:v>382</c:v>
                </c:pt>
                <c:pt idx="319">
                  <c:v>381</c:v>
                </c:pt>
                <c:pt idx="320">
                  <c:v>380</c:v>
                </c:pt>
                <c:pt idx="321">
                  <c:v>379</c:v>
                </c:pt>
                <c:pt idx="322">
                  <c:v>378</c:v>
                </c:pt>
                <c:pt idx="323">
                  <c:v>377</c:v>
                </c:pt>
                <c:pt idx="324">
                  <c:v>376</c:v>
                </c:pt>
                <c:pt idx="325">
                  <c:v>375</c:v>
                </c:pt>
                <c:pt idx="326">
                  <c:v>374</c:v>
                </c:pt>
                <c:pt idx="327">
                  <c:v>373</c:v>
                </c:pt>
                <c:pt idx="328">
                  <c:v>372</c:v>
                </c:pt>
                <c:pt idx="329">
                  <c:v>371</c:v>
                </c:pt>
                <c:pt idx="330">
                  <c:v>370</c:v>
                </c:pt>
                <c:pt idx="331">
                  <c:v>369</c:v>
                </c:pt>
                <c:pt idx="332">
                  <c:v>368</c:v>
                </c:pt>
                <c:pt idx="333">
                  <c:v>367</c:v>
                </c:pt>
                <c:pt idx="334">
                  <c:v>366</c:v>
                </c:pt>
                <c:pt idx="335">
                  <c:v>365</c:v>
                </c:pt>
                <c:pt idx="336">
                  <c:v>364</c:v>
                </c:pt>
                <c:pt idx="337">
                  <c:v>363</c:v>
                </c:pt>
                <c:pt idx="338">
                  <c:v>362</c:v>
                </c:pt>
                <c:pt idx="339">
                  <c:v>361</c:v>
                </c:pt>
                <c:pt idx="340">
                  <c:v>360</c:v>
                </c:pt>
                <c:pt idx="341">
                  <c:v>359</c:v>
                </c:pt>
                <c:pt idx="342">
                  <c:v>358</c:v>
                </c:pt>
                <c:pt idx="343">
                  <c:v>357</c:v>
                </c:pt>
                <c:pt idx="344">
                  <c:v>356</c:v>
                </c:pt>
                <c:pt idx="345">
                  <c:v>355</c:v>
                </c:pt>
                <c:pt idx="346">
                  <c:v>354</c:v>
                </c:pt>
                <c:pt idx="347">
                  <c:v>353</c:v>
                </c:pt>
                <c:pt idx="348">
                  <c:v>352</c:v>
                </c:pt>
                <c:pt idx="349">
                  <c:v>351</c:v>
                </c:pt>
                <c:pt idx="350">
                  <c:v>350</c:v>
                </c:pt>
                <c:pt idx="351">
                  <c:v>349</c:v>
                </c:pt>
                <c:pt idx="352">
                  <c:v>348</c:v>
                </c:pt>
                <c:pt idx="353">
                  <c:v>347</c:v>
                </c:pt>
                <c:pt idx="354">
                  <c:v>346</c:v>
                </c:pt>
                <c:pt idx="355">
                  <c:v>345</c:v>
                </c:pt>
                <c:pt idx="356">
                  <c:v>344</c:v>
                </c:pt>
                <c:pt idx="357">
                  <c:v>343</c:v>
                </c:pt>
                <c:pt idx="358">
                  <c:v>342</c:v>
                </c:pt>
                <c:pt idx="359">
                  <c:v>341</c:v>
                </c:pt>
                <c:pt idx="360">
                  <c:v>340</c:v>
                </c:pt>
                <c:pt idx="361">
                  <c:v>339</c:v>
                </c:pt>
                <c:pt idx="362">
                  <c:v>338</c:v>
                </c:pt>
                <c:pt idx="363">
                  <c:v>337</c:v>
                </c:pt>
                <c:pt idx="364">
                  <c:v>336</c:v>
                </c:pt>
                <c:pt idx="365">
                  <c:v>335</c:v>
                </c:pt>
                <c:pt idx="366">
                  <c:v>334</c:v>
                </c:pt>
                <c:pt idx="367">
                  <c:v>333</c:v>
                </c:pt>
                <c:pt idx="368">
                  <c:v>332</c:v>
                </c:pt>
                <c:pt idx="369">
                  <c:v>331</c:v>
                </c:pt>
                <c:pt idx="370">
                  <c:v>330</c:v>
                </c:pt>
                <c:pt idx="371">
                  <c:v>329</c:v>
                </c:pt>
                <c:pt idx="372">
                  <c:v>328</c:v>
                </c:pt>
                <c:pt idx="373">
                  <c:v>327</c:v>
                </c:pt>
                <c:pt idx="374">
                  <c:v>326</c:v>
                </c:pt>
                <c:pt idx="375">
                  <c:v>325</c:v>
                </c:pt>
                <c:pt idx="376">
                  <c:v>324</c:v>
                </c:pt>
                <c:pt idx="377">
                  <c:v>323</c:v>
                </c:pt>
                <c:pt idx="378">
                  <c:v>322</c:v>
                </c:pt>
                <c:pt idx="379">
                  <c:v>321</c:v>
                </c:pt>
                <c:pt idx="380">
                  <c:v>320</c:v>
                </c:pt>
                <c:pt idx="381">
                  <c:v>319</c:v>
                </c:pt>
                <c:pt idx="382">
                  <c:v>318</c:v>
                </c:pt>
                <c:pt idx="383">
                  <c:v>317</c:v>
                </c:pt>
                <c:pt idx="384">
                  <c:v>316</c:v>
                </c:pt>
                <c:pt idx="385">
                  <c:v>315</c:v>
                </c:pt>
                <c:pt idx="386">
                  <c:v>314</c:v>
                </c:pt>
                <c:pt idx="387">
                  <c:v>313</c:v>
                </c:pt>
                <c:pt idx="388">
                  <c:v>312</c:v>
                </c:pt>
                <c:pt idx="389">
                  <c:v>311</c:v>
                </c:pt>
                <c:pt idx="390">
                  <c:v>310</c:v>
                </c:pt>
                <c:pt idx="391">
                  <c:v>309</c:v>
                </c:pt>
                <c:pt idx="392">
                  <c:v>308</c:v>
                </c:pt>
                <c:pt idx="393">
                  <c:v>307</c:v>
                </c:pt>
                <c:pt idx="394">
                  <c:v>306</c:v>
                </c:pt>
                <c:pt idx="395">
                  <c:v>305</c:v>
                </c:pt>
                <c:pt idx="396">
                  <c:v>304</c:v>
                </c:pt>
                <c:pt idx="397">
                  <c:v>303</c:v>
                </c:pt>
                <c:pt idx="398">
                  <c:v>302</c:v>
                </c:pt>
                <c:pt idx="399">
                  <c:v>301</c:v>
                </c:pt>
                <c:pt idx="400">
                  <c:v>300</c:v>
                </c:pt>
                <c:pt idx="401">
                  <c:v>299</c:v>
                </c:pt>
                <c:pt idx="402">
                  <c:v>298</c:v>
                </c:pt>
                <c:pt idx="403">
                  <c:v>297</c:v>
                </c:pt>
                <c:pt idx="404">
                  <c:v>296</c:v>
                </c:pt>
                <c:pt idx="405">
                  <c:v>295</c:v>
                </c:pt>
                <c:pt idx="406">
                  <c:v>294</c:v>
                </c:pt>
                <c:pt idx="407">
                  <c:v>293</c:v>
                </c:pt>
                <c:pt idx="408">
                  <c:v>292</c:v>
                </c:pt>
                <c:pt idx="409">
                  <c:v>291</c:v>
                </c:pt>
                <c:pt idx="410">
                  <c:v>290</c:v>
                </c:pt>
                <c:pt idx="411">
                  <c:v>289</c:v>
                </c:pt>
                <c:pt idx="412">
                  <c:v>288</c:v>
                </c:pt>
                <c:pt idx="413">
                  <c:v>287</c:v>
                </c:pt>
                <c:pt idx="414">
                  <c:v>286</c:v>
                </c:pt>
                <c:pt idx="415">
                  <c:v>285</c:v>
                </c:pt>
                <c:pt idx="416">
                  <c:v>284</c:v>
                </c:pt>
                <c:pt idx="417">
                  <c:v>283</c:v>
                </c:pt>
                <c:pt idx="418">
                  <c:v>282</c:v>
                </c:pt>
                <c:pt idx="419">
                  <c:v>281</c:v>
                </c:pt>
                <c:pt idx="420">
                  <c:v>280</c:v>
                </c:pt>
                <c:pt idx="421">
                  <c:v>279</c:v>
                </c:pt>
                <c:pt idx="422">
                  <c:v>278</c:v>
                </c:pt>
                <c:pt idx="423">
                  <c:v>277</c:v>
                </c:pt>
                <c:pt idx="424">
                  <c:v>276</c:v>
                </c:pt>
                <c:pt idx="425">
                  <c:v>275</c:v>
                </c:pt>
                <c:pt idx="426">
                  <c:v>274</c:v>
                </c:pt>
                <c:pt idx="427">
                  <c:v>273</c:v>
                </c:pt>
                <c:pt idx="428">
                  <c:v>272</c:v>
                </c:pt>
                <c:pt idx="429">
                  <c:v>271</c:v>
                </c:pt>
                <c:pt idx="430">
                  <c:v>270</c:v>
                </c:pt>
                <c:pt idx="431">
                  <c:v>269</c:v>
                </c:pt>
                <c:pt idx="432">
                  <c:v>268</c:v>
                </c:pt>
                <c:pt idx="433">
                  <c:v>267</c:v>
                </c:pt>
                <c:pt idx="434">
                  <c:v>266</c:v>
                </c:pt>
                <c:pt idx="435">
                  <c:v>265</c:v>
                </c:pt>
                <c:pt idx="436">
                  <c:v>264</c:v>
                </c:pt>
                <c:pt idx="437">
                  <c:v>263</c:v>
                </c:pt>
                <c:pt idx="438">
                  <c:v>262</c:v>
                </c:pt>
                <c:pt idx="439">
                  <c:v>261</c:v>
                </c:pt>
                <c:pt idx="440">
                  <c:v>260</c:v>
                </c:pt>
                <c:pt idx="441">
                  <c:v>259</c:v>
                </c:pt>
                <c:pt idx="442">
                  <c:v>258</c:v>
                </c:pt>
                <c:pt idx="443">
                  <c:v>257</c:v>
                </c:pt>
                <c:pt idx="444">
                  <c:v>256</c:v>
                </c:pt>
                <c:pt idx="445">
                  <c:v>255</c:v>
                </c:pt>
                <c:pt idx="446">
                  <c:v>254</c:v>
                </c:pt>
                <c:pt idx="447">
                  <c:v>253</c:v>
                </c:pt>
                <c:pt idx="448">
                  <c:v>252</c:v>
                </c:pt>
                <c:pt idx="449">
                  <c:v>251</c:v>
                </c:pt>
                <c:pt idx="450">
                  <c:v>250</c:v>
                </c:pt>
                <c:pt idx="451">
                  <c:v>249</c:v>
                </c:pt>
                <c:pt idx="452">
                  <c:v>248</c:v>
                </c:pt>
                <c:pt idx="453">
                  <c:v>247</c:v>
                </c:pt>
                <c:pt idx="454">
                  <c:v>246</c:v>
                </c:pt>
                <c:pt idx="455">
                  <c:v>245</c:v>
                </c:pt>
                <c:pt idx="456">
                  <c:v>244</c:v>
                </c:pt>
                <c:pt idx="457">
                  <c:v>243</c:v>
                </c:pt>
                <c:pt idx="458">
                  <c:v>242</c:v>
                </c:pt>
                <c:pt idx="459">
                  <c:v>241</c:v>
                </c:pt>
                <c:pt idx="460">
                  <c:v>240</c:v>
                </c:pt>
                <c:pt idx="461">
                  <c:v>239</c:v>
                </c:pt>
                <c:pt idx="462">
                  <c:v>238</c:v>
                </c:pt>
                <c:pt idx="463">
                  <c:v>237</c:v>
                </c:pt>
                <c:pt idx="464">
                  <c:v>236</c:v>
                </c:pt>
                <c:pt idx="465">
                  <c:v>235</c:v>
                </c:pt>
                <c:pt idx="466">
                  <c:v>234</c:v>
                </c:pt>
                <c:pt idx="467">
                  <c:v>233</c:v>
                </c:pt>
                <c:pt idx="468">
                  <c:v>232</c:v>
                </c:pt>
                <c:pt idx="469">
                  <c:v>231</c:v>
                </c:pt>
                <c:pt idx="470">
                  <c:v>230</c:v>
                </c:pt>
                <c:pt idx="471">
                  <c:v>229</c:v>
                </c:pt>
                <c:pt idx="472">
                  <c:v>228</c:v>
                </c:pt>
                <c:pt idx="473">
                  <c:v>227</c:v>
                </c:pt>
                <c:pt idx="474">
                  <c:v>226</c:v>
                </c:pt>
                <c:pt idx="475">
                  <c:v>225</c:v>
                </c:pt>
                <c:pt idx="476">
                  <c:v>224</c:v>
                </c:pt>
                <c:pt idx="477">
                  <c:v>223</c:v>
                </c:pt>
                <c:pt idx="478">
                  <c:v>222</c:v>
                </c:pt>
                <c:pt idx="479">
                  <c:v>221</c:v>
                </c:pt>
                <c:pt idx="480">
                  <c:v>220</c:v>
                </c:pt>
              </c:numCache>
            </c:numRef>
          </c:xVal>
          <c:yVal>
            <c:numRef>
              <c:f>文章选用!$D$2:$D$482</c:f>
              <c:numCache>
                <c:formatCode>General</c:formatCode>
                <c:ptCount val="48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1E-3</c:v>
                </c:pt>
                <c:pt idx="27">
                  <c:v>1E-3</c:v>
                </c:pt>
                <c:pt idx="28">
                  <c:v>1E-3</c:v>
                </c:pt>
                <c:pt idx="29">
                  <c:v>1E-3</c:v>
                </c:pt>
                <c:pt idx="30">
                  <c:v>1E-3</c:v>
                </c:pt>
                <c:pt idx="31">
                  <c:v>1E-3</c:v>
                </c:pt>
                <c:pt idx="32">
                  <c:v>1E-3</c:v>
                </c:pt>
                <c:pt idx="33">
                  <c:v>1E-3</c:v>
                </c:pt>
                <c:pt idx="34">
                  <c:v>1E-3</c:v>
                </c:pt>
                <c:pt idx="35">
                  <c:v>1E-3</c:v>
                </c:pt>
                <c:pt idx="36">
                  <c:v>1E-3</c:v>
                </c:pt>
                <c:pt idx="37">
                  <c:v>1E-3</c:v>
                </c:pt>
                <c:pt idx="38">
                  <c:v>1E-3</c:v>
                </c:pt>
                <c:pt idx="39">
                  <c:v>1E-3</c:v>
                </c:pt>
                <c:pt idx="40">
                  <c:v>1E-3</c:v>
                </c:pt>
                <c:pt idx="41">
                  <c:v>1E-3</c:v>
                </c:pt>
                <c:pt idx="42">
                  <c:v>2E-3</c:v>
                </c:pt>
                <c:pt idx="43">
                  <c:v>2E-3</c:v>
                </c:pt>
                <c:pt idx="44">
                  <c:v>2E-3</c:v>
                </c:pt>
                <c:pt idx="45">
                  <c:v>2E-3</c:v>
                </c:pt>
                <c:pt idx="46">
                  <c:v>2E-3</c:v>
                </c:pt>
                <c:pt idx="47">
                  <c:v>2E-3</c:v>
                </c:pt>
                <c:pt idx="48">
                  <c:v>2E-3</c:v>
                </c:pt>
                <c:pt idx="49">
                  <c:v>2E-3</c:v>
                </c:pt>
                <c:pt idx="50">
                  <c:v>2E-3</c:v>
                </c:pt>
                <c:pt idx="51">
                  <c:v>2E-3</c:v>
                </c:pt>
                <c:pt idx="52">
                  <c:v>2E-3</c:v>
                </c:pt>
                <c:pt idx="53">
                  <c:v>2E-3</c:v>
                </c:pt>
                <c:pt idx="54">
                  <c:v>2E-3</c:v>
                </c:pt>
                <c:pt idx="55">
                  <c:v>2E-3</c:v>
                </c:pt>
                <c:pt idx="56">
                  <c:v>2E-3</c:v>
                </c:pt>
                <c:pt idx="57">
                  <c:v>2E-3</c:v>
                </c:pt>
                <c:pt idx="58">
                  <c:v>2E-3</c:v>
                </c:pt>
                <c:pt idx="59">
                  <c:v>2E-3</c:v>
                </c:pt>
                <c:pt idx="60">
                  <c:v>2E-3</c:v>
                </c:pt>
                <c:pt idx="61">
                  <c:v>2E-3</c:v>
                </c:pt>
                <c:pt idx="62">
                  <c:v>2E-3</c:v>
                </c:pt>
                <c:pt idx="63">
                  <c:v>2E-3</c:v>
                </c:pt>
                <c:pt idx="64">
                  <c:v>2E-3</c:v>
                </c:pt>
                <c:pt idx="65">
                  <c:v>2E-3</c:v>
                </c:pt>
                <c:pt idx="66">
                  <c:v>2E-3</c:v>
                </c:pt>
                <c:pt idx="67">
                  <c:v>2E-3</c:v>
                </c:pt>
                <c:pt idx="68">
                  <c:v>2E-3</c:v>
                </c:pt>
                <c:pt idx="69">
                  <c:v>2E-3</c:v>
                </c:pt>
                <c:pt idx="70">
                  <c:v>2E-3</c:v>
                </c:pt>
                <c:pt idx="71">
                  <c:v>2E-3</c:v>
                </c:pt>
                <c:pt idx="72">
                  <c:v>2E-3</c:v>
                </c:pt>
                <c:pt idx="73">
                  <c:v>2E-3</c:v>
                </c:pt>
                <c:pt idx="74">
                  <c:v>2E-3</c:v>
                </c:pt>
                <c:pt idx="75">
                  <c:v>2E-3</c:v>
                </c:pt>
                <c:pt idx="76">
                  <c:v>2E-3</c:v>
                </c:pt>
                <c:pt idx="77">
                  <c:v>2E-3</c:v>
                </c:pt>
                <c:pt idx="78">
                  <c:v>2E-3</c:v>
                </c:pt>
                <c:pt idx="79">
                  <c:v>2E-3</c:v>
                </c:pt>
                <c:pt idx="80">
                  <c:v>2E-3</c:v>
                </c:pt>
                <c:pt idx="81">
                  <c:v>2E-3</c:v>
                </c:pt>
                <c:pt idx="82">
                  <c:v>2E-3</c:v>
                </c:pt>
                <c:pt idx="83">
                  <c:v>2E-3</c:v>
                </c:pt>
                <c:pt idx="84">
                  <c:v>2E-3</c:v>
                </c:pt>
                <c:pt idx="85">
                  <c:v>2E-3</c:v>
                </c:pt>
                <c:pt idx="86">
                  <c:v>2E-3</c:v>
                </c:pt>
                <c:pt idx="87">
                  <c:v>3.0000000000000001E-3</c:v>
                </c:pt>
                <c:pt idx="88">
                  <c:v>3.0000000000000001E-3</c:v>
                </c:pt>
                <c:pt idx="89">
                  <c:v>3.0000000000000001E-3</c:v>
                </c:pt>
                <c:pt idx="90">
                  <c:v>3.0000000000000001E-3</c:v>
                </c:pt>
                <c:pt idx="91">
                  <c:v>4.0000000000000001E-3</c:v>
                </c:pt>
                <c:pt idx="92">
                  <c:v>4.0000000000000001E-3</c:v>
                </c:pt>
                <c:pt idx="93">
                  <c:v>4.0000000000000001E-3</c:v>
                </c:pt>
                <c:pt idx="94">
                  <c:v>5.0000000000000001E-3</c:v>
                </c:pt>
                <c:pt idx="95">
                  <c:v>6.0000000000000001E-3</c:v>
                </c:pt>
                <c:pt idx="96">
                  <c:v>6.0000000000000001E-3</c:v>
                </c:pt>
                <c:pt idx="97">
                  <c:v>7.0000000000000001E-3</c:v>
                </c:pt>
                <c:pt idx="98">
                  <c:v>8.0000000000000002E-3</c:v>
                </c:pt>
                <c:pt idx="99">
                  <c:v>8.9999999999999993E-3</c:v>
                </c:pt>
                <c:pt idx="100">
                  <c:v>1.0999999999999999E-2</c:v>
                </c:pt>
                <c:pt idx="101">
                  <c:v>1.2999999999999999E-2</c:v>
                </c:pt>
                <c:pt idx="102">
                  <c:v>1.4999999999999999E-2</c:v>
                </c:pt>
                <c:pt idx="103">
                  <c:v>1.7999999999999999E-2</c:v>
                </c:pt>
                <c:pt idx="104">
                  <c:v>2.1000000000000001E-2</c:v>
                </c:pt>
                <c:pt idx="105">
                  <c:v>2.5000000000000001E-2</c:v>
                </c:pt>
                <c:pt idx="106">
                  <c:v>2.9000000000000001E-2</c:v>
                </c:pt>
                <c:pt idx="107">
                  <c:v>3.5000000000000003E-2</c:v>
                </c:pt>
                <c:pt idx="108">
                  <c:v>4.1000000000000002E-2</c:v>
                </c:pt>
                <c:pt idx="109">
                  <c:v>4.9000000000000002E-2</c:v>
                </c:pt>
                <c:pt idx="110">
                  <c:v>5.8000000000000003E-2</c:v>
                </c:pt>
                <c:pt idx="111">
                  <c:v>6.9000000000000006E-2</c:v>
                </c:pt>
                <c:pt idx="112">
                  <c:v>8.3000000000000004E-2</c:v>
                </c:pt>
                <c:pt idx="113">
                  <c:v>9.8000000000000004E-2</c:v>
                </c:pt>
                <c:pt idx="114">
                  <c:v>0.11600000000000001</c:v>
                </c:pt>
                <c:pt idx="115">
                  <c:v>0.13700000000000001</c:v>
                </c:pt>
                <c:pt idx="116">
                  <c:v>0.159</c:v>
                </c:pt>
                <c:pt idx="117">
                  <c:v>0.184</c:v>
                </c:pt>
                <c:pt idx="118">
                  <c:v>0.20899999999999999</c:v>
                </c:pt>
                <c:pt idx="119">
                  <c:v>0.23599999999999999</c:v>
                </c:pt>
                <c:pt idx="120">
                  <c:v>0.26300000000000001</c:v>
                </c:pt>
                <c:pt idx="121">
                  <c:v>0.29099999999999998</c:v>
                </c:pt>
                <c:pt idx="122">
                  <c:v>0.317</c:v>
                </c:pt>
                <c:pt idx="123">
                  <c:v>0.34300000000000003</c:v>
                </c:pt>
                <c:pt idx="124">
                  <c:v>0.36699999999999999</c:v>
                </c:pt>
                <c:pt idx="125">
                  <c:v>0.39100000000000001</c:v>
                </c:pt>
                <c:pt idx="126">
                  <c:v>0.41199999999999998</c:v>
                </c:pt>
                <c:pt idx="127">
                  <c:v>0.432</c:v>
                </c:pt>
                <c:pt idx="128">
                  <c:v>0.44900000000000001</c:v>
                </c:pt>
                <c:pt idx="129">
                  <c:v>0.46500000000000002</c:v>
                </c:pt>
                <c:pt idx="130">
                  <c:v>0.48</c:v>
                </c:pt>
                <c:pt idx="131">
                  <c:v>0.49299999999999999</c:v>
                </c:pt>
                <c:pt idx="132">
                  <c:v>0.505</c:v>
                </c:pt>
                <c:pt idx="133">
                  <c:v>0.51600000000000001</c:v>
                </c:pt>
                <c:pt idx="134">
                  <c:v>0.52500000000000002</c:v>
                </c:pt>
                <c:pt idx="135">
                  <c:v>0.53300000000000003</c:v>
                </c:pt>
                <c:pt idx="136">
                  <c:v>0.54100000000000004</c:v>
                </c:pt>
                <c:pt idx="137">
                  <c:v>0.54600000000000004</c:v>
                </c:pt>
                <c:pt idx="138">
                  <c:v>0.55100000000000005</c:v>
                </c:pt>
                <c:pt idx="139">
                  <c:v>0.55400000000000005</c:v>
                </c:pt>
                <c:pt idx="140">
                  <c:v>0.55600000000000005</c:v>
                </c:pt>
                <c:pt idx="141">
                  <c:v>0.55600000000000005</c:v>
                </c:pt>
                <c:pt idx="142">
                  <c:v>0.55500000000000005</c:v>
                </c:pt>
                <c:pt idx="143">
                  <c:v>0.55300000000000005</c:v>
                </c:pt>
                <c:pt idx="144">
                  <c:v>0.54900000000000004</c:v>
                </c:pt>
                <c:pt idx="145">
                  <c:v>0.54500000000000004</c:v>
                </c:pt>
                <c:pt idx="146">
                  <c:v>0.53900000000000003</c:v>
                </c:pt>
                <c:pt idx="147">
                  <c:v>0.53200000000000003</c:v>
                </c:pt>
                <c:pt idx="148">
                  <c:v>0.52500000000000002</c:v>
                </c:pt>
                <c:pt idx="149">
                  <c:v>0.51600000000000001</c:v>
                </c:pt>
                <c:pt idx="150">
                  <c:v>0.50700000000000001</c:v>
                </c:pt>
                <c:pt idx="151">
                  <c:v>0.498</c:v>
                </c:pt>
                <c:pt idx="152">
                  <c:v>0.48899999999999999</c:v>
                </c:pt>
                <c:pt idx="153">
                  <c:v>0.48</c:v>
                </c:pt>
                <c:pt idx="154">
                  <c:v>0.47099999999999997</c:v>
                </c:pt>
                <c:pt idx="155">
                  <c:v>0.46300000000000002</c:v>
                </c:pt>
                <c:pt idx="156">
                  <c:v>0.45600000000000002</c:v>
                </c:pt>
                <c:pt idx="157">
                  <c:v>0.45</c:v>
                </c:pt>
                <c:pt idx="158">
                  <c:v>0.44400000000000001</c:v>
                </c:pt>
                <c:pt idx="159">
                  <c:v>0.44</c:v>
                </c:pt>
                <c:pt idx="160">
                  <c:v>0.436</c:v>
                </c:pt>
                <c:pt idx="161">
                  <c:v>0.434</c:v>
                </c:pt>
                <c:pt idx="162">
                  <c:v>0.434</c:v>
                </c:pt>
                <c:pt idx="163">
                  <c:v>0.434</c:v>
                </c:pt>
                <c:pt idx="164">
                  <c:v>0.436</c:v>
                </c:pt>
                <c:pt idx="165">
                  <c:v>0.439</c:v>
                </c:pt>
                <c:pt idx="166">
                  <c:v>0.443</c:v>
                </c:pt>
                <c:pt idx="167">
                  <c:v>0.44700000000000001</c:v>
                </c:pt>
                <c:pt idx="168">
                  <c:v>0.45200000000000001</c:v>
                </c:pt>
                <c:pt idx="169">
                  <c:v>0.45800000000000002</c:v>
                </c:pt>
                <c:pt idx="170">
                  <c:v>0.46400000000000002</c:v>
                </c:pt>
                <c:pt idx="171">
                  <c:v>0.47</c:v>
                </c:pt>
                <c:pt idx="172">
                  <c:v>0.47599999999999998</c:v>
                </c:pt>
                <c:pt idx="173">
                  <c:v>0.48199999999999998</c:v>
                </c:pt>
                <c:pt idx="174">
                  <c:v>0.48699999999999999</c:v>
                </c:pt>
                <c:pt idx="175">
                  <c:v>0.49199999999999999</c:v>
                </c:pt>
                <c:pt idx="176">
                  <c:v>0.496</c:v>
                </c:pt>
                <c:pt idx="177">
                  <c:v>0.499</c:v>
                </c:pt>
                <c:pt idx="178">
                  <c:v>0.502</c:v>
                </c:pt>
                <c:pt idx="179">
                  <c:v>0.503</c:v>
                </c:pt>
                <c:pt idx="180">
                  <c:v>0.503</c:v>
                </c:pt>
                <c:pt idx="181">
                  <c:v>0.502</c:v>
                </c:pt>
                <c:pt idx="182">
                  <c:v>0.499</c:v>
                </c:pt>
                <c:pt idx="183">
                  <c:v>0.496</c:v>
                </c:pt>
                <c:pt idx="184">
                  <c:v>0.49099999999999999</c:v>
                </c:pt>
                <c:pt idx="185">
                  <c:v>0.48599999999999999</c:v>
                </c:pt>
                <c:pt idx="186">
                  <c:v>0.47899999999999998</c:v>
                </c:pt>
                <c:pt idx="187">
                  <c:v>0.47099999999999997</c:v>
                </c:pt>
                <c:pt idx="188">
                  <c:v>0.46200000000000002</c:v>
                </c:pt>
                <c:pt idx="189">
                  <c:v>0.45200000000000001</c:v>
                </c:pt>
                <c:pt idx="190">
                  <c:v>0.442</c:v>
                </c:pt>
                <c:pt idx="191">
                  <c:v>0.43099999999999999</c:v>
                </c:pt>
                <c:pt idx="192">
                  <c:v>0.42</c:v>
                </c:pt>
                <c:pt idx="193">
                  <c:v>0.40799999999999997</c:v>
                </c:pt>
                <c:pt idx="194">
                  <c:v>0.39700000000000002</c:v>
                </c:pt>
                <c:pt idx="195">
                  <c:v>0.38500000000000001</c:v>
                </c:pt>
                <c:pt idx="196">
                  <c:v>0.373</c:v>
                </c:pt>
                <c:pt idx="197">
                  <c:v>0.36199999999999999</c:v>
                </c:pt>
                <c:pt idx="198">
                  <c:v>0.35</c:v>
                </c:pt>
                <c:pt idx="199">
                  <c:v>0.33900000000000002</c:v>
                </c:pt>
                <c:pt idx="200">
                  <c:v>0.32800000000000001</c:v>
                </c:pt>
                <c:pt idx="201">
                  <c:v>0.318</c:v>
                </c:pt>
                <c:pt idx="202">
                  <c:v>0.308</c:v>
                </c:pt>
                <c:pt idx="203">
                  <c:v>0.29899999999999999</c:v>
                </c:pt>
                <c:pt idx="204">
                  <c:v>0.28999999999999998</c:v>
                </c:pt>
                <c:pt idx="205">
                  <c:v>0.28199999999999997</c:v>
                </c:pt>
                <c:pt idx="206">
                  <c:v>0.27400000000000002</c:v>
                </c:pt>
                <c:pt idx="207">
                  <c:v>0.26700000000000002</c:v>
                </c:pt>
                <c:pt idx="208">
                  <c:v>0.25900000000000001</c:v>
                </c:pt>
                <c:pt idx="209">
                  <c:v>0.252</c:v>
                </c:pt>
                <c:pt idx="210">
                  <c:v>0.24399999999999999</c:v>
                </c:pt>
                <c:pt idx="211">
                  <c:v>0.23699999999999999</c:v>
                </c:pt>
                <c:pt idx="212">
                  <c:v>0.22900000000000001</c:v>
                </c:pt>
                <c:pt idx="213">
                  <c:v>0.222</c:v>
                </c:pt>
                <c:pt idx="214">
                  <c:v>0.215</c:v>
                </c:pt>
                <c:pt idx="215">
                  <c:v>0.20699999999999999</c:v>
                </c:pt>
                <c:pt idx="216">
                  <c:v>0.2</c:v>
                </c:pt>
                <c:pt idx="217">
                  <c:v>0.192</c:v>
                </c:pt>
                <c:pt idx="218">
                  <c:v>0.184</c:v>
                </c:pt>
                <c:pt idx="219">
                  <c:v>0.17699999999999999</c:v>
                </c:pt>
                <c:pt idx="220">
                  <c:v>0.16900000000000001</c:v>
                </c:pt>
                <c:pt idx="221">
                  <c:v>0.161</c:v>
                </c:pt>
                <c:pt idx="222">
                  <c:v>0.153</c:v>
                </c:pt>
                <c:pt idx="223">
                  <c:v>0.14599999999999999</c:v>
                </c:pt>
                <c:pt idx="224">
                  <c:v>0.13800000000000001</c:v>
                </c:pt>
                <c:pt idx="225">
                  <c:v>0.13100000000000001</c:v>
                </c:pt>
                <c:pt idx="226">
                  <c:v>0.124</c:v>
                </c:pt>
                <c:pt idx="227">
                  <c:v>0.11799999999999999</c:v>
                </c:pt>
                <c:pt idx="228">
                  <c:v>0.112</c:v>
                </c:pt>
                <c:pt idx="229">
                  <c:v>0.106</c:v>
                </c:pt>
                <c:pt idx="230">
                  <c:v>0.1</c:v>
                </c:pt>
                <c:pt idx="231">
                  <c:v>9.5000000000000001E-2</c:v>
                </c:pt>
                <c:pt idx="232">
                  <c:v>0.09</c:v>
                </c:pt>
                <c:pt idx="233">
                  <c:v>8.5000000000000006E-2</c:v>
                </c:pt>
                <c:pt idx="234">
                  <c:v>8.1000000000000003E-2</c:v>
                </c:pt>
                <c:pt idx="235">
                  <c:v>7.5999999999999998E-2</c:v>
                </c:pt>
                <c:pt idx="236">
                  <c:v>7.1999999999999995E-2</c:v>
                </c:pt>
                <c:pt idx="237">
                  <c:v>6.9000000000000006E-2</c:v>
                </c:pt>
                <c:pt idx="238">
                  <c:v>6.5000000000000002E-2</c:v>
                </c:pt>
                <c:pt idx="239">
                  <c:v>6.2E-2</c:v>
                </c:pt>
                <c:pt idx="240">
                  <c:v>5.8999999999999997E-2</c:v>
                </c:pt>
                <c:pt idx="241">
                  <c:v>5.6000000000000001E-2</c:v>
                </c:pt>
                <c:pt idx="242">
                  <c:v>5.3999999999999999E-2</c:v>
                </c:pt>
                <c:pt idx="243">
                  <c:v>5.0999999999999997E-2</c:v>
                </c:pt>
                <c:pt idx="244">
                  <c:v>4.9000000000000002E-2</c:v>
                </c:pt>
                <c:pt idx="245">
                  <c:v>4.5999999999999999E-2</c:v>
                </c:pt>
                <c:pt idx="246">
                  <c:v>4.3999999999999997E-2</c:v>
                </c:pt>
                <c:pt idx="247">
                  <c:v>4.2000000000000003E-2</c:v>
                </c:pt>
                <c:pt idx="248">
                  <c:v>3.9E-2</c:v>
                </c:pt>
                <c:pt idx="249">
                  <c:v>3.6999999999999998E-2</c:v>
                </c:pt>
                <c:pt idx="250">
                  <c:v>3.5999999999999997E-2</c:v>
                </c:pt>
                <c:pt idx="251">
                  <c:v>3.4000000000000002E-2</c:v>
                </c:pt>
                <c:pt idx="252">
                  <c:v>3.2000000000000001E-2</c:v>
                </c:pt>
                <c:pt idx="253">
                  <c:v>3.1E-2</c:v>
                </c:pt>
                <c:pt idx="254">
                  <c:v>2.9000000000000001E-2</c:v>
                </c:pt>
                <c:pt idx="255">
                  <c:v>2.7E-2</c:v>
                </c:pt>
                <c:pt idx="256">
                  <c:v>2.5999999999999999E-2</c:v>
                </c:pt>
                <c:pt idx="257">
                  <c:v>2.5000000000000001E-2</c:v>
                </c:pt>
                <c:pt idx="258">
                  <c:v>2.3E-2</c:v>
                </c:pt>
                <c:pt idx="259">
                  <c:v>2.1999999999999999E-2</c:v>
                </c:pt>
                <c:pt idx="260">
                  <c:v>2.1000000000000001E-2</c:v>
                </c:pt>
                <c:pt idx="261">
                  <c:v>0.02</c:v>
                </c:pt>
                <c:pt idx="262">
                  <c:v>1.9E-2</c:v>
                </c:pt>
                <c:pt idx="263">
                  <c:v>1.7999999999999999E-2</c:v>
                </c:pt>
                <c:pt idx="264">
                  <c:v>1.7999999999999999E-2</c:v>
                </c:pt>
                <c:pt idx="265">
                  <c:v>1.7000000000000001E-2</c:v>
                </c:pt>
                <c:pt idx="266">
                  <c:v>1.6E-2</c:v>
                </c:pt>
                <c:pt idx="267">
                  <c:v>1.6E-2</c:v>
                </c:pt>
                <c:pt idx="268">
                  <c:v>1.4999999999999999E-2</c:v>
                </c:pt>
                <c:pt idx="269">
                  <c:v>1.4999999999999999E-2</c:v>
                </c:pt>
                <c:pt idx="270">
                  <c:v>1.4999999999999999E-2</c:v>
                </c:pt>
                <c:pt idx="271">
                  <c:v>1.4E-2</c:v>
                </c:pt>
                <c:pt idx="272">
                  <c:v>1.4E-2</c:v>
                </c:pt>
                <c:pt idx="273">
                  <c:v>1.4E-2</c:v>
                </c:pt>
                <c:pt idx="274">
                  <c:v>1.2999999999999999E-2</c:v>
                </c:pt>
                <c:pt idx="275">
                  <c:v>1.2999999999999999E-2</c:v>
                </c:pt>
                <c:pt idx="276">
                  <c:v>1.2999999999999999E-2</c:v>
                </c:pt>
                <c:pt idx="277">
                  <c:v>1.2999999999999999E-2</c:v>
                </c:pt>
                <c:pt idx="278">
                  <c:v>1.2999999999999999E-2</c:v>
                </c:pt>
                <c:pt idx="279">
                  <c:v>1.2999999999999999E-2</c:v>
                </c:pt>
                <c:pt idx="280">
                  <c:v>1.2999999999999999E-2</c:v>
                </c:pt>
                <c:pt idx="281">
                  <c:v>1.2999999999999999E-2</c:v>
                </c:pt>
                <c:pt idx="282">
                  <c:v>1.2999999999999999E-2</c:v>
                </c:pt>
                <c:pt idx="283">
                  <c:v>1.2999999999999999E-2</c:v>
                </c:pt>
                <c:pt idx="284">
                  <c:v>1.4E-2</c:v>
                </c:pt>
                <c:pt idx="285">
                  <c:v>1.4E-2</c:v>
                </c:pt>
                <c:pt idx="286">
                  <c:v>1.4E-2</c:v>
                </c:pt>
                <c:pt idx="287">
                  <c:v>1.4E-2</c:v>
                </c:pt>
                <c:pt idx="288">
                  <c:v>1.4999999999999999E-2</c:v>
                </c:pt>
                <c:pt idx="289">
                  <c:v>1.4999999999999999E-2</c:v>
                </c:pt>
                <c:pt idx="290">
                  <c:v>1.6E-2</c:v>
                </c:pt>
                <c:pt idx="291">
                  <c:v>1.6E-2</c:v>
                </c:pt>
                <c:pt idx="292">
                  <c:v>1.7000000000000001E-2</c:v>
                </c:pt>
                <c:pt idx="293">
                  <c:v>1.7000000000000001E-2</c:v>
                </c:pt>
                <c:pt idx="294">
                  <c:v>1.7999999999999999E-2</c:v>
                </c:pt>
                <c:pt idx="295">
                  <c:v>1.9E-2</c:v>
                </c:pt>
                <c:pt idx="296">
                  <c:v>0.02</c:v>
                </c:pt>
                <c:pt idx="297">
                  <c:v>2.1000000000000001E-2</c:v>
                </c:pt>
                <c:pt idx="298">
                  <c:v>2.1000000000000001E-2</c:v>
                </c:pt>
                <c:pt idx="299">
                  <c:v>2.1999999999999999E-2</c:v>
                </c:pt>
                <c:pt idx="300">
                  <c:v>2.3E-2</c:v>
                </c:pt>
                <c:pt idx="301">
                  <c:v>2.4E-2</c:v>
                </c:pt>
                <c:pt idx="302">
                  <c:v>2.5999999999999999E-2</c:v>
                </c:pt>
                <c:pt idx="303">
                  <c:v>2.7E-2</c:v>
                </c:pt>
                <c:pt idx="304">
                  <c:v>2.8000000000000001E-2</c:v>
                </c:pt>
                <c:pt idx="305">
                  <c:v>2.9000000000000001E-2</c:v>
                </c:pt>
                <c:pt idx="306">
                  <c:v>3.1E-2</c:v>
                </c:pt>
                <c:pt idx="307">
                  <c:v>3.2000000000000001E-2</c:v>
                </c:pt>
                <c:pt idx="308">
                  <c:v>3.4000000000000002E-2</c:v>
                </c:pt>
                <c:pt idx="309">
                  <c:v>3.5000000000000003E-2</c:v>
                </c:pt>
                <c:pt idx="310">
                  <c:v>3.6999999999999998E-2</c:v>
                </c:pt>
                <c:pt idx="311">
                  <c:v>3.9E-2</c:v>
                </c:pt>
                <c:pt idx="312">
                  <c:v>4.1000000000000002E-2</c:v>
                </c:pt>
                <c:pt idx="313">
                  <c:v>4.2999999999999997E-2</c:v>
                </c:pt>
                <c:pt idx="314">
                  <c:v>4.4999999999999998E-2</c:v>
                </c:pt>
                <c:pt idx="315">
                  <c:v>4.7E-2</c:v>
                </c:pt>
                <c:pt idx="316">
                  <c:v>4.9000000000000002E-2</c:v>
                </c:pt>
                <c:pt idx="317">
                  <c:v>5.0999999999999997E-2</c:v>
                </c:pt>
                <c:pt idx="318">
                  <c:v>5.3999999999999999E-2</c:v>
                </c:pt>
                <c:pt idx="319">
                  <c:v>5.6000000000000001E-2</c:v>
                </c:pt>
                <c:pt idx="320">
                  <c:v>5.8999999999999997E-2</c:v>
                </c:pt>
                <c:pt idx="321">
                  <c:v>6.0999999999999999E-2</c:v>
                </c:pt>
                <c:pt idx="322">
                  <c:v>6.4000000000000001E-2</c:v>
                </c:pt>
                <c:pt idx="323">
                  <c:v>6.7000000000000004E-2</c:v>
                </c:pt>
                <c:pt idx="324">
                  <c:v>7.0000000000000007E-2</c:v>
                </c:pt>
                <c:pt idx="325">
                  <c:v>7.2999999999999995E-2</c:v>
                </c:pt>
                <c:pt idx="326">
                  <c:v>7.5999999999999998E-2</c:v>
                </c:pt>
                <c:pt idx="327">
                  <c:v>0.08</c:v>
                </c:pt>
                <c:pt idx="328">
                  <c:v>8.3000000000000004E-2</c:v>
                </c:pt>
                <c:pt idx="329">
                  <c:v>8.6999999999999994E-2</c:v>
                </c:pt>
                <c:pt idx="330">
                  <c:v>9.0999999999999998E-2</c:v>
                </c:pt>
                <c:pt idx="331">
                  <c:v>9.5000000000000001E-2</c:v>
                </c:pt>
                <c:pt idx="332">
                  <c:v>9.9000000000000005E-2</c:v>
                </c:pt>
                <c:pt idx="333">
                  <c:v>0.10199999999999999</c:v>
                </c:pt>
                <c:pt idx="334">
                  <c:v>0.106</c:v>
                </c:pt>
                <c:pt idx="335">
                  <c:v>0.11</c:v>
                </c:pt>
                <c:pt idx="336">
                  <c:v>0.114</c:v>
                </c:pt>
                <c:pt idx="337">
                  <c:v>0.11799999999999999</c:v>
                </c:pt>
                <c:pt idx="338">
                  <c:v>0.122</c:v>
                </c:pt>
                <c:pt idx="339">
                  <c:v>0.126</c:v>
                </c:pt>
                <c:pt idx="340">
                  <c:v>0.13100000000000001</c:v>
                </c:pt>
                <c:pt idx="341">
                  <c:v>0.13600000000000001</c:v>
                </c:pt>
                <c:pt idx="342">
                  <c:v>0.14000000000000001</c:v>
                </c:pt>
                <c:pt idx="343">
                  <c:v>0.14499999999999999</c:v>
                </c:pt>
                <c:pt idx="344">
                  <c:v>0.15</c:v>
                </c:pt>
                <c:pt idx="345">
                  <c:v>0.155</c:v>
                </c:pt>
                <c:pt idx="346">
                  <c:v>0.16</c:v>
                </c:pt>
                <c:pt idx="347">
                  <c:v>0.16600000000000001</c:v>
                </c:pt>
                <c:pt idx="348">
                  <c:v>0.17100000000000001</c:v>
                </c:pt>
                <c:pt idx="349">
                  <c:v>0.17599999999999999</c:v>
                </c:pt>
                <c:pt idx="350">
                  <c:v>0.182</c:v>
                </c:pt>
                <c:pt idx="351">
                  <c:v>0.187</c:v>
                </c:pt>
                <c:pt idx="352">
                  <c:v>0.193</c:v>
                </c:pt>
                <c:pt idx="353">
                  <c:v>0.19800000000000001</c:v>
                </c:pt>
                <c:pt idx="354">
                  <c:v>0.20399999999999999</c:v>
                </c:pt>
                <c:pt idx="355">
                  <c:v>0.21</c:v>
                </c:pt>
                <c:pt idx="356">
                  <c:v>0.216</c:v>
                </c:pt>
                <c:pt idx="357">
                  <c:v>0.221</c:v>
                </c:pt>
                <c:pt idx="358">
                  <c:v>0.22700000000000001</c:v>
                </c:pt>
                <c:pt idx="359">
                  <c:v>0.23200000000000001</c:v>
                </c:pt>
                <c:pt idx="360">
                  <c:v>0.23799999999999999</c:v>
                </c:pt>
                <c:pt idx="361">
                  <c:v>0.24299999999999999</c:v>
                </c:pt>
                <c:pt idx="362">
                  <c:v>0.249</c:v>
                </c:pt>
                <c:pt idx="363">
                  <c:v>0.255</c:v>
                </c:pt>
                <c:pt idx="364">
                  <c:v>0.26100000000000001</c:v>
                </c:pt>
                <c:pt idx="365">
                  <c:v>0.26800000000000002</c:v>
                </c:pt>
                <c:pt idx="366">
                  <c:v>0.27500000000000002</c:v>
                </c:pt>
                <c:pt idx="367">
                  <c:v>0.28199999999999997</c:v>
                </c:pt>
                <c:pt idx="368">
                  <c:v>0.28899999999999998</c:v>
                </c:pt>
                <c:pt idx="369">
                  <c:v>0.29599999999999999</c:v>
                </c:pt>
                <c:pt idx="370">
                  <c:v>0.30299999999999999</c:v>
                </c:pt>
                <c:pt idx="371">
                  <c:v>0.31</c:v>
                </c:pt>
                <c:pt idx="372">
                  <c:v>0.318</c:v>
                </c:pt>
                <c:pt idx="373">
                  <c:v>0.32600000000000001</c:v>
                </c:pt>
                <c:pt idx="374">
                  <c:v>0.33400000000000002</c:v>
                </c:pt>
                <c:pt idx="375">
                  <c:v>0.34200000000000003</c:v>
                </c:pt>
                <c:pt idx="376">
                  <c:v>0.35</c:v>
                </c:pt>
                <c:pt idx="377">
                  <c:v>0.36</c:v>
                </c:pt>
                <c:pt idx="378">
                  <c:v>0.36899999999999999</c:v>
                </c:pt>
                <c:pt idx="379">
                  <c:v>0.378</c:v>
                </c:pt>
                <c:pt idx="380">
                  <c:v>0.38800000000000001</c:v>
                </c:pt>
                <c:pt idx="381">
                  <c:v>0.39800000000000002</c:v>
                </c:pt>
                <c:pt idx="382">
                  <c:v>0.40699999999999997</c:v>
                </c:pt>
                <c:pt idx="383">
                  <c:v>0.41699999999999998</c:v>
                </c:pt>
                <c:pt idx="384">
                  <c:v>0.42699999999999999</c:v>
                </c:pt>
                <c:pt idx="385">
                  <c:v>0.437</c:v>
                </c:pt>
                <c:pt idx="386">
                  <c:v>0.44800000000000001</c:v>
                </c:pt>
                <c:pt idx="387">
                  <c:v>0.45800000000000002</c:v>
                </c:pt>
                <c:pt idx="388">
                  <c:v>0.46899999999999997</c:v>
                </c:pt>
                <c:pt idx="389">
                  <c:v>0.48</c:v>
                </c:pt>
                <c:pt idx="390">
                  <c:v>0.49099999999999999</c:v>
                </c:pt>
                <c:pt idx="391">
                  <c:v>0.503</c:v>
                </c:pt>
                <c:pt idx="392">
                  <c:v>0.51400000000000001</c:v>
                </c:pt>
                <c:pt idx="393">
                  <c:v>0.52600000000000002</c:v>
                </c:pt>
                <c:pt idx="394">
                  <c:v>0.53800000000000003</c:v>
                </c:pt>
                <c:pt idx="395">
                  <c:v>0.55000000000000004</c:v>
                </c:pt>
                <c:pt idx="396">
                  <c:v>0.56200000000000006</c:v>
                </c:pt>
                <c:pt idx="397">
                  <c:v>0.57499999999999996</c:v>
                </c:pt>
                <c:pt idx="398">
                  <c:v>0.58799999999999997</c:v>
                </c:pt>
                <c:pt idx="399">
                  <c:v>0.60199999999999998</c:v>
                </c:pt>
                <c:pt idx="400">
                  <c:v>0.61699999999999999</c:v>
                </c:pt>
                <c:pt idx="401">
                  <c:v>0.63300000000000001</c:v>
                </c:pt>
                <c:pt idx="402">
                  <c:v>0.65</c:v>
                </c:pt>
                <c:pt idx="403">
                  <c:v>0.66800000000000004</c:v>
                </c:pt>
                <c:pt idx="404">
                  <c:v>0.68600000000000005</c:v>
                </c:pt>
                <c:pt idx="405">
                  <c:v>0.70399999999999996</c:v>
                </c:pt>
                <c:pt idx="406">
                  <c:v>0.72399999999999998</c:v>
                </c:pt>
                <c:pt idx="407">
                  <c:v>0.74299999999999999</c:v>
                </c:pt>
                <c:pt idx="408">
                  <c:v>0.76300000000000001</c:v>
                </c:pt>
                <c:pt idx="409">
                  <c:v>0.78300000000000003</c:v>
                </c:pt>
                <c:pt idx="410">
                  <c:v>0.80200000000000005</c:v>
                </c:pt>
                <c:pt idx="411">
                  <c:v>0.82299999999999995</c:v>
                </c:pt>
                <c:pt idx="412">
                  <c:v>0.84399999999999997</c:v>
                </c:pt>
                <c:pt idx="413">
                  <c:v>0.86599999999999999</c:v>
                </c:pt>
                <c:pt idx="414">
                  <c:v>0.88700000000000001</c:v>
                </c:pt>
                <c:pt idx="415">
                  <c:v>0.90800000000000003</c:v>
                </c:pt>
                <c:pt idx="416">
                  <c:v>0.92700000000000005</c:v>
                </c:pt>
                <c:pt idx="417">
                  <c:v>0.94399999999999995</c:v>
                </c:pt>
                <c:pt idx="418">
                  <c:v>0.96</c:v>
                </c:pt>
                <c:pt idx="419">
                  <c:v>0.97399999999999998</c:v>
                </c:pt>
                <c:pt idx="420">
                  <c:v>0.98599999999999999</c:v>
                </c:pt>
                <c:pt idx="421">
                  <c:v>0.996</c:v>
                </c:pt>
                <c:pt idx="422">
                  <c:v>1.004</c:v>
                </c:pt>
                <c:pt idx="423">
                  <c:v>1.0089999999999999</c:v>
                </c:pt>
                <c:pt idx="424">
                  <c:v>1.014</c:v>
                </c:pt>
                <c:pt idx="425">
                  <c:v>1.016</c:v>
                </c:pt>
                <c:pt idx="426">
                  <c:v>1.0169999999999999</c:v>
                </c:pt>
                <c:pt idx="427">
                  <c:v>1.016</c:v>
                </c:pt>
                <c:pt idx="428">
                  <c:v>1.014</c:v>
                </c:pt>
                <c:pt idx="429">
                  <c:v>1.0109999999999999</c:v>
                </c:pt>
                <c:pt idx="430">
                  <c:v>1.008</c:v>
                </c:pt>
                <c:pt idx="431">
                  <c:v>1.004</c:v>
                </c:pt>
                <c:pt idx="432">
                  <c:v>1</c:v>
                </c:pt>
                <c:pt idx="433">
                  <c:v>0.995</c:v>
                </c:pt>
                <c:pt idx="434">
                  <c:v>0.99099999999999999</c:v>
                </c:pt>
                <c:pt idx="435">
                  <c:v>0.98699999999999999</c:v>
                </c:pt>
                <c:pt idx="436">
                  <c:v>0.98299999999999998</c:v>
                </c:pt>
                <c:pt idx="437">
                  <c:v>0.97799999999999998</c:v>
                </c:pt>
                <c:pt idx="438">
                  <c:v>0.97299999999999998</c:v>
                </c:pt>
                <c:pt idx="439">
                  <c:v>0.96699999999999997</c:v>
                </c:pt>
                <c:pt idx="440">
                  <c:v>0.96199999999999997</c:v>
                </c:pt>
                <c:pt idx="441">
                  <c:v>0.95499999999999996</c:v>
                </c:pt>
                <c:pt idx="442">
                  <c:v>0.94799999999999995</c:v>
                </c:pt>
                <c:pt idx="443">
                  <c:v>0.93899999999999995</c:v>
                </c:pt>
                <c:pt idx="444">
                  <c:v>0.93</c:v>
                </c:pt>
                <c:pt idx="445">
                  <c:v>0.92</c:v>
                </c:pt>
                <c:pt idx="446">
                  <c:v>0.90900000000000003</c:v>
                </c:pt>
                <c:pt idx="447">
                  <c:v>0.89800000000000002</c:v>
                </c:pt>
                <c:pt idx="448">
                  <c:v>0.88500000000000001</c:v>
                </c:pt>
                <c:pt idx="449">
                  <c:v>0.872</c:v>
                </c:pt>
                <c:pt idx="450">
                  <c:v>0.85899999999999999</c:v>
                </c:pt>
                <c:pt idx="451">
                  <c:v>0.84599999999999997</c:v>
                </c:pt>
                <c:pt idx="452">
                  <c:v>0.83399999999999996</c:v>
                </c:pt>
                <c:pt idx="453">
                  <c:v>0.82399999999999995</c:v>
                </c:pt>
                <c:pt idx="454">
                  <c:v>0.81499999999999995</c:v>
                </c:pt>
                <c:pt idx="455">
                  <c:v>0.80700000000000005</c:v>
                </c:pt>
                <c:pt idx="456">
                  <c:v>0.80200000000000005</c:v>
                </c:pt>
                <c:pt idx="457">
                  <c:v>0.79800000000000004</c:v>
                </c:pt>
                <c:pt idx="458">
                  <c:v>0.79600000000000004</c:v>
                </c:pt>
                <c:pt idx="459">
                  <c:v>0.79700000000000004</c:v>
                </c:pt>
                <c:pt idx="460">
                  <c:v>0.79900000000000004</c:v>
                </c:pt>
                <c:pt idx="461">
                  <c:v>0.80400000000000005</c:v>
                </c:pt>
                <c:pt idx="462">
                  <c:v>0.81200000000000006</c:v>
                </c:pt>
                <c:pt idx="463">
                  <c:v>0.82199999999999995</c:v>
                </c:pt>
                <c:pt idx="464">
                  <c:v>0.83599999999999997</c:v>
                </c:pt>
                <c:pt idx="465">
                  <c:v>0.85399999999999998</c:v>
                </c:pt>
                <c:pt idx="466">
                  <c:v>0.878</c:v>
                </c:pt>
                <c:pt idx="467">
                  <c:v>0.90900000000000003</c:v>
                </c:pt>
                <c:pt idx="468">
                  <c:v>0.94799999999999995</c:v>
                </c:pt>
                <c:pt idx="469">
                  <c:v>0.997</c:v>
                </c:pt>
                <c:pt idx="470">
                  <c:v>1.0589999999999999</c:v>
                </c:pt>
                <c:pt idx="471">
                  <c:v>1.137</c:v>
                </c:pt>
                <c:pt idx="472">
                  <c:v>1.2350000000000001</c:v>
                </c:pt>
                <c:pt idx="473">
                  <c:v>1.3580000000000001</c:v>
                </c:pt>
                <c:pt idx="474">
                  <c:v>1.51</c:v>
                </c:pt>
                <c:pt idx="475">
                  <c:v>1.6919999999999999</c:v>
                </c:pt>
                <c:pt idx="476">
                  <c:v>1.9039999999999999</c:v>
                </c:pt>
                <c:pt idx="477">
                  <c:v>2.1379999999999999</c:v>
                </c:pt>
                <c:pt idx="478">
                  <c:v>2.3860000000000001</c:v>
                </c:pt>
                <c:pt idx="479">
                  <c:v>2.5960000000000001</c:v>
                </c:pt>
                <c:pt idx="480">
                  <c:v>2.782</c:v>
                </c:pt>
              </c:numCache>
            </c:numRef>
          </c:yVal>
          <c:smooth val="1"/>
          <c:extLst xmlns:c15="http://schemas.microsoft.com/office/drawing/2012/chart">
            <c:ext xmlns:c16="http://schemas.microsoft.com/office/drawing/2014/chart" uri="{C3380CC4-5D6E-409C-BE32-E72D297353CC}">
              <c16:uniqueId val="{00000001-AF63-4D21-8E9E-8ED987C04AD3}"/>
            </c:ext>
          </c:extLst>
        </c:ser>
        <c:ser>
          <c:idx val="4"/>
          <c:order val="4"/>
          <c:tx>
            <c:strRef>
              <c:f>文章选用!$F$1</c:f>
              <c:strCache>
                <c:ptCount val="1"/>
                <c:pt idx="0">
                  <c:v>Baseline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文章选用!$A$2:$A$482</c:f>
              <c:numCache>
                <c:formatCode>General</c:formatCode>
                <c:ptCount val="481"/>
                <c:pt idx="0">
                  <c:v>700</c:v>
                </c:pt>
                <c:pt idx="1">
                  <c:v>699</c:v>
                </c:pt>
                <c:pt idx="2">
                  <c:v>698</c:v>
                </c:pt>
                <c:pt idx="3">
                  <c:v>697</c:v>
                </c:pt>
                <c:pt idx="4">
                  <c:v>696</c:v>
                </c:pt>
                <c:pt idx="5">
                  <c:v>695</c:v>
                </c:pt>
                <c:pt idx="6">
                  <c:v>694</c:v>
                </c:pt>
                <c:pt idx="7">
                  <c:v>693</c:v>
                </c:pt>
                <c:pt idx="8">
                  <c:v>692</c:v>
                </c:pt>
                <c:pt idx="9">
                  <c:v>691</c:v>
                </c:pt>
                <c:pt idx="10">
                  <c:v>690</c:v>
                </c:pt>
                <c:pt idx="11">
                  <c:v>689</c:v>
                </c:pt>
                <c:pt idx="12">
                  <c:v>688</c:v>
                </c:pt>
                <c:pt idx="13">
                  <c:v>687</c:v>
                </c:pt>
                <c:pt idx="14">
                  <c:v>686</c:v>
                </c:pt>
                <c:pt idx="15">
                  <c:v>685</c:v>
                </c:pt>
                <c:pt idx="16">
                  <c:v>684</c:v>
                </c:pt>
                <c:pt idx="17">
                  <c:v>683</c:v>
                </c:pt>
                <c:pt idx="18">
                  <c:v>682</c:v>
                </c:pt>
                <c:pt idx="19">
                  <c:v>681</c:v>
                </c:pt>
                <c:pt idx="20">
                  <c:v>680</c:v>
                </c:pt>
                <c:pt idx="21">
                  <c:v>679</c:v>
                </c:pt>
                <c:pt idx="22">
                  <c:v>678</c:v>
                </c:pt>
                <c:pt idx="23">
                  <c:v>677</c:v>
                </c:pt>
                <c:pt idx="24">
                  <c:v>676</c:v>
                </c:pt>
                <c:pt idx="25">
                  <c:v>675</c:v>
                </c:pt>
                <c:pt idx="26">
                  <c:v>674</c:v>
                </c:pt>
                <c:pt idx="27">
                  <c:v>673</c:v>
                </c:pt>
                <c:pt idx="28">
                  <c:v>672</c:v>
                </c:pt>
                <c:pt idx="29">
                  <c:v>671</c:v>
                </c:pt>
                <c:pt idx="30">
                  <c:v>670</c:v>
                </c:pt>
                <c:pt idx="31">
                  <c:v>669</c:v>
                </c:pt>
                <c:pt idx="32">
                  <c:v>668</c:v>
                </c:pt>
                <c:pt idx="33">
                  <c:v>667</c:v>
                </c:pt>
                <c:pt idx="34">
                  <c:v>666</c:v>
                </c:pt>
                <c:pt idx="35">
                  <c:v>665</c:v>
                </c:pt>
                <c:pt idx="36">
                  <c:v>664</c:v>
                </c:pt>
                <c:pt idx="37">
                  <c:v>663</c:v>
                </c:pt>
                <c:pt idx="38">
                  <c:v>662</c:v>
                </c:pt>
                <c:pt idx="39">
                  <c:v>661</c:v>
                </c:pt>
                <c:pt idx="40">
                  <c:v>660</c:v>
                </c:pt>
                <c:pt idx="41">
                  <c:v>659</c:v>
                </c:pt>
                <c:pt idx="42">
                  <c:v>658</c:v>
                </c:pt>
                <c:pt idx="43">
                  <c:v>657</c:v>
                </c:pt>
                <c:pt idx="44">
                  <c:v>656</c:v>
                </c:pt>
                <c:pt idx="45">
                  <c:v>655</c:v>
                </c:pt>
                <c:pt idx="46">
                  <c:v>654</c:v>
                </c:pt>
                <c:pt idx="47">
                  <c:v>653</c:v>
                </c:pt>
                <c:pt idx="48">
                  <c:v>652</c:v>
                </c:pt>
                <c:pt idx="49">
                  <c:v>651</c:v>
                </c:pt>
                <c:pt idx="50">
                  <c:v>650</c:v>
                </c:pt>
                <c:pt idx="51">
                  <c:v>649</c:v>
                </c:pt>
                <c:pt idx="52">
                  <c:v>648</c:v>
                </c:pt>
                <c:pt idx="53">
                  <c:v>647</c:v>
                </c:pt>
                <c:pt idx="54">
                  <c:v>646</c:v>
                </c:pt>
                <c:pt idx="55">
                  <c:v>645</c:v>
                </c:pt>
                <c:pt idx="56">
                  <c:v>644</c:v>
                </c:pt>
                <c:pt idx="57">
                  <c:v>643</c:v>
                </c:pt>
                <c:pt idx="58">
                  <c:v>642</c:v>
                </c:pt>
                <c:pt idx="59">
                  <c:v>641</c:v>
                </c:pt>
                <c:pt idx="60">
                  <c:v>640</c:v>
                </c:pt>
                <c:pt idx="61">
                  <c:v>639</c:v>
                </c:pt>
                <c:pt idx="62">
                  <c:v>638</c:v>
                </c:pt>
                <c:pt idx="63">
                  <c:v>637</c:v>
                </c:pt>
                <c:pt idx="64">
                  <c:v>636</c:v>
                </c:pt>
                <c:pt idx="65">
                  <c:v>635</c:v>
                </c:pt>
                <c:pt idx="66">
                  <c:v>634</c:v>
                </c:pt>
                <c:pt idx="67">
                  <c:v>633</c:v>
                </c:pt>
                <c:pt idx="68">
                  <c:v>632</c:v>
                </c:pt>
                <c:pt idx="69">
                  <c:v>631</c:v>
                </c:pt>
                <c:pt idx="70">
                  <c:v>630</c:v>
                </c:pt>
                <c:pt idx="71">
                  <c:v>629</c:v>
                </c:pt>
                <c:pt idx="72">
                  <c:v>628</c:v>
                </c:pt>
                <c:pt idx="73">
                  <c:v>627</c:v>
                </c:pt>
                <c:pt idx="74">
                  <c:v>626</c:v>
                </c:pt>
                <c:pt idx="75">
                  <c:v>625</c:v>
                </c:pt>
                <c:pt idx="76">
                  <c:v>624</c:v>
                </c:pt>
                <c:pt idx="77">
                  <c:v>623</c:v>
                </c:pt>
                <c:pt idx="78">
                  <c:v>622</c:v>
                </c:pt>
                <c:pt idx="79">
                  <c:v>621</c:v>
                </c:pt>
                <c:pt idx="80">
                  <c:v>620</c:v>
                </c:pt>
                <c:pt idx="81">
                  <c:v>619</c:v>
                </c:pt>
                <c:pt idx="82">
                  <c:v>618</c:v>
                </c:pt>
                <c:pt idx="83">
                  <c:v>617</c:v>
                </c:pt>
                <c:pt idx="84">
                  <c:v>616</c:v>
                </c:pt>
                <c:pt idx="85">
                  <c:v>615</c:v>
                </c:pt>
                <c:pt idx="86">
                  <c:v>614</c:v>
                </c:pt>
                <c:pt idx="87">
                  <c:v>613</c:v>
                </c:pt>
                <c:pt idx="88">
                  <c:v>612</c:v>
                </c:pt>
                <c:pt idx="89">
                  <c:v>611</c:v>
                </c:pt>
                <c:pt idx="90">
                  <c:v>610</c:v>
                </c:pt>
                <c:pt idx="91">
                  <c:v>609</c:v>
                </c:pt>
                <c:pt idx="92">
                  <c:v>608</c:v>
                </c:pt>
                <c:pt idx="93">
                  <c:v>607</c:v>
                </c:pt>
                <c:pt idx="94">
                  <c:v>606</c:v>
                </c:pt>
                <c:pt idx="95">
                  <c:v>605</c:v>
                </c:pt>
                <c:pt idx="96">
                  <c:v>604</c:v>
                </c:pt>
                <c:pt idx="97">
                  <c:v>603</c:v>
                </c:pt>
                <c:pt idx="98">
                  <c:v>602</c:v>
                </c:pt>
                <c:pt idx="99">
                  <c:v>601</c:v>
                </c:pt>
                <c:pt idx="100">
                  <c:v>600</c:v>
                </c:pt>
                <c:pt idx="101">
                  <c:v>599</c:v>
                </c:pt>
                <c:pt idx="102">
                  <c:v>598</c:v>
                </c:pt>
                <c:pt idx="103">
                  <c:v>597</c:v>
                </c:pt>
                <c:pt idx="104">
                  <c:v>596</c:v>
                </c:pt>
                <c:pt idx="105">
                  <c:v>595</c:v>
                </c:pt>
                <c:pt idx="106">
                  <c:v>594</c:v>
                </c:pt>
                <c:pt idx="107">
                  <c:v>593</c:v>
                </c:pt>
                <c:pt idx="108">
                  <c:v>592</c:v>
                </c:pt>
                <c:pt idx="109">
                  <c:v>591</c:v>
                </c:pt>
                <c:pt idx="110">
                  <c:v>590</c:v>
                </c:pt>
                <c:pt idx="111">
                  <c:v>589</c:v>
                </c:pt>
                <c:pt idx="112">
                  <c:v>588</c:v>
                </c:pt>
                <c:pt idx="113">
                  <c:v>587</c:v>
                </c:pt>
                <c:pt idx="114">
                  <c:v>586</c:v>
                </c:pt>
                <c:pt idx="115">
                  <c:v>585</c:v>
                </c:pt>
                <c:pt idx="116">
                  <c:v>584</c:v>
                </c:pt>
                <c:pt idx="117">
                  <c:v>583</c:v>
                </c:pt>
                <c:pt idx="118">
                  <c:v>582</c:v>
                </c:pt>
                <c:pt idx="119">
                  <c:v>581</c:v>
                </c:pt>
                <c:pt idx="120">
                  <c:v>580</c:v>
                </c:pt>
                <c:pt idx="121">
                  <c:v>579</c:v>
                </c:pt>
                <c:pt idx="122">
                  <c:v>578</c:v>
                </c:pt>
                <c:pt idx="123">
                  <c:v>577</c:v>
                </c:pt>
                <c:pt idx="124">
                  <c:v>576</c:v>
                </c:pt>
                <c:pt idx="125">
                  <c:v>575</c:v>
                </c:pt>
                <c:pt idx="126">
                  <c:v>574</c:v>
                </c:pt>
                <c:pt idx="127">
                  <c:v>573</c:v>
                </c:pt>
                <c:pt idx="128">
                  <c:v>572</c:v>
                </c:pt>
                <c:pt idx="129">
                  <c:v>571</c:v>
                </c:pt>
                <c:pt idx="130">
                  <c:v>570</c:v>
                </c:pt>
                <c:pt idx="131">
                  <c:v>569</c:v>
                </c:pt>
                <c:pt idx="132">
                  <c:v>568</c:v>
                </c:pt>
                <c:pt idx="133">
                  <c:v>567</c:v>
                </c:pt>
                <c:pt idx="134">
                  <c:v>566</c:v>
                </c:pt>
                <c:pt idx="135">
                  <c:v>565</c:v>
                </c:pt>
                <c:pt idx="136">
                  <c:v>564</c:v>
                </c:pt>
                <c:pt idx="137">
                  <c:v>563</c:v>
                </c:pt>
                <c:pt idx="138">
                  <c:v>562</c:v>
                </c:pt>
                <c:pt idx="139">
                  <c:v>561</c:v>
                </c:pt>
                <c:pt idx="140">
                  <c:v>560</c:v>
                </c:pt>
                <c:pt idx="141">
                  <c:v>559</c:v>
                </c:pt>
                <c:pt idx="142">
                  <c:v>558</c:v>
                </c:pt>
                <c:pt idx="143">
                  <c:v>557</c:v>
                </c:pt>
                <c:pt idx="144">
                  <c:v>556</c:v>
                </c:pt>
                <c:pt idx="145">
                  <c:v>555</c:v>
                </c:pt>
                <c:pt idx="146">
                  <c:v>554</c:v>
                </c:pt>
                <c:pt idx="147">
                  <c:v>553</c:v>
                </c:pt>
                <c:pt idx="148">
                  <c:v>552</c:v>
                </c:pt>
                <c:pt idx="149">
                  <c:v>551</c:v>
                </c:pt>
                <c:pt idx="150">
                  <c:v>550</c:v>
                </c:pt>
                <c:pt idx="151">
                  <c:v>549</c:v>
                </c:pt>
                <c:pt idx="152">
                  <c:v>548</c:v>
                </c:pt>
                <c:pt idx="153">
                  <c:v>547</c:v>
                </c:pt>
                <c:pt idx="154">
                  <c:v>546</c:v>
                </c:pt>
                <c:pt idx="155">
                  <c:v>545</c:v>
                </c:pt>
                <c:pt idx="156">
                  <c:v>544</c:v>
                </c:pt>
                <c:pt idx="157">
                  <c:v>543</c:v>
                </c:pt>
                <c:pt idx="158">
                  <c:v>542</c:v>
                </c:pt>
                <c:pt idx="159">
                  <c:v>541</c:v>
                </c:pt>
                <c:pt idx="160">
                  <c:v>540</c:v>
                </c:pt>
                <c:pt idx="161">
                  <c:v>539</c:v>
                </c:pt>
                <c:pt idx="162">
                  <c:v>538</c:v>
                </c:pt>
                <c:pt idx="163">
                  <c:v>537</c:v>
                </c:pt>
                <c:pt idx="164">
                  <c:v>536</c:v>
                </c:pt>
                <c:pt idx="165">
                  <c:v>535</c:v>
                </c:pt>
                <c:pt idx="166">
                  <c:v>534</c:v>
                </c:pt>
                <c:pt idx="167">
                  <c:v>533</c:v>
                </c:pt>
                <c:pt idx="168">
                  <c:v>532</c:v>
                </c:pt>
                <c:pt idx="169">
                  <c:v>531</c:v>
                </c:pt>
                <c:pt idx="170">
                  <c:v>530</c:v>
                </c:pt>
                <c:pt idx="171">
                  <c:v>529</c:v>
                </c:pt>
                <c:pt idx="172">
                  <c:v>528</c:v>
                </c:pt>
                <c:pt idx="173">
                  <c:v>527</c:v>
                </c:pt>
                <c:pt idx="174">
                  <c:v>526</c:v>
                </c:pt>
                <c:pt idx="175">
                  <c:v>525</c:v>
                </c:pt>
                <c:pt idx="176">
                  <c:v>524</c:v>
                </c:pt>
                <c:pt idx="177">
                  <c:v>523</c:v>
                </c:pt>
                <c:pt idx="178">
                  <c:v>522</c:v>
                </c:pt>
                <c:pt idx="179">
                  <c:v>521</c:v>
                </c:pt>
                <c:pt idx="180">
                  <c:v>520</c:v>
                </c:pt>
                <c:pt idx="181">
                  <c:v>519</c:v>
                </c:pt>
                <c:pt idx="182">
                  <c:v>518</c:v>
                </c:pt>
                <c:pt idx="183">
                  <c:v>517</c:v>
                </c:pt>
                <c:pt idx="184">
                  <c:v>516</c:v>
                </c:pt>
                <c:pt idx="185">
                  <c:v>515</c:v>
                </c:pt>
                <c:pt idx="186">
                  <c:v>514</c:v>
                </c:pt>
                <c:pt idx="187">
                  <c:v>513</c:v>
                </c:pt>
                <c:pt idx="188">
                  <c:v>512</c:v>
                </c:pt>
                <c:pt idx="189">
                  <c:v>511</c:v>
                </c:pt>
                <c:pt idx="190">
                  <c:v>510</c:v>
                </c:pt>
                <c:pt idx="191">
                  <c:v>509</c:v>
                </c:pt>
                <c:pt idx="192">
                  <c:v>508</c:v>
                </c:pt>
                <c:pt idx="193">
                  <c:v>507</c:v>
                </c:pt>
                <c:pt idx="194">
                  <c:v>506</c:v>
                </c:pt>
                <c:pt idx="195">
                  <c:v>505</c:v>
                </c:pt>
                <c:pt idx="196">
                  <c:v>504</c:v>
                </c:pt>
                <c:pt idx="197">
                  <c:v>503</c:v>
                </c:pt>
                <c:pt idx="198">
                  <c:v>502</c:v>
                </c:pt>
                <c:pt idx="199">
                  <c:v>501</c:v>
                </c:pt>
                <c:pt idx="200">
                  <c:v>500</c:v>
                </c:pt>
                <c:pt idx="201">
                  <c:v>499</c:v>
                </c:pt>
                <c:pt idx="202">
                  <c:v>498</c:v>
                </c:pt>
                <c:pt idx="203">
                  <c:v>497</c:v>
                </c:pt>
                <c:pt idx="204">
                  <c:v>496</c:v>
                </c:pt>
                <c:pt idx="205">
                  <c:v>495</c:v>
                </c:pt>
                <c:pt idx="206">
                  <c:v>494</c:v>
                </c:pt>
                <c:pt idx="207">
                  <c:v>493</c:v>
                </c:pt>
                <c:pt idx="208">
                  <c:v>492</c:v>
                </c:pt>
                <c:pt idx="209">
                  <c:v>491</c:v>
                </c:pt>
                <c:pt idx="210">
                  <c:v>490</c:v>
                </c:pt>
                <c:pt idx="211">
                  <c:v>489</c:v>
                </c:pt>
                <c:pt idx="212">
                  <c:v>488</c:v>
                </c:pt>
                <c:pt idx="213">
                  <c:v>487</c:v>
                </c:pt>
                <c:pt idx="214">
                  <c:v>486</c:v>
                </c:pt>
                <c:pt idx="215">
                  <c:v>485</c:v>
                </c:pt>
                <c:pt idx="216">
                  <c:v>484</c:v>
                </c:pt>
                <c:pt idx="217">
                  <c:v>483</c:v>
                </c:pt>
                <c:pt idx="218">
                  <c:v>482</c:v>
                </c:pt>
                <c:pt idx="219">
                  <c:v>481</c:v>
                </c:pt>
                <c:pt idx="220">
                  <c:v>480</c:v>
                </c:pt>
                <c:pt idx="221">
                  <c:v>479</c:v>
                </c:pt>
                <c:pt idx="222">
                  <c:v>478</c:v>
                </c:pt>
                <c:pt idx="223">
                  <c:v>477</c:v>
                </c:pt>
                <c:pt idx="224">
                  <c:v>476</c:v>
                </c:pt>
                <c:pt idx="225">
                  <c:v>475</c:v>
                </c:pt>
                <c:pt idx="226">
                  <c:v>474</c:v>
                </c:pt>
                <c:pt idx="227">
                  <c:v>473</c:v>
                </c:pt>
                <c:pt idx="228">
                  <c:v>472</c:v>
                </c:pt>
                <c:pt idx="229">
                  <c:v>471</c:v>
                </c:pt>
                <c:pt idx="230">
                  <c:v>470</c:v>
                </c:pt>
                <c:pt idx="231">
                  <c:v>469</c:v>
                </c:pt>
                <c:pt idx="232">
                  <c:v>468</c:v>
                </c:pt>
                <c:pt idx="233">
                  <c:v>467</c:v>
                </c:pt>
                <c:pt idx="234">
                  <c:v>466</c:v>
                </c:pt>
                <c:pt idx="235">
                  <c:v>465</c:v>
                </c:pt>
                <c:pt idx="236">
                  <c:v>464</c:v>
                </c:pt>
                <c:pt idx="237">
                  <c:v>463</c:v>
                </c:pt>
                <c:pt idx="238">
                  <c:v>462</c:v>
                </c:pt>
                <c:pt idx="239">
                  <c:v>461</c:v>
                </c:pt>
                <c:pt idx="240">
                  <c:v>460</c:v>
                </c:pt>
                <c:pt idx="241">
                  <c:v>459</c:v>
                </c:pt>
                <c:pt idx="242">
                  <c:v>458</c:v>
                </c:pt>
                <c:pt idx="243">
                  <c:v>457</c:v>
                </c:pt>
                <c:pt idx="244">
                  <c:v>456</c:v>
                </c:pt>
                <c:pt idx="245">
                  <c:v>455</c:v>
                </c:pt>
                <c:pt idx="246">
                  <c:v>454</c:v>
                </c:pt>
                <c:pt idx="247">
                  <c:v>453</c:v>
                </c:pt>
                <c:pt idx="248">
                  <c:v>452</c:v>
                </c:pt>
                <c:pt idx="249">
                  <c:v>451</c:v>
                </c:pt>
                <c:pt idx="250">
                  <c:v>450</c:v>
                </c:pt>
                <c:pt idx="251">
                  <c:v>449</c:v>
                </c:pt>
                <c:pt idx="252">
                  <c:v>448</c:v>
                </c:pt>
                <c:pt idx="253">
                  <c:v>447</c:v>
                </c:pt>
                <c:pt idx="254">
                  <c:v>446</c:v>
                </c:pt>
                <c:pt idx="255">
                  <c:v>445</c:v>
                </c:pt>
                <c:pt idx="256">
                  <c:v>444</c:v>
                </c:pt>
                <c:pt idx="257">
                  <c:v>443</c:v>
                </c:pt>
                <c:pt idx="258">
                  <c:v>442</c:v>
                </c:pt>
                <c:pt idx="259">
                  <c:v>441</c:v>
                </c:pt>
                <c:pt idx="260">
                  <c:v>440</c:v>
                </c:pt>
                <c:pt idx="261">
                  <c:v>439</c:v>
                </c:pt>
                <c:pt idx="262">
                  <c:v>438</c:v>
                </c:pt>
                <c:pt idx="263">
                  <c:v>437</c:v>
                </c:pt>
                <c:pt idx="264">
                  <c:v>436</c:v>
                </c:pt>
                <c:pt idx="265">
                  <c:v>435</c:v>
                </c:pt>
                <c:pt idx="266">
                  <c:v>434</c:v>
                </c:pt>
                <c:pt idx="267">
                  <c:v>433</c:v>
                </c:pt>
                <c:pt idx="268">
                  <c:v>432</c:v>
                </c:pt>
                <c:pt idx="269">
                  <c:v>431</c:v>
                </c:pt>
                <c:pt idx="270">
                  <c:v>430</c:v>
                </c:pt>
                <c:pt idx="271">
                  <c:v>429</c:v>
                </c:pt>
                <c:pt idx="272">
                  <c:v>428</c:v>
                </c:pt>
                <c:pt idx="273">
                  <c:v>427</c:v>
                </c:pt>
                <c:pt idx="274">
                  <c:v>426</c:v>
                </c:pt>
                <c:pt idx="275">
                  <c:v>425</c:v>
                </c:pt>
                <c:pt idx="276">
                  <c:v>424</c:v>
                </c:pt>
                <c:pt idx="277">
                  <c:v>423</c:v>
                </c:pt>
                <c:pt idx="278">
                  <c:v>422</c:v>
                </c:pt>
                <c:pt idx="279">
                  <c:v>421</c:v>
                </c:pt>
                <c:pt idx="280">
                  <c:v>420</c:v>
                </c:pt>
                <c:pt idx="281">
                  <c:v>419</c:v>
                </c:pt>
                <c:pt idx="282">
                  <c:v>418</c:v>
                </c:pt>
                <c:pt idx="283">
                  <c:v>417</c:v>
                </c:pt>
                <c:pt idx="284">
                  <c:v>416</c:v>
                </c:pt>
                <c:pt idx="285">
                  <c:v>415</c:v>
                </c:pt>
                <c:pt idx="286">
                  <c:v>414</c:v>
                </c:pt>
                <c:pt idx="287">
                  <c:v>413</c:v>
                </c:pt>
                <c:pt idx="288">
                  <c:v>412</c:v>
                </c:pt>
                <c:pt idx="289">
                  <c:v>411</c:v>
                </c:pt>
                <c:pt idx="290">
                  <c:v>410</c:v>
                </c:pt>
                <c:pt idx="291">
                  <c:v>409</c:v>
                </c:pt>
                <c:pt idx="292">
                  <c:v>408</c:v>
                </c:pt>
                <c:pt idx="293">
                  <c:v>407</c:v>
                </c:pt>
                <c:pt idx="294">
                  <c:v>406</c:v>
                </c:pt>
                <c:pt idx="295">
                  <c:v>405</c:v>
                </c:pt>
                <c:pt idx="296">
                  <c:v>404</c:v>
                </c:pt>
                <c:pt idx="297">
                  <c:v>403</c:v>
                </c:pt>
                <c:pt idx="298">
                  <c:v>402</c:v>
                </c:pt>
                <c:pt idx="299">
                  <c:v>401</c:v>
                </c:pt>
                <c:pt idx="300">
                  <c:v>400</c:v>
                </c:pt>
                <c:pt idx="301">
                  <c:v>399</c:v>
                </c:pt>
                <c:pt idx="302">
                  <c:v>398</c:v>
                </c:pt>
                <c:pt idx="303">
                  <c:v>397</c:v>
                </c:pt>
                <c:pt idx="304">
                  <c:v>396</c:v>
                </c:pt>
                <c:pt idx="305">
                  <c:v>395</c:v>
                </c:pt>
                <c:pt idx="306">
                  <c:v>394</c:v>
                </c:pt>
                <c:pt idx="307">
                  <c:v>393</c:v>
                </c:pt>
                <c:pt idx="308">
                  <c:v>392</c:v>
                </c:pt>
                <c:pt idx="309">
                  <c:v>391</c:v>
                </c:pt>
                <c:pt idx="310">
                  <c:v>390</c:v>
                </c:pt>
                <c:pt idx="311">
                  <c:v>389</c:v>
                </c:pt>
                <c:pt idx="312">
                  <c:v>388</c:v>
                </c:pt>
                <c:pt idx="313">
                  <c:v>387</c:v>
                </c:pt>
                <c:pt idx="314">
                  <c:v>386</c:v>
                </c:pt>
                <c:pt idx="315">
                  <c:v>385</c:v>
                </c:pt>
                <c:pt idx="316">
                  <c:v>384</c:v>
                </c:pt>
                <c:pt idx="317">
                  <c:v>383</c:v>
                </c:pt>
                <c:pt idx="318">
                  <c:v>382</c:v>
                </c:pt>
                <c:pt idx="319">
                  <c:v>381</c:v>
                </c:pt>
                <c:pt idx="320">
                  <c:v>380</c:v>
                </c:pt>
                <c:pt idx="321">
                  <c:v>379</c:v>
                </c:pt>
                <c:pt idx="322">
                  <c:v>378</c:v>
                </c:pt>
                <c:pt idx="323">
                  <c:v>377</c:v>
                </c:pt>
                <c:pt idx="324">
                  <c:v>376</c:v>
                </c:pt>
                <c:pt idx="325">
                  <c:v>375</c:v>
                </c:pt>
                <c:pt idx="326">
                  <c:v>374</c:v>
                </c:pt>
                <c:pt idx="327">
                  <c:v>373</c:v>
                </c:pt>
                <c:pt idx="328">
                  <c:v>372</c:v>
                </c:pt>
                <c:pt idx="329">
                  <c:v>371</c:v>
                </c:pt>
                <c:pt idx="330">
                  <c:v>370</c:v>
                </c:pt>
                <c:pt idx="331">
                  <c:v>369</c:v>
                </c:pt>
                <c:pt idx="332">
                  <c:v>368</c:v>
                </c:pt>
                <c:pt idx="333">
                  <c:v>367</c:v>
                </c:pt>
                <c:pt idx="334">
                  <c:v>366</c:v>
                </c:pt>
                <c:pt idx="335">
                  <c:v>365</c:v>
                </c:pt>
                <c:pt idx="336">
                  <c:v>364</c:v>
                </c:pt>
                <c:pt idx="337">
                  <c:v>363</c:v>
                </c:pt>
                <c:pt idx="338">
                  <c:v>362</c:v>
                </c:pt>
                <c:pt idx="339">
                  <c:v>361</c:v>
                </c:pt>
                <c:pt idx="340">
                  <c:v>360</c:v>
                </c:pt>
                <c:pt idx="341">
                  <c:v>359</c:v>
                </c:pt>
                <c:pt idx="342">
                  <c:v>358</c:v>
                </c:pt>
                <c:pt idx="343">
                  <c:v>357</c:v>
                </c:pt>
                <c:pt idx="344">
                  <c:v>356</c:v>
                </c:pt>
                <c:pt idx="345">
                  <c:v>355</c:v>
                </c:pt>
                <c:pt idx="346">
                  <c:v>354</c:v>
                </c:pt>
                <c:pt idx="347">
                  <c:v>353</c:v>
                </c:pt>
                <c:pt idx="348">
                  <c:v>352</c:v>
                </c:pt>
                <c:pt idx="349">
                  <c:v>351</c:v>
                </c:pt>
                <c:pt idx="350">
                  <c:v>350</c:v>
                </c:pt>
                <c:pt idx="351">
                  <c:v>349</c:v>
                </c:pt>
                <c:pt idx="352">
                  <c:v>348</c:v>
                </c:pt>
                <c:pt idx="353">
                  <c:v>347</c:v>
                </c:pt>
                <c:pt idx="354">
                  <c:v>346</c:v>
                </c:pt>
                <c:pt idx="355">
                  <c:v>345</c:v>
                </c:pt>
                <c:pt idx="356">
                  <c:v>344</c:v>
                </c:pt>
                <c:pt idx="357">
                  <c:v>343</c:v>
                </c:pt>
                <c:pt idx="358">
                  <c:v>342</c:v>
                </c:pt>
                <c:pt idx="359">
                  <c:v>341</c:v>
                </c:pt>
                <c:pt idx="360">
                  <c:v>340</c:v>
                </c:pt>
                <c:pt idx="361">
                  <c:v>339</c:v>
                </c:pt>
                <c:pt idx="362">
                  <c:v>338</c:v>
                </c:pt>
                <c:pt idx="363">
                  <c:v>337</c:v>
                </c:pt>
                <c:pt idx="364">
                  <c:v>336</c:v>
                </c:pt>
                <c:pt idx="365">
                  <c:v>335</c:v>
                </c:pt>
                <c:pt idx="366">
                  <c:v>334</c:v>
                </c:pt>
                <c:pt idx="367">
                  <c:v>333</c:v>
                </c:pt>
                <c:pt idx="368">
                  <c:v>332</c:v>
                </c:pt>
                <c:pt idx="369">
                  <c:v>331</c:v>
                </c:pt>
                <c:pt idx="370">
                  <c:v>330</c:v>
                </c:pt>
                <c:pt idx="371">
                  <c:v>329</c:v>
                </c:pt>
                <c:pt idx="372">
                  <c:v>328</c:v>
                </c:pt>
                <c:pt idx="373">
                  <c:v>327</c:v>
                </c:pt>
                <c:pt idx="374">
                  <c:v>326</c:v>
                </c:pt>
                <c:pt idx="375">
                  <c:v>325</c:v>
                </c:pt>
                <c:pt idx="376">
                  <c:v>324</c:v>
                </c:pt>
                <c:pt idx="377">
                  <c:v>323</c:v>
                </c:pt>
                <c:pt idx="378">
                  <c:v>322</c:v>
                </c:pt>
                <c:pt idx="379">
                  <c:v>321</c:v>
                </c:pt>
                <c:pt idx="380">
                  <c:v>320</c:v>
                </c:pt>
                <c:pt idx="381">
                  <c:v>319</c:v>
                </c:pt>
                <c:pt idx="382">
                  <c:v>318</c:v>
                </c:pt>
                <c:pt idx="383">
                  <c:v>317</c:v>
                </c:pt>
                <c:pt idx="384">
                  <c:v>316</c:v>
                </c:pt>
                <c:pt idx="385">
                  <c:v>315</c:v>
                </c:pt>
                <c:pt idx="386">
                  <c:v>314</c:v>
                </c:pt>
                <c:pt idx="387">
                  <c:v>313</c:v>
                </c:pt>
                <c:pt idx="388">
                  <c:v>312</c:v>
                </c:pt>
                <c:pt idx="389">
                  <c:v>311</c:v>
                </c:pt>
                <c:pt idx="390">
                  <c:v>310</c:v>
                </c:pt>
                <c:pt idx="391">
                  <c:v>309</c:v>
                </c:pt>
                <c:pt idx="392">
                  <c:v>308</c:v>
                </c:pt>
                <c:pt idx="393">
                  <c:v>307</c:v>
                </c:pt>
                <c:pt idx="394">
                  <c:v>306</c:v>
                </c:pt>
                <c:pt idx="395">
                  <c:v>305</c:v>
                </c:pt>
                <c:pt idx="396">
                  <c:v>304</c:v>
                </c:pt>
                <c:pt idx="397">
                  <c:v>303</c:v>
                </c:pt>
                <c:pt idx="398">
                  <c:v>302</c:v>
                </c:pt>
                <c:pt idx="399">
                  <c:v>301</c:v>
                </c:pt>
                <c:pt idx="400">
                  <c:v>300</c:v>
                </c:pt>
                <c:pt idx="401">
                  <c:v>299</c:v>
                </c:pt>
                <c:pt idx="402">
                  <c:v>298</c:v>
                </c:pt>
                <c:pt idx="403">
                  <c:v>297</c:v>
                </c:pt>
                <c:pt idx="404">
                  <c:v>296</c:v>
                </c:pt>
                <c:pt idx="405">
                  <c:v>295</c:v>
                </c:pt>
                <c:pt idx="406">
                  <c:v>294</c:v>
                </c:pt>
                <c:pt idx="407">
                  <c:v>293</c:v>
                </c:pt>
                <c:pt idx="408">
                  <c:v>292</c:v>
                </c:pt>
                <c:pt idx="409">
                  <c:v>291</c:v>
                </c:pt>
                <c:pt idx="410">
                  <c:v>290</c:v>
                </c:pt>
                <c:pt idx="411">
                  <c:v>289</c:v>
                </c:pt>
                <c:pt idx="412">
                  <c:v>288</c:v>
                </c:pt>
                <c:pt idx="413">
                  <c:v>287</c:v>
                </c:pt>
                <c:pt idx="414">
                  <c:v>286</c:v>
                </c:pt>
                <c:pt idx="415">
                  <c:v>285</c:v>
                </c:pt>
                <c:pt idx="416">
                  <c:v>284</c:v>
                </c:pt>
                <c:pt idx="417">
                  <c:v>283</c:v>
                </c:pt>
                <c:pt idx="418">
                  <c:v>282</c:v>
                </c:pt>
                <c:pt idx="419">
                  <c:v>281</c:v>
                </c:pt>
                <c:pt idx="420">
                  <c:v>280</c:v>
                </c:pt>
                <c:pt idx="421">
                  <c:v>279</c:v>
                </c:pt>
                <c:pt idx="422">
                  <c:v>278</c:v>
                </c:pt>
                <c:pt idx="423">
                  <c:v>277</c:v>
                </c:pt>
                <c:pt idx="424">
                  <c:v>276</c:v>
                </c:pt>
                <c:pt idx="425">
                  <c:v>275</c:v>
                </c:pt>
                <c:pt idx="426">
                  <c:v>274</c:v>
                </c:pt>
                <c:pt idx="427">
                  <c:v>273</c:v>
                </c:pt>
                <c:pt idx="428">
                  <c:v>272</c:v>
                </c:pt>
                <c:pt idx="429">
                  <c:v>271</c:v>
                </c:pt>
                <c:pt idx="430">
                  <c:v>270</c:v>
                </c:pt>
                <c:pt idx="431">
                  <c:v>269</c:v>
                </c:pt>
                <c:pt idx="432">
                  <c:v>268</c:v>
                </c:pt>
                <c:pt idx="433">
                  <c:v>267</c:v>
                </c:pt>
                <c:pt idx="434">
                  <c:v>266</c:v>
                </c:pt>
                <c:pt idx="435">
                  <c:v>265</c:v>
                </c:pt>
                <c:pt idx="436">
                  <c:v>264</c:v>
                </c:pt>
                <c:pt idx="437">
                  <c:v>263</c:v>
                </c:pt>
                <c:pt idx="438">
                  <c:v>262</c:v>
                </c:pt>
                <c:pt idx="439">
                  <c:v>261</c:v>
                </c:pt>
                <c:pt idx="440">
                  <c:v>260</c:v>
                </c:pt>
                <c:pt idx="441">
                  <c:v>259</c:v>
                </c:pt>
                <c:pt idx="442">
                  <c:v>258</c:v>
                </c:pt>
                <c:pt idx="443">
                  <c:v>257</c:v>
                </c:pt>
                <c:pt idx="444">
                  <c:v>256</c:v>
                </c:pt>
                <c:pt idx="445">
                  <c:v>255</c:v>
                </c:pt>
                <c:pt idx="446">
                  <c:v>254</c:v>
                </c:pt>
                <c:pt idx="447">
                  <c:v>253</c:v>
                </c:pt>
                <c:pt idx="448">
                  <c:v>252</c:v>
                </c:pt>
                <c:pt idx="449">
                  <c:v>251</c:v>
                </c:pt>
                <c:pt idx="450">
                  <c:v>250</c:v>
                </c:pt>
                <c:pt idx="451">
                  <c:v>249</c:v>
                </c:pt>
                <c:pt idx="452">
                  <c:v>248</c:v>
                </c:pt>
                <c:pt idx="453">
                  <c:v>247</c:v>
                </c:pt>
                <c:pt idx="454">
                  <c:v>246</c:v>
                </c:pt>
                <c:pt idx="455">
                  <c:v>245</c:v>
                </c:pt>
                <c:pt idx="456">
                  <c:v>244</c:v>
                </c:pt>
                <c:pt idx="457">
                  <c:v>243</c:v>
                </c:pt>
                <c:pt idx="458">
                  <c:v>242</c:v>
                </c:pt>
                <c:pt idx="459">
                  <c:v>241</c:v>
                </c:pt>
                <c:pt idx="460">
                  <c:v>240</c:v>
                </c:pt>
                <c:pt idx="461">
                  <c:v>239</c:v>
                </c:pt>
                <c:pt idx="462">
                  <c:v>238</c:v>
                </c:pt>
                <c:pt idx="463">
                  <c:v>237</c:v>
                </c:pt>
                <c:pt idx="464">
                  <c:v>236</c:v>
                </c:pt>
                <c:pt idx="465">
                  <c:v>235</c:v>
                </c:pt>
                <c:pt idx="466">
                  <c:v>234</c:v>
                </c:pt>
                <c:pt idx="467">
                  <c:v>233</c:v>
                </c:pt>
                <c:pt idx="468">
                  <c:v>232</c:v>
                </c:pt>
                <c:pt idx="469">
                  <c:v>231</c:v>
                </c:pt>
                <c:pt idx="470">
                  <c:v>230</c:v>
                </c:pt>
                <c:pt idx="471">
                  <c:v>229</c:v>
                </c:pt>
                <c:pt idx="472">
                  <c:v>228</c:v>
                </c:pt>
                <c:pt idx="473">
                  <c:v>227</c:v>
                </c:pt>
                <c:pt idx="474">
                  <c:v>226</c:v>
                </c:pt>
                <c:pt idx="475">
                  <c:v>225</c:v>
                </c:pt>
                <c:pt idx="476">
                  <c:v>224</c:v>
                </c:pt>
                <c:pt idx="477">
                  <c:v>223</c:v>
                </c:pt>
                <c:pt idx="478">
                  <c:v>222</c:v>
                </c:pt>
                <c:pt idx="479">
                  <c:v>221</c:v>
                </c:pt>
                <c:pt idx="480">
                  <c:v>220</c:v>
                </c:pt>
              </c:numCache>
            </c:numRef>
          </c:xVal>
          <c:yVal>
            <c:numRef>
              <c:f>文章选用!$F$2:$F$482</c:f>
              <c:numCache>
                <c:formatCode>General</c:formatCode>
                <c:ptCount val="48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  <c:pt idx="291">
                  <c:v>0</c:v>
                </c:pt>
                <c:pt idx="292">
                  <c:v>0</c:v>
                </c:pt>
                <c:pt idx="293">
                  <c:v>0</c:v>
                </c:pt>
                <c:pt idx="294">
                  <c:v>0</c:v>
                </c:pt>
                <c:pt idx="295">
                  <c:v>0</c:v>
                </c:pt>
                <c:pt idx="296">
                  <c:v>0</c:v>
                </c:pt>
                <c:pt idx="297">
                  <c:v>0</c:v>
                </c:pt>
                <c:pt idx="298">
                  <c:v>0</c:v>
                </c:pt>
                <c:pt idx="299">
                  <c:v>0</c:v>
                </c:pt>
                <c:pt idx="300">
                  <c:v>0</c:v>
                </c:pt>
                <c:pt idx="301">
                  <c:v>0</c:v>
                </c:pt>
                <c:pt idx="302">
                  <c:v>0</c:v>
                </c:pt>
                <c:pt idx="303">
                  <c:v>0</c:v>
                </c:pt>
                <c:pt idx="304">
                  <c:v>0</c:v>
                </c:pt>
                <c:pt idx="305">
                  <c:v>0</c:v>
                </c:pt>
                <c:pt idx="306">
                  <c:v>0</c:v>
                </c:pt>
                <c:pt idx="307">
                  <c:v>0</c:v>
                </c:pt>
                <c:pt idx="308">
                  <c:v>0</c:v>
                </c:pt>
                <c:pt idx="309">
                  <c:v>0</c:v>
                </c:pt>
                <c:pt idx="310">
                  <c:v>0</c:v>
                </c:pt>
                <c:pt idx="311">
                  <c:v>0</c:v>
                </c:pt>
                <c:pt idx="312">
                  <c:v>0</c:v>
                </c:pt>
                <c:pt idx="313">
                  <c:v>0</c:v>
                </c:pt>
                <c:pt idx="314">
                  <c:v>0</c:v>
                </c:pt>
                <c:pt idx="315">
                  <c:v>0</c:v>
                </c:pt>
                <c:pt idx="316">
                  <c:v>0</c:v>
                </c:pt>
                <c:pt idx="317">
                  <c:v>0</c:v>
                </c:pt>
                <c:pt idx="318">
                  <c:v>0</c:v>
                </c:pt>
                <c:pt idx="319">
                  <c:v>0</c:v>
                </c:pt>
                <c:pt idx="320">
                  <c:v>0</c:v>
                </c:pt>
                <c:pt idx="321">
                  <c:v>0</c:v>
                </c:pt>
                <c:pt idx="322">
                  <c:v>0</c:v>
                </c:pt>
                <c:pt idx="323">
                  <c:v>0</c:v>
                </c:pt>
                <c:pt idx="324">
                  <c:v>0</c:v>
                </c:pt>
                <c:pt idx="325">
                  <c:v>0</c:v>
                </c:pt>
                <c:pt idx="326">
                  <c:v>0</c:v>
                </c:pt>
                <c:pt idx="327">
                  <c:v>0</c:v>
                </c:pt>
                <c:pt idx="328">
                  <c:v>0</c:v>
                </c:pt>
                <c:pt idx="329">
                  <c:v>0</c:v>
                </c:pt>
                <c:pt idx="330">
                  <c:v>0</c:v>
                </c:pt>
                <c:pt idx="331">
                  <c:v>0</c:v>
                </c:pt>
                <c:pt idx="332">
                  <c:v>0</c:v>
                </c:pt>
                <c:pt idx="333">
                  <c:v>0</c:v>
                </c:pt>
                <c:pt idx="334">
                  <c:v>0</c:v>
                </c:pt>
                <c:pt idx="335">
                  <c:v>0</c:v>
                </c:pt>
                <c:pt idx="336">
                  <c:v>0</c:v>
                </c:pt>
                <c:pt idx="337">
                  <c:v>0</c:v>
                </c:pt>
                <c:pt idx="338">
                  <c:v>0</c:v>
                </c:pt>
                <c:pt idx="339">
                  <c:v>0</c:v>
                </c:pt>
                <c:pt idx="340">
                  <c:v>0</c:v>
                </c:pt>
                <c:pt idx="341">
                  <c:v>0</c:v>
                </c:pt>
                <c:pt idx="342">
                  <c:v>0</c:v>
                </c:pt>
                <c:pt idx="343">
                  <c:v>0</c:v>
                </c:pt>
                <c:pt idx="344">
                  <c:v>0</c:v>
                </c:pt>
                <c:pt idx="345">
                  <c:v>0</c:v>
                </c:pt>
                <c:pt idx="346">
                  <c:v>0</c:v>
                </c:pt>
                <c:pt idx="347">
                  <c:v>0</c:v>
                </c:pt>
                <c:pt idx="348">
                  <c:v>0</c:v>
                </c:pt>
                <c:pt idx="349">
                  <c:v>0</c:v>
                </c:pt>
                <c:pt idx="350">
                  <c:v>0</c:v>
                </c:pt>
                <c:pt idx="351">
                  <c:v>0</c:v>
                </c:pt>
                <c:pt idx="352">
                  <c:v>0</c:v>
                </c:pt>
                <c:pt idx="353">
                  <c:v>0</c:v>
                </c:pt>
                <c:pt idx="354">
                  <c:v>0</c:v>
                </c:pt>
                <c:pt idx="355">
                  <c:v>0</c:v>
                </c:pt>
                <c:pt idx="356">
                  <c:v>0</c:v>
                </c:pt>
                <c:pt idx="357">
                  <c:v>0</c:v>
                </c:pt>
                <c:pt idx="358">
                  <c:v>0</c:v>
                </c:pt>
                <c:pt idx="359">
                  <c:v>0</c:v>
                </c:pt>
                <c:pt idx="360">
                  <c:v>0</c:v>
                </c:pt>
                <c:pt idx="361">
                  <c:v>0</c:v>
                </c:pt>
                <c:pt idx="362">
                  <c:v>0</c:v>
                </c:pt>
                <c:pt idx="363">
                  <c:v>0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  <c:pt idx="402">
                  <c:v>0</c:v>
                </c:pt>
                <c:pt idx="403">
                  <c:v>0</c:v>
                </c:pt>
                <c:pt idx="404">
                  <c:v>0</c:v>
                </c:pt>
                <c:pt idx="405">
                  <c:v>0</c:v>
                </c:pt>
                <c:pt idx="406">
                  <c:v>0</c:v>
                </c:pt>
                <c:pt idx="407">
                  <c:v>0</c:v>
                </c:pt>
                <c:pt idx="408">
                  <c:v>0</c:v>
                </c:pt>
                <c:pt idx="409">
                  <c:v>0</c:v>
                </c:pt>
                <c:pt idx="410">
                  <c:v>0</c:v>
                </c:pt>
                <c:pt idx="411">
                  <c:v>0</c:v>
                </c:pt>
                <c:pt idx="412">
                  <c:v>0</c:v>
                </c:pt>
                <c:pt idx="413">
                  <c:v>0</c:v>
                </c:pt>
                <c:pt idx="414">
                  <c:v>0</c:v>
                </c:pt>
                <c:pt idx="415">
                  <c:v>0</c:v>
                </c:pt>
                <c:pt idx="416">
                  <c:v>0</c:v>
                </c:pt>
                <c:pt idx="417">
                  <c:v>0</c:v>
                </c:pt>
                <c:pt idx="418">
                  <c:v>0</c:v>
                </c:pt>
                <c:pt idx="419">
                  <c:v>0</c:v>
                </c:pt>
                <c:pt idx="420">
                  <c:v>0</c:v>
                </c:pt>
                <c:pt idx="421">
                  <c:v>0</c:v>
                </c:pt>
                <c:pt idx="422">
                  <c:v>0</c:v>
                </c:pt>
                <c:pt idx="423">
                  <c:v>0</c:v>
                </c:pt>
                <c:pt idx="424">
                  <c:v>0</c:v>
                </c:pt>
                <c:pt idx="425">
                  <c:v>0</c:v>
                </c:pt>
                <c:pt idx="426">
                  <c:v>0</c:v>
                </c:pt>
                <c:pt idx="427">
                  <c:v>0</c:v>
                </c:pt>
                <c:pt idx="428">
                  <c:v>0</c:v>
                </c:pt>
                <c:pt idx="429">
                  <c:v>0</c:v>
                </c:pt>
                <c:pt idx="430">
                  <c:v>0</c:v>
                </c:pt>
                <c:pt idx="431">
                  <c:v>0</c:v>
                </c:pt>
                <c:pt idx="432">
                  <c:v>0</c:v>
                </c:pt>
                <c:pt idx="433">
                  <c:v>0</c:v>
                </c:pt>
                <c:pt idx="434">
                  <c:v>0</c:v>
                </c:pt>
                <c:pt idx="435">
                  <c:v>0</c:v>
                </c:pt>
                <c:pt idx="436">
                  <c:v>0</c:v>
                </c:pt>
                <c:pt idx="437">
                  <c:v>0</c:v>
                </c:pt>
                <c:pt idx="438">
                  <c:v>0</c:v>
                </c:pt>
                <c:pt idx="439">
                  <c:v>0</c:v>
                </c:pt>
                <c:pt idx="440">
                  <c:v>0</c:v>
                </c:pt>
                <c:pt idx="441">
                  <c:v>0</c:v>
                </c:pt>
                <c:pt idx="442">
                  <c:v>0</c:v>
                </c:pt>
                <c:pt idx="443">
                  <c:v>0</c:v>
                </c:pt>
                <c:pt idx="444">
                  <c:v>0</c:v>
                </c:pt>
                <c:pt idx="445">
                  <c:v>0</c:v>
                </c:pt>
                <c:pt idx="446">
                  <c:v>0</c:v>
                </c:pt>
                <c:pt idx="447">
                  <c:v>0</c:v>
                </c:pt>
                <c:pt idx="448">
                  <c:v>0</c:v>
                </c:pt>
                <c:pt idx="449">
                  <c:v>0</c:v>
                </c:pt>
                <c:pt idx="450">
                  <c:v>0</c:v>
                </c:pt>
                <c:pt idx="451">
                  <c:v>0</c:v>
                </c:pt>
                <c:pt idx="452">
                  <c:v>0</c:v>
                </c:pt>
                <c:pt idx="453">
                  <c:v>0</c:v>
                </c:pt>
                <c:pt idx="454">
                  <c:v>0</c:v>
                </c:pt>
                <c:pt idx="455">
                  <c:v>0</c:v>
                </c:pt>
                <c:pt idx="456">
                  <c:v>0</c:v>
                </c:pt>
                <c:pt idx="457">
                  <c:v>0</c:v>
                </c:pt>
                <c:pt idx="458">
                  <c:v>0</c:v>
                </c:pt>
                <c:pt idx="459">
                  <c:v>0</c:v>
                </c:pt>
                <c:pt idx="460">
                  <c:v>0</c:v>
                </c:pt>
                <c:pt idx="461">
                  <c:v>0</c:v>
                </c:pt>
                <c:pt idx="462">
                  <c:v>0</c:v>
                </c:pt>
                <c:pt idx="463">
                  <c:v>0</c:v>
                </c:pt>
                <c:pt idx="464">
                  <c:v>0</c:v>
                </c:pt>
                <c:pt idx="465">
                  <c:v>0</c:v>
                </c:pt>
                <c:pt idx="466">
                  <c:v>0</c:v>
                </c:pt>
                <c:pt idx="467">
                  <c:v>0</c:v>
                </c:pt>
                <c:pt idx="468">
                  <c:v>0</c:v>
                </c:pt>
                <c:pt idx="469">
                  <c:v>0</c:v>
                </c:pt>
                <c:pt idx="470">
                  <c:v>0</c:v>
                </c:pt>
                <c:pt idx="471">
                  <c:v>0</c:v>
                </c:pt>
                <c:pt idx="472">
                  <c:v>0</c:v>
                </c:pt>
                <c:pt idx="473">
                  <c:v>0</c:v>
                </c:pt>
                <c:pt idx="474">
                  <c:v>0</c:v>
                </c:pt>
                <c:pt idx="475">
                  <c:v>0</c:v>
                </c:pt>
                <c:pt idx="476">
                  <c:v>0</c:v>
                </c:pt>
                <c:pt idx="477">
                  <c:v>0</c:v>
                </c:pt>
                <c:pt idx="478">
                  <c:v>0</c:v>
                </c:pt>
                <c:pt idx="479">
                  <c:v>0</c:v>
                </c:pt>
                <c:pt idx="480">
                  <c:v>0</c:v>
                </c:pt>
              </c:numCache>
            </c:numRef>
          </c:y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2-AF63-4D21-8E9E-8ED987C04A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07404447"/>
        <c:axId val="1507405279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文章选用!$B$1</c15:sqref>
                        </c15:formulaRef>
                      </c:ext>
                    </c:extLst>
                    <c:strCache>
                      <c:ptCount val="1"/>
                      <c:pt idx="0">
                        <c:v>Dil-PMnS</c:v>
                      </c:pt>
                    </c:strCache>
                  </c:strRef>
                </c:tx>
                <c:spPr>
                  <a:ln w="19050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none"/>
                </c:marker>
                <c:xVal>
                  <c:numRef>
                    <c:extLst>
                      <c:ext uri="{02D57815-91ED-43cb-92C2-25804820EDAC}">
                        <c15:formulaRef>
                          <c15:sqref>文章选用!$A$2:$A$482</c15:sqref>
                        </c15:formulaRef>
                      </c:ext>
                    </c:extLst>
                    <c:numCache>
                      <c:formatCode>General</c:formatCode>
                      <c:ptCount val="481"/>
                      <c:pt idx="0">
                        <c:v>700</c:v>
                      </c:pt>
                      <c:pt idx="1">
                        <c:v>699</c:v>
                      </c:pt>
                      <c:pt idx="2">
                        <c:v>698</c:v>
                      </c:pt>
                      <c:pt idx="3">
                        <c:v>697</c:v>
                      </c:pt>
                      <c:pt idx="4">
                        <c:v>696</c:v>
                      </c:pt>
                      <c:pt idx="5">
                        <c:v>695</c:v>
                      </c:pt>
                      <c:pt idx="6">
                        <c:v>694</c:v>
                      </c:pt>
                      <c:pt idx="7">
                        <c:v>693</c:v>
                      </c:pt>
                      <c:pt idx="8">
                        <c:v>692</c:v>
                      </c:pt>
                      <c:pt idx="9">
                        <c:v>691</c:v>
                      </c:pt>
                      <c:pt idx="10">
                        <c:v>690</c:v>
                      </c:pt>
                      <c:pt idx="11">
                        <c:v>689</c:v>
                      </c:pt>
                      <c:pt idx="12">
                        <c:v>688</c:v>
                      </c:pt>
                      <c:pt idx="13">
                        <c:v>687</c:v>
                      </c:pt>
                      <c:pt idx="14">
                        <c:v>686</c:v>
                      </c:pt>
                      <c:pt idx="15">
                        <c:v>685</c:v>
                      </c:pt>
                      <c:pt idx="16">
                        <c:v>684</c:v>
                      </c:pt>
                      <c:pt idx="17">
                        <c:v>683</c:v>
                      </c:pt>
                      <c:pt idx="18">
                        <c:v>682</c:v>
                      </c:pt>
                      <c:pt idx="19">
                        <c:v>681</c:v>
                      </c:pt>
                      <c:pt idx="20">
                        <c:v>680</c:v>
                      </c:pt>
                      <c:pt idx="21">
                        <c:v>679</c:v>
                      </c:pt>
                      <c:pt idx="22">
                        <c:v>678</c:v>
                      </c:pt>
                      <c:pt idx="23">
                        <c:v>677</c:v>
                      </c:pt>
                      <c:pt idx="24">
                        <c:v>676</c:v>
                      </c:pt>
                      <c:pt idx="25">
                        <c:v>675</c:v>
                      </c:pt>
                      <c:pt idx="26">
                        <c:v>674</c:v>
                      </c:pt>
                      <c:pt idx="27">
                        <c:v>673</c:v>
                      </c:pt>
                      <c:pt idx="28">
                        <c:v>672</c:v>
                      </c:pt>
                      <c:pt idx="29">
                        <c:v>671</c:v>
                      </c:pt>
                      <c:pt idx="30">
                        <c:v>670</c:v>
                      </c:pt>
                      <c:pt idx="31">
                        <c:v>669</c:v>
                      </c:pt>
                      <c:pt idx="32">
                        <c:v>668</c:v>
                      </c:pt>
                      <c:pt idx="33">
                        <c:v>667</c:v>
                      </c:pt>
                      <c:pt idx="34">
                        <c:v>666</c:v>
                      </c:pt>
                      <c:pt idx="35">
                        <c:v>665</c:v>
                      </c:pt>
                      <c:pt idx="36">
                        <c:v>664</c:v>
                      </c:pt>
                      <c:pt idx="37">
                        <c:v>663</c:v>
                      </c:pt>
                      <c:pt idx="38">
                        <c:v>662</c:v>
                      </c:pt>
                      <c:pt idx="39">
                        <c:v>661</c:v>
                      </c:pt>
                      <c:pt idx="40">
                        <c:v>660</c:v>
                      </c:pt>
                      <c:pt idx="41">
                        <c:v>659</c:v>
                      </c:pt>
                      <c:pt idx="42">
                        <c:v>658</c:v>
                      </c:pt>
                      <c:pt idx="43">
                        <c:v>657</c:v>
                      </c:pt>
                      <c:pt idx="44">
                        <c:v>656</c:v>
                      </c:pt>
                      <c:pt idx="45">
                        <c:v>655</c:v>
                      </c:pt>
                      <c:pt idx="46">
                        <c:v>654</c:v>
                      </c:pt>
                      <c:pt idx="47">
                        <c:v>653</c:v>
                      </c:pt>
                      <c:pt idx="48">
                        <c:v>652</c:v>
                      </c:pt>
                      <c:pt idx="49">
                        <c:v>651</c:v>
                      </c:pt>
                      <c:pt idx="50">
                        <c:v>650</c:v>
                      </c:pt>
                      <c:pt idx="51">
                        <c:v>649</c:v>
                      </c:pt>
                      <c:pt idx="52">
                        <c:v>648</c:v>
                      </c:pt>
                      <c:pt idx="53">
                        <c:v>647</c:v>
                      </c:pt>
                      <c:pt idx="54">
                        <c:v>646</c:v>
                      </c:pt>
                      <c:pt idx="55">
                        <c:v>645</c:v>
                      </c:pt>
                      <c:pt idx="56">
                        <c:v>644</c:v>
                      </c:pt>
                      <c:pt idx="57">
                        <c:v>643</c:v>
                      </c:pt>
                      <c:pt idx="58">
                        <c:v>642</c:v>
                      </c:pt>
                      <c:pt idx="59">
                        <c:v>641</c:v>
                      </c:pt>
                      <c:pt idx="60">
                        <c:v>640</c:v>
                      </c:pt>
                      <c:pt idx="61">
                        <c:v>639</c:v>
                      </c:pt>
                      <c:pt idx="62">
                        <c:v>638</c:v>
                      </c:pt>
                      <c:pt idx="63">
                        <c:v>637</c:v>
                      </c:pt>
                      <c:pt idx="64">
                        <c:v>636</c:v>
                      </c:pt>
                      <c:pt idx="65">
                        <c:v>635</c:v>
                      </c:pt>
                      <c:pt idx="66">
                        <c:v>634</c:v>
                      </c:pt>
                      <c:pt idx="67">
                        <c:v>633</c:v>
                      </c:pt>
                      <c:pt idx="68">
                        <c:v>632</c:v>
                      </c:pt>
                      <c:pt idx="69">
                        <c:v>631</c:v>
                      </c:pt>
                      <c:pt idx="70">
                        <c:v>630</c:v>
                      </c:pt>
                      <c:pt idx="71">
                        <c:v>629</c:v>
                      </c:pt>
                      <c:pt idx="72">
                        <c:v>628</c:v>
                      </c:pt>
                      <c:pt idx="73">
                        <c:v>627</c:v>
                      </c:pt>
                      <c:pt idx="74">
                        <c:v>626</c:v>
                      </c:pt>
                      <c:pt idx="75">
                        <c:v>625</c:v>
                      </c:pt>
                      <c:pt idx="76">
                        <c:v>624</c:v>
                      </c:pt>
                      <c:pt idx="77">
                        <c:v>623</c:v>
                      </c:pt>
                      <c:pt idx="78">
                        <c:v>622</c:v>
                      </c:pt>
                      <c:pt idx="79">
                        <c:v>621</c:v>
                      </c:pt>
                      <c:pt idx="80">
                        <c:v>620</c:v>
                      </c:pt>
                      <c:pt idx="81">
                        <c:v>619</c:v>
                      </c:pt>
                      <c:pt idx="82">
                        <c:v>618</c:v>
                      </c:pt>
                      <c:pt idx="83">
                        <c:v>617</c:v>
                      </c:pt>
                      <c:pt idx="84">
                        <c:v>616</c:v>
                      </c:pt>
                      <c:pt idx="85">
                        <c:v>615</c:v>
                      </c:pt>
                      <c:pt idx="86">
                        <c:v>614</c:v>
                      </c:pt>
                      <c:pt idx="87">
                        <c:v>613</c:v>
                      </c:pt>
                      <c:pt idx="88">
                        <c:v>612</c:v>
                      </c:pt>
                      <c:pt idx="89">
                        <c:v>611</c:v>
                      </c:pt>
                      <c:pt idx="90">
                        <c:v>610</c:v>
                      </c:pt>
                      <c:pt idx="91">
                        <c:v>609</c:v>
                      </c:pt>
                      <c:pt idx="92">
                        <c:v>608</c:v>
                      </c:pt>
                      <c:pt idx="93">
                        <c:v>607</c:v>
                      </c:pt>
                      <c:pt idx="94">
                        <c:v>606</c:v>
                      </c:pt>
                      <c:pt idx="95">
                        <c:v>605</c:v>
                      </c:pt>
                      <c:pt idx="96">
                        <c:v>604</c:v>
                      </c:pt>
                      <c:pt idx="97">
                        <c:v>603</c:v>
                      </c:pt>
                      <c:pt idx="98">
                        <c:v>602</c:v>
                      </c:pt>
                      <c:pt idx="99">
                        <c:v>601</c:v>
                      </c:pt>
                      <c:pt idx="100">
                        <c:v>600</c:v>
                      </c:pt>
                      <c:pt idx="101">
                        <c:v>599</c:v>
                      </c:pt>
                      <c:pt idx="102">
                        <c:v>598</c:v>
                      </c:pt>
                      <c:pt idx="103">
                        <c:v>597</c:v>
                      </c:pt>
                      <c:pt idx="104">
                        <c:v>596</c:v>
                      </c:pt>
                      <c:pt idx="105">
                        <c:v>595</c:v>
                      </c:pt>
                      <c:pt idx="106">
                        <c:v>594</c:v>
                      </c:pt>
                      <c:pt idx="107">
                        <c:v>593</c:v>
                      </c:pt>
                      <c:pt idx="108">
                        <c:v>592</c:v>
                      </c:pt>
                      <c:pt idx="109">
                        <c:v>591</c:v>
                      </c:pt>
                      <c:pt idx="110">
                        <c:v>590</c:v>
                      </c:pt>
                      <c:pt idx="111">
                        <c:v>589</c:v>
                      </c:pt>
                      <c:pt idx="112">
                        <c:v>588</c:v>
                      </c:pt>
                      <c:pt idx="113">
                        <c:v>587</c:v>
                      </c:pt>
                      <c:pt idx="114">
                        <c:v>586</c:v>
                      </c:pt>
                      <c:pt idx="115">
                        <c:v>585</c:v>
                      </c:pt>
                      <c:pt idx="116">
                        <c:v>584</c:v>
                      </c:pt>
                      <c:pt idx="117">
                        <c:v>583</c:v>
                      </c:pt>
                      <c:pt idx="118">
                        <c:v>582</c:v>
                      </c:pt>
                      <c:pt idx="119">
                        <c:v>581</c:v>
                      </c:pt>
                      <c:pt idx="120">
                        <c:v>580</c:v>
                      </c:pt>
                      <c:pt idx="121">
                        <c:v>579</c:v>
                      </c:pt>
                      <c:pt idx="122">
                        <c:v>578</c:v>
                      </c:pt>
                      <c:pt idx="123">
                        <c:v>577</c:v>
                      </c:pt>
                      <c:pt idx="124">
                        <c:v>576</c:v>
                      </c:pt>
                      <c:pt idx="125">
                        <c:v>575</c:v>
                      </c:pt>
                      <c:pt idx="126">
                        <c:v>574</c:v>
                      </c:pt>
                      <c:pt idx="127">
                        <c:v>573</c:v>
                      </c:pt>
                      <c:pt idx="128">
                        <c:v>572</c:v>
                      </c:pt>
                      <c:pt idx="129">
                        <c:v>571</c:v>
                      </c:pt>
                      <c:pt idx="130">
                        <c:v>570</c:v>
                      </c:pt>
                      <c:pt idx="131">
                        <c:v>569</c:v>
                      </c:pt>
                      <c:pt idx="132">
                        <c:v>568</c:v>
                      </c:pt>
                      <c:pt idx="133">
                        <c:v>567</c:v>
                      </c:pt>
                      <c:pt idx="134">
                        <c:v>566</c:v>
                      </c:pt>
                      <c:pt idx="135">
                        <c:v>565</c:v>
                      </c:pt>
                      <c:pt idx="136">
                        <c:v>564</c:v>
                      </c:pt>
                      <c:pt idx="137">
                        <c:v>563</c:v>
                      </c:pt>
                      <c:pt idx="138">
                        <c:v>562</c:v>
                      </c:pt>
                      <c:pt idx="139">
                        <c:v>561</c:v>
                      </c:pt>
                      <c:pt idx="140">
                        <c:v>560</c:v>
                      </c:pt>
                      <c:pt idx="141">
                        <c:v>559</c:v>
                      </c:pt>
                      <c:pt idx="142">
                        <c:v>558</c:v>
                      </c:pt>
                      <c:pt idx="143">
                        <c:v>557</c:v>
                      </c:pt>
                      <c:pt idx="144">
                        <c:v>556</c:v>
                      </c:pt>
                      <c:pt idx="145">
                        <c:v>555</c:v>
                      </c:pt>
                      <c:pt idx="146">
                        <c:v>554</c:v>
                      </c:pt>
                      <c:pt idx="147">
                        <c:v>553</c:v>
                      </c:pt>
                      <c:pt idx="148">
                        <c:v>552</c:v>
                      </c:pt>
                      <c:pt idx="149">
                        <c:v>551</c:v>
                      </c:pt>
                      <c:pt idx="150">
                        <c:v>550</c:v>
                      </c:pt>
                      <c:pt idx="151">
                        <c:v>549</c:v>
                      </c:pt>
                      <c:pt idx="152">
                        <c:v>548</c:v>
                      </c:pt>
                      <c:pt idx="153">
                        <c:v>547</c:v>
                      </c:pt>
                      <c:pt idx="154">
                        <c:v>546</c:v>
                      </c:pt>
                      <c:pt idx="155">
                        <c:v>545</c:v>
                      </c:pt>
                      <c:pt idx="156">
                        <c:v>544</c:v>
                      </c:pt>
                      <c:pt idx="157">
                        <c:v>543</c:v>
                      </c:pt>
                      <c:pt idx="158">
                        <c:v>542</c:v>
                      </c:pt>
                      <c:pt idx="159">
                        <c:v>541</c:v>
                      </c:pt>
                      <c:pt idx="160">
                        <c:v>540</c:v>
                      </c:pt>
                      <c:pt idx="161">
                        <c:v>539</c:v>
                      </c:pt>
                      <c:pt idx="162">
                        <c:v>538</c:v>
                      </c:pt>
                      <c:pt idx="163">
                        <c:v>537</c:v>
                      </c:pt>
                      <c:pt idx="164">
                        <c:v>536</c:v>
                      </c:pt>
                      <c:pt idx="165">
                        <c:v>535</c:v>
                      </c:pt>
                      <c:pt idx="166">
                        <c:v>534</c:v>
                      </c:pt>
                      <c:pt idx="167">
                        <c:v>533</c:v>
                      </c:pt>
                      <c:pt idx="168">
                        <c:v>532</c:v>
                      </c:pt>
                      <c:pt idx="169">
                        <c:v>531</c:v>
                      </c:pt>
                      <c:pt idx="170">
                        <c:v>530</c:v>
                      </c:pt>
                      <c:pt idx="171">
                        <c:v>529</c:v>
                      </c:pt>
                      <c:pt idx="172">
                        <c:v>528</c:v>
                      </c:pt>
                      <c:pt idx="173">
                        <c:v>527</c:v>
                      </c:pt>
                      <c:pt idx="174">
                        <c:v>526</c:v>
                      </c:pt>
                      <c:pt idx="175">
                        <c:v>525</c:v>
                      </c:pt>
                      <c:pt idx="176">
                        <c:v>524</c:v>
                      </c:pt>
                      <c:pt idx="177">
                        <c:v>523</c:v>
                      </c:pt>
                      <c:pt idx="178">
                        <c:v>522</c:v>
                      </c:pt>
                      <c:pt idx="179">
                        <c:v>521</c:v>
                      </c:pt>
                      <c:pt idx="180">
                        <c:v>520</c:v>
                      </c:pt>
                      <c:pt idx="181">
                        <c:v>519</c:v>
                      </c:pt>
                      <c:pt idx="182">
                        <c:v>518</c:v>
                      </c:pt>
                      <c:pt idx="183">
                        <c:v>517</c:v>
                      </c:pt>
                      <c:pt idx="184">
                        <c:v>516</c:v>
                      </c:pt>
                      <c:pt idx="185">
                        <c:v>515</c:v>
                      </c:pt>
                      <c:pt idx="186">
                        <c:v>514</c:v>
                      </c:pt>
                      <c:pt idx="187">
                        <c:v>513</c:v>
                      </c:pt>
                      <c:pt idx="188">
                        <c:v>512</c:v>
                      </c:pt>
                      <c:pt idx="189">
                        <c:v>511</c:v>
                      </c:pt>
                      <c:pt idx="190">
                        <c:v>510</c:v>
                      </c:pt>
                      <c:pt idx="191">
                        <c:v>509</c:v>
                      </c:pt>
                      <c:pt idx="192">
                        <c:v>508</c:v>
                      </c:pt>
                      <c:pt idx="193">
                        <c:v>507</c:v>
                      </c:pt>
                      <c:pt idx="194">
                        <c:v>506</c:v>
                      </c:pt>
                      <c:pt idx="195">
                        <c:v>505</c:v>
                      </c:pt>
                      <c:pt idx="196">
                        <c:v>504</c:v>
                      </c:pt>
                      <c:pt idx="197">
                        <c:v>503</c:v>
                      </c:pt>
                      <c:pt idx="198">
                        <c:v>502</c:v>
                      </c:pt>
                      <c:pt idx="199">
                        <c:v>501</c:v>
                      </c:pt>
                      <c:pt idx="200">
                        <c:v>500</c:v>
                      </c:pt>
                      <c:pt idx="201">
                        <c:v>499</c:v>
                      </c:pt>
                      <c:pt idx="202">
                        <c:v>498</c:v>
                      </c:pt>
                      <c:pt idx="203">
                        <c:v>497</c:v>
                      </c:pt>
                      <c:pt idx="204">
                        <c:v>496</c:v>
                      </c:pt>
                      <c:pt idx="205">
                        <c:v>495</c:v>
                      </c:pt>
                      <c:pt idx="206">
                        <c:v>494</c:v>
                      </c:pt>
                      <c:pt idx="207">
                        <c:v>493</c:v>
                      </c:pt>
                      <c:pt idx="208">
                        <c:v>492</c:v>
                      </c:pt>
                      <c:pt idx="209">
                        <c:v>491</c:v>
                      </c:pt>
                      <c:pt idx="210">
                        <c:v>490</c:v>
                      </c:pt>
                      <c:pt idx="211">
                        <c:v>489</c:v>
                      </c:pt>
                      <c:pt idx="212">
                        <c:v>488</c:v>
                      </c:pt>
                      <c:pt idx="213">
                        <c:v>487</c:v>
                      </c:pt>
                      <c:pt idx="214">
                        <c:v>486</c:v>
                      </c:pt>
                      <c:pt idx="215">
                        <c:v>485</c:v>
                      </c:pt>
                      <c:pt idx="216">
                        <c:v>484</c:v>
                      </c:pt>
                      <c:pt idx="217">
                        <c:v>483</c:v>
                      </c:pt>
                      <c:pt idx="218">
                        <c:v>482</c:v>
                      </c:pt>
                      <c:pt idx="219">
                        <c:v>481</c:v>
                      </c:pt>
                      <c:pt idx="220">
                        <c:v>480</c:v>
                      </c:pt>
                      <c:pt idx="221">
                        <c:v>479</c:v>
                      </c:pt>
                      <c:pt idx="222">
                        <c:v>478</c:v>
                      </c:pt>
                      <c:pt idx="223">
                        <c:v>477</c:v>
                      </c:pt>
                      <c:pt idx="224">
                        <c:v>476</c:v>
                      </c:pt>
                      <c:pt idx="225">
                        <c:v>475</c:v>
                      </c:pt>
                      <c:pt idx="226">
                        <c:v>474</c:v>
                      </c:pt>
                      <c:pt idx="227">
                        <c:v>473</c:v>
                      </c:pt>
                      <c:pt idx="228">
                        <c:v>472</c:v>
                      </c:pt>
                      <c:pt idx="229">
                        <c:v>471</c:v>
                      </c:pt>
                      <c:pt idx="230">
                        <c:v>470</c:v>
                      </c:pt>
                      <c:pt idx="231">
                        <c:v>469</c:v>
                      </c:pt>
                      <c:pt idx="232">
                        <c:v>468</c:v>
                      </c:pt>
                      <c:pt idx="233">
                        <c:v>467</c:v>
                      </c:pt>
                      <c:pt idx="234">
                        <c:v>466</c:v>
                      </c:pt>
                      <c:pt idx="235">
                        <c:v>465</c:v>
                      </c:pt>
                      <c:pt idx="236">
                        <c:v>464</c:v>
                      </c:pt>
                      <c:pt idx="237">
                        <c:v>463</c:v>
                      </c:pt>
                      <c:pt idx="238">
                        <c:v>462</c:v>
                      </c:pt>
                      <c:pt idx="239">
                        <c:v>461</c:v>
                      </c:pt>
                      <c:pt idx="240">
                        <c:v>460</c:v>
                      </c:pt>
                      <c:pt idx="241">
                        <c:v>459</c:v>
                      </c:pt>
                      <c:pt idx="242">
                        <c:v>458</c:v>
                      </c:pt>
                      <c:pt idx="243">
                        <c:v>457</c:v>
                      </c:pt>
                      <c:pt idx="244">
                        <c:v>456</c:v>
                      </c:pt>
                      <c:pt idx="245">
                        <c:v>455</c:v>
                      </c:pt>
                      <c:pt idx="246">
                        <c:v>454</c:v>
                      </c:pt>
                      <c:pt idx="247">
                        <c:v>453</c:v>
                      </c:pt>
                      <c:pt idx="248">
                        <c:v>452</c:v>
                      </c:pt>
                      <c:pt idx="249">
                        <c:v>451</c:v>
                      </c:pt>
                      <c:pt idx="250">
                        <c:v>450</c:v>
                      </c:pt>
                      <c:pt idx="251">
                        <c:v>449</c:v>
                      </c:pt>
                      <c:pt idx="252">
                        <c:v>448</c:v>
                      </c:pt>
                      <c:pt idx="253">
                        <c:v>447</c:v>
                      </c:pt>
                      <c:pt idx="254">
                        <c:v>446</c:v>
                      </c:pt>
                      <c:pt idx="255">
                        <c:v>445</c:v>
                      </c:pt>
                      <c:pt idx="256">
                        <c:v>444</c:v>
                      </c:pt>
                      <c:pt idx="257">
                        <c:v>443</c:v>
                      </c:pt>
                      <c:pt idx="258">
                        <c:v>442</c:v>
                      </c:pt>
                      <c:pt idx="259">
                        <c:v>441</c:v>
                      </c:pt>
                      <c:pt idx="260">
                        <c:v>440</c:v>
                      </c:pt>
                      <c:pt idx="261">
                        <c:v>439</c:v>
                      </c:pt>
                      <c:pt idx="262">
                        <c:v>438</c:v>
                      </c:pt>
                      <c:pt idx="263">
                        <c:v>437</c:v>
                      </c:pt>
                      <c:pt idx="264">
                        <c:v>436</c:v>
                      </c:pt>
                      <c:pt idx="265">
                        <c:v>435</c:v>
                      </c:pt>
                      <c:pt idx="266">
                        <c:v>434</c:v>
                      </c:pt>
                      <c:pt idx="267">
                        <c:v>433</c:v>
                      </c:pt>
                      <c:pt idx="268">
                        <c:v>432</c:v>
                      </c:pt>
                      <c:pt idx="269">
                        <c:v>431</c:v>
                      </c:pt>
                      <c:pt idx="270">
                        <c:v>430</c:v>
                      </c:pt>
                      <c:pt idx="271">
                        <c:v>429</c:v>
                      </c:pt>
                      <c:pt idx="272">
                        <c:v>428</c:v>
                      </c:pt>
                      <c:pt idx="273">
                        <c:v>427</c:v>
                      </c:pt>
                      <c:pt idx="274">
                        <c:v>426</c:v>
                      </c:pt>
                      <c:pt idx="275">
                        <c:v>425</c:v>
                      </c:pt>
                      <c:pt idx="276">
                        <c:v>424</c:v>
                      </c:pt>
                      <c:pt idx="277">
                        <c:v>423</c:v>
                      </c:pt>
                      <c:pt idx="278">
                        <c:v>422</c:v>
                      </c:pt>
                      <c:pt idx="279">
                        <c:v>421</c:v>
                      </c:pt>
                      <c:pt idx="280">
                        <c:v>420</c:v>
                      </c:pt>
                      <c:pt idx="281">
                        <c:v>419</c:v>
                      </c:pt>
                      <c:pt idx="282">
                        <c:v>418</c:v>
                      </c:pt>
                      <c:pt idx="283">
                        <c:v>417</c:v>
                      </c:pt>
                      <c:pt idx="284">
                        <c:v>416</c:v>
                      </c:pt>
                      <c:pt idx="285">
                        <c:v>415</c:v>
                      </c:pt>
                      <c:pt idx="286">
                        <c:v>414</c:v>
                      </c:pt>
                      <c:pt idx="287">
                        <c:v>413</c:v>
                      </c:pt>
                      <c:pt idx="288">
                        <c:v>412</c:v>
                      </c:pt>
                      <c:pt idx="289">
                        <c:v>411</c:v>
                      </c:pt>
                      <c:pt idx="290">
                        <c:v>410</c:v>
                      </c:pt>
                      <c:pt idx="291">
                        <c:v>409</c:v>
                      </c:pt>
                      <c:pt idx="292">
                        <c:v>408</c:v>
                      </c:pt>
                      <c:pt idx="293">
                        <c:v>407</c:v>
                      </c:pt>
                      <c:pt idx="294">
                        <c:v>406</c:v>
                      </c:pt>
                      <c:pt idx="295">
                        <c:v>405</c:v>
                      </c:pt>
                      <c:pt idx="296">
                        <c:v>404</c:v>
                      </c:pt>
                      <c:pt idx="297">
                        <c:v>403</c:v>
                      </c:pt>
                      <c:pt idx="298">
                        <c:v>402</c:v>
                      </c:pt>
                      <c:pt idx="299">
                        <c:v>401</c:v>
                      </c:pt>
                      <c:pt idx="300">
                        <c:v>400</c:v>
                      </c:pt>
                      <c:pt idx="301">
                        <c:v>399</c:v>
                      </c:pt>
                      <c:pt idx="302">
                        <c:v>398</c:v>
                      </c:pt>
                      <c:pt idx="303">
                        <c:v>397</c:v>
                      </c:pt>
                      <c:pt idx="304">
                        <c:v>396</c:v>
                      </c:pt>
                      <c:pt idx="305">
                        <c:v>395</c:v>
                      </c:pt>
                      <c:pt idx="306">
                        <c:v>394</c:v>
                      </c:pt>
                      <c:pt idx="307">
                        <c:v>393</c:v>
                      </c:pt>
                      <c:pt idx="308">
                        <c:v>392</c:v>
                      </c:pt>
                      <c:pt idx="309">
                        <c:v>391</c:v>
                      </c:pt>
                      <c:pt idx="310">
                        <c:v>390</c:v>
                      </c:pt>
                      <c:pt idx="311">
                        <c:v>389</c:v>
                      </c:pt>
                      <c:pt idx="312">
                        <c:v>388</c:v>
                      </c:pt>
                      <c:pt idx="313">
                        <c:v>387</c:v>
                      </c:pt>
                      <c:pt idx="314">
                        <c:v>386</c:v>
                      </c:pt>
                      <c:pt idx="315">
                        <c:v>385</c:v>
                      </c:pt>
                      <c:pt idx="316">
                        <c:v>384</c:v>
                      </c:pt>
                      <c:pt idx="317">
                        <c:v>383</c:v>
                      </c:pt>
                      <c:pt idx="318">
                        <c:v>382</c:v>
                      </c:pt>
                      <c:pt idx="319">
                        <c:v>381</c:v>
                      </c:pt>
                      <c:pt idx="320">
                        <c:v>380</c:v>
                      </c:pt>
                      <c:pt idx="321">
                        <c:v>379</c:v>
                      </c:pt>
                      <c:pt idx="322">
                        <c:v>378</c:v>
                      </c:pt>
                      <c:pt idx="323">
                        <c:v>377</c:v>
                      </c:pt>
                      <c:pt idx="324">
                        <c:v>376</c:v>
                      </c:pt>
                      <c:pt idx="325">
                        <c:v>375</c:v>
                      </c:pt>
                      <c:pt idx="326">
                        <c:v>374</c:v>
                      </c:pt>
                      <c:pt idx="327">
                        <c:v>373</c:v>
                      </c:pt>
                      <c:pt idx="328">
                        <c:v>372</c:v>
                      </c:pt>
                      <c:pt idx="329">
                        <c:v>371</c:v>
                      </c:pt>
                      <c:pt idx="330">
                        <c:v>370</c:v>
                      </c:pt>
                      <c:pt idx="331">
                        <c:v>369</c:v>
                      </c:pt>
                      <c:pt idx="332">
                        <c:v>368</c:v>
                      </c:pt>
                      <c:pt idx="333">
                        <c:v>367</c:v>
                      </c:pt>
                      <c:pt idx="334">
                        <c:v>366</c:v>
                      </c:pt>
                      <c:pt idx="335">
                        <c:v>365</c:v>
                      </c:pt>
                      <c:pt idx="336">
                        <c:v>364</c:v>
                      </c:pt>
                      <c:pt idx="337">
                        <c:v>363</c:v>
                      </c:pt>
                      <c:pt idx="338">
                        <c:v>362</c:v>
                      </c:pt>
                      <c:pt idx="339">
                        <c:v>361</c:v>
                      </c:pt>
                      <c:pt idx="340">
                        <c:v>360</c:v>
                      </c:pt>
                      <c:pt idx="341">
                        <c:v>359</c:v>
                      </c:pt>
                      <c:pt idx="342">
                        <c:v>358</c:v>
                      </c:pt>
                      <c:pt idx="343">
                        <c:v>357</c:v>
                      </c:pt>
                      <c:pt idx="344">
                        <c:v>356</c:v>
                      </c:pt>
                      <c:pt idx="345">
                        <c:v>355</c:v>
                      </c:pt>
                      <c:pt idx="346">
                        <c:v>354</c:v>
                      </c:pt>
                      <c:pt idx="347">
                        <c:v>353</c:v>
                      </c:pt>
                      <c:pt idx="348">
                        <c:v>352</c:v>
                      </c:pt>
                      <c:pt idx="349">
                        <c:v>351</c:v>
                      </c:pt>
                      <c:pt idx="350">
                        <c:v>350</c:v>
                      </c:pt>
                      <c:pt idx="351">
                        <c:v>349</c:v>
                      </c:pt>
                      <c:pt idx="352">
                        <c:v>348</c:v>
                      </c:pt>
                      <c:pt idx="353">
                        <c:v>347</c:v>
                      </c:pt>
                      <c:pt idx="354">
                        <c:v>346</c:v>
                      </c:pt>
                      <c:pt idx="355">
                        <c:v>345</c:v>
                      </c:pt>
                      <c:pt idx="356">
                        <c:v>344</c:v>
                      </c:pt>
                      <c:pt idx="357">
                        <c:v>343</c:v>
                      </c:pt>
                      <c:pt idx="358">
                        <c:v>342</c:v>
                      </c:pt>
                      <c:pt idx="359">
                        <c:v>341</c:v>
                      </c:pt>
                      <c:pt idx="360">
                        <c:v>340</c:v>
                      </c:pt>
                      <c:pt idx="361">
                        <c:v>339</c:v>
                      </c:pt>
                      <c:pt idx="362">
                        <c:v>338</c:v>
                      </c:pt>
                      <c:pt idx="363">
                        <c:v>337</c:v>
                      </c:pt>
                      <c:pt idx="364">
                        <c:v>336</c:v>
                      </c:pt>
                      <c:pt idx="365">
                        <c:v>335</c:v>
                      </c:pt>
                      <c:pt idx="366">
                        <c:v>334</c:v>
                      </c:pt>
                      <c:pt idx="367">
                        <c:v>333</c:v>
                      </c:pt>
                      <c:pt idx="368">
                        <c:v>332</c:v>
                      </c:pt>
                      <c:pt idx="369">
                        <c:v>331</c:v>
                      </c:pt>
                      <c:pt idx="370">
                        <c:v>330</c:v>
                      </c:pt>
                      <c:pt idx="371">
                        <c:v>329</c:v>
                      </c:pt>
                      <c:pt idx="372">
                        <c:v>328</c:v>
                      </c:pt>
                      <c:pt idx="373">
                        <c:v>327</c:v>
                      </c:pt>
                      <c:pt idx="374">
                        <c:v>326</c:v>
                      </c:pt>
                      <c:pt idx="375">
                        <c:v>325</c:v>
                      </c:pt>
                      <c:pt idx="376">
                        <c:v>324</c:v>
                      </c:pt>
                      <c:pt idx="377">
                        <c:v>323</c:v>
                      </c:pt>
                      <c:pt idx="378">
                        <c:v>322</c:v>
                      </c:pt>
                      <c:pt idx="379">
                        <c:v>321</c:v>
                      </c:pt>
                      <c:pt idx="380">
                        <c:v>320</c:v>
                      </c:pt>
                      <c:pt idx="381">
                        <c:v>319</c:v>
                      </c:pt>
                      <c:pt idx="382">
                        <c:v>318</c:v>
                      </c:pt>
                      <c:pt idx="383">
                        <c:v>317</c:v>
                      </c:pt>
                      <c:pt idx="384">
                        <c:v>316</c:v>
                      </c:pt>
                      <c:pt idx="385">
                        <c:v>315</c:v>
                      </c:pt>
                      <c:pt idx="386">
                        <c:v>314</c:v>
                      </c:pt>
                      <c:pt idx="387">
                        <c:v>313</c:v>
                      </c:pt>
                      <c:pt idx="388">
                        <c:v>312</c:v>
                      </c:pt>
                      <c:pt idx="389">
                        <c:v>311</c:v>
                      </c:pt>
                      <c:pt idx="390">
                        <c:v>310</c:v>
                      </c:pt>
                      <c:pt idx="391">
                        <c:v>309</c:v>
                      </c:pt>
                      <c:pt idx="392">
                        <c:v>308</c:v>
                      </c:pt>
                      <c:pt idx="393">
                        <c:v>307</c:v>
                      </c:pt>
                      <c:pt idx="394">
                        <c:v>306</c:v>
                      </c:pt>
                      <c:pt idx="395">
                        <c:v>305</c:v>
                      </c:pt>
                      <c:pt idx="396">
                        <c:v>304</c:v>
                      </c:pt>
                      <c:pt idx="397">
                        <c:v>303</c:v>
                      </c:pt>
                      <c:pt idx="398">
                        <c:v>302</c:v>
                      </c:pt>
                      <c:pt idx="399">
                        <c:v>301</c:v>
                      </c:pt>
                      <c:pt idx="400">
                        <c:v>300</c:v>
                      </c:pt>
                      <c:pt idx="401">
                        <c:v>299</c:v>
                      </c:pt>
                      <c:pt idx="402">
                        <c:v>298</c:v>
                      </c:pt>
                      <c:pt idx="403">
                        <c:v>297</c:v>
                      </c:pt>
                      <c:pt idx="404">
                        <c:v>296</c:v>
                      </c:pt>
                      <c:pt idx="405">
                        <c:v>295</c:v>
                      </c:pt>
                      <c:pt idx="406">
                        <c:v>294</c:v>
                      </c:pt>
                      <c:pt idx="407">
                        <c:v>293</c:v>
                      </c:pt>
                      <c:pt idx="408">
                        <c:v>292</c:v>
                      </c:pt>
                      <c:pt idx="409">
                        <c:v>291</c:v>
                      </c:pt>
                      <c:pt idx="410">
                        <c:v>290</c:v>
                      </c:pt>
                      <c:pt idx="411">
                        <c:v>289</c:v>
                      </c:pt>
                      <c:pt idx="412">
                        <c:v>288</c:v>
                      </c:pt>
                      <c:pt idx="413">
                        <c:v>287</c:v>
                      </c:pt>
                      <c:pt idx="414">
                        <c:v>286</c:v>
                      </c:pt>
                      <c:pt idx="415">
                        <c:v>285</c:v>
                      </c:pt>
                      <c:pt idx="416">
                        <c:v>284</c:v>
                      </c:pt>
                      <c:pt idx="417">
                        <c:v>283</c:v>
                      </c:pt>
                      <c:pt idx="418">
                        <c:v>282</c:v>
                      </c:pt>
                      <c:pt idx="419">
                        <c:v>281</c:v>
                      </c:pt>
                      <c:pt idx="420">
                        <c:v>280</c:v>
                      </c:pt>
                      <c:pt idx="421">
                        <c:v>279</c:v>
                      </c:pt>
                      <c:pt idx="422">
                        <c:v>278</c:v>
                      </c:pt>
                      <c:pt idx="423">
                        <c:v>277</c:v>
                      </c:pt>
                      <c:pt idx="424">
                        <c:v>276</c:v>
                      </c:pt>
                      <c:pt idx="425">
                        <c:v>275</c:v>
                      </c:pt>
                      <c:pt idx="426">
                        <c:v>274</c:v>
                      </c:pt>
                      <c:pt idx="427">
                        <c:v>273</c:v>
                      </c:pt>
                      <c:pt idx="428">
                        <c:v>272</c:v>
                      </c:pt>
                      <c:pt idx="429">
                        <c:v>271</c:v>
                      </c:pt>
                      <c:pt idx="430">
                        <c:v>270</c:v>
                      </c:pt>
                      <c:pt idx="431">
                        <c:v>269</c:v>
                      </c:pt>
                      <c:pt idx="432">
                        <c:v>268</c:v>
                      </c:pt>
                      <c:pt idx="433">
                        <c:v>267</c:v>
                      </c:pt>
                      <c:pt idx="434">
                        <c:v>266</c:v>
                      </c:pt>
                      <c:pt idx="435">
                        <c:v>265</c:v>
                      </c:pt>
                      <c:pt idx="436">
                        <c:v>264</c:v>
                      </c:pt>
                      <c:pt idx="437">
                        <c:v>263</c:v>
                      </c:pt>
                      <c:pt idx="438">
                        <c:v>262</c:v>
                      </c:pt>
                      <c:pt idx="439">
                        <c:v>261</c:v>
                      </c:pt>
                      <c:pt idx="440">
                        <c:v>260</c:v>
                      </c:pt>
                      <c:pt idx="441">
                        <c:v>259</c:v>
                      </c:pt>
                      <c:pt idx="442">
                        <c:v>258</c:v>
                      </c:pt>
                      <c:pt idx="443">
                        <c:v>257</c:v>
                      </c:pt>
                      <c:pt idx="444">
                        <c:v>256</c:v>
                      </c:pt>
                      <c:pt idx="445">
                        <c:v>255</c:v>
                      </c:pt>
                      <c:pt idx="446">
                        <c:v>254</c:v>
                      </c:pt>
                      <c:pt idx="447">
                        <c:v>253</c:v>
                      </c:pt>
                      <c:pt idx="448">
                        <c:v>252</c:v>
                      </c:pt>
                      <c:pt idx="449">
                        <c:v>251</c:v>
                      </c:pt>
                      <c:pt idx="450">
                        <c:v>250</c:v>
                      </c:pt>
                      <c:pt idx="451">
                        <c:v>249</c:v>
                      </c:pt>
                      <c:pt idx="452">
                        <c:v>248</c:v>
                      </c:pt>
                      <c:pt idx="453">
                        <c:v>247</c:v>
                      </c:pt>
                      <c:pt idx="454">
                        <c:v>246</c:v>
                      </c:pt>
                      <c:pt idx="455">
                        <c:v>245</c:v>
                      </c:pt>
                      <c:pt idx="456">
                        <c:v>244</c:v>
                      </c:pt>
                      <c:pt idx="457">
                        <c:v>243</c:v>
                      </c:pt>
                      <c:pt idx="458">
                        <c:v>242</c:v>
                      </c:pt>
                      <c:pt idx="459">
                        <c:v>241</c:v>
                      </c:pt>
                      <c:pt idx="460">
                        <c:v>240</c:v>
                      </c:pt>
                      <c:pt idx="461">
                        <c:v>239</c:v>
                      </c:pt>
                      <c:pt idx="462">
                        <c:v>238</c:v>
                      </c:pt>
                      <c:pt idx="463">
                        <c:v>237</c:v>
                      </c:pt>
                      <c:pt idx="464">
                        <c:v>236</c:v>
                      </c:pt>
                      <c:pt idx="465">
                        <c:v>235</c:v>
                      </c:pt>
                      <c:pt idx="466">
                        <c:v>234</c:v>
                      </c:pt>
                      <c:pt idx="467">
                        <c:v>233</c:v>
                      </c:pt>
                      <c:pt idx="468">
                        <c:v>232</c:v>
                      </c:pt>
                      <c:pt idx="469">
                        <c:v>231</c:v>
                      </c:pt>
                      <c:pt idx="470">
                        <c:v>230</c:v>
                      </c:pt>
                      <c:pt idx="471">
                        <c:v>229</c:v>
                      </c:pt>
                      <c:pt idx="472">
                        <c:v>228</c:v>
                      </c:pt>
                      <c:pt idx="473">
                        <c:v>227</c:v>
                      </c:pt>
                      <c:pt idx="474">
                        <c:v>226</c:v>
                      </c:pt>
                      <c:pt idx="475">
                        <c:v>225</c:v>
                      </c:pt>
                      <c:pt idx="476">
                        <c:v>224</c:v>
                      </c:pt>
                      <c:pt idx="477">
                        <c:v>223</c:v>
                      </c:pt>
                      <c:pt idx="478">
                        <c:v>222</c:v>
                      </c:pt>
                      <c:pt idx="479">
                        <c:v>221</c:v>
                      </c:pt>
                      <c:pt idx="480">
                        <c:v>220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文章选用!$B$2:$B$482</c15:sqref>
                        </c15:formulaRef>
                      </c:ext>
                    </c:extLst>
                    <c:numCache>
                      <c:formatCode>General</c:formatCode>
                      <c:ptCount val="481"/>
                      <c:pt idx="0">
                        <c:v>3.0000000000000001E-3</c:v>
                      </c:pt>
                      <c:pt idx="1">
                        <c:v>3.0000000000000001E-3</c:v>
                      </c:pt>
                      <c:pt idx="2">
                        <c:v>3.0000000000000001E-3</c:v>
                      </c:pt>
                      <c:pt idx="3">
                        <c:v>4.0000000000000001E-3</c:v>
                      </c:pt>
                      <c:pt idx="4">
                        <c:v>4.0000000000000001E-3</c:v>
                      </c:pt>
                      <c:pt idx="5">
                        <c:v>4.0000000000000001E-3</c:v>
                      </c:pt>
                      <c:pt idx="6">
                        <c:v>4.0000000000000001E-3</c:v>
                      </c:pt>
                      <c:pt idx="7">
                        <c:v>4.0000000000000001E-3</c:v>
                      </c:pt>
                      <c:pt idx="8">
                        <c:v>4.0000000000000001E-3</c:v>
                      </c:pt>
                      <c:pt idx="9">
                        <c:v>4.0000000000000001E-3</c:v>
                      </c:pt>
                      <c:pt idx="10">
                        <c:v>4.0000000000000001E-3</c:v>
                      </c:pt>
                      <c:pt idx="11">
                        <c:v>4.0000000000000001E-3</c:v>
                      </c:pt>
                      <c:pt idx="12">
                        <c:v>4.0000000000000001E-3</c:v>
                      </c:pt>
                      <c:pt idx="13">
                        <c:v>4.0000000000000001E-3</c:v>
                      </c:pt>
                      <c:pt idx="14">
                        <c:v>4.0000000000000001E-3</c:v>
                      </c:pt>
                      <c:pt idx="15">
                        <c:v>4.0000000000000001E-3</c:v>
                      </c:pt>
                      <c:pt idx="16">
                        <c:v>4.0000000000000001E-3</c:v>
                      </c:pt>
                      <c:pt idx="17">
                        <c:v>4.0000000000000001E-3</c:v>
                      </c:pt>
                      <c:pt idx="18">
                        <c:v>4.0000000000000001E-3</c:v>
                      </c:pt>
                      <c:pt idx="19">
                        <c:v>4.0000000000000001E-3</c:v>
                      </c:pt>
                      <c:pt idx="20">
                        <c:v>4.0000000000000001E-3</c:v>
                      </c:pt>
                      <c:pt idx="21">
                        <c:v>4.0000000000000001E-3</c:v>
                      </c:pt>
                      <c:pt idx="22">
                        <c:v>4.0000000000000001E-3</c:v>
                      </c:pt>
                      <c:pt idx="23">
                        <c:v>4.0000000000000001E-3</c:v>
                      </c:pt>
                      <c:pt idx="24">
                        <c:v>5.0000000000000001E-3</c:v>
                      </c:pt>
                      <c:pt idx="25">
                        <c:v>5.0000000000000001E-3</c:v>
                      </c:pt>
                      <c:pt idx="26">
                        <c:v>5.0000000000000001E-3</c:v>
                      </c:pt>
                      <c:pt idx="27">
                        <c:v>5.0000000000000001E-3</c:v>
                      </c:pt>
                      <c:pt idx="28">
                        <c:v>5.0000000000000001E-3</c:v>
                      </c:pt>
                      <c:pt idx="29">
                        <c:v>5.0000000000000001E-3</c:v>
                      </c:pt>
                      <c:pt idx="30">
                        <c:v>5.0000000000000001E-3</c:v>
                      </c:pt>
                      <c:pt idx="31">
                        <c:v>5.0000000000000001E-3</c:v>
                      </c:pt>
                      <c:pt idx="32">
                        <c:v>5.0000000000000001E-3</c:v>
                      </c:pt>
                      <c:pt idx="33">
                        <c:v>5.0000000000000001E-3</c:v>
                      </c:pt>
                      <c:pt idx="34">
                        <c:v>5.0000000000000001E-3</c:v>
                      </c:pt>
                      <c:pt idx="35">
                        <c:v>6.0000000000000001E-3</c:v>
                      </c:pt>
                      <c:pt idx="36">
                        <c:v>6.0000000000000001E-3</c:v>
                      </c:pt>
                      <c:pt idx="37">
                        <c:v>6.0000000000000001E-3</c:v>
                      </c:pt>
                      <c:pt idx="38">
                        <c:v>6.0000000000000001E-3</c:v>
                      </c:pt>
                      <c:pt idx="39">
                        <c:v>6.0000000000000001E-3</c:v>
                      </c:pt>
                      <c:pt idx="40">
                        <c:v>6.0000000000000001E-3</c:v>
                      </c:pt>
                      <c:pt idx="41">
                        <c:v>6.0000000000000001E-3</c:v>
                      </c:pt>
                      <c:pt idx="42">
                        <c:v>6.0000000000000001E-3</c:v>
                      </c:pt>
                      <c:pt idx="43">
                        <c:v>7.0000000000000001E-3</c:v>
                      </c:pt>
                      <c:pt idx="44">
                        <c:v>7.0000000000000001E-3</c:v>
                      </c:pt>
                      <c:pt idx="45">
                        <c:v>7.0000000000000001E-3</c:v>
                      </c:pt>
                      <c:pt idx="46">
                        <c:v>7.0000000000000001E-3</c:v>
                      </c:pt>
                      <c:pt idx="47">
                        <c:v>7.0000000000000001E-3</c:v>
                      </c:pt>
                      <c:pt idx="48">
                        <c:v>7.0000000000000001E-3</c:v>
                      </c:pt>
                      <c:pt idx="49">
                        <c:v>7.0000000000000001E-3</c:v>
                      </c:pt>
                      <c:pt idx="50">
                        <c:v>7.0000000000000001E-3</c:v>
                      </c:pt>
                      <c:pt idx="51">
                        <c:v>7.0000000000000001E-3</c:v>
                      </c:pt>
                      <c:pt idx="52">
                        <c:v>7.0000000000000001E-3</c:v>
                      </c:pt>
                      <c:pt idx="53">
                        <c:v>7.0000000000000001E-3</c:v>
                      </c:pt>
                      <c:pt idx="54">
                        <c:v>7.0000000000000001E-3</c:v>
                      </c:pt>
                      <c:pt idx="55">
                        <c:v>7.0000000000000001E-3</c:v>
                      </c:pt>
                      <c:pt idx="56">
                        <c:v>7.0000000000000001E-3</c:v>
                      </c:pt>
                      <c:pt idx="57">
                        <c:v>7.0000000000000001E-3</c:v>
                      </c:pt>
                      <c:pt idx="58">
                        <c:v>7.0000000000000001E-3</c:v>
                      </c:pt>
                      <c:pt idx="59">
                        <c:v>7.0000000000000001E-3</c:v>
                      </c:pt>
                      <c:pt idx="60">
                        <c:v>7.0000000000000001E-3</c:v>
                      </c:pt>
                      <c:pt idx="61">
                        <c:v>7.0000000000000001E-3</c:v>
                      </c:pt>
                      <c:pt idx="62">
                        <c:v>7.0000000000000001E-3</c:v>
                      </c:pt>
                      <c:pt idx="63">
                        <c:v>7.0000000000000001E-3</c:v>
                      </c:pt>
                      <c:pt idx="64">
                        <c:v>7.0000000000000001E-3</c:v>
                      </c:pt>
                      <c:pt idx="65">
                        <c:v>7.0000000000000001E-3</c:v>
                      </c:pt>
                      <c:pt idx="66">
                        <c:v>7.0000000000000001E-3</c:v>
                      </c:pt>
                      <c:pt idx="67">
                        <c:v>7.0000000000000001E-3</c:v>
                      </c:pt>
                      <c:pt idx="68">
                        <c:v>7.0000000000000001E-3</c:v>
                      </c:pt>
                      <c:pt idx="69">
                        <c:v>7.0000000000000001E-3</c:v>
                      </c:pt>
                      <c:pt idx="70">
                        <c:v>7.0000000000000001E-3</c:v>
                      </c:pt>
                      <c:pt idx="71">
                        <c:v>7.0000000000000001E-3</c:v>
                      </c:pt>
                      <c:pt idx="72">
                        <c:v>7.0000000000000001E-3</c:v>
                      </c:pt>
                      <c:pt idx="73">
                        <c:v>7.0000000000000001E-3</c:v>
                      </c:pt>
                      <c:pt idx="74">
                        <c:v>7.0000000000000001E-3</c:v>
                      </c:pt>
                      <c:pt idx="75">
                        <c:v>7.0000000000000001E-3</c:v>
                      </c:pt>
                      <c:pt idx="76">
                        <c:v>7.0000000000000001E-3</c:v>
                      </c:pt>
                      <c:pt idx="77">
                        <c:v>7.0000000000000001E-3</c:v>
                      </c:pt>
                      <c:pt idx="78">
                        <c:v>7.0000000000000001E-3</c:v>
                      </c:pt>
                      <c:pt idx="79">
                        <c:v>7.0000000000000001E-3</c:v>
                      </c:pt>
                      <c:pt idx="80">
                        <c:v>7.0000000000000001E-3</c:v>
                      </c:pt>
                      <c:pt idx="81">
                        <c:v>7.0000000000000001E-3</c:v>
                      </c:pt>
                      <c:pt idx="82">
                        <c:v>8.0000000000000002E-3</c:v>
                      </c:pt>
                      <c:pt idx="83">
                        <c:v>8.0000000000000002E-3</c:v>
                      </c:pt>
                      <c:pt idx="84">
                        <c:v>8.0000000000000002E-3</c:v>
                      </c:pt>
                      <c:pt idx="85">
                        <c:v>8.0000000000000002E-3</c:v>
                      </c:pt>
                      <c:pt idx="86">
                        <c:v>8.0000000000000002E-3</c:v>
                      </c:pt>
                      <c:pt idx="87">
                        <c:v>8.9999999999999993E-3</c:v>
                      </c:pt>
                      <c:pt idx="88">
                        <c:v>8.9999999999999993E-3</c:v>
                      </c:pt>
                      <c:pt idx="89">
                        <c:v>8.9999999999999993E-3</c:v>
                      </c:pt>
                      <c:pt idx="90">
                        <c:v>0.01</c:v>
                      </c:pt>
                      <c:pt idx="91">
                        <c:v>0.01</c:v>
                      </c:pt>
                      <c:pt idx="92">
                        <c:v>1.0999999999999999E-2</c:v>
                      </c:pt>
                      <c:pt idx="93">
                        <c:v>1.2E-2</c:v>
                      </c:pt>
                      <c:pt idx="94">
                        <c:v>1.2999999999999999E-2</c:v>
                      </c:pt>
                      <c:pt idx="95">
                        <c:v>1.4E-2</c:v>
                      </c:pt>
                      <c:pt idx="96">
                        <c:v>1.4999999999999999E-2</c:v>
                      </c:pt>
                      <c:pt idx="97">
                        <c:v>1.6E-2</c:v>
                      </c:pt>
                      <c:pt idx="98">
                        <c:v>1.7999999999999999E-2</c:v>
                      </c:pt>
                      <c:pt idx="99">
                        <c:v>0.02</c:v>
                      </c:pt>
                      <c:pt idx="100">
                        <c:v>2.1999999999999999E-2</c:v>
                      </c:pt>
                      <c:pt idx="101">
                        <c:v>2.5000000000000001E-2</c:v>
                      </c:pt>
                      <c:pt idx="102">
                        <c:v>2.9000000000000001E-2</c:v>
                      </c:pt>
                      <c:pt idx="103">
                        <c:v>3.3000000000000002E-2</c:v>
                      </c:pt>
                      <c:pt idx="104">
                        <c:v>3.7999999999999999E-2</c:v>
                      </c:pt>
                      <c:pt idx="105">
                        <c:v>4.2999999999999997E-2</c:v>
                      </c:pt>
                      <c:pt idx="106">
                        <c:v>0.05</c:v>
                      </c:pt>
                      <c:pt idx="107">
                        <c:v>5.8000000000000003E-2</c:v>
                      </c:pt>
                      <c:pt idx="108">
                        <c:v>6.8000000000000005E-2</c:v>
                      </c:pt>
                      <c:pt idx="109">
                        <c:v>7.9000000000000001E-2</c:v>
                      </c:pt>
                      <c:pt idx="110">
                        <c:v>9.0999999999999998E-2</c:v>
                      </c:pt>
                      <c:pt idx="111">
                        <c:v>0.105</c:v>
                      </c:pt>
                      <c:pt idx="112">
                        <c:v>0.122</c:v>
                      </c:pt>
                      <c:pt idx="113">
                        <c:v>0.14000000000000001</c:v>
                      </c:pt>
                      <c:pt idx="114">
                        <c:v>0.161</c:v>
                      </c:pt>
                      <c:pt idx="115">
                        <c:v>0.183</c:v>
                      </c:pt>
                      <c:pt idx="116">
                        <c:v>0.20699999999999999</c:v>
                      </c:pt>
                      <c:pt idx="117">
                        <c:v>0.23300000000000001</c:v>
                      </c:pt>
                      <c:pt idx="118">
                        <c:v>0.26</c:v>
                      </c:pt>
                      <c:pt idx="119">
                        <c:v>0.28799999999999998</c:v>
                      </c:pt>
                      <c:pt idx="120">
                        <c:v>0.317</c:v>
                      </c:pt>
                      <c:pt idx="121">
                        <c:v>0.34599999999999997</c:v>
                      </c:pt>
                      <c:pt idx="122">
                        <c:v>0.375</c:v>
                      </c:pt>
                      <c:pt idx="123">
                        <c:v>0.40500000000000003</c:v>
                      </c:pt>
                      <c:pt idx="124">
                        <c:v>0.434</c:v>
                      </c:pt>
                      <c:pt idx="125">
                        <c:v>0.46400000000000002</c:v>
                      </c:pt>
                      <c:pt idx="126">
                        <c:v>0.49299999999999999</c:v>
                      </c:pt>
                      <c:pt idx="127">
                        <c:v>0.52</c:v>
                      </c:pt>
                      <c:pt idx="128">
                        <c:v>0.54600000000000004</c:v>
                      </c:pt>
                      <c:pt idx="129">
                        <c:v>0.57099999999999995</c:v>
                      </c:pt>
                      <c:pt idx="130">
                        <c:v>0.59399999999999997</c:v>
                      </c:pt>
                      <c:pt idx="131">
                        <c:v>0.61499999999999999</c:v>
                      </c:pt>
                      <c:pt idx="132">
                        <c:v>0.63400000000000001</c:v>
                      </c:pt>
                      <c:pt idx="133">
                        <c:v>0.65200000000000002</c:v>
                      </c:pt>
                      <c:pt idx="134">
                        <c:v>0.66700000000000004</c:v>
                      </c:pt>
                      <c:pt idx="135">
                        <c:v>0.68100000000000005</c:v>
                      </c:pt>
                      <c:pt idx="136">
                        <c:v>0.69299999999999995</c:v>
                      </c:pt>
                      <c:pt idx="137">
                        <c:v>0.70299999999999996</c:v>
                      </c:pt>
                      <c:pt idx="138">
                        <c:v>0.71</c:v>
                      </c:pt>
                      <c:pt idx="139">
                        <c:v>0.71599999999999997</c:v>
                      </c:pt>
                      <c:pt idx="140">
                        <c:v>0.72</c:v>
                      </c:pt>
                      <c:pt idx="141">
                        <c:v>0.72099999999999997</c:v>
                      </c:pt>
                      <c:pt idx="142">
                        <c:v>0.72099999999999997</c:v>
                      </c:pt>
                      <c:pt idx="143">
                        <c:v>0.71799999999999997</c:v>
                      </c:pt>
                      <c:pt idx="144">
                        <c:v>0.71399999999999997</c:v>
                      </c:pt>
                      <c:pt idx="145">
                        <c:v>0.70899999999999996</c:v>
                      </c:pt>
                      <c:pt idx="146">
                        <c:v>0.70199999999999996</c:v>
                      </c:pt>
                      <c:pt idx="147">
                        <c:v>0.69299999999999995</c:v>
                      </c:pt>
                      <c:pt idx="148">
                        <c:v>0.68400000000000005</c:v>
                      </c:pt>
                      <c:pt idx="149">
                        <c:v>0.67300000000000004</c:v>
                      </c:pt>
                      <c:pt idx="150">
                        <c:v>0.66100000000000003</c:v>
                      </c:pt>
                      <c:pt idx="151">
                        <c:v>0.65</c:v>
                      </c:pt>
                      <c:pt idx="152">
                        <c:v>0.63800000000000001</c:v>
                      </c:pt>
                      <c:pt idx="153">
                        <c:v>0.627</c:v>
                      </c:pt>
                      <c:pt idx="154">
                        <c:v>0.61599999999999999</c:v>
                      </c:pt>
                      <c:pt idx="155">
                        <c:v>0.60699999999999998</c:v>
                      </c:pt>
                      <c:pt idx="156">
                        <c:v>0.59799999999999998</c:v>
                      </c:pt>
                      <c:pt idx="157">
                        <c:v>0.59099999999999997</c:v>
                      </c:pt>
                      <c:pt idx="158">
                        <c:v>0.58499999999999996</c:v>
                      </c:pt>
                      <c:pt idx="159">
                        <c:v>0.58099999999999996</c:v>
                      </c:pt>
                      <c:pt idx="160">
                        <c:v>0.57799999999999996</c:v>
                      </c:pt>
                      <c:pt idx="161">
                        <c:v>0.57699999999999996</c:v>
                      </c:pt>
                      <c:pt idx="162">
                        <c:v>0.57799999999999996</c:v>
                      </c:pt>
                      <c:pt idx="163">
                        <c:v>0.58099999999999996</c:v>
                      </c:pt>
                      <c:pt idx="164">
                        <c:v>0.58499999999999996</c:v>
                      </c:pt>
                      <c:pt idx="165">
                        <c:v>0.59</c:v>
                      </c:pt>
                      <c:pt idx="166">
                        <c:v>0.59699999999999998</c:v>
                      </c:pt>
                      <c:pt idx="167">
                        <c:v>0.60499999999999998</c:v>
                      </c:pt>
                      <c:pt idx="168">
                        <c:v>0.61299999999999999</c:v>
                      </c:pt>
                      <c:pt idx="169">
                        <c:v>0.622</c:v>
                      </c:pt>
                      <c:pt idx="170">
                        <c:v>0.63100000000000001</c:v>
                      </c:pt>
                      <c:pt idx="171">
                        <c:v>0.64</c:v>
                      </c:pt>
                      <c:pt idx="172">
                        <c:v>0.64900000000000002</c:v>
                      </c:pt>
                      <c:pt idx="173">
                        <c:v>0.65700000000000003</c:v>
                      </c:pt>
                      <c:pt idx="174">
                        <c:v>0.66500000000000004</c:v>
                      </c:pt>
                      <c:pt idx="175">
                        <c:v>0.67200000000000004</c:v>
                      </c:pt>
                      <c:pt idx="176">
                        <c:v>0.67700000000000005</c:v>
                      </c:pt>
                      <c:pt idx="177">
                        <c:v>0.68100000000000005</c:v>
                      </c:pt>
                      <c:pt idx="178">
                        <c:v>0.68400000000000005</c:v>
                      </c:pt>
                      <c:pt idx="179">
                        <c:v>0.68500000000000005</c:v>
                      </c:pt>
                      <c:pt idx="180">
                        <c:v>0.68400000000000005</c:v>
                      </c:pt>
                      <c:pt idx="181">
                        <c:v>0.68200000000000005</c:v>
                      </c:pt>
                      <c:pt idx="182">
                        <c:v>0.67900000000000005</c:v>
                      </c:pt>
                      <c:pt idx="183">
                        <c:v>0.67400000000000004</c:v>
                      </c:pt>
                      <c:pt idx="184">
                        <c:v>0.66700000000000004</c:v>
                      </c:pt>
                      <c:pt idx="185">
                        <c:v>0.65900000000000003</c:v>
                      </c:pt>
                      <c:pt idx="186">
                        <c:v>0.64900000000000002</c:v>
                      </c:pt>
                      <c:pt idx="187">
                        <c:v>0.63700000000000001</c:v>
                      </c:pt>
                      <c:pt idx="188">
                        <c:v>0.625</c:v>
                      </c:pt>
                      <c:pt idx="189">
                        <c:v>0.61199999999999999</c:v>
                      </c:pt>
                      <c:pt idx="190">
                        <c:v>0.59799999999999998</c:v>
                      </c:pt>
                      <c:pt idx="191">
                        <c:v>0.58299999999999996</c:v>
                      </c:pt>
                      <c:pt idx="192">
                        <c:v>0.56799999999999995</c:v>
                      </c:pt>
                      <c:pt idx="193">
                        <c:v>0.55300000000000005</c:v>
                      </c:pt>
                      <c:pt idx="194">
                        <c:v>0.53800000000000003</c:v>
                      </c:pt>
                      <c:pt idx="195">
                        <c:v>0.52200000000000002</c:v>
                      </c:pt>
                      <c:pt idx="196">
                        <c:v>0.50700000000000001</c:v>
                      </c:pt>
                      <c:pt idx="197">
                        <c:v>0.49099999999999999</c:v>
                      </c:pt>
                      <c:pt idx="198">
                        <c:v>0.47599999999999998</c:v>
                      </c:pt>
                      <c:pt idx="199">
                        <c:v>0.46200000000000002</c:v>
                      </c:pt>
                      <c:pt idx="200">
                        <c:v>0.44800000000000001</c:v>
                      </c:pt>
                      <c:pt idx="201">
                        <c:v>0.435</c:v>
                      </c:pt>
                      <c:pt idx="202">
                        <c:v>0.42299999999999999</c:v>
                      </c:pt>
                      <c:pt idx="203">
                        <c:v>0.41099999999999998</c:v>
                      </c:pt>
                      <c:pt idx="204">
                        <c:v>0.4</c:v>
                      </c:pt>
                      <c:pt idx="205">
                        <c:v>0.38900000000000001</c:v>
                      </c:pt>
                      <c:pt idx="206">
                        <c:v>0.379</c:v>
                      </c:pt>
                      <c:pt idx="207">
                        <c:v>0.36899999999999999</c:v>
                      </c:pt>
                      <c:pt idx="208">
                        <c:v>0.35899999999999999</c:v>
                      </c:pt>
                      <c:pt idx="209">
                        <c:v>0.34899999999999998</c:v>
                      </c:pt>
                      <c:pt idx="210">
                        <c:v>0.33800000000000002</c:v>
                      </c:pt>
                      <c:pt idx="211">
                        <c:v>0.32800000000000001</c:v>
                      </c:pt>
                      <c:pt idx="212">
                        <c:v>0.318</c:v>
                      </c:pt>
                      <c:pt idx="213">
                        <c:v>0.308</c:v>
                      </c:pt>
                      <c:pt idx="214">
                        <c:v>0.29699999999999999</c:v>
                      </c:pt>
                      <c:pt idx="215">
                        <c:v>0.28699999999999998</c:v>
                      </c:pt>
                      <c:pt idx="216">
                        <c:v>0.27600000000000002</c:v>
                      </c:pt>
                      <c:pt idx="217">
                        <c:v>0.26600000000000001</c:v>
                      </c:pt>
                      <c:pt idx="218">
                        <c:v>0.255</c:v>
                      </c:pt>
                      <c:pt idx="219">
                        <c:v>0.24399999999999999</c:v>
                      </c:pt>
                      <c:pt idx="220">
                        <c:v>0.23300000000000001</c:v>
                      </c:pt>
                      <c:pt idx="221">
                        <c:v>0.222</c:v>
                      </c:pt>
                      <c:pt idx="222">
                        <c:v>0.21099999999999999</c:v>
                      </c:pt>
                      <c:pt idx="223">
                        <c:v>0.2</c:v>
                      </c:pt>
                      <c:pt idx="224">
                        <c:v>0.19</c:v>
                      </c:pt>
                      <c:pt idx="225">
                        <c:v>0.18</c:v>
                      </c:pt>
                      <c:pt idx="226">
                        <c:v>0.17</c:v>
                      </c:pt>
                      <c:pt idx="227">
                        <c:v>0.161</c:v>
                      </c:pt>
                      <c:pt idx="228">
                        <c:v>0.153</c:v>
                      </c:pt>
                      <c:pt idx="229">
                        <c:v>0.14399999999999999</c:v>
                      </c:pt>
                      <c:pt idx="230">
                        <c:v>0.13700000000000001</c:v>
                      </c:pt>
                      <c:pt idx="231">
                        <c:v>0.129</c:v>
                      </c:pt>
                      <c:pt idx="232">
                        <c:v>0.123</c:v>
                      </c:pt>
                      <c:pt idx="233">
                        <c:v>0.11600000000000001</c:v>
                      </c:pt>
                      <c:pt idx="234">
                        <c:v>0.11</c:v>
                      </c:pt>
                      <c:pt idx="235">
                        <c:v>0.104</c:v>
                      </c:pt>
                      <c:pt idx="236">
                        <c:v>9.9000000000000005E-2</c:v>
                      </c:pt>
                      <c:pt idx="237">
                        <c:v>9.4E-2</c:v>
                      </c:pt>
                      <c:pt idx="238">
                        <c:v>8.8999999999999996E-2</c:v>
                      </c:pt>
                      <c:pt idx="239">
                        <c:v>8.5000000000000006E-2</c:v>
                      </c:pt>
                      <c:pt idx="240">
                        <c:v>8.1000000000000003E-2</c:v>
                      </c:pt>
                      <c:pt idx="241">
                        <c:v>7.6999999999999999E-2</c:v>
                      </c:pt>
                      <c:pt idx="242">
                        <c:v>7.2999999999999995E-2</c:v>
                      </c:pt>
                      <c:pt idx="243">
                        <c:v>6.9000000000000006E-2</c:v>
                      </c:pt>
                      <c:pt idx="244">
                        <c:v>6.6000000000000003E-2</c:v>
                      </c:pt>
                      <c:pt idx="245">
                        <c:v>6.3E-2</c:v>
                      </c:pt>
                      <c:pt idx="246">
                        <c:v>5.8999999999999997E-2</c:v>
                      </c:pt>
                      <c:pt idx="247">
                        <c:v>5.6000000000000001E-2</c:v>
                      </c:pt>
                      <c:pt idx="248">
                        <c:v>5.2999999999999999E-2</c:v>
                      </c:pt>
                      <c:pt idx="249">
                        <c:v>5.0999999999999997E-2</c:v>
                      </c:pt>
                      <c:pt idx="250">
                        <c:v>4.8000000000000001E-2</c:v>
                      </c:pt>
                      <c:pt idx="251">
                        <c:v>4.5999999999999999E-2</c:v>
                      </c:pt>
                      <c:pt idx="252">
                        <c:v>4.2999999999999997E-2</c:v>
                      </c:pt>
                      <c:pt idx="253">
                        <c:v>4.1000000000000002E-2</c:v>
                      </c:pt>
                      <c:pt idx="254">
                        <c:v>3.9E-2</c:v>
                      </c:pt>
                      <c:pt idx="255">
                        <c:v>3.6999999999999998E-2</c:v>
                      </c:pt>
                      <c:pt idx="256">
                        <c:v>3.5000000000000003E-2</c:v>
                      </c:pt>
                      <c:pt idx="257">
                        <c:v>3.3000000000000002E-2</c:v>
                      </c:pt>
                      <c:pt idx="258">
                        <c:v>3.1E-2</c:v>
                      </c:pt>
                      <c:pt idx="259">
                        <c:v>2.9000000000000001E-2</c:v>
                      </c:pt>
                      <c:pt idx="260">
                        <c:v>2.8000000000000001E-2</c:v>
                      </c:pt>
                      <c:pt idx="261">
                        <c:v>2.5999999999999999E-2</c:v>
                      </c:pt>
                      <c:pt idx="262">
                        <c:v>2.5000000000000001E-2</c:v>
                      </c:pt>
                      <c:pt idx="263">
                        <c:v>2.4E-2</c:v>
                      </c:pt>
                      <c:pt idx="264">
                        <c:v>2.3E-2</c:v>
                      </c:pt>
                      <c:pt idx="265">
                        <c:v>2.1000000000000001E-2</c:v>
                      </c:pt>
                      <c:pt idx="266">
                        <c:v>0.02</c:v>
                      </c:pt>
                      <c:pt idx="267">
                        <c:v>0.02</c:v>
                      </c:pt>
                      <c:pt idx="268">
                        <c:v>1.9E-2</c:v>
                      </c:pt>
                      <c:pt idx="269">
                        <c:v>1.7999999999999999E-2</c:v>
                      </c:pt>
                      <c:pt idx="270">
                        <c:v>1.7000000000000001E-2</c:v>
                      </c:pt>
                      <c:pt idx="271">
                        <c:v>1.6E-2</c:v>
                      </c:pt>
                      <c:pt idx="272">
                        <c:v>1.6E-2</c:v>
                      </c:pt>
                      <c:pt idx="273">
                        <c:v>1.4999999999999999E-2</c:v>
                      </c:pt>
                      <c:pt idx="274">
                        <c:v>1.4999999999999999E-2</c:v>
                      </c:pt>
                      <c:pt idx="275">
                        <c:v>1.4E-2</c:v>
                      </c:pt>
                      <c:pt idx="276">
                        <c:v>1.4E-2</c:v>
                      </c:pt>
                      <c:pt idx="277">
                        <c:v>1.2999999999999999E-2</c:v>
                      </c:pt>
                      <c:pt idx="278">
                        <c:v>1.2999999999999999E-2</c:v>
                      </c:pt>
                      <c:pt idx="279">
                        <c:v>1.2E-2</c:v>
                      </c:pt>
                      <c:pt idx="280">
                        <c:v>1.2E-2</c:v>
                      </c:pt>
                      <c:pt idx="281">
                        <c:v>1.2E-2</c:v>
                      </c:pt>
                      <c:pt idx="282">
                        <c:v>1.0999999999999999E-2</c:v>
                      </c:pt>
                      <c:pt idx="283">
                        <c:v>1.0999999999999999E-2</c:v>
                      </c:pt>
                      <c:pt idx="284">
                        <c:v>1.0999999999999999E-2</c:v>
                      </c:pt>
                      <c:pt idx="285">
                        <c:v>1.0999999999999999E-2</c:v>
                      </c:pt>
                      <c:pt idx="286">
                        <c:v>0.01</c:v>
                      </c:pt>
                      <c:pt idx="287">
                        <c:v>0.01</c:v>
                      </c:pt>
                      <c:pt idx="288">
                        <c:v>0.01</c:v>
                      </c:pt>
                      <c:pt idx="289">
                        <c:v>0.01</c:v>
                      </c:pt>
                      <c:pt idx="290">
                        <c:v>0.01</c:v>
                      </c:pt>
                      <c:pt idx="291">
                        <c:v>0.01</c:v>
                      </c:pt>
                      <c:pt idx="292">
                        <c:v>8.9999999999999993E-3</c:v>
                      </c:pt>
                      <c:pt idx="293">
                        <c:v>8.9999999999999993E-3</c:v>
                      </c:pt>
                      <c:pt idx="294">
                        <c:v>8.9999999999999993E-3</c:v>
                      </c:pt>
                      <c:pt idx="295">
                        <c:v>8.9999999999999993E-3</c:v>
                      </c:pt>
                      <c:pt idx="296">
                        <c:v>8.9999999999999993E-3</c:v>
                      </c:pt>
                      <c:pt idx="297">
                        <c:v>8.9999999999999993E-3</c:v>
                      </c:pt>
                      <c:pt idx="298">
                        <c:v>8.9999999999999993E-3</c:v>
                      </c:pt>
                      <c:pt idx="299">
                        <c:v>8.9999999999999993E-3</c:v>
                      </c:pt>
                      <c:pt idx="300">
                        <c:v>8.9999999999999993E-3</c:v>
                      </c:pt>
                      <c:pt idx="301">
                        <c:v>8.9999999999999993E-3</c:v>
                      </c:pt>
                      <c:pt idx="302">
                        <c:v>8.9999999999999993E-3</c:v>
                      </c:pt>
                      <c:pt idx="303">
                        <c:v>8.9999999999999993E-3</c:v>
                      </c:pt>
                      <c:pt idx="304">
                        <c:v>8.9999999999999993E-3</c:v>
                      </c:pt>
                      <c:pt idx="305">
                        <c:v>8.9999999999999993E-3</c:v>
                      </c:pt>
                      <c:pt idx="306">
                        <c:v>8.9999999999999993E-3</c:v>
                      </c:pt>
                      <c:pt idx="307">
                        <c:v>8.9999999999999993E-3</c:v>
                      </c:pt>
                      <c:pt idx="308">
                        <c:v>8.9999999999999993E-3</c:v>
                      </c:pt>
                      <c:pt idx="309">
                        <c:v>8.9999999999999993E-3</c:v>
                      </c:pt>
                      <c:pt idx="310">
                        <c:v>8.9999999999999993E-3</c:v>
                      </c:pt>
                      <c:pt idx="311">
                        <c:v>8.9999999999999993E-3</c:v>
                      </c:pt>
                      <c:pt idx="312">
                        <c:v>8.9999999999999993E-3</c:v>
                      </c:pt>
                      <c:pt idx="313">
                        <c:v>8.9999999999999993E-3</c:v>
                      </c:pt>
                      <c:pt idx="314">
                        <c:v>8.9999999999999993E-3</c:v>
                      </c:pt>
                      <c:pt idx="315">
                        <c:v>0.01</c:v>
                      </c:pt>
                      <c:pt idx="316">
                        <c:v>0.01</c:v>
                      </c:pt>
                      <c:pt idx="317">
                        <c:v>0.01</c:v>
                      </c:pt>
                      <c:pt idx="318">
                        <c:v>0.01</c:v>
                      </c:pt>
                      <c:pt idx="319">
                        <c:v>0.01</c:v>
                      </c:pt>
                      <c:pt idx="320">
                        <c:v>0.01</c:v>
                      </c:pt>
                      <c:pt idx="321">
                        <c:v>0.01</c:v>
                      </c:pt>
                      <c:pt idx="322">
                        <c:v>0.01</c:v>
                      </c:pt>
                      <c:pt idx="323">
                        <c:v>0.01</c:v>
                      </c:pt>
                      <c:pt idx="324">
                        <c:v>1.0999999999999999E-2</c:v>
                      </c:pt>
                      <c:pt idx="325">
                        <c:v>1.0999999999999999E-2</c:v>
                      </c:pt>
                      <c:pt idx="326">
                        <c:v>1.0999999999999999E-2</c:v>
                      </c:pt>
                      <c:pt idx="327">
                        <c:v>1.0999999999999999E-2</c:v>
                      </c:pt>
                      <c:pt idx="328">
                        <c:v>1.2E-2</c:v>
                      </c:pt>
                      <c:pt idx="329">
                        <c:v>1.2E-2</c:v>
                      </c:pt>
                      <c:pt idx="330">
                        <c:v>1.2E-2</c:v>
                      </c:pt>
                      <c:pt idx="331">
                        <c:v>1.2999999999999999E-2</c:v>
                      </c:pt>
                      <c:pt idx="332">
                        <c:v>1.2999999999999999E-2</c:v>
                      </c:pt>
                      <c:pt idx="333">
                        <c:v>1.2999999999999999E-2</c:v>
                      </c:pt>
                      <c:pt idx="334">
                        <c:v>1.4E-2</c:v>
                      </c:pt>
                      <c:pt idx="335">
                        <c:v>1.4E-2</c:v>
                      </c:pt>
                      <c:pt idx="336">
                        <c:v>1.4E-2</c:v>
                      </c:pt>
                      <c:pt idx="337">
                        <c:v>1.4E-2</c:v>
                      </c:pt>
                      <c:pt idx="338">
                        <c:v>1.4E-2</c:v>
                      </c:pt>
                      <c:pt idx="339">
                        <c:v>1.4E-2</c:v>
                      </c:pt>
                      <c:pt idx="340">
                        <c:v>1.4999999999999999E-2</c:v>
                      </c:pt>
                      <c:pt idx="341">
                        <c:v>1.4999999999999999E-2</c:v>
                      </c:pt>
                      <c:pt idx="342">
                        <c:v>1.6E-2</c:v>
                      </c:pt>
                      <c:pt idx="343">
                        <c:v>1.6E-2</c:v>
                      </c:pt>
                      <c:pt idx="344">
                        <c:v>1.7000000000000001E-2</c:v>
                      </c:pt>
                      <c:pt idx="345">
                        <c:v>1.7999999999999999E-2</c:v>
                      </c:pt>
                      <c:pt idx="346">
                        <c:v>1.7999999999999999E-2</c:v>
                      </c:pt>
                      <c:pt idx="347">
                        <c:v>1.9E-2</c:v>
                      </c:pt>
                      <c:pt idx="348">
                        <c:v>0.02</c:v>
                      </c:pt>
                      <c:pt idx="349">
                        <c:v>2.1000000000000001E-2</c:v>
                      </c:pt>
                      <c:pt idx="350">
                        <c:v>2.1000000000000001E-2</c:v>
                      </c:pt>
                      <c:pt idx="351">
                        <c:v>2.1999999999999999E-2</c:v>
                      </c:pt>
                      <c:pt idx="352">
                        <c:v>2.3E-2</c:v>
                      </c:pt>
                      <c:pt idx="353">
                        <c:v>2.4E-2</c:v>
                      </c:pt>
                      <c:pt idx="354">
                        <c:v>2.4E-2</c:v>
                      </c:pt>
                      <c:pt idx="355">
                        <c:v>2.5000000000000001E-2</c:v>
                      </c:pt>
                      <c:pt idx="356">
                        <c:v>2.5000000000000001E-2</c:v>
                      </c:pt>
                      <c:pt idx="357">
                        <c:v>2.5999999999999999E-2</c:v>
                      </c:pt>
                      <c:pt idx="358">
                        <c:v>2.5999999999999999E-2</c:v>
                      </c:pt>
                      <c:pt idx="359">
                        <c:v>2.7E-2</c:v>
                      </c:pt>
                      <c:pt idx="360">
                        <c:v>2.7E-2</c:v>
                      </c:pt>
                      <c:pt idx="361">
                        <c:v>2.7E-2</c:v>
                      </c:pt>
                      <c:pt idx="362">
                        <c:v>2.7E-2</c:v>
                      </c:pt>
                      <c:pt idx="363">
                        <c:v>2.8000000000000001E-2</c:v>
                      </c:pt>
                      <c:pt idx="364">
                        <c:v>2.8000000000000001E-2</c:v>
                      </c:pt>
                      <c:pt idx="365">
                        <c:v>2.8000000000000001E-2</c:v>
                      </c:pt>
                      <c:pt idx="366">
                        <c:v>2.9000000000000001E-2</c:v>
                      </c:pt>
                      <c:pt idx="367">
                        <c:v>2.9000000000000001E-2</c:v>
                      </c:pt>
                      <c:pt idx="368">
                        <c:v>0.03</c:v>
                      </c:pt>
                      <c:pt idx="369">
                        <c:v>0.03</c:v>
                      </c:pt>
                      <c:pt idx="370">
                        <c:v>3.1E-2</c:v>
                      </c:pt>
                      <c:pt idx="371">
                        <c:v>3.1E-2</c:v>
                      </c:pt>
                      <c:pt idx="372">
                        <c:v>3.2000000000000001E-2</c:v>
                      </c:pt>
                      <c:pt idx="373">
                        <c:v>3.2000000000000001E-2</c:v>
                      </c:pt>
                      <c:pt idx="374">
                        <c:v>3.2000000000000001E-2</c:v>
                      </c:pt>
                      <c:pt idx="375">
                        <c:v>3.3000000000000002E-2</c:v>
                      </c:pt>
                      <c:pt idx="376">
                        <c:v>3.3000000000000002E-2</c:v>
                      </c:pt>
                      <c:pt idx="377">
                        <c:v>3.4000000000000002E-2</c:v>
                      </c:pt>
                      <c:pt idx="378">
                        <c:v>3.5000000000000003E-2</c:v>
                      </c:pt>
                      <c:pt idx="379">
                        <c:v>3.5000000000000003E-2</c:v>
                      </c:pt>
                      <c:pt idx="380">
                        <c:v>3.5999999999999997E-2</c:v>
                      </c:pt>
                      <c:pt idx="381">
                        <c:v>3.5999999999999997E-2</c:v>
                      </c:pt>
                      <c:pt idx="382">
                        <c:v>3.6999999999999998E-2</c:v>
                      </c:pt>
                      <c:pt idx="383">
                        <c:v>3.6999999999999998E-2</c:v>
                      </c:pt>
                      <c:pt idx="384">
                        <c:v>3.7999999999999999E-2</c:v>
                      </c:pt>
                      <c:pt idx="385">
                        <c:v>3.7999999999999999E-2</c:v>
                      </c:pt>
                      <c:pt idx="386">
                        <c:v>3.9E-2</c:v>
                      </c:pt>
                      <c:pt idx="387">
                        <c:v>0.04</c:v>
                      </c:pt>
                      <c:pt idx="388">
                        <c:v>4.1000000000000002E-2</c:v>
                      </c:pt>
                      <c:pt idx="389">
                        <c:v>4.2000000000000003E-2</c:v>
                      </c:pt>
                      <c:pt idx="390">
                        <c:v>4.2999999999999997E-2</c:v>
                      </c:pt>
                      <c:pt idx="391">
                        <c:v>4.3999999999999997E-2</c:v>
                      </c:pt>
                      <c:pt idx="392">
                        <c:v>4.5999999999999999E-2</c:v>
                      </c:pt>
                      <c:pt idx="393">
                        <c:v>4.7E-2</c:v>
                      </c:pt>
                      <c:pt idx="394">
                        <c:v>4.9000000000000002E-2</c:v>
                      </c:pt>
                      <c:pt idx="395">
                        <c:v>5.0999999999999997E-2</c:v>
                      </c:pt>
                      <c:pt idx="396">
                        <c:v>5.2999999999999999E-2</c:v>
                      </c:pt>
                      <c:pt idx="397">
                        <c:v>5.6000000000000001E-2</c:v>
                      </c:pt>
                      <c:pt idx="398">
                        <c:v>5.8999999999999997E-2</c:v>
                      </c:pt>
                      <c:pt idx="399">
                        <c:v>6.3E-2</c:v>
                      </c:pt>
                      <c:pt idx="400">
                        <c:v>6.7000000000000004E-2</c:v>
                      </c:pt>
                      <c:pt idx="401">
                        <c:v>7.1999999999999995E-2</c:v>
                      </c:pt>
                      <c:pt idx="402">
                        <c:v>7.6999999999999999E-2</c:v>
                      </c:pt>
                      <c:pt idx="403">
                        <c:v>8.2000000000000003E-2</c:v>
                      </c:pt>
                      <c:pt idx="404">
                        <c:v>8.6999999999999994E-2</c:v>
                      </c:pt>
                      <c:pt idx="405">
                        <c:v>9.1999999999999998E-2</c:v>
                      </c:pt>
                      <c:pt idx="406">
                        <c:v>9.6000000000000002E-2</c:v>
                      </c:pt>
                      <c:pt idx="407">
                        <c:v>0.1</c:v>
                      </c:pt>
                      <c:pt idx="408">
                        <c:v>0.10299999999999999</c:v>
                      </c:pt>
                      <c:pt idx="409">
                        <c:v>0.106</c:v>
                      </c:pt>
                      <c:pt idx="410">
                        <c:v>0.11</c:v>
                      </c:pt>
                      <c:pt idx="411">
                        <c:v>0.113</c:v>
                      </c:pt>
                      <c:pt idx="412">
                        <c:v>0.11600000000000001</c:v>
                      </c:pt>
                      <c:pt idx="413">
                        <c:v>0.11899999999999999</c:v>
                      </c:pt>
                      <c:pt idx="414">
                        <c:v>0.122</c:v>
                      </c:pt>
                      <c:pt idx="415">
                        <c:v>0.125</c:v>
                      </c:pt>
                      <c:pt idx="416">
                        <c:v>0.126</c:v>
                      </c:pt>
                      <c:pt idx="417">
                        <c:v>0.127</c:v>
                      </c:pt>
                      <c:pt idx="418">
                        <c:v>0.126</c:v>
                      </c:pt>
                      <c:pt idx="419">
                        <c:v>0.125</c:v>
                      </c:pt>
                      <c:pt idx="420">
                        <c:v>0.123</c:v>
                      </c:pt>
                      <c:pt idx="421">
                        <c:v>0.121</c:v>
                      </c:pt>
                      <c:pt idx="422">
                        <c:v>0.11899999999999999</c:v>
                      </c:pt>
                      <c:pt idx="423">
                        <c:v>0.11600000000000001</c:v>
                      </c:pt>
                      <c:pt idx="424">
                        <c:v>0.113</c:v>
                      </c:pt>
                      <c:pt idx="425">
                        <c:v>0.109</c:v>
                      </c:pt>
                      <c:pt idx="426">
                        <c:v>0.106</c:v>
                      </c:pt>
                      <c:pt idx="427">
                        <c:v>0.10299999999999999</c:v>
                      </c:pt>
                      <c:pt idx="428">
                        <c:v>9.9000000000000005E-2</c:v>
                      </c:pt>
                      <c:pt idx="429">
                        <c:v>9.6000000000000002E-2</c:v>
                      </c:pt>
                      <c:pt idx="430">
                        <c:v>9.2999999999999999E-2</c:v>
                      </c:pt>
                      <c:pt idx="431">
                        <c:v>9.0999999999999998E-2</c:v>
                      </c:pt>
                      <c:pt idx="432">
                        <c:v>8.8999999999999996E-2</c:v>
                      </c:pt>
                      <c:pt idx="433">
                        <c:v>8.5999999999999993E-2</c:v>
                      </c:pt>
                      <c:pt idx="434">
                        <c:v>8.5000000000000006E-2</c:v>
                      </c:pt>
                      <c:pt idx="435">
                        <c:v>8.3000000000000004E-2</c:v>
                      </c:pt>
                      <c:pt idx="436">
                        <c:v>8.2000000000000003E-2</c:v>
                      </c:pt>
                      <c:pt idx="437">
                        <c:v>8.1000000000000003E-2</c:v>
                      </c:pt>
                      <c:pt idx="438">
                        <c:v>8.1000000000000003E-2</c:v>
                      </c:pt>
                      <c:pt idx="439">
                        <c:v>0.08</c:v>
                      </c:pt>
                      <c:pt idx="440">
                        <c:v>0.08</c:v>
                      </c:pt>
                      <c:pt idx="441">
                        <c:v>0.08</c:v>
                      </c:pt>
                      <c:pt idx="442">
                        <c:v>0.08</c:v>
                      </c:pt>
                      <c:pt idx="443">
                        <c:v>0.08</c:v>
                      </c:pt>
                      <c:pt idx="444">
                        <c:v>0.08</c:v>
                      </c:pt>
                      <c:pt idx="445">
                        <c:v>0.08</c:v>
                      </c:pt>
                      <c:pt idx="446">
                        <c:v>0.08</c:v>
                      </c:pt>
                      <c:pt idx="447">
                        <c:v>0.08</c:v>
                      </c:pt>
                      <c:pt idx="448">
                        <c:v>0.08</c:v>
                      </c:pt>
                      <c:pt idx="449">
                        <c:v>0.08</c:v>
                      </c:pt>
                      <c:pt idx="450">
                        <c:v>0.08</c:v>
                      </c:pt>
                      <c:pt idx="451">
                        <c:v>8.1000000000000003E-2</c:v>
                      </c:pt>
                      <c:pt idx="452">
                        <c:v>8.1000000000000003E-2</c:v>
                      </c:pt>
                      <c:pt idx="453">
                        <c:v>8.1000000000000003E-2</c:v>
                      </c:pt>
                      <c:pt idx="454">
                        <c:v>8.1000000000000003E-2</c:v>
                      </c:pt>
                      <c:pt idx="455">
                        <c:v>8.2000000000000003E-2</c:v>
                      </c:pt>
                      <c:pt idx="456">
                        <c:v>8.3000000000000004E-2</c:v>
                      </c:pt>
                      <c:pt idx="457">
                        <c:v>8.4000000000000005E-2</c:v>
                      </c:pt>
                      <c:pt idx="458">
                        <c:v>8.5999999999999993E-2</c:v>
                      </c:pt>
                      <c:pt idx="459">
                        <c:v>8.7999999999999995E-2</c:v>
                      </c:pt>
                      <c:pt idx="460">
                        <c:v>0.09</c:v>
                      </c:pt>
                      <c:pt idx="461">
                        <c:v>9.2999999999999999E-2</c:v>
                      </c:pt>
                      <c:pt idx="462">
                        <c:v>9.7000000000000003E-2</c:v>
                      </c:pt>
                      <c:pt idx="463">
                        <c:v>0.10199999999999999</c:v>
                      </c:pt>
                      <c:pt idx="464">
                        <c:v>0.107</c:v>
                      </c:pt>
                      <c:pt idx="465">
                        <c:v>0.114</c:v>
                      </c:pt>
                      <c:pt idx="466">
                        <c:v>0.122</c:v>
                      </c:pt>
                      <c:pt idx="467">
                        <c:v>0.13200000000000001</c:v>
                      </c:pt>
                      <c:pt idx="468">
                        <c:v>0.14399999999999999</c:v>
                      </c:pt>
                      <c:pt idx="469">
                        <c:v>0.159</c:v>
                      </c:pt>
                      <c:pt idx="470">
                        <c:v>0.17599999999999999</c:v>
                      </c:pt>
                      <c:pt idx="471">
                        <c:v>0.19800000000000001</c:v>
                      </c:pt>
                      <c:pt idx="472">
                        <c:v>0.224</c:v>
                      </c:pt>
                      <c:pt idx="473">
                        <c:v>0.25700000000000001</c:v>
                      </c:pt>
                      <c:pt idx="474">
                        <c:v>0.29699999999999999</c:v>
                      </c:pt>
                      <c:pt idx="475">
                        <c:v>0.34499999999999997</c:v>
                      </c:pt>
                      <c:pt idx="476">
                        <c:v>0.40100000000000002</c:v>
                      </c:pt>
                      <c:pt idx="477">
                        <c:v>0.46700000000000003</c:v>
                      </c:pt>
                      <c:pt idx="478">
                        <c:v>0.54400000000000004</c:v>
                      </c:pt>
                      <c:pt idx="479">
                        <c:v>0.60899999999999999</c:v>
                      </c:pt>
                      <c:pt idx="480">
                        <c:v>0.67400000000000004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3-AF63-4D21-8E9E-8ED987C04AD3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文章选用!$C$1</c15:sqref>
                        </c15:formulaRef>
                      </c:ext>
                    </c:extLst>
                    <c:strCache>
                      <c:ptCount val="1"/>
                      <c:pt idx="0">
                        <c:v>PMnS</c:v>
                      </c:pt>
                    </c:strCache>
                  </c:strRef>
                </c:tx>
                <c:spPr>
                  <a:ln w="19050" cap="rnd">
                    <a:solidFill>
                      <a:schemeClr val="tx1"/>
                    </a:solidFill>
                    <a:round/>
                  </a:ln>
                  <a:effectLst/>
                </c:spPr>
                <c:marker>
                  <c:symbol val="none"/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文章选用!$A$2:$A$482</c15:sqref>
                        </c15:formulaRef>
                      </c:ext>
                    </c:extLst>
                    <c:numCache>
                      <c:formatCode>General</c:formatCode>
                      <c:ptCount val="481"/>
                      <c:pt idx="0">
                        <c:v>700</c:v>
                      </c:pt>
                      <c:pt idx="1">
                        <c:v>699</c:v>
                      </c:pt>
                      <c:pt idx="2">
                        <c:v>698</c:v>
                      </c:pt>
                      <c:pt idx="3">
                        <c:v>697</c:v>
                      </c:pt>
                      <c:pt idx="4">
                        <c:v>696</c:v>
                      </c:pt>
                      <c:pt idx="5">
                        <c:v>695</c:v>
                      </c:pt>
                      <c:pt idx="6">
                        <c:v>694</c:v>
                      </c:pt>
                      <c:pt idx="7">
                        <c:v>693</c:v>
                      </c:pt>
                      <c:pt idx="8">
                        <c:v>692</c:v>
                      </c:pt>
                      <c:pt idx="9">
                        <c:v>691</c:v>
                      </c:pt>
                      <c:pt idx="10">
                        <c:v>690</c:v>
                      </c:pt>
                      <c:pt idx="11">
                        <c:v>689</c:v>
                      </c:pt>
                      <c:pt idx="12">
                        <c:v>688</c:v>
                      </c:pt>
                      <c:pt idx="13">
                        <c:v>687</c:v>
                      </c:pt>
                      <c:pt idx="14">
                        <c:v>686</c:v>
                      </c:pt>
                      <c:pt idx="15">
                        <c:v>685</c:v>
                      </c:pt>
                      <c:pt idx="16">
                        <c:v>684</c:v>
                      </c:pt>
                      <c:pt idx="17">
                        <c:v>683</c:v>
                      </c:pt>
                      <c:pt idx="18">
                        <c:v>682</c:v>
                      </c:pt>
                      <c:pt idx="19">
                        <c:v>681</c:v>
                      </c:pt>
                      <c:pt idx="20">
                        <c:v>680</c:v>
                      </c:pt>
                      <c:pt idx="21">
                        <c:v>679</c:v>
                      </c:pt>
                      <c:pt idx="22">
                        <c:v>678</c:v>
                      </c:pt>
                      <c:pt idx="23">
                        <c:v>677</c:v>
                      </c:pt>
                      <c:pt idx="24">
                        <c:v>676</c:v>
                      </c:pt>
                      <c:pt idx="25">
                        <c:v>675</c:v>
                      </c:pt>
                      <c:pt idx="26">
                        <c:v>674</c:v>
                      </c:pt>
                      <c:pt idx="27">
                        <c:v>673</c:v>
                      </c:pt>
                      <c:pt idx="28">
                        <c:v>672</c:v>
                      </c:pt>
                      <c:pt idx="29">
                        <c:v>671</c:v>
                      </c:pt>
                      <c:pt idx="30">
                        <c:v>670</c:v>
                      </c:pt>
                      <c:pt idx="31">
                        <c:v>669</c:v>
                      </c:pt>
                      <c:pt idx="32">
                        <c:v>668</c:v>
                      </c:pt>
                      <c:pt idx="33">
                        <c:v>667</c:v>
                      </c:pt>
                      <c:pt idx="34">
                        <c:v>666</c:v>
                      </c:pt>
                      <c:pt idx="35">
                        <c:v>665</c:v>
                      </c:pt>
                      <c:pt idx="36">
                        <c:v>664</c:v>
                      </c:pt>
                      <c:pt idx="37">
                        <c:v>663</c:v>
                      </c:pt>
                      <c:pt idx="38">
                        <c:v>662</c:v>
                      </c:pt>
                      <c:pt idx="39">
                        <c:v>661</c:v>
                      </c:pt>
                      <c:pt idx="40">
                        <c:v>660</c:v>
                      </c:pt>
                      <c:pt idx="41">
                        <c:v>659</c:v>
                      </c:pt>
                      <c:pt idx="42">
                        <c:v>658</c:v>
                      </c:pt>
                      <c:pt idx="43">
                        <c:v>657</c:v>
                      </c:pt>
                      <c:pt idx="44">
                        <c:v>656</c:v>
                      </c:pt>
                      <c:pt idx="45">
                        <c:v>655</c:v>
                      </c:pt>
                      <c:pt idx="46">
                        <c:v>654</c:v>
                      </c:pt>
                      <c:pt idx="47">
                        <c:v>653</c:v>
                      </c:pt>
                      <c:pt idx="48">
                        <c:v>652</c:v>
                      </c:pt>
                      <c:pt idx="49">
                        <c:v>651</c:v>
                      </c:pt>
                      <c:pt idx="50">
                        <c:v>650</c:v>
                      </c:pt>
                      <c:pt idx="51">
                        <c:v>649</c:v>
                      </c:pt>
                      <c:pt idx="52">
                        <c:v>648</c:v>
                      </c:pt>
                      <c:pt idx="53">
                        <c:v>647</c:v>
                      </c:pt>
                      <c:pt idx="54">
                        <c:v>646</c:v>
                      </c:pt>
                      <c:pt idx="55">
                        <c:v>645</c:v>
                      </c:pt>
                      <c:pt idx="56">
                        <c:v>644</c:v>
                      </c:pt>
                      <c:pt idx="57">
                        <c:v>643</c:v>
                      </c:pt>
                      <c:pt idx="58">
                        <c:v>642</c:v>
                      </c:pt>
                      <c:pt idx="59">
                        <c:v>641</c:v>
                      </c:pt>
                      <c:pt idx="60">
                        <c:v>640</c:v>
                      </c:pt>
                      <c:pt idx="61">
                        <c:v>639</c:v>
                      </c:pt>
                      <c:pt idx="62">
                        <c:v>638</c:v>
                      </c:pt>
                      <c:pt idx="63">
                        <c:v>637</c:v>
                      </c:pt>
                      <c:pt idx="64">
                        <c:v>636</c:v>
                      </c:pt>
                      <c:pt idx="65">
                        <c:v>635</c:v>
                      </c:pt>
                      <c:pt idx="66">
                        <c:v>634</c:v>
                      </c:pt>
                      <c:pt idx="67">
                        <c:v>633</c:v>
                      </c:pt>
                      <c:pt idx="68">
                        <c:v>632</c:v>
                      </c:pt>
                      <c:pt idx="69">
                        <c:v>631</c:v>
                      </c:pt>
                      <c:pt idx="70">
                        <c:v>630</c:v>
                      </c:pt>
                      <c:pt idx="71">
                        <c:v>629</c:v>
                      </c:pt>
                      <c:pt idx="72">
                        <c:v>628</c:v>
                      </c:pt>
                      <c:pt idx="73">
                        <c:v>627</c:v>
                      </c:pt>
                      <c:pt idx="74">
                        <c:v>626</c:v>
                      </c:pt>
                      <c:pt idx="75">
                        <c:v>625</c:v>
                      </c:pt>
                      <c:pt idx="76">
                        <c:v>624</c:v>
                      </c:pt>
                      <c:pt idx="77">
                        <c:v>623</c:v>
                      </c:pt>
                      <c:pt idx="78">
                        <c:v>622</c:v>
                      </c:pt>
                      <c:pt idx="79">
                        <c:v>621</c:v>
                      </c:pt>
                      <c:pt idx="80">
                        <c:v>620</c:v>
                      </c:pt>
                      <c:pt idx="81">
                        <c:v>619</c:v>
                      </c:pt>
                      <c:pt idx="82">
                        <c:v>618</c:v>
                      </c:pt>
                      <c:pt idx="83">
                        <c:v>617</c:v>
                      </c:pt>
                      <c:pt idx="84">
                        <c:v>616</c:v>
                      </c:pt>
                      <c:pt idx="85">
                        <c:v>615</c:v>
                      </c:pt>
                      <c:pt idx="86">
                        <c:v>614</c:v>
                      </c:pt>
                      <c:pt idx="87">
                        <c:v>613</c:v>
                      </c:pt>
                      <c:pt idx="88">
                        <c:v>612</c:v>
                      </c:pt>
                      <c:pt idx="89">
                        <c:v>611</c:v>
                      </c:pt>
                      <c:pt idx="90">
                        <c:v>610</c:v>
                      </c:pt>
                      <c:pt idx="91">
                        <c:v>609</c:v>
                      </c:pt>
                      <c:pt idx="92">
                        <c:v>608</c:v>
                      </c:pt>
                      <c:pt idx="93">
                        <c:v>607</c:v>
                      </c:pt>
                      <c:pt idx="94">
                        <c:v>606</c:v>
                      </c:pt>
                      <c:pt idx="95">
                        <c:v>605</c:v>
                      </c:pt>
                      <c:pt idx="96">
                        <c:v>604</c:v>
                      </c:pt>
                      <c:pt idx="97">
                        <c:v>603</c:v>
                      </c:pt>
                      <c:pt idx="98">
                        <c:v>602</c:v>
                      </c:pt>
                      <c:pt idx="99">
                        <c:v>601</c:v>
                      </c:pt>
                      <c:pt idx="100">
                        <c:v>600</c:v>
                      </c:pt>
                      <c:pt idx="101">
                        <c:v>599</c:v>
                      </c:pt>
                      <c:pt idx="102">
                        <c:v>598</c:v>
                      </c:pt>
                      <c:pt idx="103">
                        <c:v>597</c:v>
                      </c:pt>
                      <c:pt idx="104">
                        <c:v>596</c:v>
                      </c:pt>
                      <c:pt idx="105">
                        <c:v>595</c:v>
                      </c:pt>
                      <c:pt idx="106">
                        <c:v>594</c:v>
                      </c:pt>
                      <c:pt idx="107">
                        <c:v>593</c:v>
                      </c:pt>
                      <c:pt idx="108">
                        <c:v>592</c:v>
                      </c:pt>
                      <c:pt idx="109">
                        <c:v>591</c:v>
                      </c:pt>
                      <c:pt idx="110">
                        <c:v>590</c:v>
                      </c:pt>
                      <c:pt idx="111">
                        <c:v>589</c:v>
                      </c:pt>
                      <c:pt idx="112">
                        <c:v>588</c:v>
                      </c:pt>
                      <c:pt idx="113">
                        <c:v>587</c:v>
                      </c:pt>
                      <c:pt idx="114">
                        <c:v>586</c:v>
                      </c:pt>
                      <c:pt idx="115">
                        <c:v>585</c:v>
                      </c:pt>
                      <c:pt idx="116">
                        <c:v>584</c:v>
                      </c:pt>
                      <c:pt idx="117">
                        <c:v>583</c:v>
                      </c:pt>
                      <c:pt idx="118">
                        <c:v>582</c:v>
                      </c:pt>
                      <c:pt idx="119">
                        <c:v>581</c:v>
                      </c:pt>
                      <c:pt idx="120">
                        <c:v>580</c:v>
                      </c:pt>
                      <c:pt idx="121">
                        <c:v>579</c:v>
                      </c:pt>
                      <c:pt idx="122">
                        <c:v>578</c:v>
                      </c:pt>
                      <c:pt idx="123">
                        <c:v>577</c:v>
                      </c:pt>
                      <c:pt idx="124">
                        <c:v>576</c:v>
                      </c:pt>
                      <c:pt idx="125">
                        <c:v>575</c:v>
                      </c:pt>
                      <c:pt idx="126">
                        <c:v>574</c:v>
                      </c:pt>
                      <c:pt idx="127">
                        <c:v>573</c:v>
                      </c:pt>
                      <c:pt idx="128">
                        <c:v>572</c:v>
                      </c:pt>
                      <c:pt idx="129">
                        <c:v>571</c:v>
                      </c:pt>
                      <c:pt idx="130">
                        <c:v>570</c:v>
                      </c:pt>
                      <c:pt idx="131">
                        <c:v>569</c:v>
                      </c:pt>
                      <c:pt idx="132">
                        <c:v>568</c:v>
                      </c:pt>
                      <c:pt idx="133">
                        <c:v>567</c:v>
                      </c:pt>
                      <c:pt idx="134">
                        <c:v>566</c:v>
                      </c:pt>
                      <c:pt idx="135">
                        <c:v>565</c:v>
                      </c:pt>
                      <c:pt idx="136">
                        <c:v>564</c:v>
                      </c:pt>
                      <c:pt idx="137">
                        <c:v>563</c:v>
                      </c:pt>
                      <c:pt idx="138">
                        <c:v>562</c:v>
                      </c:pt>
                      <c:pt idx="139">
                        <c:v>561</c:v>
                      </c:pt>
                      <c:pt idx="140">
                        <c:v>560</c:v>
                      </c:pt>
                      <c:pt idx="141">
                        <c:v>559</c:v>
                      </c:pt>
                      <c:pt idx="142">
                        <c:v>558</c:v>
                      </c:pt>
                      <c:pt idx="143">
                        <c:v>557</c:v>
                      </c:pt>
                      <c:pt idx="144">
                        <c:v>556</c:v>
                      </c:pt>
                      <c:pt idx="145">
                        <c:v>555</c:v>
                      </c:pt>
                      <c:pt idx="146">
                        <c:v>554</c:v>
                      </c:pt>
                      <c:pt idx="147">
                        <c:v>553</c:v>
                      </c:pt>
                      <c:pt idx="148">
                        <c:v>552</c:v>
                      </c:pt>
                      <c:pt idx="149">
                        <c:v>551</c:v>
                      </c:pt>
                      <c:pt idx="150">
                        <c:v>550</c:v>
                      </c:pt>
                      <c:pt idx="151">
                        <c:v>549</c:v>
                      </c:pt>
                      <c:pt idx="152">
                        <c:v>548</c:v>
                      </c:pt>
                      <c:pt idx="153">
                        <c:v>547</c:v>
                      </c:pt>
                      <c:pt idx="154">
                        <c:v>546</c:v>
                      </c:pt>
                      <c:pt idx="155">
                        <c:v>545</c:v>
                      </c:pt>
                      <c:pt idx="156">
                        <c:v>544</c:v>
                      </c:pt>
                      <c:pt idx="157">
                        <c:v>543</c:v>
                      </c:pt>
                      <c:pt idx="158">
                        <c:v>542</c:v>
                      </c:pt>
                      <c:pt idx="159">
                        <c:v>541</c:v>
                      </c:pt>
                      <c:pt idx="160">
                        <c:v>540</c:v>
                      </c:pt>
                      <c:pt idx="161">
                        <c:v>539</c:v>
                      </c:pt>
                      <c:pt idx="162">
                        <c:v>538</c:v>
                      </c:pt>
                      <c:pt idx="163">
                        <c:v>537</c:v>
                      </c:pt>
                      <c:pt idx="164">
                        <c:v>536</c:v>
                      </c:pt>
                      <c:pt idx="165">
                        <c:v>535</c:v>
                      </c:pt>
                      <c:pt idx="166">
                        <c:v>534</c:v>
                      </c:pt>
                      <c:pt idx="167">
                        <c:v>533</c:v>
                      </c:pt>
                      <c:pt idx="168">
                        <c:v>532</c:v>
                      </c:pt>
                      <c:pt idx="169">
                        <c:v>531</c:v>
                      </c:pt>
                      <c:pt idx="170">
                        <c:v>530</c:v>
                      </c:pt>
                      <c:pt idx="171">
                        <c:v>529</c:v>
                      </c:pt>
                      <c:pt idx="172">
                        <c:v>528</c:v>
                      </c:pt>
                      <c:pt idx="173">
                        <c:v>527</c:v>
                      </c:pt>
                      <c:pt idx="174">
                        <c:v>526</c:v>
                      </c:pt>
                      <c:pt idx="175">
                        <c:v>525</c:v>
                      </c:pt>
                      <c:pt idx="176">
                        <c:v>524</c:v>
                      </c:pt>
                      <c:pt idx="177">
                        <c:v>523</c:v>
                      </c:pt>
                      <c:pt idx="178">
                        <c:v>522</c:v>
                      </c:pt>
                      <c:pt idx="179">
                        <c:v>521</c:v>
                      </c:pt>
                      <c:pt idx="180">
                        <c:v>520</c:v>
                      </c:pt>
                      <c:pt idx="181">
                        <c:v>519</c:v>
                      </c:pt>
                      <c:pt idx="182">
                        <c:v>518</c:v>
                      </c:pt>
                      <c:pt idx="183">
                        <c:v>517</c:v>
                      </c:pt>
                      <c:pt idx="184">
                        <c:v>516</c:v>
                      </c:pt>
                      <c:pt idx="185">
                        <c:v>515</c:v>
                      </c:pt>
                      <c:pt idx="186">
                        <c:v>514</c:v>
                      </c:pt>
                      <c:pt idx="187">
                        <c:v>513</c:v>
                      </c:pt>
                      <c:pt idx="188">
                        <c:v>512</c:v>
                      </c:pt>
                      <c:pt idx="189">
                        <c:v>511</c:v>
                      </c:pt>
                      <c:pt idx="190">
                        <c:v>510</c:v>
                      </c:pt>
                      <c:pt idx="191">
                        <c:v>509</c:v>
                      </c:pt>
                      <c:pt idx="192">
                        <c:v>508</c:v>
                      </c:pt>
                      <c:pt idx="193">
                        <c:v>507</c:v>
                      </c:pt>
                      <c:pt idx="194">
                        <c:v>506</c:v>
                      </c:pt>
                      <c:pt idx="195">
                        <c:v>505</c:v>
                      </c:pt>
                      <c:pt idx="196">
                        <c:v>504</c:v>
                      </c:pt>
                      <c:pt idx="197">
                        <c:v>503</c:v>
                      </c:pt>
                      <c:pt idx="198">
                        <c:v>502</c:v>
                      </c:pt>
                      <c:pt idx="199">
                        <c:v>501</c:v>
                      </c:pt>
                      <c:pt idx="200">
                        <c:v>500</c:v>
                      </c:pt>
                      <c:pt idx="201">
                        <c:v>499</c:v>
                      </c:pt>
                      <c:pt idx="202">
                        <c:v>498</c:v>
                      </c:pt>
                      <c:pt idx="203">
                        <c:v>497</c:v>
                      </c:pt>
                      <c:pt idx="204">
                        <c:v>496</c:v>
                      </c:pt>
                      <c:pt idx="205">
                        <c:v>495</c:v>
                      </c:pt>
                      <c:pt idx="206">
                        <c:v>494</c:v>
                      </c:pt>
                      <c:pt idx="207">
                        <c:v>493</c:v>
                      </c:pt>
                      <c:pt idx="208">
                        <c:v>492</c:v>
                      </c:pt>
                      <c:pt idx="209">
                        <c:v>491</c:v>
                      </c:pt>
                      <c:pt idx="210">
                        <c:v>490</c:v>
                      </c:pt>
                      <c:pt idx="211">
                        <c:v>489</c:v>
                      </c:pt>
                      <c:pt idx="212">
                        <c:v>488</c:v>
                      </c:pt>
                      <c:pt idx="213">
                        <c:v>487</c:v>
                      </c:pt>
                      <c:pt idx="214">
                        <c:v>486</c:v>
                      </c:pt>
                      <c:pt idx="215">
                        <c:v>485</c:v>
                      </c:pt>
                      <c:pt idx="216">
                        <c:v>484</c:v>
                      </c:pt>
                      <c:pt idx="217">
                        <c:v>483</c:v>
                      </c:pt>
                      <c:pt idx="218">
                        <c:v>482</c:v>
                      </c:pt>
                      <c:pt idx="219">
                        <c:v>481</c:v>
                      </c:pt>
                      <c:pt idx="220">
                        <c:v>480</c:v>
                      </c:pt>
                      <c:pt idx="221">
                        <c:v>479</c:v>
                      </c:pt>
                      <c:pt idx="222">
                        <c:v>478</c:v>
                      </c:pt>
                      <c:pt idx="223">
                        <c:v>477</c:v>
                      </c:pt>
                      <c:pt idx="224">
                        <c:v>476</c:v>
                      </c:pt>
                      <c:pt idx="225">
                        <c:v>475</c:v>
                      </c:pt>
                      <c:pt idx="226">
                        <c:v>474</c:v>
                      </c:pt>
                      <c:pt idx="227">
                        <c:v>473</c:v>
                      </c:pt>
                      <c:pt idx="228">
                        <c:v>472</c:v>
                      </c:pt>
                      <c:pt idx="229">
                        <c:v>471</c:v>
                      </c:pt>
                      <c:pt idx="230">
                        <c:v>470</c:v>
                      </c:pt>
                      <c:pt idx="231">
                        <c:v>469</c:v>
                      </c:pt>
                      <c:pt idx="232">
                        <c:v>468</c:v>
                      </c:pt>
                      <c:pt idx="233">
                        <c:v>467</c:v>
                      </c:pt>
                      <c:pt idx="234">
                        <c:v>466</c:v>
                      </c:pt>
                      <c:pt idx="235">
                        <c:v>465</c:v>
                      </c:pt>
                      <c:pt idx="236">
                        <c:v>464</c:v>
                      </c:pt>
                      <c:pt idx="237">
                        <c:v>463</c:v>
                      </c:pt>
                      <c:pt idx="238">
                        <c:v>462</c:v>
                      </c:pt>
                      <c:pt idx="239">
                        <c:v>461</c:v>
                      </c:pt>
                      <c:pt idx="240">
                        <c:v>460</c:v>
                      </c:pt>
                      <c:pt idx="241">
                        <c:v>459</c:v>
                      </c:pt>
                      <c:pt idx="242">
                        <c:v>458</c:v>
                      </c:pt>
                      <c:pt idx="243">
                        <c:v>457</c:v>
                      </c:pt>
                      <c:pt idx="244">
                        <c:v>456</c:v>
                      </c:pt>
                      <c:pt idx="245">
                        <c:v>455</c:v>
                      </c:pt>
                      <c:pt idx="246">
                        <c:v>454</c:v>
                      </c:pt>
                      <c:pt idx="247">
                        <c:v>453</c:v>
                      </c:pt>
                      <c:pt idx="248">
                        <c:v>452</c:v>
                      </c:pt>
                      <c:pt idx="249">
                        <c:v>451</c:v>
                      </c:pt>
                      <c:pt idx="250">
                        <c:v>450</c:v>
                      </c:pt>
                      <c:pt idx="251">
                        <c:v>449</c:v>
                      </c:pt>
                      <c:pt idx="252">
                        <c:v>448</c:v>
                      </c:pt>
                      <c:pt idx="253">
                        <c:v>447</c:v>
                      </c:pt>
                      <c:pt idx="254">
                        <c:v>446</c:v>
                      </c:pt>
                      <c:pt idx="255">
                        <c:v>445</c:v>
                      </c:pt>
                      <c:pt idx="256">
                        <c:v>444</c:v>
                      </c:pt>
                      <c:pt idx="257">
                        <c:v>443</c:v>
                      </c:pt>
                      <c:pt idx="258">
                        <c:v>442</c:v>
                      </c:pt>
                      <c:pt idx="259">
                        <c:v>441</c:v>
                      </c:pt>
                      <c:pt idx="260">
                        <c:v>440</c:v>
                      </c:pt>
                      <c:pt idx="261">
                        <c:v>439</c:v>
                      </c:pt>
                      <c:pt idx="262">
                        <c:v>438</c:v>
                      </c:pt>
                      <c:pt idx="263">
                        <c:v>437</c:v>
                      </c:pt>
                      <c:pt idx="264">
                        <c:v>436</c:v>
                      </c:pt>
                      <c:pt idx="265">
                        <c:v>435</c:v>
                      </c:pt>
                      <c:pt idx="266">
                        <c:v>434</c:v>
                      </c:pt>
                      <c:pt idx="267">
                        <c:v>433</c:v>
                      </c:pt>
                      <c:pt idx="268">
                        <c:v>432</c:v>
                      </c:pt>
                      <c:pt idx="269">
                        <c:v>431</c:v>
                      </c:pt>
                      <c:pt idx="270">
                        <c:v>430</c:v>
                      </c:pt>
                      <c:pt idx="271">
                        <c:v>429</c:v>
                      </c:pt>
                      <c:pt idx="272">
                        <c:v>428</c:v>
                      </c:pt>
                      <c:pt idx="273">
                        <c:v>427</c:v>
                      </c:pt>
                      <c:pt idx="274">
                        <c:v>426</c:v>
                      </c:pt>
                      <c:pt idx="275">
                        <c:v>425</c:v>
                      </c:pt>
                      <c:pt idx="276">
                        <c:v>424</c:v>
                      </c:pt>
                      <c:pt idx="277">
                        <c:v>423</c:v>
                      </c:pt>
                      <c:pt idx="278">
                        <c:v>422</c:v>
                      </c:pt>
                      <c:pt idx="279">
                        <c:v>421</c:v>
                      </c:pt>
                      <c:pt idx="280">
                        <c:v>420</c:v>
                      </c:pt>
                      <c:pt idx="281">
                        <c:v>419</c:v>
                      </c:pt>
                      <c:pt idx="282">
                        <c:v>418</c:v>
                      </c:pt>
                      <c:pt idx="283">
                        <c:v>417</c:v>
                      </c:pt>
                      <c:pt idx="284">
                        <c:v>416</c:v>
                      </c:pt>
                      <c:pt idx="285">
                        <c:v>415</c:v>
                      </c:pt>
                      <c:pt idx="286">
                        <c:v>414</c:v>
                      </c:pt>
                      <c:pt idx="287">
                        <c:v>413</c:v>
                      </c:pt>
                      <c:pt idx="288">
                        <c:v>412</c:v>
                      </c:pt>
                      <c:pt idx="289">
                        <c:v>411</c:v>
                      </c:pt>
                      <c:pt idx="290">
                        <c:v>410</c:v>
                      </c:pt>
                      <c:pt idx="291">
                        <c:v>409</c:v>
                      </c:pt>
                      <c:pt idx="292">
                        <c:v>408</c:v>
                      </c:pt>
                      <c:pt idx="293">
                        <c:v>407</c:v>
                      </c:pt>
                      <c:pt idx="294">
                        <c:v>406</c:v>
                      </c:pt>
                      <c:pt idx="295">
                        <c:v>405</c:v>
                      </c:pt>
                      <c:pt idx="296">
                        <c:v>404</c:v>
                      </c:pt>
                      <c:pt idx="297">
                        <c:v>403</c:v>
                      </c:pt>
                      <c:pt idx="298">
                        <c:v>402</c:v>
                      </c:pt>
                      <c:pt idx="299">
                        <c:v>401</c:v>
                      </c:pt>
                      <c:pt idx="300">
                        <c:v>400</c:v>
                      </c:pt>
                      <c:pt idx="301">
                        <c:v>399</c:v>
                      </c:pt>
                      <c:pt idx="302">
                        <c:v>398</c:v>
                      </c:pt>
                      <c:pt idx="303">
                        <c:v>397</c:v>
                      </c:pt>
                      <c:pt idx="304">
                        <c:v>396</c:v>
                      </c:pt>
                      <c:pt idx="305">
                        <c:v>395</c:v>
                      </c:pt>
                      <c:pt idx="306">
                        <c:v>394</c:v>
                      </c:pt>
                      <c:pt idx="307">
                        <c:v>393</c:v>
                      </c:pt>
                      <c:pt idx="308">
                        <c:v>392</c:v>
                      </c:pt>
                      <c:pt idx="309">
                        <c:v>391</c:v>
                      </c:pt>
                      <c:pt idx="310">
                        <c:v>390</c:v>
                      </c:pt>
                      <c:pt idx="311">
                        <c:v>389</c:v>
                      </c:pt>
                      <c:pt idx="312">
                        <c:v>388</c:v>
                      </c:pt>
                      <c:pt idx="313">
                        <c:v>387</c:v>
                      </c:pt>
                      <c:pt idx="314">
                        <c:v>386</c:v>
                      </c:pt>
                      <c:pt idx="315">
                        <c:v>385</c:v>
                      </c:pt>
                      <c:pt idx="316">
                        <c:v>384</c:v>
                      </c:pt>
                      <c:pt idx="317">
                        <c:v>383</c:v>
                      </c:pt>
                      <c:pt idx="318">
                        <c:v>382</c:v>
                      </c:pt>
                      <c:pt idx="319">
                        <c:v>381</c:v>
                      </c:pt>
                      <c:pt idx="320">
                        <c:v>380</c:v>
                      </c:pt>
                      <c:pt idx="321">
                        <c:v>379</c:v>
                      </c:pt>
                      <c:pt idx="322">
                        <c:v>378</c:v>
                      </c:pt>
                      <c:pt idx="323">
                        <c:v>377</c:v>
                      </c:pt>
                      <c:pt idx="324">
                        <c:v>376</c:v>
                      </c:pt>
                      <c:pt idx="325">
                        <c:v>375</c:v>
                      </c:pt>
                      <c:pt idx="326">
                        <c:v>374</c:v>
                      </c:pt>
                      <c:pt idx="327">
                        <c:v>373</c:v>
                      </c:pt>
                      <c:pt idx="328">
                        <c:v>372</c:v>
                      </c:pt>
                      <c:pt idx="329">
                        <c:v>371</c:v>
                      </c:pt>
                      <c:pt idx="330">
                        <c:v>370</c:v>
                      </c:pt>
                      <c:pt idx="331">
                        <c:v>369</c:v>
                      </c:pt>
                      <c:pt idx="332">
                        <c:v>368</c:v>
                      </c:pt>
                      <c:pt idx="333">
                        <c:v>367</c:v>
                      </c:pt>
                      <c:pt idx="334">
                        <c:v>366</c:v>
                      </c:pt>
                      <c:pt idx="335">
                        <c:v>365</c:v>
                      </c:pt>
                      <c:pt idx="336">
                        <c:v>364</c:v>
                      </c:pt>
                      <c:pt idx="337">
                        <c:v>363</c:v>
                      </c:pt>
                      <c:pt idx="338">
                        <c:v>362</c:v>
                      </c:pt>
                      <c:pt idx="339">
                        <c:v>361</c:v>
                      </c:pt>
                      <c:pt idx="340">
                        <c:v>360</c:v>
                      </c:pt>
                      <c:pt idx="341">
                        <c:v>359</c:v>
                      </c:pt>
                      <c:pt idx="342">
                        <c:v>358</c:v>
                      </c:pt>
                      <c:pt idx="343">
                        <c:v>357</c:v>
                      </c:pt>
                      <c:pt idx="344">
                        <c:v>356</c:v>
                      </c:pt>
                      <c:pt idx="345">
                        <c:v>355</c:v>
                      </c:pt>
                      <c:pt idx="346">
                        <c:v>354</c:v>
                      </c:pt>
                      <c:pt idx="347">
                        <c:v>353</c:v>
                      </c:pt>
                      <c:pt idx="348">
                        <c:v>352</c:v>
                      </c:pt>
                      <c:pt idx="349">
                        <c:v>351</c:v>
                      </c:pt>
                      <c:pt idx="350">
                        <c:v>350</c:v>
                      </c:pt>
                      <c:pt idx="351">
                        <c:v>349</c:v>
                      </c:pt>
                      <c:pt idx="352">
                        <c:v>348</c:v>
                      </c:pt>
                      <c:pt idx="353">
                        <c:v>347</c:v>
                      </c:pt>
                      <c:pt idx="354">
                        <c:v>346</c:v>
                      </c:pt>
                      <c:pt idx="355">
                        <c:v>345</c:v>
                      </c:pt>
                      <c:pt idx="356">
                        <c:v>344</c:v>
                      </c:pt>
                      <c:pt idx="357">
                        <c:v>343</c:v>
                      </c:pt>
                      <c:pt idx="358">
                        <c:v>342</c:v>
                      </c:pt>
                      <c:pt idx="359">
                        <c:v>341</c:v>
                      </c:pt>
                      <c:pt idx="360">
                        <c:v>340</c:v>
                      </c:pt>
                      <c:pt idx="361">
                        <c:v>339</c:v>
                      </c:pt>
                      <c:pt idx="362">
                        <c:v>338</c:v>
                      </c:pt>
                      <c:pt idx="363">
                        <c:v>337</c:v>
                      </c:pt>
                      <c:pt idx="364">
                        <c:v>336</c:v>
                      </c:pt>
                      <c:pt idx="365">
                        <c:v>335</c:v>
                      </c:pt>
                      <c:pt idx="366">
                        <c:v>334</c:v>
                      </c:pt>
                      <c:pt idx="367">
                        <c:v>333</c:v>
                      </c:pt>
                      <c:pt idx="368">
                        <c:v>332</c:v>
                      </c:pt>
                      <c:pt idx="369">
                        <c:v>331</c:v>
                      </c:pt>
                      <c:pt idx="370">
                        <c:v>330</c:v>
                      </c:pt>
                      <c:pt idx="371">
                        <c:v>329</c:v>
                      </c:pt>
                      <c:pt idx="372">
                        <c:v>328</c:v>
                      </c:pt>
                      <c:pt idx="373">
                        <c:v>327</c:v>
                      </c:pt>
                      <c:pt idx="374">
                        <c:v>326</c:v>
                      </c:pt>
                      <c:pt idx="375">
                        <c:v>325</c:v>
                      </c:pt>
                      <c:pt idx="376">
                        <c:v>324</c:v>
                      </c:pt>
                      <c:pt idx="377">
                        <c:v>323</c:v>
                      </c:pt>
                      <c:pt idx="378">
                        <c:v>322</c:v>
                      </c:pt>
                      <c:pt idx="379">
                        <c:v>321</c:v>
                      </c:pt>
                      <c:pt idx="380">
                        <c:v>320</c:v>
                      </c:pt>
                      <c:pt idx="381">
                        <c:v>319</c:v>
                      </c:pt>
                      <c:pt idx="382">
                        <c:v>318</c:v>
                      </c:pt>
                      <c:pt idx="383">
                        <c:v>317</c:v>
                      </c:pt>
                      <c:pt idx="384">
                        <c:v>316</c:v>
                      </c:pt>
                      <c:pt idx="385">
                        <c:v>315</c:v>
                      </c:pt>
                      <c:pt idx="386">
                        <c:v>314</c:v>
                      </c:pt>
                      <c:pt idx="387">
                        <c:v>313</c:v>
                      </c:pt>
                      <c:pt idx="388">
                        <c:v>312</c:v>
                      </c:pt>
                      <c:pt idx="389">
                        <c:v>311</c:v>
                      </c:pt>
                      <c:pt idx="390">
                        <c:v>310</c:v>
                      </c:pt>
                      <c:pt idx="391">
                        <c:v>309</c:v>
                      </c:pt>
                      <c:pt idx="392">
                        <c:v>308</c:v>
                      </c:pt>
                      <c:pt idx="393">
                        <c:v>307</c:v>
                      </c:pt>
                      <c:pt idx="394">
                        <c:v>306</c:v>
                      </c:pt>
                      <c:pt idx="395">
                        <c:v>305</c:v>
                      </c:pt>
                      <c:pt idx="396">
                        <c:v>304</c:v>
                      </c:pt>
                      <c:pt idx="397">
                        <c:v>303</c:v>
                      </c:pt>
                      <c:pt idx="398">
                        <c:v>302</c:v>
                      </c:pt>
                      <c:pt idx="399">
                        <c:v>301</c:v>
                      </c:pt>
                      <c:pt idx="400">
                        <c:v>300</c:v>
                      </c:pt>
                      <c:pt idx="401">
                        <c:v>299</c:v>
                      </c:pt>
                      <c:pt idx="402">
                        <c:v>298</c:v>
                      </c:pt>
                      <c:pt idx="403">
                        <c:v>297</c:v>
                      </c:pt>
                      <c:pt idx="404">
                        <c:v>296</c:v>
                      </c:pt>
                      <c:pt idx="405">
                        <c:v>295</c:v>
                      </c:pt>
                      <c:pt idx="406">
                        <c:v>294</c:v>
                      </c:pt>
                      <c:pt idx="407">
                        <c:v>293</c:v>
                      </c:pt>
                      <c:pt idx="408">
                        <c:v>292</c:v>
                      </c:pt>
                      <c:pt idx="409">
                        <c:v>291</c:v>
                      </c:pt>
                      <c:pt idx="410">
                        <c:v>290</c:v>
                      </c:pt>
                      <c:pt idx="411">
                        <c:v>289</c:v>
                      </c:pt>
                      <c:pt idx="412">
                        <c:v>288</c:v>
                      </c:pt>
                      <c:pt idx="413">
                        <c:v>287</c:v>
                      </c:pt>
                      <c:pt idx="414">
                        <c:v>286</c:v>
                      </c:pt>
                      <c:pt idx="415">
                        <c:v>285</c:v>
                      </c:pt>
                      <c:pt idx="416">
                        <c:v>284</c:v>
                      </c:pt>
                      <c:pt idx="417">
                        <c:v>283</c:v>
                      </c:pt>
                      <c:pt idx="418">
                        <c:v>282</c:v>
                      </c:pt>
                      <c:pt idx="419">
                        <c:v>281</c:v>
                      </c:pt>
                      <c:pt idx="420">
                        <c:v>280</c:v>
                      </c:pt>
                      <c:pt idx="421">
                        <c:v>279</c:v>
                      </c:pt>
                      <c:pt idx="422">
                        <c:v>278</c:v>
                      </c:pt>
                      <c:pt idx="423">
                        <c:v>277</c:v>
                      </c:pt>
                      <c:pt idx="424">
                        <c:v>276</c:v>
                      </c:pt>
                      <c:pt idx="425">
                        <c:v>275</c:v>
                      </c:pt>
                      <c:pt idx="426">
                        <c:v>274</c:v>
                      </c:pt>
                      <c:pt idx="427">
                        <c:v>273</c:v>
                      </c:pt>
                      <c:pt idx="428">
                        <c:v>272</c:v>
                      </c:pt>
                      <c:pt idx="429">
                        <c:v>271</c:v>
                      </c:pt>
                      <c:pt idx="430">
                        <c:v>270</c:v>
                      </c:pt>
                      <c:pt idx="431">
                        <c:v>269</c:v>
                      </c:pt>
                      <c:pt idx="432">
                        <c:v>268</c:v>
                      </c:pt>
                      <c:pt idx="433">
                        <c:v>267</c:v>
                      </c:pt>
                      <c:pt idx="434">
                        <c:v>266</c:v>
                      </c:pt>
                      <c:pt idx="435">
                        <c:v>265</c:v>
                      </c:pt>
                      <c:pt idx="436">
                        <c:v>264</c:v>
                      </c:pt>
                      <c:pt idx="437">
                        <c:v>263</c:v>
                      </c:pt>
                      <c:pt idx="438">
                        <c:v>262</c:v>
                      </c:pt>
                      <c:pt idx="439">
                        <c:v>261</c:v>
                      </c:pt>
                      <c:pt idx="440">
                        <c:v>260</c:v>
                      </c:pt>
                      <c:pt idx="441">
                        <c:v>259</c:v>
                      </c:pt>
                      <c:pt idx="442">
                        <c:v>258</c:v>
                      </c:pt>
                      <c:pt idx="443">
                        <c:v>257</c:v>
                      </c:pt>
                      <c:pt idx="444">
                        <c:v>256</c:v>
                      </c:pt>
                      <c:pt idx="445">
                        <c:v>255</c:v>
                      </c:pt>
                      <c:pt idx="446">
                        <c:v>254</c:v>
                      </c:pt>
                      <c:pt idx="447">
                        <c:v>253</c:v>
                      </c:pt>
                      <c:pt idx="448">
                        <c:v>252</c:v>
                      </c:pt>
                      <c:pt idx="449">
                        <c:v>251</c:v>
                      </c:pt>
                      <c:pt idx="450">
                        <c:v>250</c:v>
                      </c:pt>
                      <c:pt idx="451">
                        <c:v>249</c:v>
                      </c:pt>
                      <c:pt idx="452">
                        <c:v>248</c:v>
                      </c:pt>
                      <c:pt idx="453">
                        <c:v>247</c:v>
                      </c:pt>
                      <c:pt idx="454">
                        <c:v>246</c:v>
                      </c:pt>
                      <c:pt idx="455">
                        <c:v>245</c:v>
                      </c:pt>
                      <c:pt idx="456">
                        <c:v>244</c:v>
                      </c:pt>
                      <c:pt idx="457">
                        <c:v>243</c:v>
                      </c:pt>
                      <c:pt idx="458">
                        <c:v>242</c:v>
                      </c:pt>
                      <c:pt idx="459">
                        <c:v>241</c:v>
                      </c:pt>
                      <c:pt idx="460">
                        <c:v>240</c:v>
                      </c:pt>
                      <c:pt idx="461">
                        <c:v>239</c:v>
                      </c:pt>
                      <c:pt idx="462">
                        <c:v>238</c:v>
                      </c:pt>
                      <c:pt idx="463">
                        <c:v>237</c:v>
                      </c:pt>
                      <c:pt idx="464">
                        <c:v>236</c:v>
                      </c:pt>
                      <c:pt idx="465">
                        <c:v>235</c:v>
                      </c:pt>
                      <c:pt idx="466">
                        <c:v>234</c:v>
                      </c:pt>
                      <c:pt idx="467">
                        <c:v>233</c:v>
                      </c:pt>
                      <c:pt idx="468">
                        <c:v>232</c:v>
                      </c:pt>
                      <c:pt idx="469">
                        <c:v>231</c:v>
                      </c:pt>
                      <c:pt idx="470">
                        <c:v>230</c:v>
                      </c:pt>
                      <c:pt idx="471">
                        <c:v>229</c:v>
                      </c:pt>
                      <c:pt idx="472">
                        <c:v>228</c:v>
                      </c:pt>
                      <c:pt idx="473">
                        <c:v>227</c:v>
                      </c:pt>
                      <c:pt idx="474">
                        <c:v>226</c:v>
                      </c:pt>
                      <c:pt idx="475">
                        <c:v>225</c:v>
                      </c:pt>
                      <c:pt idx="476">
                        <c:v>224</c:v>
                      </c:pt>
                      <c:pt idx="477">
                        <c:v>223</c:v>
                      </c:pt>
                      <c:pt idx="478">
                        <c:v>222</c:v>
                      </c:pt>
                      <c:pt idx="479">
                        <c:v>221</c:v>
                      </c:pt>
                      <c:pt idx="480">
                        <c:v>220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文章选用!$C$2:$C$482</c15:sqref>
                        </c15:formulaRef>
                      </c:ext>
                    </c:extLst>
                    <c:numCache>
                      <c:formatCode>General</c:formatCode>
                      <c:ptCount val="481"/>
                      <c:pt idx="0">
                        <c:v>5.0000000000000001E-3</c:v>
                      </c:pt>
                      <c:pt idx="1">
                        <c:v>5.0000000000000001E-3</c:v>
                      </c:pt>
                      <c:pt idx="2">
                        <c:v>5.0000000000000001E-3</c:v>
                      </c:pt>
                      <c:pt idx="3">
                        <c:v>5.0000000000000001E-3</c:v>
                      </c:pt>
                      <c:pt idx="4">
                        <c:v>5.0000000000000001E-3</c:v>
                      </c:pt>
                      <c:pt idx="5">
                        <c:v>5.0000000000000001E-3</c:v>
                      </c:pt>
                      <c:pt idx="6">
                        <c:v>5.0000000000000001E-3</c:v>
                      </c:pt>
                      <c:pt idx="7">
                        <c:v>5.0000000000000001E-3</c:v>
                      </c:pt>
                      <c:pt idx="8">
                        <c:v>6.0000000000000001E-3</c:v>
                      </c:pt>
                      <c:pt idx="9">
                        <c:v>6.0000000000000001E-3</c:v>
                      </c:pt>
                      <c:pt idx="10">
                        <c:v>6.0000000000000001E-3</c:v>
                      </c:pt>
                      <c:pt idx="11">
                        <c:v>6.0000000000000001E-3</c:v>
                      </c:pt>
                      <c:pt idx="12">
                        <c:v>6.0000000000000001E-3</c:v>
                      </c:pt>
                      <c:pt idx="13">
                        <c:v>6.0000000000000001E-3</c:v>
                      </c:pt>
                      <c:pt idx="14">
                        <c:v>6.0000000000000001E-3</c:v>
                      </c:pt>
                      <c:pt idx="15">
                        <c:v>6.0000000000000001E-3</c:v>
                      </c:pt>
                      <c:pt idx="16">
                        <c:v>6.0000000000000001E-3</c:v>
                      </c:pt>
                      <c:pt idx="17">
                        <c:v>6.0000000000000001E-3</c:v>
                      </c:pt>
                      <c:pt idx="18">
                        <c:v>6.0000000000000001E-3</c:v>
                      </c:pt>
                      <c:pt idx="19">
                        <c:v>6.0000000000000001E-3</c:v>
                      </c:pt>
                      <c:pt idx="20">
                        <c:v>6.0000000000000001E-3</c:v>
                      </c:pt>
                      <c:pt idx="21">
                        <c:v>6.0000000000000001E-3</c:v>
                      </c:pt>
                      <c:pt idx="22">
                        <c:v>6.0000000000000001E-3</c:v>
                      </c:pt>
                      <c:pt idx="23">
                        <c:v>6.0000000000000001E-3</c:v>
                      </c:pt>
                      <c:pt idx="24">
                        <c:v>6.0000000000000001E-3</c:v>
                      </c:pt>
                      <c:pt idx="25">
                        <c:v>6.0000000000000001E-3</c:v>
                      </c:pt>
                      <c:pt idx="26">
                        <c:v>6.0000000000000001E-3</c:v>
                      </c:pt>
                      <c:pt idx="27">
                        <c:v>6.0000000000000001E-3</c:v>
                      </c:pt>
                      <c:pt idx="28">
                        <c:v>6.0000000000000001E-3</c:v>
                      </c:pt>
                      <c:pt idx="29">
                        <c:v>6.0000000000000001E-3</c:v>
                      </c:pt>
                      <c:pt idx="30">
                        <c:v>6.0000000000000001E-3</c:v>
                      </c:pt>
                      <c:pt idx="31">
                        <c:v>6.0000000000000001E-3</c:v>
                      </c:pt>
                      <c:pt idx="32">
                        <c:v>6.0000000000000001E-3</c:v>
                      </c:pt>
                      <c:pt idx="33">
                        <c:v>6.0000000000000001E-3</c:v>
                      </c:pt>
                      <c:pt idx="34">
                        <c:v>6.0000000000000001E-3</c:v>
                      </c:pt>
                      <c:pt idx="35">
                        <c:v>6.0000000000000001E-3</c:v>
                      </c:pt>
                      <c:pt idx="36">
                        <c:v>6.0000000000000001E-3</c:v>
                      </c:pt>
                      <c:pt idx="37">
                        <c:v>7.0000000000000001E-3</c:v>
                      </c:pt>
                      <c:pt idx="38">
                        <c:v>7.0000000000000001E-3</c:v>
                      </c:pt>
                      <c:pt idx="39">
                        <c:v>7.0000000000000001E-3</c:v>
                      </c:pt>
                      <c:pt idx="40">
                        <c:v>6.0000000000000001E-3</c:v>
                      </c:pt>
                      <c:pt idx="41">
                        <c:v>6.0000000000000001E-3</c:v>
                      </c:pt>
                      <c:pt idx="42">
                        <c:v>6.0000000000000001E-3</c:v>
                      </c:pt>
                      <c:pt idx="43">
                        <c:v>6.0000000000000001E-3</c:v>
                      </c:pt>
                      <c:pt idx="44">
                        <c:v>6.0000000000000001E-3</c:v>
                      </c:pt>
                      <c:pt idx="45">
                        <c:v>6.0000000000000001E-3</c:v>
                      </c:pt>
                      <c:pt idx="46">
                        <c:v>6.0000000000000001E-3</c:v>
                      </c:pt>
                      <c:pt idx="47">
                        <c:v>6.0000000000000001E-3</c:v>
                      </c:pt>
                      <c:pt idx="48">
                        <c:v>6.0000000000000001E-3</c:v>
                      </c:pt>
                      <c:pt idx="49">
                        <c:v>6.0000000000000001E-3</c:v>
                      </c:pt>
                      <c:pt idx="50">
                        <c:v>6.0000000000000001E-3</c:v>
                      </c:pt>
                      <c:pt idx="51">
                        <c:v>6.0000000000000001E-3</c:v>
                      </c:pt>
                      <c:pt idx="52">
                        <c:v>6.0000000000000001E-3</c:v>
                      </c:pt>
                      <c:pt idx="53">
                        <c:v>5.0000000000000001E-3</c:v>
                      </c:pt>
                      <c:pt idx="54">
                        <c:v>5.0000000000000001E-3</c:v>
                      </c:pt>
                      <c:pt idx="55">
                        <c:v>5.0000000000000001E-3</c:v>
                      </c:pt>
                      <c:pt idx="56">
                        <c:v>5.0000000000000001E-3</c:v>
                      </c:pt>
                      <c:pt idx="57">
                        <c:v>5.0000000000000001E-3</c:v>
                      </c:pt>
                      <c:pt idx="58">
                        <c:v>5.0000000000000001E-3</c:v>
                      </c:pt>
                      <c:pt idx="59">
                        <c:v>5.0000000000000001E-3</c:v>
                      </c:pt>
                      <c:pt idx="60">
                        <c:v>5.0000000000000001E-3</c:v>
                      </c:pt>
                      <c:pt idx="61">
                        <c:v>5.0000000000000001E-3</c:v>
                      </c:pt>
                      <c:pt idx="62">
                        <c:v>5.0000000000000001E-3</c:v>
                      </c:pt>
                      <c:pt idx="63">
                        <c:v>5.0000000000000001E-3</c:v>
                      </c:pt>
                      <c:pt idx="64">
                        <c:v>4.0000000000000001E-3</c:v>
                      </c:pt>
                      <c:pt idx="65">
                        <c:v>4.0000000000000001E-3</c:v>
                      </c:pt>
                      <c:pt idx="66">
                        <c:v>4.0000000000000001E-3</c:v>
                      </c:pt>
                      <c:pt idx="67">
                        <c:v>4.0000000000000001E-3</c:v>
                      </c:pt>
                      <c:pt idx="68">
                        <c:v>4.0000000000000001E-3</c:v>
                      </c:pt>
                      <c:pt idx="69">
                        <c:v>4.0000000000000001E-3</c:v>
                      </c:pt>
                      <c:pt idx="70">
                        <c:v>4.0000000000000001E-3</c:v>
                      </c:pt>
                      <c:pt idx="71">
                        <c:v>4.0000000000000001E-3</c:v>
                      </c:pt>
                      <c:pt idx="72">
                        <c:v>4.0000000000000001E-3</c:v>
                      </c:pt>
                      <c:pt idx="73">
                        <c:v>4.0000000000000001E-3</c:v>
                      </c:pt>
                      <c:pt idx="74">
                        <c:v>4.0000000000000001E-3</c:v>
                      </c:pt>
                      <c:pt idx="75">
                        <c:v>4.0000000000000001E-3</c:v>
                      </c:pt>
                      <c:pt idx="76">
                        <c:v>4.0000000000000001E-3</c:v>
                      </c:pt>
                      <c:pt idx="77">
                        <c:v>4.0000000000000001E-3</c:v>
                      </c:pt>
                      <c:pt idx="78">
                        <c:v>4.0000000000000001E-3</c:v>
                      </c:pt>
                      <c:pt idx="79">
                        <c:v>4.0000000000000001E-3</c:v>
                      </c:pt>
                      <c:pt idx="80">
                        <c:v>4.0000000000000001E-3</c:v>
                      </c:pt>
                      <c:pt idx="81">
                        <c:v>4.0000000000000001E-3</c:v>
                      </c:pt>
                      <c:pt idx="82">
                        <c:v>4.0000000000000001E-3</c:v>
                      </c:pt>
                      <c:pt idx="83">
                        <c:v>4.0000000000000001E-3</c:v>
                      </c:pt>
                      <c:pt idx="84">
                        <c:v>4.0000000000000001E-3</c:v>
                      </c:pt>
                      <c:pt idx="85">
                        <c:v>4.0000000000000001E-3</c:v>
                      </c:pt>
                      <c:pt idx="86">
                        <c:v>4.0000000000000001E-3</c:v>
                      </c:pt>
                      <c:pt idx="87">
                        <c:v>4.0000000000000001E-3</c:v>
                      </c:pt>
                      <c:pt idx="88">
                        <c:v>4.0000000000000001E-3</c:v>
                      </c:pt>
                      <c:pt idx="89">
                        <c:v>4.0000000000000001E-3</c:v>
                      </c:pt>
                      <c:pt idx="90">
                        <c:v>4.0000000000000001E-3</c:v>
                      </c:pt>
                      <c:pt idx="91">
                        <c:v>4.0000000000000001E-3</c:v>
                      </c:pt>
                      <c:pt idx="92">
                        <c:v>4.0000000000000001E-3</c:v>
                      </c:pt>
                      <c:pt idx="93">
                        <c:v>4.0000000000000001E-3</c:v>
                      </c:pt>
                      <c:pt idx="94">
                        <c:v>4.0000000000000001E-3</c:v>
                      </c:pt>
                      <c:pt idx="95">
                        <c:v>4.0000000000000001E-3</c:v>
                      </c:pt>
                      <c:pt idx="96">
                        <c:v>4.0000000000000001E-3</c:v>
                      </c:pt>
                      <c:pt idx="97">
                        <c:v>4.0000000000000001E-3</c:v>
                      </c:pt>
                      <c:pt idx="98">
                        <c:v>4.0000000000000001E-3</c:v>
                      </c:pt>
                      <c:pt idx="99">
                        <c:v>4.0000000000000001E-3</c:v>
                      </c:pt>
                      <c:pt idx="100">
                        <c:v>4.0000000000000001E-3</c:v>
                      </c:pt>
                      <c:pt idx="101">
                        <c:v>4.0000000000000001E-3</c:v>
                      </c:pt>
                      <c:pt idx="102">
                        <c:v>4.0000000000000001E-3</c:v>
                      </c:pt>
                      <c:pt idx="103">
                        <c:v>4.0000000000000001E-3</c:v>
                      </c:pt>
                      <c:pt idx="104">
                        <c:v>4.0000000000000001E-3</c:v>
                      </c:pt>
                      <c:pt idx="105">
                        <c:v>5.0000000000000001E-3</c:v>
                      </c:pt>
                      <c:pt idx="106">
                        <c:v>5.0000000000000001E-3</c:v>
                      </c:pt>
                      <c:pt idx="107">
                        <c:v>5.0000000000000001E-3</c:v>
                      </c:pt>
                      <c:pt idx="108">
                        <c:v>5.0000000000000001E-3</c:v>
                      </c:pt>
                      <c:pt idx="109">
                        <c:v>4.0000000000000001E-3</c:v>
                      </c:pt>
                      <c:pt idx="110">
                        <c:v>4.0000000000000001E-3</c:v>
                      </c:pt>
                      <c:pt idx="111">
                        <c:v>4.0000000000000001E-3</c:v>
                      </c:pt>
                      <c:pt idx="112">
                        <c:v>4.0000000000000001E-3</c:v>
                      </c:pt>
                      <c:pt idx="113">
                        <c:v>4.0000000000000001E-3</c:v>
                      </c:pt>
                      <c:pt idx="114">
                        <c:v>4.0000000000000001E-3</c:v>
                      </c:pt>
                      <c:pt idx="115">
                        <c:v>4.0000000000000001E-3</c:v>
                      </c:pt>
                      <c:pt idx="116">
                        <c:v>4.0000000000000001E-3</c:v>
                      </c:pt>
                      <c:pt idx="117">
                        <c:v>3.0000000000000001E-3</c:v>
                      </c:pt>
                      <c:pt idx="118">
                        <c:v>3.0000000000000001E-3</c:v>
                      </c:pt>
                      <c:pt idx="119">
                        <c:v>3.0000000000000001E-3</c:v>
                      </c:pt>
                      <c:pt idx="120">
                        <c:v>3.0000000000000001E-3</c:v>
                      </c:pt>
                      <c:pt idx="121">
                        <c:v>3.0000000000000001E-3</c:v>
                      </c:pt>
                      <c:pt idx="122">
                        <c:v>3.0000000000000001E-3</c:v>
                      </c:pt>
                      <c:pt idx="123">
                        <c:v>3.0000000000000001E-3</c:v>
                      </c:pt>
                      <c:pt idx="124">
                        <c:v>3.0000000000000001E-3</c:v>
                      </c:pt>
                      <c:pt idx="125">
                        <c:v>2E-3</c:v>
                      </c:pt>
                      <c:pt idx="126">
                        <c:v>2E-3</c:v>
                      </c:pt>
                      <c:pt idx="127">
                        <c:v>2E-3</c:v>
                      </c:pt>
                      <c:pt idx="128">
                        <c:v>2E-3</c:v>
                      </c:pt>
                      <c:pt idx="129">
                        <c:v>2E-3</c:v>
                      </c:pt>
                      <c:pt idx="130">
                        <c:v>2E-3</c:v>
                      </c:pt>
                      <c:pt idx="131">
                        <c:v>1E-3</c:v>
                      </c:pt>
                      <c:pt idx="132">
                        <c:v>1E-3</c:v>
                      </c:pt>
                      <c:pt idx="133">
                        <c:v>1E-3</c:v>
                      </c:pt>
                      <c:pt idx="134">
                        <c:v>1E-3</c:v>
                      </c:pt>
                      <c:pt idx="135">
                        <c:v>0</c:v>
                      </c:pt>
                      <c:pt idx="136">
                        <c:v>0</c:v>
                      </c:pt>
                      <c:pt idx="137">
                        <c:v>0</c:v>
                      </c:pt>
                      <c:pt idx="138">
                        <c:v>0</c:v>
                      </c:pt>
                      <c:pt idx="139">
                        <c:v>0</c:v>
                      </c:pt>
                      <c:pt idx="140">
                        <c:v>0</c:v>
                      </c:pt>
                      <c:pt idx="141">
                        <c:v>-1E-3</c:v>
                      </c:pt>
                      <c:pt idx="142">
                        <c:v>-1E-3</c:v>
                      </c:pt>
                      <c:pt idx="143">
                        <c:v>-1E-3</c:v>
                      </c:pt>
                      <c:pt idx="144">
                        <c:v>-1E-3</c:v>
                      </c:pt>
                      <c:pt idx="145">
                        <c:v>-1E-3</c:v>
                      </c:pt>
                      <c:pt idx="146">
                        <c:v>-1E-3</c:v>
                      </c:pt>
                      <c:pt idx="147">
                        <c:v>-1E-3</c:v>
                      </c:pt>
                      <c:pt idx="148">
                        <c:v>-1E-3</c:v>
                      </c:pt>
                      <c:pt idx="149">
                        <c:v>-1E-3</c:v>
                      </c:pt>
                      <c:pt idx="150">
                        <c:v>-2E-3</c:v>
                      </c:pt>
                      <c:pt idx="151">
                        <c:v>-2E-3</c:v>
                      </c:pt>
                      <c:pt idx="152">
                        <c:v>-2E-3</c:v>
                      </c:pt>
                      <c:pt idx="153">
                        <c:v>-2E-3</c:v>
                      </c:pt>
                      <c:pt idx="154">
                        <c:v>-2E-3</c:v>
                      </c:pt>
                      <c:pt idx="155">
                        <c:v>-2E-3</c:v>
                      </c:pt>
                      <c:pt idx="156">
                        <c:v>-2E-3</c:v>
                      </c:pt>
                      <c:pt idx="157">
                        <c:v>-2E-3</c:v>
                      </c:pt>
                      <c:pt idx="158">
                        <c:v>-2E-3</c:v>
                      </c:pt>
                      <c:pt idx="159">
                        <c:v>-2E-3</c:v>
                      </c:pt>
                      <c:pt idx="160">
                        <c:v>-2E-3</c:v>
                      </c:pt>
                      <c:pt idx="161">
                        <c:v>-2E-3</c:v>
                      </c:pt>
                      <c:pt idx="162">
                        <c:v>-1E-3</c:v>
                      </c:pt>
                      <c:pt idx="163">
                        <c:v>-1E-3</c:v>
                      </c:pt>
                      <c:pt idx="164">
                        <c:v>-1E-3</c:v>
                      </c:pt>
                      <c:pt idx="165">
                        <c:v>-1E-3</c:v>
                      </c:pt>
                      <c:pt idx="166">
                        <c:v>-1E-3</c:v>
                      </c:pt>
                      <c:pt idx="167">
                        <c:v>-1E-3</c:v>
                      </c:pt>
                      <c:pt idx="168">
                        <c:v>-1E-3</c:v>
                      </c:pt>
                      <c:pt idx="169">
                        <c:v>-1E-3</c:v>
                      </c:pt>
                      <c:pt idx="170">
                        <c:v>-1E-3</c:v>
                      </c:pt>
                      <c:pt idx="171">
                        <c:v>-1E-3</c:v>
                      </c:pt>
                      <c:pt idx="172">
                        <c:v>-1E-3</c:v>
                      </c:pt>
                      <c:pt idx="173">
                        <c:v>-1E-3</c:v>
                      </c:pt>
                      <c:pt idx="174">
                        <c:v>0</c:v>
                      </c:pt>
                      <c:pt idx="175">
                        <c:v>0</c:v>
                      </c:pt>
                      <c:pt idx="176">
                        <c:v>0</c:v>
                      </c:pt>
                      <c:pt idx="177">
                        <c:v>0</c:v>
                      </c:pt>
                      <c:pt idx="178">
                        <c:v>0</c:v>
                      </c:pt>
                      <c:pt idx="179">
                        <c:v>0</c:v>
                      </c:pt>
                      <c:pt idx="180">
                        <c:v>1E-3</c:v>
                      </c:pt>
                      <c:pt idx="181">
                        <c:v>1E-3</c:v>
                      </c:pt>
                      <c:pt idx="182">
                        <c:v>1E-3</c:v>
                      </c:pt>
                      <c:pt idx="183">
                        <c:v>1E-3</c:v>
                      </c:pt>
                      <c:pt idx="184">
                        <c:v>1E-3</c:v>
                      </c:pt>
                      <c:pt idx="185">
                        <c:v>1E-3</c:v>
                      </c:pt>
                      <c:pt idx="186">
                        <c:v>1E-3</c:v>
                      </c:pt>
                      <c:pt idx="187">
                        <c:v>1E-3</c:v>
                      </c:pt>
                      <c:pt idx="188">
                        <c:v>1E-3</c:v>
                      </c:pt>
                      <c:pt idx="189">
                        <c:v>2E-3</c:v>
                      </c:pt>
                      <c:pt idx="190">
                        <c:v>2E-3</c:v>
                      </c:pt>
                      <c:pt idx="191">
                        <c:v>2E-3</c:v>
                      </c:pt>
                      <c:pt idx="192">
                        <c:v>2E-3</c:v>
                      </c:pt>
                      <c:pt idx="193">
                        <c:v>2E-3</c:v>
                      </c:pt>
                      <c:pt idx="194">
                        <c:v>2E-3</c:v>
                      </c:pt>
                      <c:pt idx="195">
                        <c:v>2E-3</c:v>
                      </c:pt>
                      <c:pt idx="196">
                        <c:v>2E-3</c:v>
                      </c:pt>
                      <c:pt idx="197">
                        <c:v>2E-3</c:v>
                      </c:pt>
                      <c:pt idx="198">
                        <c:v>2E-3</c:v>
                      </c:pt>
                      <c:pt idx="199">
                        <c:v>2E-3</c:v>
                      </c:pt>
                      <c:pt idx="200">
                        <c:v>2E-3</c:v>
                      </c:pt>
                      <c:pt idx="201">
                        <c:v>2E-3</c:v>
                      </c:pt>
                      <c:pt idx="202">
                        <c:v>2E-3</c:v>
                      </c:pt>
                      <c:pt idx="203">
                        <c:v>2E-3</c:v>
                      </c:pt>
                      <c:pt idx="204">
                        <c:v>2E-3</c:v>
                      </c:pt>
                      <c:pt idx="205">
                        <c:v>2E-3</c:v>
                      </c:pt>
                      <c:pt idx="206">
                        <c:v>2E-3</c:v>
                      </c:pt>
                      <c:pt idx="207">
                        <c:v>2E-3</c:v>
                      </c:pt>
                      <c:pt idx="208">
                        <c:v>2E-3</c:v>
                      </c:pt>
                      <c:pt idx="209">
                        <c:v>2E-3</c:v>
                      </c:pt>
                      <c:pt idx="210">
                        <c:v>2E-3</c:v>
                      </c:pt>
                      <c:pt idx="211">
                        <c:v>2E-3</c:v>
                      </c:pt>
                      <c:pt idx="212">
                        <c:v>2E-3</c:v>
                      </c:pt>
                      <c:pt idx="213">
                        <c:v>2E-3</c:v>
                      </c:pt>
                      <c:pt idx="214">
                        <c:v>2E-3</c:v>
                      </c:pt>
                      <c:pt idx="215">
                        <c:v>2E-3</c:v>
                      </c:pt>
                      <c:pt idx="216">
                        <c:v>3.0000000000000001E-3</c:v>
                      </c:pt>
                      <c:pt idx="217">
                        <c:v>3.0000000000000001E-3</c:v>
                      </c:pt>
                      <c:pt idx="218">
                        <c:v>3.0000000000000001E-3</c:v>
                      </c:pt>
                      <c:pt idx="219">
                        <c:v>3.0000000000000001E-3</c:v>
                      </c:pt>
                      <c:pt idx="220">
                        <c:v>3.0000000000000001E-3</c:v>
                      </c:pt>
                      <c:pt idx="221">
                        <c:v>3.0000000000000001E-3</c:v>
                      </c:pt>
                      <c:pt idx="222">
                        <c:v>3.0000000000000001E-3</c:v>
                      </c:pt>
                      <c:pt idx="223">
                        <c:v>3.0000000000000001E-3</c:v>
                      </c:pt>
                      <c:pt idx="224">
                        <c:v>3.0000000000000001E-3</c:v>
                      </c:pt>
                      <c:pt idx="225">
                        <c:v>3.0000000000000001E-3</c:v>
                      </c:pt>
                      <c:pt idx="226">
                        <c:v>3.0000000000000001E-3</c:v>
                      </c:pt>
                      <c:pt idx="227">
                        <c:v>3.0000000000000001E-3</c:v>
                      </c:pt>
                      <c:pt idx="228">
                        <c:v>3.0000000000000001E-3</c:v>
                      </c:pt>
                      <c:pt idx="229">
                        <c:v>3.0000000000000001E-3</c:v>
                      </c:pt>
                      <c:pt idx="230">
                        <c:v>3.0000000000000001E-3</c:v>
                      </c:pt>
                      <c:pt idx="231">
                        <c:v>3.0000000000000001E-3</c:v>
                      </c:pt>
                      <c:pt idx="232">
                        <c:v>3.0000000000000001E-3</c:v>
                      </c:pt>
                      <c:pt idx="233">
                        <c:v>3.0000000000000001E-3</c:v>
                      </c:pt>
                      <c:pt idx="234">
                        <c:v>3.0000000000000001E-3</c:v>
                      </c:pt>
                      <c:pt idx="235">
                        <c:v>4.0000000000000001E-3</c:v>
                      </c:pt>
                      <c:pt idx="236">
                        <c:v>4.0000000000000001E-3</c:v>
                      </c:pt>
                      <c:pt idx="237">
                        <c:v>4.0000000000000001E-3</c:v>
                      </c:pt>
                      <c:pt idx="238">
                        <c:v>4.0000000000000001E-3</c:v>
                      </c:pt>
                      <c:pt idx="239">
                        <c:v>4.0000000000000001E-3</c:v>
                      </c:pt>
                      <c:pt idx="240">
                        <c:v>4.0000000000000001E-3</c:v>
                      </c:pt>
                      <c:pt idx="241">
                        <c:v>4.0000000000000001E-3</c:v>
                      </c:pt>
                      <c:pt idx="242">
                        <c:v>3.0000000000000001E-3</c:v>
                      </c:pt>
                      <c:pt idx="243">
                        <c:v>3.0000000000000001E-3</c:v>
                      </c:pt>
                      <c:pt idx="244">
                        <c:v>3.0000000000000001E-3</c:v>
                      </c:pt>
                      <c:pt idx="245">
                        <c:v>3.0000000000000001E-3</c:v>
                      </c:pt>
                      <c:pt idx="246">
                        <c:v>3.0000000000000001E-3</c:v>
                      </c:pt>
                      <c:pt idx="247">
                        <c:v>3.0000000000000001E-3</c:v>
                      </c:pt>
                      <c:pt idx="248">
                        <c:v>3.0000000000000001E-3</c:v>
                      </c:pt>
                      <c:pt idx="249">
                        <c:v>3.0000000000000001E-3</c:v>
                      </c:pt>
                      <c:pt idx="250">
                        <c:v>3.0000000000000001E-3</c:v>
                      </c:pt>
                      <c:pt idx="251">
                        <c:v>3.0000000000000001E-3</c:v>
                      </c:pt>
                      <c:pt idx="252">
                        <c:v>3.0000000000000001E-3</c:v>
                      </c:pt>
                      <c:pt idx="253">
                        <c:v>2E-3</c:v>
                      </c:pt>
                      <c:pt idx="254">
                        <c:v>2E-3</c:v>
                      </c:pt>
                      <c:pt idx="255">
                        <c:v>2E-3</c:v>
                      </c:pt>
                      <c:pt idx="256">
                        <c:v>2E-3</c:v>
                      </c:pt>
                      <c:pt idx="257">
                        <c:v>2E-3</c:v>
                      </c:pt>
                      <c:pt idx="258">
                        <c:v>2E-3</c:v>
                      </c:pt>
                      <c:pt idx="259">
                        <c:v>2E-3</c:v>
                      </c:pt>
                      <c:pt idx="260">
                        <c:v>2E-3</c:v>
                      </c:pt>
                      <c:pt idx="261">
                        <c:v>2E-3</c:v>
                      </c:pt>
                      <c:pt idx="262">
                        <c:v>2E-3</c:v>
                      </c:pt>
                      <c:pt idx="263">
                        <c:v>2E-3</c:v>
                      </c:pt>
                      <c:pt idx="264">
                        <c:v>2E-3</c:v>
                      </c:pt>
                      <c:pt idx="265">
                        <c:v>2E-3</c:v>
                      </c:pt>
                      <c:pt idx="266">
                        <c:v>2E-3</c:v>
                      </c:pt>
                      <c:pt idx="267">
                        <c:v>2E-3</c:v>
                      </c:pt>
                      <c:pt idx="268">
                        <c:v>2E-3</c:v>
                      </c:pt>
                      <c:pt idx="269">
                        <c:v>3.0000000000000001E-3</c:v>
                      </c:pt>
                      <c:pt idx="270">
                        <c:v>3.0000000000000001E-3</c:v>
                      </c:pt>
                      <c:pt idx="271">
                        <c:v>3.0000000000000001E-3</c:v>
                      </c:pt>
                      <c:pt idx="272">
                        <c:v>3.0000000000000001E-3</c:v>
                      </c:pt>
                      <c:pt idx="273">
                        <c:v>3.0000000000000001E-3</c:v>
                      </c:pt>
                      <c:pt idx="274">
                        <c:v>3.0000000000000001E-3</c:v>
                      </c:pt>
                      <c:pt idx="275">
                        <c:v>3.0000000000000001E-3</c:v>
                      </c:pt>
                      <c:pt idx="276">
                        <c:v>3.0000000000000001E-3</c:v>
                      </c:pt>
                      <c:pt idx="277">
                        <c:v>3.0000000000000001E-3</c:v>
                      </c:pt>
                      <c:pt idx="278">
                        <c:v>3.0000000000000001E-3</c:v>
                      </c:pt>
                      <c:pt idx="279">
                        <c:v>3.0000000000000001E-3</c:v>
                      </c:pt>
                      <c:pt idx="280">
                        <c:v>3.0000000000000001E-3</c:v>
                      </c:pt>
                      <c:pt idx="281">
                        <c:v>4.0000000000000001E-3</c:v>
                      </c:pt>
                      <c:pt idx="282">
                        <c:v>4.0000000000000001E-3</c:v>
                      </c:pt>
                      <c:pt idx="283">
                        <c:v>4.0000000000000001E-3</c:v>
                      </c:pt>
                      <c:pt idx="284">
                        <c:v>4.0000000000000001E-3</c:v>
                      </c:pt>
                      <c:pt idx="285">
                        <c:v>4.0000000000000001E-3</c:v>
                      </c:pt>
                      <c:pt idx="286">
                        <c:v>4.0000000000000001E-3</c:v>
                      </c:pt>
                      <c:pt idx="287">
                        <c:v>4.0000000000000001E-3</c:v>
                      </c:pt>
                      <c:pt idx="288">
                        <c:v>5.0000000000000001E-3</c:v>
                      </c:pt>
                      <c:pt idx="289">
                        <c:v>5.0000000000000001E-3</c:v>
                      </c:pt>
                      <c:pt idx="290">
                        <c:v>5.0000000000000001E-3</c:v>
                      </c:pt>
                      <c:pt idx="291">
                        <c:v>5.0000000000000001E-3</c:v>
                      </c:pt>
                      <c:pt idx="292">
                        <c:v>5.0000000000000001E-3</c:v>
                      </c:pt>
                      <c:pt idx="293">
                        <c:v>5.0000000000000001E-3</c:v>
                      </c:pt>
                      <c:pt idx="294">
                        <c:v>5.0000000000000001E-3</c:v>
                      </c:pt>
                      <c:pt idx="295">
                        <c:v>5.0000000000000001E-3</c:v>
                      </c:pt>
                      <c:pt idx="296">
                        <c:v>5.0000000000000001E-3</c:v>
                      </c:pt>
                      <c:pt idx="297">
                        <c:v>5.0000000000000001E-3</c:v>
                      </c:pt>
                      <c:pt idx="298">
                        <c:v>5.0000000000000001E-3</c:v>
                      </c:pt>
                      <c:pt idx="299">
                        <c:v>6.0000000000000001E-3</c:v>
                      </c:pt>
                      <c:pt idx="300">
                        <c:v>6.0000000000000001E-3</c:v>
                      </c:pt>
                      <c:pt idx="301">
                        <c:v>6.0000000000000001E-3</c:v>
                      </c:pt>
                      <c:pt idx="302">
                        <c:v>6.0000000000000001E-3</c:v>
                      </c:pt>
                      <c:pt idx="303">
                        <c:v>6.0000000000000001E-3</c:v>
                      </c:pt>
                      <c:pt idx="304">
                        <c:v>6.0000000000000001E-3</c:v>
                      </c:pt>
                      <c:pt idx="305">
                        <c:v>6.0000000000000001E-3</c:v>
                      </c:pt>
                      <c:pt idx="306">
                        <c:v>6.0000000000000001E-3</c:v>
                      </c:pt>
                      <c:pt idx="307">
                        <c:v>6.0000000000000001E-3</c:v>
                      </c:pt>
                      <c:pt idx="308">
                        <c:v>6.0000000000000001E-3</c:v>
                      </c:pt>
                      <c:pt idx="309">
                        <c:v>6.0000000000000001E-3</c:v>
                      </c:pt>
                      <c:pt idx="310">
                        <c:v>7.0000000000000001E-3</c:v>
                      </c:pt>
                      <c:pt idx="311">
                        <c:v>7.0000000000000001E-3</c:v>
                      </c:pt>
                      <c:pt idx="312">
                        <c:v>7.0000000000000001E-3</c:v>
                      </c:pt>
                      <c:pt idx="313">
                        <c:v>7.0000000000000001E-3</c:v>
                      </c:pt>
                      <c:pt idx="314">
                        <c:v>7.0000000000000001E-3</c:v>
                      </c:pt>
                      <c:pt idx="315">
                        <c:v>7.0000000000000001E-3</c:v>
                      </c:pt>
                      <c:pt idx="316">
                        <c:v>7.0000000000000001E-3</c:v>
                      </c:pt>
                      <c:pt idx="317">
                        <c:v>7.0000000000000001E-3</c:v>
                      </c:pt>
                      <c:pt idx="318">
                        <c:v>7.0000000000000001E-3</c:v>
                      </c:pt>
                      <c:pt idx="319">
                        <c:v>8.0000000000000002E-3</c:v>
                      </c:pt>
                      <c:pt idx="320">
                        <c:v>8.0000000000000002E-3</c:v>
                      </c:pt>
                      <c:pt idx="321">
                        <c:v>8.0000000000000002E-3</c:v>
                      </c:pt>
                      <c:pt idx="322">
                        <c:v>8.0000000000000002E-3</c:v>
                      </c:pt>
                      <c:pt idx="323">
                        <c:v>8.0000000000000002E-3</c:v>
                      </c:pt>
                      <c:pt idx="324">
                        <c:v>8.0000000000000002E-3</c:v>
                      </c:pt>
                      <c:pt idx="325">
                        <c:v>8.0000000000000002E-3</c:v>
                      </c:pt>
                      <c:pt idx="326">
                        <c:v>8.0000000000000002E-3</c:v>
                      </c:pt>
                      <c:pt idx="327">
                        <c:v>8.0000000000000002E-3</c:v>
                      </c:pt>
                      <c:pt idx="328">
                        <c:v>8.0000000000000002E-3</c:v>
                      </c:pt>
                      <c:pt idx="329">
                        <c:v>8.9999999999999993E-3</c:v>
                      </c:pt>
                      <c:pt idx="330">
                        <c:v>8.9999999999999993E-3</c:v>
                      </c:pt>
                      <c:pt idx="331">
                        <c:v>8.9999999999999993E-3</c:v>
                      </c:pt>
                      <c:pt idx="332">
                        <c:v>8.9999999999999993E-3</c:v>
                      </c:pt>
                      <c:pt idx="333">
                        <c:v>8.9999999999999993E-3</c:v>
                      </c:pt>
                      <c:pt idx="334">
                        <c:v>8.9999999999999993E-3</c:v>
                      </c:pt>
                      <c:pt idx="335">
                        <c:v>0.01</c:v>
                      </c:pt>
                      <c:pt idx="336">
                        <c:v>0.01</c:v>
                      </c:pt>
                      <c:pt idx="337">
                        <c:v>0.01</c:v>
                      </c:pt>
                      <c:pt idx="338">
                        <c:v>0.01</c:v>
                      </c:pt>
                      <c:pt idx="339">
                        <c:v>0.01</c:v>
                      </c:pt>
                      <c:pt idx="340">
                        <c:v>1.0999999999999999E-2</c:v>
                      </c:pt>
                      <c:pt idx="341">
                        <c:v>1.0999999999999999E-2</c:v>
                      </c:pt>
                      <c:pt idx="342">
                        <c:v>1.0999999999999999E-2</c:v>
                      </c:pt>
                      <c:pt idx="343">
                        <c:v>1.2E-2</c:v>
                      </c:pt>
                      <c:pt idx="344">
                        <c:v>1.2E-2</c:v>
                      </c:pt>
                      <c:pt idx="345">
                        <c:v>1.2999999999999999E-2</c:v>
                      </c:pt>
                      <c:pt idx="346">
                        <c:v>1.2999999999999999E-2</c:v>
                      </c:pt>
                      <c:pt idx="347">
                        <c:v>1.2999999999999999E-2</c:v>
                      </c:pt>
                      <c:pt idx="348">
                        <c:v>1.4E-2</c:v>
                      </c:pt>
                      <c:pt idx="349">
                        <c:v>1.4E-2</c:v>
                      </c:pt>
                      <c:pt idx="350">
                        <c:v>1.4999999999999999E-2</c:v>
                      </c:pt>
                      <c:pt idx="351">
                        <c:v>1.4999999999999999E-2</c:v>
                      </c:pt>
                      <c:pt idx="352">
                        <c:v>1.4999999999999999E-2</c:v>
                      </c:pt>
                      <c:pt idx="353">
                        <c:v>1.4999999999999999E-2</c:v>
                      </c:pt>
                      <c:pt idx="354">
                        <c:v>1.6E-2</c:v>
                      </c:pt>
                      <c:pt idx="355">
                        <c:v>1.6E-2</c:v>
                      </c:pt>
                      <c:pt idx="356">
                        <c:v>1.6E-2</c:v>
                      </c:pt>
                      <c:pt idx="357">
                        <c:v>1.7000000000000001E-2</c:v>
                      </c:pt>
                      <c:pt idx="358">
                        <c:v>1.7000000000000001E-2</c:v>
                      </c:pt>
                      <c:pt idx="359">
                        <c:v>1.7000000000000001E-2</c:v>
                      </c:pt>
                      <c:pt idx="360">
                        <c:v>1.7000000000000001E-2</c:v>
                      </c:pt>
                      <c:pt idx="361">
                        <c:v>1.7999999999999999E-2</c:v>
                      </c:pt>
                      <c:pt idx="362">
                        <c:v>1.7999999999999999E-2</c:v>
                      </c:pt>
                      <c:pt idx="363">
                        <c:v>1.7999999999999999E-2</c:v>
                      </c:pt>
                      <c:pt idx="364">
                        <c:v>1.7999999999999999E-2</c:v>
                      </c:pt>
                      <c:pt idx="365">
                        <c:v>1.9E-2</c:v>
                      </c:pt>
                      <c:pt idx="366">
                        <c:v>1.9E-2</c:v>
                      </c:pt>
                      <c:pt idx="367">
                        <c:v>1.9E-2</c:v>
                      </c:pt>
                      <c:pt idx="368">
                        <c:v>0.02</c:v>
                      </c:pt>
                      <c:pt idx="369">
                        <c:v>0.02</c:v>
                      </c:pt>
                      <c:pt idx="370">
                        <c:v>2.1000000000000001E-2</c:v>
                      </c:pt>
                      <c:pt idx="371">
                        <c:v>2.1000000000000001E-2</c:v>
                      </c:pt>
                      <c:pt idx="372">
                        <c:v>2.1000000000000001E-2</c:v>
                      </c:pt>
                      <c:pt idx="373">
                        <c:v>2.1999999999999999E-2</c:v>
                      </c:pt>
                      <c:pt idx="374">
                        <c:v>2.1999999999999999E-2</c:v>
                      </c:pt>
                      <c:pt idx="375">
                        <c:v>2.1999999999999999E-2</c:v>
                      </c:pt>
                      <c:pt idx="376">
                        <c:v>2.3E-2</c:v>
                      </c:pt>
                      <c:pt idx="377">
                        <c:v>2.3E-2</c:v>
                      </c:pt>
                      <c:pt idx="378">
                        <c:v>2.4E-2</c:v>
                      </c:pt>
                      <c:pt idx="379">
                        <c:v>2.4E-2</c:v>
                      </c:pt>
                      <c:pt idx="380">
                        <c:v>2.4E-2</c:v>
                      </c:pt>
                      <c:pt idx="381">
                        <c:v>2.5000000000000001E-2</c:v>
                      </c:pt>
                      <c:pt idx="382">
                        <c:v>2.5000000000000001E-2</c:v>
                      </c:pt>
                      <c:pt idx="383">
                        <c:v>2.5999999999999999E-2</c:v>
                      </c:pt>
                      <c:pt idx="384">
                        <c:v>2.5999999999999999E-2</c:v>
                      </c:pt>
                      <c:pt idx="385">
                        <c:v>2.7E-2</c:v>
                      </c:pt>
                      <c:pt idx="386">
                        <c:v>2.7E-2</c:v>
                      </c:pt>
                      <c:pt idx="387">
                        <c:v>2.7E-2</c:v>
                      </c:pt>
                      <c:pt idx="388">
                        <c:v>2.8000000000000001E-2</c:v>
                      </c:pt>
                      <c:pt idx="389">
                        <c:v>2.8000000000000001E-2</c:v>
                      </c:pt>
                      <c:pt idx="390">
                        <c:v>2.8000000000000001E-2</c:v>
                      </c:pt>
                      <c:pt idx="391">
                        <c:v>2.9000000000000001E-2</c:v>
                      </c:pt>
                      <c:pt idx="392">
                        <c:v>2.9000000000000001E-2</c:v>
                      </c:pt>
                      <c:pt idx="393">
                        <c:v>2.9000000000000001E-2</c:v>
                      </c:pt>
                      <c:pt idx="394">
                        <c:v>2.9000000000000001E-2</c:v>
                      </c:pt>
                      <c:pt idx="395">
                        <c:v>0.03</c:v>
                      </c:pt>
                      <c:pt idx="396">
                        <c:v>0.03</c:v>
                      </c:pt>
                      <c:pt idx="397">
                        <c:v>0.03</c:v>
                      </c:pt>
                      <c:pt idx="398">
                        <c:v>3.1E-2</c:v>
                      </c:pt>
                      <c:pt idx="399">
                        <c:v>3.1E-2</c:v>
                      </c:pt>
                      <c:pt idx="400">
                        <c:v>3.1E-2</c:v>
                      </c:pt>
                      <c:pt idx="401">
                        <c:v>3.2000000000000001E-2</c:v>
                      </c:pt>
                      <c:pt idx="402">
                        <c:v>3.3000000000000002E-2</c:v>
                      </c:pt>
                      <c:pt idx="403">
                        <c:v>3.4000000000000002E-2</c:v>
                      </c:pt>
                      <c:pt idx="404">
                        <c:v>3.5000000000000003E-2</c:v>
                      </c:pt>
                      <c:pt idx="405">
                        <c:v>3.5999999999999997E-2</c:v>
                      </c:pt>
                      <c:pt idx="406">
                        <c:v>3.7999999999999999E-2</c:v>
                      </c:pt>
                      <c:pt idx="407">
                        <c:v>3.9E-2</c:v>
                      </c:pt>
                      <c:pt idx="408">
                        <c:v>0.04</c:v>
                      </c:pt>
                      <c:pt idx="409">
                        <c:v>4.2000000000000003E-2</c:v>
                      </c:pt>
                      <c:pt idx="410">
                        <c:v>4.3999999999999997E-2</c:v>
                      </c:pt>
                      <c:pt idx="411">
                        <c:v>4.4999999999999998E-2</c:v>
                      </c:pt>
                      <c:pt idx="412">
                        <c:v>4.7E-2</c:v>
                      </c:pt>
                      <c:pt idx="413">
                        <c:v>4.9000000000000002E-2</c:v>
                      </c:pt>
                      <c:pt idx="414">
                        <c:v>5.0999999999999997E-2</c:v>
                      </c:pt>
                      <c:pt idx="415">
                        <c:v>5.2999999999999999E-2</c:v>
                      </c:pt>
                      <c:pt idx="416">
                        <c:v>5.6000000000000001E-2</c:v>
                      </c:pt>
                      <c:pt idx="417">
                        <c:v>5.8000000000000003E-2</c:v>
                      </c:pt>
                      <c:pt idx="418">
                        <c:v>0.06</c:v>
                      </c:pt>
                      <c:pt idx="419">
                        <c:v>6.2E-2</c:v>
                      </c:pt>
                      <c:pt idx="420">
                        <c:v>6.4000000000000001E-2</c:v>
                      </c:pt>
                      <c:pt idx="421">
                        <c:v>6.6000000000000003E-2</c:v>
                      </c:pt>
                      <c:pt idx="422">
                        <c:v>6.8000000000000005E-2</c:v>
                      </c:pt>
                      <c:pt idx="423">
                        <c:v>7.0000000000000007E-2</c:v>
                      </c:pt>
                      <c:pt idx="424">
                        <c:v>7.1999999999999995E-2</c:v>
                      </c:pt>
                      <c:pt idx="425">
                        <c:v>7.2999999999999995E-2</c:v>
                      </c:pt>
                      <c:pt idx="426">
                        <c:v>7.4999999999999997E-2</c:v>
                      </c:pt>
                      <c:pt idx="427">
                        <c:v>7.6999999999999999E-2</c:v>
                      </c:pt>
                      <c:pt idx="428">
                        <c:v>7.9000000000000001E-2</c:v>
                      </c:pt>
                      <c:pt idx="429">
                        <c:v>8.1000000000000003E-2</c:v>
                      </c:pt>
                      <c:pt idx="430">
                        <c:v>8.3000000000000004E-2</c:v>
                      </c:pt>
                      <c:pt idx="431">
                        <c:v>8.4000000000000005E-2</c:v>
                      </c:pt>
                      <c:pt idx="432">
                        <c:v>8.5999999999999993E-2</c:v>
                      </c:pt>
                      <c:pt idx="433">
                        <c:v>8.6999999999999994E-2</c:v>
                      </c:pt>
                      <c:pt idx="434">
                        <c:v>8.8999999999999996E-2</c:v>
                      </c:pt>
                      <c:pt idx="435">
                        <c:v>0.09</c:v>
                      </c:pt>
                      <c:pt idx="436">
                        <c:v>9.0999999999999998E-2</c:v>
                      </c:pt>
                      <c:pt idx="437">
                        <c:v>9.2999999999999999E-2</c:v>
                      </c:pt>
                      <c:pt idx="438">
                        <c:v>9.5000000000000001E-2</c:v>
                      </c:pt>
                      <c:pt idx="439">
                        <c:v>9.6000000000000002E-2</c:v>
                      </c:pt>
                      <c:pt idx="440">
                        <c:v>9.8000000000000004E-2</c:v>
                      </c:pt>
                      <c:pt idx="441">
                        <c:v>0.1</c:v>
                      </c:pt>
                      <c:pt idx="442">
                        <c:v>0.10100000000000001</c:v>
                      </c:pt>
                      <c:pt idx="443">
                        <c:v>0.10299999999999999</c:v>
                      </c:pt>
                      <c:pt idx="444">
                        <c:v>0.104</c:v>
                      </c:pt>
                      <c:pt idx="445">
                        <c:v>0.105</c:v>
                      </c:pt>
                      <c:pt idx="446">
                        <c:v>0.107</c:v>
                      </c:pt>
                      <c:pt idx="447">
                        <c:v>0.108</c:v>
                      </c:pt>
                      <c:pt idx="448">
                        <c:v>0.109</c:v>
                      </c:pt>
                      <c:pt idx="449">
                        <c:v>0.111</c:v>
                      </c:pt>
                      <c:pt idx="450">
                        <c:v>0.113</c:v>
                      </c:pt>
                      <c:pt idx="451">
                        <c:v>0.115</c:v>
                      </c:pt>
                      <c:pt idx="452">
                        <c:v>0.11700000000000001</c:v>
                      </c:pt>
                      <c:pt idx="453">
                        <c:v>0.11899999999999999</c:v>
                      </c:pt>
                      <c:pt idx="454">
                        <c:v>0.122</c:v>
                      </c:pt>
                      <c:pt idx="455">
                        <c:v>0.124</c:v>
                      </c:pt>
                      <c:pt idx="456">
                        <c:v>0.127</c:v>
                      </c:pt>
                      <c:pt idx="457">
                        <c:v>0.13</c:v>
                      </c:pt>
                      <c:pt idx="458">
                        <c:v>0.13300000000000001</c:v>
                      </c:pt>
                      <c:pt idx="459">
                        <c:v>0.13700000000000001</c:v>
                      </c:pt>
                      <c:pt idx="460">
                        <c:v>0.14000000000000001</c:v>
                      </c:pt>
                      <c:pt idx="461">
                        <c:v>0.14399999999999999</c:v>
                      </c:pt>
                      <c:pt idx="462">
                        <c:v>0.14899999999999999</c:v>
                      </c:pt>
                      <c:pt idx="463">
                        <c:v>0.154</c:v>
                      </c:pt>
                      <c:pt idx="464">
                        <c:v>0.159</c:v>
                      </c:pt>
                      <c:pt idx="465">
                        <c:v>0.16500000000000001</c:v>
                      </c:pt>
                      <c:pt idx="466">
                        <c:v>0.17100000000000001</c:v>
                      </c:pt>
                      <c:pt idx="467">
                        <c:v>0.17799999999999999</c:v>
                      </c:pt>
                      <c:pt idx="468">
                        <c:v>0.185</c:v>
                      </c:pt>
                      <c:pt idx="469">
                        <c:v>0.193</c:v>
                      </c:pt>
                      <c:pt idx="470">
                        <c:v>0.20100000000000001</c:v>
                      </c:pt>
                      <c:pt idx="471">
                        <c:v>0.21099999999999999</c:v>
                      </c:pt>
                      <c:pt idx="472">
                        <c:v>0.222</c:v>
                      </c:pt>
                      <c:pt idx="473">
                        <c:v>0.23400000000000001</c:v>
                      </c:pt>
                      <c:pt idx="474">
                        <c:v>0.248</c:v>
                      </c:pt>
                      <c:pt idx="475">
                        <c:v>0.26400000000000001</c:v>
                      </c:pt>
                      <c:pt idx="476">
                        <c:v>0.28100000000000003</c:v>
                      </c:pt>
                      <c:pt idx="477">
                        <c:v>0.30099999999999999</c:v>
                      </c:pt>
                      <c:pt idx="478">
                        <c:v>0.32200000000000001</c:v>
                      </c:pt>
                      <c:pt idx="479">
                        <c:v>0.33800000000000002</c:v>
                      </c:pt>
                      <c:pt idx="480">
                        <c:v>0.353999999999999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AF63-4D21-8E9E-8ED987C04AD3}"/>
                  </c:ext>
                </c:extLst>
              </c15:ser>
            </c15:filteredScatterSeries>
          </c:ext>
        </c:extLst>
      </c:scatterChart>
      <c:valAx>
        <c:axId val="1507404447"/>
        <c:scaling>
          <c:orientation val="minMax"/>
          <c:max val="700"/>
          <c:min val="2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507405279"/>
        <c:crosses val="autoZero"/>
        <c:crossBetween val="midCat"/>
        <c:majorUnit val="80"/>
      </c:valAx>
      <c:valAx>
        <c:axId val="1507405279"/>
        <c:scaling>
          <c:orientation val="minMax"/>
          <c:max val="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507404447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2196275288932368"/>
          <c:y val="7.6039977455601745E-2"/>
          <c:w val="0.34601101457762762"/>
          <c:h val="0.2625059940105132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8783323162109467E-2"/>
          <c:y val="3.0497594050743659E-2"/>
          <c:w val="0.87835290673731947"/>
          <c:h val="0.87667067658209386"/>
        </c:manualLayout>
      </c:layout>
      <c:scatterChart>
        <c:scatterStyle val="lineMarker"/>
        <c:varyColors val="0"/>
        <c:ser>
          <c:idx val="1"/>
          <c:order val="0"/>
          <c:tx>
            <c:strRef>
              <c:f>文章选用!$C$1</c:f>
              <c:strCache>
                <c:ptCount val="1"/>
                <c:pt idx="0">
                  <c:v>PMO</c:v>
                </c:pt>
              </c:strCache>
            </c:strRef>
          </c:tx>
          <c:spPr>
            <a:ln w="25400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xVal>
            <c:numRef>
              <c:f>文章选用!$A$2:$A$482</c:f>
              <c:numCache>
                <c:formatCode>General</c:formatCode>
                <c:ptCount val="481"/>
                <c:pt idx="0">
                  <c:v>700</c:v>
                </c:pt>
                <c:pt idx="1">
                  <c:v>699</c:v>
                </c:pt>
                <c:pt idx="2">
                  <c:v>698</c:v>
                </c:pt>
                <c:pt idx="3">
                  <c:v>697</c:v>
                </c:pt>
                <c:pt idx="4">
                  <c:v>696</c:v>
                </c:pt>
                <c:pt idx="5">
                  <c:v>695</c:v>
                </c:pt>
                <c:pt idx="6">
                  <c:v>694</c:v>
                </c:pt>
                <c:pt idx="7">
                  <c:v>693</c:v>
                </c:pt>
                <c:pt idx="8">
                  <c:v>692</c:v>
                </c:pt>
                <c:pt idx="9">
                  <c:v>691</c:v>
                </c:pt>
                <c:pt idx="10">
                  <c:v>690</c:v>
                </c:pt>
                <c:pt idx="11">
                  <c:v>689</c:v>
                </c:pt>
                <c:pt idx="12">
                  <c:v>688</c:v>
                </c:pt>
                <c:pt idx="13">
                  <c:v>687</c:v>
                </c:pt>
                <c:pt idx="14">
                  <c:v>686</c:v>
                </c:pt>
                <c:pt idx="15">
                  <c:v>685</c:v>
                </c:pt>
                <c:pt idx="16">
                  <c:v>684</c:v>
                </c:pt>
                <c:pt idx="17">
                  <c:v>683</c:v>
                </c:pt>
                <c:pt idx="18">
                  <c:v>682</c:v>
                </c:pt>
                <c:pt idx="19">
                  <c:v>681</c:v>
                </c:pt>
                <c:pt idx="20">
                  <c:v>680</c:v>
                </c:pt>
                <c:pt idx="21">
                  <c:v>679</c:v>
                </c:pt>
                <c:pt idx="22">
                  <c:v>678</c:v>
                </c:pt>
                <c:pt idx="23">
                  <c:v>677</c:v>
                </c:pt>
                <c:pt idx="24">
                  <c:v>676</c:v>
                </c:pt>
                <c:pt idx="25">
                  <c:v>675</c:v>
                </c:pt>
                <c:pt idx="26">
                  <c:v>674</c:v>
                </c:pt>
                <c:pt idx="27">
                  <c:v>673</c:v>
                </c:pt>
                <c:pt idx="28">
                  <c:v>672</c:v>
                </c:pt>
                <c:pt idx="29">
                  <c:v>671</c:v>
                </c:pt>
                <c:pt idx="30">
                  <c:v>670</c:v>
                </c:pt>
                <c:pt idx="31">
                  <c:v>669</c:v>
                </c:pt>
                <c:pt idx="32">
                  <c:v>668</c:v>
                </c:pt>
                <c:pt idx="33">
                  <c:v>667</c:v>
                </c:pt>
                <c:pt idx="34">
                  <c:v>666</c:v>
                </c:pt>
                <c:pt idx="35">
                  <c:v>665</c:v>
                </c:pt>
                <c:pt idx="36">
                  <c:v>664</c:v>
                </c:pt>
                <c:pt idx="37">
                  <c:v>663</c:v>
                </c:pt>
                <c:pt idx="38">
                  <c:v>662</c:v>
                </c:pt>
                <c:pt idx="39">
                  <c:v>661</c:v>
                </c:pt>
                <c:pt idx="40">
                  <c:v>660</c:v>
                </c:pt>
                <c:pt idx="41">
                  <c:v>659</c:v>
                </c:pt>
                <c:pt idx="42">
                  <c:v>658</c:v>
                </c:pt>
                <c:pt idx="43">
                  <c:v>657</c:v>
                </c:pt>
                <c:pt idx="44">
                  <c:v>656</c:v>
                </c:pt>
                <c:pt idx="45">
                  <c:v>655</c:v>
                </c:pt>
                <c:pt idx="46">
                  <c:v>654</c:v>
                </c:pt>
                <c:pt idx="47">
                  <c:v>653</c:v>
                </c:pt>
                <c:pt idx="48">
                  <c:v>652</c:v>
                </c:pt>
                <c:pt idx="49">
                  <c:v>651</c:v>
                </c:pt>
                <c:pt idx="50">
                  <c:v>650</c:v>
                </c:pt>
                <c:pt idx="51">
                  <c:v>649</c:v>
                </c:pt>
                <c:pt idx="52">
                  <c:v>648</c:v>
                </c:pt>
                <c:pt idx="53">
                  <c:v>647</c:v>
                </c:pt>
                <c:pt idx="54">
                  <c:v>646</c:v>
                </c:pt>
                <c:pt idx="55">
                  <c:v>645</c:v>
                </c:pt>
                <c:pt idx="56">
                  <c:v>644</c:v>
                </c:pt>
                <c:pt idx="57">
                  <c:v>643</c:v>
                </c:pt>
                <c:pt idx="58">
                  <c:v>642</c:v>
                </c:pt>
                <c:pt idx="59">
                  <c:v>641</c:v>
                </c:pt>
                <c:pt idx="60">
                  <c:v>640</c:v>
                </c:pt>
                <c:pt idx="61">
                  <c:v>639</c:v>
                </c:pt>
                <c:pt idx="62">
                  <c:v>638</c:v>
                </c:pt>
                <c:pt idx="63">
                  <c:v>637</c:v>
                </c:pt>
                <c:pt idx="64">
                  <c:v>636</c:v>
                </c:pt>
                <c:pt idx="65">
                  <c:v>635</c:v>
                </c:pt>
                <c:pt idx="66">
                  <c:v>634</c:v>
                </c:pt>
                <c:pt idx="67">
                  <c:v>633</c:v>
                </c:pt>
                <c:pt idx="68">
                  <c:v>632</c:v>
                </c:pt>
                <c:pt idx="69">
                  <c:v>631</c:v>
                </c:pt>
                <c:pt idx="70">
                  <c:v>630</c:v>
                </c:pt>
                <c:pt idx="71">
                  <c:v>629</c:v>
                </c:pt>
                <c:pt idx="72">
                  <c:v>628</c:v>
                </c:pt>
                <c:pt idx="73">
                  <c:v>627</c:v>
                </c:pt>
                <c:pt idx="74">
                  <c:v>626</c:v>
                </c:pt>
                <c:pt idx="75">
                  <c:v>625</c:v>
                </c:pt>
                <c:pt idx="76">
                  <c:v>624</c:v>
                </c:pt>
                <c:pt idx="77">
                  <c:v>623</c:v>
                </c:pt>
                <c:pt idx="78">
                  <c:v>622</c:v>
                </c:pt>
                <c:pt idx="79">
                  <c:v>621</c:v>
                </c:pt>
                <c:pt idx="80">
                  <c:v>620</c:v>
                </c:pt>
                <c:pt idx="81">
                  <c:v>619</c:v>
                </c:pt>
                <c:pt idx="82">
                  <c:v>618</c:v>
                </c:pt>
                <c:pt idx="83">
                  <c:v>617</c:v>
                </c:pt>
                <c:pt idx="84">
                  <c:v>616</c:v>
                </c:pt>
                <c:pt idx="85">
                  <c:v>615</c:v>
                </c:pt>
                <c:pt idx="86">
                  <c:v>614</c:v>
                </c:pt>
                <c:pt idx="87">
                  <c:v>613</c:v>
                </c:pt>
                <c:pt idx="88">
                  <c:v>612</c:v>
                </c:pt>
                <c:pt idx="89">
                  <c:v>611</c:v>
                </c:pt>
                <c:pt idx="90">
                  <c:v>610</c:v>
                </c:pt>
                <c:pt idx="91">
                  <c:v>609</c:v>
                </c:pt>
                <c:pt idx="92">
                  <c:v>608</c:v>
                </c:pt>
                <c:pt idx="93">
                  <c:v>607</c:v>
                </c:pt>
                <c:pt idx="94">
                  <c:v>606</c:v>
                </c:pt>
                <c:pt idx="95">
                  <c:v>605</c:v>
                </c:pt>
                <c:pt idx="96">
                  <c:v>604</c:v>
                </c:pt>
                <c:pt idx="97">
                  <c:v>603</c:v>
                </c:pt>
                <c:pt idx="98">
                  <c:v>602</c:v>
                </c:pt>
                <c:pt idx="99">
                  <c:v>601</c:v>
                </c:pt>
                <c:pt idx="100">
                  <c:v>600</c:v>
                </c:pt>
                <c:pt idx="101">
                  <c:v>599</c:v>
                </c:pt>
                <c:pt idx="102">
                  <c:v>598</c:v>
                </c:pt>
                <c:pt idx="103">
                  <c:v>597</c:v>
                </c:pt>
                <c:pt idx="104">
                  <c:v>596</c:v>
                </c:pt>
                <c:pt idx="105">
                  <c:v>595</c:v>
                </c:pt>
                <c:pt idx="106">
                  <c:v>594</c:v>
                </c:pt>
                <c:pt idx="107">
                  <c:v>593</c:v>
                </c:pt>
                <c:pt idx="108">
                  <c:v>592</c:v>
                </c:pt>
                <c:pt idx="109">
                  <c:v>591</c:v>
                </c:pt>
                <c:pt idx="110">
                  <c:v>590</c:v>
                </c:pt>
                <c:pt idx="111">
                  <c:v>589</c:v>
                </c:pt>
                <c:pt idx="112">
                  <c:v>588</c:v>
                </c:pt>
                <c:pt idx="113">
                  <c:v>587</c:v>
                </c:pt>
                <c:pt idx="114">
                  <c:v>586</c:v>
                </c:pt>
                <c:pt idx="115">
                  <c:v>585</c:v>
                </c:pt>
                <c:pt idx="116">
                  <c:v>584</c:v>
                </c:pt>
                <c:pt idx="117">
                  <c:v>583</c:v>
                </c:pt>
                <c:pt idx="118">
                  <c:v>582</c:v>
                </c:pt>
                <c:pt idx="119">
                  <c:v>581</c:v>
                </c:pt>
                <c:pt idx="120">
                  <c:v>580</c:v>
                </c:pt>
                <c:pt idx="121">
                  <c:v>579</c:v>
                </c:pt>
                <c:pt idx="122">
                  <c:v>578</c:v>
                </c:pt>
                <c:pt idx="123">
                  <c:v>577</c:v>
                </c:pt>
                <c:pt idx="124">
                  <c:v>576</c:v>
                </c:pt>
                <c:pt idx="125">
                  <c:v>575</c:v>
                </c:pt>
                <c:pt idx="126">
                  <c:v>574</c:v>
                </c:pt>
                <c:pt idx="127">
                  <c:v>573</c:v>
                </c:pt>
                <c:pt idx="128">
                  <c:v>572</c:v>
                </c:pt>
                <c:pt idx="129">
                  <c:v>571</c:v>
                </c:pt>
                <c:pt idx="130">
                  <c:v>570</c:v>
                </c:pt>
                <c:pt idx="131">
                  <c:v>569</c:v>
                </c:pt>
                <c:pt idx="132">
                  <c:v>568</c:v>
                </c:pt>
                <c:pt idx="133">
                  <c:v>567</c:v>
                </c:pt>
                <c:pt idx="134">
                  <c:v>566</c:v>
                </c:pt>
                <c:pt idx="135">
                  <c:v>565</c:v>
                </c:pt>
                <c:pt idx="136">
                  <c:v>564</c:v>
                </c:pt>
                <c:pt idx="137">
                  <c:v>563</c:v>
                </c:pt>
                <c:pt idx="138">
                  <c:v>562</c:v>
                </c:pt>
                <c:pt idx="139">
                  <c:v>561</c:v>
                </c:pt>
                <c:pt idx="140">
                  <c:v>560</c:v>
                </c:pt>
                <c:pt idx="141">
                  <c:v>559</c:v>
                </c:pt>
                <c:pt idx="142">
                  <c:v>558</c:v>
                </c:pt>
                <c:pt idx="143">
                  <c:v>557</c:v>
                </c:pt>
                <c:pt idx="144">
                  <c:v>556</c:v>
                </c:pt>
                <c:pt idx="145">
                  <c:v>555</c:v>
                </c:pt>
                <c:pt idx="146">
                  <c:v>554</c:v>
                </c:pt>
                <c:pt idx="147">
                  <c:v>553</c:v>
                </c:pt>
                <c:pt idx="148">
                  <c:v>552</c:v>
                </c:pt>
                <c:pt idx="149">
                  <c:v>551</c:v>
                </c:pt>
                <c:pt idx="150">
                  <c:v>550</c:v>
                </c:pt>
                <c:pt idx="151">
                  <c:v>549</c:v>
                </c:pt>
                <c:pt idx="152">
                  <c:v>548</c:v>
                </c:pt>
                <c:pt idx="153">
                  <c:v>547</c:v>
                </c:pt>
                <c:pt idx="154">
                  <c:v>546</c:v>
                </c:pt>
                <c:pt idx="155">
                  <c:v>545</c:v>
                </c:pt>
                <c:pt idx="156">
                  <c:v>544</c:v>
                </c:pt>
                <c:pt idx="157">
                  <c:v>543</c:v>
                </c:pt>
                <c:pt idx="158">
                  <c:v>542</c:v>
                </c:pt>
                <c:pt idx="159">
                  <c:v>541</c:v>
                </c:pt>
                <c:pt idx="160">
                  <c:v>540</c:v>
                </c:pt>
                <c:pt idx="161">
                  <c:v>539</c:v>
                </c:pt>
                <c:pt idx="162">
                  <c:v>538</c:v>
                </c:pt>
                <c:pt idx="163">
                  <c:v>537</c:v>
                </c:pt>
                <c:pt idx="164">
                  <c:v>536</c:v>
                </c:pt>
                <c:pt idx="165">
                  <c:v>535</c:v>
                </c:pt>
                <c:pt idx="166">
                  <c:v>534</c:v>
                </c:pt>
                <c:pt idx="167">
                  <c:v>533</c:v>
                </c:pt>
                <c:pt idx="168">
                  <c:v>532</c:v>
                </c:pt>
                <c:pt idx="169">
                  <c:v>531</c:v>
                </c:pt>
                <c:pt idx="170">
                  <c:v>530</c:v>
                </c:pt>
                <c:pt idx="171">
                  <c:v>529</c:v>
                </c:pt>
                <c:pt idx="172">
                  <c:v>528</c:v>
                </c:pt>
                <c:pt idx="173">
                  <c:v>527</c:v>
                </c:pt>
                <c:pt idx="174">
                  <c:v>526</c:v>
                </c:pt>
                <c:pt idx="175">
                  <c:v>525</c:v>
                </c:pt>
                <c:pt idx="176">
                  <c:v>524</c:v>
                </c:pt>
                <c:pt idx="177">
                  <c:v>523</c:v>
                </c:pt>
                <c:pt idx="178">
                  <c:v>522</c:v>
                </c:pt>
                <c:pt idx="179">
                  <c:v>521</c:v>
                </c:pt>
                <c:pt idx="180">
                  <c:v>520</c:v>
                </c:pt>
                <c:pt idx="181">
                  <c:v>519</c:v>
                </c:pt>
                <c:pt idx="182">
                  <c:v>518</c:v>
                </c:pt>
                <c:pt idx="183">
                  <c:v>517</c:v>
                </c:pt>
                <c:pt idx="184">
                  <c:v>516</c:v>
                </c:pt>
                <c:pt idx="185">
                  <c:v>515</c:v>
                </c:pt>
                <c:pt idx="186">
                  <c:v>514</c:v>
                </c:pt>
                <c:pt idx="187">
                  <c:v>513</c:v>
                </c:pt>
                <c:pt idx="188">
                  <c:v>512</c:v>
                </c:pt>
                <c:pt idx="189">
                  <c:v>511</c:v>
                </c:pt>
                <c:pt idx="190">
                  <c:v>510</c:v>
                </c:pt>
                <c:pt idx="191">
                  <c:v>509</c:v>
                </c:pt>
                <c:pt idx="192">
                  <c:v>508</c:v>
                </c:pt>
                <c:pt idx="193">
                  <c:v>507</c:v>
                </c:pt>
                <c:pt idx="194">
                  <c:v>506</c:v>
                </c:pt>
                <c:pt idx="195">
                  <c:v>505</c:v>
                </c:pt>
                <c:pt idx="196">
                  <c:v>504</c:v>
                </c:pt>
                <c:pt idx="197">
                  <c:v>503</c:v>
                </c:pt>
                <c:pt idx="198">
                  <c:v>502</c:v>
                </c:pt>
                <c:pt idx="199">
                  <c:v>501</c:v>
                </c:pt>
                <c:pt idx="200">
                  <c:v>500</c:v>
                </c:pt>
                <c:pt idx="201">
                  <c:v>499</c:v>
                </c:pt>
                <c:pt idx="202">
                  <c:v>498</c:v>
                </c:pt>
                <c:pt idx="203">
                  <c:v>497</c:v>
                </c:pt>
                <c:pt idx="204">
                  <c:v>496</c:v>
                </c:pt>
                <c:pt idx="205">
                  <c:v>495</c:v>
                </c:pt>
                <c:pt idx="206">
                  <c:v>494</c:v>
                </c:pt>
                <c:pt idx="207">
                  <c:v>493</c:v>
                </c:pt>
                <c:pt idx="208">
                  <c:v>492</c:v>
                </c:pt>
                <c:pt idx="209">
                  <c:v>491</c:v>
                </c:pt>
                <c:pt idx="210">
                  <c:v>490</c:v>
                </c:pt>
                <c:pt idx="211">
                  <c:v>489</c:v>
                </c:pt>
                <c:pt idx="212">
                  <c:v>488</c:v>
                </c:pt>
                <c:pt idx="213">
                  <c:v>487</c:v>
                </c:pt>
                <c:pt idx="214">
                  <c:v>486</c:v>
                </c:pt>
                <c:pt idx="215">
                  <c:v>485</c:v>
                </c:pt>
                <c:pt idx="216">
                  <c:v>484</c:v>
                </c:pt>
                <c:pt idx="217">
                  <c:v>483</c:v>
                </c:pt>
                <c:pt idx="218">
                  <c:v>482</c:v>
                </c:pt>
                <c:pt idx="219">
                  <c:v>481</c:v>
                </c:pt>
                <c:pt idx="220">
                  <c:v>480</c:v>
                </c:pt>
                <c:pt idx="221">
                  <c:v>479</c:v>
                </c:pt>
                <c:pt idx="222">
                  <c:v>478</c:v>
                </c:pt>
                <c:pt idx="223">
                  <c:v>477</c:v>
                </c:pt>
                <c:pt idx="224">
                  <c:v>476</c:v>
                </c:pt>
                <c:pt idx="225">
                  <c:v>475</c:v>
                </c:pt>
                <c:pt idx="226">
                  <c:v>474</c:v>
                </c:pt>
                <c:pt idx="227">
                  <c:v>473</c:v>
                </c:pt>
                <c:pt idx="228">
                  <c:v>472</c:v>
                </c:pt>
                <c:pt idx="229">
                  <c:v>471</c:v>
                </c:pt>
                <c:pt idx="230">
                  <c:v>470</c:v>
                </c:pt>
                <c:pt idx="231">
                  <c:v>469</c:v>
                </c:pt>
                <c:pt idx="232">
                  <c:v>468</c:v>
                </c:pt>
                <c:pt idx="233">
                  <c:v>467</c:v>
                </c:pt>
                <c:pt idx="234">
                  <c:v>466</c:v>
                </c:pt>
                <c:pt idx="235">
                  <c:v>465</c:v>
                </c:pt>
                <c:pt idx="236">
                  <c:v>464</c:v>
                </c:pt>
                <c:pt idx="237">
                  <c:v>463</c:v>
                </c:pt>
                <c:pt idx="238">
                  <c:v>462</c:v>
                </c:pt>
                <c:pt idx="239">
                  <c:v>461</c:v>
                </c:pt>
                <c:pt idx="240">
                  <c:v>460</c:v>
                </c:pt>
                <c:pt idx="241">
                  <c:v>459</c:v>
                </c:pt>
                <c:pt idx="242">
                  <c:v>458</c:v>
                </c:pt>
                <c:pt idx="243">
                  <c:v>457</c:v>
                </c:pt>
                <c:pt idx="244">
                  <c:v>456</c:v>
                </c:pt>
                <c:pt idx="245">
                  <c:v>455</c:v>
                </c:pt>
                <c:pt idx="246">
                  <c:v>454</c:v>
                </c:pt>
                <c:pt idx="247">
                  <c:v>453</c:v>
                </c:pt>
                <c:pt idx="248">
                  <c:v>452</c:v>
                </c:pt>
                <c:pt idx="249">
                  <c:v>451</c:v>
                </c:pt>
                <c:pt idx="250">
                  <c:v>450</c:v>
                </c:pt>
                <c:pt idx="251">
                  <c:v>449</c:v>
                </c:pt>
                <c:pt idx="252">
                  <c:v>448</c:v>
                </c:pt>
                <c:pt idx="253">
                  <c:v>447</c:v>
                </c:pt>
                <c:pt idx="254">
                  <c:v>446</c:v>
                </c:pt>
                <c:pt idx="255">
                  <c:v>445</c:v>
                </c:pt>
                <c:pt idx="256">
                  <c:v>444</c:v>
                </c:pt>
                <c:pt idx="257">
                  <c:v>443</c:v>
                </c:pt>
                <c:pt idx="258">
                  <c:v>442</c:v>
                </c:pt>
                <c:pt idx="259">
                  <c:v>441</c:v>
                </c:pt>
                <c:pt idx="260">
                  <c:v>440</c:v>
                </c:pt>
                <c:pt idx="261">
                  <c:v>439</c:v>
                </c:pt>
                <c:pt idx="262">
                  <c:v>438</c:v>
                </c:pt>
                <c:pt idx="263">
                  <c:v>437</c:v>
                </c:pt>
                <c:pt idx="264">
                  <c:v>436</c:v>
                </c:pt>
                <c:pt idx="265">
                  <c:v>435</c:v>
                </c:pt>
                <c:pt idx="266">
                  <c:v>434</c:v>
                </c:pt>
                <c:pt idx="267">
                  <c:v>433</c:v>
                </c:pt>
                <c:pt idx="268">
                  <c:v>432</c:v>
                </c:pt>
                <c:pt idx="269">
                  <c:v>431</c:v>
                </c:pt>
                <c:pt idx="270">
                  <c:v>430</c:v>
                </c:pt>
                <c:pt idx="271">
                  <c:v>429</c:v>
                </c:pt>
                <c:pt idx="272">
                  <c:v>428</c:v>
                </c:pt>
                <c:pt idx="273">
                  <c:v>427</c:v>
                </c:pt>
                <c:pt idx="274">
                  <c:v>426</c:v>
                </c:pt>
                <c:pt idx="275">
                  <c:v>425</c:v>
                </c:pt>
                <c:pt idx="276">
                  <c:v>424</c:v>
                </c:pt>
                <c:pt idx="277">
                  <c:v>423</c:v>
                </c:pt>
                <c:pt idx="278">
                  <c:v>422</c:v>
                </c:pt>
                <c:pt idx="279">
                  <c:v>421</c:v>
                </c:pt>
                <c:pt idx="280">
                  <c:v>420</c:v>
                </c:pt>
                <c:pt idx="281">
                  <c:v>419</c:v>
                </c:pt>
                <c:pt idx="282">
                  <c:v>418</c:v>
                </c:pt>
                <c:pt idx="283">
                  <c:v>417</c:v>
                </c:pt>
                <c:pt idx="284">
                  <c:v>416</c:v>
                </c:pt>
                <c:pt idx="285">
                  <c:v>415</c:v>
                </c:pt>
                <c:pt idx="286">
                  <c:v>414</c:v>
                </c:pt>
                <c:pt idx="287">
                  <c:v>413</c:v>
                </c:pt>
                <c:pt idx="288">
                  <c:v>412</c:v>
                </c:pt>
                <c:pt idx="289">
                  <c:v>411</c:v>
                </c:pt>
                <c:pt idx="290">
                  <c:v>410</c:v>
                </c:pt>
                <c:pt idx="291">
                  <c:v>409</c:v>
                </c:pt>
                <c:pt idx="292">
                  <c:v>408</c:v>
                </c:pt>
                <c:pt idx="293">
                  <c:v>407</c:v>
                </c:pt>
                <c:pt idx="294">
                  <c:v>406</c:v>
                </c:pt>
                <c:pt idx="295">
                  <c:v>405</c:v>
                </c:pt>
                <c:pt idx="296">
                  <c:v>404</c:v>
                </c:pt>
                <c:pt idx="297">
                  <c:v>403</c:v>
                </c:pt>
                <c:pt idx="298">
                  <c:v>402</c:v>
                </c:pt>
                <c:pt idx="299">
                  <c:v>401</c:v>
                </c:pt>
                <c:pt idx="300">
                  <c:v>400</c:v>
                </c:pt>
                <c:pt idx="301">
                  <c:v>399</c:v>
                </c:pt>
                <c:pt idx="302">
                  <c:v>398</c:v>
                </c:pt>
                <c:pt idx="303">
                  <c:v>397</c:v>
                </c:pt>
                <c:pt idx="304">
                  <c:v>396</c:v>
                </c:pt>
                <c:pt idx="305">
                  <c:v>395</c:v>
                </c:pt>
                <c:pt idx="306">
                  <c:v>394</c:v>
                </c:pt>
                <c:pt idx="307">
                  <c:v>393</c:v>
                </c:pt>
                <c:pt idx="308">
                  <c:v>392</c:v>
                </c:pt>
                <c:pt idx="309">
                  <c:v>391</c:v>
                </c:pt>
                <c:pt idx="310">
                  <c:v>390</c:v>
                </c:pt>
                <c:pt idx="311">
                  <c:v>389</c:v>
                </c:pt>
                <c:pt idx="312">
                  <c:v>388</c:v>
                </c:pt>
                <c:pt idx="313">
                  <c:v>387</c:v>
                </c:pt>
                <c:pt idx="314">
                  <c:v>386</c:v>
                </c:pt>
                <c:pt idx="315">
                  <c:v>385</c:v>
                </c:pt>
                <c:pt idx="316">
                  <c:v>384</c:v>
                </c:pt>
                <c:pt idx="317">
                  <c:v>383</c:v>
                </c:pt>
                <c:pt idx="318">
                  <c:v>382</c:v>
                </c:pt>
                <c:pt idx="319">
                  <c:v>381</c:v>
                </c:pt>
                <c:pt idx="320">
                  <c:v>380</c:v>
                </c:pt>
                <c:pt idx="321">
                  <c:v>379</c:v>
                </c:pt>
                <c:pt idx="322">
                  <c:v>378</c:v>
                </c:pt>
                <c:pt idx="323">
                  <c:v>377</c:v>
                </c:pt>
                <c:pt idx="324">
                  <c:v>376</c:v>
                </c:pt>
                <c:pt idx="325">
                  <c:v>375</c:v>
                </c:pt>
                <c:pt idx="326">
                  <c:v>374</c:v>
                </c:pt>
                <c:pt idx="327">
                  <c:v>373</c:v>
                </c:pt>
                <c:pt idx="328">
                  <c:v>372</c:v>
                </c:pt>
                <c:pt idx="329">
                  <c:v>371</c:v>
                </c:pt>
                <c:pt idx="330">
                  <c:v>370</c:v>
                </c:pt>
                <c:pt idx="331">
                  <c:v>369</c:v>
                </c:pt>
                <c:pt idx="332">
                  <c:v>368</c:v>
                </c:pt>
                <c:pt idx="333">
                  <c:v>367</c:v>
                </c:pt>
                <c:pt idx="334">
                  <c:v>366</c:v>
                </c:pt>
                <c:pt idx="335">
                  <c:v>365</c:v>
                </c:pt>
                <c:pt idx="336">
                  <c:v>364</c:v>
                </c:pt>
                <c:pt idx="337">
                  <c:v>363</c:v>
                </c:pt>
                <c:pt idx="338">
                  <c:v>362</c:v>
                </c:pt>
                <c:pt idx="339">
                  <c:v>361</c:v>
                </c:pt>
                <c:pt idx="340">
                  <c:v>360</c:v>
                </c:pt>
                <c:pt idx="341">
                  <c:v>359</c:v>
                </c:pt>
                <c:pt idx="342">
                  <c:v>358</c:v>
                </c:pt>
                <c:pt idx="343">
                  <c:v>357</c:v>
                </c:pt>
                <c:pt idx="344">
                  <c:v>356</c:v>
                </c:pt>
                <c:pt idx="345">
                  <c:v>355</c:v>
                </c:pt>
                <c:pt idx="346">
                  <c:v>354</c:v>
                </c:pt>
                <c:pt idx="347">
                  <c:v>353</c:v>
                </c:pt>
                <c:pt idx="348">
                  <c:v>352</c:v>
                </c:pt>
                <c:pt idx="349">
                  <c:v>351</c:v>
                </c:pt>
                <c:pt idx="350">
                  <c:v>350</c:v>
                </c:pt>
                <c:pt idx="351">
                  <c:v>349</c:v>
                </c:pt>
                <c:pt idx="352">
                  <c:v>348</c:v>
                </c:pt>
                <c:pt idx="353">
                  <c:v>347</c:v>
                </c:pt>
                <c:pt idx="354">
                  <c:v>346</c:v>
                </c:pt>
                <c:pt idx="355">
                  <c:v>345</c:v>
                </c:pt>
                <c:pt idx="356">
                  <c:v>344</c:v>
                </c:pt>
                <c:pt idx="357">
                  <c:v>343</c:v>
                </c:pt>
                <c:pt idx="358">
                  <c:v>342</c:v>
                </c:pt>
                <c:pt idx="359">
                  <c:v>341</c:v>
                </c:pt>
                <c:pt idx="360">
                  <c:v>340</c:v>
                </c:pt>
                <c:pt idx="361">
                  <c:v>339</c:v>
                </c:pt>
                <c:pt idx="362">
                  <c:v>338</c:v>
                </c:pt>
                <c:pt idx="363">
                  <c:v>337</c:v>
                </c:pt>
                <c:pt idx="364">
                  <c:v>336</c:v>
                </c:pt>
                <c:pt idx="365">
                  <c:v>335</c:v>
                </c:pt>
                <c:pt idx="366">
                  <c:v>334</c:v>
                </c:pt>
                <c:pt idx="367">
                  <c:v>333</c:v>
                </c:pt>
                <c:pt idx="368">
                  <c:v>332</c:v>
                </c:pt>
                <c:pt idx="369">
                  <c:v>331</c:v>
                </c:pt>
                <c:pt idx="370">
                  <c:v>330</c:v>
                </c:pt>
                <c:pt idx="371">
                  <c:v>329</c:v>
                </c:pt>
                <c:pt idx="372">
                  <c:v>328</c:v>
                </c:pt>
                <c:pt idx="373">
                  <c:v>327</c:v>
                </c:pt>
                <c:pt idx="374">
                  <c:v>326</c:v>
                </c:pt>
                <c:pt idx="375">
                  <c:v>325</c:v>
                </c:pt>
                <c:pt idx="376">
                  <c:v>324</c:v>
                </c:pt>
                <c:pt idx="377">
                  <c:v>323</c:v>
                </c:pt>
                <c:pt idx="378">
                  <c:v>322</c:v>
                </c:pt>
                <c:pt idx="379">
                  <c:v>321</c:v>
                </c:pt>
                <c:pt idx="380">
                  <c:v>320</c:v>
                </c:pt>
                <c:pt idx="381">
                  <c:v>319</c:v>
                </c:pt>
                <c:pt idx="382">
                  <c:v>318</c:v>
                </c:pt>
                <c:pt idx="383">
                  <c:v>317</c:v>
                </c:pt>
                <c:pt idx="384">
                  <c:v>316</c:v>
                </c:pt>
                <c:pt idx="385">
                  <c:v>315</c:v>
                </c:pt>
                <c:pt idx="386">
                  <c:v>314</c:v>
                </c:pt>
                <c:pt idx="387">
                  <c:v>313</c:v>
                </c:pt>
                <c:pt idx="388">
                  <c:v>312</c:v>
                </c:pt>
                <c:pt idx="389">
                  <c:v>311</c:v>
                </c:pt>
                <c:pt idx="390">
                  <c:v>310</c:v>
                </c:pt>
                <c:pt idx="391">
                  <c:v>309</c:v>
                </c:pt>
                <c:pt idx="392">
                  <c:v>308</c:v>
                </c:pt>
                <c:pt idx="393">
                  <c:v>307</c:v>
                </c:pt>
                <c:pt idx="394">
                  <c:v>306</c:v>
                </c:pt>
                <c:pt idx="395">
                  <c:v>305</c:v>
                </c:pt>
                <c:pt idx="396">
                  <c:v>304</c:v>
                </c:pt>
                <c:pt idx="397">
                  <c:v>303</c:v>
                </c:pt>
                <c:pt idx="398">
                  <c:v>302</c:v>
                </c:pt>
                <c:pt idx="399">
                  <c:v>301</c:v>
                </c:pt>
                <c:pt idx="400">
                  <c:v>300</c:v>
                </c:pt>
                <c:pt idx="401">
                  <c:v>299</c:v>
                </c:pt>
                <c:pt idx="402">
                  <c:v>298</c:v>
                </c:pt>
                <c:pt idx="403">
                  <c:v>297</c:v>
                </c:pt>
                <c:pt idx="404">
                  <c:v>296</c:v>
                </c:pt>
                <c:pt idx="405">
                  <c:v>295</c:v>
                </c:pt>
                <c:pt idx="406">
                  <c:v>294</c:v>
                </c:pt>
                <c:pt idx="407">
                  <c:v>293</c:v>
                </c:pt>
                <c:pt idx="408">
                  <c:v>292</c:v>
                </c:pt>
                <c:pt idx="409">
                  <c:v>291</c:v>
                </c:pt>
                <c:pt idx="410">
                  <c:v>290</c:v>
                </c:pt>
                <c:pt idx="411">
                  <c:v>289</c:v>
                </c:pt>
                <c:pt idx="412">
                  <c:v>288</c:v>
                </c:pt>
                <c:pt idx="413">
                  <c:v>287</c:v>
                </c:pt>
                <c:pt idx="414">
                  <c:v>286</c:v>
                </c:pt>
                <c:pt idx="415">
                  <c:v>285</c:v>
                </c:pt>
                <c:pt idx="416">
                  <c:v>284</c:v>
                </c:pt>
                <c:pt idx="417">
                  <c:v>283</c:v>
                </c:pt>
                <c:pt idx="418">
                  <c:v>282</c:v>
                </c:pt>
                <c:pt idx="419">
                  <c:v>281</c:v>
                </c:pt>
                <c:pt idx="420">
                  <c:v>280</c:v>
                </c:pt>
                <c:pt idx="421">
                  <c:v>279</c:v>
                </c:pt>
                <c:pt idx="422">
                  <c:v>278</c:v>
                </c:pt>
                <c:pt idx="423">
                  <c:v>277</c:v>
                </c:pt>
                <c:pt idx="424">
                  <c:v>276</c:v>
                </c:pt>
                <c:pt idx="425">
                  <c:v>275</c:v>
                </c:pt>
                <c:pt idx="426">
                  <c:v>274</c:v>
                </c:pt>
                <c:pt idx="427">
                  <c:v>273</c:v>
                </c:pt>
                <c:pt idx="428">
                  <c:v>272</c:v>
                </c:pt>
                <c:pt idx="429">
                  <c:v>271</c:v>
                </c:pt>
                <c:pt idx="430">
                  <c:v>270</c:v>
                </c:pt>
                <c:pt idx="431">
                  <c:v>269</c:v>
                </c:pt>
                <c:pt idx="432">
                  <c:v>268</c:v>
                </c:pt>
                <c:pt idx="433">
                  <c:v>267</c:v>
                </c:pt>
                <c:pt idx="434">
                  <c:v>266</c:v>
                </c:pt>
                <c:pt idx="435">
                  <c:v>265</c:v>
                </c:pt>
                <c:pt idx="436">
                  <c:v>264</c:v>
                </c:pt>
                <c:pt idx="437">
                  <c:v>263</c:v>
                </c:pt>
                <c:pt idx="438">
                  <c:v>262</c:v>
                </c:pt>
                <c:pt idx="439">
                  <c:v>261</c:v>
                </c:pt>
                <c:pt idx="440">
                  <c:v>260</c:v>
                </c:pt>
                <c:pt idx="441">
                  <c:v>259</c:v>
                </c:pt>
                <c:pt idx="442">
                  <c:v>258</c:v>
                </c:pt>
                <c:pt idx="443">
                  <c:v>257</c:v>
                </c:pt>
                <c:pt idx="444">
                  <c:v>256</c:v>
                </c:pt>
                <c:pt idx="445">
                  <c:v>255</c:v>
                </c:pt>
                <c:pt idx="446">
                  <c:v>254</c:v>
                </c:pt>
                <c:pt idx="447">
                  <c:v>253</c:v>
                </c:pt>
                <c:pt idx="448">
                  <c:v>252</c:v>
                </c:pt>
                <c:pt idx="449">
                  <c:v>251</c:v>
                </c:pt>
                <c:pt idx="450">
                  <c:v>250</c:v>
                </c:pt>
                <c:pt idx="451">
                  <c:v>249</c:v>
                </c:pt>
                <c:pt idx="452">
                  <c:v>248</c:v>
                </c:pt>
                <c:pt idx="453">
                  <c:v>247</c:v>
                </c:pt>
                <c:pt idx="454">
                  <c:v>246</c:v>
                </c:pt>
                <c:pt idx="455">
                  <c:v>245</c:v>
                </c:pt>
                <c:pt idx="456">
                  <c:v>244</c:v>
                </c:pt>
                <c:pt idx="457">
                  <c:v>243</c:v>
                </c:pt>
                <c:pt idx="458">
                  <c:v>242</c:v>
                </c:pt>
                <c:pt idx="459">
                  <c:v>241</c:v>
                </c:pt>
                <c:pt idx="460">
                  <c:v>240</c:v>
                </c:pt>
                <c:pt idx="461">
                  <c:v>239</c:v>
                </c:pt>
                <c:pt idx="462">
                  <c:v>238</c:v>
                </c:pt>
                <c:pt idx="463">
                  <c:v>237</c:v>
                </c:pt>
                <c:pt idx="464">
                  <c:v>236</c:v>
                </c:pt>
                <c:pt idx="465">
                  <c:v>235</c:v>
                </c:pt>
                <c:pt idx="466">
                  <c:v>234</c:v>
                </c:pt>
                <c:pt idx="467">
                  <c:v>233</c:v>
                </c:pt>
                <c:pt idx="468">
                  <c:v>232</c:v>
                </c:pt>
                <c:pt idx="469">
                  <c:v>231</c:v>
                </c:pt>
                <c:pt idx="470">
                  <c:v>230</c:v>
                </c:pt>
                <c:pt idx="471">
                  <c:v>229</c:v>
                </c:pt>
                <c:pt idx="472">
                  <c:v>228</c:v>
                </c:pt>
                <c:pt idx="473">
                  <c:v>227</c:v>
                </c:pt>
                <c:pt idx="474">
                  <c:v>226</c:v>
                </c:pt>
                <c:pt idx="475">
                  <c:v>225</c:v>
                </c:pt>
                <c:pt idx="476">
                  <c:v>224</c:v>
                </c:pt>
                <c:pt idx="477">
                  <c:v>223</c:v>
                </c:pt>
                <c:pt idx="478">
                  <c:v>222</c:v>
                </c:pt>
                <c:pt idx="479">
                  <c:v>221</c:v>
                </c:pt>
                <c:pt idx="480">
                  <c:v>220</c:v>
                </c:pt>
              </c:numCache>
            </c:numRef>
          </c:xVal>
          <c:yVal>
            <c:numRef>
              <c:f>文章选用!$C$2:$C$482</c:f>
              <c:numCache>
                <c:formatCode>General</c:formatCode>
                <c:ptCount val="481"/>
                <c:pt idx="0">
                  <c:v>5.0000000000000001E-3</c:v>
                </c:pt>
                <c:pt idx="1">
                  <c:v>5.0000000000000001E-3</c:v>
                </c:pt>
                <c:pt idx="2">
                  <c:v>5.0000000000000001E-3</c:v>
                </c:pt>
                <c:pt idx="3">
                  <c:v>5.0000000000000001E-3</c:v>
                </c:pt>
                <c:pt idx="4">
                  <c:v>5.0000000000000001E-3</c:v>
                </c:pt>
                <c:pt idx="5">
                  <c:v>5.0000000000000001E-3</c:v>
                </c:pt>
                <c:pt idx="6">
                  <c:v>5.0000000000000001E-3</c:v>
                </c:pt>
                <c:pt idx="7">
                  <c:v>5.0000000000000001E-3</c:v>
                </c:pt>
                <c:pt idx="8">
                  <c:v>6.0000000000000001E-3</c:v>
                </c:pt>
                <c:pt idx="9">
                  <c:v>6.0000000000000001E-3</c:v>
                </c:pt>
                <c:pt idx="10">
                  <c:v>6.0000000000000001E-3</c:v>
                </c:pt>
                <c:pt idx="11">
                  <c:v>6.0000000000000001E-3</c:v>
                </c:pt>
                <c:pt idx="12">
                  <c:v>6.0000000000000001E-3</c:v>
                </c:pt>
                <c:pt idx="13">
                  <c:v>6.0000000000000001E-3</c:v>
                </c:pt>
                <c:pt idx="14">
                  <c:v>6.0000000000000001E-3</c:v>
                </c:pt>
                <c:pt idx="15">
                  <c:v>6.0000000000000001E-3</c:v>
                </c:pt>
                <c:pt idx="16">
                  <c:v>6.0000000000000001E-3</c:v>
                </c:pt>
                <c:pt idx="17">
                  <c:v>6.0000000000000001E-3</c:v>
                </c:pt>
                <c:pt idx="18">
                  <c:v>6.0000000000000001E-3</c:v>
                </c:pt>
                <c:pt idx="19">
                  <c:v>6.0000000000000001E-3</c:v>
                </c:pt>
                <c:pt idx="20">
                  <c:v>6.0000000000000001E-3</c:v>
                </c:pt>
                <c:pt idx="21">
                  <c:v>6.0000000000000001E-3</c:v>
                </c:pt>
                <c:pt idx="22">
                  <c:v>6.0000000000000001E-3</c:v>
                </c:pt>
                <c:pt idx="23">
                  <c:v>6.0000000000000001E-3</c:v>
                </c:pt>
                <c:pt idx="24">
                  <c:v>6.0000000000000001E-3</c:v>
                </c:pt>
                <c:pt idx="25">
                  <c:v>6.0000000000000001E-3</c:v>
                </c:pt>
                <c:pt idx="26">
                  <c:v>6.0000000000000001E-3</c:v>
                </c:pt>
                <c:pt idx="27">
                  <c:v>6.0000000000000001E-3</c:v>
                </c:pt>
                <c:pt idx="28">
                  <c:v>6.0000000000000001E-3</c:v>
                </c:pt>
                <c:pt idx="29">
                  <c:v>6.0000000000000001E-3</c:v>
                </c:pt>
                <c:pt idx="30">
                  <c:v>6.0000000000000001E-3</c:v>
                </c:pt>
                <c:pt idx="31">
                  <c:v>6.0000000000000001E-3</c:v>
                </c:pt>
                <c:pt idx="32">
                  <c:v>6.0000000000000001E-3</c:v>
                </c:pt>
                <c:pt idx="33">
                  <c:v>6.0000000000000001E-3</c:v>
                </c:pt>
                <c:pt idx="34">
                  <c:v>6.0000000000000001E-3</c:v>
                </c:pt>
                <c:pt idx="35">
                  <c:v>6.0000000000000001E-3</c:v>
                </c:pt>
                <c:pt idx="36">
                  <c:v>6.0000000000000001E-3</c:v>
                </c:pt>
                <c:pt idx="37">
                  <c:v>7.0000000000000001E-3</c:v>
                </c:pt>
                <c:pt idx="38">
                  <c:v>7.0000000000000001E-3</c:v>
                </c:pt>
                <c:pt idx="39">
                  <c:v>7.0000000000000001E-3</c:v>
                </c:pt>
                <c:pt idx="40">
                  <c:v>6.0000000000000001E-3</c:v>
                </c:pt>
                <c:pt idx="41">
                  <c:v>6.0000000000000001E-3</c:v>
                </c:pt>
                <c:pt idx="42">
                  <c:v>6.0000000000000001E-3</c:v>
                </c:pt>
                <c:pt idx="43">
                  <c:v>6.0000000000000001E-3</c:v>
                </c:pt>
                <c:pt idx="44">
                  <c:v>6.0000000000000001E-3</c:v>
                </c:pt>
                <c:pt idx="45">
                  <c:v>6.0000000000000001E-3</c:v>
                </c:pt>
                <c:pt idx="46">
                  <c:v>6.0000000000000001E-3</c:v>
                </c:pt>
                <c:pt idx="47">
                  <c:v>6.0000000000000001E-3</c:v>
                </c:pt>
                <c:pt idx="48">
                  <c:v>6.0000000000000001E-3</c:v>
                </c:pt>
                <c:pt idx="49">
                  <c:v>6.0000000000000001E-3</c:v>
                </c:pt>
                <c:pt idx="50">
                  <c:v>6.0000000000000001E-3</c:v>
                </c:pt>
                <c:pt idx="51">
                  <c:v>6.0000000000000001E-3</c:v>
                </c:pt>
                <c:pt idx="52">
                  <c:v>6.0000000000000001E-3</c:v>
                </c:pt>
                <c:pt idx="53">
                  <c:v>5.0000000000000001E-3</c:v>
                </c:pt>
                <c:pt idx="54">
                  <c:v>5.0000000000000001E-3</c:v>
                </c:pt>
                <c:pt idx="55">
                  <c:v>5.0000000000000001E-3</c:v>
                </c:pt>
                <c:pt idx="56">
                  <c:v>5.0000000000000001E-3</c:v>
                </c:pt>
                <c:pt idx="57">
                  <c:v>5.0000000000000001E-3</c:v>
                </c:pt>
                <c:pt idx="58">
                  <c:v>5.0000000000000001E-3</c:v>
                </c:pt>
                <c:pt idx="59">
                  <c:v>5.0000000000000001E-3</c:v>
                </c:pt>
                <c:pt idx="60">
                  <c:v>5.0000000000000001E-3</c:v>
                </c:pt>
                <c:pt idx="61">
                  <c:v>5.0000000000000001E-3</c:v>
                </c:pt>
                <c:pt idx="62">
                  <c:v>5.0000000000000001E-3</c:v>
                </c:pt>
                <c:pt idx="63">
                  <c:v>5.0000000000000001E-3</c:v>
                </c:pt>
                <c:pt idx="64">
                  <c:v>4.0000000000000001E-3</c:v>
                </c:pt>
                <c:pt idx="65">
                  <c:v>4.0000000000000001E-3</c:v>
                </c:pt>
                <c:pt idx="66">
                  <c:v>4.0000000000000001E-3</c:v>
                </c:pt>
                <c:pt idx="67">
                  <c:v>4.0000000000000001E-3</c:v>
                </c:pt>
                <c:pt idx="68">
                  <c:v>4.0000000000000001E-3</c:v>
                </c:pt>
                <c:pt idx="69">
                  <c:v>4.0000000000000001E-3</c:v>
                </c:pt>
                <c:pt idx="70">
                  <c:v>4.0000000000000001E-3</c:v>
                </c:pt>
                <c:pt idx="71">
                  <c:v>4.0000000000000001E-3</c:v>
                </c:pt>
                <c:pt idx="72">
                  <c:v>4.0000000000000001E-3</c:v>
                </c:pt>
                <c:pt idx="73">
                  <c:v>4.0000000000000001E-3</c:v>
                </c:pt>
                <c:pt idx="74">
                  <c:v>4.0000000000000001E-3</c:v>
                </c:pt>
                <c:pt idx="75">
                  <c:v>4.0000000000000001E-3</c:v>
                </c:pt>
                <c:pt idx="76">
                  <c:v>4.0000000000000001E-3</c:v>
                </c:pt>
                <c:pt idx="77">
                  <c:v>4.0000000000000001E-3</c:v>
                </c:pt>
                <c:pt idx="78">
                  <c:v>4.0000000000000001E-3</c:v>
                </c:pt>
                <c:pt idx="79">
                  <c:v>4.0000000000000001E-3</c:v>
                </c:pt>
                <c:pt idx="80">
                  <c:v>4.0000000000000001E-3</c:v>
                </c:pt>
                <c:pt idx="81">
                  <c:v>4.0000000000000001E-3</c:v>
                </c:pt>
                <c:pt idx="82">
                  <c:v>4.0000000000000001E-3</c:v>
                </c:pt>
                <c:pt idx="83">
                  <c:v>4.0000000000000001E-3</c:v>
                </c:pt>
                <c:pt idx="84">
                  <c:v>4.0000000000000001E-3</c:v>
                </c:pt>
                <c:pt idx="85">
                  <c:v>4.0000000000000001E-3</c:v>
                </c:pt>
                <c:pt idx="86">
                  <c:v>4.0000000000000001E-3</c:v>
                </c:pt>
                <c:pt idx="87">
                  <c:v>4.0000000000000001E-3</c:v>
                </c:pt>
                <c:pt idx="88">
                  <c:v>4.0000000000000001E-3</c:v>
                </c:pt>
                <c:pt idx="89">
                  <c:v>4.0000000000000001E-3</c:v>
                </c:pt>
                <c:pt idx="90">
                  <c:v>4.0000000000000001E-3</c:v>
                </c:pt>
                <c:pt idx="91">
                  <c:v>4.0000000000000001E-3</c:v>
                </c:pt>
                <c:pt idx="92">
                  <c:v>4.0000000000000001E-3</c:v>
                </c:pt>
                <c:pt idx="93">
                  <c:v>4.0000000000000001E-3</c:v>
                </c:pt>
                <c:pt idx="94">
                  <c:v>4.0000000000000001E-3</c:v>
                </c:pt>
                <c:pt idx="95">
                  <c:v>4.0000000000000001E-3</c:v>
                </c:pt>
                <c:pt idx="96">
                  <c:v>4.0000000000000001E-3</c:v>
                </c:pt>
                <c:pt idx="97">
                  <c:v>4.0000000000000001E-3</c:v>
                </c:pt>
                <c:pt idx="98">
                  <c:v>4.0000000000000001E-3</c:v>
                </c:pt>
                <c:pt idx="99">
                  <c:v>4.0000000000000001E-3</c:v>
                </c:pt>
                <c:pt idx="100">
                  <c:v>4.0000000000000001E-3</c:v>
                </c:pt>
                <c:pt idx="101">
                  <c:v>4.0000000000000001E-3</c:v>
                </c:pt>
                <c:pt idx="102">
                  <c:v>4.0000000000000001E-3</c:v>
                </c:pt>
                <c:pt idx="103">
                  <c:v>4.0000000000000001E-3</c:v>
                </c:pt>
                <c:pt idx="104">
                  <c:v>4.0000000000000001E-3</c:v>
                </c:pt>
                <c:pt idx="105">
                  <c:v>5.0000000000000001E-3</c:v>
                </c:pt>
                <c:pt idx="106">
                  <c:v>5.0000000000000001E-3</c:v>
                </c:pt>
                <c:pt idx="107">
                  <c:v>5.0000000000000001E-3</c:v>
                </c:pt>
                <c:pt idx="108">
                  <c:v>5.0000000000000001E-3</c:v>
                </c:pt>
                <c:pt idx="109">
                  <c:v>4.0000000000000001E-3</c:v>
                </c:pt>
                <c:pt idx="110">
                  <c:v>4.0000000000000001E-3</c:v>
                </c:pt>
                <c:pt idx="111">
                  <c:v>4.0000000000000001E-3</c:v>
                </c:pt>
                <c:pt idx="112">
                  <c:v>4.0000000000000001E-3</c:v>
                </c:pt>
                <c:pt idx="113">
                  <c:v>4.0000000000000001E-3</c:v>
                </c:pt>
                <c:pt idx="114">
                  <c:v>4.0000000000000001E-3</c:v>
                </c:pt>
                <c:pt idx="115">
                  <c:v>4.0000000000000001E-3</c:v>
                </c:pt>
                <c:pt idx="116">
                  <c:v>4.0000000000000001E-3</c:v>
                </c:pt>
                <c:pt idx="117">
                  <c:v>3.0000000000000001E-3</c:v>
                </c:pt>
                <c:pt idx="118">
                  <c:v>3.0000000000000001E-3</c:v>
                </c:pt>
                <c:pt idx="119">
                  <c:v>3.0000000000000001E-3</c:v>
                </c:pt>
                <c:pt idx="120">
                  <c:v>3.0000000000000001E-3</c:v>
                </c:pt>
                <c:pt idx="121">
                  <c:v>3.0000000000000001E-3</c:v>
                </c:pt>
                <c:pt idx="122">
                  <c:v>3.0000000000000001E-3</c:v>
                </c:pt>
                <c:pt idx="123">
                  <c:v>3.0000000000000001E-3</c:v>
                </c:pt>
                <c:pt idx="124">
                  <c:v>3.0000000000000001E-3</c:v>
                </c:pt>
                <c:pt idx="125">
                  <c:v>2E-3</c:v>
                </c:pt>
                <c:pt idx="126">
                  <c:v>2E-3</c:v>
                </c:pt>
                <c:pt idx="127">
                  <c:v>2E-3</c:v>
                </c:pt>
                <c:pt idx="128">
                  <c:v>2E-3</c:v>
                </c:pt>
                <c:pt idx="129">
                  <c:v>2E-3</c:v>
                </c:pt>
                <c:pt idx="130">
                  <c:v>2E-3</c:v>
                </c:pt>
                <c:pt idx="131">
                  <c:v>1E-3</c:v>
                </c:pt>
                <c:pt idx="132">
                  <c:v>1E-3</c:v>
                </c:pt>
                <c:pt idx="133">
                  <c:v>1E-3</c:v>
                </c:pt>
                <c:pt idx="134">
                  <c:v>1E-3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-1E-3</c:v>
                </c:pt>
                <c:pt idx="142">
                  <c:v>-1E-3</c:v>
                </c:pt>
                <c:pt idx="143">
                  <c:v>-1E-3</c:v>
                </c:pt>
                <c:pt idx="144">
                  <c:v>-1E-3</c:v>
                </c:pt>
                <c:pt idx="145">
                  <c:v>-1E-3</c:v>
                </c:pt>
                <c:pt idx="146">
                  <c:v>-1E-3</c:v>
                </c:pt>
                <c:pt idx="147">
                  <c:v>-1E-3</c:v>
                </c:pt>
                <c:pt idx="148">
                  <c:v>-1E-3</c:v>
                </c:pt>
                <c:pt idx="149">
                  <c:v>-1E-3</c:v>
                </c:pt>
                <c:pt idx="150">
                  <c:v>-2E-3</c:v>
                </c:pt>
                <c:pt idx="151">
                  <c:v>-2E-3</c:v>
                </c:pt>
                <c:pt idx="152">
                  <c:v>-2E-3</c:v>
                </c:pt>
                <c:pt idx="153">
                  <c:v>-2E-3</c:v>
                </c:pt>
                <c:pt idx="154">
                  <c:v>-2E-3</c:v>
                </c:pt>
                <c:pt idx="155">
                  <c:v>-2E-3</c:v>
                </c:pt>
                <c:pt idx="156">
                  <c:v>-2E-3</c:v>
                </c:pt>
                <c:pt idx="157">
                  <c:v>-2E-3</c:v>
                </c:pt>
                <c:pt idx="158">
                  <c:v>-2E-3</c:v>
                </c:pt>
                <c:pt idx="159">
                  <c:v>-2E-3</c:v>
                </c:pt>
                <c:pt idx="160">
                  <c:v>-2E-3</c:v>
                </c:pt>
                <c:pt idx="161">
                  <c:v>-2E-3</c:v>
                </c:pt>
                <c:pt idx="162">
                  <c:v>-1E-3</c:v>
                </c:pt>
                <c:pt idx="163">
                  <c:v>-1E-3</c:v>
                </c:pt>
                <c:pt idx="164">
                  <c:v>-1E-3</c:v>
                </c:pt>
                <c:pt idx="165">
                  <c:v>-1E-3</c:v>
                </c:pt>
                <c:pt idx="166">
                  <c:v>-1E-3</c:v>
                </c:pt>
                <c:pt idx="167">
                  <c:v>-1E-3</c:v>
                </c:pt>
                <c:pt idx="168">
                  <c:v>-1E-3</c:v>
                </c:pt>
                <c:pt idx="169">
                  <c:v>-1E-3</c:v>
                </c:pt>
                <c:pt idx="170">
                  <c:v>-1E-3</c:v>
                </c:pt>
                <c:pt idx="171">
                  <c:v>-1E-3</c:v>
                </c:pt>
                <c:pt idx="172">
                  <c:v>-1E-3</c:v>
                </c:pt>
                <c:pt idx="173">
                  <c:v>-1E-3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1E-3</c:v>
                </c:pt>
                <c:pt idx="181">
                  <c:v>1E-3</c:v>
                </c:pt>
                <c:pt idx="182">
                  <c:v>1E-3</c:v>
                </c:pt>
                <c:pt idx="183">
                  <c:v>1E-3</c:v>
                </c:pt>
                <c:pt idx="184">
                  <c:v>1E-3</c:v>
                </c:pt>
                <c:pt idx="185">
                  <c:v>1E-3</c:v>
                </c:pt>
                <c:pt idx="186">
                  <c:v>1E-3</c:v>
                </c:pt>
                <c:pt idx="187">
                  <c:v>1E-3</c:v>
                </c:pt>
                <c:pt idx="188">
                  <c:v>1E-3</c:v>
                </c:pt>
                <c:pt idx="189">
                  <c:v>2E-3</c:v>
                </c:pt>
                <c:pt idx="190">
                  <c:v>2E-3</c:v>
                </c:pt>
                <c:pt idx="191">
                  <c:v>2E-3</c:v>
                </c:pt>
                <c:pt idx="192">
                  <c:v>2E-3</c:v>
                </c:pt>
                <c:pt idx="193">
                  <c:v>2E-3</c:v>
                </c:pt>
                <c:pt idx="194">
                  <c:v>2E-3</c:v>
                </c:pt>
                <c:pt idx="195">
                  <c:v>2E-3</c:v>
                </c:pt>
                <c:pt idx="196">
                  <c:v>2E-3</c:v>
                </c:pt>
                <c:pt idx="197">
                  <c:v>2E-3</c:v>
                </c:pt>
                <c:pt idx="198">
                  <c:v>2E-3</c:v>
                </c:pt>
                <c:pt idx="199">
                  <c:v>2E-3</c:v>
                </c:pt>
                <c:pt idx="200">
                  <c:v>2E-3</c:v>
                </c:pt>
                <c:pt idx="201">
                  <c:v>2E-3</c:v>
                </c:pt>
                <c:pt idx="202">
                  <c:v>2E-3</c:v>
                </c:pt>
                <c:pt idx="203">
                  <c:v>2E-3</c:v>
                </c:pt>
                <c:pt idx="204">
                  <c:v>2E-3</c:v>
                </c:pt>
                <c:pt idx="205">
                  <c:v>2E-3</c:v>
                </c:pt>
                <c:pt idx="206">
                  <c:v>2E-3</c:v>
                </c:pt>
                <c:pt idx="207">
                  <c:v>2E-3</c:v>
                </c:pt>
                <c:pt idx="208">
                  <c:v>2E-3</c:v>
                </c:pt>
                <c:pt idx="209">
                  <c:v>2E-3</c:v>
                </c:pt>
                <c:pt idx="210">
                  <c:v>2E-3</c:v>
                </c:pt>
                <c:pt idx="211">
                  <c:v>2E-3</c:v>
                </c:pt>
                <c:pt idx="212">
                  <c:v>2E-3</c:v>
                </c:pt>
                <c:pt idx="213">
                  <c:v>2E-3</c:v>
                </c:pt>
                <c:pt idx="214">
                  <c:v>2E-3</c:v>
                </c:pt>
                <c:pt idx="215">
                  <c:v>2E-3</c:v>
                </c:pt>
                <c:pt idx="216">
                  <c:v>3.0000000000000001E-3</c:v>
                </c:pt>
                <c:pt idx="217">
                  <c:v>3.0000000000000001E-3</c:v>
                </c:pt>
                <c:pt idx="218">
                  <c:v>3.0000000000000001E-3</c:v>
                </c:pt>
                <c:pt idx="219">
                  <c:v>3.0000000000000001E-3</c:v>
                </c:pt>
                <c:pt idx="220">
                  <c:v>3.0000000000000001E-3</c:v>
                </c:pt>
                <c:pt idx="221">
                  <c:v>3.0000000000000001E-3</c:v>
                </c:pt>
                <c:pt idx="222">
                  <c:v>3.0000000000000001E-3</c:v>
                </c:pt>
                <c:pt idx="223">
                  <c:v>3.0000000000000001E-3</c:v>
                </c:pt>
                <c:pt idx="224">
                  <c:v>3.0000000000000001E-3</c:v>
                </c:pt>
                <c:pt idx="225">
                  <c:v>3.0000000000000001E-3</c:v>
                </c:pt>
                <c:pt idx="226">
                  <c:v>3.0000000000000001E-3</c:v>
                </c:pt>
                <c:pt idx="227">
                  <c:v>3.0000000000000001E-3</c:v>
                </c:pt>
                <c:pt idx="228">
                  <c:v>3.0000000000000001E-3</c:v>
                </c:pt>
                <c:pt idx="229">
                  <c:v>3.0000000000000001E-3</c:v>
                </c:pt>
                <c:pt idx="230">
                  <c:v>3.0000000000000001E-3</c:v>
                </c:pt>
                <c:pt idx="231">
                  <c:v>3.0000000000000001E-3</c:v>
                </c:pt>
                <c:pt idx="232">
                  <c:v>3.0000000000000001E-3</c:v>
                </c:pt>
                <c:pt idx="233">
                  <c:v>3.0000000000000001E-3</c:v>
                </c:pt>
                <c:pt idx="234">
                  <c:v>3.0000000000000001E-3</c:v>
                </c:pt>
                <c:pt idx="235">
                  <c:v>4.0000000000000001E-3</c:v>
                </c:pt>
                <c:pt idx="236">
                  <c:v>4.0000000000000001E-3</c:v>
                </c:pt>
                <c:pt idx="237">
                  <c:v>4.0000000000000001E-3</c:v>
                </c:pt>
                <c:pt idx="238">
                  <c:v>4.0000000000000001E-3</c:v>
                </c:pt>
                <c:pt idx="239">
                  <c:v>4.0000000000000001E-3</c:v>
                </c:pt>
                <c:pt idx="240">
                  <c:v>4.0000000000000001E-3</c:v>
                </c:pt>
                <c:pt idx="241">
                  <c:v>4.0000000000000001E-3</c:v>
                </c:pt>
                <c:pt idx="242">
                  <c:v>3.0000000000000001E-3</c:v>
                </c:pt>
                <c:pt idx="243">
                  <c:v>3.0000000000000001E-3</c:v>
                </c:pt>
                <c:pt idx="244">
                  <c:v>3.0000000000000001E-3</c:v>
                </c:pt>
                <c:pt idx="245">
                  <c:v>3.0000000000000001E-3</c:v>
                </c:pt>
                <c:pt idx="246">
                  <c:v>3.0000000000000001E-3</c:v>
                </c:pt>
                <c:pt idx="247">
                  <c:v>3.0000000000000001E-3</c:v>
                </c:pt>
                <c:pt idx="248">
                  <c:v>3.0000000000000001E-3</c:v>
                </c:pt>
                <c:pt idx="249">
                  <c:v>3.0000000000000001E-3</c:v>
                </c:pt>
                <c:pt idx="250">
                  <c:v>3.0000000000000001E-3</c:v>
                </c:pt>
                <c:pt idx="251">
                  <c:v>3.0000000000000001E-3</c:v>
                </c:pt>
                <c:pt idx="252">
                  <c:v>3.0000000000000001E-3</c:v>
                </c:pt>
                <c:pt idx="253">
                  <c:v>2E-3</c:v>
                </c:pt>
                <c:pt idx="254">
                  <c:v>2E-3</c:v>
                </c:pt>
                <c:pt idx="255">
                  <c:v>2E-3</c:v>
                </c:pt>
                <c:pt idx="256">
                  <c:v>2E-3</c:v>
                </c:pt>
                <c:pt idx="257">
                  <c:v>2E-3</c:v>
                </c:pt>
                <c:pt idx="258">
                  <c:v>2E-3</c:v>
                </c:pt>
                <c:pt idx="259">
                  <c:v>2E-3</c:v>
                </c:pt>
                <c:pt idx="260">
                  <c:v>2E-3</c:v>
                </c:pt>
                <c:pt idx="261">
                  <c:v>2E-3</c:v>
                </c:pt>
                <c:pt idx="262">
                  <c:v>2E-3</c:v>
                </c:pt>
                <c:pt idx="263">
                  <c:v>2E-3</c:v>
                </c:pt>
                <c:pt idx="264">
                  <c:v>2E-3</c:v>
                </c:pt>
                <c:pt idx="265">
                  <c:v>2E-3</c:v>
                </c:pt>
                <c:pt idx="266">
                  <c:v>2E-3</c:v>
                </c:pt>
                <c:pt idx="267">
                  <c:v>2E-3</c:v>
                </c:pt>
                <c:pt idx="268">
                  <c:v>2E-3</c:v>
                </c:pt>
                <c:pt idx="269">
                  <c:v>3.0000000000000001E-3</c:v>
                </c:pt>
                <c:pt idx="270">
                  <c:v>3.0000000000000001E-3</c:v>
                </c:pt>
                <c:pt idx="271">
                  <c:v>3.0000000000000001E-3</c:v>
                </c:pt>
                <c:pt idx="272">
                  <c:v>3.0000000000000001E-3</c:v>
                </c:pt>
                <c:pt idx="273">
                  <c:v>3.0000000000000001E-3</c:v>
                </c:pt>
                <c:pt idx="274">
                  <c:v>3.0000000000000001E-3</c:v>
                </c:pt>
                <c:pt idx="275">
                  <c:v>3.0000000000000001E-3</c:v>
                </c:pt>
                <c:pt idx="276">
                  <c:v>3.0000000000000001E-3</c:v>
                </c:pt>
                <c:pt idx="277">
                  <c:v>3.0000000000000001E-3</c:v>
                </c:pt>
                <c:pt idx="278">
                  <c:v>3.0000000000000001E-3</c:v>
                </c:pt>
                <c:pt idx="279">
                  <c:v>3.0000000000000001E-3</c:v>
                </c:pt>
                <c:pt idx="280">
                  <c:v>3.0000000000000001E-3</c:v>
                </c:pt>
                <c:pt idx="281">
                  <c:v>4.0000000000000001E-3</c:v>
                </c:pt>
                <c:pt idx="282">
                  <c:v>4.0000000000000001E-3</c:v>
                </c:pt>
                <c:pt idx="283">
                  <c:v>4.0000000000000001E-3</c:v>
                </c:pt>
                <c:pt idx="284">
                  <c:v>4.0000000000000001E-3</c:v>
                </c:pt>
                <c:pt idx="285">
                  <c:v>4.0000000000000001E-3</c:v>
                </c:pt>
                <c:pt idx="286">
                  <c:v>4.0000000000000001E-3</c:v>
                </c:pt>
                <c:pt idx="287">
                  <c:v>4.0000000000000001E-3</c:v>
                </c:pt>
                <c:pt idx="288">
                  <c:v>5.0000000000000001E-3</c:v>
                </c:pt>
                <c:pt idx="289">
                  <c:v>5.0000000000000001E-3</c:v>
                </c:pt>
                <c:pt idx="290">
                  <c:v>5.0000000000000001E-3</c:v>
                </c:pt>
                <c:pt idx="291">
                  <c:v>5.0000000000000001E-3</c:v>
                </c:pt>
                <c:pt idx="292">
                  <c:v>5.0000000000000001E-3</c:v>
                </c:pt>
                <c:pt idx="293">
                  <c:v>5.0000000000000001E-3</c:v>
                </c:pt>
                <c:pt idx="294">
                  <c:v>5.0000000000000001E-3</c:v>
                </c:pt>
                <c:pt idx="295">
                  <c:v>5.0000000000000001E-3</c:v>
                </c:pt>
                <c:pt idx="296">
                  <c:v>5.0000000000000001E-3</c:v>
                </c:pt>
                <c:pt idx="297">
                  <c:v>5.0000000000000001E-3</c:v>
                </c:pt>
                <c:pt idx="298">
                  <c:v>5.0000000000000001E-3</c:v>
                </c:pt>
                <c:pt idx="299">
                  <c:v>6.0000000000000001E-3</c:v>
                </c:pt>
                <c:pt idx="300">
                  <c:v>6.0000000000000001E-3</c:v>
                </c:pt>
                <c:pt idx="301">
                  <c:v>6.0000000000000001E-3</c:v>
                </c:pt>
                <c:pt idx="302">
                  <c:v>6.0000000000000001E-3</c:v>
                </c:pt>
                <c:pt idx="303">
                  <c:v>6.0000000000000001E-3</c:v>
                </c:pt>
                <c:pt idx="304">
                  <c:v>6.0000000000000001E-3</c:v>
                </c:pt>
                <c:pt idx="305">
                  <c:v>6.0000000000000001E-3</c:v>
                </c:pt>
                <c:pt idx="306">
                  <c:v>6.0000000000000001E-3</c:v>
                </c:pt>
                <c:pt idx="307">
                  <c:v>6.0000000000000001E-3</c:v>
                </c:pt>
                <c:pt idx="308">
                  <c:v>6.0000000000000001E-3</c:v>
                </c:pt>
                <c:pt idx="309">
                  <c:v>6.0000000000000001E-3</c:v>
                </c:pt>
                <c:pt idx="310">
                  <c:v>7.0000000000000001E-3</c:v>
                </c:pt>
                <c:pt idx="311">
                  <c:v>7.0000000000000001E-3</c:v>
                </c:pt>
                <c:pt idx="312">
                  <c:v>7.0000000000000001E-3</c:v>
                </c:pt>
                <c:pt idx="313">
                  <c:v>7.0000000000000001E-3</c:v>
                </c:pt>
                <c:pt idx="314">
                  <c:v>7.0000000000000001E-3</c:v>
                </c:pt>
                <c:pt idx="315">
                  <c:v>7.0000000000000001E-3</c:v>
                </c:pt>
                <c:pt idx="316">
                  <c:v>7.0000000000000001E-3</c:v>
                </c:pt>
                <c:pt idx="317">
                  <c:v>7.0000000000000001E-3</c:v>
                </c:pt>
                <c:pt idx="318">
                  <c:v>7.0000000000000001E-3</c:v>
                </c:pt>
                <c:pt idx="319">
                  <c:v>8.0000000000000002E-3</c:v>
                </c:pt>
                <c:pt idx="320">
                  <c:v>8.0000000000000002E-3</c:v>
                </c:pt>
                <c:pt idx="321">
                  <c:v>8.0000000000000002E-3</c:v>
                </c:pt>
                <c:pt idx="322">
                  <c:v>8.0000000000000002E-3</c:v>
                </c:pt>
                <c:pt idx="323">
                  <c:v>8.0000000000000002E-3</c:v>
                </c:pt>
                <c:pt idx="324">
                  <c:v>8.0000000000000002E-3</c:v>
                </c:pt>
                <c:pt idx="325">
                  <c:v>8.0000000000000002E-3</c:v>
                </c:pt>
                <c:pt idx="326">
                  <c:v>8.0000000000000002E-3</c:v>
                </c:pt>
                <c:pt idx="327">
                  <c:v>8.0000000000000002E-3</c:v>
                </c:pt>
                <c:pt idx="328">
                  <c:v>8.0000000000000002E-3</c:v>
                </c:pt>
                <c:pt idx="329">
                  <c:v>8.9999999999999993E-3</c:v>
                </c:pt>
                <c:pt idx="330">
                  <c:v>8.9999999999999993E-3</c:v>
                </c:pt>
                <c:pt idx="331">
                  <c:v>8.9999999999999993E-3</c:v>
                </c:pt>
                <c:pt idx="332">
                  <c:v>8.9999999999999993E-3</c:v>
                </c:pt>
                <c:pt idx="333">
                  <c:v>8.9999999999999993E-3</c:v>
                </c:pt>
                <c:pt idx="334">
                  <c:v>8.9999999999999993E-3</c:v>
                </c:pt>
                <c:pt idx="335">
                  <c:v>0.01</c:v>
                </c:pt>
                <c:pt idx="336">
                  <c:v>0.01</c:v>
                </c:pt>
                <c:pt idx="337">
                  <c:v>0.01</c:v>
                </c:pt>
                <c:pt idx="338">
                  <c:v>0.01</c:v>
                </c:pt>
                <c:pt idx="339">
                  <c:v>0.01</c:v>
                </c:pt>
                <c:pt idx="340">
                  <c:v>1.0999999999999999E-2</c:v>
                </c:pt>
                <c:pt idx="341">
                  <c:v>1.0999999999999999E-2</c:v>
                </c:pt>
                <c:pt idx="342">
                  <c:v>1.0999999999999999E-2</c:v>
                </c:pt>
                <c:pt idx="343">
                  <c:v>1.2E-2</c:v>
                </c:pt>
                <c:pt idx="344">
                  <c:v>1.2E-2</c:v>
                </c:pt>
                <c:pt idx="345">
                  <c:v>1.2999999999999999E-2</c:v>
                </c:pt>
                <c:pt idx="346">
                  <c:v>1.2999999999999999E-2</c:v>
                </c:pt>
                <c:pt idx="347">
                  <c:v>1.2999999999999999E-2</c:v>
                </c:pt>
                <c:pt idx="348">
                  <c:v>1.4E-2</c:v>
                </c:pt>
                <c:pt idx="349">
                  <c:v>1.4E-2</c:v>
                </c:pt>
                <c:pt idx="350">
                  <c:v>1.4999999999999999E-2</c:v>
                </c:pt>
                <c:pt idx="351">
                  <c:v>1.4999999999999999E-2</c:v>
                </c:pt>
                <c:pt idx="352">
                  <c:v>1.4999999999999999E-2</c:v>
                </c:pt>
                <c:pt idx="353">
                  <c:v>1.4999999999999999E-2</c:v>
                </c:pt>
                <c:pt idx="354">
                  <c:v>1.6E-2</c:v>
                </c:pt>
                <c:pt idx="355">
                  <c:v>1.6E-2</c:v>
                </c:pt>
                <c:pt idx="356">
                  <c:v>1.6E-2</c:v>
                </c:pt>
                <c:pt idx="357">
                  <c:v>1.7000000000000001E-2</c:v>
                </c:pt>
                <c:pt idx="358">
                  <c:v>1.7000000000000001E-2</c:v>
                </c:pt>
                <c:pt idx="359">
                  <c:v>1.7000000000000001E-2</c:v>
                </c:pt>
                <c:pt idx="360">
                  <c:v>1.7000000000000001E-2</c:v>
                </c:pt>
                <c:pt idx="361">
                  <c:v>1.7999999999999999E-2</c:v>
                </c:pt>
                <c:pt idx="362">
                  <c:v>1.7999999999999999E-2</c:v>
                </c:pt>
                <c:pt idx="363">
                  <c:v>1.7999999999999999E-2</c:v>
                </c:pt>
                <c:pt idx="364">
                  <c:v>1.7999999999999999E-2</c:v>
                </c:pt>
                <c:pt idx="365">
                  <c:v>1.9E-2</c:v>
                </c:pt>
                <c:pt idx="366">
                  <c:v>1.9E-2</c:v>
                </c:pt>
                <c:pt idx="367">
                  <c:v>1.9E-2</c:v>
                </c:pt>
                <c:pt idx="368">
                  <c:v>0.02</c:v>
                </c:pt>
                <c:pt idx="369">
                  <c:v>0.02</c:v>
                </c:pt>
                <c:pt idx="370">
                  <c:v>2.1000000000000001E-2</c:v>
                </c:pt>
                <c:pt idx="371">
                  <c:v>2.1000000000000001E-2</c:v>
                </c:pt>
                <c:pt idx="372">
                  <c:v>2.1000000000000001E-2</c:v>
                </c:pt>
                <c:pt idx="373">
                  <c:v>2.1999999999999999E-2</c:v>
                </c:pt>
                <c:pt idx="374">
                  <c:v>2.1999999999999999E-2</c:v>
                </c:pt>
                <c:pt idx="375">
                  <c:v>2.1999999999999999E-2</c:v>
                </c:pt>
                <c:pt idx="376">
                  <c:v>2.3E-2</c:v>
                </c:pt>
                <c:pt idx="377">
                  <c:v>2.3E-2</c:v>
                </c:pt>
                <c:pt idx="378">
                  <c:v>2.4E-2</c:v>
                </c:pt>
                <c:pt idx="379">
                  <c:v>2.4E-2</c:v>
                </c:pt>
                <c:pt idx="380">
                  <c:v>2.4E-2</c:v>
                </c:pt>
                <c:pt idx="381">
                  <c:v>2.5000000000000001E-2</c:v>
                </c:pt>
                <c:pt idx="382">
                  <c:v>2.5000000000000001E-2</c:v>
                </c:pt>
                <c:pt idx="383">
                  <c:v>2.5999999999999999E-2</c:v>
                </c:pt>
                <c:pt idx="384">
                  <c:v>2.5999999999999999E-2</c:v>
                </c:pt>
                <c:pt idx="385">
                  <c:v>2.7E-2</c:v>
                </c:pt>
                <c:pt idx="386">
                  <c:v>2.7E-2</c:v>
                </c:pt>
                <c:pt idx="387">
                  <c:v>2.7E-2</c:v>
                </c:pt>
                <c:pt idx="388">
                  <c:v>2.8000000000000001E-2</c:v>
                </c:pt>
                <c:pt idx="389">
                  <c:v>2.8000000000000001E-2</c:v>
                </c:pt>
                <c:pt idx="390">
                  <c:v>2.8000000000000001E-2</c:v>
                </c:pt>
                <c:pt idx="391">
                  <c:v>2.9000000000000001E-2</c:v>
                </c:pt>
                <c:pt idx="392">
                  <c:v>2.9000000000000001E-2</c:v>
                </c:pt>
                <c:pt idx="393">
                  <c:v>2.9000000000000001E-2</c:v>
                </c:pt>
                <c:pt idx="394">
                  <c:v>2.9000000000000001E-2</c:v>
                </c:pt>
                <c:pt idx="395">
                  <c:v>0.03</c:v>
                </c:pt>
                <c:pt idx="396">
                  <c:v>0.03</c:v>
                </c:pt>
                <c:pt idx="397">
                  <c:v>0.03</c:v>
                </c:pt>
                <c:pt idx="398">
                  <c:v>3.1E-2</c:v>
                </c:pt>
                <c:pt idx="399">
                  <c:v>3.1E-2</c:v>
                </c:pt>
                <c:pt idx="400">
                  <c:v>3.1E-2</c:v>
                </c:pt>
                <c:pt idx="401">
                  <c:v>3.2000000000000001E-2</c:v>
                </c:pt>
                <c:pt idx="402">
                  <c:v>3.3000000000000002E-2</c:v>
                </c:pt>
                <c:pt idx="403">
                  <c:v>3.4000000000000002E-2</c:v>
                </c:pt>
                <c:pt idx="404">
                  <c:v>3.5000000000000003E-2</c:v>
                </c:pt>
                <c:pt idx="405">
                  <c:v>3.5999999999999997E-2</c:v>
                </c:pt>
                <c:pt idx="406">
                  <c:v>3.7999999999999999E-2</c:v>
                </c:pt>
                <c:pt idx="407">
                  <c:v>3.9E-2</c:v>
                </c:pt>
                <c:pt idx="408">
                  <c:v>0.04</c:v>
                </c:pt>
                <c:pt idx="409">
                  <c:v>4.2000000000000003E-2</c:v>
                </c:pt>
                <c:pt idx="410">
                  <c:v>4.3999999999999997E-2</c:v>
                </c:pt>
                <c:pt idx="411">
                  <c:v>4.4999999999999998E-2</c:v>
                </c:pt>
                <c:pt idx="412">
                  <c:v>4.7E-2</c:v>
                </c:pt>
                <c:pt idx="413">
                  <c:v>4.9000000000000002E-2</c:v>
                </c:pt>
                <c:pt idx="414">
                  <c:v>5.0999999999999997E-2</c:v>
                </c:pt>
                <c:pt idx="415">
                  <c:v>5.2999999999999999E-2</c:v>
                </c:pt>
                <c:pt idx="416">
                  <c:v>5.6000000000000001E-2</c:v>
                </c:pt>
                <c:pt idx="417">
                  <c:v>5.8000000000000003E-2</c:v>
                </c:pt>
                <c:pt idx="418">
                  <c:v>0.06</c:v>
                </c:pt>
                <c:pt idx="419">
                  <c:v>6.2E-2</c:v>
                </c:pt>
                <c:pt idx="420">
                  <c:v>6.4000000000000001E-2</c:v>
                </c:pt>
                <c:pt idx="421">
                  <c:v>6.6000000000000003E-2</c:v>
                </c:pt>
                <c:pt idx="422">
                  <c:v>6.8000000000000005E-2</c:v>
                </c:pt>
                <c:pt idx="423">
                  <c:v>7.0000000000000007E-2</c:v>
                </c:pt>
                <c:pt idx="424">
                  <c:v>7.1999999999999995E-2</c:v>
                </c:pt>
                <c:pt idx="425">
                  <c:v>7.2999999999999995E-2</c:v>
                </c:pt>
                <c:pt idx="426">
                  <c:v>7.4999999999999997E-2</c:v>
                </c:pt>
                <c:pt idx="427">
                  <c:v>7.6999999999999999E-2</c:v>
                </c:pt>
                <c:pt idx="428">
                  <c:v>7.9000000000000001E-2</c:v>
                </c:pt>
                <c:pt idx="429">
                  <c:v>8.1000000000000003E-2</c:v>
                </c:pt>
                <c:pt idx="430">
                  <c:v>8.3000000000000004E-2</c:v>
                </c:pt>
                <c:pt idx="431">
                  <c:v>8.4000000000000005E-2</c:v>
                </c:pt>
                <c:pt idx="432">
                  <c:v>8.5999999999999993E-2</c:v>
                </c:pt>
                <c:pt idx="433">
                  <c:v>8.6999999999999994E-2</c:v>
                </c:pt>
                <c:pt idx="434">
                  <c:v>8.8999999999999996E-2</c:v>
                </c:pt>
                <c:pt idx="435">
                  <c:v>0.09</c:v>
                </c:pt>
                <c:pt idx="436">
                  <c:v>9.0999999999999998E-2</c:v>
                </c:pt>
                <c:pt idx="437">
                  <c:v>9.2999999999999999E-2</c:v>
                </c:pt>
                <c:pt idx="438">
                  <c:v>9.5000000000000001E-2</c:v>
                </c:pt>
                <c:pt idx="439">
                  <c:v>9.6000000000000002E-2</c:v>
                </c:pt>
                <c:pt idx="440">
                  <c:v>9.8000000000000004E-2</c:v>
                </c:pt>
                <c:pt idx="441">
                  <c:v>0.1</c:v>
                </c:pt>
                <c:pt idx="442">
                  <c:v>0.10100000000000001</c:v>
                </c:pt>
                <c:pt idx="443">
                  <c:v>0.10299999999999999</c:v>
                </c:pt>
                <c:pt idx="444">
                  <c:v>0.104</c:v>
                </c:pt>
                <c:pt idx="445">
                  <c:v>0.105</c:v>
                </c:pt>
                <c:pt idx="446">
                  <c:v>0.107</c:v>
                </c:pt>
                <c:pt idx="447">
                  <c:v>0.108</c:v>
                </c:pt>
                <c:pt idx="448">
                  <c:v>0.109</c:v>
                </c:pt>
                <c:pt idx="449">
                  <c:v>0.111</c:v>
                </c:pt>
                <c:pt idx="450">
                  <c:v>0.113</c:v>
                </c:pt>
                <c:pt idx="451">
                  <c:v>0.115</c:v>
                </c:pt>
                <c:pt idx="452">
                  <c:v>0.11700000000000001</c:v>
                </c:pt>
                <c:pt idx="453">
                  <c:v>0.11899999999999999</c:v>
                </c:pt>
                <c:pt idx="454">
                  <c:v>0.122</c:v>
                </c:pt>
                <c:pt idx="455">
                  <c:v>0.124</c:v>
                </c:pt>
                <c:pt idx="456">
                  <c:v>0.127</c:v>
                </c:pt>
                <c:pt idx="457">
                  <c:v>0.13</c:v>
                </c:pt>
                <c:pt idx="458">
                  <c:v>0.13300000000000001</c:v>
                </c:pt>
                <c:pt idx="459">
                  <c:v>0.13700000000000001</c:v>
                </c:pt>
                <c:pt idx="460">
                  <c:v>0.14000000000000001</c:v>
                </c:pt>
                <c:pt idx="461">
                  <c:v>0.14399999999999999</c:v>
                </c:pt>
                <c:pt idx="462">
                  <c:v>0.14899999999999999</c:v>
                </c:pt>
                <c:pt idx="463">
                  <c:v>0.154</c:v>
                </c:pt>
                <c:pt idx="464">
                  <c:v>0.159</c:v>
                </c:pt>
                <c:pt idx="465">
                  <c:v>0.16500000000000001</c:v>
                </c:pt>
                <c:pt idx="466">
                  <c:v>0.17100000000000001</c:v>
                </c:pt>
                <c:pt idx="467">
                  <c:v>0.17799999999999999</c:v>
                </c:pt>
                <c:pt idx="468">
                  <c:v>0.185</c:v>
                </c:pt>
                <c:pt idx="469">
                  <c:v>0.193</c:v>
                </c:pt>
                <c:pt idx="470">
                  <c:v>0.20100000000000001</c:v>
                </c:pt>
                <c:pt idx="471">
                  <c:v>0.21099999999999999</c:v>
                </c:pt>
                <c:pt idx="472">
                  <c:v>0.222</c:v>
                </c:pt>
                <c:pt idx="473">
                  <c:v>0.23400000000000001</c:v>
                </c:pt>
                <c:pt idx="474">
                  <c:v>0.248</c:v>
                </c:pt>
                <c:pt idx="475">
                  <c:v>0.26400000000000001</c:v>
                </c:pt>
                <c:pt idx="476">
                  <c:v>0.28100000000000003</c:v>
                </c:pt>
                <c:pt idx="477">
                  <c:v>0.30099999999999999</c:v>
                </c:pt>
                <c:pt idx="478">
                  <c:v>0.32200000000000001</c:v>
                </c:pt>
                <c:pt idx="479">
                  <c:v>0.33800000000000002</c:v>
                </c:pt>
                <c:pt idx="480">
                  <c:v>0.35399999999999998</c:v>
                </c:pt>
              </c:numCache>
            </c:numRef>
          </c:yVal>
          <c:smooth val="1"/>
          <c:extLst xmlns:c15="http://schemas.microsoft.com/office/drawing/2012/chart">
            <c:ext xmlns:c16="http://schemas.microsoft.com/office/drawing/2014/chart" uri="{C3380CC4-5D6E-409C-BE32-E72D297353CC}">
              <c16:uniqueId val="{00000000-484E-4AD9-A9AA-15FEB2A4FBA8}"/>
            </c:ext>
          </c:extLst>
        </c:ser>
        <c:ser>
          <c:idx val="0"/>
          <c:order val="1"/>
          <c:tx>
            <c:strRef>
              <c:f>文章选用!$B$1</c:f>
              <c:strCache>
                <c:ptCount val="1"/>
                <c:pt idx="0">
                  <c:v>Dil-PMO</c:v>
                </c:pt>
              </c:strCache>
            </c:strRef>
          </c:tx>
          <c:spPr>
            <a:ln w="25400" cap="rnd">
              <a:solidFill>
                <a:srgbClr val="00B0F0"/>
              </a:solidFill>
              <a:round/>
            </a:ln>
            <a:effectLst/>
          </c:spPr>
          <c:marker>
            <c:symbol val="none"/>
          </c:marker>
          <c:xVal>
            <c:numRef>
              <c:f>文章选用!$A$2:$A$482</c:f>
              <c:numCache>
                <c:formatCode>General</c:formatCode>
                <c:ptCount val="481"/>
                <c:pt idx="0">
                  <c:v>700</c:v>
                </c:pt>
                <c:pt idx="1">
                  <c:v>699</c:v>
                </c:pt>
                <c:pt idx="2">
                  <c:v>698</c:v>
                </c:pt>
                <c:pt idx="3">
                  <c:v>697</c:v>
                </c:pt>
                <c:pt idx="4">
                  <c:v>696</c:v>
                </c:pt>
                <c:pt idx="5">
                  <c:v>695</c:v>
                </c:pt>
                <c:pt idx="6">
                  <c:v>694</c:v>
                </c:pt>
                <c:pt idx="7">
                  <c:v>693</c:v>
                </c:pt>
                <c:pt idx="8">
                  <c:v>692</c:v>
                </c:pt>
                <c:pt idx="9">
                  <c:v>691</c:v>
                </c:pt>
                <c:pt idx="10">
                  <c:v>690</c:v>
                </c:pt>
                <c:pt idx="11">
                  <c:v>689</c:v>
                </c:pt>
                <c:pt idx="12">
                  <c:v>688</c:v>
                </c:pt>
                <c:pt idx="13">
                  <c:v>687</c:v>
                </c:pt>
                <c:pt idx="14">
                  <c:v>686</c:v>
                </c:pt>
                <c:pt idx="15">
                  <c:v>685</c:v>
                </c:pt>
                <c:pt idx="16">
                  <c:v>684</c:v>
                </c:pt>
                <c:pt idx="17">
                  <c:v>683</c:v>
                </c:pt>
                <c:pt idx="18">
                  <c:v>682</c:v>
                </c:pt>
                <c:pt idx="19">
                  <c:v>681</c:v>
                </c:pt>
                <c:pt idx="20">
                  <c:v>680</c:v>
                </c:pt>
                <c:pt idx="21">
                  <c:v>679</c:v>
                </c:pt>
                <c:pt idx="22">
                  <c:v>678</c:v>
                </c:pt>
                <c:pt idx="23">
                  <c:v>677</c:v>
                </c:pt>
                <c:pt idx="24">
                  <c:v>676</c:v>
                </c:pt>
                <c:pt idx="25">
                  <c:v>675</c:v>
                </c:pt>
                <c:pt idx="26">
                  <c:v>674</c:v>
                </c:pt>
                <c:pt idx="27">
                  <c:v>673</c:v>
                </c:pt>
                <c:pt idx="28">
                  <c:v>672</c:v>
                </c:pt>
                <c:pt idx="29">
                  <c:v>671</c:v>
                </c:pt>
                <c:pt idx="30">
                  <c:v>670</c:v>
                </c:pt>
                <c:pt idx="31">
                  <c:v>669</c:v>
                </c:pt>
                <c:pt idx="32">
                  <c:v>668</c:v>
                </c:pt>
                <c:pt idx="33">
                  <c:v>667</c:v>
                </c:pt>
                <c:pt idx="34">
                  <c:v>666</c:v>
                </c:pt>
                <c:pt idx="35">
                  <c:v>665</c:v>
                </c:pt>
                <c:pt idx="36">
                  <c:v>664</c:v>
                </c:pt>
                <c:pt idx="37">
                  <c:v>663</c:v>
                </c:pt>
                <c:pt idx="38">
                  <c:v>662</c:v>
                </c:pt>
                <c:pt idx="39">
                  <c:v>661</c:v>
                </c:pt>
                <c:pt idx="40">
                  <c:v>660</c:v>
                </c:pt>
                <c:pt idx="41">
                  <c:v>659</c:v>
                </c:pt>
                <c:pt idx="42">
                  <c:v>658</c:v>
                </c:pt>
                <c:pt idx="43">
                  <c:v>657</c:v>
                </c:pt>
                <c:pt idx="44">
                  <c:v>656</c:v>
                </c:pt>
                <c:pt idx="45">
                  <c:v>655</c:v>
                </c:pt>
                <c:pt idx="46">
                  <c:v>654</c:v>
                </c:pt>
                <c:pt idx="47">
                  <c:v>653</c:v>
                </c:pt>
                <c:pt idx="48">
                  <c:v>652</c:v>
                </c:pt>
                <c:pt idx="49">
                  <c:v>651</c:v>
                </c:pt>
                <c:pt idx="50">
                  <c:v>650</c:v>
                </c:pt>
                <c:pt idx="51">
                  <c:v>649</c:v>
                </c:pt>
                <c:pt idx="52">
                  <c:v>648</c:v>
                </c:pt>
                <c:pt idx="53">
                  <c:v>647</c:v>
                </c:pt>
                <c:pt idx="54">
                  <c:v>646</c:v>
                </c:pt>
                <c:pt idx="55">
                  <c:v>645</c:v>
                </c:pt>
                <c:pt idx="56">
                  <c:v>644</c:v>
                </c:pt>
                <c:pt idx="57">
                  <c:v>643</c:v>
                </c:pt>
                <c:pt idx="58">
                  <c:v>642</c:v>
                </c:pt>
                <c:pt idx="59">
                  <c:v>641</c:v>
                </c:pt>
                <c:pt idx="60">
                  <c:v>640</c:v>
                </c:pt>
                <c:pt idx="61">
                  <c:v>639</c:v>
                </c:pt>
                <c:pt idx="62">
                  <c:v>638</c:v>
                </c:pt>
                <c:pt idx="63">
                  <c:v>637</c:v>
                </c:pt>
                <c:pt idx="64">
                  <c:v>636</c:v>
                </c:pt>
                <c:pt idx="65">
                  <c:v>635</c:v>
                </c:pt>
                <c:pt idx="66">
                  <c:v>634</c:v>
                </c:pt>
                <c:pt idx="67">
                  <c:v>633</c:v>
                </c:pt>
                <c:pt idx="68">
                  <c:v>632</c:v>
                </c:pt>
                <c:pt idx="69">
                  <c:v>631</c:v>
                </c:pt>
                <c:pt idx="70">
                  <c:v>630</c:v>
                </c:pt>
                <c:pt idx="71">
                  <c:v>629</c:v>
                </c:pt>
                <c:pt idx="72">
                  <c:v>628</c:v>
                </c:pt>
                <c:pt idx="73">
                  <c:v>627</c:v>
                </c:pt>
                <c:pt idx="74">
                  <c:v>626</c:v>
                </c:pt>
                <c:pt idx="75">
                  <c:v>625</c:v>
                </c:pt>
                <c:pt idx="76">
                  <c:v>624</c:v>
                </c:pt>
                <c:pt idx="77">
                  <c:v>623</c:v>
                </c:pt>
                <c:pt idx="78">
                  <c:v>622</c:v>
                </c:pt>
                <c:pt idx="79">
                  <c:v>621</c:v>
                </c:pt>
                <c:pt idx="80">
                  <c:v>620</c:v>
                </c:pt>
                <c:pt idx="81">
                  <c:v>619</c:v>
                </c:pt>
                <c:pt idx="82">
                  <c:v>618</c:v>
                </c:pt>
                <c:pt idx="83">
                  <c:v>617</c:v>
                </c:pt>
                <c:pt idx="84">
                  <c:v>616</c:v>
                </c:pt>
                <c:pt idx="85">
                  <c:v>615</c:v>
                </c:pt>
                <c:pt idx="86">
                  <c:v>614</c:v>
                </c:pt>
                <c:pt idx="87">
                  <c:v>613</c:v>
                </c:pt>
                <c:pt idx="88">
                  <c:v>612</c:v>
                </c:pt>
                <c:pt idx="89">
                  <c:v>611</c:v>
                </c:pt>
                <c:pt idx="90">
                  <c:v>610</c:v>
                </c:pt>
                <c:pt idx="91">
                  <c:v>609</c:v>
                </c:pt>
                <c:pt idx="92">
                  <c:v>608</c:v>
                </c:pt>
                <c:pt idx="93">
                  <c:v>607</c:v>
                </c:pt>
                <c:pt idx="94">
                  <c:v>606</c:v>
                </c:pt>
                <c:pt idx="95">
                  <c:v>605</c:v>
                </c:pt>
                <c:pt idx="96">
                  <c:v>604</c:v>
                </c:pt>
                <c:pt idx="97">
                  <c:v>603</c:v>
                </c:pt>
                <c:pt idx="98">
                  <c:v>602</c:v>
                </c:pt>
                <c:pt idx="99">
                  <c:v>601</c:v>
                </c:pt>
                <c:pt idx="100">
                  <c:v>600</c:v>
                </c:pt>
                <c:pt idx="101">
                  <c:v>599</c:v>
                </c:pt>
                <c:pt idx="102">
                  <c:v>598</c:v>
                </c:pt>
                <c:pt idx="103">
                  <c:v>597</c:v>
                </c:pt>
                <c:pt idx="104">
                  <c:v>596</c:v>
                </c:pt>
                <c:pt idx="105">
                  <c:v>595</c:v>
                </c:pt>
                <c:pt idx="106">
                  <c:v>594</c:v>
                </c:pt>
                <c:pt idx="107">
                  <c:v>593</c:v>
                </c:pt>
                <c:pt idx="108">
                  <c:v>592</c:v>
                </c:pt>
                <c:pt idx="109">
                  <c:v>591</c:v>
                </c:pt>
                <c:pt idx="110">
                  <c:v>590</c:v>
                </c:pt>
                <c:pt idx="111">
                  <c:v>589</c:v>
                </c:pt>
                <c:pt idx="112">
                  <c:v>588</c:v>
                </c:pt>
                <c:pt idx="113">
                  <c:v>587</c:v>
                </c:pt>
                <c:pt idx="114">
                  <c:v>586</c:v>
                </c:pt>
                <c:pt idx="115">
                  <c:v>585</c:v>
                </c:pt>
                <c:pt idx="116">
                  <c:v>584</c:v>
                </c:pt>
                <c:pt idx="117">
                  <c:v>583</c:v>
                </c:pt>
                <c:pt idx="118">
                  <c:v>582</c:v>
                </c:pt>
                <c:pt idx="119">
                  <c:v>581</c:v>
                </c:pt>
                <c:pt idx="120">
                  <c:v>580</c:v>
                </c:pt>
                <c:pt idx="121">
                  <c:v>579</c:v>
                </c:pt>
                <c:pt idx="122">
                  <c:v>578</c:v>
                </c:pt>
                <c:pt idx="123">
                  <c:v>577</c:v>
                </c:pt>
                <c:pt idx="124">
                  <c:v>576</c:v>
                </c:pt>
                <c:pt idx="125">
                  <c:v>575</c:v>
                </c:pt>
                <c:pt idx="126">
                  <c:v>574</c:v>
                </c:pt>
                <c:pt idx="127">
                  <c:v>573</c:v>
                </c:pt>
                <c:pt idx="128">
                  <c:v>572</c:v>
                </c:pt>
                <c:pt idx="129">
                  <c:v>571</c:v>
                </c:pt>
                <c:pt idx="130">
                  <c:v>570</c:v>
                </c:pt>
                <c:pt idx="131">
                  <c:v>569</c:v>
                </c:pt>
                <c:pt idx="132">
                  <c:v>568</c:v>
                </c:pt>
                <c:pt idx="133">
                  <c:v>567</c:v>
                </c:pt>
                <c:pt idx="134">
                  <c:v>566</c:v>
                </c:pt>
                <c:pt idx="135">
                  <c:v>565</c:v>
                </c:pt>
                <c:pt idx="136">
                  <c:v>564</c:v>
                </c:pt>
                <c:pt idx="137">
                  <c:v>563</c:v>
                </c:pt>
                <c:pt idx="138">
                  <c:v>562</c:v>
                </c:pt>
                <c:pt idx="139">
                  <c:v>561</c:v>
                </c:pt>
                <c:pt idx="140">
                  <c:v>560</c:v>
                </c:pt>
                <c:pt idx="141">
                  <c:v>559</c:v>
                </c:pt>
                <c:pt idx="142">
                  <c:v>558</c:v>
                </c:pt>
                <c:pt idx="143">
                  <c:v>557</c:v>
                </c:pt>
                <c:pt idx="144">
                  <c:v>556</c:v>
                </c:pt>
                <c:pt idx="145">
                  <c:v>555</c:v>
                </c:pt>
                <c:pt idx="146">
                  <c:v>554</c:v>
                </c:pt>
                <c:pt idx="147">
                  <c:v>553</c:v>
                </c:pt>
                <c:pt idx="148">
                  <c:v>552</c:v>
                </c:pt>
                <c:pt idx="149">
                  <c:v>551</c:v>
                </c:pt>
                <c:pt idx="150">
                  <c:v>550</c:v>
                </c:pt>
                <c:pt idx="151">
                  <c:v>549</c:v>
                </c:pt>
                <c:pt idx="152">
                  <c:v>548</c:v>
                </c:pt>
                <c:pt idx="153">
                  <c:v>547</c:v>
                </c:pt>
                <c:pt idx="154">
                  <c:v>546</c:v>
                </c:pt>
                <c:pt idx="155">
                  <c:v>545</c:v>
                </c:pt>
                <c:pt idx="156">
                  <c:v>544</c:v>
                </c:pt>
                <c:pt idx="157">
                  <c:v>543</c:v>
                </c:pt>
                <c:pt idx="158">
                  <c:v>542</c:v>
                </c:pt>
                <c:pt idx="159">
                  <c:v>541</c:v>
                </c:pt>
                <c:pt idx="160">
                  <c:v>540</c:v>
                </c:pt>
                <c:pt idx="161">
                  <c:v>539</c:v>
                </c:pt>
                <c:pt idx="162">
                  <c:v>538</c:v>
                </c:pt>
                <c:pt idx="163">
                  <c:v>537</c:v>
                </c:pt>
                <c:pt idx="164">
                  <c:v>536</c:v>
                </c:pt>
                <c:pt idx="165">
                  <c:v>535</c:v>
                </c:pt>
                <c:pt idx="166">
                  <c:v>534</c:v>
                </c:pt>
                <c:pt idx="167">
                  <c:v>533</c:v>
                </c:pt>
                <c:pt idx="168">
                  <c:v>532</c:v>
                </c:pt>
                <c:pt idx="169">
                  <c:v>531</c:v>
                </c:pt>
                <c:pt idx="170">
                  <c:v>530</c:v>
                </c:pt>
                <c:pt idx="171">
                  <c:v>529</c:v>
                </c:pt>
                <c:pt idx="172">
                  <c:v>528</c:v>
                </c:pt>
                <c:pt idx="173">
                  <c:v>527</c:v>
                </c:pt>
                <c:pt idx="174">
                  <c:v>526</c:v>
                </c:pt>
                <c:pt idx="175">
                  <c:v>525</c:v>
                </c:pt>
                <c:pt idx="176">
                  <c:v>524</c:v>
                </c:pt>
                <c:pt idx="177">
                  <c:v>523</c:v>
                </c:pt>
                <c:pt idx="178">
                  <c:v>522</c:v>
                </c:pt>
                <c:pt idx="179">
                  <c:v>521</c:v>
                </c:pt>
                <c:pt idx="180">
                  <c:v>520</c:v>
                </c:pt>
                <c:pt idx="181">
                  <c:v>519</c:v>
                </c:pt>
                <c:pt idx="182">
                  <c:v>518</c:v>
                </c:pt>
                <c:pt idx="183">
                  <c:v>517</c:v>
                </c:pt>
                <c:pt idx="184">
                  <c:v>516</c:v>
                </c:pt>
                <c:pt idx="185">
                  <c:v>515</c:v>
                </c:pt>
                <c:pt idx="186">
                  <c:v>514</c:v>
                </c:pt>
                <c:pt idx="187">
                  <c:v>513</c:v>
                </c:pt>
                <c:pt idx="188">
                  <c:v>512</c:v>
                </c:pt>
                <c:pt idx="189">
                  <c:v>511</c:v>
                </c:pt>
                <c:pt idx="190">
                  <c:v>510</c:v>
                </c:pt>
                <c:pt idx="191">
                  <c:v>509</c:v>
                </c:pt>
                <c:pt idx="192">
                  <c:v>508</c:v>
                </c:pt>
                <c:pt idx="193">
                  <c:v>507</c:v>
                </c:pt>
                <c:pt idx="194">
                  <c:v>506</c:v>
                </c:pt>
                <c:pt idx="195">
                  <c:v>505</c:v>
                </c:pt>
                <c:pt idx="196">
                  <c:v>504</c:v>
                </c:pt>
                <c:pt idx="197">
                  <c:v>503</c:v>
                </c:pt>
                <c:pt idx="198">
                  <c:v>502</c:v>
                </c:pt>
                <c:pt idx="199">
                  <c:v>501</c:v>
                </c:pt>
                <c:pt idx="200">
                  <c:v>500</c:v>
                </c:pt>
                <c:pt idx="201">
                  <c:v>499</c:v>
                </c:pt>
                <c:pt idx="202">
                  <c:v>498</c:v>
                </c:pt>
                <c:pt idx="203">
                  <c:v>497</c:v>
                </c:pt>
                <c:pt idx="204">
                  <c:v>496</c:v>
                </c:pt>
                <c:pt idx="205">
                  <c:v>495</c:v>
                </c:pt>
                <c:pt idx="206">
                  <c:v>494</c:v>
                </c:pt>
                <c:pt idx="207">
                  <c:v>493</c:v>
                </c:pt>
                <c:pt idx="208">
                  <c:v>492</c:v>
                </c:pt>
                <c:pt idx="209">
                  <c:v>491</c:v>
                </c:pt>
                <c:pt idx="210">
                  <c:v>490</c:v>
                </c:pt>
                <c:pt idx="211">
                  <c:v>489</c:v>
                </c:pt>
                <c:pt idx="212">
                  <c:v>488</c:v>
                </c:pt>
                <c:pt idx="213">
                  <c:v>487</c:v>
                </c:pt>
                <c:pt idx="214">
                  <c:v>486</c:v>
                </c:pt>
                <c:pt idx="215">
                  <c:v>485</c:v>
                </c:pt>
                <c:pt idx="216">
                  <c:v>484</c:v>
                </c:pt>
                <c:pt idx="217">
                  <c:v>483</c:v>
                </c:pt>
                <c:pt idx="218">
                  <c:v>482</c:v>
                </c:pt>
                <c:pt idx="219">
                  <c:v>481</c:v>
                </c:pt>
                <c:pt idx="220">
                  <c:v>480</c:v>
                </c:pt>
                <c:pt idx="221">
                  <c:v>479</c:v>
                </c:pt>
                <c:pt idx="222">
                  <c:v>478</c:v>
                </c:pt>
                <c:pt idx="223">
                  <c:v>477</c:v>
                </c:pt>
                <c:pt idx="224">
                  <c:v>476</c:v>
                </c:pt>
                <c:pt idx="225">
                  <c:v>475</c:v>
                </c:pt>
                <c:pt idx="226">
                  <c:v>474</c:v>
                </c:pt>
                <c:pt idx="227">
                  <c:v>473</c:v>
                </c:pt>
                <c:pt idx="228">
                  <c:v>472</c:v>
                </c:pt>
                <c:pt idx="229">
                  <c:v>471</c:v>
                </c:pt>
                <c:pt idx="230">
                  <c:v>470</c:v>
                </c:pt>
                <c:pt idx="231">
                  <c:v>469</c:v>
                </c:pt>
                <c:pt idx="232">
                  <c:v>468</c:v>
                </c:pt>
                <c:pt idx="233">
                  <c:v>467</c:v>
                </c:pt>
                <c:pt idx="234">
                  <c:v>466</c:v>
                </c:pt>
                <c:pt idx="235">
                  <c:v>465</c:v>
                </c:pt>
                <c:pt idx="236">
                  <c:v>464</c:v>
                </c:pt>
                <c:pt idx="237">
                  <c:v>463</c:v>
                </c:pt>
                <c:pt idx="238">
                  <c:v>462</c:v>
                </c:pt>
                <c:pt idx="239">
                  <c:v>461</c:v>
                </c:pt>
                <c:pt idx="240">
                  <c:v>460</c:v>
                </c:pt>
                <c:pt idx="241">
                  <c:v>459</c:v>
                </c:pt>
                <c:pt idx="242">
                  <c:v>458</c:v>
                </c:pt>
                <c:pt idx="243">
                  <c:v>457</c:v>
                </c:pt>
                <c:pt idx="244">
                  <c:v>456</c:v>
                </c:pt>
                <c:pt idx="245">
                  <c:v>455</c:v>
                </c:pt>
                <c:pt idx="246">
                  <c:v>454</c:v>
                </c:pt>
                <c:pt idx="247">
                  <c:v>453</c:v>
                </c:pt>
                <c:pt idx="248">
                  <c:v>452</c:v>
                </c:pt>
                <c:pt idx="249">
                  <c:v>451</c:v>
                </c:pt>
                <c:pt idx="250">
                  <c:v>450</c:v>
                </c:pt>
                <c:pt idx="251">
                  <c:v>449</c:v>
                </c:pt>
                <c:pt idx="252">
                  <c:v>448</c:v>
                </c:pt>
                <c:pt idx="253">
                  <c:v>447</c:v>
                </c:pt>
                <c:pt idx="254">
                  <c:v>446</c:v>
                </c:pt>
                <c:pt idx="255">
                  <c:v>445</c:v>
                </c:pt>
                <c:pt idx="256">
                  <c:v>444</c:v>
                </c:pt>
                <c:pt idx="257">
                  <c:v>443</c:v>
                </c:pt>
                <c:pt idx="258">
                  <c:v>442</c:v>
                </c:pt>
                <c:pt idx="259">
                  <c:v>441</c:v>
                </c:pt>
                <c:pt idx="260">
                  <c:v>440</c:v>
                </c:pt>
                <c:pt idx="261">
                  <c:v>439</c:v>
                </c:pt>
                <c:pt idx="262">
                  <c:v>438</c:v>
                </c:pt>
                <c:pt idx="263">
                  <c:v>437</c:v>
                </c:pt>
                <c:pt idx="264">
                  <c:v>436</c:v>
                </c:pt>
                <c:pt idx="265">
                  <c:v>435</c:v>
                </c:pt>
                <c:pt idx="266">
                  <c:v>434</c:v>
                </c:pt>
                <c:pt idx="267">
                  <c:v>433</c:v>
                </c:pt>
                <c:pt idx="268">
                  <c:v>432</c:v>
                </c:pt>
                <c:pt idx="269">
                  <c:v>431</c:v>
                </c:pt>
                <c:pt idx="270">
                  <c:v>430</c:v>
                </c:pt>
                <c:pt idx="271">
                  <c:v>429</c:v>
                </c:pt>
                <c:pt idx="272">
                  <c:v>428</c:v>
                </c:pt>
                <c:pt idx="273">
                  <c:v>427</c:v>
                </c:pt>
                <c:pt idx="274">
                  <c:v>426</c:v>
                </c:pt>
                <c:pt idx="275">
                  <c:v>425</c:v>
                </c:pt>
                <c:pt idx="276">
                  <c:v>424</c:v>
                </c:pt>
                <c:pt idx="277">
                  <c:v>423</c:v>
                </c:pt>
                <c:pt idx="278">
                  <c:v>422</c:v>
                </c:pt>
                <c:pt idx="279">
                  <c:v>421</c:v>
                </c:pt>
                <c:pt idx="280">
                  <c:v>420</c:v>
                </c:pt>
                <c:pt idx="281">
                  <c:v>419</c:v>
                </c:pt>
                <c:pt idx="282">
                  <c:v>418</c:v>
                </c:pt>
                <c:pt idx="283">
                  <c:v>417</c:v>
                </c:pt>
                <c:pt idx="284">
                  <c:v>416</c:v>
                </c:pt>
                <c:pt idx="285">
                  <c:v>415</c:v>
                </c:pt>
                <c:pt idx="286">
                  <c:v>414</c:v>
                </c:pt>
                <c:pt idx="287">
                  <c:v>413</c:v>
                </c:pt>
                <c:pt idx="288">
                  <c:v>412</c:v>
                </c:pt>
                <c:pt idx="289">
                  <c:v>411</c:v>
                </c:pt>
                <c:pt idx="290">
                  <c:v>410</c:v>
                </c:pt>
                <c:pt idx="291">
                  <c:v>409</c:v>
                </c:pt>
                <c:pt idx="292">
                  <c:v>408</c:v>
                </c:pt>
                <c:pt idx="293">
                  <c:v>407</c:v>
                </c:pt>
                <c:pt idx="294">
                  <c:v>406</c:v>
                </c:pt>
                <c:pt idx="295">
                  <c:v>405</c:v>
                </c:pt>
                <c:pt idx="296">
                  <c:v>404</c:v>
                </c:pt>
                <c:pt idx="297">
                  <c:v>403</c:v>
                </c:pt>
                <c:pt idx="298">
                  <c:v>402</c:v>
                </c:pt>
                <c:pt idx="299">
                  <c:v>401</c:v>
                </c:pt>
                <c:pt idx="300">
                  <c:v>400</c:v>
                </c:pt>
                <c:pt idx="301">
                  <c:v>399</c:v>
                </c:pt>
                <c:pt idx="302">
                  <c:v>398</c:v>
                </c:pt>
                <c:pt idx="303">
                  <c:v>397</c:v>
                </c:pt>
                <c:pt idx="304">
                  <c:v>396</c:v>
                </c:pt>
                <c:pt idx="305">
                  <c:v>395</c:v>
                </c:pt>
                <c:pt idx="306">
                  <c:v>394</c:v>
                </c:pt>
                <c:pt idx="307">
                  <c:v>393</c:v>
                </c:pt>
                <c:pt idx="308">
                  <c:v>392</c:v>
                </c:pt>
                <c:pt idx="309">
                  <c:v>391</c:v>
                </c:pt>
                <c:pt idx="310">
                  <c:v>390</c:v>
                </c:pt>
                <c:pt idx="311">
                  <c:v>389</c:v>
                </c:pt>
                <c:pt idx="312">
                  <c:v>388</c:v>
                </c:pt>
                <c:pt idx="313">
                  <c:v>387</c:v>
                </c:pt>
                <c:pt idx="314">
                  <c:v>386</c:v>
                </c:pt>
                <c:pt idx="315">
                  <c:v>385</c:v>
                </c:pt>
                <c:pt idx="316">
                  <c:v>384</c:v>
                </c:pt>
                <c:pt idx="317">
                  <c:v>383</c:v>
                </c:pt>
                <c:pt idx="318">
                  <c:v>382</c:v>
                </c:pt>
                <c:pt idx="319">
                  <c:v>381</c:v>
                </c:pt>
                <c:pt idx="320">
                  <c:v>380</c:v>
                </c:pt>
                <c:pt idx="321">
                  <c:v>379</c:v>
                </c:pt>
                <c:pt idx="322">
                  <c:v>378</c:v>
                </c:pt>
                <c:pt idx="323">
                  <c:v>377</c:v>
                </c:pt>
                <c:pt idx="324">
                  <c:v>376</c:v>
                </c:pt>
                <c:pt idx="325">
                  <c:v>375</c:v>
                </c:pt>
                <c:pt idx="326">
                  <c:v>374</c:v>
                </c:pt>
                <c:pt idx="327">
                  <c:v>373</c:v>
                </c:pt>
                <c:pt idx="328">
                  <c:v>372</c:v>
                </c:pt>
                <c:pt idx="329">
                  <c:v>371</c:v>
                </c:pt>
                <c:pt idx="330">
                  <c:v>370</c:v>
                </c:pt>
                <c:pt idx="331">
                  <c:v>369</c:v>
                </c:pt>
                <c:pt idx="332">
                  <c:v>368</c:v>
                </c:pt>
                <c:pt idx="333">
                  <c:v>367</c:v>
                </c:pt>
                <c:pt idx="334">
                  <c:v>366</c:v>
                </c:pt>
                <c:pt idx="335">
                  <c:v>365</c:v>
                </c:pt>
                <c:pt idx="336">
                  <c:v>364</c:v>
                </c:pt>
                <c:pt idx="337">
                  <c:v>363</c:v>
                </c:pt>
                <c:pt idx="338">
                  <c:v>362</c:v>
                </c:pt>
                <c:pt idx="339">
                  <c:v>361</c:v>
                </c:pt>
                <c:pt idx="340">
                  <c:v>360</c:v>
                </c:pt>
                <c:pt idx="341">
                  <c:v>359</c:v>
                </c:pt>
                <c:pt idx="342">
                  <c:v>358</c:v>
                </c:pt>
                <c:pt idx="343">
                  <c:v>357</c:v>
                </c:pt>
                <c:pt idx="344">
                  <c:v>356</c:v>
                </c:pt>
                <c:pt idx="345">
                  <c:v>355</c:v>
                </c:pt>
                <c:pt idx="346">
                  <c:v>354</c:v>
                </c:pt>
                <c:pt idx="347">
                  <c:v>353</c:v>
                </c:pt>
                <c:pt idx="348">
                  <c:v>352</c:v>
                </c:pt>
                <c:pt idx="349">
                  <c:v>351</c:v>
                </c:pt>
                <c:pt idx="350">
                  <c:v>350</c:v>
                </c:pt>
                <c:pt idx="351">
                  <c:v>349</c:v>
                </c:pt>
                <c:pt idx="352">
                  <c:v>348</c:v>
                </c:pt>
                <c:pt idx="353">
                  <c:v>347</c:v>
                </c:pt>
                <c:pt idx="354">
                  <c:v>346</c:v>
                </c:pt>
                <c:pt idx="355">
                  <c:v>345</c:v>
                </c:pt>
                <c:pt idx="356">
                  <c:v>344</c:v>
                </c:pt>
                <c:pt idx="357">
                  <c:v>343</c:v>
                </c:pt>
                <c:pt idx="358">
                  <c:v>342</c:v>
                </c:pt>
                <c:pt idx="359">
                  <c:v>341</c:v>
                </c:pt>
                <c:pt idx="360">
                  <c:v>340</c:v>
                </c:pt>
                <c:pt idx="361">
                  <c:v>339</c:v>
                </c:pt>
                <c:pt idx="362">
                  <c:v>338</c:v>
                </c:pt>
                <c:pt idx="363">
                  <c:v>337</c:v>
                </c:pt>
                <c:pt idx="364">
                  <c:v>336</c:v>
                </c:pt>
                <c:pt idx="365">
                  <c:v>335</c:v>
                </c:pt>
                <c:pt idx="366">
                  <c:v>334</c:v>
                </c:pt>
                <c:pt idx="367">
                  <c:v>333</c:v>
                </c:pt>
                <c:pt idx="368">
                  <c:v>332</c:v>
                </c:pt>
                <c:pt idx="369">
                  <c:v>331</c:v>
                </c:pt>
                <c:pt idx="370">
                  <c:v>330</c:v>
                </c:pt>
                <c:pt idx="371">
                  <c:v>329</c:v>
                </c:pt>
                <c:pt idx="372">
                  <c:v>328</c:v>
                </c:pt>
                <c:pt idx="373">
                  <c:v>327</c:v>
                </c:pt>
                <c:pt idx="374">
                  <c:v>326</c:v>
                </c:pt>
                <c:pt idx="375">
                  <c:v>325</c:v>
                </c:pt>
                <c:pt idx="376">
                  <c:v>324</c:v>
                </c:pt>
                <c:pt idx="377">
                  <c:v>323</c:v>
                </c:pt>
                <c:pt idx="378">
                  <c:v>322</c:v>
                </c:pt>
                <c:pt idx="379">
                  <c:v>321</c:v>
                </c:pt>
                <c:pt idx="380">
                  <c:v>320</c:v>
                </c:pt>
                <c:pt idx="381">
                  <c:v>319</c:v>
                </c:pt>
                <c:pt idx="382">
                  <c:v>318</c:v>
                </c:pt>
                <c:pt idx="383">
                  <c:v>317</c:v>
                </c:pt>
                <c:pt idx="384">
                  <c:v>316</c:v>
                </c:pt>
                <c:pt idx="385">
                  <c:v>315</c:v>
                </c:pt>
                <c:pt idx="386">
                  <c:v>314</c:v>
                </c:pt>
                <c:pt idx="387">
                  <c:v>313</c:v>
                </c:pt>
                <c:pt idx="388">
                  <c:v>312</c:v>
                </c:pt>
                <c:pt idx="389">
                  <c:v>311</c:v>
                </c:pt>
                <c:pt idx="390">
                  <c:v>310</c:v>
                </c:pt>
                <c:pt idx="391">
                  <c:v>309</c:v>
                </c:pt>
                <c:pt idx="392">
                  <c:v>308</c:v>
                </c:pt>
                <c:pt idx="393">
                  <c:v>307</c:v>
                </c:pt>
                <c:pt idx="394">
                  <c:v>306</c:v>
                </c:pt>
                <c:pt idx="395">
                  <c:v>305</c:v>
                </c:pt>
                <c:pt idx="396">
                  <c:v>304</c:v>
                </c:pt>
                <c:pt idx="397">
                  <c:v>303</c:v>
                </c:pt>
                <c:pt idx="398">
                  <c:v>302</c:v>
                </c:pt>
                <c:pt idx="399">
                  <c:v>301</c:v>
                </c:pt>
                <c:pt idx="400">
                  <c:v>300</c:v>
                </c:pt>
                <c:pt idx="401">
                  <c:v>299</c:v>
                </c:pt>
                <c:pt idx="402">
                  <c:v>298</c:v>
                </c:pt>
                <c:pt idx="403">
                  <c:v>297</c:v>
                </c:pt>
                <c:pt idx="404">
                  <c:v>296</c:v>
                </c:pt>
                <c:pt idx="405">
                  <c:v>295</c:v>
                </c:pt>
                <c:pt idx="406">
                  <c:v>294</c:v>
                </c:pt>
                <c:pt idx="407">
                  <c:v>293</c:v>
                </c:pt>
                <c:pt idx="408">
                  <c:v>292</c:v>
                </c:pt>
                <c:pt idx="409">
                  <c:v>291</c:v>
                </c:pt>
                <c:pt idx="410">
                  <c:v>290</c:v>
                </c:pt>
                <c:pt idx="411">
                  <c:v>289</c:v>
                </c:pt>
                <c:pt idx="412">
                  <c:v>288</c:v>
                </c:pt>
                <c:pt idx="413">
                  <c:v>287</c:v>
                </c:pt>
                <c:pt idx="414">
                  <c:v>286</c:v>
                </c:pt>
                <c:pt idx="415">
                  <c:v>285</c:v>
                </c:pt>
                <c:pt idx="416">
                  <c:v>284</c:v>
                </c:pt>
                <c:pt idx="417">
                  <c:v>283</c:v>
                </c:pt>
                <c:pt idx="418">
                  <c:v>282</c:v>
                </c:pt>
                <c:pt idx="419">
                  <c:v>281</c:v>
                </c:pt>
                <c:pt idx="420">
                  <c:v>280</c:v>
                </c:pt>
                <c:pt idx="421">
                  <c:v>279</c:v>
                </c:pt>
                <c:pt idx="422">
                  <c:v>278</c:v>
                </c:pt>
                <c:pt idx="423">
                  <c:v>277</c:v>
                </c:pt>
                <c:pt idx="424">
                  <c:v>276</c:v>
                </c:pt>
                <c:pt idx="425">
                  <c:v>275</c:v>
                </c:pt>
                <c:pt idx="426">
                  <c:v>274</c:v>
                </c:pt>
                <c:pt idx="427">
                  <c:v>273</c:v>
                </c:pt>
                <c:pt idx="428">
                  <c:v>272</c:v>
                </c:pt>
                <c:pt idx="429">
                  <c:v>271</c:v>
                </c:pt>
                <c:pt idx="430">
                  <c:v>270</c:v>
                </c:pt>
                <c:pt idx="431">
                  <c:v>269</c:v>
                </c:pt>
                <c:pt idx="432">
                  <c:v>268</c:v>
                </c:pt>
                <c:pt idx="433">
                  <c:v>267</c:v>
                </c:pt>
                <c:pt idx="434">
                  <c:v>266</c:v>
                </c:pt>
                <c:pt idx="435">
                  <c:v>265</c:v>
                </c:pt>
                <c:pt idx="436">
                  <c:v>264</c:v>
                </c:pt>
                <c:pt idx="437">
                  <c:v>263</c:v>
                </c:pt>
                <c:pt idx="438">
                  <c:v>262</c:v>
                </c:pt>
                <c:pt idx="439">
                  <c:v>261</c:v>
                </c:pt>
                <c:pt idx="440">
                  <c:v>260</c:v>
                </c:pt>
                <c:pt idx="441">
                  <c:v>259</c:v>
                </c:pt>
                <c:pt idx="442">
                  <c:v>258</c:v>
                </c:pt>
                <c:pt idx="443">
                  <c:v>257</c:v>
                </c:pt>
                <c:pt idx="444">
                  <c:v>256</c:v>
                </c:pt>
                <c:pt idx="445">
                  <c:v>255</c:v>
                </c:pt>
                <c:pt idx="446">
                  <c:v>254</c:v>
                </c:pt>
                <c:pt idx="447">
                  <c:v>253</c:v>
                </c:pt>
                <c:pt idx="448">
                  <c:v>252</c:v>
                </c:pt>
                <c:pt idx="449">
                  <c:v>251</c:v>
                </c:pt>
                <c:pt idx="450">
                  <c:v>250</c:v>
                </c:pt>
                <c:pt idx="451">
                  <c:v>249</c:v>
                </c:pt>
                <c:pt idx="452">
                  <c:v>248</c:v>
                </c:pt>
                <c:pt idx="453">
                  <c:v>247</c:v>
                </c:pt>
                <c:pt idx="454">
                  <c:v>246</c:v>
                </c:pt>
                <c:pt idx="455">
                  <c:v>245</c:v>
                </c:pt>
                <c:pt idx="456">
                  <c:v>244</c:v>
                </c:pt>
                <c:pt idx="457">
                  <c:v>243</c:v>
                </c:pt>
                <c:pt idx="458">
                  <c:v>242</c:v>
                </c:pt>
                <c:pt idx="459">
                  <c:v>241</c:v>
                </c:pt>
                <c:pt idx="460">
                  <c:v>240</c:v>
                </c:pt>
                <c:pt idx="461">
                  <c:v>239</c:v>
                </c:pt>
                <c:pt idx="462">
                  <c:v>238</c:v>
                </c:pt>
                <c:pt idx="463">
                  <c:v>237</c:v>
                </c:pt>
                <c:pt idx="464">
                  <c:v>236</c:v>
                </c:pt>
                <c:pt idx="465">
                  <c:v>235</c:v>
                </c:pt>
                <c:pt idx="466">
                  <c:v>234</c:v>
                </c:pt>
                <c:pt idx="467">
                  <c:v>233</c:v>
                </c:pt>
                <c:pt idx="468">
                  <c:v>232</c:v>
                </c:pt>
                <c:pt idx="469">
                  <c:v>231</c:v>
                </c:pt>
                <c:pt idx="470">
                  <c:v>230</c:v>
                </c:pt>
                <c:pt idx="471">
                  <c:v>229</c:v>
                </c:pt>
                <c:pt idx="472">
                  <c:v>228</c:v>
                </c:pt>
                <c:pt idx="473">
                  <c:v>227</c:v>
                </c:pt>
                <c:pt idx="474">
                  <c:v>226</c:v>
                </c:pt>
                <c:pt idx="475">
                  <c:v>225</c:v>
                </c:pt>
                <c:pt idx="476">
                  <c:v>224</c:v>
                </c:pt>
                <c:pt idx="477">
                  <c:v>223</c:v>
                </c:pt>
                <c:pt idx="478">
                  <c:v>222</c:v>
                </c:pt>
                <c:pt idx="479">
                  <c:v>221</c:v>
                </c:pt>
                <c:pt idx="480">
                  <c:v>220</c:v>
                </c:pt>
              </c:numCache>
            </c:numRef>
          </c:xVal>
          <c:yVal>
            <c:numRef>
              <c:f>文章选用!$B$2:$B$482</c:f>
              <c:numCache>
                <c:formatCode>General</c:formatCode>
                <c:ptCount val="481"/>
                <c:pt idx="0">
                  <c:v>3.0000000000000001E-3</c:v>
                </c:pt>
                <c:pt idx="1">
                  <c:v>3.0000000000000001E-3</c:v>
                </c:pt>
                <c:pt idx="2">
                  <c:v>3.0000000000000001E-3</c:v>
                </c:pt>
                <c:pt idx="3">
                  <c:v>4.0000000000000001E-3</c:v>
                </c:pt>
                <c:pt idx="4">
                  <c:v>4.0000000000000001E-3</c:v>
                </c:pt>
                <c:pt idx="5">
                  <c:v>4.0000000000000001E-3</c:v>
                </c:pt>
                <c:pt idx="6">
                  <c:v>4.0000000000000001E-3</c:v>
                </c:pt>
                <c:pt idx="7">
                  <c:v>4.0000000000000001E-3</c:v>
                </c:pt>
                <c:pt idx="8">
                  <c:v>4.0000000000000001E-3</c:v>
                </c:pt>
                <c:pt idx="9">
                  <c:v>4.0000000000000001E-3</c:v>
                </c:pt>
                <c:pt idx="10">
                  <c:v>4.0000000000000001E-3</c:v>
                </c:pt>
                <c:pt idx="11">
                  <c:v>4.0000000000000001E-3</c:v>
                </c:pt>
                <c:pt idx="12">
                  <c:v>4.0000000000000001E-3</c:v>
                </c:pt>
                <c:pt idx="13">
                  <c:v>4.0000000000000001E-3</c:v>
                </c:pt>
                <c:pt idx="14">
                  <c:v>4.0000000000000001E-3</c:v>
                </c:pt>
                <c:pt idx="15">
                  <c:v>4.0000000000000001E-3</c:v>
                </c:pt>
                <c:pt idx="16">
                  <c:v>4.0000000000000001E-3</c:v>
                </c:pt>
                <c:pt idx="17">
                  <c:v>4.0000000000000001E-3</c:v>
                </c:pt>
                <c:pt idx="18">
                  <c:v>4.0000000000000001E-3</c:v>
                </c:pt>
                <c:pt idx="19">
                  <c:v>4.0000000000000001E-3</c:v>
                </c:pt>
                <c:pt idx="20">
                  <c:v>4.0000000000000001E-3</c:v>
                </c:pt>
                <c:pt idx="21">
                  <c:v>4.0000000000000001E-3</c:v>
                </c:pt>
                <c:pt idx="22">
                  <c:v>4.0000000000000001E-3</c:v>
                </c:pt>
                <c:pt idx="23">
                  <c:v>4.0000000000000001E-3</c:v>
                </c:pt>
                <c:pt idx="24">
                  <c:v>5.0000000000000001E-3</c:v>
                </c:pt>
                <c:pt idx="25">
                  <c:v>5.0000000000000001E-3</c:v>
                </c:pt>
                <c:pt idx="26">
                  <c:v>5.0000000000000001E-3</c:v>
                </c:pt>
                <c:pt idx="27">
                  <c:v>5.0000000000000001E-3</c:v>
                </c:pt>
                <c:pt idx="28">
                  <c:v>5.0000000000000001E-3</c:v>
                </c:pt>
                <c:pt idx="29">
                  <c:v>5.0000000000000001E-3</c:v>
                </c:pt>
                <c:pt idx="30">
                  <c:v>5.0000000000000001E-3</c:v>
                </c:pt>
                <c:pt idx="31">
                  <c:v>5.0000000000000001E-3</c:v>
                </c:pt>
                <c:pt idx="32">
                  <c:v>5.0000000000000001E-3</c:v>
                </c:pt>
                <c:pt idx="33">
                  <c:v>5.0000000000000001E-3</c:v>
                </c:pt>
                <c:pt idx="34">
                  <c:v>5.0000000000000001E-3</c:v>
                </c:pt>
                <c:pt idx="35">
                  <c:v>6.0000000000000001E-3</c:v>
                </c:pt>
                <c:pt idx="36">
                  <c:v>6.0000000000000001E-3</c:v>
                </c:pt>
                <c:pt idx="37">
                  <c:v>6.0000000000000001E-3</c:v>
                </c:pt>
                <c:pt idx="38">
                  <c:v>6.0000000000000001E-3</c:v>
                </c:pt>
                <c:pt idx="39">
                  <c:v>6.0000000000000001E-3</c:v>
                </c:pt>
                <c:pt idx="40">
                  <c:v>6.0000000000000001E-3</c:v>
                </c:pt>
                <c:pt idx="41">
                  <c:v>6.0000000000000001E-3</c:v>
                </c:pt>
                <c:pt idx="42">
                  <c:v>6.0000000000000001E-3</c:v>
                </c:pt>
                <c:pt idx="43">
                  <c:v>7.0000000000000001E-3</c:v>
                </c:pt>
                <c:pt idx="44">
                  <c:v>7.0000000000000001E-3</c:v>
                </c:pt>
                <c:pt idx="45">
                  <c:v>7.0000000000000001E-3</c:v>
                </c:pt>
                <c:pt idx="46">
                  <c:v>7.0000000000000001E-3</c:v>
                </c:pt>
                <c:pt idx="47">
                  <c:v>7.0000000000000001E-3</c:v>
                </c:pt>
                <c:pt idx="48">
                  <c:v>7.0000000000000001E-3</c:v>
                </c:pt>
                <c:pt idx="49">
                  <c:v>7.0000000000000001E-3</c:v>
                </c:pt>
                <c:pt idx="50">
                  <c:v>7.0000000000000001E-3</c:v>
                </c:pt>
                <c:pt idx="51">
                  <c:v>7.0000000000000001E-3</c:v>
                </c:pt>
                <c:pt idx="52">
                  <c:v>7.0000000000000001E-3</c:v>
                </c:pt>
                <c:pt idx="53">
                  <c:v>7.0000000000000001E-3</c:v>
                </c:pt>
                <c:pt idx="54">
                  <c:v>7.0000000000000001E-3</c:v>
                </c:pt>
                <c:pt idx="55">
                  <c:v>7.0000000000000001E-3</c:v>
                </c:pt>
                <c:pt idx="56">
                  <c:v>7.0000000000000001E-3</c:v>
                </c:pt>
                <c:pt idx="57">
                  <c:v>7.0000000000000001E-3</c:v>
                </c:pt>
                <c:pt idx="58">
                  <c:v>7.0000000000000001E-3</c:v>
                </c:pt>
                <c:pt idx="59">
                  <c:v>7.0000000000000001E-3</c:v>
                </c:pt>
                <c:pt idx="60">
                  <c:v>7.0000000000000001E-3</c:v>
                </c:pt>
                <c:pt idx="61">
                  <c:v>7.0000000000000001E-3</c:v>
                </c:pt>
                <c:pt idx="62">
                  <c:v>7.0000000000000001E-3</c:v>
                </c:pt>
                <c:pt idx="63">
                  <c:v>7.0000000000000001E-3</c:v>
                </c:pt>
                <c:pt idx="64">
                  <c:v>7.0000000000000001E-3</c:v>
                </c:pt>
                <c:pt idx="65">
                  <c:v>7.0000000000000001E-3</c:v>
                </c:pt>
                <c:pt idx="66">
                  <c:v>7.0000000000000001E-3</c:v>
                </c:pt>
                <c:pt idx="67">
                  <c:v>7.0000000000000001E-3</c:v>
                </c:pt>
                <c:pt idx="68">
                  <c:v>7.0000000000000001E-3</c:v>
                </c:pt>
                <c:pt idx="69">
                  <c:v>7.0000000000000001E-3</c:v>
                </c:pt>
                <c:pt idx="70">
                  <c:v>7.0000000000000001E-3</c:v>
                </c:pt>
                <c:pt idx="71">
                  <c:v>7.0000000000000001E-3</c:v>
                </c:pt>
                <c:pt idx="72">
                  <c:v>7.0000000000000001E-3</c:v>
                </c:pt>
                <c:pt idx="73">
                  <c:v>7.0000000000000001E-3</c:v>
                </c:pt>
                <c:pt idx="74">
                  <c:v>7.0000000000000001E-3</c:v>
                </c:pt>
                <c:pt idx="75">
                  <c:v>7.0000000000000001E-3</c:v>
                </c:pt>
                <c:pt idx="76">
                  <c:v>7.0000000000000001E-3</c:v>
                </c:pt>
                <c:pt idx="77">
                  <c:v>7.0000000000000001E-3</c:v>
                </c:pt>
                <c:pt idx="78">
                  <c:v>7.0000000000000001E-3</c:v>
                </c:pt>
                <c:pt idx="79">
                  <c:v>7.0000000000000001E-3</c:v>
                </c:pt>
                <c:pt idx="80">
                  <c:v>7.0000000000000001E-3</c:v>
                </c:pt>
                <c:pt idx="81">
                  <c:v>7.0000000000000001E-3</c:v>
                </c:pt>
                <c:pt idx="82">
                  <c:v>8.0000000000000002E-3</c:v>
                </c:pt>
                <c:pt idx="83">
                  <c:v>8.0000000000000002E-3</c:v>
                </c:pt>
                <c:pt idx="84">
                  <c:v>8.0000000000000002E-3</c:v>
                </c:pt>
                <c:pt idx="85">
                  <c:v>8.0000000000000002E-3</c:v>
                </c:pt>
                <c:pt idx="86">
                  <c:v>8.0000000000000002E-3</c:v>
                </c:pt>
                <c:pt idx="87">
                  <c:v>8.9999999999999993E-3</c:v>
                </c:pt>
                <c:pt idx="88">
                  <c:v>8.9999999999999993E-3</c:v>
                </c:pt>
                <c:pt idx="89">
                  <c:v>8.9999999999999993E-3</c:v>
                </c:pt>
                <c:pt idx="90">
                  <c:v>0.01</c:v>
                </c:pt>
                <c:pt idx="91">
                  <c:v>0.01</c:v>
                </c:pt>
                <c:pt idx="92">
                  <c:v>1.0999999999999999E-2</c:v>
                </c:pt>
                <c:pt idx="93">
                  <c:v>1.2E-2</c:v>
                </c:pt>
                <c:pt idx="94">
                  <c:v>1.2999999999999999E-2</c:v>
                </c:pt>
                <c:pt idx="95">
                  <c:v>1.4E-2</c:v>
                </c:pt>
                <c:pt idx="96">
                  <c:v>1.4999999999999999E-2</c:v>
                </c:pt>
                <c:pt idx="97">
                  <c:v>1.6E-2</c:v>
                </c:pt>
                <c:pt idx="98">
                  <c:v>1.7999999999999999E-2</c:v>
                </c:pt>
                <c:pt idx="99">
                  <c:v>0.02</c:v>
                </c:pt>
                <c:pt idx="100">
                  <c:v>2.1999999999999999E-2</c:v>
                </c:pt>
                <c:pt idx="101">
                  <c:v>2.5000000000000001E-2</c:v>
                </c:pt>
                <c:pt idx="102">
                  <c:v>2.9000000000000001E-2</c:v>
                </c:pt>
                <c:pt idx="103">
                  <c:v>3.3000000000000002E-2</c:v>
                </c:pt>
                <c:pt idx="104">
                  <c:v>3.7999999999999999E-2</c:v>
                </c:pt>
                <c:pt idx="105">
                  <c:v>4.2999999999999997E-2</c:v>
                </c:pt>
                <c:pt idx="106">
                  <c:v>0.05</c:v>
                </c:pt>
                <c:pt idx="107">
                  <c:v>5.8000000000000003E-2</c:v>
                </c:pt>
                <c:pt idx="108">
                  <c:v>6.8000000000000005E-2</c:v>
                </c:pt>
                <c:pt idx="109">
                  <c:v>7.9000000000000001E-2</c:v>
                </c:pt>
                <c:pt idx="110">
                  <c:v>9.0999999999999998E-2</c:v>
                </c:pt>
                <c:pt idx="111">
                  <c:v>0.105</c:v>
                </c:pt>
                <c:pt idx="112">
                  <c:v>0.122</c:v>
                </c:pt>
                <c:pt idx="113">
                  <c:v>0.14000000000000001</c:v>
                </c:pt>
                <c:pt idx="114">
                  <c:v>0.161</c:v>
                </c:pt>
                <c:pt idx="115">
                  <c:v>0.183</c:v>
                </c:pt>
                <c:pt idx="116">
                  <c:v>0.20699999999999999</c:v>
                </c:pt>
                <c:pt idx="117">
                  <c:v>0.23300000000000001</c:v>
                </c:pt>
                <c:pt idx="118">
                  <c:v>0.26</c:v>
                </c:pt>
                <c:pt idx="119">
                  <c:v>0.28799999999999998</c:v>
                </c:pt>
                <c:pt idx="120">
                  <c:v>0.317</c:v>
                </c:pt>
                <c:pt idx="121">
                  <c:v>0.34599999999999997</c:v>
                </c:pt>
                <c:pt idx="122">
                  <c:v>0.375</c:v>
                </c:pt>
                <c:pt idx="123">
                  <c:v>0.40500000000000003</c:v>
                </c:pt>
                <c:pt idx="124">
                  <c:v>0.434</c:v>
                </c:pt>
                <c:pt idx="125">
                  <c:v>0.46400000000000002</c:v>
                </c:pt>
                <c:pt idx="126">
                  <c:v>0.49299999999999999</c:v>
                </c:pt>
                <c:pt idx="127">
                  <c:v>0.52</c:v>
                </c:pt>
                <c:pt idx="128">
                  <c:v>0.54600000000000004</c:v>
                </c:pt>
                <c:pt idx="129">
                  <c:v>0.57099999999999995</c:v>
                </c:pt>
                <c:pt idx="130">
                  <c:v>0.59399999999999997</c:v>
                </c:pt>
                <c:pt idx="131">
                  <c:v>0.61499999999999999</c:v>
                </c:pt>
                <c:pt idx="132">
                  <c:v>0.63400000000000001</c:v>
                </c:pt>
                <c:pt idx="133">
                  <c:v>0.65200000000000002</c:v>
                </c:pt>
                <c:pt idx="134">
                  <c:v>0.66700000000000004</c:v>
                </c:pt>
                <c:pt idx="135">
                  <c:v>0.68100000000000005</c:v>
                </c:pt>
                <c:pt idx="136">
                  <c:v>0.69299999999999995</c:v>
                </c:pt>
                <c:pt idx="137">
                  <c:v>0.70299999999999996</c:v>
                </c:pt>
                <c:pt idx="138">
                  <c:v>0.71</c:v>
                </c:pt>
                <c:pt idx="139">
                  <c:v>0.71599999999999997</c:v>
                </c:pt>
                <c:pt idx="140">
                  <c:v>0.72</c:v>
                </c:pt>
                <c:pt idx="141">
                  <c:v>0.72099999999999997</c:v>
                </c:pt>
                <c:pt idx="142">
                  <c:v>0.72099999999999997</c:v>
                </c:pt>
                <c:pt idx="143">
                  <c:v>0.71799999999999997</c:v>
                </c:pt>
                <c:pt idx="144">
                  <c:v>0.71399999999999997</c:v>
                </c:pt>
                <c:pt idx="145">
                  <c:v>0.70899999999999996</c:v>
                </c:pt>
                <c:pt idx="146">
                  <c:v>0.70199999999999996</c:v>
                </c:pt>
                <c:pt idx="147">
                  <c:v>0.69299999999999995</c:v>
                </c:pt>
                <c:pt idx="148">
                  <c:v>0.68400000000000005</c:v>
                </c:pt>
                <c:pt idx="149">
                  <c:v>0.67300000000000004</c:v>
                </c:pt>
                <c:pt idx="150">
                  <c:v>0.66100000000000003</c:v>
                </c:pt>
                <c:pt idx="151">
                  <c:v>0.65</c:v>
                </c:pt>
                <c:pt idx="152">
                  <c:v>0.63800000000000001</c:v>
                </c:pt>
                <c:pt idx="153">
                  <c:v>0.627</c:v>
                </c:pt>
                <c:pt idx="154">
                  <c:v>0.61599999999999999</c:v>
                </c:pt>
                <c:pt idx="155">
                  <c:v>0.60699999999999998</c:v>
                </c:pt>
                <c:pt idx="156">
                  <c:v>0.59799999999999998</c:v>
                </c:pt>
                <c:pt idx="157">
                  <c:v>0.59099999999999997</c:v>
                </c:pt>
                <c:pt idx="158">
                  <c:v>0.58499999999999996</c:v>
                </c:pt>
                <c:pt idx="159">
                  <c:v>0.58099999999999996</c:v>
                </c:pt>
                <c:pt idx="160">
                  <c:v>0.57799999999999996</c:v>
                </c:pt>
                <c:pt idx="161">
                  <c:v>0.57699999999999996</c:v>
                </c:pt>
                <c:pt idx="162">
                  <c:v>0.57799999999999996</c:v>
                </c:pt>
                <c:pt idx="163">
                  <c:v>0.58099999999999996</c:v>
                </c:pt>
                <c:pt idx="164">
                  <c:v>0.58499999999999996</c:v>
                </c:pt>
                <c:pt idx="165">
                  <c:v>0.59</c:v>
                </c:pt>
                <c:pt idx="166">
                  <c:v>0.59699999999999998</c:v>
                </c:pt>
                <c:pt idx="167">
                  <c:v>0.60499999999999998</c:v>
                </c:pt>
                <c:pt idx="168">
                  <c:v>0.61299999999999999</c:v>
                </c:pt>
                <c:pt idx="169">
                  <c:v>0.622</c:v>
                </c:pt>
                <c:pt idx="170">
                  <c:v>0.63100000000000001</c:v>
                </c:pt>
                <c:pt idx="171">
                  <c:v>0.64</c:v>
                </c:pt>
                <c:pt idx="172">
                  <c:v>0.64900000000000002</c:v>
                </c:pt>
                <c:pt idx="173">
                  <c:v>0.65700000000000003</c:v>
                </c:pt>
                <c:pt idx="174">
                  <c:v>0.66500000000000004</c:v>
                </c:pt>
                <c:pt idx="175">
                  <c:v>0.67200000000000004</c:v>
                </c:pt>
                <c:pt idx="176">
                  <c:v>0.67700000000000005</c:v>
                </c:pt>
                <c:pt idx="177">
                  <c:v>0.68100000000000005</c:v>
                </c:pt>
                <c:pt idx="178">
                  <c:v>0.68400000000000005</c:v>
                </c:pt>
                <c:pt idx="179">
                  <c:v>0.68500000000000005</c:v>
                </c:pt>
                <c:pt idx="180">
                  <c:v>0.68400000000000005</c:v>
                </c:pt>
                <c:pt idx="181">
                  <c:v>0.68200000000000005</c:v>
                </c:pt>
                <c:pt idx="182">
                  <c:v>0.67900000000000005</c:v>
                </c:pt>
                <c:pt idx="183">
                  <c:v>0.67400000000000004</c:v>
                </c:pt>
                <c:pt idx="184">
                  <c:v>0.66700000000000004</c:v>
                </c:pt>
                <c:pt idx="185">
                  <c:v>0.65900000000000003</c:v>
                </c:pt>
                <c:pt idx="186">
                  <c:v>0.64900000000000002</c:v>
                </c:pt>
                <c:pt idx="187">
                  <c:v>0.63700000000000001</c:v>
                </c:pt>
                <c:pt idx="188">
                  <c:v>0.625</c:v>
                </c:pt>
                <c:pt idx="189">
                  <c:v>0.61199999999999999</c:v>
                </c:pt>
                <c:pt idx="190">
                  <c:v>0.59799999999999998</c:v>
                </c:pt>
                <c:pt idx="191">
                  <c:v>0.58299999999999996</c:v>
                </c:pt>
                <c:pt idx="192">
                  <c:v>0.56799999999999995</c:v>
                </c:pt>
                <c:pt idx="193">
                  <c:v>0.55300000000000005</c:v>
                </c:pt>
                <c:pt idx="194">
                  <c:v>0.53800000000000003</c:v>
                </c:pt>
                <c:pt idx="195">
                  <c:v>0.52200000000000002</c:v>
                </c:pt>
                <c:pt idx="196">
                  <c:v>0.50700000000000001</c:v>
                </c:pt>
                <c:pt idx="197">
                  <c:v>0.49099999999999999</c:v>
                </c:pt>
                <c:pt idx="198">
                  <c:v>0.47599999999999998</c:v>
                </c:pt>
                <c:pt idx="199">
                  <c:v>0.46200000000000002</c:v>
                </c:pt>
                <c:pt idx="200">
                  <c:v>0.44800000000000001</c:v>
                </c:pt>
                <c:pt idx="201">
                  <c:v>0.435</c:v>
                </c:pt>
                <c:pt idx="202">
                  <c:v>0.42299999999999999</c:v>
                </c:pt>
                <c:pt idx="203">
                  <c:v>0.41099999999999998</c:v>
                </c:pt>
                <c:pt idx="204">
                  <c:v>0.4</c:v>
                </c:pt>
                <c:pt idx="205">
                  <c:v>0.38900000000000001</c:v>
                </c:pt>
                <c:pt idx="206">
                  <c:v>0.379</c:v>
                </c:pt>
                <c:pt idx="207">
                  <c:v>0.36899999999999999</c:v>
                </c:pt>
                <c:pt idx="208">
                  <c:v>0.35899999999999999</c:v>
                </c:pt>
                <c:pt idx="209">
                  <c:v>0.34899999999999998</c:v>
                </c:pt>
                <c:pt idx="210">
                  <c:v>0.33800000000000002</c:v>
                </c:pt>
                <c:pt idx="211">
                  <c:v>0.32800000000000001</c:v>
                </c:pt>
                <c:pt idx="212">
                  <c:v>0.318</c:v>
                </c:pt>
                <c:pt idx="213">
                  <c:v>0.308</c:v>
                </c:pt>
                <c:pt idx="214">
                  <c:v>0.29699999999999999</c:v>
                </c:pt>
                <c:pt idx="215">
                  <c:v>0.28699999999999998</c:v>
                </c:pt>
                <c:pt idx="216">
                  <c:v>0.27600000000000002</c:v>
                </c:pt>
                <c:pt idx="217">
                  <c:v>0.26600000000000001</c:v>
                </c:pt>
                <c:pt idx="218">
                  <c:v>0.255</c:v>
                </c:pt>
                <c:pt idx="219">
                  <c:v>0.24399999999999999</c:v>
                </c:pt>
                <c:pt idx="220">
                  <c:v>0.23300000000000001</c:v>
                </c:pt>
                <c:pt idx="221">
                  <c:v>0.222</c:v>
                </c:pt>
                <c:pt idx="222">
                  <c:v>0.21099999999999999</c:v>
                </c:pt>
                <c:pt idx="223">
                  <c:v>0.2</c:v>
                </c:pt>
                <c:pt idx="224">
                  <c:v>0.19</c:v>
                </c:pt>
                <c:pt idx="225">
                  <c:v>0.18</c:v>
                </c:pt>
                <c:pt idx="226">
                  <c:v>0.17</c:v>
                </c:pt>
                <c:pt idx="227">
                  <c:v>0.161</c:v>
                </c:pt>
                <c:pt idx="228">
                  <c:v>0.153</c:v>
                </c:pt>
                <c:pt idx="229">
                  <c:v>0.14399999999999999</c:v>
                </c:pt>
                <c:pt idx="230">
                  <c:v>0.13700000000000001</c:v>
                </c:pt>
                <c:pt idx="231">
                  <c:v>0.129</c:v>
                </c:pt>
                <c:pt idx="232">
                  <c:v>0.123</c:v>
                </c:pt>
                <c:pt idx="233">
                  <c:v>0.11600000000000001</c:v>
                </c:pt>
                <c:pt idx="234">
                  <c:v>0.11</c:v>
                </c:pt>
                <c:pt idx="235">
                  <c:v>0.104</c:v>
                </c:pt>
                <c:pt idx="236">
                  <c:v>9.9000000000000005E-2</c:v>
                </c:pt>
                <c:pt idx="237">
                  <c:v>9.4E-2</c:v>
                </c:pt>
                <c:pt idx="238">
                  <c:v>8.8999999999999996E-2</c:v>
                </c:pt>
                <c:pt idx="239">
                  <c:v>8.5000000000000006E-2</c:v>
                </c:pt>
                <c:pt idx="240">
                  <c:v>8.1000000000000003E-2</c:v>
                </c:pt>
                <c:pt idx="241">
                  <c:v>7.6999999999999999E-2</c:v>
                </c:pt>
                <c:pt idx="242">
                  <c:v>7.2999999999999995E-2</c:v>
                </c:pt>
                <c:pt idx="243">
                  <c:v>6.9000000000000006E-2</c:v>
                </c:pt>
                <c:pt idx="244">
                  <c:v>6.6000000000000003E-2</c:v>
                </c:pt>
                <c:pt idx="245">
                  <c:v>6.3E-2</c:v>
                </c:pt>
                <c:pt idx="246">
                  <c:v>5.8999999999999997E-2</c:v>
                </c:pt>
                <c:pt idx="247">
                  <c:v>5.6000000000000001E-2</c:v>
                </c:pt>
                <c:pt idx="248">
                  <c:v>5.2999999999999999E-2</c:v>
                </c:pt>
                <c:pt idx="249">
                  <c:v>5.0999999999999997E-2</c:v>
                </c:pt>
                <c:pt idx="250">
                  <c:v>4.8000000000000001E-2</c:v>
                </c:pt>
                <c:pt idx="251">
                  <c:v>4.5999999999999999E-2</c:v>
                </c:pt>
                <c:pt idx="252">
                  <c:v>4.2999999999999997E-2</c:v>
                </c:pt>
                <c:pt idx="253">
                  <c:v>4.1000000000000002E-2</c:v>
                </c:pt>
                <c:pt idx="254">
                  <c:v>3.9E-2</c:v>
                </c:pt>
                <c:pt idx="255">
                  <c:v>3.6999999999999998E-2</c:v>
                </c:pt>
                <c:pt idx="256">
                  <c:v>3.5000000000000003E-2</c:v>
                </c:pt>
                <c:pt idx="257">
                  <c:v>3.3000000000000002E-2</c:v>
                </c:pt>
                <c:pt idx="258">
                  <c:v>3.1E-2</c:v>
                </c:pt>
                <c:pt idx="259">
                  <c:v>2.9000000000000001E-2</c:v>
                </c:pt>
                <c:pt idx="260">
                  <c:v>2.8000000000000001E-2</c:v>
                </c:pt>
                <c:pt idx="261">
                  <c:v>2.5999999999999999E-2</c:v>
                </c:pt>
                <c:pt idx="262">
                  <c:v>2.5000000000000001E-2</c:v>
                </c:pt>
                <c:pt idx="263">
                  <c:v>2.4E-2</c:v>
                </c:pt>
                <c:pt idx="264">
                  <c:v>2.3E-2</c:v>
                </c:pt>
                <c:pt idx="265">
                  <c:v>2.1000000000000001E-2</c:v>
                </c:pt>
                <c:pt idx="266">
                  <c:v>0.02</c:v>
                </c:pt>
                <c:pt idx="267">
                  <c:v>0.02</c:v>
                </c:pt>
                <c:pt idx="268">
                  <c:v>1.9E-2</c:v>
                </c:pt>
                <c:pt idx="269">
                  <c:v>1.7999999999999999E-2</c:v>
                </c:pt>
                <c:pt idx="270">
                  <c:v>1.7000000000000001E-2</c:v>
                </c:pt>
                <c:pt idx="271">
                  <c:v>1.6E-2</c:v>
                </c:pt>
                <c:pt idx="272">
                  <c:v>1.6E-2</c:v>
                </c:pt>
                <c:pt idx="273">
                  <c:v>1.4999999999999999E-2</c:v>
                </c:pt>
                <c:pt idx="274">
                  <c:v>1.4999999999999999E-2</c:v>
                </c:pt>
                <c:pt idx="275">
                  <c:v>1.4E-2</c:v>
                </c:pt>
                <c:pt idx="276">
                  <c:v>1.4E-2</c:v>
                </c:pt>
                <c:pt idx="277">
                  <c:v>1.2999999999999999E-2</c:v>
                </c:pt>
                <c:pt idx="278">
                  <c:v>1.2999999999999999E-2</c:v>
                </c:pt>
                <c:pt idx="279">
                  <c:v>1.2E-2</c:v>
                </c:pt>
                <c:pt idx="280">
                  <c:v>1.2E-2</c:v>
                </c:pt>
                <c:pt idx="281">
                  <c:v>1.2E-2</c:v>
                </c:pt>
                <c:pt idx="282">
                  <c:v>1.0999999999999999E-2</c:v>
                </c:pt>
                <c:pt idx="283">
                  <c:v>1.0999999999999999E-2</c:v>
                </c:pt>
                <c:pt idx="284">
                  <c:v>1.0999999999999999E-2</c:v>
                </c:pt>
                <c:pt idx="285">
                  <c:v>1.0999999999999999E-2</c:v>
                </c:pt>
                <c:pt idx="286">
                  <c:v>0.01</c:v>
                </c:pt>
                <c:pt idx="287">
                  <c:v>0.01</c:v>
                </c:pt>
                <c:pt idx="288">
                  <c:v>0.01</c:v>
                </c:pt>
                <c:pt idx="289">
                  <c:v>0.01</c:v>
                </c:pt>
                <c:pt idx="290">
                  <c:v>0.01</c:v>
                </c:pt>
                <c:pt idx="291">
                  <c:v>0.01</c:v>
                </c:pt>
                <c:pt idx="292">
                  <c:v>8.9999999999999993E-3</c:v>
                </c:pt>
                <c:pt idx="293">
                  <c:v>8.9999999999999993E-3</c:v>
                </c:pt>
                <c:pt idx="294">
                  <c:v>8.9999999999999993E-3</c:v>
                </c:pt>
                <c:pt idx="295">
                  <c:v>8.9999999999999993E-3</c:v>
                </c:pt>
                <c:pt idx="296">
                  <c:v>8.9999999999999993E-3</c:v>
                </c:pt>
                <c:pt idx="297">
                  <c:v>8.9999999999999993E-3</c:v>
                </c:pt>
                <c:pt idx="298">
                  <c:v>8.9999999999999993E-3</c:v>
                </c:pt>
                <c:pt idx="299">
                  <c:v>8.9999999999999993E-3</c:v>
                </c:pt>
                <c:pt idx="300">
                  <c:v>8.9999999999999993E-3</c:v>
                </c:pt>
                <c:pt idx="301">
                  <c:v>8.9999999999999993E-3</c:v>
                </c:pt>
                <c:pt idx="302">
                  <c:v>8.9999999999999993E-3</c:v>
                </c:pt>
                <c:pt idx="303">
                  <c:v>8.9999999999999993E-3</c:v>
                </c:pt>
                <c:pt idx="304">
                  <c:v>8.9999999999999993E-3</c:v>
                </c:pt>
                <c:pt idx="305">
                  <c:v>8.9999999999999993E-3</c:v>
                </c:pt>
                <c:pt idx="306">
                  <c:v>8.9999999999999993E-3</c:v>
                </c:pt>
                <c:pt idx="307">
                  <c:v>8.9999999999999993E-3</c:v>
                </c:pt>
                <c:pt idx="308">
                  <c:v>8.9999999999999993E-3</c:v>
                </c:pt>
                <c:pt idx="309">
                  <c:v>8.9999999999999993E-3</c:v>
                </c:pt>
                <c:pt idx="310">
                  <c:v>8.9999999999999993E-3</c:v>
                </c:pt>
                <c:pt idx="311">
                  <c:v>8.9999999999999993E-3</c:v>
                </c:pt>
                <c:pt idx="312">
                  <c:v>8.9999999999999993E-3</c:v>
                </c:pt>
                <c:pt idx="313">
                  <c:v>8.9999999999999993E-3</c:v>
                </c:pt>
                <c:pt idx="314">
                  <c:v>8.9999999999999993E-3</c:v>
                </c:pt>
                <c:pt idx="315">
                  <c:v>0.01</c:v>
                </c:pt>
                <c:pt idx="316">
                  <c:v>0.01</c:v>
                </c:pt>
                <c:pt idx="317">
                  <c:v>0.01</c:v>
                </c:pt>
                <c:pt idx="318">
                  <c:v>0.01</c:v>
                </c:pt>
                <c:pt idx="319">
                  <c:v>0.01</c:v>
                </c:pt>
                <c:pt idx="320">
                  <c:v>0.01</c:v>
                </c:pt>
                <c:pt idx="321">
                  <c:v>0.01</c:v>
                </c:pt>
                <c:pt idx="322">
                  <c:v>0.01</c:v>
                </c:pt>
                <c:pt idx="323">
                  <c:v>0.01</c:v>
                </c:pt>
                <c:pt idx="324">
                  <c:v>1.0999999999999999E-2</c:v>
                </c:pt>
                <c:pt idx="325">
                  <c:v>1.0999999999999999E-2</c:v>
                </c:pt>
                <c:pt idx="326">
                  <c:v>1.0999999999999999E-2</c:v>
                </c:pt>
                <c:pt idx="327">
                  <c:v>1.0999999999999999E-2</c:v>
                </c:pt>
                <c:pt idx="328">
                  <c:v>1.2E-2</c:v>
                </c:pt>
                <c:pt idx="329">
                  <c:v>1.2E-2</c:v>
                </c:pt>
                <c:pt idx="330">
                  <c:v>1.2E-2</c:v>
                </c:pt>
                <c:pt idx="331">
                  <c:v>1.2999999999999999E-2</c:v>
                </c:pt>
                <c:pt idx="332">
                  <c:v>1.2999999999999999E-2</c:v>
                </c:pt>
                <c:pt idx="333">
                  <c:v>1.2999999999999999E-2</c:v>
                </c:pt>
                <c:pt idx="334">
                  <c:v>1.4E-2</c:v>
                </c:pt>
                <c:pt idx="335">
                  <c:v>1.4E-2</c:v>
                </c:pt>
                <c:pt idx="336">
                  <c:v>1.4E-2</c:v>
                </c:pt>
                <c:pt idx="337">
                  <c:v>1.4E-2</c:v>
                </c:pt>
                <c:pt idx="338">
                  <c:v>1.4E-2</c:v>
                </c:pt>
                <c:pt idx="339">
                  <c:v>1.4E-2</c:v>
                </c:pt>
                <c:pt idx="340">
                  <c:v>1.4999999999999999E-2</c:v>
                </c:pt>
                <c:pt idx="341">
                  <c:v>1.4999999999999999E-2</c:v>
                </c:pt>
                <c:pt idx="342">
                  <c:v>1.6E-2</c:v>
                </c:pt>
                <c:pt idx="343">
                  <c:v>1.6E-2</c:v>
                </c:pt>
                <c:pt idx="344">
                  <c:v>1.7000000000000001E-2</c:v>
                </c:pt>
                <c:pt idx="345">
                  <c:v>1.7999999999999999E-2</c:v>
                </c:pt>
                <c:pt idx="346">
                  <c:v>1.7999999999999999E-2</c:v>
                </c:pt>
                <c:pt idx="347">
                  <c:v>1.9E-2</c:v>
                </c:pt>
                <c:pt idx="348">
                  <c:v>0.02</c:v>
                </c:pt>
                <c:pt idx="349">
                  <c:v>2.1000000000000001E-2</c:v>
                </c:pt>
                <c:pt idx="350">
                  <c:v>2.1000000000000001E-2</c:v>
                </c:pt>
                <c:pt idx="351">
                  <c:v>2.1999999999999999E-2</c:v>
                </c:pt>
                <c:pt idx="352">
                  <c:v>2.3E-2</c:v>
                </c:pt>
                <c:pt idx="353">
                  <c:v>2.4E-2</c:v>
                </c:pt>
                <c:pt idx="354">
                  <c:v>2.4E-2</c:v>
                </c:pt>
                <c:pt idx="355">
                  <c:v>2.5000000000000001E-2</c:v>
                </c:pt>
                <c:pt idx="356">
                  <c:v>2.5000000000000001E-2</c:v>
                </c:pt>
                <c:pt idx="357">
                  <c:v>2.5999999999999999E-2</c:v>
                </c:pt>
                <c:pt idx="358">
                  <c:v>2.5999999999999999E-2</c:v>
                </c:pt>
                <c:pt idx="359">
                  <c:v>2.7E-2</c:v>
                </c:pt>
                <c:pt idx="360">
                  <c:v>2.7E-2</c:v>
                </c:pt>
                <c:pt idx="361">
                  <c:v>2.7E-2</c:v>
                </c:pt>
                <c:pt idx="362">
                  <c:v>2.7E-2</c:v>
                </c:pt>
                <c:pt idx="363">
                  <c:v>2.8000000000000001E-2</c:v>
                </c:pt>
                <c:pt idx="364">
                  <c:v>2.8000000000000001E-2</c:v>
                </c:pt>
                <c:pt idx="365">
                  <c:v>2.8000000000000001E-2</c:v>
                </c:pt>
                <c:pt idx="366">
                  <c:v>2.9000000000000001E-2</c:v>
                </c:pt>
                <c:pt idx="367">
                  <c:v>2.9000000000000001E-2</c:v>
                </c:pt>
                <c:pt idx="368">
                  <c:v>0.03</c:v>
                </c:pt>
                <c:pt idx="369">
                  <c:v>0.03</c:v>
                </c:pt>
                <c:pt idx="370">
                  <c:v>3.1E-2</c:v>
                </c:pt>
                <c:pt idx="371">
                  <c:v>3.1E-2</c:v>
                </c:pt>
                <c:pt idx="372">
                  <c:v>3.2000000000000001E-2</c:v>
                </c:pt>
                <c:pt idx="373">
                  <c:v>3.2000000000000001E-2</c:v>
                </c:pt>
                <c:pt idx="374">
                  <c:v>3.2000000000000001E-2</c:v>
                </c:pt>
                <c:pt idx="375">
                  <c:v>3.3000000000000002E-2</c:v>
                </c:pt>
                <c:pt idx="376">
                  <c:v>3.3000000000000002E-2</c:v>
                </c:pt>
                <c:pt idx="377">
                  <c:v>3.4000000000000002E-2</c:v>
                </c:pt>
                <c:pt idx="378">
                  <c:v>3.5000000000000003E-2</c:v>
                </c:pt>
                <c:pt idx="379">
                  <c:v>3.5000000000000003E-2</c:v>
                </c:pt>
                <c:pt idx="380">
                  <c:v>3.5999999999999997E-2</c:v>
                </c:pt>
                <c:pt idx="381">
                  <c:v>3.5999999999999997E-2</c:v>
                </c:pt>
                <c:pt idx="382">
                  <c:v>3.6999999999999998E-2</c:v>
                </c:pt>
                <c:pt idx="383">
                  <c:v>3.6999999999999998E-2</c:v>
                </c:pt>
                <c:pt idx="384">
                  <c:v>3.7999999999999999E-2</c:v>
                </c:pt>
                <c:pt idx="385">
                  <c:v>3.7999999999999999E-2</c:v>
                </c:pt>
                <c:pt idx="386">
                  <c:v>3.9E-2</c:v>
                </c:pt>
                <c:pt idx="387">
                  <c:v>0.04</c:v>
                </c:pt>
                <c:pt idx="388">
                  <c:v>4.1000000000000002E-2</c:v>
                </c:pt>
                <c:pt idx="389">
                  <c:v>4.2000000000000003E-2</c:v>
                </c:pt>
                <c:pt idx="390">
                  <c:v>4.2999999999999997E-2</c:v>
                </c:pt>
                <c:pt idx="391">
                  <c:v>4.3999999999999997E-2</c:v>
                </c:pt>
                <c:pt idx="392">
                  <c:v>4.5999999999999999E-2</c:v>
                </c:pt>
                <c:pt idx="393">
                  <c:v>4.7E-2</c:v>
                </c:pt>
                <c:pt idx="394">
                  <c:v>4.9000000000000002E-2</c:v>
                </c:pt>
                <c:pt idx="395">
                  <c:v>5.0999999999999997E-2</c:v>
                </c:pt>
                <c:pt idx="396">
                  <c:v>5.2999999999999999E-2</c:v>
                </c:pt>
                <c:pt idx="397">
                  <c:v>5.6000000000000001E-2</c:v>
                </c:pt>
                <c:pt idx="398">
                  <c:v>5.8999999999999997E-2</c:v>
                </c:pt>
                <c:pt idx="399">
                  <c:v>6.3E-2</c:v>
                </c:pt>
                <c:pt idx="400">
                  <c:v>6.7000000000000004E-2</c:v>
                </c:pt>
                <c:pt idx="401">
                  <c:v>7.1999999999999995E-2</c:v>
                </c:pt>
                <c:pt idx="402">
                  <c:v>7.6999999999999999E-2</c:v>
                </c:pt>
                <c:pt idx="403">
                  <c:v>8.2000000000000003E-2</c:v>
                </c:pt>
                <c:pt idx="404">
                  <c:v>8.6999999999999994E-2</c:v>
                </c:pt>
                <c:pt idx="405">
                  <c:v>9.1999999999999998E-2</c:v>
                </c:pt>
                <c:pt idx="406">
                  <c:v>9.6000000000000002E-2</c:v>
                </c:pt>
                <c:pt idx="407">
                  <c:v>0.1</c:v>
                </c:pt>
                <c:pt idx="408">
                  <c:v>0.10299999999999999</c:v>
                </c:pt>
                <c:pt idx="409">
                  <c:v>0.106</c:v>
                </c:pt>
                <c:pt idx="410">
                  <c:v>0.11</c:v>
                </c:pt>
                <c:pt idx="411">
                  <c:v>0.113</c:v>
                </c:pt>
                <c:pt idx="412">
                  <c:v>0.11600000000000001</c:v>
                </c:pt>
                <c:pt idx="413">
                  <c:v>0.11899999999999999</c:v>
                </c:pt>
                <c:pt idx="414">
                  <c:v>0.122</c:v>
                </c:pt>
                <c:pt idx="415">
                  <c:v>0.125</c:v>
                </c:pt>
                <c:pt idx="416">
                  <c:v>0.126</c:v>
                </c:pt>
                <c:pt idx="417">
                  <c:v>0.127</c:v>
                </c:pt>
                <c:pt idx="418">
                  <c:v>0.126</c:v>
                </c:pt>
                <c:pt idx="419">
                  <c:v>0.125</c:v>
                </c:pt>
                <c:pt idx="420">
                  <c:v>0.123</c:v>
                </c:pt>
                <c:pt idx="421">
                  <c:v>0.121</c:v>
                </c:pt>
                <c:pt idx="422">
                  <c:v>0.11899999999999999</c:v>
                </c:pt>
                <c:pt idx="423">
                  <c:v>0.11600000000000001</c:v>
                </c:pt>
                <c:pt idx="424">
                  <c:v>0.113</c:v>
                </c:pt>
                <c:pt idx="425">
                  <c:v>0.109</c:v>
                </c:pt>
                <c:pt idx="426">
                  <c:v>0.106</c:v>
                </c:pt>
                <c:pt idx="427">
                  <c:v>0.10299999999999999</c:v>
                </c:pt>
                <c:pt idx="428">
                  <c:v>9.9000000000000005E-2</c:v>
                </c:pt>
                <c:pt idx="429">
                  <c:v>9.6000000000000002E-2</c:v>
                </c:pt>
                <c:pt idx="430">
                  <c:v>9.2999999999999999E-2</c:v>
                </c:pt>
                <c:pt idx="431">
                  <c:v>9.0999999999999998E-2</c:v>
                </c:pt>
                <c:pt idx="432">
                  <c:v>8.8999999999999996E-2</c:v>
                </c:pt>
                <c:pt idx="433">
                  <c:v>8.5999999999999993E-2</c:v>
                </c:pt>
                <c:pt idx="434">
                  <c:v>8.5000000000000006E-2</c:v>
                </c:pt>
                <c:pt idx="435">
                  <c:v>8.3000000000000004E-2</c:v>
                </c:pt>
                <c:pt idx="436">
                  <c:v>8.2000000000000003E-2</c:v>
                </c:pt>
                <c:pt idx="437">
                  <c:v>8.1000000000000003E-2</c:v>
                </c:pt>
                <c:pt idx="438">
                  <c:v>8.1000000000000003E-2</c:v>
                </c:pt>
                <c:pt idx="439">
                  <c:v>0.08</c:v>
                </c:pt>
                <c:pt idx="440">
                  <c:v>0.08</c:v>
                </c:pt>
                <c:pt idx="441">
                  <c:v>0.08</c:v>
                </c:pt>
                <c:pt idx="442">
                  <c:v>0.08</c:v>
                </c:pt>
                <c:pt idx="443">
                  <c:v>0.08</c:v>
                </c:pt>
                <c:pt idx="444">
                  <c:v>0.08</c:v>
                </c:pt>
                <c:pt idx="445">
                  <c:v>0.08</c:v>
                </c:pt>
                <c:pt idx="446">
                  <c:v>0.08</c:v>
                </c:pt>
                <c:pt idx="447">
                  <c:v>0.08</c:v>
                </c:pt>
                <c:pt idx="448">
                  <c:v>0.08</c:v>
                </c:pt>
                <c:pt idx="449">
                  <c:v>0.08</c:v>
                </c:pt>
                <c:pt idx="450">
                  <c:v>0.08</c:v>
                </c:pt>
                <c:pt idx="451">
                  <c:v>8.1000000000000003E-2</c:v>
                </c:pt>
                <c:pt idx="452">
                  <c:v>8.1000000000000003E-2</c:v>
                </c:pt>
                <c:pt idx="453">
                  <c:v>8.1000000000000003E-2</c:v>
                </c:pt>
                <c:pt idx="454">
                  <c:v>8.1000000000000003E-2</c:v>
                </c:pt>
                <c:pt idx="455">
                  <c:v>8.2000000000000003E-2</c:v>
                </c:pt>
                <c:pt idx="456">
                  <c:v>8.3000000000000004E-2</c:v>
                </c:pt>
                <c:pt idx="457">
                  <c:v>8.4000000000000005E-2</c:v>
                </c:pt>
                <c:pt idx="458">
                  <c:v>8.5999999999999993E-2</c:v>
                </c:pt>
                <c:pt idx="459">
                  <c:v>8.7999999999999995E-2</c:v>
                </c:pt>
                <c:pt idx="460">
                  <c:v>0.09</c:v>
                </c:pt>
                <c:pt idx="461">
                  <c:v>9.2999999999999999E-2</c:v>
                </c:pt>
                <c:pt idx="462">
                  <c:v>9.7000000000000003E-2</c:v>
                </c:pt>
                <c:pt idx="463">
                  <c:v>0.10199999999999999</c:v>
                </c:pt>
                <c:pt idx="464">
                  <c:v>0.107</c:v>
                </c:pt>
                <c:pt idx="465">
                  <c:v>0.114</c:v>
                </c:pt>
                <c:pt idx="466">
                  <c:v>0.122</c:v>
                </c:pt>
                <c:pt idx="467">
                  <c:v>0.13200000000000001</c:v>
                </c:pt>
                <c:pt idx="468">
                  <c:v>0.14399999999999999</c:v>
                </c:pt>
                <c:pt idx="469">
                  <c:v>0.159</c:v>
                </c:pt>
                <c:pt idx="470">
                  <c:v>0.17599999999999999</c:v>
                </c:pt>
                <c:pt idx="471">
                  <c:v>0.19800000000000001</c:v>
                </c:pt>
                <c:pt idx="472">
                  <c:v>0.224</c:v>
                </c:pt>
                <c:pt idx="473">
                  <c:v>0.25700000000000001</c:v>
                </c:pt>
                <c:pt idx="474">
                  <c:v>0.29699999999999999</c:v>
                </c:pt>
                <c:pt idx="475">
                  <c:v>0.34499999999999997</c:v>
                </c:pt>
                <c:pt idx="476">
                  <c:v>0.40100000000000002</c:v>
                </c:pt>
                <c:pt idx="477">
                  <c:v>0.46700000000000003</c:v>
                </c:pt>
                <c:pt idx="478">
                  <c:v>0.54400000000000004</c:v>
                </c:pt>
                <c:pt idx="479">
                  <c:v>0.60899999999999999</c:v>
                </c:pt>
                <c:pt idx="480">
                  <c:v>0.67400000000000004</c:v>
                </c:pt>
              </c:numCache>
            </c:numRef>
          </c:yVal>
          <c:smooth val="1"/>
          <c:extLst xmlns:c15="http://schemas.microsoft.com/office/drawing/2012/chart">
            <c:ext xmlns:c16="http://schemas.microsoft.com/office/drawing/2014/chart" uri="{C3380CC4-5D6E-409C-BE32-E72D297353CC}">
              <c16:uniqueId val="{00000001-484E-4AD9-A9AA-15FEB2A4FBA8}"/>
            </c:ext>
          </c:extLst>
        </c:ser>
        <c:ser>
          <c:idx val="4"/>
          <c:order val="4"/>
          <c:tx>
            <c:strRef>
              <c:f>文章选用!$F$1</c:f>
              <c:strCache>
                <c:ptCount val="1"/>
                <c:pt idx="0">
                  <c:v>Baseline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文章选用!$A$2:$A$482</c:f>
              <c:numCache>
                <c:formatCode>General</c:formatCode>
                <c:ptCount val="481"/>
                <c:pt idx="0">
                  <c:v>700</c:v>
                </c:pt>
                <c:pt idx="1">
                  <c:v>699</c:v>
                </c:pt>
                <c:pt idx="2">
                  <c:v>698</c:v>
                </c:pt>
                <c:pt idx="3">
                  <c:v>697</c:v>
                </c:pt>
                <c:pt idx="4">
                  <c:v>696</c:v>
                </c:pt>
                <c:pt idx="5">
                  <c:v>695</c:v>
                </c:pt>
                <c:pt idx="6">
                  <c:v>694</c:v>
                </c:pt>
                <c:pt idx="7">
                  <c:v>693</c:v>
                </c:pt>
                <c:pt idx="8">
                  <c:v>692</c:v>
                </c:pt>
                <c:pt idx="9">
                  <c:v>691</c:v>
                </c:pt>
                <c:pt idx="10">
                  <c:v>690</c:v>
                </c:pt>
                <c:pt idx="11">
                  <c:v>689</c:v>
                </c:pt>
                <c:pt idx="12">
                  <c:v>688</c:v>
                </c:pt>
                <c:pt idx="13">
                  <c:v>687</c:v>
                </c:pt>
                <c:pt idx="14">
                  <c:v>686</c:v>
                </c:pt>
                <c:pt idx="15">
                  <c:v>685</c:v>
                </c:pt>
                <c:pt idx="16">
                  <c:v>684</c:v>
                </c:pt>
                <c:pt idx="17">
                  <c:v>683</c:v>
                </c:pt>
                <c:pt idx="18">
                  <c:v>682</c:v>
                </c:pt>
                <c:pt idx="19">
                  <c:v>681</c:v>
                </c:pt>
                <c:pt idx="20">
                  <c:v>680</c:v>
                </c:pt>
                <c:pt idx="21">
                  <c:v>679</c:v>
                </c:pt>
                <c:pt idx="22">
                  <c:v>678</c:v>
                </c:pt>
                <c:pt idx="23">
                  <c:v>677</c:v>
                </c:pt>
                <c:pt idx="24">
                  <c:v>676</c:v>
                </c:pt>
                <c:pt idx="25">
                  <c:v>675</c:v>
                </c:pt>
                <c:pt idx="26">
                  <c:v>674</c:v>
                </c:pt>
                <c:pt idx="27">
                  <c:v>673</c:v>
                </c:pt>
                <c:pt idx="28">
                  <c:v>672</c:v>
                </c:pt>
                <c:pt idx="29">
                  <c:v>671</c:v>
                </c:pt>
                <c:pt idx="30">
                  <c:v>670</c:v>
                </c:pt>
                <c:pt idx="31">
                  <c:v>669</c:v>
                </c:pt>
                <c:pt idx="32">
                  <c:v>668</c:v>
                </c:pt>
                <c:pt idx="33">
                  <c:v>667</c:v>
                </c:pt>
                <c:pt idx="34">
                  <c:v>666</c:v>
                </c:pt>
                <c:pt idx="35">
                  <c:v>665</c:v>
                </c:pt>
                <c:pt idx="36">
                  <c:v>664</c:v>
                </c:pt>
                <c:pt idx="37">
                  <c:v>663</c:v>
                </c:pt>
                <c:pt idx="38">
                  <c:v>662</c:v>
                </c:pt>
                <c:pt idx="39">
                  <c:v>661</c:v>
                </c:pt>
                <c:pt idx="40">
                  <c:v>660</c:v>
                </c:pt>
                <c:pt idx="41">
                  <c:v>659</c:v>
                </c:pt>
                <c:pt idx="42">
                  <c:v>658</c:v>
                </c:pt>
                <c:pt idx="43">
                  <c:v>657</c:v>
                </c:pt>
                <c:pt idx="44">
                  <c:v>656</c:v>
                </c:pt>
                <c:pt idx="45">
                  <c:v>655</c:v>
                </c:pt>
                <c:pt idx="46">
                  <c:v>654</c:v>
                </c:pt>
                <c:pt idx="47">
                  <c:v>653</c:v>
                </c:pt>
                <c:pt idx="48">
                  <c:v>652</c:v>
                </c:pt>
                <c:pt idx="49">
                  <c:v>651</c:v>
                </c:pt>
                <c:pt idx="50">
                  <c:v>650</c:v>
                </c:pt>
                <c:pt idx="51">
                  <c:v>649</c:v>
                </c:pt>
                <c:pt idx="52">
                  <c:v>648</c:v>
                </c:pt>
                <c:pt idx="53">
                  <c:v>647</c:v>
                </c:pt>
                <c:pt idx="54">
                  <c:v>646</c:v>
                </c:pt>
                <c:pt idx="55">
                  <c:v>645</c:v>
                </c:pt>
                <c:pt idx="56">
                  <c:v>644</c:v>
                </c:pt>
                <c:pt idx="57">
                  <c:v>643</c:v>
                </c:pt>
                <c:pt idx="58">
                  <c:v>642</c:v>
                </c:pt>
                <c:pt idx="59">
                  <c:v>641</c:v>
                </c:pt>
                <c:pt idx="60">
                  <c:v>640</c:v>
                </c:pt>
                <c:pt idx="61">
                  <c:v>639</c:v>
                </c:pt>
                <c:pt idx="62">
                  <c:v>638</c:v>
                </c:pt>
                <c:pt idx="63">
                  <c:v>637</c:v>
                </c:pt>
                <c:pt idx="64">
                  <c:v>636</c:v>
                </c:pt>
                <c:pt idx="65">
                  <c:v>635</c:v>
                </c:pt>
                <c:pt idx="66">
                  <c:v>634</c:v>
                </c:pt>
                <c:pt idx="67">
                  <c:v>633</c:v>
                </c:pt>
                <c:pt idx="68">
                  <c:v>632</c:v>
                </c:pt>
                <c:pt idx="69">
                  <c:v>631</c:v>
                </c:pt>
                <c:pt idx="70">
                  <c:v>630</c:v>
                </c:pt>
                <c:pt idx="71">
                  <c:v>629</c:v>
                </c:pt>
                <c:pt idx="72">
                  <c:v>628</c:v>
                </c:pt>
                <c:pt idx="73">
                  <c:v>627</c:v>
                </c:pt>
                <c:pt idx="74">
                  <c:v>626</c:v>
                </c:pt>
                <c:pt idx="75">
                  <c:v>625</c:v>
                </c:pt>
                <c:pt idx="76">
                  <c:v>624</c:v>
                </c:pt>
                <c:pt idx="77">
                  <c:v>623</c:v>
                </c:pt>
                <c:pt idx="78">
                  <c:v>622</c:v>
                </c:pt>
                <c:pt idx="79">
                  <c:v>621</c:v>
                </c:pt>
                <c:pt idx="80">
                  <c:v>620</c:v>
                </c:pt>
                <c:pt idx="81">
                  <c:v>619</c:v>
                </c:pt>
                <c:pt idx="82">
                  <c:v>618</c:v>
                </c:pt>
                <c:pt idx="83">
                  <c:v>617</c:v>
                </c:pt>
                <c:pt idx="84">
                  <c:v>616</c:v>
                </c:pt>
                <c:pt idx="85">
                  <c:v>615</c:v>
                </c:pt>
                <c:pt idx="86">
                  <c:v>614</c:v>
                </c:pt>
                <c:pt idx="87">
                  <c:v>613</c:v>
                </c:pt>
                <c:pt idx="88">
                  <c:v>612</c:v>
                </c:pt>
                <c:pt idx="89">
                  <c:v>611</c:v>
                </c:pt>
                <c:pt idx="90">
                  <c:v>610</c:v>
                </c:pt>
                <c:pt idx="91">
                  <c:v>609</c:v>
                </c:pt>
                <c:pt idx="92">
                  <c:v>608</c:v>
                </c:pt>
                <c:pt idx="93">
                  <c:v>607</c:v>
                </c:pt>
                <c:pt idx="94">
                  <c:v>606</c:v>
                </c:pt>
                <c:pt idx="95">
                  <c:v>605</c:v>
                </c:pt>
                <c:pt idx="96">
                  <c:v>604</c:v>
                </c:pt>
                <c:pt idx="97">
                  <c:v>603</c:v>
                </c:pt>
                <c:pt idx="98">
                  <c:v>602</c:v>
                </c:pt>
                <c:pt idx="99">
                  <c:v>601</c:v>
                </c:pt>
                <c:pt idx="100">
                  <c:v>600</c:v>
                </c:pt>
                <c:pt idx="101">
                  <c:v>599</c:v>
                </c:pt>
                <c:pt idx="102">
                  <c:v>598</c:v>
                </c:pt>
                <c:pt idx="103">
                  <c:v>597</c:v>
                </c:pt>
                <c:pt idx="104">
                  <c:v>596</c:v>
                </c:pt>
                <c:pt idx="105">
                  <c:v>595</c:v>
                </c:pt>
                <c:pt idx="106">
                  <c:v>594</c:v>
                </c:pt>
                <c:pt idx="107">
                  <c:v>593</c:v>
                </c:pt>
                <c:pt idx="108">
                  <c:v>592</c:v>
                </c:pt>
                <c:pt idx="109">
                  <c:v>591</c:v>
                </c:pt>
                <c:pt idx="110">
                  <c:v>590</c:v>
                </c:pt>
                <c:pt idx="111">
                  <c:v>589</c:v>
                </c:pt>
                <c:pt idx="112">
                  <c:v>588</c:v>
                </c:pt>
                <c:pt idx="113">
                  <c:v>587</c:v>
                </c:pt>
                <c:pt idx="114">
                  <c:v>586</c:v>
                </c:pt>
                <c:pt idx="115">
                  <c:v>585</c:v>
                </c:pt>
                <c:pt idx="116">
                  <c:v>584</c:v>
                </c:pt>
                <c:pt idx="117">
                  <c:v>583</c:v>
                </c:pt>
                <c:pt idx="118">
                  <c:v>582</c:v>
                </c:pt>
                <c:pt idx="119">
                  <c:v>581</c:v>
                </c:pt>
                <c:pt idx="120">
                  <c:v>580</c:v>
                </c:pt>
                <c:pt idx="121">
                  <c:v>579</c:v>
                </c:pt>
                <c:pt idx="122">
                  <c:v>578</c:v>
                </c:pt>
                <c:pt idx="123">
                  <c:v>577</c:v>
                </c:pt>
                <c:pt idx="124">
                  <c:v>576</c:v>
                </c:pt>
                <c:pt idx="125">
                  <c:v>575</c:v>
                </c:pt>
                <c:pt idx="126">
                  <c:v>574</c:v>
                </c:pt>
                <c:pt idx="127">
                  <c:v>573</c:v>
                </c:pt>
                <c:pt idx="128">
                  <c:v>572</c:v>
                </c:pt>
                <c:pt idx="129">
                  <c:v>571</c:v>
                </c:pt>
                <c:pt idx="130">
                  <c:v>570</c:v>
                </c:pt>
                <c:pt idx="131">
                  <c:v>569</c:v>
                </c:pt>
                <c:pt idx="132">
                  <c:v>568</c:v>
                </c:pt>
                <c:pt idx="133">
                  <c:v>567</c:v>
                </c:pt>
                <c:pt idx="134">
                  <c:v>566</c:v>
                </c:pt>
                <c:pt idx="135">
                  <c:v>565</c:v>
                </c:pt>
                <c:pt idx="136">
                  <c:v>564</c:v>
                </c:pt>
                <c:pt idx="137">
                  <c:v>563</c:v>
                </c:pt>
                <c:pt idx="138">
                  <c:v>562</c:v>
                </c:pt>
                <c:pt idx="139">
                  <c:v>561</c:v>
                </c:pt>
                <c:pt idx="140">
                  <c:v>560</c:v>
                </c:pt>
                <c:pt idx="141">
                  <c:v>559</c:v>
                </c:pt>
                <c:pt idx="142">
                  <c:v>558</c:v>
                </c:pt>
                <c:pt idx="143">
                  <c:v>557</c:v>
                </c:pt>
                <c:pt idx="144">
                  <c:v>556</c:v>
                </c:pt>
                <c:pt idx="145">
                  <c:v>555</c:v>
                </c:pt>
                <c:pt idx="146">
                  <c:v>554</c:v>
                </c:pt>
                <c:pt idx="147">
                  <c:v>553</c:v>
                </c:pt>
                <c:pt idx="148">
                  <c:v>552</c:v>
                </c:pt>
                <c:pt idx="149">
                  <c:v>551</c:v>
                </c:pt>
                <c:pt idx="150">
                  <c:v>550</c:v>
                </c:pt>
                <c:pt idx="151">
                  <c:v>549</c:v>
                </c:pt>
                <c:pt idx="152">
                  <c:v>548</c:v>
                </c:pt>
                <c:pt idx="153">
                  <c:v>547</c:v>
                </c:pt>
                <c:pt idx="154">
                  <c:v>546</c:v>
                </c:pt>
                <c:pt idx="155">
                  <c:v>545</c:v>
                </c:pt>
                <c:pt idx="156">
                  <c:v>544</c:v>
                </c:pt>
                <c:pt idx="157">
                  <c:v>543</c:v>
                </c:pt>
                <c:pt idx="158">
                  <c:v>542</c:v>
                </c:pt>
                <c:pt idx="159">
                  <c:v>541</c:v>
                </c:pt>
                <c:pt idx="160">
                  <c:v>540</c:v>
                </c:pt>
                <c:pt idx="161">
                  <c:v>539</c:v>
                </c:pt>
                <c:pt idx="162">
                  <c:v>538</c:v>
                </c:pt>
                <c:pt idx="163">
                  <c:v>537</c:v>
                </c:pt>
                <c:pt idx="164">
                  <c:v>536</c:v>
                </c:pt>
                <c:pt idx="165">
                  <c:v>535</c:v>
                </c:pt>
                <c:pt idx="166">
                  <c:v>534</c:v>
                </c:pt>
                <c:pt idx="167">
                  <c:v>533</c:v>
                </c:pt>
                <c:pt idx="168">
                  <c:v>532</c:v>
                </c:pt>
                <c:pt idx="169">
                  <c:v>531</c:v>
                </c:pt>
                <c:pt idx="170">
                  <c:v>530</c:v>
                </c:pt>
                <c:pt idx="171">
                  <c:v>529</c:v>
                </c:pt>
                <c:pt idx="172">
                  <c:v>528</c:v>
                </c:pt>
                <c:pt idx="173">
                  <c:v>527</c:v>
                </c:pt>
                <c:pt idx="174">
                  <c:v>526</c:v>
                </c:pt>
                <c:pt idx="175">
                  <c:v>525</c:v>
                </c:pt>
                <c:pt idx="176">
                  <c:v>524</c:v>
                </c:pt>
                <c:pt idx="177">
                  <c:v>523</c:v>
                </c:pt>
                <c:pt idx="178">
                  <c:v>522</c:v>
                </c:pt>
                <c:pt idx="179">
                  <c:v>521</c:v>
                </c:pt>
                <c:pt idx="180">
                  <c:v>520</c:v>
                </c:pt>
                <c:pt idx="181">
                  <c:v>519</c:v>
                </c:pt>
                <c:pt idx="182">
                  <c:v>518</c:v>
                </c:pt>
                <c:pt idx="183">
                  <c:v>517</c:v>
                </c:pt>
                <c:pt idx="184">
                  <c:v>516</c:v>
                </c:pt>
                <c:pt idx="185">
                  <c:v>515</c:v>
                </c:pt>
                <c:pt idx="186">
                  <c:v>514</c:v>
                </c:pt>
                <c:pt idx="187">
                  <c:v>513</c:v>
                </c:pt>
                <c:pt idx="188">
                  <c:v>512</c:v>
                </c:pt>
                <c:pt idx="189">
                  <c:v>511</c:v>
                </c:pt>
                <c:pt idx="190">
                  <c:v>510</c:v>
                </c:pt>
                <c:pt idx="191">
                  <c:v>509</c:v>
                </c:pt>
                <c:pt idx="192">
                  <c:v>508</c:v>
                </c:pt>
                <c:pt idx="193">
                  <c:v>507</c:v>
                </c:pt>
                <c:pt idx="194">
                  <c:v>506</c:v>
                </c:pt>
                <c:pt idx="195">
                  <c:v>505</c:v>
                </c:pt>
                <c:pt idx="196">
                  <c:v>504</c:v>
                </c:pt>
                <c:pt idx="197">
                  <c:v>503</c:v>
                </c:pt>
                <c:pt idx="198">
                  <c:v>502</c:v>
                </c:pt>
                <c:pt idx="199">
                  <c:v>501</c:v>
                </c:pt>
                <c:pt idx="200">
                  <c:v>500</c:v>
                </c:pt>
                <c:pt idx="201">
                  <c:v>499</c:v>
                </c:pt>
                <c:pt idx="202">
                  <c:v>498</c:v>
                </c:pt>
                <c:pt idx="203">
                  <c:v>497</c:v>
                </c:pt>
                <c:pt idx="204">
                  <c:v>496</c:v>
                </c:pt>
                <c:pt idx="205">
                  <c:v>495</c:v>
                </c:pt>
                <c:pt idx="206">
                  <c:v>494</c:v>
                </c:pt>
                <c:pt idx="207">
                  <c:v>493</c:v>
                </c:pt>
                <c:pt idx="208">
                  <c:v>492</c:v>
                </c:pt>
                <c:pt idx="209">
                  <c:v>491</c:v>
                </c:pt>
                <c:pt idx="210">
                  <c:v>490</c:v>
                </c:pt>
                <c:pt idx="211">
                  <c:v>489</c:v>
                </c:pt>
                <c:pt idx="212">
                  <c:v>488</c:v>
                </c:pt>
                <c:pt idx="213">
                  <c:v>487</c:v>
                </c:pt>
                <c:pt idx="214">
                  <c:v>486</c:v>
                </c:pt>
                <c:pt idx="215">
                  <c:v>485</c:v>
                </c:pt>
                <c:pt idx="216">
                  <c:v>484</c:v>
                </c:pt>
                <c:pt idx="217">
                  <c:v>483</c:v>
                </c:pt>
                <c:pt idx="218">
                  <c:v>482</c:v>
                </c:pt>
                <c:pt idx="219">
                  <c:v>481</c:v>
                </c:pt>
                <c:pt idx="220">
                  <c:v>480</c:v>
                </c:pt>
                <c:pt idx="221">
                  <c:v>479</c:v>
                </c:pt>
                <c:pt idx="222">
                  <c:v>478</c:v>
                </c:pt>
                <c:pt idx="223">
                  <c:v>477</c:v>
                </c:pt>
                <c:pt idx="224">
                  <c:v>476</c:v>
                </c:pt>
                <c:pt idx="225">
                  <c:v>475</c:v>
                </c:pt>
                <c:pt idx="226">
                  <c:v>474</c:v>
                </c:pt>
                <c:pt idx="227">
                  <c:v>473</c:v>
                </c:pt>
                <c:pt idx="228">
                  <c:v>472</c:v>
                </c:pt>
                <c:pt idx="229">
                  <c:v>471</c:v>
                </c:pt>
                <c:pt idx="230">
                  <c:v>470</c:v>
                </c:pt>
                <c:pt idx="231">
                  <c:v>469</c:v>
                </c:pt>
                <c:pt idx="232">
                  <c:v>468</c:v>
                </c:pt>
                <c:pt idx="233">
                  <c:v>467</c:v>
                </c:pt>
                <c:pt idx="234">
                  <c:v>466</c:v>
                </c:pt>
                <c:pt idx="235">
                  <c:v>465</c:v>
                </c:pt>
                <c:pt idx="236">
                  <c:v>464</c:v>
                </c:pt>
                <c:pt idx="237">
                  <c:v>463</c:v>
                </c:pt>
                <c:pt idx="238">
                  <c:v>462</c:v>
                </c:pt>
                <c:pt idx="239">
                  <c:v>461</c:v>
                </c:pt>
                <c:pt idx="240">
                  <c:v>460</c:v>
                </c:pt>
                <c:pt idx="241">
                  <c:v>459</c:v>
                </c:pt>
                <c:pt idx="242">
                  <c:v>458</c:v>
                </c:pt>
                <c:pt idx="243">
                  <c:v>457</c:v>
                </c:pt>
                <c:pt idx="244">
                  <c:v>456</c:v>
                </c:pt>
                <c:pt idx="245">
                  <c:v>455</c:v>
                </c:pt>
                <c:pt idx="246">
                  <c:v>454</c:v>
                </c:pt>
                <c:pt idx="247">
                  <c:v>453</c:v>
                </c:pt>
                <c:pt idx="248">
                  <c:v>452</c:v>
                </c:pt>
                <c:pt idx="249">
                  <c:v>451</c:v>
                </c:pt>
                <c:pt idx="250">
                  <c:v>450</c:v>
                </c:pt>
                <c:pt idx="251">
                  <c:v>449</c:v>
                </c:pt>
                <c:pt idx="252">
                  <c:v>448</c:v>
                </c:pt>
                <c:pt idx="253">
                  <c:v>447</c:v>
                </c:pt>
                <c:pt idx="254">
                  <c:v>446</c:v>
                </c:pt>
                <c:pt idx="255">
                  <c:v>445</c:v>
                </c:pt>
                <c:pt idx="256">
                  <c:v>444</c:v>
                </c:pt>
                <c:pt idx="257">
                  <c:v>443</c:v>
                </c:pt>
                <c:pt idx="258">
                  <c:v>442</c:v>
                </c:pt>
                <c:pt idx="259">
                  <c:v>441</c:v>
                </c:pt>
                <c:pt idx="260">
                  <c:v>440</c:v>
                </c:pt>
                <c:pt idx="261">
                  <c:v>439</c:v>
                </c:pt>
                <c:pt idx="262">
                  <c:v>438</c:v>
                </c:pt>
                <c:pt idx="263">
                  <c:v>437</c:v>
                </c:pt>
                <c:pt idx="264">
                  <c:v>436</c:v>
                </c:pt>
                <c:pt idx="265">
                  <c:v>435</c:v>
                </c:pt>
                <c:pt idx="266">
                  <c:v>434</c:v>
                </c:pt>
                <c:pt idx="267">
                  <c:v>433</c:v>
                </c:pt>
                <c:pt idx="268">
                  <c:v>432</c:v>
                </c:pt>
                <c:pt idx="269">
                  <c:v>431</c:v>
                </c:pt>
                <c:pt idx="270">
                  <c:v>430</c:v>
                </c:pt>
                <c:pt idx="271">
                  <c:v>429</c:v>
                </c:pt>
                <c:pt idx="272">
                  <c:v>428</c:v>
                </c:pt>
                <c:pt idx="273">
                  <c:v>427</c:v>
                </c:pt>
                <c:pt idx="274">
                  <c:v>426</c:v>
                </c:pt>
                <c:pt idx="275">
                  <c:v>425</c:v>
                </c:pt>
                <c:pt idx="276">
                  <c:v>424</c:v>
                </c:pt>
                <c:pt idx="277">
                  <c:v>423</c:v>
                </c:pt>
                <c:pt idx="278">
                  <c:v>422</c:v>
                </c:pt>
                <c:pt idx="279">
                  <c:v>421</c:v>
                </c:pt>
                <c:pt idx="280">
                  <c:v>420</c:v>
                </c:pt>
                <c:pt idx="281">
                  <c:v>419</c:v>
                </c:pt>
                <c:pt idx="282">
                  <c:v>418</c:v>
                </c:pt>
                <c:pt idx="283">
                  <c:v>417</c:v>
                </c:pt>
                <c:pt idx="284">
                  <c:v>416</c:v>
                </c:pt>
                <c:pt idx="285">
                  <c:v>415</c:v>
                </c:pt>
                <c:pt idx="286">
                  <c:v>414</c:v>
                </c:pt>
                <c:pt idx="287">
                  <c:v>413</c:v>
                </c:pt>
                <c:pt idx="288">
                  <c:v>412</c:v>
                </c:pt>
                <c:pt idx="289">
                  <c:v>411</c:v>
                </c:pt>
                <c:pt idx="290">
                  <c:v>410</c:v>
                </c:pt>
                <c:pt idx="291">
                  <c:v>409</c:v>
                </c:pt>
                <c:pt idx="292">
                  <c:v>408</c:v>
                </c:pt>
                <c:pt idx="293">
                  <c:v>407</c:v>
                </c:pt>
                <c:pt idx="294">
                  <c:v>406</c:v>
                </c:pt>
                <c:pt idx="295">
                  <c:v>405</c:v>
                </c:pt>
                <c:pt idx="296">
                  <c:v>404</c:v>
                </c:pt>
                <c:pt idx="297">
                  <c:v>403</c:v>
                </c:pt>
                <c:pt idx="298">
                  <c:v>402</c:v>
                </c:pt>
                <c:pt idx="299">
                  <c:v>401</c:v>
                </c:pt>
                <c:pt idx="300">
                  <c:v>400</c:v>
                </c:pt>
                <c:pt idx="301">
                  <c:v>399</c:v>
                </c:pt>
                <c:pt idx="302">
                  <c:v>398</c:v>
                </c:pt>
                <c:pt idx="303">
                  <c:v>397</c:v>
                </c:pt>
                <c:pt idx="304">
                  <c:v>396</c:v>
                </c:pt>
                <c:pt idx="305">
                  <c:v>395</c:v>
                </c:pt>
                <c:pt idx="306">
                  <c:v>394</c:v>
                </c:pt>
                <c:pt idx="307">
                  <c:v>393</c:v>
                </c:pt>
                <c:pt idx="308">
                  <c:v>392</c:v>
                </c:pt>
                <c:pt idx="309">
                  <c:v>391</c:v>
                </c:pt>
                <c:pt idx="310">
                  <c:v>390</c:v>
                </c:pt>
                <c:pt idx="311">
                  <c:v>389</c:v>
                </c:pt>
                <c:pt idx="312">
                  <c:v>388</c:v>
                </c:pt>
                <c:pt idx="313">
                  <c:v>387</c:v>
                </c:pt>
                <c:pt idx="314">
                  <c:v>386</c:v>
                </c:pt>
                <c:pt idx="315">
                  <c:v>385</c:v>
                </c:pt>
                <c:pt idx="316">
                  <c:v>384</c:v>
                </c:pt>
                <c:pt idx="317">
                  <c:v>383</c:v>
                </c:pt>
                <c:pt idx="318">
                  <c:v>382</c:v>
                </c:pt>
                <c:pt idx="319">
                  <c:v>381</c:v>
                </c:pt>
                <c:pt idx="320">
                  <c:v>380</c:v>
                </c:pt>
                <c:pt idx="321">
                  <c:v>379</c:v>
                </c:pt>
                <c:pt idx="322">
                  <c:v>378</c:v>
                </c:pt>
                <c:pt idx="323">
                  <c:v>377</c:v>
                </c:pt>
                <c:pt idx="324">
                  <c:v>376</c:v>
                </c:pt>
                <c:pt idx="325">
                  <c:v>375</c:v>
                </c:pt>
                <c:pt idx="326">
                  <c:v>374</c:v>
                </c:pt>
                <c:pt idx="327">
                  <c:v>373</c:v>
                </c:pt>
                <c:pt idx="328">
                  <c:v>372</c:v>
                </c:pt>
                <c:pt idx="329">
                  <c:v>371</c:v>
                </c:pt>
                <c:pt idx="330">
                  <c:v>370</c:v>
                </c:pt>
                <c:pt idx="331">
                  <c:v>369</c:v>
                </c:pt>
                <c:pt idx="332">
                  <c:v>368</c:v>
                </c:pt>
                <c:pt idx="333">
                  <c:v>367</c:v>
                </c:pt>
                <c:pt idx="334">
                  <c:v>366</c:v>
                </c:pt>
                <c:pt idx="335">
                  <c:v>365</c:v>
                </c:pt>
                <c:pt idx="336">
                  <c:v>364</c:v>
                </c:pt>
                <c:pt idx="337">
                  <c:v>363</c:v>
                </c:pt>
                <c:pt idx="338">
                  <c:v>362</c:v>
                </c:pt>
                <c:pt idx="339">
                  <c:v>361</c:v>
                </c:pt>
                <c:pt idx="340">
                  <c:v>360</c:v>
                </c:pt>
                <c:pt idx="341">
                  <c:v>359</c:v>
                </c:pt>
                <c:pt idx="342">
                  <c:v>358</c:v>
                </c:pt>
                <c:pt idx="343">
                  <c:v>357</c:v>
                </c:pt>
                <c:pt idx="344">
                  <c:v>356</c:v>
                </c:pt>
                <c:pt idx="345">
                  <c:v>355</c:v>
                </c:pt>
                <c:pt idx="346">
                  <c:v>354</c:v>
                </c:pt>
                <c:pt idx="347">
                  <c:v>353</c:v>
                </c:pt>
                <c:pt idx="348">
                  <c:v>352</c:v>
                </c:pt>
                <c:pt idx="349">
                  <c:v>351</c:v>
                </c:pt>
                <c:pt idx="350">
                  <c:v>350</c:v>
                </c:pt>
                <c:pt idx="351">
                  <c:v>349</c:v>
                </c:pt>
                <c:pt idx="352">
                  <c:v>348</c:v>
                </c:pt>
                <c:pt idx="353">
                  <c:v>347</c:v>
                </c:pt>
                <c:pt idx="354">
                  <c:v>346</c:v>
                </c:pt>
                <c:pt idx="355">
                  <c:v>345</c:v>
                </c:pt>
                <c:pt idx="356">
                  <c:v>344</c:v>
                </c:pt>
                <c:pt idx="357">
                  <c:v>343</c:v>
                </c:pt>
                <c:pt idx="358">
                  <c:v>342</c:v>
                </c:pt>
                <c:pt idx="359">
                  <c:v>341</c:v>
                </c:pt>
                <c:pt idx="360">
                  <c:v>340</c:v>
                </c:pt>
                <c:pt idx="361">
                  <c:v>339</c:v>
                </c:pt>
                <c:pt idx="362">
                  <c:v>338</c:v>
                </c:pt>
                <c:pt idx="363">
                  <c:v>337</c:v>
                </c:pt>
                <c:pt idx="364">
                  <c:v>336</c:v>
                </c:pt>
                <c:pt idx="365">
                  <c:v>335</c:v>
                </c:pt>
                <c:pt idx="366">
                  <c:v>334</c:v>
                </c:pt>
                <c:pt idx="367">
                  <c:v>333</c:v>
                </c:pt>
                <c:pt idx="368">
                  <c:v>332</c:v>
                </c:pt>
                <c:pt idx="369">
                  <c:v>331</c:v>
                </c:pt>
                <c:pt idx="370">
                  <c:v>330</c:v>
                </c:pt>
                <c:pt idx="371">
                  <c:v>329</c:v>
                </c:pt>
                <c:pt idx="372">
                  <c:v>328</c:v>
                </c:pt>
                <c:pt idx="373">
                  <c:v>327</c:v>
                </c:pt>
                <c:pt idx="374">
                  <c:v>326</c:v>
                </c:pt>
                <c:pt idx="375">
                  <c:v>325</c:v>
                </c:pt>
                <c:pt idx="376">
                  <c:v>324</c:v>
                </c:pt>
                <c:pt idx="377">
                  <c:v>323</c:v>
                </c:pt>
                <c:pt idx="378">
                  <c:v>322</c:v>
                </c:pt>
                <c:pt idx="379">
                  <c:v>321</c:v>
                </c:pt>
                <c:pt idx="380">
                  <c:v>320</c:v>
                </c:pt>
                <c:pt idx="381">
                  <c:v>319</c:v>
                </c:pt>
                <c:pt idx="382">
                  <c:v>318</c:v>
                </c:pt>
                <c:pt idx="383">
                  <c:v>317</c:v>
                </c:pt>
                <c:pt idx="384">
                  <c:v>316</c:v>
                </c:pt>
                <c:pt idx="385">
                  <c:v>315</c:v>
                </c:pt>
                <c:pt idx="386">
                  <c:v>314</c:v>
                </c:pt>
                <c:pt idx="387">
                  <c:v>313</c:v>
                </c:pt>
                <c:pt idx="388">
                  <c:v>312</c:v>
                </c:pt>
                <c:pt idx="389">
                  <c:v>311</c:v>
                </c:pt>
                <c:pt idx="390">
                  <c:v>310</c:v>
                </c:pt>
                <c:pt idx="391">
                  <c:v>309</c:v>
                </c:pt>
                <c:pt idx="392">
                  <c:v>308</c:v>
                </c:pt>
                <c:pt idx="393">
                  <c:v>307</c:v>
                </c:pt>
                <c:pt idx="394">
                  <c:v>306</c:v>
                </c:pt>
                <c:pt idx="395">
                  <c:v>305</c:v>
                </c:pt>
                <c:pt idx="396">
                  <c:v>304</c:v>
                </c:pt>
                <c:pt idx="397">
                  <c:v>303</c:v>
                </c:pt>
                <c:pt idx="398">
                  <c:v>302</c:v>
                </c:pt>
                <c:pt idx="399">
                  <c:v>301</c:v>
                </c:pt>
                <c:pt idx="400">
                  <c:v>300</c:v>
                </c:pt>
                <c:pt idx="401">
                  <c:v>299</c:v>
                </c:pt>
                <c:pt idx="402">
                  <c:v>298</c:v>
                </c:pt>
                <c:pt idx="403">
                  <c:v>297</c:v>
                </c:pt>
                <c:pt idx="404">
                  <c:v>296</c:v>
                </c:pt>
                <c:pt idx="405">
                  <c:v>295</c:v>
                </c:pt>
                <c:pt idx="406">
                  <c:v>294</c:v>
                </c:pt>
                <c:pt idx="407">
                  <c:v>293</c:v>
                </c:pt>
                <c:pt idx="408">
                  <c:v>292</c:v>
                </c:pt>
                <c:pt idx="409">
                  <c:v>291</c:v>
                </c:pt>
                <c:pt idx="410">
                  <c:v>290</c:v>
                </c:pt>
                <c:pt idx="411">
                  <c:v>289</c:v>
                </c:pt>
                <c:pt idx="412">
                  <c:v>288</c:v>
                </c:pt>
                <c:pt idx="413">
                  <c:v>287</c:v>
                </c:pt>
                <c:pt idx="414">
                  <c:v>286</c:v>
                </c:pt>
                <c:pt idx="415">
                  <c:v>285</c:v>
                </c:pt>
                <c:pt idx="416">
                  <c:v>284</c:v>
                </c:pt>
                <c:pt idx="417">
                  <c:v>283</c:v>
                </c:pt>
                <c:pt idx="418">
                  <c:v>282</c:v>
                </c:pt>
                <c:pt idx="419">
                  <c:v>281</c:v>
                </c:pt>
                <c:pt idx="420">
                  <c:v>280</c:v>
                </c:pt>
                <c:pt idx="421">
                  <c:v>279</c:v>
                </c:pt>
                <c:pt idx="422">
                  <c:v>278</c:v>
                </c:pt>
                <c:pt idx="423">
                  <c:v>277</c:v>
                </c:pt>
                <c:pt idx="424">
                  <c:v>276</c:v>
                </c:pt>
                <c:pt idx="425">
                  <c:v>275</c:v>
                </c:pt>
                <c:pt idx="426">
                  <c:v>274</c:v>
                </c:pt>
                <c:pt idx="427">
                  <c:v>273</c:v>
                </c:pt>
                <c:pt idx="428">
                  <c:v>272</c:v>
                </c:pt>
                <c:pt idx="429">
                  <c:v>271</c:v>
                </c:pt>
                <c:pt idx="430">
                  <c:v>270</c:v>
                </c:pt>
                <c:pt idx="431">
                  <c:v>269</c:v>
                </c:pt>
                <c:pt idx="432">
                  <c:v>268</c:v>
                </c:pt>
                <c:pt idx="433">
                  <c:v>267</c:v>
                </c:pt>
                <c:pt idx="434">
                  <c:v>266</c:v>
                </c:pt>
                <c:pt idx="435">
                  <c:v>265</c:v>
                </c:pt>
                <c:pt idx="436">
                  <c:v>264</c:v>
                </c:pt>
                <c:pt idx="437">
                  <c:v>263</c:v>
                </c:pt>
                <c:pt idx="438">
                  <c:v>262</c:v>
                </c:pt>
                <c:pt idx="439">
                  <c:v>261</c:v>
                </c:pt>
                <c:pt idx="440">
                  <c:v>260</c:v>
                </c:pt>
                <c:pt idx="441">
                  <c:v>259</c:v>
                </c:pt>
                <c:pt idx="442">
                  <c:v>258</c:v>
                </c:pt>
                <c:pt idx="443">
                  <c:v>257</c:v>
                </c:pt>
                <c:pt idx="444">
                  <c:v>256</c:v>
                </c:pt>
                <c:pt idx="445">
                  <c:v>255</c:v>
                </c:pt>
                <c:pt idx="446">
                  <c:v>254</c:v>
                </c:pt>
                <c:pt idx="447">
                  <c:v>253</c:v>
                </c:pt>
                <c:pt idx="448">
                  <c:v>252</c:v>
                </c:pt>
                <c:pt idx="449">
                  <c:v>251</c:v>
                </c:pt>
                <c:pt idx="450">
                  <c:v>250</c:v>
                </c:pt>
                <c:pt idx="451">
                  <c:v>249</c:v>
                </c:pt>
                <c:pt idx="452">
                  <c:v>248</c:v>
                </c:pt>
                <c:pt idx="453">
                  <c:v>247</c:v>
                </c:pt>
                <c:pt idx="454">
                  <c:v>246</c:v>
                </c:pt>
                <c:pt idx="455">
                  <c:v>245</c:v>
                </c:pt>
                <c:pt idx="456">
                  <c:v>244</c:v>
                </c:pt>
                <c:pt idx="457">
                  <c:v>243</c:v>
                </c:pt>
                <c:pt idx="458">
                  <c:v>242</c:v>
                </c:pt>
                <c:pt idx="459">
                  <c:v>241</c:v>
                </c:pt>
                <c:pt idx="460">
                  <c:v>240</c:v>
                </c:pt>
                <c:pt idx="461">
                  <c:v>239</c:v>
                </c:pt>
                <c:pt idx="462">
                  <c:v>238</c:v>
                </c:pt>
                <c:pt idx="463">
                  <c:v>237</c:v>
                </c:pt>
                <c:pt idx="464">
                  <c:v>236</c:v>
                </c:pt>
                <c:pt idx="465">
                  <c:v>235</c:v>
                </c:pt>
                <c:pt idx="466">
                  <c:v>234</c:v>
                </c:pt>
                <c:pt idx="467">
                  <c:v>233</c:v>
                </c:pt>
                <c:pt idx="468">
                  <c:v>232</c:v>
                </c:pt>
                <c:pt idx="469">
                  <c:v>231</c:v>
                </c:pt>
                <c:pt idx="470">
                  <c:v>230</c:v>
                </c:pt>
                <c:pt idx="471">
                  <c:v>229</c:v>
                </c:pt>
                <c:pt idx="472">
                  <c:v>228</c:v>
                </c:pt>
                <c:pt idx="473">
                  <c:v>227</c:v>
                </c:pt>
                <c:pt idx="474">
                  <c:v>226</c:v>
                </c:pt>
                <c:pt idx="475">
                  <c:v>225</c:v>
                </c:pt>
                <c:pt idx="476">
                  <c:v>224</c:v>
                </c:pt>
                <c:pt idx="477">
                  <c:v>223</c:v>
                </c:pt>
                <c:pt idx="478">
                  <c:v>222</c:v>
                </c:pt>
                <c:pt idx="479">
                  <c:v>221</c:v>
                </c:pt>
                <c:pt idx="480">
                  <c:v>220</c:v>
                </c:pt>
              </c:numCache>
            </c:numRef>
          </c:xVal>
          <c:yVal>
            <c:numRef>
              <c:f>文章选用!$F$2:$F$482</c:f>
              <c:numCache>
                <c:formatCode>General</c:formatCode>
                <c:ptCount val="48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  <c:pt idx="291">
                  <c:v>0</c:v>
                </c:pt>
                <c:pt idx="292">
                  <c:v>0</c:v>
                </c:pt>
                <c:pt idx="293">
                  <c:v>0</c:v>
                </c:pt>
                <c:pt idx="294">
                  <c:v>0</c:v>
                </c:pt>
                <c:pt idx="295">
                  <c:v>0</c:v>
                </c:pt>
                <c:pt idx="296">
                  <c:v>0</c:v>
                </c:pt>
                <c:pt idx="297">
                  <c:v>0</c:v>
                </c:pt>
                <c:pt idx="298">
                  <c:v>0</c:v>
                </c:pt>
                <c:pt idx="299">
                  <c:v>0</c:v>
                </c:pt>
                <c:pt idx="300">
                  <c:v>0</c:v>
                </c:pt>
                <c:pt idx="301">
                  <c:v>0</c:v>
                </c:pt>
                <c:pt idx="302">
                  <c:v>0</c:v>
                </c:pt>
                <c:pt idx="303">
                  <c:v>0</c:v>
                </c:pt>
                <c:pt idx="304">
                  <c:v>0</c:v>
                </c:pt>
                <c:pt idx="305">
                  <c:v>0</c:v>
                </c:pt>
                <c:pt idx="306">
                  <c:v>0</c:v>
                </c:pt>
                <c:pt idx="307">
                  <c:v>0</c:v>
                </c:pt>
                <c:pt idx="308">
                  <c:v>0</c:v>
                </c:pt>
                <c:pt idx="309">
                  <c:v>0</c:v>
                </c:pt>
                <c:pt idx="310">
                  <c:v>0</c:v>
                </c:pt>
                <c:pt idx="311">
                  <c:v>0</c:v>
                </c:pt>
                <c:pt idx="312">
                  <c:v>0</c:v>
                </c:pt>
                <c:pt idx="313">
                  <c:v>0</c:v>
                </c:pt>
                <c:pt idx="314">
                  <c:v>0</c:v>
                </c:pt>
                <c:pt idx="315">
                  <c:v>0</c:v>
                </c:pt>
                <c:pt idx="316">
                  <c:v>0</c:v>
                </c:pt>
                <c:pt idx="317">
                  <c:v>0</c:v>
                </c:pt>
                <c:pt idx="318">
                  <c:v>0</c:v>
                </c:pt>
                <c:pt idx="319">
                  <c:v>0</c:v>
                </c:pt>
                <c:pt idx="320">
                  <c:v>0</c:v>
                </c:pt>
                <c:pt idx="321">
                  <c:v>0</c:v>
                </c:pt>
                <c:pt idx="322">
                  <c:v>0</c:v>
                </c:pt>
                <c:pt idx="323">
                  <c:v>0</c:v>
                </c:pt>
                <c:pt idx="324">
                  <c:v>0</c:v>
                </c:pt>
                <c:pt idx="325">
                  <c:v>0</c:v>
                </c:pt>
                <c:pt idx="326">
                  <c:v>0</c:v>
                </c:pt>
                <c:pt idx="327">
                  <c:v>0</c:v>
                </c:pt>
                <c:pt idx="328">
                  <c:v>0</c:v>
                </c:pt>
                <c:pt idx="329">
                  <c:v>0</c:v>
                </c:pt>
                <c:pt idx="330">
                  <c:v>0</c:v>
                </c:pt>
                <c:pt idx="331">
                  <c:v>0</c:v>
                </c:pt>
                <c:pt idx="332">
                  <c:v>0</c:v>
                </c:pt>
                <c:pt idx="333">
                  <c:v>0</c:v>
                </c:pt>
                <c:pt idx="334">
                  <c:v>0</c:v>
                </c:pt>
                <c:pt idx="335">
                  <c:v>0</c:v>
                </c:pt>
                <c:pt idx="336">
                  <c:v>0</c:v>
                </c:pt>
                <c:pt idx="337">
                  <c:v>0</c:v>
                </c:pt>
                <c:pt idx="338">
                  <c:v>0</c:v>
                </c:pt>
                <c:pt idx="339">
                  <c:v>0</c:v>
                </c:pt>
                <c:pt idx="340">
                  <c:v>0</c:v>
                </c:pt>
                <c:pt idx="341">
                  <c:v>0</c:v>
                </c:pt>
                <c:pt idx="342">
                  <c:v>0</c:v>
                </c:pt>
                <c:pt idx="343">
                  <c:v>0</c:v>
                </c:pt>
                <c:pt idx="344">
                  <c:v>0</c:v>
                </c:pt>
                <c:pt idx="345">
                  <c:v>0</c:v>
                </c:pt>
                <c:pt idx="346">
                  <c:v>0</c:v>
                </c:pt>
                <c:pt idx="347">
                  <c:v>0</c:v>
                </c:pt>
                <c:pt idx="348">
                  <c:v>0</c:v>
                </c:pt>
                <c:pt idx="349">
                  <c:v>0</c:v>
                </c:pt>
                <c:pt idx="350">
                  <c:v>0</c:v>
                </c:pt>
                <c:pt idx="351">
                  <c:v>0</c:v>
                </c:pt>
                <c:pt idx="352">
                  <c:v>0</c:v>
                </c:pt>
                <c:pt idx="353">
                  <c:v>0</c:v>
                </c:pt>
                <c:pt idx="354">
                  <c:v>0</c:v>
                </c:pt>
                <c:pt idx="355">
                  <c:v>0</c:v>
                </c:pt>
                <c:pt idx="356">
                  <c:v>0</c:v>
                </c:pt>
                <c:pt idx="357">
                  <c:v>0</c:v>
                </c:pt>
                <c:pt idx="358">
                  <c:v>0</c:v>
                </c:pt>
                <c:pt idx="359">
                  <c:v>0</c:v>
                </c:pt>
                <c:pt idx="360">
                  <c:v>0</c:v>
                </c:pt>
                <c:pt idx="361">
                  <c:v>0</c:v>
                </c:pt>
                <c:pt idx="362">
                  <c:v>0</c:v>
                </c:pt>
                <c:pt idx="363">
                  <c:v>0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  <c:pt idx="402">
                  <c:v>0</c:v>
                </c:pt>
                <c:pt idx="403">
                  <c:v>0</c:v>
                </c:pt>
                <c:pt idx="404">
                  <c:v>0</c:v>
                </c:pt>
                <c:pt idx="405">
                  <c:v>0</c:v>
                </c:pt>
                <c:pt idx="406">
                  <c:v>0</c:v>
                </c:pt>
                <c:pt idx="407">
                  <c:v>0</c:v>
                </c:pt>
                <c:pt idx="408">
                  <c:v>0</c:v>
                </c:pt>
                <c:pt idx="409">
                  <c:v>0</c:v>
                </c:pt>
                <c:pt idx="410">
                  <c:v>0</c:v>
                </c:pt>
                <c:pt idx="411">
                  <c:v>0</c:v>
                </c:pt>
                <c:pt idx="412">
                  <c:v>0</c:v>
                </c:pt>
                <c:pt idx="413">
                  <c:v>0</c:v>
                </c:pt>
                <c:pt idx="414">
                  <c:v>0</c:v>
                </c:pt>
                <c:pt idx="415">
                  <c:v>0</c:v>
                </c:pt>
                <c:pt idx="416">
                  <c:v>0</c:v>
                </c:pt>
                <c:pt idx="417">
                  <c:v>0</c:v>
                </c:pt>
                <c:pt idx="418">
                  <c:v>0</c:v>
                </c:pt>
                <c:pt idx="419">
                  <c:v>0</c:v>
                </c:pt>
                <c:pt idx="420">
                  <c:v>0</c:v>
                </c:pt>
                <c:pt idx="421">
                  <c:v>0</c:v>
                </c:pt>
                <c:pt idx="422">
                  <c:v>0</c:v>
                </c:pt>
                <c:pt idx="423">
                  <c:v>0</c:v>
                </c:pt>
                <c:pt idx="424">
                  <c:v>0</c:v>
                </c:pt>
                <c:pt idx="425">
                  <c:v>0</c:v>
                </c:pt>
                <c:pt idx="426">
                  <c:v>0</c:v>
                </c:pt>
                <c:pt idx="427">
                  <c:v>0</c:v>
                </c:pt>
                <c:pt idx="428">
                  <c:v>0</c:v>
                </c:pt>
                <c:pt idx="429">
                  <c:v>0</c:v>
                </c:pt>
                <c:pt idx="430">
                  <c:v>0</c:v>
                </c:pt>
                <c:pt idx="431">
                  <c:v>0</c:v>
                </c:pt>
                <c:pt idx="432">
                  <c:v>0</c:v>
                </c:pt>
                <c:pt idx="433">
                  <c:v>0</c:v>
                </c:pt>
                <c:pt idx="434">
                  <c:v>0</c:v>
                </c:pt>
                <c:pt idx="435">
                  <c:v>0</c:v>
                </c:pt>
                <c:pt idx="436">
                  <c:v>0</c:v>
                </c:pt>
                <c:pt idx="437">
                  <c:v>0</c:v>
                </c:pt>
                <c:pt idx="438">
                  <c:v>0</c:v>
                </c:pt>
                <c:pt idx="439">
                  <c:v>0</c:v>
                </c:pt>
                <c:pt idx="440">
                  <c:v>0</c:v>
                </c:pt>
                <c:pt idx="441">
                  <c:v>0</c:v>
                </c:pt>
                <c:pt idx="442">
                  <c:v>0</c:v>
                </c:pt>
                <c:pt idx="443">
                  <c:v>0</c:v>
                </c:pt>
                <c:pt idx="444">
                  <c:v>0</c:v>
                </c:pt>
                <c:pt idx="445">
                  <c:v>0</c:v>
                </c:pt>
                <c:pt idx="446">
                  <c:v>0</c:v>
                </c:pt>
                <c:pt idx="447">
                  <c:v>0</c:v>
                </c:pt>
                <c:pt idx="448">
                  <c:v>0</c:v>
                </c:pt>
                <c:pt idx="449">
                  <c:v>0</c:v>
                </c:pt>
                <c:pt idx="450">
                  <c:v>0</c:v>
                </c:pt>
                <c:pt idx="451">
                  <c:v>0</c:v>
                </c:pt>
                <c:pt idx="452">
                  <c:v>0</c:v>
                </c:pt>
                <c:pt idx="453">
                  <c:v>0</c:v>
                </c:pt>
                <c:pt idx="454">
                  <c:v>0</c:v>
                </c:pt>
                <c:pt idx="455">
                  <c:v>0</c:v>
                </c:pt>
                <c:pt idx="456">
                  <c:v>0</c:v>
                </c:pt>
                <c:pt idx="457">
                  <c:v>0</c:v>
                </c:pt>
                <c:pt idx="458">
                  <c:v>0</c:v>
                </c:pt>
                <c:pt idx="459">
                  <c:v>0</c:v>
                </c:pt>
                <c:pt idx="460">
                  <c:v>0</c:v>
                </c:pt>
                <c:pt idx="461">
                  <c:v>0</c:v>
                </c:pt>
                <c:pt idx="462">
                  <c:v>0</c:v>
                </c:pt>
                <c:pt idx="463">
                  <c:v>0</c:v>
                </c:pt>
                <c:pt idx="464">
                  <c:v>0</c:v>
                </c:pt>
                <c:pt idx="465">
                  <c:v>0</c:v>
                </c:pt>
                <c:pt idx="466">
                  <c:v>0</c:v>
                </c:pt>
                <c:pt idx="467">
                  <c:v>0</c:v>
                </c:pt>
                <c:pt idx="468">
                  <c:v>0</c:v>
                </c:pt>
                <c:pt idx="469">
                  <c:v>0</c:v>
                </c:pt>
                <c:pt idx="470">
                  <c:v>0</c:v>
                </c:pt>
                <c:pt idx="471">
                  <c:v>0</c:v>
                </c:pt>
                <c:pt idx="472">
                  <c:v>0</c:v>
                </c:pt>
                <c:pt idx="473">
                  <c:v>0</c:v>
                </c:pt>
                <c:pt idx="474">
                  <c:v>0</c:v>
                </c:pt>
                <c:pt idx="475">
                  <c:v>0</c:v>
                </c:pt>
                <c:pt idx="476">
                  <c:v>0</c:v>
                </c:pt>
                <c:pt idx="477">
                  <c:v>0</c:v>
                </c:pt>
                <c:pt idx="478">
                  <c:v>0</c:v>
                </c:pt>
                <c:pt idx="479">
                  <c:v>0</c:v>
                </c:pt>
                <c:pt idx="480">
                  <c:v>0</c:v>
                </c:pt>
              </c:numCache>
            </c:numRef>
          </c:yVal>
          <c:smooth val="1"/>
          <c:extLst xmlns:c15="http://schemas.microsoft.com/office/drawing/2012/chart">
            <c:ext xmlns:c16="http://schemas.microsoft.com/office/drawing/2014/chart" uri="{C3380CC4-5D6E-409C-BE32-E72D297353CC}">
              <c16:uniqueId val="{00000002-484E-4AD9-A9AA-15FEB2A4FB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07404447"/>
        <c:axId val="1507405279"/>
        <c:extLst>
          <c:ext xmlns:c15="http://schemas.microsoft.com/office/drawing/2012/chart" uri="{02D57815-91ED-43cb-92C2-25804820EDAC}">
            <c15:filteredScatte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文章选用!$D$1</c15:sqref>
                        </c15:formulaRef>
                      </c:ext>
                    </c:extLst>
                    <c:strCache>
                      <c:ptCount val="1"/>
                      <c:pt idx="0">
                        <c:v>Dil-PNC</c:v>
                      </c:pt>
                    </c:strCache>
                  </c:strRef>
                </c:tx>
                <c:spPr>
                  <a:ln w="12700" cap="rnd">
                    <a:solidFill>
                      <a:srgbClr val="FF0000"/>
                    </a:solidFill>
                    <a:round/>
                  </a:ln>
                  <a:effectLst/>
                </c:spPr>
                <c:marker>
                  <c:symbol val="none"/>
                </c:marker>
                <c:xVal>
                  <c:numRef>
                    <c:extLst>
                      <c:ext uri="{02D57815-91ED-43cb-92C2-25804820EDAC}">
                        <c15:formulaRef>
                          <c15:sqref>文章选用!$A$2:$A$482</c15:sqref>
                        </c15:formulaRef>
                      </c:ext>
                    </c:extLst>
                    <c:numCache>
                      <c:formatCode>General</c:formatCode>
                      <c:ptCount val="481"/>
                      <c:pt idx="0">
                        <c:v>700</c:v>
                      </c:pt>
                      <c:pt idx="1">
                        <c:v>699</c:v>
                      </c:pt>
                      <c:pt idx="2">
                        <c:v>698</c:v>
                      </c:pt>
                      <c:pt idx="3">
                        <c:v>697</c:v>
                      </c:pt>
                      <c:pt idx="4">
                        <c:v>696</c:v>
                      </c:pt>
                      <c:pt idx="5">
                        <c:v>695</c:v>
                      </c:pt>
                      <c:pt idx="6">
                        <c:v>694</c:v>
                      </c:pt>
                      <c:pt idx="7">
                        <c:v>693</c:v>
                      </c:pt>
                      <c:pt idx="8">
                        <c:v>692</c:v>
                      </c:pt>
                      <c:pt idx="9">
                        <c:v>691</c:v>
                      </c:pt>
                      <c:pt idx="10">
                        <c:v>690</c:v>
                      </c:pt>
                      <c:pt idx="11">
                        <c:v>689</c:v>
                      </c:pt>
                      <c:pt idx="12">
                        <c:v>688</c:v>
                      </c:pt>
                      <c:pt idx="13">
                        <c:v>687</c:v>
                      </c:pt>
                      <c:pt idx="14">
                        <c:v>686</c:v>
                      </c:pt>
                      <c:pt idx="15">
                        <c:v>685</c:v>
                      </c:pt>
                      <c:pt idx="16">
                        <c:v>684</c:v>
                      </c:pt>
                      <c:pt idx="17">
                        <c:v>683</c:v>
                      </c:pt>
                      <c:pt idx="18">
                        <c:v>682</c:v>
                      </c:pt>
                      <c:pt idx="19">
                        <c:v>681</c:v>
                      </c:pt>
                      <c:pt idx="20">
                        <c:v>680</c:v>
                      </c:pt>
                      <c:pt idx="21">
                        <c:v>679</c:v>
                      </c:pt>
                      <c:pt idx="22">
                        <c:v>678</c:v>
                      </c:pt>
                      <c:pt idx="23">
                        <c:v>677</c:v>
                      </c:pt>
                      <c:pt idx="24">
                        <c:v>676</c:v>
                      </c:pt>
                      <c:pt idx="25">
                        <c:v>675</c:v>
                      </c:pt>
                      <c:pt idx="26">
                        <c:v>674</c:v>
                      </c:pt>
                      <c:pt idx="27">
                        <c:v>673</c:v>
                      </c:pt>
                      <c:pt idx="28">
                        <c:v>672</c:v>
                      </c:pt>
                      <c:pt idx="29">
                        <c:v>671</c:v>
                      </c:pt>
                      <c:pt idx="30">
                        <c:v>670</c:v>
                      </c:pt>
                      <c:pt idx="31">
                        <c:v>669</c:v>
                      </c:pt>
                      <c:pt idx="32">
                        <c:v>668</c:v>
                      </c:pt>
                      <c:pt idx="33">
                        <c:v>667</c:v>
                      </c:pt>
                      <c:pt idx="34">
                        <c:v>666</c:v>
                      </c:pt>
                      <c:pt idx="35">
                        <c:v>665</c:v>
                      </c:pt>
                      <c:pt idx="36">
                        <c:v>664</c:v>
                      </c:pt>
                      <c:pt idx="37">
                        <c:v>663</c:v>
                      </c:pt>
                      <c:pt idx="38">
                        <c:v>662</c:v>
                      </c:pt>
                      <c:pt idx="39">
                        <c:v>661</c:v>
                      </c:pt>
                      <c:pt idx="40">
                        <c:v>660</c:v>
                      </c:pt>
                      <c:pt idx="41">
                        <c:v>659</c:v>
                      </c:pt>
                      <c:pt idx="42">
                        <c:v>658</c:v>
                      </c:pt>
                      <c:pt idx="43">
                        <c:v>657</c:v>
                      </c:pt>
                      <c:pt idx="44">
                        <c:v>656</c:v>
                      </c:pt>
                      <c:pt idx="45">
                        <c:v>655</c:v>
                      </c:pt>
                      <c:pt idx="46">
                        <c:v>654</c:v>
                      </c:pt>
                      <c:pt idx="47">
                        <c:v>653</c:v>
                      </c:pt>
                      <c:pt idx="48">
                        <c:v>652</c:v>
                      </c:pt>
                      <c:pt idx="49">
                        <c:v>651</c:v>
                      </c:pt>
                      <c:pt idx="50">
                        <c:v>650</c:v>
                      </c:pt>
                      <c:pt idx="51">
                        <c:v>649</c:v>
                      </c:pt>
                      <c:pt idx="52">
                        <c:v>648</c:v>
                      </c:pt>
                      <c:pt idx="53">
                        <c:v>647</c:v>
                      </c:pt>
                      <c:pt idx="54">
                        <c:v>646</c:v>
                      </c:pt>
                      <c:pt idx="55">
                        <c:v>645</c:v>
                      </c:pt>
                      <c:pt idx="56">
                        <c:v>644</c:v>
                      </c:pt>
                      <c:pt idx="57">
                        <c:v>643</c:v>
                      </c:pt>
                      <c:pt idx="58">
                        <c:v>642</c:v>
                      </c:pt>
                      <c:pt idx="59">
                        <c:v>641</c:v>
                      </c:pt>
                      <c:pt idx="60">
                        <c:v>640</c:v>
                      </c:pt>
                      <c:pt idx="61">
                        <c:v>639</c:v>
                      </c:pt>
                      <c:pt idx="62">
                        <c:v>638</c:v>
                      </c:pt>
                      <c:pt idx="63">
                        <c:v>637</c:v>
                      </c:pt>
                      <c:pt idx="64">
                        <c:v>636</c:v>
                      </c:pt>
                      <c:pt idx="65">
                        <c:v>635</c:v>
                      </c:pt>
                      <c:pt idx="66">
                        <c:v>634</c:v>
                      </c:pt>
                      <c:pt idx="67">
                        <c:v>633</c:v>
                      </c:pt>
                      <c:pt idx="68">
                        <c:v>632</c:v>
                      </c:pt>
                      <c:pt idx="69">
                        <c:v>631</c:v>
                      </c:pt>
                      <c:pt idx="70">
                        <c:v>630</c:v>
                      </c:pt>
                      <c:pt idx="71">
                        <c:v>629</c:v>
                      </c:pt>
                      <c:pt idx="72">
                        <c:v>628</c:v>
                      </c:pt>
                      <c:pt idx="73">
                        <c:v>627</c:v>
                      </c:pt>
                      <c:pt idx="74">
                        <c:v>626</c:v>
                      </c:pt>
                      <c:pt idx="75">
                        <c:v>625</c:v>
                      </c:pt>
                      <c:pt idx="76">
                        <c:v>624</c:v>
                      </c:pt>
                      <c:pt idx="77">
                        <c:v>623</c:v>
                      </c:pt>
                      <c:pt idx="78">
                        <c:v>622</c:v>
                      </c:pt>
                      <c:pt idx="79">
                        <c:v>621</c:v>
                      </c:pt>
                      <c:pt idx="80">
                        <c:v>620</c:v>
                      </c:pt>
                      <c:pt idx="81">
                        <c:v>619</c:v>
                      </c:pt>
                      <c:pt idx="82">
                        <c:v>618</c:v>
                      </c:pt>
                      <c:pt idx="83">
                        <c:v>617</c:v>
                      </c:pt>
                      <c:pt idx="84">
                        <c:v>616</c:v>
                      </c:pt>
                      <c:pt idx="85">
                        <c:v>615</c:v>
                      </c:pt>
                      <c:pt idx="86">
                        <c:v>614</c:v>
                      </c:pt>
                      <c:pt idx="87">
                        <c:v>613</c:v>
                      </c:pt>
                      <c:pt idx="88">
                        <c:v>612</c:v>
                      </c:pt>
                      <c:pt idx="89">
                        <c:v>611</c:v>
                      </c:pt>
                      <c:pt idx="90">
                        <c:v>610</c:v>
                      </c:pt>
                      <c:pt idx="91">
                        <c:v>609</c:v>
                      </c:pt>
                      <c:pt idx="92">
                        <c:v>608</c:v>
                      </c:pt>
                      <c:pt idx="93">
                        <c:v>607</c:v>
                      </c:pt>
                      <c:pt idx="94">
                        <c:v>606</c:v>
                      </c:pt>
                      <c:pt idx="95">
                        <c:v>605</c:v>
                      </c:pt>
                      <c:pt idx="96">
                        <c:v>604</c:v>
                      </c:pt>
                      <c:pt idx="97">
                        <c:v>603</c:v>
                      </c:pt>
                      <c:pt idx="98">
                        <c:v>602</c:v>
                      </c:pt>
                      <c:pt idx="99">
                        <c:v>601</c:v>
                      </c:pt>
                      <c:pt idx="100">
                        <c:v>600</c:v>
                      </c:pt>
                      <c:pt idx="101">
                        <c:v>599</c:v>
                      </c:pt>
                      <c:pt idx="102">
                        <c:v>598</c:v>
                      </c:pt>
                      <c:pt idx="103">
                        <c:v>597</c:v>
                      </c:pt>
                      <c:pt idx="104">
                        <c:v>596</c:v>
                      </c:pt>
                      <c:pt idx="105">
                        <c:v>595</c:v>
                      </c:pt>
                      <c:pt idx="106">
                        <c:v>594</c:v>
                      </c:pt>
                      <c:pt idx="107">
                        <c:v>593</c:v>
                      </c:pt>
                      <c:pt idx="108">
                        <c:v>592</c:v>
                      </c:pt>
                      <c:pt idx="109">
                        <c:v>591</c:v>
                      </c:pt>
                      <c:pt idx="110">
                        <c:v>590</c:v>
                      </c:pt>
                      <c:pt idx="111">
                        <c:v>589</c:v>
                      </c:pt>
                      <c:pt idx="112">
                        <c:v>588</c:v>
                      </c:pt>
                      <c:pt idx="113">
                        <c:v>587</c:v>
                      </c:pt>
                      <c:pt idx="114">
                        <c:v>586</c:v>
                      </c:pt>
                      <c:pt idx="115">
                        <c:v>585</c:v>
                      </c:pt>
                      <c:pt idx="116">
                        <c:v>584</c:v>
                      </c:pt>
                      <c:pt idx="117">
                        <c:v>583</c:v>
                      </c:pt>
                      <c:pt idx="118">
                        <c:v>582</c:v>
                      </c:pt>
                      <c:pt idx="119">
                        <c:v>581</c:v>
                      </c:pt>
                      <c:pt idx="120">
                        <c:v>580</c:v>
                      </c:pt>
                      <c:pt idx="121">
                        <c:v>579</c:v>
                      </c:pt>
                      <c:pt idx="122">
                        <c:v>578</c:v>
                      </c:pt>
                      <c:pt idx="123">
                        <c:v>577</c:v>
                      </c:pt>
                      <c:pt idx="124">
                        <c:v>576</c:v>
                      </c:pt>
                      <c:pt idx="125">
                        <c:v>575</c:v>
                      </c:pt>
                      <c:pt idx="126">
                        <c:v>574</c:v>
                      </c:pt>
                      <c:pt idx="127">
                        <c:v>573</c:v>
                      </c:pt>
                      <c:pt idx="128">
                        <c:v>572</c:v>
                      </c:pt>
                      <c:pt idx="129">
                        <c:v>571</c:v>
                      </c:pt>
                      <c:pt idx="130">
                        <c:v>570</c:v>
                      </c:pt>
                      <c:pt idx="131">
                        <c:v>569</c:v>
                      </c:pt>
                      <c:pt idx="132">
                        <c:v>568</c:v>
                      </c:pt>
                      <c:pt idx="133">
                        <c:v>567</c:v>
                      </c:pt>
                      <c:pt idx="134">
                        <c:v>566</c:v>
                      </c:pt>
                      <c:pt idx="135">
                        <c:v>565</c:v>
                      </c:pt>
                      <c:pt idx="136">
                        <c:v>564</c:v>
                      </c:pt>
                      <c:pt idx="137">
                        <c:v>563</c:v>
                      </c:pt>
                      <c:pt idx="138">
                        <c:v>562</c:v>
                      </c:pt>
                      <c:pt idx="139">
                        <c:v>561</c:v>
                      </c:pt>
                      <c:pt idx="140">
                        <c:v>560</c:v>
                      </c:pt>
                      <c:pt idx="141">
                        <c:v>559</c:v>
                      </c:pt>
                      <c:pt idx="142">
                        <c:v>558</c:v>
                      </c:pt>
                      <c:pt idx="143">
                        <c:v>557</c:v>
                      </c:pt>
                      <c:pt idx="144">
                        <c:v>556</c:v>
                      </c:pt>
                      <c:pt idx="145">
                        <c:v>555</c:v>
                      </c:pt>
                      <c:pt idx="146">
                        <c:v>554</c:v>
                      </c:pt>
                      <c:pt idx="147">
                        <c:v>553</c:v>
                      </c:pt>
                      <c:pt idx="148">
                        <c:v>552</c:v>
                      </c:pt>
                      <c:pt idx="149">
                        <c:v>551</c:v>
                      </c:pt>
                      <c:pt idx="150">
                        <c:v>550</c:v>
                      </c:pt>
                      <c:pt idx="151">
                        <c:v>549</c:v>
                      </c:pt>
                      <c:pt idx="152">
                        <c:v>548</c:v>
                      </c:pt>
                      <c:pt idx="153">
                        <c:v>547</c:v>
                      </c:pt>
                      <c:pt idx="154">
                        <c:v>546</c:v>
                      </c:pt>
                      <c:pt idx="155">
                        <c:v>545</c:v>
                      </c:pt>
                      <c:pt idx="156">
                        <c:v>544</c:v>
                      </c:pt>
                      <c:pt idx="157">
                        <c:v>543</c:v>
                      </c:pt>
                      <c:pt idx="158">
                        <c:v>542</c:v>
                      </c:pt>
                      <c:pt idx="159">
                        <c:v>541</c:v>
                      </c:pt>
                      <c:pt idx="160">
                        <c:v>540</c:v>
                      </c:pt>
                      <c:pt idx="161">
                        <c:v>539</c:v>
                      </c:pt>
                      <c:pt idx="162">
                        <c:v>538</c:v>
                      </c:pt>
                      <c:pt idx="163">
                        <c:v>537</c:v>
                      </c:pt>
                      <c:pt idx="164">
                        <c:v>536</c:v>
                      </c:pt>
                      <c:pt idx="165">
                        <c:v>535</c:v>
                      </c:pt>
                      <c:pt idx="166">
                        <c:v>534</c:v>
                      </c:pt>
                      <c:pt idx="167">
                        <c:v>533</c:v>
                      </c:pt>
                      <c:pt idx="168">
                        <c:v>532</c:v>
                      </c:pt>
                      <c:pt idx="169">
                        <c:v>531</c:v>
                      </c:pt>
                      <c:pt idx="170">
                        <c:v>530</c:v>
                      </c:pt>
                      <c:pt idx="171">
                        <c:v>529</c:v>
                      </c:pt>
                      <c:pt idx="172">
                        <c:v>528</c:v>
                      </c:pt>
                      <c:pt idx="173">
                        <c:v>527</c:v>
                      </c:pt>
                      <c:pt idx="174">
                        <c:v>526</c:v>
                      </c:pt>
                      <c:pt idx="175">
                        <c:v>525</c:v>
                      </c:pt>
                      <c:pt idx="176">
                        <c:v>524</c:v>
                      </c:pt>
                      <c:pt idx="177">
                        <c:v>523</c:v>
                      </c:pt>
                      <c:pt idx="178">
                        <c:v>522</c:v>
                      </c:pt>
                      <c:pt idx="179">
                        <c:v>521</c:v>
                      </c:pt>
                      <c:pt idx="180">
                        <c:v>520</c:v>
                      </c:pt>
                      <c:pt idx="181">
                        <c:v>519</c:v>
                      </c:pt>
                      <c:pt idx="182">
                        <c:v>518</c:v>
                      </c:pt>
                      <c:pt idx="183">
                        <c:v>517</c:v>
                      </c:pt>
                      <c:pt idx="184">
                        <c:v>516</c:v>
                      </c:pt>
                      <c:pt idx="185">
                        <c:v>515</c:v>
                      </c:pt>
                      <c:pt idx="186">
                        <c:v>514</c:v>
                      </c:pt>
                      <c:pt idx="187">
                        <c:v>513</c:v>
                      </c:pt>
                      <c:pt idx="188">
                        <c:v>512</c:v>
                      </c:pt>
                      <c:pt idx="189">
                        <c:v>511</c:v>
                      </c:pt>
                      <c:pt idx="190">
                        <c:v>510</c:v>
                      </c:pt>
                      <c:pt idx="191">
                        <c:v>509</c:v>
                      </c:pt>
                      <c:pt idx="192">
                        <c:v>508</c:v>
                      </c:pt>
                      <c:pt idx="193">
                        <c:v>507</c:v>
                      </c:pt>
                      <c:pt idx="194">
                        <c:v>506</c:v>
                      </c:pt>
                      <c:pt idx="195">
                        <c:v>505</c:v>
                      </c:pt>
                      <c:pt idx="196">
                        <c:v>504</c:v>
                      </c:pt>
                      <c:pt idx="197">
                        <c:v>503</c:v>
                      </c:pt>
                      <c:pt idx="198">
                        <c:v>502</c:v>
                      </c:pt>
                      <c:pt idx="199">
                        <c:v>501</c:v>
                      </c:pt>
                      <c:pt idx="200">
                        <c:v>500</c:v>
                      </c:pt>
                      <c:pt idx="201">
                        <c:v>499</c:v>
                      </c:pt>
                      <c:pt idx="202">
                        <c:v>498</c:v>
                      </c:pt>
                      <c:pt idx="203">
                        <c:v>497</c:v>
                      </c:pt>
                      <c:pt idx="204">
                        <c:v>496</c:v>
                      </c:pt>
                      <c:pt idx="205">
                        <c:v>495</c:v>
                      </c:pt>
                      <c:pt idx="206">
                        <c:v>494</c:v>
                      </c:pt>
                      <c:pt idx="207">
                        <c:v>493</c:v>
                      </c:pt>
                      <c:pt idx="208">
                        <c:v>492</c:v>
                      </c:pt>
                      <c:pt idx="209">
                        <c:v>491</c:v>
                      </c:pt>
                      <c:pt idx="210">
                        <c:v>490</c:v>
                      </c:pt>
                      <c:pt idx="211">
                        <c:v>489</c:v>
                      </c:pt>
                      <c:pt idx="212">
                        <c:v>488</c:v>
                      </c:pt>
                      <c:pt idx="213">
                        <c:v>487</c:v>
                      </c:pt>
                      <c:pt idx="214">
                        <c:v>486</c:v>
                      </c:pt>
                      <c:pt idx="215">
                        <c:v>485</c:v>
                      </c:pt>
                      <c:pt idx="216">
                        <c:v>484</c:v>
                      </c:pt>
                      <c:pt idx="217">
                        <c:v>483</c:v>
                      </c:pt>
                      <c:pt idx="218">
                        <c:v>482</c:v>
                      </c:pt>
                      <c:pt idx="219">
                        <c:v>481</c:v>
                      </c:pt>
                      <c:pt idx="220">
                        <c:v>480</c:v>
                      </c:pt>
                      <c:pt idx="221">
                        <c:v>479</c:v>
                      </c:pt>
                      <c:pt idx="222">
                        <c:v>478</c:v>
                      </c:pt>
                      <c:pt idx="223">
                        <c:v>477</c:v>
                      </c:pt>
                      <c:pt idx="224">
                        <c:v>476</c:v>
                      </c:pt>
                      <c:pt idx="225">
                        <c:v>475</c:v>
                      </c:pt>
                      <c:pt idx="226">
                        <c:v>474</c:v>
                      </c:pt>
                      <c:pt idx="227">
                        <c:v>473</c:v>
                      </c:pt>
                      <c:pt idx="228">
                        <c:v>472</c:v>
                      </c:pt>
                      <c:pt idx="229">
                        <c:v>471</c:v>
                      </c:pt>
                      <c:pt idx="230">
                        <c:v>470</c:v>
                      </c:pt>
                      <c:pt idx="231">
                        <c:v>469</c:v>
                      </c:pt>
                      <c:pt idx="232">
                        <c:v>468</c:v>
                      </c:pt>
                      <c:pt idx="233">
                        <c:v>467</c:v>
                      </c:pt>
                      <c:pt idx="234">
                        <c:v>466</c:v>
                      </c:pt>
                      <c:pt idx="235">
                        <c:v>465</c:v>
                      </c:pt>
                      <c:pt idx="236">
                        <c:v>464</c:v>
                      </c:pt>
                      <c:pt idx="237">
                        <c:v>463</c:v>
                      </c:pt>
                      <c:pt idx="238">
                        <c:v>462</c:v>
                      </c:pt>
                      <c:pt idx="239">
                        <c:v>461</c:v>
                      </c:pt>
                      <c:pt idx="240">
                        <c:v>460</c:v>
                      </c:pt>
                      <c:pt idx="241">
                        <c:v>459</c:v>
                      </c:pt>
                      <c:pt idx="242">
                        <c:v>458</c:v>
                      </c:pt>
                      <c:pt idx="243">
                        <c:v>457</c:v>
                      </c:pt>
                      <c:pt idx="244">
                        <c:v>456</c:v>
                      </c:pt>
                      <c:pt idx="245">
                        <c:v>455</c:v>
                      </c:pt>
                      <c:pt idx="246">
                        <c:v>454</c:v>
                      </c:pt>
                      <c:pt idx="247">
                        <c:v>453</c:v>
                      </c:pt>
                      <c:pt idx="248">
                        <c:v>452</c:v>
                      </c:pt>
                      <c:pt idx="249">
                        <c:v>451</c:v>
                      </c:pt>
                      <c:pt idx="250">
                        <c:v>450</c:v>
                      </c:pt>
                      <c:pt idx="251">
                        <c:v>449</c:v>
                      </c:pt>
                      <c:pt idx="252">
                        <c:v>448</c:v>
                      </c:pt>
                      <c:pt idx="253">
                        <c:v>447</c:v>
                      </c:pt>
                      <c:pt idx="254">
                        <c:v>446</c:v>
                      </c:pt>
                      <c:pt idx="255">
                        <c:v>445</c:v>
                      </c:pt>
                      <c:pt idx="256">
                        <c:v>444</c:v>
                      </c:pt>
                      <c:pt idx="257">
                        <c:v>443</c:v>
                      </c:pt>
                      <c:pt idx="258">
                        <c:v>442</c:v>
                      </c:pt>
                      <c:pt idx="259">
                        <c:v>441</c:v>
                      </c:pt>
                      <c:pt idx="260">
                        <c:v>440</c:v>
                      </c:pt>
                      <c:pt idx="261">
                        <c:v>439</c:v>
                      </c:pt>
                      <c:pt idx="262">
                        <c:v>438</c:v>
                      </c:pt>
                      <c:pt idx="263">
                        <c:v>437</c:v>
                      </c:pt>
                      <c:pt idx="264">
                        <c:v>436</c:v>
                      </c:pt>
                      <c:pt idx="265">
                        <c:v>435</c:v>
                      </c:pt>
                      <c:pt idx="266">
                        <c:v>434</c:v>
                      </c:pt>
                      <c:pt idx="267">
                        <c:v>433</c:v>
                      </c:pt>
                      <c:pt idx="268">
                        <c:v>432</c:v>
                      </c:pt>
                      <c:pt idx="269">
                        <c:v>431</c:v>
                      </c:pt>
                      <c:pt idx="270">
                        <c:v>430</c:v>
                      </c:pt>
                      <c:pt idx="271">
                        <c:v>429</c:v>
                      </c:pt>
                      <c:pt idx="272">
                        <c:v>428</c:v>
                      </c:pt>
                      <c:pt idx="273">
                        <c:v>427</c:v>
                      </c:pt>
                      <c:pt idx="274">
                        <c:v>426</c:v>
                      </c:pt>
                      <c:pt idx="275">
                        <c:v>425</c:v>
                      </c:pt>
                      <c:pt idx="276">
                        <c:v>424</c:v>
                      </c:pt>
                      <c:pt idx="277">
                        <c:v>423</c:v>
                      </c:pt>
                      <c:pt idx="278">
                        <c:v>422</c:v>
                      </c:pt>
                      <c:pt idx="279">
                        <c:v>421</c:v>
                      </c:pt>
                      <c:pt idx="280">
                        <c:v>420</c:v>
                      </c:pt>
                      <c:pt idx="281">
                        <c:v>419</c:v>
                      </c:pt>
                      <c:pt idx="282">
                        <c:v>418</c:v>
                      </c:pt>
                      <c:pt idx="283">
                        <c:v>417</c:v>
                      </c:pt>
                      <c:pt idx="284">
                        <c:v>416</c:v>
                      </c:pt>
                      <c:pt idx="285">
                        <c:v>415</c:v>
                      </c:pt>
                      <c:pt idx="286">
                        <c:v>414</c:v>
                      </c:pt>
                      <c:pt idx="287">
                        <c:v>413</c:v>
                      </c:pt>
                      <c:pt idx="288">
                        <c:v>412</c:v>
                      </c:pt>
                      <c:pt idx="289">
                        <c:v>411</c:v>
                      </c:pt>
                      <c:pt idx="290">
                        <c:v>410</c:v>
                      </c:pt>
                      <c:pt idx="291">
                        <c:v>409</c:v>
                      </c:pt>
                      <c:pt idx="292">
                        <c:v>408</c:v>
                      </c:pt>
                      <c:pt idx="293">
                        <c:v>407</c:v>
                      </c:pt>
                      <c:pt idx="294">
                        <c:v>406</c:v>
                      </c:pt>
                      <c:pt idx="295">
                        <c:v>405</c:v>
                      </c:pt>
                      <c:pt idx="296">
                        <c:v>404</c:v>
                      </c:pt>
                      <c:pt idx="297">
                        <c:v>403</c:v>
                      </c:pt>
                      <c:pt idx="298">
                        <c:v>402</c:v>
                      </c:pt>
                      <c:pt idx="299">
                        <c:v>401</c:v>
                      </c:pt>
                      <c:pt idx="300">
                        <c:v>400</c:v>
                      </c:pt>
                      <c:pt idx="301">
                        <c:v>399</c:v>
                      </c:pt>
                      <c:pt idx="302">
                        <c:v>398</c:v>
                      </c:pt>
                      <c:pt idx="303">
                        <c:v>397</c:v>
                      </c:pt>
                      <c:pt idx="304">
                        <c:v>396</c:v>
                      </c:pt>
                      <c:pt idx="305">
                        <c:v>395</c:v>
                      </c:pt>
                      <c:pt idx="306">
                        <c:v>394</c:v>
                      </c:pt>
                      <c:pt idx="307">
                        <c:v>393</c:v>
                      </c:pt>
                      <c:pt idx="308">
                        <c:v>392</c:v>
                      </c:pt>
                      <c:pt idx="309">
                        <c:v>391</c:v>
                      </c:pt>
                      <c:pt idx="310">
                        <c:v>390</c:v>
                      </c:pt>
                      <c:pt idx="311">
                        <c:v>389</c:v>
                      </c:pt>
                      <c:pt idx="312">
                        <c:v>388</c:v>
                      </c:pt>
                      <c:pt idx="313">
                        <c:v>387</c:v>
                      </c:pt>
                      <c:pt idx="314">
                        <c:v>386</c:v>
                      </c:pt>
                      <c:pt idx="315">
                        <c:v>385</c:v>
                      </c:pt>
                      <c:pt idx="316">
                        <c:v>384</c:v>
                      </c:pt>
                      <c:pt idx="317">
                        <c:v>383</c:v>
                      </c:pt>
                      <c:pt idx="318">
                        <c:v>382</c:v>
                      </c:pt>
                      <c:pt idx="319">
                        <c:v>381</c:v>
                      </c:pt>
                      <c:pt idx="320">
                        <c:v>380</c:v>
                      </c:pt>
                      <c:pt idx="321">
                        <c:v>379</c:v>
                      </c:pt>
                      <c:pt idx="322">
                        <c:v>378</c:v>
                      </c:pt>
                      <c:pt idx="323">
                        <c:v>377</c:v>
                      </c:pt>
                      <c:pt idx="324">
                        <c:v>376</c:v>
                      </c:pt>
                      <c:pt idx="325">
                        <c:v>375</c:v>
                      </c:pt>
                      <c:pt idx="326">
                        <c:v>374</c:v>
                      </c:pt>
                      <c:pt idx="327">
                        <c:v>373</c:v>
                      </c:pt>
                      <c:pt idx="328">
                        <c:v>372</c:v>
                      </c:pt>
                      <c:pt idx="329">
                        <c:v>371</c:v>
                      </c:pt>
                      <c:pt idx="330">
                        <c:v>370</c:v>
                      </c:pt>
                      <c:pt idx="331">
                        <c:v>369</c:v>
                      </c:pt>
                      <c:pt idx="332">
                        <c:v>368</c:v>
                      </c:pt>
                      <c:pt idx="333">
                        <c:v>367</c:v>
                      </c:pt>
                      <c:pt idx="334">
                        <c:v>366</c:v>
                      </c:pt>
                      <c:pt idx="335">
                        <c:v>365</c:v>
                      </c:pt>
                      <c:pt idx="336">
                        <c:v>364</c:v>
                      </c:pt>
                      <c:pt idx="337">
                        <c:v>363</c:v>
                      </c:pt>
                      <c:pt idx="338">
                        <c:v>362</c:v>
                      </c:pt>
                      <c:pt idx="339">
                        <c:v>361</c:v>
                      </c:pt>
                      <c:pt idx="340">
                        <c:v>360</c:v>
                      </c:pt>
                      <c:pt idx="341">
                        <c:v>359</c:v>
                      </c:pt>
                      <c:pt idx="342">
                        <c:v>358</c:v>
                      </c:pt>
                      <c:pt idx="343">
                        <c:v>357</c:v>
                      </c:pt>
                      <c:pt idx="344">
                        <c:v>356</c:v>
                      </c:pt>
                      <c:pt idx="345">
                        <c:v>355</c:v>
                      </c:pt>
                      <c:pt idx="346">
                        <c:v>354</c:v>
                      </c:pt>
                      <c:pt idx="347">
                        <c:v>353</c:v>
                      </c:pt>
                      <c:pt idx="348">
                        <c:v>352</c:v>
                      </c:pt>
                      <c:pt idx="349">
                        <c:v>351</c:v>
                      </c:pt>
                      <c:pt idx="350">
                        <c:v>350</c:v>
                      </c:pt>
                      <c:pt idx="351">
                        <c:v>349</c:v>
                      </c:pt>
                      <c:pt idx="352">
                        <c:v>348</c:v>
                      </c:pt>
                      <c:pt idx="353">
                        <c:v>347</c:v>
                      </c:pt>
                      <c:pt idx="354">
                        <c:v>346</c:v>
                      </c:pt>
                      <c:pt idx="355">
                        <c:v>345</c:v>
                      </c:pt>
                      <c:pt idx="356">
                        <c:v>344</c:v>
                      </c:pt>
                      <c:pt idx="357">
                        <c:v>343</c:v>
                      </c:pt>
                      <c:pt idx="358">
                        <c:v>342</c:v>
                      </c:pt>
                      <c:pt idx="359">
                        <c:v>341</c:v>
                      </c:pt>
                      <c:pt idx="360">
                        <c:v>340</c:v>
                      </c:pt>
                      <c:pt idx="361">
                        <c:v>339</c:v>
                      </c:pt>
                      <c:pt idx="362">
                        <c:v>338</c:v>
                      </c:pt>
                      <c:pt idx="363">
                        <c:v>337</c:v>
                      </c:pt>
                      <c:pt idx="364">
                        <c:v>336</c:v>
                      </c:pt>
                      <c:pt idx="365">
                        <c:v>335</c:v>
                      </c:pt>
                      <c:pt idx="366">
                        <c:v>334</c:v>
                      </c:pt>
                      <c:pt idx="367">
                        <c:v>333</c:v>
                      </c:pt>
                      <c:pt idx="368">
                        <c:v>332</c:v>
                      </c:pt>
                      <c:pt idx="369">
                        <c:v>331</c:v>
                      </c:pt>
                      <c:pt idx="370">
                        <c:v>330</c:v>
                      </c:pt>
                      <c:pt idx="371">
                        <c:v>329</c:v>
                      </c:pt>
                      <c:pt idx="372">
                        <c:v>328</c:v>
                      </c:pt>
                      <c:pt idx="373">
                        <c:v>327</c:v>
                      </c:pt>
                      <c:pt idx="374">
                        <c:v>326</c:v>
                      </c:pt>
                      <c:pt idx="375">
                        <c:v>325</c:v>
                      </c:pt>
                      <c:pt idx="376">
                        <c:v>324</c:v>
                      </c:pt>
                      <c:pt idx="377">
                        <c:v>323</c:v>
                      </c:pt>
                      <c:pt idx="378">
                        <c:v>322</c:v>
                      </c:pt>
                      <c:pt idx="379">
                        <c:v>321</c:v>
                      </c:pt>
                      <c:pt idx="380">
                        <c:v>320</c:v>
                      </c:pt>
                      <c:pt idx="381">
                        <c:v>319</c:v>
                      </c:pt>
                      <c:pt idx="382">
                        <c:v>318</c:v>
                      </c:pt>
                      <c:pt idx="383">
                        <c:v>317</c:v>
                      </c:pt>
                      <c:pt idx="384">
                        <c:v>316</c:v>
                      </c:pt>
                      <c:pt idx="385">
                        <c:v>315</c:v>
                      </c:pt>
                      <c:pt idx="386">
                        <c:v>314</c:v>
                      </c:pt>
                      <c:pt idx="387">
                        <c:v>313</c:v>
                      </c:pt>
                      <c:pt idx="388">
                        <c:v>312</c:v>
                      </c:pt>
                      <c:pt idx="389">
                        <c:v>311</c:v>
                      </c:pt>
                      <c:pt idx="390">
                        <c:v>310</c:v>
                      </c:pt>
                      <c:pt idx="391">
                        <c:v>309</c:v>
                      </c:pt>
                      <c:pt idx="392">
                        <c:v>308</c:v>
                      </c:pt>
                      <c:pt idx="393">
                        <c:v>307</c:v>
                      </c:pt>
                      <c:pt idx="394">
                        <c:v>306</c:v>
                      </c:pt>
                      <c:pt idx="395">
                        <c:v>305</c:v>
                      </c:pt>
                      <c:pt idx="396">
                        <c:v>304</c:v>
                      </c:pt>
                      <c:pt idx="397">
                        <c:v>303</c:v>
                      </c:pt>
                      <c:pt idx="398">
                        <c:v>302</c:v>
                      </c:pt>
                      <c:pt idx="399">
                        <c:v>301</c:v>
                      </c:pt>
                      <c:pt idx="400">
                        <c:v>300</c:v>
                      </c:pt>
                      <c:pt idx="401">
                        <c:v>299</c:v>
                      </c:pt>
                      <c:pt idx="402">
                        <c:v>298</c:v>
                      </c:pt>
                      <c:pt idx="403">
                        <c:v>297</c:v>
                      </c:pt>
                      <c:pt idx="404">
                        <c:v>296</c:v>
                      </c:pt>
                      <c:pt idx="405">
                        <c:v>295</c:v>
                      </c:pt>
                      <c:pt idx="406">
                        <c:v>294</c:v>
                      </c:pt>
                      <c:pt idx="407">
                        <c:v>293</c:v>
                      </c:pt>
                      <c:pt idx="408">
                        <c:v>292</c:v>
                      </c:pt>
                      <c:pt idx="409">
                        <c:v>291</c:v>
                      </c:pt>
                      <c:pt idx="410">
                        <c:v>290</c:v>
                      </c:pt>
                      <c:pt idx="411">
                        <c:v>289</c:v>
                      </c:pt>
                      <c:pt idx="412">
                        <c:v>288</c:v>
                      </c:pt>
                      <c:pt idx="413">
                        <c:v>287</c:v>
                      </c:pt>
                      <c:pt idx="414">
                        <c:v>286</c:v>
                      </c:pt>
                      <c:pt idx="415">
                        <c:v>285</c:v>
                      </c:pt>
                      <c:pt idx="416">
                        <c:v>284</c:v>
                      </c:pt>
                      <c:pt idx="417">
                        <c:v>283</c:v>
                      </c:pt>
                      <c:pt idx="418">
                        <c:v>282</c:v>
                      </c:pt>
                      <c:pt idx="419">
                        <c:v>281</c:v>
                      </c:pt>
                      <c:pt idx="420">
                        <c:v>280</c:v>
                      </c:pt>
                      <c:pt idx="421">
                        <c:v>279</c:v>
                      </c:pt>
                      <c:pt idx="422">
                        <c:v>278</c:v>
                      </c:pt>
                      <c:pt idx="423">
                        <c:v>277</c:v>
                      </c:pt>
                      <c:pt idx="424">
                        <c:v>276</c:v>
                      </c:pt>
                      <c:pt idx="425">
                        <c:v>275</c:v>
                      </c:pt>
                      <c:pt idx="426">
                        <c:v>274</c:v>
                      </c:pt>
                      <c:pt idx="427">
                        <c:v>273</c:v>
                      </c:pt>
                      <c:pt idx="428">
                        <c:v>272</c:v>
                      </c:pt>
                      <c:pt idx="429">
                        <c:v>271</c:v>
                      </c:pt>
                      <c:pt idx="430">
                        <c:v>270</c:v>
                      </c:pt>
                      <c:pt idx="431">
                        <c:v>269</c:v>
                      </c:pt>
                      <c:pt idx="432">
                        <c:v>268</c:v>
                      </c:pt>
                      <c:pt idx="433">
                        <c:v>267</c:v>
                      </c:pt>
                      <c:pt idx="434">
                        <c:v>266</c:v>
                      </c:pt>
                      <c:pt idx="435">
                        <c:v>265</c:v>
                      </c:pt>
                      <c:pt idx="436">
                        <c:v>264</c:v>
                      </c:pt>
                      <c:pt idx="437">
                        <c:v>263</c:v>
                      </c:pt>
                      <c:pt idx="438">
                        <c:v>262</c:v>
                      </c:pt>
                      <c:pt idx="439">
                        <c:v>261</c:v>
                      </c:pt>
                      <c:pt idx="440">
                        <c:v>260</c:v>
                      </c:pt>
                      <c:pt idx="441">
                        <c:v>259</c:v>
                      </c:pt>
                      <c:pt idx="442">
                        <c:v>258</c:v>
                      </c:pt>
                      <c:pt idx="443">
                        <c:v>257</c:v>
                      </c:pt>
                      <c:pt idx="444">
                        <c:v>256</c:v>
                      </c:pt>
                      <c:pt idx="445">
                        <c:v>255</c:v>
                      </c:pt>
                      <c:pt idx="446">
                        <c:v>254</c:v>
                      </c:pt>
                      <c:pt idx="447">
                        <c:v>253</c:v>
                      </c:pt>
                      <c:pt idx="448">
                        <c:v>252</c:v>
                      </c:pt>
                      <c:pt idx="449">
                        <c:v>251</c:v>
                      </c:pt>
                      <c:pt idx="450">
                        <c:v>250</c:v>
                      </c:pt>
                      <c:pt idx="451">
                        <c:v>249</c:v>
                      </c:pt>
                      <c:pt idx="452">
                        <c:v>248</c:v>
                      </c:pt>
                      <c:pt idx="453">
                        <c:v>247</c:v>
                      </c:pt>
                      <c:pt idx="454">
                        <c:v>246</c:v>
                      </c:pt>
                      <c:pt idx="455">
                        <c:v>245</c:v>
                      </c:pt>
                      <c:pt idx="456">
                        <c:v>244</c:v>
                      </c:pt>
                      <c:pt idx="457">
                        <c:v>243</c:v>
                      </c:pt>
                      <c:pt idx="458">
                        <c:v>242</c:v>
                      </c:pt>
                      <c:pt idx="459">
                        <c:v>241</c:v>
                      </c:pt>
                      <c:pt idx="460">
                        <c:v>240</c:v>
                      </c:pt>
                      <c:pt idx="461">
                        <c:v>239</c:v>
                      </c:pt>
                      <c:pt idx="462">
                        <c:v>238</c:v>
                      </c:pt>
                      <c:pt idx="463">
                        <c:v>237</c:v>
                      </c:pt>
                      <c:pt idx="464">
                        <c:v>236</c:v>
                      </c:pt>
                      <c:pt idx="465">
                        <c:v>235</c:v>
                      </c:pt>
                      <c:pt idx="466">
                        <c:v>234</c:v>
                      </c:pt>
                      <c:pt idx="467">
                        <c:v>233</c:v>
                      </c:pt>
                      <c:pt idx="468">
                        <c:v>232</c:v>
                      </c:pt>
                      <c:pt idx="469">
                        <c:v>231</c:v>
                      </c:pt>
                      <c:pt idx="470">
                        <c:v>230</c:v>
                      </c:pt>
                      <c:pt idx="471">
                        <c:v>229</c:v>
                      </c:pt>
                      <c:pt idx="472">
                        <c:v>228</c:v>
                      </c:pt>
                      <c:pt idx="473">
                        <c:v>227</c:v>
                      </c:pt>
                      <c:pt idx="474">
                        <c:v>226</c:v>
                      </c:pt>
                      <c:pt idx="475">
                        <c:v>225</c:v>
                      </c:pt>
                      <c:pt idx="476">
                        <c:v>224</c:v>
                      </c:pt>
                      <c:pt idx="477">
                        <c:v>223</c:v>
                      </c:pt>
                      <c:pt idx="478">
                        <c:v>222</c:v>
                      </c:pt>
                      <c:pt idx="479">
                        <c:v>221</c:v>
                      </c:pt>
                      <c:pt idx="480">
                        <c:v>220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文章选用!$D$2:$D$482</c15:sqref>
                        </c15:formulaRef>
                      </c:ext>
                    </c:extLst>
                    <c:numCache>
                      <c:formatCode>General</c:formatCode>
                      <c:ptCount val="481"/>
                      <c:pt idx="0">
                        <c:v>0</c:v>
                      </c:pt>
                      <c:pt idx="1">
                        <c:v>0</c:v>
                      </c:pt>
                      <c:pt idx="2">
                        <c:v>0</c:v>
                      </c:pt>
                      <c:pt idx="3">
                        <c:v>0</c:v>
                      </c:pt>
                      <c:pt idx="4">
                        <c:v>0</c:v>
                      </c:pt>
                      <c:pt idx="5">
                        <c:v>0</c:v>
                      </c:pt>
                      <c:pt idx="6">
                        <c:v>0</c:v>
                      </c:pt>
                      <c:pt idx="7">
                        <c:v>0</c:v>
                      </c:pt>
                      <c:pt idx="8">
                        <c:v>0</c:v>
                      </c:pt>
                      <c:pt idx="9">
                        <c:v>0</c:v>
                      </c:pt>
                      <c:pt idx="10">
                        <c:v>0</c:v>
                      </c:pt>
                      <c:pt idx="11">
                        <c:v>0</c:v>
                      </c:pt>
                      <c:pt idx="12">
                        <c:v>0</c:v>
                      </c:pt>
                      <c:pt idx="13">
                        <c:v>0</c:v>
                      </c:pt>
                      <c:pt idx="14">
                        <c:v>0</c:v>
                      </c:pt>
                      <c:pt idx="15">
                        <c:v>0</c:v>
                      </c:pt>
                      <c:pt idx="16">
                        <c:v>0</c:v>
                      </c:pt>
                      <c:pt idx="17">
                        <c:v>0</c:v>
                      </c:pt>
                      <c:pt idx="18">
                        <c:v>0</c:v>
                      </c:pt>
                      <c:pt idx="19">
                        <c:v>0</c:v>
                      </c:pt>
                      <c:pt idx="20">
                        <c:v>0</c:v>
                      </c:pt>
                      <c:pt idx="21">
                        <c:v>0</c:v>
                      </c:pt>
                      <c:pt idx="22">
                        <c:v>0</c:v>
                      </c:pt>
                      <c:pt idx="23">
                        <c:v>0</c:v>
                      </c:pt>
                      <c:pt idx="24">
                        <c:v>0</c:v>
                      </c:pt>
                      <c:pt idx="25">
                        <c:v>0</c:v>
                      </c:pt>
                      <c:pt idx="26">
                        <c:v>1E-3</c:v>
                      </c:pt>
                      <c:pt idx="27">
                        <c:v>1E-3</c:v>
                      </c:pt>
                      <c:pt idx="28">
                        <c:v>1E-3</c:v>
                      </c:pt>
                      <c:pt idx="29">
                        <c:v>1E-3</c:v>
                      </c:pt>
                      <c:pt idx="30">
                        <c:v>1E-3</c:v>
                      </c:pt>
                      <c:pt idx="31">
                        <c:v>1E-3</c:v>
                      </c:pt>
                      <c:pt idx="32">
                        <c:v>1E-3</c:v>
                      </c:pt>
                      <c:pt idx="33">
                        <c:v>1E-3</c:v>
                      </c:pt>
                      <c:pt idx="34">
                        <c:v>1E-3</c:v>
                      </c:pt>
                      <c:pt idx="35">
                        <c:v>1E-3</c:v>
                      </c:pt>
                      <c:pt idx="36">
                        <c:v>1E-3</c:v>
                      </c:pt>
                      <c:pt idx="37">
                        <c:v>1E-3</c:v>
                      </c:pt>
                      <c:pt idx="38">
                        <c:v>1E-3</c:v>
                      </c:pt>
                      <c:pt idx="39">
                        <c:v>1E-3</c:v>
                      </c:pt>
                      <c:pt idx="40">
                        <c:v>1E-3</c:v>
                      </c:pt>
                      <c:pt idx="41">
                        <c:v>1E-3</c:v>
                      </c:pt>
                      <c:pt idx="42">
                        <c:v>2E-3</c:v>
                      </c:pt>
                      <c:pt idx="43">
                        <c:v>2E-3</c:v>
                      </c:pt>
                      <c:pt idx="44">
                        <c:v>2E-3</c:v>
                      </c:pt>
                      <c:pt idx="45">
                        <c:v>2E-3</c:v>
                      </c:pt>
                      <c:pt idx="46">
                        <c:v>2E-3</c:v>
                      </c:pt>
                      <c:pt idx="47">
                        <c:v>2E-3</c:v>
                      </c:pt>
                      <c:pt idx="48">
                        <c:v>2E-3</c:v>
                      </c:pt>
                      <c:pt idx="49">
                        <c:v>2E-3</c:v>
                      </c:pt>
                      <c:pt idx="50">
                        <c:v>2E-3</c:v>
                      </c:pt>
                      <c:pt idx="51">
                        <c:v>2E-3</c:v>
                      </c:pt>
                      <c:pt idx="52">
                        <c:v>2E-3</c:v>
                      </c:pt>
                      <c:pt idx="53">
                        <c:v>2E-3</c:v>
                      </c:pt>
                      <c:pt idx="54">
                        <c:v>2E-3</c:v>
                      </c:pt>
                      <c:pt idx="55">
                        <c:v>2E-3</c:v>
                      </c:pt>
                      <c:pt idx="56">
                        <c:v>2E-3</c:v>
                      </c:pt>
                      <c:pt idx="57">
                        <c:v>2E-3</c:v>
                      </c:pt>
                      <c:pt idx="58">
                        <c:v>2E-3</c:v>
                      </c:pt>
                      <c:pt idx="59">
                        <c:v>2E-3</c:v>
                      </c:pt>
                      <c:pt idx="60">
                        <c:v>2E-3</c:v>
                      </c:pt>
                      <c:pt idx="61">
                        <c:v>2E-3</c:v>
                      </c:pt>
                      <c:pt idx="62">
                        <c:v>2E-3</c:v>
                      </c:pt>
                      <c:pt idx="63">
                        <c:v>2E-3</c:v>
                      </c:pt>
                      <c:pt idx="64">
                        <c:v>2E-3</c:v>
                      </c:pt>
                      <c:pt idx="65">
                        <c:v>2E-3</c:v>
                      </c:pt>
                      <c:pt idx="66">
                        <c:v>2E-3</c:v>
                      </c:pt>
                      <c:pt idx="67">
                        <c:v>2E-3</c:v>
                      </c:pt>
                      <c:pt idx="68">
                        <c:v>2E-3</c:v>
                      </c:pt>
                      <c:pt idx="69">
                        <c:v>2E-3</c:v>
                      </c:pt>
                      <c:pt idx="70">
                        <c:v>2E-3</c:v>
                      </c:pt>
                      <c:pt idx="71">
                        <c:v>2E-3</c:v>
                      </c:pt>
                      <c:pt idx="72">
                        <c:v>2E-3</c:v>
                      </c:pt>
                      <c:pt idx="73">
                        <c:v>2E-3</c:v>
                      </c:pt>
                      <c:pt idx="74">
                        <c:v>2E-3</c:v>
                      </c:pt>
                      <c:pt idx="75">
                        <c:v>2E-3</c:v>
                      </c:pt>
                      <c:pt idx="76">
                        <c:v>2E-3</c:v>
                      </c:pt>
                      <c:pt idx="77">
                        <c:v>2E-3</c:v>
                      </c:pt>
                      <c:pt idx="78">
                        <c:v>2E-3</c:v>
                      </c:pt>
                      <c:pt idx="79">
                        <c:v>2E-3</c:v>
                      </c:pt>
                      <c:pt idx="80">
                        <c:v>2E-3</c:v>
                      </c:pt>
                      <c:pt idx="81">
                        <c:v>2E-3</c:v>
                      </c:pt>
                      <c:pt idx="82">
                        <c:v>2E-3</c:v>
                      </c:pt>
                      <c:pt idx="83">
                        <c:v>2E-3</c:v>
                      </c:pt>
                      <c:pt idx="84">
                        <c:v>2E-3</c:v>
                      </c:pt>
                      <c:pt idx="85">
                        <c:v>2E-3</c:v>
                      </c:pt>
                      <c:pt idx="86">
                        <c:v>2E-3</c:v>
                      </c:pt>
                      <c:pt idx="87">
                        <c:v>3.0000000000000001E-3</c:v>
                      </c:pt>
                      <c:pt idx="88">
                        <c:v>3.0000000000000001E-3</c:v>
                      </c:pt>
                      <c:pt idx="89">
                        <c:v>3.0000000000000001E-3</c:v>
                      </c:pt>
                      <c:pt idx="90">
                        <c:v>3.0000000000000001E-3</c:v>
                      </c:pt>
                      <c:pt idx="91">
                        <c:v>4.0000000000000001E-3</c:v>
                      </c:pt>
                      <c:pt idx="92">
                        <c:v>4.0000000000000001E-3</c:v>
                      </c:pt>
                      <c:pt idx="93">
                        <c:v>4.0000000000000001E-3</c:v>
                      </c:pt>
                      <c:pt idx="94">
                        <c:v>5.0000000000000001E-3</c:v>
                      </c:pt>
                      <c:pt idx="95">
                        <c:v>6.0000000000000001E-3</c:v>
                      </c:pt>
                      <c:pt idx="96">
                        <c:v>6.0000000000000001E-3</c:v>
                      </c:pt>
                      <c:pt idx="97">
                        <c:v>7.0000000000000001E-3</c:v>
                      </c:pt>
                      <c:pt idx="98">
                        <c:v>8.0000000000000002E-3</c:v>
                      </c:pt>
                      <c:pt idx="99">
                        <c:v>8.9999999999999993E-3</c:v>
                      </c:pt>
                      <c:pt idx="100">
                        <c:v>1.0999999999999999E-2</c:v>
                      </c:pt>
                      <c:pt idx="101">
                        <c:v>1.2999999999999999E-2</c:v>
                      </c:pt>
                      <c:pt idx="102">
                        <c:v>1.4999999999999999E-2</c:v>
                      </c:pt>
                      <c:pt idx="103">
                        <c:v>1.7999999999999999E-2</c:v>
                      </c:pt>
                      <c:pt idx="104">
                        <c:v>2.1000000000000001E-2</c:v>
                      </c:pt>
                      <c:pt idx="105">
                        <c:v>2.5000000000000001E-2</c:v>
                      </c:pt>
                      <c:pt idx="106">
                        <c:v>2.9000000000000001E-2</c:v>
                      </c:pt>
                      <c:pt idx="107">
                        <c:v>3.5000000000000003E-2</c:v>
                      </c:pt>
                      <c:pt idx="108">
                        <c:v>4.1000000000000002E-2</c:v>
                      </c:pt>
                      <c:pt idx="109">
                        <c:v>4.9000000000000002E-2</c:v>
                      </c:pt>
                      <c:pt idx="110">
                        <c:v>5.8000000000000003E-2</c:v>
                      </c:pt>
                      <c:pt idx="111">
                        <c:v>6.9000000000000006E-2</c:v>
                      </c:pt>
                      <c:pt idx="112">
                        <c:v>8.3000000000000004E-2</c:v>
                      </c:pt>
                      <c:pt idx="113">
                        <c:v>9.8000000000000004E-2</c:v>
                      </c:pt>
                      <c:pt idx="114">
                        <c:v>0.11600000000000001</c:v>
                      </c:pt>
                      <c:pt idx="115">
                        <c:v>0.13700000000000001</c:v>
                      </c:pt>
                      <c:pt idx="116">
                        <c:v>0.159</c:v>
                      </c:pt>
                      <c:pt idx="117">
                        <c:v>0.184</c:v>
                      </c:pt>
                      <c:pt idx="118">
                        <c:v>0.20899999999999999</c:v>
                      </c:pt>
                      <c:pt idx="119">
                        <c:v>0.23599999999999999</c:v>
                      </c:pt>
                      <c:pt idx="120">
                        <c:v>0.26300000000000001</c:v>
                      </c:pt>
                      <c:pt idx="121">
                        <c:v>0.29099999999999998</c:v>
                      </c:pt>
                      <c:pt idx="122">
                        <c:v>0.317</c:v>
                      </c:pt>
                      <c:pt idx="123">
                        <c:v>0.34300000000000003</c:v>
                      </c:pt>
                      <c:pt idx="124">
                        <c:v>0.36699999999999999</c:v>
                      </c:pt>
                      <c:pt idx="125">
                        <c:v>0.39100000000000001</c:v>
                      </c:pt>
                      <c:pt idx="126">
                        <c:v>0.41199999999999998</c:v>
                      </c:pt>
                      <c:pt idx="127">
                        <c:v>0.432</c:v>
                      </c:pt>
                      <c:pt idx="128">
                        <c:v>0.44900000000000001</c:v>
                      </c:pt>
                      <c:pt idx="129">
                        <c:v>0.46500000000000002</c:v>
                      </c:pt>
                      <c:pt idx="130">
                        <c:v>0.48</c:v>
                      </c:pt>
                      <c:pt idx="131">
                        <c:v>0.49299999999999999</c:v>
                      </c:pt>
                      <c:pt idx="132">
                        <c:v>0.505</c:v>
                      </c:pt>
                      <c:pt idx="133">
                        <c:v>0.51600000000000001</c:v>
                      </c:pt>
                      <c:pt idx="134">
                        <c:v>0.52500000000000002</c:v>
                      </c:pt>
                      <c:pt idx="135">
                        <c:v>0.53300000000000003</c:v>
                      </c:pt>
                      <c:pt idx="136">
                        <c:v>0.54100000000000004</c:v>
                      </c:pt>
                      <c:pt idx="137">
                        <c:v>0.54600000000000004</c:v>
                      </c:pt>
                      <c:pt idx="138">
                        <c:v>0.55100000000000005</c:v>
                      </c:pt>
                      <c:pt idx="139">
                        <c:v>0.55400000000000005</c:v>
                      </c:pt>
                      <c:pt idx="140">
                        <c:v>0.55600000000000005</c:v>
                      </c:pt>
                      <c:pt idx="141">
                        <c:v>0.55600000000000005</c:v>
                      </c:pt>
                      <c:pt idx="142">
                        <c:v>0.55500000000000005</c:v>
                      </c:pt>
                      <c:pt idx="143">
                        <c:v>0.55300000000000005</c:v>
                      </c:pt>
                      <c:pt idx="144">
                        <c:v>0.54900000000000004</c:v>
                      </c:pt>
                      <c:pt idx="145">
                        <c:v>0.54500000000000004</c:v>
                      </c:pt>
                      <c:pt idx="146">
                        <c:v>0.53900000000000003</c:v>
                      </c:pt>
                      <c:pt idx="147">
                        <c:v>0.53200000000000003</c:v>
                      </c:pt>
                      <c:pt idx="148">
                        <c:v>0.52500000000000002</c:v>
                      </c:pt>
                      <c:pt idx="149">
                        <c:v>0.51600000000000001</c:v>
                      </c:pt>
                      <c:pt idx="150">
                        <c:v>0.50700000000000001</c:v>
                      </c:pt>
                      <c:pt idx="151">
                        <c:v>0.498</c:v>
                      </c:pt>
                      <c:pt idx="152">
                        <c:v>0.48899999999999999</c:v>
                      </c:pt>
                      <c:pt idx="153">
                        <c:v>0.48</c:v>
                      </c:pt>
                      <c:pt idx="154">
                        <c:v>0.47099999999999997</c:v>
                      </c:pt>
                      <c:pt idx="155">
                        <c:v>0.46300000000000002</c:v>
                      </c:pt>
                      <c:pt idx="156">
                        <c:v>0.45600000000000002</c:v>
                      </c:pt>
                      <c:pt idx="157">
                        <c:v>0.45</c:v>
                      </c:pt>
                      <c:pt idx="158">
                        <c:v>0.44400000000000001</c:v>
                      </c:pt>
                      <c:pt idx="159">
                        <c:v>0.44</c:v>
                      </c:pt>
                      <c:pt idx="160">
                        <c:v>0.436</c:v>
                      </c:pt>
                      <c:pt idx="161">
                        <c:v>0.434</c:v>
                      </c:pt>
                      <c:pt idx="162">
                        <c:v>0.434</c:v>
                      </c:pt>
                      <c:pt idx="163">
                        <c:v>0.434</c:v>
                      </c:pt>
                      <c:pt idx="164">
                        <c:v>0.436</c:v>
                      </c:pt>
                      <c:pt idx="165">
                        <c:v>0.439</c:v>
                      </c:pt>
                      <c:pt idx="166">
                        <c:v>0.443</c:v>
                      </c:pt>
                      <c:pt idx="167">
                        <c:v>0.44700000000000001</c:v>
                      </c:pt>
                      <c:pt idx="168">
                        <c:v>0.45200000000000001</c:v>
                      </c:pt>
                      <c:pt idx="169">
                        <c:v>0.45800000000000002</c:v>
                      </c:pt>
                      <c:pt idx="170">
                        <c:v>0.46400000000000002</c:v>
                      </c:pt>
                      <c:pt idx="171">
                        <c:v>0.47</c:v>
                      </c:pt>
                      <c:pt idx="172">
                        <c:v>0.47599999999999998</c:v>
                      </c:pt>
                      <c:pt idx="173">
                        <c:v>0.48199999999999998</c:v>
                      </c:pt>
                      <c:pt idx="174">
                        <c:v>0.48699999999999999</c:v>
                      </c:pt>
                      <c:pt idx="175">
                        <c:v>0.49199999999999999</c:v>
                      </c:pt>
                      <c:pt idx="176">
                        <c:v>0.496</c:v>
                      </c:pt>
                      <c:pt idx="177">
                        <c:v>0.499</c:v>
                      </c:pt>
                      <c:pt idx="178">
                        <c:v>0.502</c:v>
                      </c:pt>
                      <c:pt idx="179">
                        <c:v>0.503</c:v>
                      </c:pt>
                      <c:pt idx="180">
                        <c:v>0.503</c:v>
                      </c:pt>
                      <c:pt idx="181">
                        <c:v>0.502</c:v>
                      </c:pt>
                      <c:pt idx="182">
                        <c:v>0.499</c:v>
                      </c:pt>
                      <c:pt idx="183">
                        <c:v>0.496</c:v>
                      </c:pt>
                      <c:pt idx="184">
                        <c:v>0.49099999999999999</c:v>
                      </c:pt>
                      <c:pt idx="185">
                        <c:v>0.48599999999999999</c:v>
                      </c:pt>
                      <c:pt idx="186">
                        <c:v>0.47899999999999998</c:v>
                      </c:pt>
                      <c:pt idx="187">
                        <c:v>0.47099999999999997</c:v>
                      </c:pt>
                      <c:pt idx="188">
                        <c:v>0.46200000000000002</c:v>
                      </c:pt>
                      <c:pt idx="189">
                        <c:v>0.45200000000000001</c:v>
                      </c:pt>
                      <c:pt idx="190">
                        <c:v>0.442</c:v>
                      </c:pt>
                      <c:pt idx="191">
                        <c:v>0.43099999999999999</c:v>
                      </c:pt>
                      <c:pt idx="192">
                        <c:v>0.42</c:v>
                      </c:pt>
                      <c:pt idx="193">
                        <c:v>0.40799999999999997</c:v>
                      </c:pt>
                      <c:pt idx="194">
                        <c:v>0.39700000000000002</c:v>
                      </c:pt>
                      <c:pt idx="195">
                        <c:v>0.38500000000000001</c:v>
                      </c:pt>
                      <c:pt idx="196">
                        <c:v>0.373</c:v>
                      </c:pt>
                      <c:pt idx="197">
                        <c:v>0.36199999999999999</c:v>
                      </c:pt>
                      <c:pt idx="198">
                        <c:v>0.35</c:v>
                      </c:pt>
                      <c:pt idx="199">
                        <c:v>0.33900000000000002</c:v>
                      </c:pt>
                      <c:pt idx="200">
                        <c:v>0.32800000000000001</c:v>
                      </c:pt>
                      <c:pt idx="201">
                        <c:v>0.318</c:v>
                      </c:pt>
                      <c:pt idx="202">
                        <c:v>0.308</c:v>
                      </c:pt>
                      <c:pt idx="203">
                        <c:v>0.29899999999999999</c:v>
                      </c:pt>
                      <c:pt idx="204">
                        <c:v>0.28999999999999998</c:v>
                      </c:pt>
                      <c:pt idx="205">
                        <c:v>0.28199999999999997</c:v>
                      </c:pt>
                      <c:pt idx="206">
                        <c:v>0.27400000000000002</c:v>
                      </c:pt>
                      <c:pt idx="207">
                        <c:v>0.26700000000000002</c:v>
                      </c:pt>
                      <c:pt idx="208">
                        <c:v>0.25900000000000001</c:v>
                      </c:pt>
                      <c:pt idx="209">
                        <c:v>0.252</c:v>
                      </c:pt>
                      <c:pt idx="210">
                        <c:v>0.24399999999999999</c:v>
                      </c:pt>
                      <c:pt idx="211">
                        <c:v>0.23699999999999999</c:v>
                      </c:pt>
                      <c:pt idx="212">
                        <c:v>0.22900000000000001</c:v>
                      </c:pt>
                      <c:pt idx="213">
                        <c:v>0.222</c:v>
                      </c:pt>
                      <c:pt idx="214">
                        <c:v>0.215</c:v>
                      </c:pt>
                      <c:pt idx="215">
                        <c:v>0.20699999999999999</c:v>
                      </c:pt>
                      <c:pt idx="216">
                        <c:v>0.2</c:v>
                      </c:pt>
                      <c:pt idx="217">
                        <c:v>0.192</c:v>
                      </c:pt>
                      <c:pt idx="218">
                        <c:v>0.184</c:v>
                      </c:pt>
                      <c:pt idx="219">
                        <c:v>0.17699999999999999</c:v>
                      </c:pt>
                      <c:pt idx="220">
                        <c:v>0.16900000000000001</c:v>
                      </c:pt>
                      <c:pt idx="221">
                        <c:v>0.161</c:v>
                      </c:pt>
                      <c:pt idx="222">
                        <c:v>0.153</c:v>
                      </c:pt>
                      <c:pt idx="223">
                        <c:v>0.14599999999999999</c:v>
                      </c:pt>
                      <c:pt idx="224">
                        <c:v>0.13800000000000001</c:v>
                      </c:pt>
                      <c:pt idx="225">
                        <c:v>0.13100000000000001</c:v>
                      </c:pt>
                      <c:pt idx="226">
                        <c:v>0.124</c:v>
                      </c:pt>
                      <c:pt idx="227">
                        <c:v>0.11799999999999999</c:v>
                      </c:pt>
                      <c:pt idx="228">
                        <c:v>0.112</c:v>
                      </c:pt>
                      <c:pt idx="229">
                        <c:v>0.106</c:v>
                      </c:pt>
                      <c:pt idx="230">
                        <c:v>0.1</c:v>
                      </c:pt>
                      <c:pt idx="231">
                        <c:v>9.5000000000000001E-2</c:v>
                      </c:pt>
                      <c:pt idx="232">
                        <c:v>0.09</c:v>
                      </c:pt>
                      <c:pt idx="233">
                        <c:v>8.5000000000000006E-2</c:v>
                      </c:pt>
                      <c:pt idx="234">
                        <c:v>8.1000000000000003E-2</c:v>
                      </c:pt>
                      <c:pt idx="235">
                        <c:v>7.5999999999999998E-2</c:v>
                      </c:pt>
                      <c:pt idx="236">
                        <c:v>7.1999999999999995E-2</c:v>
                      </c:pt>
                      <c:pt idx="237">
                        <c:v>6.9000000000000006E-2</c:v>
                      </c:pt>
                      <c:pt idx="238">
                        <c:v>6.5000000000000002E-2</c:v>
                      </c:pt>
                      <c:pt idx="239">
                        <c:v>6.2E-2</c:v>
                      </c:pt>
                      <c:pt idx="240">
                        <c:v>5.8999999999999997E-2</c:v>
                      </c:pt>
                      <c:pt idx="241">
                        <c:v>5.6000000000000001E-2</c:v>
                      </c:pt>
                      <c:pt idx="242">
                        <c:v>5.3999999999999999E-2</c:v>
                      </c:pt>
                      <c:pt idx="243">
                        <c:v>5.0999999999999997E-2</c:v>
                      </c:pt>
                      <c:pt idx="244">
                        <c:v>4.9000000000000002E-2</c:v>
                      </c:pt>
                      <c:pt idx="245">
                        <c:v>4.5999999999999999E-2</c:v>
                      </c:pt>
                      <c:pt idx="246">
                        <c:v>4.3999999999999997E-2</c:v>
                      </c:pt>
                      <c:pt idx="247">
                        <c:v>4.2000000000000003E-2</c:v>
                      </c:pt>
                      <c:pt idx="248">
                        <c:v>3.9E-2</c:v>
                      </c:pt>
                      <c:pt idx="249">
                        <c:v>3.6999999999999998E-2</c:v>
                      </c:pt>
                      <c:pt idx="250">
                        <c:v>3.5999999999999997E-2</c:v>
                      </c:pt>
                      <c:pt idx="251">
                        <c:v>3.4000000000000002E-2</c:v>
                      </c:pt>
                      <c:pt idx="252">
                        <c:v>3.2000000000000001E-2</c:v>
                      </c:pt>
                      <c:pt idx="253">
                        <c:v>3.1E-2</c:v>
                      </c:pt>
                      <c:pt idx="254">
                        <c:v>2.9000000000000001E-2</c:v>
                      </c:pt>
                      <c:pt idx="255">
                        <c:v>2.7E-2</c:v>
                      </c:pt>
                      <c:pt idx="256">
                        <c:v>2.5999999999999999E-2</c:v>
                      </c:pt>
                      <c:pt idx="257">
                        <c:v>2.5000000000000001E-2</c:v>
                      </c:pt>
                      <c:pt idx="258">
                        <c:v>2.3E-2</c:v>
                      </c:pt>
                      <c:pt idx="259">
                        <c:v>2.1999999999999999E-2</c:v>
                      </c:pt>
                      <c:pt idx="260">
                        <c:v>2.1000000000000001E-2</c:v>
                      </c:pt>
                      <c:pt idx="261">
                        <c:v>0.02</c:v>
                      </c:pt>
                      <c:pt idx="262">
                        <c:v>1.9E-2</c:v>
                      </c:pt>
                      <c:pt idx="263">
                        <c:v>1.7999999999999999E-2</c:v>
                      </c:pt>
                      <c:pt idx="264">
                        <c:v>1.7999999999999999E-2</c:v>
                      </c:pt>
                      <c:pt idx="265">
                        <c:v>1.7000000000000001E-2</c:v>
                      </c:pt>
                      <c:pt idx="266">
                        <c:v>1.6E-2</c:v>
                      </c:pt>
                      <c:pt idx="267">
                        <c:v>1.6E-2</c:v>
                      </c:pt>
                      <c:pt idx="268">
                        <c:v>1.4999999999999999E-2</c:v>
                      </c:pt>
                      <c:pt idx="269">
                        <c:v>1.4999999999999999E-2</c:v>
                      </c:pt>
                      <c:pt idx="270">
                        <c:v>1.4999999999999999E-2</c:v>
                      </c:pt>
                      <c:pt idx="271">
                        <c:v>1.4E-2</c:v>
                      </c:pt>
                      <c:pt idx="272">
                        <c:v>1.4E-2</c:v>
                      </c:pt>
                      <c:pt idx="273">
                        <c:v>1.4E-2</c:v>
                      </c:pt>
                      <c:pt idx="274">
                        <c:v>1.2999999999999999E-2</c:v>
                      </c:pt>
                      <c:pt idx="275">
                        <c:v>1.2999999999999999E-2</c:v>
                      </c:pt>
                      <c:pt idx="276">
                        <c:v>1.2999999999999999E-2</c:v>
                      </c:pt>
                      <c:pt idx="277">
                        <c:v>1.2999999999999999E-2</c:v>
                      </c:pt>
                      <c:pt idx="278">
                        <c:v>1.2999999999999999E-2</c:v>
                      </c:pt>
                      <c:pt idx="279">
                        <c:v>1.2999999999999999E-2</c:v>
                      </c:pt>
                      <c:pt idx="280">
                        <c:v>1.2999999999999999E-2</c:v>
                      </c:pt>
                      <c:pt idx="281">
                        <c:v>1.2999999999999999E-2</c:v>
                      </c:pt>
                      <c:pt idx="282">
                        <c:v>1.2999999999999999E-2</c:v>
                      </c:pt>
                      <c:pt idx="283">
                        <c:v>1.2999999999999999E-2</c:v>
                      </c:pt>
                      <c:pt idx="284">
                        <c:v>1.4E-2</c:v>
                      </c:pt>
                      <c:pt idx="285">
                        <c:v>1.4E-2</c:v>
                      </c:pt>
                      <c:pt idx="286">
                        <c:v>1.4E-2</c:v>
                      </c:pt>
                      <c:pt idx="287">
                        <c:v>1.4E-2</c:v>
                      </c:pt>
                      <c:pt idx="288">
                        <c:v>1.4999999999999999E-2</c:v>
                      </c:pt>
                      <c:pt idx="289">
                        <c:v>1.4999999999999999E-2</c:v>
                      </c:pt>
                      <c:pt idx="290">
                        <c:v>1.6E-2</c:v>
                      </c:pt>
                      <c:pt idx="291">
                        <c:v>1.6E-2</c:v>
                      </c:pt>
                      <c:pt idx="292">
                        <c:v>1.7000000000000001E-2</c:v>
                      </c:pt>
                      <c:pt idx="293">
                        <c:v>1.7000000000000001E-2</c:v>
                      </c:pt>
                      <c:pt idx="294">
                        <c:v>1.7999999999999999E-2</c:v>
                      </c:pt>
                      <c:pt idx="295">
                        <c:v>1.9E-2</c:v>
                      </c:pt>
                      <c:pt idx="296">
                        <c:v>0.02</c:v>
                      </c:pt>
                      <c:pt idx="297">
                        <c:v>2.1000000000000001E-2</c:v>
                      </c:pt>
                      <c:pt idx="298">
                        <c:v>2.1000000000000001E-2</c:v>
                      </c:pt>
                      <c:pt idx="299">
                        <c:v>2.1999999999999999E-2</c:v>
                      </c:pt>
                      <c:pt idx="300">
                        <c:v>2.3E-2</c:v>
                      </c:pt>
                      <c:pt idx="301">
                        <c:v>2.4E-2</c:v>
                      </c:pt>
                      <c:pt idx="302">
                        <c:v>2.5999999999999999E-2</c:v>
                      </c:pt>
                      <c:pt idx="303">
                        <c:v>2.7E-2</c:v>
                      </c:pt>
                      <c:pt idx="304">
                        <c:v>2.8000000000000001E-2</c:v>
                      </c:pt>
                      <c:pt idx="305">
                        <c:v>2.9000000000000001E-2</c:v>
                      </c:pt>
                      <c:pt idx="306">
                        <c:v>3.1E-2</c:v>
                      </c:pt>
                      <c:pt idx="307">
                        <c:v>3.2000000000000001E-2</c:v>
                      </c:pt>
                      <c:pt idx="308">
                        <c:v>3.4000000000000002E-2</c:v>
                      </c:pt>
                      <c:pt idx="309">
                        <c:v>3.5000000000000003E-2</c:v>
                      </c:pt>
                      <c:pt idx="310">
                        <c:v>3.6999999999999998E-2</c:v>
                      </c:pt>
                      <c:pt idx="311">
                        <c:v>3.9E-2</c:v>
                      </c:pt>
                      <c:pt idx="312">
                        <c:v>4.1000000000000002E-2</c:v>
                      </c:pt>
                      <c:pt idx="313">
                        <c:v>4.2999999999999997E-2</c:v>
                      </c:pt>
                      <c:pt idx="314">
                        <c:v>4.4999999999999998E-2</c:v>
                      </c:pt>
                      <c:pt idx="315">
                        <c:v>4.7E-2</c:v>
                      </c:pt>
                      <c:pt idx="316">
                        <c:v>4.9000000000000002E-2</c:v>
                      </c:pt>
                      <c:pt idx="317">
                        <c:v>5.0999999999999997E-2</c:v>
                      </c:pt>
                      <c:pt idx="318">
                        <c:v>5.3999999999999999E-2</c:v>
                      </c:pt>
                      <c:pt idx="319">
                        <c:v>5.6000000000000001E-2</c:v>
                      </c:pt>
                      <c:pt idx="320">
                        <c:v>5.8999999999999997E-2</c:v>
                      </c:pt>
                      <c:pt idx="321">
                        <c:v>6.0999999999999999E-2</c:v>
                      </c:pt>
                      <c:pt idx="322">
                        <c:v>6.4000000000000001E-2</c:v>
                      </c:pt>
                      <c:pt idx="323">
                        <c:v>6.7000000000000004E-2</c:v>
                      </c:pt>
                      <c:pt idx="324">
                        <c:v>7.0000000000000007E-2</c:v>
                      </c:pt>
                      <c:pt idx="325">
                        <c:v>7.2999999999999995E-2</c:v>
                      </c:pt>
                      <c:pt idx="326">
                        <c:v>7.5999999999999998E-2</c:v>
                      </c:pt>
                      <c:pt idx="327">
                        <c:v>0.08</c:v>
                      </c:pt>
                      <c:pt idx="328">
                        <c:v>8.3000000000000004E-2</c:v>
                      </c:pt>
                      <c:pt idx="329">
                        <c:v>8.6999999999999994E-2</c:v>
                      </c:pt>
                      <c:pt idx="330">
                        <c:v>9.0999999999999998E-2</c:v>
                      </c:pt>
                      <c:pt idx="331">
                        <c:v>9.5000000000000001E-2</c:v>
                      </c:pt>
                      <c:pt idx="332">
                        <c:v>9.9000000000000005E-2</c:v>
                      </c:pt>
                      <c:pt idx="333">
                        <c:v>0.10199999999999999</c:v>
                      </c:pt>
                      <c:pt idx="334">
                        <c:v>0.106</c:v>
                      </c:pt>
                      <c:pt idx="335">
                        <c:v>0.11</c:v>
                      </c:pt>
                      <c:pt idx="336">
                        <c:v>0.114</c:v>
                      </c:pt>
                      <c:pt idx="337">
                        <c:v>0.11799999999999999</c:v>
                      </c:pt>
                      <c:pt idx="338">
                        <c:v>0.122</c:v>
                      </c:pt>
                      <c:pt idx="339">
                        <c:v>0.126</c:v>
                      </c:pt>
                      <c:pt idx="340">
                        <c:v>0.13100000000000001</c:v>
                      </c:pt>
                      <c:pt idx="341">
                        <c:v>0.13600000000000001</c:v>
                      </c:pt>
                      <c:pt idx="342">
                        <c:v>0.14000000000000001</c:v>
                      </c:pt>
                      <c:pt idx="343">
                        <c:v>0.14499999999999999</c:v>
                      </c:pt>
                      <c:pt idx="344">
                        <c:v>0.15</c:v>
                      </c:pt>
                      <c:pt idx="345">
                        <c:v>0.155</c:v>
                      </c:pt>
                      <c:pt idx="346">
                        <c:v>0.16</c:v>
                      </c:pt>
                      <c:pt idx="347">
                        <c:v>0.16600000000000001</c:v>
                      </c:pt>
                      <c:pt idx="348">
                        <c:v>0.17100000000000001</c:v>
                      </c:pt>
                      <c:pt idx="349">
                        <c:v>0.17599999999999999</c:v>
                      </c:pt>
                      <c:pt idx="350">
                        <c:v>0.182</c:v>
                      </c:pt>
                      <c:pt idx="351">
                        <c:v>0.187</c:v>
                      </c:pt>
                      <c:pt idx="352">
                        <c:v>0.193</c:v>
                      </c:pt>
                      <c:pt idx="353">
                        <c:v>0.19800000000000001</c:v>
                      </c:pt>
                      <c:pt idx="354">
                        <c:v>0.20399999999999999</c:v>
                      </c:pt>
                      <c:pt idx="355">
                        <c:v>0.21</c:v>
                      </c:pt>
                      <c:pt idx="356">
                        <c:v>0.216</c:v>
                      </c:pt>
                      <c:pt idx="357">
                        <c:v>0.221</c:v>
                      </c:pt>
                      <c:pt idx="358">
                        <c:v>0.22700000000000001</c:v>
                      </c:pt>
                      <c:pt idx="359">
                        <c:v>0.23200000000000001</c:v>
                      </c:pt>
                      <c:pt idx="360">
                        <c:v>0.23799999999999999</c:v>
                      </c:pt>
                      <c:pt idx="361">
                        <c:v>0.24299999999999999</c:v>
                      </c:pt>
                      <c:pt idx="362">
                        <c:v>0.249</c:v>
                      </c:pt>
                      <c:pt idx="363">
                        <c:v>0.255</c:v>
                      </c:pt>
                      <c:pt idx="364">
                        <c:v>0.26100000000000001</c:v>
                      </c:pt>
                      <c:pt idx="365">
                        <c:v>0.26800000000000002</c:v>
                      </c:pt>
                      <c:pt idx="366">
                        <c:v>0.27500000000000002</c:v>
                      </c:pt>
                      <c:pt idx="367">
                        <c:v>0.28199999999999997</c:v>
                      </c:pt>
                      <c:pt idx="368">
                        <c:v>0.28899999999999998</c:v>
                      </c:pt>
                      <c:pt idx="369">
                        <c:v>0.29599999999999999</c:v>
                      </c:pt>
                      <c:pt idx="370">
                        <c:v>0.30299999999999999</c:v>
                      </c:pt>
                      <c:pt idx="371">
                        <c:v>0.31</c:v>
                      </c:pt>
                      <c:pt idx="372">
                        <c:v>0.318</c:v>
                      </c:pt>
                      <c:pt idx="373">
                        <c:v>0.32600000000000001</c:v>
                      </c:pt>
                      <c:pt idx="374">
                        <c:v>0.33400000000000002</c:v>
                      </c:pt>
                      <c:pt idx="375">
                        <c:v>0.34200000000000003</c:v>
                      </c:pt>
                      <c:pt idx="376">
                        <c:v>0.35</c:v>
                      </c:pt>
                      <c:pt idx="377">
                        <c:v>0.36</c:v>
                      </c:pt>
                      <c:pt idx="378">
                        <c:v>0.36899999999999999</c:v>
                      </c:pt>
                      <c:pt idx="379">
                        <c:v>0.378</c:v>
                      </c:pt>
                      <c:pt idx="380">
                        <c:v>0.38800000000000001</c:v>
                      </c:pt>
                      <c:pt idx="381">
                        <c:v>0.39800000000000002</c:v>
                      </c:pt>
                      <c:pt idx="382">
                        <c:v>0.40699999999999997</c:v>
                      </c:pt>
                      <c:pt idx="383">
                        <c:v>0.41699999999999998</c:v>
                      </c:pt>
                      <c:pt idx="384">
                        <c:v>0.42699999999999999</c:v>
                      </c:pt>
                      <c:pt idx="385">
                        <c:v>0.437</c:v>
                      </c:pt>
                      <c:pt idx="386">
                        <c:v>0.44800000000000001</c:v>
                      </c:pt>
                      <c:pt idx="387">
                        <c:v>0.45800000000000002</c:v>
                      </c:pt>
                      <c:pt idx="388">
                        <c:v>0.46899999999999997</c:v>
                      </c:pt>
                      <c:pt idx="389">
                        <c:v>0.48</c:v>
                      </c:pt>
                      <c:pt idx="390">
                        <c:v>0.49099999999999999</c:v>
                      </c:pt>
                      <c:pt idx="391">
                        <c:v>0.503</c:v>
                      </c:pt>
                      <c:pt idx="392">
                        <c:v>0.51400000000000001</c:v>
                      </c:pt>
                      <c:pt idx="393">
                        <c:v>0.52600000000000002</c:v>
                      </c:pt>
                      <c:pt idx="394">
                        <c:v>0.53800000000000003</c:v>
                      </c:pt>
                      <c:pt idx="395">
                        <c:v>0.55000000000000004</c:v>
                      </c:pt>
                      <c:pt idx="396">
                        <c:v>0.56200000000000006</c:v>
                      </c:pt>
                      <c:pt idx="397">
                        <c:v>0.57499999999999996</c:v>
                      </c:pt>
                      <c:pt idx="398">
                        <c:v>0.58799999999999997</c:v>
                      </c:pt>
                      <c:pt idx="399">
                        <c:v>0.60199999999999998</c:v>
                      </c:pt>
                      <c:pt idx="400">
                        <c:v>0.61699999999999999</c:v>
                      </c:pt>
                      <c:pt idx="401">
                        <c:v>0.63300000000000001</c:v>
                      </c:pt>
                      <c:pt idx="402">
                        <c:v>0.65</c:v>
                      </c:pt>
                      <c:pt idx="403">
                        <c:v>0.66800000000000004</c:v>
                      </c:pt>
                      <c:pt idx="404">
                        <c:v>0.68600000000000005</c:v>
                      </c:pt>
                      <c:pt idx="405">
                        <c:v>0.70399999999999996</c:v>
                      </c:pt>
                      <c:pt idx="406">
                        <c:v>0.72399999999999998</c:v>
                      </c:pt>
                      <c:pt idx="407">
                        <c:v>0.74299999999999999</c:v>
                      </c:pt>
                      <c:pt idx="408">
                        <c:v>0.76300000000000001</c:v>
                      </c:pt>
                      <c:pt idx="409">
                        <c:v>0.78300000000000003</c:v>
                      </c:pt>
                      <c:pt idx="410">
                        <c:v>0.80200000000000005</c:v>
                      </c:pt>
                      <c:pt idx="411">
                        <c:v>0.82299999999999995</c:v>
                      </c:pt>
                      <c:pt idx="412">
                        <c:v>0.84399999999999997</c:v>
                      </c:pt>
                      <c:pt idx="413">
                        <c:v>0.86599999999999999</c:v>
                      </c:pt>
                      <c:pt idx="414">
                        <c:v>0.88700000000000001</c:v>
                      </c:pt>
                      <c:pt idx="415">
                        <c:v>0.90800000000000003</c:v>
                      </c:pt>
                      <c:pt idx="416">
                        <c:v>0.92700000000000005</c:v>
                      </c:pt>
                      <c:pt idx="417">
                        <c:v>0.94399999999999995</c:v>
                      </c:pt>
                      <c:pt idx="418">
                        <c:v>0.96</c:v>
                      </c:pt>
                      <c:pt idx="419">
                        <c:v>0.97399999999999998</c:v>
                      </c:pt>
                      <c:pt idx="420">
                        <c:v>0.98599999999999999</c:v>
                      </c:pt>
                      <c:pt idx="421">
                        <c:v>0.996</c:v>
                      </c:pt>
                      <c:pt idx="422">
                        <c:v>1.004</c:v>
                      </c:pt>
                      <c:pt idx="423">
                        <c:v>1.0089999999999999</c:v>
                      </c:pt>
                      <c:pt idx="424">
                        <c:v>1.014</c:v>
                      </c:pt>
                      <c:pt idx="425">
                        <c:v>1.016</c:v>
                      </c:pt>
                      <c:pt idx="426">
                        <c:v>1.0169999999999999</c:v>
                      </c:pt>
                      <c:pt idx="427">
                        <c:v>1.016</c:v>
                      </c:pt>
                      <c:pt idx="428">
                        <c:v>1.014</c:v>
                      </c:pt>
                      <c:pt idx="429">
                        <c:v>1.0109999999999999</c:v>
                      </c:pt>
                      <c:pt idx="430">
                        <c:v>1.008</c:v>
                      </c:pt>
                      <c:pt idx="431">
                        <c:v>1.004</c:v>
                      </c:pt>
                      <c:pt idx="432">
                        <c:v>1</c:v>
                      </c:pt>
                      <c:pt idx="433">
                        <c:v>0.995</c:v>
                      </c:pt>
                      <c:pt idx="434">
                        <c:v>0.99099999999999999</c:v>
                      </c:pt>
                      <c:pt idx="435">
                        <c:v>0.98699999999999999</c:v>
                      </c:pt>
                      <c:pt idx="436">
                        <c:v>0.98299999999999998</c:v>
                      </c:pt>
                      <c:pt idx="437">
                        <c:v>0.97799999999999998</c:v>
                      </c:pt>
                      <c:pt idx="438">
                        <c:v>0.97299999999999998</c:v>
                      </c:pt>
                      <c:pt idx="439">
                        <c:v>0.96699999999999997</c:v>
                      </c:pt>
                      <c:pt idx="440">
                        <c:v>0.96199999999999997</c:v>
                      </c:pt>
                      <c:pt idx="441">
                        <c:v>0.95499999999999996</c:v>
                      </c:pt>
                      <c:pt idx="442">
                        <c:v>0.94799999999999995</c:v>
                      </c:pt>
                      <c:pt idx="443">
                        <c:v>0.93899999999999995</c:v>
                      </c:pt>
                      <c:pt idx="444">
                        <c:v>0.93</c:v>
                      </c:pt>
                      <c:pt idx="445">
                        <c:v>0.92</c:v>
                      </c:pt>
                      <c:pt idx="446">
                        <c:v>0.90900000000000003</c:v>
                      </c:pt>
                      <c:pt idx="447">
                        <c:v>0.89800000000000002</c:v>
                      </c:pt>
                      <c:pt idx="448">
                        <c:v>0.88500000000000001</c:v>
                      </c:pt>
                      <c:pt idx="449">
                        <c:v>0.872</c:v>
                      </c:pt>
                      <c:pt idx="450">
                        <c:v>0.85899999999999999</c:v>
                      </c:pt>
                      <c:pt idx="451">
                        <c:v>0.84599999999999997</c:v>
                      </c:pt>
                      <c:pt idx="452">
                        <c:v>0.83399999999999996</c:v>
                      </c:pt>
                      <c:pt idx="453">
                        <c:v>0.82399999999999995</c:v>
                      </c:pt>
                      <c:pt idx="454">
                        <c:v>0.81499999999999995</c:v>
                      </c:pt>
                      <c:pt idx="455">
                        <c:v>0.80700000000000005</c:v>
                      </c:pt>
                      <c:pt idx="456">
                        <c:v>0.80200000000000005</c:v>
                      </c:pt>
                      <c:pt idx="457">
                        <c:v>0.79800000000000004</c:v>
                      </c:pt>
                      <c:pt idx="458">
                        <c:v>0.79600000000000004</c:v>
                      </c:pt>
                      <c:pt idx="459">
                        <c:v>0.79700000000000004</c:v>
                      </c:pt>
                      <c:pt idx="460">
                        <c:v>0.79900000000000004</c:v>
                      </c:pt>
                      <c:pt idx="461">
                        <c:v>0.80400000000000005</c:v>
                      </c:pt>
                      <c:pt idx="462">
                        <c:v>0.81200000000000006</c:v>
                      </c:pt>
                      <c:pt idx="463">
                        <c:v>0.82199999999999995</c:v>
                      </c:pt>
                      <c:pt idx="464">
                        <c:v>0.83599999999999997</c:v>
                      </c:pt>
                      <c:pt idx="465">
                        <c:v>0.85399999999999998</c:v>
                      </c:pt>
                      <c:pt idx="466">
                        <c:v>0.878</c:v>
                      </c:pt>
                      <c:pt idx="467">
                        <c:v>0.90900000000000003</c:v>
                      </c:pt>
                      <c:pt idx="468">
                        <c:v>0.94799999999999995</c:v>
                      </c:pt>
                      <c:pt idx="469">
                        <c:v>0.997</c:v>
                      </c:pt>
                      <c:pt idx="470">
                        <c:v>1.0589999999999999</c:v>
                      </c:pt>
                      <c:pt idx="471">
                        <c:v>1.137</c:v>
                      </c:pt>
                      <c:pt idx="472">
                        <c:v>1.2350000000000001</c:v>
                      </c:pt>
                      <c:pt idx="473">
                        <c:v>1.3580000000000001</c:v>
                      </c:pt>
                      <c:pt idx="474">
                        <c:v>1.51</c:v>
                      </c:pt>
                      <c:pt idx="475">
                        <c:v>1.6919999999999999</c:v>
                      </c:pt>
                      <c:pt idx="476">
                        <c:v>1.9039999999999999</c:v>
                      </c:pt>
                      <c:pt idx="477">
                        <c:v>2.1379999999999999</c:v>
                      </c:pt>
                      <c:pt idx="478">
                        <c:v>2.3860000000000001</c:v>
                      </c:pt>
                      <c:pt idx="479">
                        <c:v>2.5960000000000001</c:v>
                      </c:pt>
                      <c:pt idx="480">
                        <c:v>2.782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3-484E-4AD9-A9AA-15FEB2A4FBA8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文章选用!$E$1</c15:sqref>
                        </c15:formulaRef>
                      </c:ext>
                    </c:extLst>
                    <c:strCache>
                      <c:ptCount val="1"/>
                      <c:pt idx="0">
                        <c:v>PNC</c:v>
                      </c:pt>
                    </c:strCache>
                  </c:strRef>
                </c:tx>
                <c:spPr>
                  <a:ln w="19050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none"/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文章选用!$A$2:$A$482</c15:sqref>
                        </c15:formulaRef>
                      </c:ext>
                    </c:extLst>
                    <c:numCache>
                      <c:formatCode>General</c:formatCode>
                      <c:ptCount val="481"/>
                      <c:pt idx="0">
                        <c:v>700</c:v>
                      </c:pt>
                      <c:pt idx="1">
                        <c:v>699</c:v>
                      </c:pt>
                      <c:pt idx="2">
                        <c:v>698</c:v>
                      </c:pt>
                      <c:pt idx="3">
                        <c:v>697</c:v>
                      </c:pt>
                      <c:pt idx="4">
                        <c:v>696</c:v>
                      </c:pt>
                      <c:pt idx="5">
                        <c:v>695</c:v>
                      </c:pt>
                      <c:pt idx="6">
                        <c:v>694</c:v>
                      </c:pt>
                      <c:pt idx="7">
                        <c:v>693</c:v>
                      </c:pt>
                      <c:pt idx="8">
                        <c:v>692</c:v>
                      </c:pt>
                      <c:pt idx="9">
                        <c:v>691</c:v>
                      </c:pt>
                      <c:pt idx="10">
                        <c:v>690</c:v>
                      </c:pt>
                      <c:pt idx="11">
                        <c:v>689</c:v>
                      </c:pt>
                      <c:pt idx="12">
                        <c:v>688</c:v>
                      </c:pt>
                      <c:pt idx="13">
                        <c:v>687</c:v>
                      </c:pt>
                      <c:pt idx="14">
                        <c:v>686</c:v>
                      </c:pt>
                      <c:pt idx="15">
                        <c:v>685</c:v>
                      </c:pt>
                      <c:pt idx="16">
                        <c:v>684</c:v>
                      </c:pt>
                      <c:pt idx="17">
                        <c:v>683</c:v>
                      </c:pt>
                      <c:pt idx="18">
                        <c:v>682</c:v>
                      </c:pt>
                      <c:pt idx="19">
                        <c:v>681</c:v>
                      </c:pt>
                      <c:pt idx="20">
                        <c:v>680</c:v>
                      </c:pt>
                      <c:pt idx="21">
                        <c:v>679</c:v>
                      </c:pt>
                      <c:pt idx="22">
                        <c:v>678</c:v>
                      </c:pt>
                      <c:pt idx="23">
                        <c:v>677</c:v>
                      </c:pt>
                      <c:pt idx="24">
                        <c:v>676</c:v>
                      </c:pt>
                      <c:pt idx="25">
                        <c:v>675</c:v>
                      </c:pt>
                      <c:pt idx="26">
                        <c:v>674</c:v>
                      </c:pt>
                      <c:pt idx="27">
                        <c:v>673</c:v>
                      </c:pt>
                      <c:pt idx="28">
                        <c:v>672</c:v>
                      </c:pt>
                      <c:pt idx="29">
                        <c:v>671</c:v>
                      </c:pt>
                      <c:pt idx="30">
                        <c:v>670</c:v>
                      </c:pt>
                      <c:pt idx="31">
                        <c:v>669</c:v>
                      </c:pt>
                      <c:pt idx="32">
                        <c:v>668</c:v>
                      </c:pt>
                      <c:pt idx="33">
                        <c:v>667</c:v>
                      </c:pt>
                      <c:pt idx="34">
                        <c:v>666</c:v>
                      </c:pt>
                      <c:pt idx="35">
                        <c:v>665</c:v>
                      </c:pt>
                      <c:pt idx="36">
                        <c:v>664</c:v>
                      </c:pt>
                      <c:pt idx="37">
                        <c:v>663</c:v>
                      </c:pt>
                      <c:pt idx="38">
                        <c:v>662</c:v>
                      </c:pt>
                      <c:pt idx="39">
                        <c:v>661</c:v>
                      </c:pt>
                      <c:pt idx="40">
                        <c:v>660</c:v>
                      </c:pt>
                      <c:pt idx="41">
                        <c:v>659</c:v>
                      </c:pt>
                      <c:pt idx="42">
                        <c:v>658</c:v>
                      </c:pt>
                      <c:pt idx="43">
                        <c:v>657</c:v>
                      </c:pt>
                      <c:pt idx="44">
                        <c:v>656</c:v>
                      </c:pt>
                      <c:pt idx="45">
                        <c:v>655</c:v>
                      </c:pt>
                      <c:pt idx="46">
                        <c:v>654</c:v>
                      </c:pt>
                      <c:pt idx="47">
                        <c:v>653</c:v>
                      </c:pt>
                      <c:pt idx="48">
                        <c:v>652</c:v>
                      </c:pt>
                      <c:pt idx="49">
                        <c:v>651</c:v>
                      </c:pt>
                      <c:pt idx="50">
                        <c:v>650</c:v>
                      </c:pt>
                      <c:pt idx="51">
                        <c:v>649</c:v>
                      </c:pt>
                      <c:pt idx="52">
                        <c:v>648</c:v>
                      </c:pt>
                      <c:pt idx="53">
                        <c:v>647</c:v>
                      </c:pt>
                      <c:pt idx="54">
                        <c:v>646</c:v>
                      </c:pt>
                      <c:pt idx="55">
                        <c:v>645</c:v>
                      </c:pt>
                      <c:pt idx="56">
                        <c:v>644</c:v>
                      </c:pt>
                      <c:pt idx="57">
                        <c:v>643</c:v>
                      </c:pt>
                      <c:pt idx="58">
                        <c:v>642</c:v>
                      </c:pt>
                      <c:pt idx="59">
                        <c:v>641</c:v>
                      </c:pt>
                      <c:pt idx="60">
                        <c:v>640</c:v>
                      </c:pt>
                      <c:pt idx="61">
                        <c:v>639</c:v>
                      </c:pt>
                      <c:pt idx="62">
                        <c:v>638</c:v>
                      </c:pt>
                      <c:pt idx="63">
                        <c:v>637</c:v>
                      </c:pt>
                      <c:pt idx="64">
                        <c:v>636</c:v>
                      </c:pt>
                      <c:pt idx="65">
                        <c:v>635</c:v>
                      </c:pt>
                      <c:pt idx="66">
                        <c:v>634</c:v>
                      </c:pt>
                      <c:pt idx="67">
                        <c:v>633</c:v>
                      </c:pt>
                      <c:pt idx="68">
                        <c:v>632</c:v>
                      </c:pt>
                      <c:pt idx="69">
                        <c:v>631</c:v>
                      </c:pt>
                      <c:pt idx="70">
                        <c:v>630</c:v>
                      </c:pt>
                      <c:pt idx="71">
                        <c:v>629</c:v>
                      </c:pt>
                      <c:pt idx="72">
                        <c:v>628</c:v>
                      </c:pt>
                      <c:pt idx="73">
                        <c:v>627</c:v>
                      </c:pt>
                      <c:pt idx="74">
                        <c:v>626</c:v>
                      </c:pt>
                      <c:pt idx="75">
                        <c:v>625</c:v>
                      </c:pt>
                      <c:pt idx="76">
                        <c:v>624</c:v>
                      </c:pt>
                      <c:pt idx="77">
                        <c:v>623</c:v>
                      </c:pt>
                      <c:pt idx="78">
                        <c:v>622</c:v>
                      </c:pt>
                      <c:pt idx="79">
                        <c:v>621</c:v>
                      </c:pt>
                      <c:pt idx="80">
                        <c:v>620</c:v>
                      </c:pt>
                      <c:pt idx="81">
                        <c:v>619</c:v>
                      </c:pt>
                      <c:pt idx="82">
                        <c:v>618</c:v>
                      </c:pt>
                      <c:pt idx="83">
                        <c:v>617</c:v>
                      </c:pt>
                      <c:pt idx="84">
                        <c:v>616</c:v>
                      </c:pt>
                      <c:pt idx="85">
                        <c:v>615</c:v>
                      </c:pt>
                      <c:pt idx="86">
                        <c:v>614</c:v>
                      </c:pt>
                      <c:pt idx="87">
                        <c:v>613</c:v>
                      </c:pt>
                      <c:pt idx="88">
                        <c:v>612</c:v>
                      </c:pt>
                      <c:pt idx="89">
                        <c:v>611</c:v>
                      </c:pt>
                      <c:pt idx="90">
                        <c:v>610</c:v>
                      </c:pt>
                      <c:pt idx="91">
                        <c:v>609</c:v>
                      </c:pt>
                      <c:pt idx="92">
                        <c:v>608</c:v>
                      </c:pt>
                      <c:pt idx="93">
                        <c:v>607</c:v>
                      </c:pt>
                      <c:pt idx="94">
                        <c:v>606</c:v>
                      </c:pt>
                      <c:pt idx="95">
                        <c:v>605</c:v>
                      </c:pt>
                      <c:pt idx="96">
                        <c:v>604</c:v>
                      </c:pt>
                      <c:pt idx="97">
                        <c:v>603</c:v>
                      </c:pt>
                      <c:pt idx="98">
                        <c:v>602</c:v>
                      </c:pt>
                      <c:pt idx="99">
                        <c:v>601</c:v>
                      </c:pt>
                      <c:pt idx="100">
                        <c:v>600</c:v>
                      </c:pt>
                      <c:pt idx="101">
                        <c:v>599</c:v>
                      </c:pt>
                      <c:pt idx="102">
                        <c:v>598</c:v>
                      </c:pt>
                      <c:pt idx="103">
                        <c:v>597</c:v>
                      </c:pt>
                      <c:pt idx="104">
                        <c:v>596</c:v>
                      </c:pt>
                      <c:pt idx="105">
                        <c:v>595</c:v>
                      </c:pt>
                      <c:pt idx="106">
                        <c:v>594</c:v>
                      </c:pt>
                      <c:pt idx="107">
                        <c:v>593</c:v>
                      </c:pt>
                      <c:pt idx="108">
                        <c:v>592</c:v>
                      </c:pt>
                      <c:pt idx="109">
                        <c:v>591</c:v>
                      </c:pt>
                      <c:pt idx="110">
                        <c:v>590</c:v>
                      </c:pt>
                      <c:pt idx="111">
                        <c:v>589</c:v>
                      </c:pt>
                      <c:pt idx="112">
                        <c:v>588</c:v>
                      </c:pt>
                      <c:pt idx="113">
                        <c:v>587</c:v>
                      </c:pt>
                      <c:pt idx="114">
                        <c:v>586</c:v>
                      </c:pt>
                      <c:pt idx="115">
                        <c:v>585</c:v>
                      </c:pt>
                      <c:pt idx="116">
                        <c:v>584</c:v>
                      </c:pt>
                      <c:pt idx="117">
                        <c:v>583</c:v>
                      </c:pt>
                      <c:pt idx="118">
                        <c:v>582</c:v>
                      </c:pt>
                      <c:pt idx="119">
                        <c:v>581</c:v>
                      </c:pt>
                      <c:pt idx="120">
                        <c:v>580</c:v>
                      </c:pt>
                      <c:pt idx="121">
                        <c:v>579</c:v>
                      </c:pt>
                      <c:pt idx="122">
                        <c:v>578</c:v>
                      </c:pt>
                      <c:pt idx="123">
                        <c:v>577</c:v>
                      </c:pt>
                      <c:pt idx="124">
                        <c:v>576</c:v>
                      </c:pt>
                      <c:pt idx="125">
                        <c:v>575</c:v>
                      </c:pt>
                      <c:pt idx="126">
                        <c:v>574</c:v>
                      </c:pt>
                      <c:pt idx="127">
                        <c:v>573</c:v>
                      </c:pt>
                      <c:pt idx="128">
                        <c:v>572</c:v>
                      </c:pt>
                      <c:pt idx="129">
                        <c:v>571</c:v>
                      </c:pt>
                      <c:pt idx="130">
                        <c:v>570</c:v>
                      </c:pt>
                      <c:pt idx="131">
                        <c:v>569</c:v>
                      </c:pt>
                      <c:pt idx="132">
                        <c:v>568</c:v>
                      </c:pt>
                      <c:pt idx="133">
                        <c:v>567</c:v>
                      </c:pt>
                      <c:pt idx="134">
                        <c:v>566</c:v>
                      </c:pt>
                      <c:pt idx="135">
                        <c:v>565</c:v>
                      </c:pt>
                      <c:pt idx="136">
                        <c:v>564</c:v>
                      </c:pt>
                      <c:pt idx="137">
                        <c:v>563</c:v>
                      </c:pt>
                      <c:pt idx="138">
                        <c:v>562</c:v>
                      </c:pt>
                      <c:pt idx="139">
                        <c:v>561</c:v>
                      </c:pt>
                      <c:pt idx="140">
                        <c:v>560</c:v>
                      </c:pt>
                      <c:pt idx="141">
                        <c:v>559</c:v>
                      </c:pt>
                      <c:pt idx="142">
                        <c:v>558</c:v>
                      </c:pt>
                      <c:pt idx="143">
                        <c:v>557</c:v>
                      </c:pt>
                      <c:pt idx="144">
                        <c:v>556</c:v>
                      </c:pt>
                      <c:pt idx="145">
                        <c:v>555</c:v>
                      </c:pt>
                      <c:pt idx="146">
                        <c:v>554</c:v>
                      </c:pt>
                      <c:pt idx="147">
                        <c:v>553</c:v>
                      </c:pt>
                      <c:pt idx="148">
                        <c:v>552</c:v>
                      </c:pt>
                      <c:pt idx="149">
                        <c:v>551</c:v>
                      </c:pt>
                      <c:pt idx="150">
                        <c:v>550</c:v>
                      </c:pt>
                      <c:pt idx="151">
                        <c:v>549</c:v>
                      </c:pt>
                      <c:pt idx="152">
                        <c:v>548</c:v>
                      </c:pt>
                      <c:pt idx="153">
                        <c:v>547</c:v>
                      </c:pt>
                      <c:pt idx="154">
                        <c:v>546</c:v>
                      </c:pt>
                      <c:pt idx="155">
                        <c:v>545</c:v>
                      </c:pt>
                      <c:pt idx="156">
                        <c:v>544</c:v>
                      </c:pt>
                      <c:pt idx="157">
                        <c:v>543</c:v>
                      </c:pt>
                      <c:pt idx="158">
                        <c:v>542</c:v>
                      </c:pt>
                      <c:pt idx="159">
                        <c:v>541</c:v>
                      </c:pt>
                      <c:pt idx="160">
                        <c:v>540</c:v>
                      </c:pt>
                      <c:pt idx="161">
                        <c:v>539</c:v>
                      </c:pt>
                      <c:pt idx="162">
                        <c:v>538</c:v>
                      </c:pt>
                      <c:pt idx="163">
                        <c:v>537</c:v>
                      </c:pt>
                      <c:pt idx="164">
                        <c:v>536</c:v>
                      </c:pt>
                      <c:pt idx="165">
                        <c:v>535</c:v>
                      </c:pt>
                      <c:pt idx="166">
                        <c:v>534</c:v>
                      </c:pt>
                      <c:pt idx="167">
                        <c:v>533</c:v>
                      </c:pt>
                      <c:pt idx="168">
                        <c:v>532</c:v>
                      </c:pt>
                      <c:pt idx="169">
                        <c:v>531</c:v>
                      </c:pt>
                      <c:pt idx="170">
                        <c:v>530</c:v>
                      </c:pt>
                      <c:pt idx="171">
                        <c:v>529</c:v>
                      </c:pt>
                      <c:pt idx="172">
                        <c:v>528</c:v>
                      </c:pt>
                      <c:pt idx="173">
                        <c:v>527</c:v>
                      </c:pt>
                      <c:pt idx="174">
                        <c:v>526</c:v>
                      </c:pt>
                      <c:pt idx="175">
                        <c:v>525</c:v>
                      </c:pt>
                      <c:pt idx="176">
                        <c:v>524</c:v>
                      </c:pt>
                      <c:pt idx="177">
                        <c:v>523</c:v>
                      </c:pt>
                      <c:pt idx="178">
                        <c:v>522</c:v>
                      </c:pt>
                      <c:pt idx="179">
                        <c:v>521</c:v>
                      </c:pt>
                      <c:pt idx="180">
                        <c:v>520</c:v>
                      </c:pt>
                      <c:pt idx="181">
                        <c:v>519</c:v>
                      </c:pt>
                      <c:pt idx="182">
                        <c:v>518</c:v>
                      </c:pt>
                      <c:pt idx="183">
                        <c:v>517</c:v>
                      </c:pt>
                      <c:pt idx="184">
                        <c:v>516</c:v>
                      </c:pt>
                      <c:pt idx="185">
                        <c:v>515</c:v>
                      </c:pt>
                      <c:pt idx="186">
                        <c:v>514</c:v>
                      </c:pt>
                      <c:pt idx="187">
                        <c:v>513</c:v>
                      </c:pt>
                      <c:pt idx="188">
                        <c:v>512</c:v>
                      </c:pt>
                      <c:pt idx="189">
                        <c:v>511</c:v>
                      </c:pt>
                      <c:pt idx="190">
                        <c:v>510</c:v>
                      </c:pt>
                      <c:pt idx="191">
                        <c:v>509</c:v>
                      </c:pt>
                      <c:pt idx="192">
                        <c:v>508</c:v>
                      </c:pt>
                      <c:pt idx="193">
                        <c:v>507</c:v>
                      </c:pt>
                      <c:pt idx="194">
                        <c:v>506</c:v>
                      </c:pt>
                      <c:pt idx="195">
                        <c:v>505</c:v>
                      </c:pt>
                      <c:pt idx="196">
                        <c:v>504</c:v>
                      </c:pt>
                      <c:pt idx="197">
                        <c:v>503</c:v>
                      </c:pt>
                      <c:pt idx="198">
                        <c:v>502</c:v>
                      </c:pt>
                      <c:pt idx="199">
                        <c:v>501</c:v>
                      </c:pt>
                      <c:pt idx="200">
                        <c:v>500</c:v>
                      </c:pt>
                      <c:pt idx="201">
                        <c:v>499</c:v>
                      </c:pt>
                      <c:pt idx="202">
                        <c:v>498</c:v>
                      </c:pt>
                      <c:pt idx="203">
                        <c:v>497</c:v>
                      </c:pt>
                      <c:pt idx="204">
                        <c:v>496</c:v>
                      </c:pt>
                      <c:pt idx="205">
                        <c:v>495</c:v>
                      </c:pt>
                      <c:pt idx="206">
                        <c:v>494</c:v>
                      </c:pt>
                      <c:pt idx="207">
                        <c:v>493</c:v>
                      </c:pt>
                      <c:pt idx="208">
                        <c:v>492</c:v>
                      </c:pt>
                      <c:pt idx="209">
                        <c:v>491</c:v>
                      </c:pt>
                      <c:pt idx="210">
                        <c:v>490</c:v>
                      </c:pt>
                      <c:pt idx="211">
                        <c:v>489</c:v>
                      </c:pt>
                      <c:pt idx="212">
                        <c:v>488</c:v>
                      </c:pt>
                      <c:pt idx="213">
                        <c:v>487</c:v>
                      </c:pt>
                      <c:pt idx="214">
                        <c:v>486</c:v>
                      </c:pt>
                      <c:pt idx="215">
                        <c:v>485</c:v>
                      </c:pt>
                      <c:pt idx="216">
                        <c:v>484</c:v>
                      </c:pt>
                      <c:pt idx="217">
                        <c:v>483</c:v>
                      </c:pt>
                      <c:pt idx="218">
                        <c:v>482</c:v>
                      </c:pt>
                      <c:pt idx="219">
                        <c:v>481</c:v>
                      </c:pt>
                      <c:pt idx="220">
                        <c:v>480</c:v>
                      </c:pt>
                      <c:pt idx="221">
                        <c:v>479</c:v>
                      </c:pt>
                      <c:pt idx="222">
                        <c:v>478</c:v>
                      </c:pt>
                      <c:pt idx="223">
                        <c:v>477</c:v>
                      </c:pt>
                      <c:pt idx="224">
                        <c:v>476</c:v>
                      </c:pt>
                      <c:pt idx="225">
                        <c:v>475</c:v>
                      </c:pt>
                      <c:pt idx="226">
                        <c:v>474</c:v>
                      </c:pt>
                      <c:pt idx="227">
                        <c:v>473</c:v>
                      </c:pt>
                      <c:pt idx="228">
                        <c:v>472</c:v>
                      </c:pt>
                      <c:pt idx="229">
                        <c:v>471</c:v>
                      </c:pt>
                      <c:pt idx="230">
                        <c:v>470</c:v>
                      </c:pt>
                      <c:pt idx="231">
                        <c:v>469</c:v>
                      </c:pt>
                      <c:pt idx="232">
                        <c:v>468</c:v>
                      </c:pt>
                      <c:pt idx="233">
                        <c:v>467</c:v>
                      </c:pt>
                      <c:pt idx="234">
                        <c:v>466</c:v>
                      </c:pt>
                      <c:pt idx="235">
                        <c:v>465</c:v>
                      </c:pt>
                      <c:pt idx="236">
                        <c:v>464</c:v>
                      </c:pt>
                      <c:pt idx="237">
                        <c:v>463</c:v>
                      </c:pt>
                      <c:pt idx="238">
                        <c:v>462</c:v>
                      </c:pt>
                      <c:pt idx="239">
                        <c:v>461</c:v>
                      </c:pt>
                      <c:pt idx="240">
                        <c:v>460</c:v>
                      </c:pt>
                      <c:pt idx="241">
                        <c:v>459</c:v>
                      </c:pt>
                      <c:pt idx="242">
                        <c:v>458</c:v>
                      </c:pt>
                      <c:pt idx="243">
                        <c:v>457</c:v>
                      </c:pt>
                      <c:pt idx="244">
                        <c:v>456</c:v>
                      </c:pt>
                      <c:pt idx="245">
                        <c:v>455</c:v>
                      </c:pt>
                      <c:pt idx="246">
                        <c:v>454</c:v>
                      </c:pt>
                      <c:pt idx="247">
                        <c:v>453</c:v>
                      </c:pt>
                      <c:pt idx="248">
                        <c:v>452</c:v>
                      </c:pt>
                      <c:pt idx="249">
                        <c:v>451</c:v>
                      </c:pt>
                      <c:pt idx="250">
                        <c:v>450</c:v>
                      </c:pt>
                      <c:pt idx="251">
                        <c:v>449</c:v>
                      </c:pt>
                      <c:pt idx="252">
                        <c:v>448</c:v>
                      </c:pt>
                      <c:pt idx="253">
                        <c:v>447</c:v>
                      </c:pt>
                      <c:pt idx="254">
                        <c:v>446</c:v>
                      </c:pt>
                      <c:pt idx="255">
                        <c:v>445</c:v>
                      </c:pt>
                      <c:pt idx="256">
                        <c:v>444</c:v>
                      </c:pt>
                      <c:pt idx="257">
                        <c:v>443</c:v>
                      </c:pt>
                      <c:pt idx="258">
                        <c:v>442</c:v>
                      </c:pt>
                      <c:pt idx="259">
                        <c:v>441</c:v>
                      </c:pt>
                      <c:pt idx="260">
                        <c:v>440</c:v>
                      </c:pt>
                      <c:pt idx="261">
                        <c:v>439</c:v>
                      </c:pt>
                      <c:pt idx="262">
                        <c:v>438</c:v>
                      </c:pt>
                      <c:pt idx="263">
                        <c:v>437</c:v>
                      </c:pt>
                      <c:pt idx="264">
                        <c:v>436</c:v>
                      </c:pt>
                      <c:pt idx="265">
                        <c:v>435</c:v>
                      </c:pt>
                      <c:pt idx="266">
                        <c:v>434</c:v>
                      </c:pt>
                      <c:pt idx="267">
                        <c:v>433</c:v>
                      </c:pt>
                      <c:pt idx="268">
                        <c:v>432</c:v>
                      </c:pt>
                      <c:pt idx="269">
                        <c:v>431</c:v>
                      </c:pt>
                      <c:pt idx="270">
                        <c:v>430</c:v>
                      </c:pt>
                      <c:pt idx="271">
                        <c:v>429</c:v>
                      </c:pt>
                      <c:pt idx="272">
                        <c:v>428</c:v>
                      </c:pt>
                      <c:pt idx="273">
                        <c:v>427</c:v>
                      </c:pt>
                      <c:pt idx="274">
                        <c:v>426</c:v>
                      </c:pt>
                      <c:pt idx="275">
                        <c:v>425</c:v>
                      </c:pt>
                      <c:pt idx="276">
                        <c:v>424</c:v>
                      </c:pt>
                      <c:pt idx="277">
                        <c:v>423</c:v>
                      </c:pt>
                      <c:pt idx="278">
                        <c:v>422</c:v>
                      </c:pt>
                      <c:pt idx="279">
                        <c:v>421</c:v>
                      </c:pt>
                      <c:pt idx="280">
                        <c:v>420</c:v>
                      </c:pt>
                      <c:pt idx="281">
                        <c:v>419</c:v>
                      </c:pt>
                      <c:pt idx="282">
                        <c:v>418</c:v>
                      </c:pt>
                      <c:pt idx="283">
                        <c:v>417</c:v>
                      </c:pt>
                      <c:pt idx="284">
                        <c:v>416</c:v>
                      </c:pt>
                      <c:pt idx="285">
                        <c:v>415</c:v>
                      </c:pt>
                      <c:pt idx="286">
                        <c:v>414</c:v>
                      </c:pt>
                      <c:pt idx="287">
                        <c:v>413</c:v>
                      </c:pt>
                      <c:pt idx="288">
                        <c:v>412</c:v>
                      </c:pt>
                      <c:pt idx="289">
                        <c:v>411</c:v>
                      </c:pt>
                      <c:pt idx="290">
                        <c:v>410</c:v>
                      </c:pt>
                      <c:pt idx="291">
                        <c:v>409</c:v>
                      </c:pt>
                      <c:pt idx="292">
                        <c:v>408</c:v>
                      </c:pt>
                      <c:pt idx="293">
                        <c:v>407</c:v>
                      </c:pt>
                      <c:pt idx="294">
                        <c:v>406</c:v>
                      </c:pt>
                      <c:pt idx="295">
                        <c:v>405</c:v>
                      </c:pt>
                      <c:pt idx="296">
                        <c:v>404</c:v>
                      </c:pt>
                      <c:pt idx="297">
                        <c:v>403</c:v>
                      </c:pt>
                      <c:pt idx="298">
                        <c:v>402</c:v>
                      </c:pt>
                      <c:pt idx="299">
                        <c:v>401</c:v>
                      </c:pt>
                      <c:pt idx="300">
                        <c:v>400</c:v>
                      </c:pt>
                      <c:pt idx="301">
                        <c:v>399</c:v>
                      </c:pt>
                      <c:pt idx="302">
                        <c:v>398</c:v>
                      </c:pt>
                      <c:pt idx="303">
                        <c:v>397</c:v>
                      </c:pt>
                      <c:pt idx="304">
                        <c:v>396</c:v>
                      </c:pt>
                      <c:pt idx="305">
                        <c:v>395</c:v>
                      </c:pt>
                      <c:pt idx="306">
                        <c:v>394</c:v>
                      </c:pt>
                      <c:pt idx="307">
                        <c:v>393</c:v>
                      </c:pt>
                      <c:pt idx="308">
                        <c:v>392</c:v>
                      </c:pt>
                      <c:pt idx="309">
                        <c:v>391</c:v>
                      </c:pt>
                      <c:pt idx="310">
                        <c:v>390</c:v>
                      </c:pt>
                      <c:pt idx="311">
                        <c:v>389</c:v>
                      </c:pt>
                      <c:pt idx="312">
                        <c:v>388</c:v>
                      </c:pt>
                      <c:pt idx="313">
                        <c:v>387</c:v>
                      </c:pt>
                      <c:pt idx="314">
                        <c:v>386</c:v>
                      </c:pt>
                      <c:pt idx="315">
                        <c:v>385</c:v>
                      </c:pt>
                      <c:pt idx="316">
                        <c:v>384</c:v>
                      </c:pt>
                      <c:pt idx="317">
                        <c:v>383</c:v>
                      </c:pt>
                      <c:pt idx="318">
                        <c:v>382</c:v>
                      </c:pt>
                      <c:pt idx="319">
                        <c:v>381</c:v>
                      </c:pt>
                      <c:pt idx="320">
                        <c:v>380</c:v>
                      </c:pt>
                      <c:pt idx="321">
                        <c:v>379</c:v>
                      </c:pt>
                      <c:pt idx="322">
                        <c:v>378</c:v>
                      </c:pt>
                      <c:pt idx="323">
                        <c:v>377</c:v>
                      </c:pt>
                      <c:pt idx="324">
                        <c:v>376</c:v>
                      </c:pt>
                      <c:pt idx="325">
                        <c:v>375</c:v>
                      </c:pt>
                      <c:pt idx="326">
                        <c:v>374</c:v>
                      </c:pt>
                      <c:pt idx="327">
                        <c:v>373</c:v>
                      </c:pt>
                      <c:pt idx="328">
                        <c:v>372</c:v>
                      </c:pt>
                      <c:pt idx="329">
                        <c:v>371</c:v>
                      </c:pt>
                      <c:pt idx="330">
                        <c:v>370</c:v>
                      </c:pt>
                      <c:pt idx="331">
                        <c:v>369</c:v>
                      </c:pt>
                      <c:pt idx="332">
                        <c:v>368</c:v>
                      </c:pt>
                      <c:pt idx="333">
                        <c:v>367</c:v>
                      </c:pt>
                      <c:pt idx="334">
                        <c:v>366</c:v>
                      </c:pt>
                      <c:pt idx="335">
                        <c:v>365</c:v>
                      </c:pt>
                      <c:pt idx="336">
                        <c:v>364</c:v>
                      </c:pt>
                      <c:pt idx="337">
                        <c:v>363</c:v>
                      </c:pt>
                      <c:pt idx="338">
                        <c:v>362</c:v>
                      </c:pt>
                      <c:pt idx="339">
                        <c:v>361</c:v>
                      </c:pt>
                      <c:pt idx="340">
                        <c:v>360</c:v>
                      </c:pt>
                      <c:pt idx="341">
                        <c:v>359</c:v>
                      </c:pt>
                      <c:pt idx="342">
                        <c:v>358</c:v>
                      </c:pt>
                      <c:pt idx="343">
                        <c:v>357</c:v>
                      </c:pt>
                      <c:pt idx="344">
                        <c:v>356</c:v>
                      </c:pt>
                      <c:pt idx="345">
                        <c:v>355</c:v>
                      </c:pt>
                      <c:pt idx="346">
                        <c:v>354</c:v>
                      </c:pt>
                      <c:pt idx="347">
                        <c:v>353</c:v>
                      </c:pt>
                      <c:pt idx="348">
                        <c:v>352</c:v>
                      </c:pt>
                      <c:pt idx="349">
                        <c:v>351</c:v>
                      </c:pt>
                      <c:pt idx="350">
                        <c:v>350</c:v>
                      </c:pt>
                      <c:pt idx="351">
                        <c:v>349</c:v>
                      </c:pt>
                      <c:pt idx="352">
                        <c:v>348</c:v>
                      </c:pt>
                      <c:pt idx="353">
                        <c:v>347</c:v>
                      </c:pt>
                      <c:pt idx="354">
                        <c:v>346</c:v>
                      </c:pt>
                      <c:pt idx="355">
                        <c:v>345</c:v>
                      </c:pt>
                      <c:pt idx="356">
                        <c:v>344</c:v>
                      </c:pt>
                      <c:pt idx="357">
                        <c:v>343</c:v>
                      </c:pt>
                      <c:pt idx="358">
                        <c:v>342</c:v>
                      </c:pt>
                      <c:pt idx="359">
                        <c:v>341</c:v>
                      </c:pt>
                      <c:pt idx="360">
                        <c:v>340</c:v>
                      </c:pt>
                      <c:pt idx="361">
                        <c:v>339</c:v>
                      </c:pt>
                      <c:pt idx="362">
                        <c:v>338</c:v>
                      </c:pt>
                      <c:pt idx="363">
                        <c:v>337</c:v>
                      </c:pt>
                      <c:pt idx="364">
                        <c:v>336</c:v>
                      </c:pt>
                      <c:pt idx="365">
                        <c:v>335</c:v>
                      </c:pt>
                      <c:pt idx="366">
                        <c:v>334</c:v>
                      </c:pt>
                      <c:pt idx="367">
                        <c:v>333</c:v>
                      </c:pt>
                      <c:pt idx="368">
                        <c:v>332</c:v>
                      </c:pt>
                      <c:pt idx="369">
                        <c:v>331</c:v>
                      </c:pt>
                      <c:pt idx="370">
                        <c:v>330</c:v>
                      </c:pt>
                      <c:pt idx="371">
                        <c:v>329</c:v>
                      </c:pt>
                      <c:pt idx="372">
                        <c:v>328</c:v>
                      </c:pt>
                      <c:pt idx="373">
                        <c:v>327</c:v>
                      </c:pt>
                      <c:pt idx="374">
                        <c:v>326</c:v>
                      </c:pt>
                      <c:pt idx="375">
                        <c:v>325</c:v>
                      </c:pt>
                      <c:pt idx="376">
                        <c:v>324</c:v>
                      </c:pt>
                      <c:pt idx="377">
                        <c:v>323</c:v>
                      </c:pt>
                      <c:pt idx="378">
                        <c:v>322</c:v>
                      </c:pt>
                      <c:pt idx="379">
                        <c:v>321</c:v>
                      </c:pt>
                      <c:pt idx="380">
                        <c:v>320</c:v>
                      </c:pt>
                      <c:pt idx="381">
                        <c:v>319</c:v>
                      </c:pt>
                      <c:pt idx="382">
                        <c:v>318</c:v>
                      </c:pt>
                      <c:pt idx="383">
                        <c:v>317</c:v>
                      </c:pt>
                      <c:pt idx="384">
                        <c:v>316</c:v>
                      </c:pt>
                      <c:pt idx="385">
                        <c:v>315</c:v>
                      </c:pt>
                      <c:pt idx="386">
                        <c:v>314</c:v>
                      </c:pt>
                      <c:pt idx="387">
                        <c:v>313</c:v>
                      </c:pt>
                      <c:pt idx="388">
                        <c:v>312</c:v>
                      </c:pt>
                      <c:pt idx="389">
                        <c:v>311</c:v>
                      </c:pt>
                      <c:pt idx="390">
                        <c:v>310</c:v>
                      </c:pt>
                      <c:pt idx="391">
                        <c:v>309</c:v>
                      </c:pt>
                      <c:pt idx="392">
                        <c:v>308</c:v>
                      </c:pt>
                      <c:pt idx="393">
                        <c:v>307</c:v>
                      </c:pt>
                      <c:pt idx="394">
                        <c:v>306</c:v>
                      </c:pt>
                      <c:pt idx="395">
                        <c:v>305</c:v>
                      </c:pt>
                      <c:pt idx="396">
                        <c:v>304</c:v>
                      </c:pt>
                      <c:pt idx="397">
                        <c:v>303</c:v>
                      </c:pt>
                      <c:pt idx="398">
                        <c:v>302</c:v>
                      </c:pt>
                      <c:pt idx="399">
                        <c:v>301</c:v>
                      </c:pt>
                      <c:pt idx="400">
                        <c:v>300</c:v>
                      </c:pt>
                      <c:pt idx="401">
                        <c:v>299</c:v>
                      </c:pt>
                      <c:pt idx="402">
                        <c:v>298</c:v>
                      </c:pt>
                      <c:pt idx="403">
                        <c:v>297</c:v>
                      </c:pt>
                      <c:pt idx="404">
                        <c:v>296</c:v>
                      </c:pt>
                      <c:pt idx="405">
                        <c:v>295</c:v>
                      </c:pt>
                      <c:pt idx="406">
                        <c:v>294</c:v>
                      </c:pt>
                      <c:pt idx="407">
                        <c:v>293</c:v>
                      </c:pt>
                      <c:pt idx="408">
                        <c:v>292</c:v>
                      </c:pt>
                      <c:pt idx="409">
                        <c:v>291</c:v>
                      </c:pt>
                      <c:pt idx="410">
                        <c:v>290</c:v>
                      </c:pt>
                      <c:pt idx="411">
                        <c:v>289</c:v>
                      </c:pt>
                      <c:pt idx="412">
                        <c:v>288</c:v>
                      </c:pt>
                      <c:pt idx="413">
                        <c:v>287</c:v>
                      </c:pt>
                      <c:pt idx="414">
                        <c:v>286</c:v>
                      </c:pt>
                      <c:pt idx="415">
                        <c:v>285</c:v>
                      </c:pt>
                      <c:pt idx="416">
                        <c:v>284</c:v>
                      </c:pt>
                      <c:pt idx="417">
                        <c:v>283</c:v>
                      </c:pt>
                      <c:pt idx="418">
                        <c:v>282</c:v>
                      </c:pt>
                      <c:pt idx="419">
                        <c:v>281</c:v>
                      </c:pt>
                      <c:pt idx="420">
                        <c:v>280</c:v>
                      </c:pt>
                      <c:pt idx="421">
                        <c:v>279</c:v>
                      </c:pt>
                      <c:pt idx="422">
                        <c:v>278</c:v>
                      </c:pt>
                      <c:pt idx="423">
                        <c:v>277</c:v>
                      </c:pt>
                      <c:pt idx="424">
                        <c:v>276</c:v>
                      </c:pt>
                      <c:pt idx="425">
                        <c:v>275</c:v>
                      </c:pt>
                      <c:pt idx="426">
                        <c:v>274</c:v>
                      </c:pt>
                      <c:pt idx="427">
                        <c:v>273</c:v>
                      </c:pt>
                      <c:pt idx="428">
                        <c:v>272</c:v>
                      </c:pt>
                      <c:pt idx="429">
                        <c:v>271</c:v>
                      </c:pt>
                      <c:pt idx="430">
                        <c:v>270</c:v>
                      </c:pt>
                      <c:pt idx="431">
                        <c:v>269</c:v>
                      </c:pt>
                      <c:pt idx="432">
                        <c:v>268</c:v>
                      </c:pt>
                      <c:pt idx="433">
                        <c:v>267</c:v>
                      </c:pt>
                      <c:pt idx="434">
                        <c:v>266</c:v>
                      </c:pt>
                      <c:pt idx="435">
                        <c:v>265</c:v>
                      </c:pt>
                      <c:pt idx="436">
                        <c:v>264</c:v>
                      </c:pt>
                      <c:pt idx="437">
                        <c:v>263</c:v>
                      </c:pt>
                      <c:pt idx="438">
                        <c:v>262</c:v>
                      </c:pt>
                      <c:pt idx="439">
                        <c:v>261</c:v>
                      </c:pt>
                      <c:pt idx="440">
                        <c:v>260</c:v>
                      </c:pt>
                      <c:pt idx="441">
                        <c:v>259</c:v>
                      </c:pt>
                      <c:pt idx="442">
                        <c:v>258</c:v>
                      </c:pt>
                      <c:pt idx="443">
                        <c:v>257</c:v>
                      </c:pt>
                      <c:pt idx="444">
                        <c:v>256</c:v>
                      </c:pt>
                      <c:pt idx="445">
                        <c:v>255</c:v>
                      </c:pt>
                      <c:pt idx="446">
                        <c:v>254</c:v>
                      </c:pt>
                      <c:pt idx="447">
                        <c:v>253</c:v>
                      </c:pt>
                      <c:pt idx="448">
                        <c:v>252</c:v>
                      </c:pt>
                      <c:pt idx="449">
                        <c:v>251</c:v>
                      </c:pt>
                      <c:pt idx="450">
                        <c:v>250</c:v>
                      </c:pt>
                      <c:pt idx="451">
                        <c:v>249</c:v>
                      </c:pt>
                      <c:pt idx="452">
                        <c:v>248</c:v>
                      </c:pt>
                      <c:pt idx="453">
                        <c:v>247</c:v>
                      </c:pt>
                      <c:pt idx="454">
                        <c:v>246</c:v>
                      </c:pt>
                      <c:pt idx="455">
                        <c:v>245</c:v>
                      </c:pt>
                      <c:pt idx="456">
                        <c:v>244</c:v>
                      </c:pt>
                      <c:pt idx="457">
                        <c:v>243</c:v>
                      </c:pt>
                      <c:pt idx="458">
                        <c:v>242</c:v>
                      </c:pt>
                      <c:pt idx="459">
                        <c:v>241</c:v>
                      </c:pt>
                      <c:pt idx="460">
                        <c:v>240</c:v>
                      </c:pt>
                      <c:pt idx="461">
                        <c:v>239</c:v>
                      </c:pt>
                      <c:pt idx="462">
                        <c:v>238</c:v>
                      </c:pt>
                      <c:pt idx="463">
                        <c:v>237</c:v>
                      </c:pt>
                      <c:pt idx="464">
                        <c:v>236</c:v>
                      </c:pt>
                      <c:pt idx="465">
                        <c:v>235</c:v>
                      </c:pt>
                      <c:pt idx="466">
                        <c:v>234</c:v>
                      </c:pt>
                      <c:pt idx="467">
                        <c:v>233</c:v>
                      </c:pt>
                      <c:pt idx="468">
                        <c:v>232</c:v>
                      </c:pt>
                      <c:pt idx="469">
                        <c:v>231</c:v>
                      </c:pt>
                      <c:pt idx="470">
                        <c:v>230</c:v>
                      </c:pt>
                      <c:pt idx="471">
                        <c:v>229</c:v>
                      </c:pt>
                      <c:pt idx="472">
                        <c:v>228</c:v>
                      </c:pt>
                      <c:pt idx="473">
                        <c:v>227</c:v>
                      </c:pt>
                      <c:pt idx="474">
                        <c:v>226</c:v>
                      </c:pt>
                      <c:pt idx="475">
                        <c:v>225</c:v>
                      </c:pt>
                      <c:pt idx="476">
                        <c:v>224</c:v>
                      </c:pt>
                      <c:pt idx="477">
                        <c:v>223</c:v>
                      </c:pt>
                      <c:pt idx="478">
                        <c:v>222</c:v>
                      </c:pt>
                      <c:pt idx="479">
                        <c:v>221</c:v>
                      </c:pt>
                      <c:pt idx="480">
                        <c:v>220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文章选用!$E$2:$E$482</c15:sqref>
                        </c15:formulaRef>
                      </c:ext>
                    </c:extLst>
                    <c:numCache>
                      <c:formatCode>General</c:formatCode>
                      <c:ptCount val="481"/>
                      <c:pt idx="0">
                        <c:v>-1E-3</c:v>
                      </c:pt>
                      <c:pt idx="1">
                        <c:v>-1E-3</c:v>
                      </c:pt>
                      <c:pt idx="2">
                        <c:v>-1E-3</c:v>
                      </c:pt>
                      <c:pt idx="3">
                        <c:v>-1E-3</c:v>
                      </c:pt>
                      <c:pt idx="4">
                        <c:v>-1E-3</c:v>
                      </c:pt>
                      <c:pt idx="5">
                        <c:v>-1E-3</c:v>
                      </c:pt>
                      <c:pt idx="6">
                        <c:v>-1E-3</c:v>
                      </c:pt>
                      <c:pt idx="7">
                        <c:v>-1E-3</c:v>
                      </c:pt>
                      <c:pt idx="8">
                        <c:v>-1E-3</c:v>
                      </c:pt>
                      <c:pt idx="9">
                        <c:v>-1E-3</c:v>
                      </c:pt>
                      <c:pt idx="10">
                        <c:v>-1E-3</c:v>
                      </c:pt>
                      <c:pt idx="11">
                        <c:v>-1E-3</c:v>
                      </c:pt>
                      <c:pt idx="12">
                        <c:v>-1E-3</c:v>
                      </c:pt>
                      <c:pt idx="13">
                        <c:v>-1E-3</c:v>
                      </c:pt>
                      <c:pt idx="14">
                        <c:v>-1E-3</c:v>
                      </c:pt>
                      <c:pt idx="15">
                        <c:v>-1E-3</c:v>
                      </c:pt>
                      <c:pt idx="16">
                        <c:v>-1E-3</c:v>
                      </c:pt>
                      <c:pt idx="17">
                        <c:v>-1E-3</c:v>
                      </c:pt>
                      <c:pt idx="18">
                        <c:v>-1E-3</c:v>
                      </c:pt>
                      <c:pt idx="19">
                        <c:v>-1E-3</c:v>
                      </c:pt>
                      <c:pt idx="20">
                        <c:v>-1E-3</c:v>
                      </c:pt>
                      <c:pt idx="21">
                        <c:v>-1E-3</c:v>
                      </c:pt>
                      <c:pt idx="22">
                        <c:v>-1E-3</c:v>
                      </c:pt>
                      <c:pt idx="23">
                        <c:v>-1E-3</c:v>
                      </c:pt>
                      <c:pt idx="24">
                        <c:v>-1E-3</c:v>
                      </c:pt>
                      <c:pt idx="25">
                        <c:v>-1E-3</c:v>
                      </c:pt>
                      <c:pt idx="26">
                        <c:v>-1E-3</c:v>
                      </c:pt>
                      <c:pt idx="27">
                        <c:v>-1E-3</c:v>
                      </c:pt>
                      <c:pt idx="28">
                        <c:v>-1E-3</c:v>
                      </c:pt>
                      <c:pt idx="29">
                        <c:v>-1E-3</c:v>
                      </c:pt>
                      <c:pt idx="30">
                        <c:v>-1E-3</c:v>
                      </c:pt>
                      <c:pt idx="31">
                        <c:v>-1E-3</c:v>
                      </c:pt>
                      <c:pt idx="32">
                        <c:v>-1E-3</c:v>
                      </c:pt>
                      <c:pt idx="33">
                        <c:v>-1E-3</c:v>
                      </c:pt>
                      <c:pt idx="34">
                        <c:v>-1E-3</c:v>
                      </c:pt>
                      <c:pt idx="35">
                        <c:v>-1E-3</c:v>
                      </c:pt>
                      <c:pt idx="36">
                        <c:v>-1E-3</c:v>
                      </c:pt>
                      <c:pt idx="37">
                        <c:v>-1E-3</c:v>
                      </c:pt>
                      <c:pt idx="38">
                        <c:v>-1E-3</c:v>
                      </c:pt>
                      <c:pt idx="39">
                        <c:v>-1E-3</c:v>
                      </c:pt>
                      <c:pt idx="40">
                        <c:v>-1E-3</c:v>
                      </c:pt>
                      <c:pt idx="41">
                        <c:v>-1E-3</c:v>
                      </c:pt>
                      <c:pt idx="42">
                        <c:v>-1E-3</c:v>
                      </c:pt>
                      <c:pt idx="43">
                        <c:v>-1E-3</c:v>
                      </c:pt>
                      <c:pt idx="44">
                        <c:v>-1E-3</c:v>
                      </c:pt>
                      <c:pt idx="45">
                        <c:v>-1E-3</c:v>
                      </c:pt>
                      <c:pt idx="46">
                        <c:v>-1E-3</c:v>
                      </c:pt>
                      <c:pt idx="47">
                        <c:v>-1E-3</c:v>
                      </c:pt>
                      <c:pt idx="48">
                        <c:v>-1E-3</c:v>
                      </c:pt>
                      <c:pt idx="49">
                        <c:v>-1E-3</c:v>
                      </c:pt>
                      <c:pt idx="50">
                        <c:v>-1E-3</c:v>
                      </c:pt>
                      <c:pt idx="51">
                        <c:v>-1E-3</c:v>
                      </c:pt>
                      <c:pt idx="52">
                        <c:v>-1E-3</c:v>
                      </c:pt>
                      <c:pt idx="53">
                        <c:v>-1E-3</c:v>
                      </c:pt>
                      <c:pt idx="54">
                        <c:v>-1E-3</c:v>
                      </c:pt>
                      <c:pt idx="55">
                        <c:v>-1E-3</c:v>
                      </c:pt>
                      <c:pt idx="56">
                        <c:v>-1E-3</c:v>
                      </c:pt>
                      <c:pt idx="57">
                        <c:v>-1E-3</c:v>
                      </c:pt>
                      <c:pt idx="58">
                        <c:v>-1E-3</c:v>
                      </c:pt>
                      <c:pt idx="59">
                        <c:v>-1E-3</c:v>
                      </c:pt>
                      <c:pt idx="60">
                        <c:v>-1E-3</c:v>
                      </c:pt>
                      <c:pt idx="61">
                        <c:v>-1E-3</c:v>
                      </c:pt>
                      <c:pt idx="62">
                        <c:v>-1E-3</c:v>
                      </c:pt>
                      <c:pt idx="63">
                        <c:v>0</c:v>
                      </c:pt>
                      <c:pt idx="64">
                        <c:v>0</c:v>
                      </c:pt>
                      <c:pt idx="65">
                        <c:v>0</c:v>
                      </c:pt>
                      <c:pt idx="66">
                        <c:v>-1E-3</c:v>
                      </c:pt>
                      <c:pt idx="67">
                        <c:v>0</c:v>
                      </c:pt>
                      <c:pt idx="68">
                        <c:v>0</c:v>
                      </c:pt>
                      <c:pt idx="69">
                        <c:v>0</c:v>
                      </c:pt>
                      <c:pt idx="70">
                        <c:v>0</c:v>
                      </c:pt>
                      <c:pt idx="71">
                        <c:v>0</c:v>
                      </c:pt>
                      <c:pt idx="72">
                        <c:v>0</c:v>
                      </c:pt>
                      <c:pt idx="73">
                        <c:v>0</c:v>
                      </c:pt>
                      <c:pt idx="74">
                        <c:v>0</c:v>
                      </c:pt>
                      <c:pt idx="75">
                        <c:v>0</c:v>
                      </c:pt>
                      <c:pt idx="76">
                        <c:v>0</c:v>
                      </c:pt>
                      <c:pt idx="77">
                        <c:v>0</c:v>
                      </c:pt>
                      <c:pt idx="78">
                        <c:v>0</c:v>
                      </c:pt>
                      <c:pt idx="79">
                        <c:v>0</c:v>
                      </c:pt>
                      <c:pt idx="80">
                        <c:v>0</c:v>
                      </c:pt>
                      <c:pt idx="81">
                        <c:v>0</c:v>
                      </c:pt>
                      <c:pt idx="82">
                        <c:v>0</c:v>
                      </c:pt>
                      <c:pt idx="83">
                        <c:v>0</c:v>
                      </c:pt>
                      <c:pt idx="84">
                        <c:v>0</c:v>
                      </c:pt>
                      <c:pt idx="85">
                        <c:v>0</c:v>
                      </c:pt>
                      <c:pt idx="86">
                        <c:v>0</c:v>
                      </c:pt>
                      <c:pt idx="87">
                        <c:v>0</c:v>
                      </c:pt>
                      <c:pt idx="88">
                        <c:v>0</c:v>
                      </c:pt>
                      <c:pt idx="89">
                        <c:v>0</c:v>
                      </c:pt>
                      <c:pt idx="90">
                        <c:v>0</c:v>
                      </c:pt>
                      <c:pt idx="91">
                        <c:v>0</c:v>
                      </c:pt>
                      <c:pt idx="92">
                        <c:v>0</c:v>
                      </c:pt>
                      <c:pt idx="93">
                        <c:v>0</c:v>
                      </c:pt>
                      <c:pt idx="94">
                        <c:v>0</c:v>
                      </c:pt>
                      <c:pt idx="95">
                        <c:v>0</c:v>
                      </c:pt>
                      <c:pt idx="96">
                        <c:v>0</c:v>
                      </c:pt>
                      <c:pt idx="97">
                        <c:v>0</c:v>
                      </c:pt>
                      <c:pt idx="98">
                        <c:v>0</c:v>
                      </c:pt>
                      <c:pt idx="99">
                        <c:v>0</c:v>
                      </c:pt>
                      <c:pt idx="100">
                        <c:v>0</c:v>
                      </c:pt>
                      <c:pt idx="101">
                        <c:v>0</c:v>
                      </c:pt>
                      <c:pt idx="102">
                        <c:v>0</c:v>
                      </c:pt>
                      <c:pt idx="103">
                        <c:v>0</c:v>
                      </c:pt>
                      <c:pt idx="104">
                        <c:v>0</c:v>
                      </c:pt>
                      <c:pt idx="105">
                        <c:v>0</c:v>
                      </c:pt>
                      <c:pt idx="106">
                        <c:v>0</c:v>
                      </c:pt>
                      <c:pt idx="107">
                        <c:v>0</c:v>
                      </c:pt>
                      <c:pt idx="108">
                        <c:v>0</c:v>
                      </c:pt>
                      <c:pt idx="109">
                        <c:v>0</c:v>
                      </c:pt>
                      <c:pt idx="110">
                        <c:v>0</c:v>
                      </c:pt>
                      <c:pt idx="111">
                        <c:v>0</c:v>
                      </c:pt>
                      <c:pt idx="112">
                        <c:v>0</c:v>
                      </c:pt>
                      <c:pt idx="113">
                        <c:v>0</c:v>
                      </c:pt>
                      <c:pt idx="114">
                        <c:v>0</c:v>
                      </c:pt>
                      <c:pt idx="115">
                        <c:v>0</c:v>
                      </c:pt>
                      <c:pt idx="116">
                        <c:v>0</c:v>
                      </c:pt>
                      <c:pt idx="117">
                        <c:v>0</c:v>
                      </c:pt>
                      <c:pt idx="118">
                        <c:v>0</c:v>
                      </c:pt>
                      <c:pt idx="119">
                        <c:v>0</c:v>
                      </c:pt>
                      <c:pt idx="120">
                        <c:v>0</c:v>
                      </c:pt>
                      <c:pt idx="121">
                        <c:v>0</c:v>
                      </c:pt>
                      <c:pt idx="122">
                        <c:v>0</c:v>
                      </c:pt>
                      <c:pt idx="123">
                        <c:v>0</c:v>
                      </c:pt>
                      <c:pt idx="124">
                        <c:v>0</c:v>
                      </c:pt>
                      <c:pt idx="125">
                        <c:v>0</c:v>
                      </c:pt>
                      <c:pt idx="126">
                        <c:v>0</c:v>
                      </c:pt>
                      <c:pt idx="127">
                        <c:v>0</c:v>
                      </c:pt>
                      <c:pt idx="128">
                        <c:v>0</c:v>
                      </c:pt>
                      <c:pt idx="129">
                        <c:v>0</c:v>
                      </c:pt>
                      <c:pt idx="130">
                        <c:v>0</c:v>
                      </c:pt>
                      <c:pt idx="131">
                        <c:v>0</c:v>
                      </c:pt>
                      <c:pt idx="132">
                        <c:v>0</c:v>
                      </c:pt>
                      <c:pt idx="133">
                        <c:v>0</c:v>
                      </c:pt>
                      <c:pt idx="134">
                        <c:v>0</c:v>
                      </c:pt>
                      <c:pt idx="135">
                        <c:v>0</c:v>
                      </c:pt>
                      <c:pt idx="136">
                        <c:v>0</c:v>
                      </c:pt>
                      <c:pt idx="137">
                        <c:v>0</c:v>
                      </c:pt>
                      <c:pt idx="138">
                        <c:v>0</c:v>
                      </c:pt>
                      <c:pt idx="139">
                        <c:v>0</c:v>
                      </c:pt>
                      <c:pt idx="140">
                        <c:v>0</c:v>
                      </c:pt>
                      <c:pt idx="141">
                        <c:v>0</c:v>
                      </c:pt>
                      <c:pt idx="142">
                        <c:v>0</c:v>
                      </c:pt>
                      <c:pt idx="143">
                        <c:v>0</c:v>
                      </c:pt>
                      <c:pt idx="144">
                        <c:v>0</c:v>
                      </c:pt>
                      <c:pt idx="145">
                        <c:v>0</c:v>
                      </c:pt>
                      <c:pt idx="146">
                        <c:v>0</c:v>
                      </c:pt>
                      <c:pt idx="147">
                        <c:v>0</c:v>
                      </c:pt>
                      <c:pt idx="148">
                        <c:v>0</c:v>
                      </c:pt>
                      <c:pt idx="149">
                        <c:v>0</c:v>
                      </c:pt>
                      <c:pt idx="150">
                        <c:v>0</c:v>
                      </c:pt>
                      <c:pt idx="151">
                        <c:v>0</c:v>
                      </c:pt>
                      <c:pt idx="152">
                        <c:v>0</c:v>
                      </c:pt>
                      <c:pt idx="153">
                        <c:v>0</c:v>
                      </c:pt>
                      <c:pt idx="154">
                        <c:v>0</c:v>
                      </c:pt>
                      <c:pt idx="155">
                        <c:v>0</c:v>
                      </c:pt>
                      <c:pt idx="156">
                        <c:v>0</c:v>
                      </c:pt>
                      <c:pt idx="157">
                        <c:v>0</c:v>
                      </c:pt>
                      <c:pt idx="158">
                        <c:v>0</c:v>
                      </c:pt>
                      <c:pt idx="159">
                        <c:v>0</c:v>
                      </c:pt>
                      <c:pt idx="160">
                        <c:v>0</c:v>
                      </c:pt>
                      <c:pt idx="161">
                        <c:v>0</c:v>
                      </c:pt>
                      <c:pt idx="162">
                        <c:v>0</c:v>
                      </c:pt>
                      <c:pt idx="163">
                        <c:v>0</c:v>
                      </c:pt>
                      <c:pt idx="164">
                        <c:v>0</c:v>
                      </c:pt>
                      <c:pt idx="165">
                        <c:v>0</c:v>
                      </c:pt>
                      <c:pt idx="166">
                        <c:v>0</c:v>
                      </c:pt>
                      <c:pt idx="167">
                        <c:v>0</c:v>
                      </c:pt>
                      <c:pt idx="168">
                        <c:v>0</c:v>
                      </c:pt>
                      <c:pt idx="169">
                        <c:v>0</c:v>
                      </c:pt>
                      <c:pt idx="170">
                        <c:v>0</c:v>
                      </c:pt>
                      <c:pt idx="171">
                        <c:v>0</c:v>
                      </c:pt>
                      <c:pt idx="172">
                        <c:v>0</c:v>
                      </c:pt>
                      <c:pt idx="173">
                        <c:v>0</c:v>
                      </c:pt>
                      <c:pt idx="174">
                        <c:v>0</c:v>
                      </c:pt>
                      <c:pt idx="175">
                        <c:v>0</c:v>
                      </c:pt>
                      <c:pt idx="176">
                        <c:v>0</c:v>
                      </c:pt>
                      <c:pt idx="177">
                        <c:v>0</c:v>
                      </c:pt>
                      <c:pt idx="178">
                        <c:v>0</c:v>
                      </c:pt>
                      <c:pt idx="179">
                        <c:v>0</c:v>
                      </c:pt>
                      <c:pt idx="180">
                        <c:v>0</c:v>
                      </c:pt>
                      <c:pt idx="181">
                        <c:v>0</c:v>
                      </c:pt>
                      <c:pt idx="182">
                        <c:v>0</c:v>
                      </c:pt>
                      <c:pt idx="183">
                        <c:v>0</c:v>
                      </c:pt>
                      <c:pt idx="184">
                        <c:v>0</c:v>
                      </c:pt>
                      <c:pt idx="185">
                        <c:v>0</c:v>
                      </c:pt>
                      <c:pt idx="186">
                        <c:v>0</c:v>
                      </c:pt>
                      <c:pt idx="187">
                        <c:v>0</c:v>
                      </c:pt>
                      <c:pt idx="188">
                        <c:v>0</c:v>
                      </c:pt>
                      <c:pt idx="189">
                        <c:v>0</c:v>
                      </c:pt>
                      <c:pt idx="190">
                        <c:v>0</c:v>
                      </c:pt>
                      <c:pt idx="191">
                        <c:v>0</c:v>
                      </c:pt>
                      <c:pt idx="192">
                        <c:v>0</c:v>
                      </c:pt>
                      <c:pt idx="193">
                        <c:v>0</c:v>
                      </c:pt>
                      <c:pt idx="194">
                        <c:v>0</c:v>
                      </c:pt>
                      <c:pt idx="195">
                        <c:v>0</c:v>
                      </c:pt>
                      <c:pt idx="196">
                        <c:v>0</c:v>
                      </c:pt>
                      <c:pt idx="197">
                        <c:v>0</c:v>
                      </c:pt>
                      <c:pt idx="198">
                        <c:v>0</c:v>
                      </c:pt>
                      <c:pt idx="199">
                        <c:v>0</c:v>
                      </c:pt>
                      <c:pt idx="200">
                        <c:v>0</c:v>
                      </c:pt>
                      <c:pt idx="201">
                        <c:v>0</c:v>
                      </c:pt>
                      <c:pt idx="202">
                        <c:v>0</c:v>
                      </c:pt>
                      <c:pt idx="203">
                        <c:v>0</c:v>
                      </c:pt>
                      <c:pt idx="204">
                        <c:v>0</c:v>
                      </c:pt>
                      <c:pt idx="205">
                        <c:v>0</c:v>
                      </c:pt>
                      <c:pt idx="206">
                        <c:v>0</c:v>
                      </c:pt>
                      <c:pt idx="207">
                        <c:v>0</c:v>
                      </c:pt>
                      <c:pt idx="208">
                        <c:v>0</c:v>
                      </c:pt>
                      <c:pt idx="209">
                        <c:v>0</c:v>
                      </c:pt>
                      <c:pt idx="210">
                        <c:v>0</c:v>
                      </c:pt>
                      <c:pt idx="211">
                        <c:v>0</c:v>
                      </c:pt>
                      <c:pt idx="212">
                        <c:v>0</c:v>
                      </c:pt>
                      <c:pt idx="213">
                        <c:v>0</c:v>
                      </c:pt>
                      <c:pt idx="214">
                        <c:v>0</c:v>
                      </c:pt>
                      <c:pt idx="215">
                        <c:v>0</c:v>
                      </c:pt>
                      <c:pt idx="216">
                        <c:v>0</c:v>
                      </c:pt>
                      <c:pt idx="217">
                        <c:v>0</c:v>
                      </c:pt>
                      <c:pt idx="218">
                        <c:v>0</c:v>
                      </c:pt>
                      <c:pt idx="219">
                        <c:v>0</c:v>
                      </c:pt>
                      <c:pt idx="220">
                        <c:v>0</c:v>
                      </c:pt>
                      <c:pt idx="221">
                        <c:v>0</c:v>
                      </c:pt>
                      <c:pt idx="222">
                        <c:v>0</c:v>
                      </c:pt>
                      <c:pt idx="223">
                        <c:v>0</c:v>
                      </c:pt>
                      <c:pt idx="224">
                        <c:v>0</c:v>
                      </c:pt>
                      <c:pt idx="225">
                        <c:v>0</c:v>
                      </c:pt>
                      <c:pt idx="226">
                        <c:v>0</c:v>
                      </c:pt>
                      <c:pt idx="227">
                        <c:v>0</c:v>
                      </c:pt>
                      <c:pt idx="228">
                        <c:v>0</c:v>
                      </c:pt>
                      <c:pt idx="229">
                        <c:v>0</c:v>
                      </c:pt>
                      <c:pt idx="230">
                        <c:v>0</c:v>
                      </c:pt>
                      <c:pt idx="231">
                        <c:v>0</c:v>
                      </c:pt>
                      <c:pt idx="232">
                        <c:v>0</c:v>
                      </c:pt>
                      <c:pt idx="233">
                        <c:v>0</c:v>
                      </c:pt>
                      <c:pt idx="234">
                        <c:v>0</c:v>
                      </c:pt>
                      <c:pt idx="235">
                        <c:v>0</c:v>
                      </c:pt>
                      <c:pt idx="236">
                        <c:v>0</c:v>
                      </c:pt>
                      <c:pt idx="237">
                        <c:v>0</c:v>
                      </c:pt>
                      <c:pt idx="238">
                        <c:v>0</c:v>
                      </c:pt>
                      <c:pt idx="239">
                        <c:v>0</c:v>
                      </c:pt>
                      <c:pt idx="240">
                        <c:v>0</c:v>
                      </c:pt>
                      <c:pt idx="241">
                        <c:v>0</c:v>
                      </c:pt>
                      <c:pt idx="242">
                        <c:v>0</c:v>
                      </c:pt>
                      <c:pt idx="243">
                        <c:v>0</c:v>
                      </c:pt>
                      <c:pt idx="244">
                        <c:v>0</c:v>
                      </c:pt>
                      <c:pt idx="245">
                        <c:v>0</c:v>
                      </c:pt>
                      <c:pt idx="246">
                        <c:v>0</c:v>
                      </c:pt>
                      <c:pt idx="247">
                        <c:v>0</c:v>
                      </c:pt>
                      <c:pt idx="248">
                        <c:v>0</c:v>
                      </c:pt>
                      <c:pt idx="249">
                        <c:v>0</c:v>
                      </c:pt>
                      <c:pt idx="250">
                        <c:v>0</c:v>
                      </c:pt>
                      <c:pt idx="251">
                        <c:v>1E-3</c:v>
                      </c:pt>
                      <c:pt idx="252">
                        <c:v>1E-3</c:v>
                      </c:pt>
                      <c:pt idx="253">
                        <c:v>1E-3</c:v>
                      </c:pt>
                      <c:pt idx="254">
                        <c:v>1E-3</c:v>
                      </c:pt>
                      <c:pt idx="255">
                        <c:v>1E-3</c:v>
                      </c:pt>
                      <c:pt idx="256">
                        <c:v>1E-3</c:v>
                      </c:pt>
                      <c:pt idx="257">
                        <c:v>1E-3</c:v>
                      </c:pt>
                      <c:pt idx="258">
                        <c:v>1E-3</c:v>
                      </c:pt>
                      <c:pt idx="259">
                        <c:v>1E-3</c:v>
                      </c:pt>
                      <c:pt idx="260">
                        <c:v>1E-3</c:v>
                      </c:pt>
                      <c:pt idx="261">
                        <c:v>1E-3</c:v>
                      </c:pt>
                      <c:pt idx="262">
                        <c:v>1E-3</c:v>
                      </c:pt>
                      <c:pt idx="263">
                        <c:v>1E-3</c:v>
                      </c:pt>
                      <c:pt idx="264">
                        <c:v>1E-3</c:v>
                      </c:pt>
                      <c:pt idx="265">
                        <c:v>1E-3</c:v>
                      </c:pt>
                      <c:pt idx="266">
                        <c:v>1E-3</c:v>
                      </c:pt>
                      <c:pt idx="267">
                        <c:v>1E-3</c:v>
                      </c:pt>
                      <c:pt idx="268">
                        <c:v>2E-3</c:v>
                      </c:pt>
                      <c:pt idx="269">
                        <c:v>2E-3</c:v>
                      </c:pt>
                      <c:pt idx="270">
                        <c:v>2E-3</c:v>
                      </c:pt>
                      <c:pt idx="271">
                        <c:v>2E-3</c:v>
                      </c:pt>
                      <c:pt idx="272">
                        <c:v>2E-3</c:v>
                      </c:pt>
                      <c:pt idx="273">
                        <c:v>2E-3</c:v>
                      </c:pt>
                      <c:pt idx="274">
                        <c:v>2E-3</c:v>
                      </c:pt>
                      <c:pt idx="275">
                        <c:v>2E-3</c:v>
                      </c:pt>
                      <c:pt idx="276">
                        <c:v>2E-3</c:v>
                      </c:pt>
                      <c:pt idx="277">
                        <c:v>3.0000000000000001E-3</c:v>
                      </c:pt>
                      <c:pt idx="278">
                        <c:v>3.0000000000000001E-3</c:v>
                      </c:pt>
                      <c:pt idx="279">
                        <c:v>3.0000000000000001E-3</c:v>
                      </c:pt>
                      <c:pt idx="280">
                        <c:v>3.0000000000000001E-3</c:v>
                      </c:pt>
                      <c:pt idx="281">
                        <c:v>3.0000000000000001E-3</c:v>
                      </c:pt>
                      <c:pt idx="282">
                        <c:v>4.0000000000000001E-3</c:v>
                      </c:pt>
                      <c:pt idx="283">
                        <c:v>4.0000000000000001E-3</c:v>
                      </c:pt>
                      <c:pt idx="284">
                        <c:v>4.0000000000000001E-3</c:v>
                      </c:pt>
                      <c:pt idx="285">
                        <c:v>4.0000000000000001E-3</c:v>
                      </c:pt>
                      <c:pt idx="286">
                        <c:v>4.0000000000000001E-3</c:v>
                      </c:pt>
                      <c:pt idx="287">
                        <c:v>5.0000000000000001E-3</c:v>
                      </c:pt>
                      <c:pt idx="288">
                        <c:v>5.0000000000000001E-3</c:v>
                      </c:pt>
                      <c:pt idx="289">
                        <c:v>5.0000000000000001E-3</c:v>
                      </c:pt>
                      <c:pt idx="290">
                        <c:v>6.0000000000000001E-3</c:v>
                      </c:pt>
                      <c:pt idx="291">
                        <c:v>6.0000000000000001E-3</c:v>
                      </c:pt>
                      <c:pt idx="292">
                        <c:v>6.0000000000000001E-3</c:v>
                      </c:pt>
                      <c:pt idx="293">
                        <c:v>7.0000000000000001E-3</c:v>
                      </c:pt>
                      <c:pt idx="294">
                        <c:v>7.0000000000000001E-3</c:v>
                      </c:pt>
                      <c:pt idx="295">
                        <c:v>8.0000000000000002E-3</c:v>
                      </c:pt>
                      <c:pt idx="296">
                        <c:v>8.0000000000000002E-3</c:v>
                      </c:pt>
                      <c:pt idx="297">
                        <c:v>8.9999999999999993E-3</c:v>
                      </c:pt>
                      <c:pt idx="298">
                        <c:v>8.9999999999999993E-3</c:v>
                      </c:pt>
                      <c:pt idx="299">
                        <c:v>0.01</c:v>
                      </c:pt>
                      <c:pt idx="300">
                        <c:v>0.01</c:v>
                      </c:pt>
                      <c:pt idx="301">
                        <c:v>1.0999999999999999E-2</c:v>
                      </c:pt>
                      <c:pt idx="302">
                        <c:v>1.2E-2</c:v>
                      </c:pt>
                      <c:pt idx="303">
                        <c:v>1.2E-2</c:v>
                      </c:pt>
                      <c:pt idx="304">
                        <c:v>1.2999999999999999E-2</c:v>
                      </c:pt>
                      <c:pt idx="305">
                        <c:v>1.4E-2</c:v>
                      </c:pt>
                      <c:pt idx="306">
                        <c:v>1.4999999999999999E-2</c:v>
                      </c:pt>
                      <c:pt idx="307">
                        <c:v>1.4999999999999999E-2</c:v>
                      </c:pt>
                      <c:pt idx="308">
                        <c:v>1.6E-2</c:v>
                      </c:pt>
                      <c:pt idx="309">
                        <c:v>1.7000000000000001E-2</c:v>
                      </c:pt>
                      <c:pt idx="310">
                        <c:v>1.7999999999999999E-2</c:v>
                      </c:pt>
                      <c:pt idx="311">
                        <c:v>1.9E-2</c:v>
                      </c:pt>
                      <c:pt idx="312">
                        <c:v>0.02</c:v>
                      </c:pt>
                      <c:pt idx="313">
                        <c:v>2.1000000000000001E-2</c:v>
                      </c:pt>
                      <c:pt idx="314">
                        <c:v>2.1999999999999999E-2</c:v>
                      </c:pt>
                      <c:pt idx="315">
                        <c:v>2.4E-2</c:v>
                      </c:pt>
                      <c:pt idx="316">
                        <c:v>2.5000000000000001E-2</c:v>
                      </c:pt>
                      <c:pt idx="317">
                        <c:v>2.5999999999999999E-2</c:v>
                      </c:pt>
                      <c:pt idx="318">
                        <c:v>2.8000000000000001E-2</c:v>
                      </c:pt>
                      <c:pt idx="319">
                        <c:v>2.9000000000000001E-2</c:v>
                      </c:pt>
                      <c:pt idx="320">
                        <c:v>0.03</c:v>
                      </c:pt>
                      <c:pt idx="321">
                        <c:v>3.2000000000000001E-2</c:v>
                      </c:pt>
                      <c:pt idx="322">
                        <c:v>3.3000000000000002E-2</c:v>
                      </c:pt>
                      <c:pt idx="323">
                        <c:v>3.5000000000000003E-2</c:v>
                      </c:pt>
                      <c:pt idx="324">
                        <c:v>3.6999999999999998E-2</c:v>
                      </c:pt>
                      <c:pt idx="325">
                        <c:v>3.7999999999999999E-2</c:v>
                      </c:pt>
                      <c:pt idx="326">
                        <c:v>0.04</c:v>
                      </c:pt>
                      <c:pt idx="327">
                        <c:v>4.2000000000000003E-2</c:v>
                      </c:pt>
                      <c:pt idx="328">
                        <c:v>4.3999999999999997E-2</c:v>
                      </c:pt>
                      <c:pt idx="329">
                        <c:v>4.5999999999999999E-2</c:v>
                      </c:pt>
                      <c:pt idx="330">
                        <c:v>4.8000000000000001E-2</c:v>
                      </c:pt>
                      <c:pt idx="331">
                        <c:v>0.05</c:v>
                      </c:pt>
                      <c:pt idx="332">
                        <c:v>5.1999999999999998E-2</c:v>
                      </c:pt>
                      <c:pt idx="333">
                        <c:v>5.5E-2</c:v>
                      </c:pt>
                      <c:pt idx="334">
                        <c:v>5.7000000000000002E-2</c:v>
                      </c:pt>
                      <c:pt idx="335">
                        <c:v>5.8999999999999997E-2</c:v>
                      </c:pt>
                      <c:pt idx="336">
                        <c:v>6.0999999999999999E-2</c:v>
                      </c:pt>
                      <c:pt idx="337">
                        <c:v>6.3E-2</c:v>
                      </c:pt>
                      <c:pt idx="338">
                        <c:v>6.6000000000000003E-2</c:v>
                      </c:pt>
                      <c:pt idx="339">
                        <c:v>6.8000000000000005E-2</c:v>
                      </c:pt>
                      <c:pt idx="340">
                        <c:v>7.0999999999999994E-2</c:v>
                      </c:pt>
                      <c:pt idx="341">
                        <c:v>7.2999999999999995E-2</c:v>
                      </c:pt>
                      <c:pt idx="342">
                        <c:v>7.5999999999999998E-2</c:v>
                      </c:pt>
                      <c:pt idx="343">
                        <c:v>7.8E-2</c:v>
                      </c:pt>
                      <c:pt idx="344">
                        <c:v>8.1000000000000003E-2</c:v>
                      </c:pt>
                      <c:pt idx="345">
                        <c:v>8.4000000000000005E-2</c:v>
                      </c:pt>
                      <c:pt idx="346">
                        <c:v>8.5999999999999993E-2</c:v>
                      </c:pt>
                      <c:pt idx="347">
                        <c:v>8.8999999999999996E-2</c:v>
                      </c:pt>
                      <c:pt idx="348">
                        <c:v>9.1999999999999998E-2</c:v>
                      </c:pt>
                      <c:pt idx="349">
                        <c:v>9.5000000000000001E-2</c:v>
                      </c:pt>
                      <c:pt idx="350">
                        <c:v>9.8000000000000004E-2</c:v>
                      </c:pt>
                      <c:pt idx="351">
                        <c:v>0.1</c:v>
                      </c:pt>
                      <c:pt idx="352">
                        <c:v>0.10299999999999999</c:v>
                      </c:pt>
                      <c:pt idx="353">
                        <c:v>0.106</c:v>
                      </c:pt>
                      <c:pt idx="354">
                        <c:v>0.11</c:v>
                      </c:pt>
                      <c:pt idx="355">
                        <c:v>0.113</c:v>
                      </c:pt>
                      <c:pt idx="356">
                        <c:v>0.11600000000000001</c:v>
                      </c:pt>
                      <c:pt idx="357">
                        <c:v>0.11899999999999999</c:v>
                      </c:pt>
                      <c:pt idx="358">
                        <c:v>0.123</c:v>
                      </c:pt>
                      <c:pt idx="359">
                        <c:v>0.126</c:v>
                      </c:pt>
                      <c:pt idx="360">
                        <c:v>0.129</c:v>
                      </c:pt>
                      <c:pt idx="361">
                        <c:v>0.13300000000000001</c:v>
                      </c:pt>
                      <c:pt idx="362">
                        <c:v>0.13600000000000001</c:v>
                      </c:pt>
                      <c:pt idx="363">
                        <c:v>0.13900000000000001</c:v>
                      </c:pt>
                      <c:pt idx="364">
                        <c:v>0.14299999999999999</c:v>
                      </c:pt>
                      <c:pt idx="365">
                        <c:v>0.14699999999999999</c:v>
                      </c:pt>
                      <c:pt idx="366">
                        <c:v>0.151</c:v>
                      </c:pt>
                      <c:pt idx="367">
                        <c:v>0.155</c:v>
                      </c:pt>
                      <c:pt idx="368">
                        <c:v>0.159</c:v>
                      </c:pt>
                      <c:pt idx="369">
                        <c:v>0.16300000000000001</c:v>
                      </c:pt>
                      <c:pt idx="370">
                        <c:v>0.16700000000000001</c:v>
                      </c:pt>
                      <c:pt idx="371">
                        <c:v>0.17199999999999999</c:v>
                      </c:pt>
                      <c:pt idx="372">
                        <c:v>0.17699999999999999</c:v>
                      </c:pt>
                      <c:pt idx="373">
                        <c:v>0.18099999999999999</c:v>
                      </c:pt>
                      <c:pt idx="374">
                        <c:v>0.186</c:v>
                      </c:pt>
                      <c:pt idx="375">
                        <c:v>0.19</c:v>
                      </c:pt>
                      <c:pt idx="376">
                        <c:v>0.19600000000000001</c:v>
                      </c:pt>
                      <c:pt idx="377">
                        <c:v>0.20100000000000001</c:v>
                      </c:pt>
                      <c:pt idx="378">
                        <c:v>0.20699999999999999</c:v>
                      </c:pt>
                      <c:pt idx="379">
                        <c:v>0.21199999999999999</c:v>
                      </c:pt>
                      <c:pt idx="380">
                        <c:v>0.218</c:v>
                      </c:pt>
                      <c:pt idx="381">
                        <c:v>0.224</c:v>
                      </c:pt>
                      <c:pt idx="382">
                        <c:v>0.23</c:v>
                      </c:pt>
                      <c:pt idx="383">
                        <c:v>0.23499999999999999</c:v>
                      </c:pt>
                      <c:pt idx="384">
                        <c:v>0.24099999999999999</c:v>
                      </c:pt>
                      <c:pt idx="385">
                        <c:v>0.247</c:v>
                      </c:pt>
                      <c:pt idx="386">
                        <c:v>0.254</c:v>
                      </c:pt>
                      <c:pt idx="387">
                        <c:v>0.26</c:v>
                      </c:pt>
                      <c:pt idx="388">
                        <c:v>0.26600000000000001</c:v>
                      </c:pt>
                      <c:pt idx="389">
                        <c:v>0.27200000000000002</c:v>
                      </c:pt>
                      <c:pt idx="390">
                        <c:v>0.27900000000000003</c:v>
                      </c:pt>
                      <c:pt idx="391">
                        <c:v>0.28499999999999998</c:v>
                      </c:pt>
                      <c:pt idx="392">
                        <c:v>0.29199999999999998</c:v>
                      </c:pt>
                      <c:pt idx="393">
                        <c:v>0.29799999999999999</c:v>
                      </c:pt>
                      <c:pt idx="394">
                        <c:v>0.30399999999999999</c:v>
                      </c:pt>
                      <c:pt idx="395">
                        <c:v>0.31</c:v>
                      </c:pt>
                      <c:pt idx="396">
                        <c:v>0.317</c:v>
                      </c:pt>
                      <c:pt idx="397">
                        <c:v>0.32300000000000001</c:v>
                      </c:pt>
                      <c:pt idx="398">
                        <c:v>0.32900000000000001</c:v>
                      </c:pt>
                      <c:pt idx="399">
                        <c:v>0.33600000000000002</c:v>
                      </c:pt>
                      <c:pt idx="400">
                        <c:v>0.34300000000000003</c:v>
                      </c:pt>
                      <c:pt idx="401">
                        <c:v>0.35099999999999998</c:v>
                      </c:pt>
                      <c:pt idx="402">
                        <c:v>0.35899999999999999</c:v>
                      </c:pt>
                      <c:pt idx="403">
                        <c:v>0.36699999999999999</c:v>
                      </c:pt>
                      <c:pt idx="404">
                        <c:v>0.376</c:v>
                      </c:pt>
                      <c:pt idx="405">
                        <c:v>0.38500000000000001</c:v>
                      </c:pt>
                      <c:pt idx="406">
                        <c:v>0.39400000000000002</c:v>
                      </c:pt>
                      <c:pt idx="407">
                        <c:v>0.40400000000000003</c:v>
                      </c:pt>
                      <c:pt idx="408">
                        <c:v>0.41399999999999998</c:v>
                      </c:pt>
                      <c:pt idx="409">
                        <c:v>0.42499999999999999</c:v>
                      </c:pt>
                      <c:pt idx="410">
                        <c:v>0.436</c:v>
                      </c:pt>
                      <c:pt idx="411">
                        <c:v>0.44700000000000001</c:v>
                      </c:pt>
                      <c:pt idx="412">
                        <c:v>0.45900000000000002</c:v>
                      </c:pt>
                      <c:pt idx="413">
                        <c:v>0.47099999999999997</c:v>
                      </c:pt>
                      <c:pt idx="414">
                        <c:v>0.48299999999999998</c:v>
                      </c:pt>
                      <c:pt idx="415">
                        <c:v>0.495</c:v>
                      </c:pt>
                      <c:pt idx="416">
                        <c:v>0.50700000000000001</c:v>
                      </c:pt>
                      <c:pt idx="417">
                        <c:v>0.51800000000000002</c:v>
                      </c:pt>
                      <c:pt idx="418">
                        <c:v>0.52800000000000002</c:v>
                      </c:pt>
                      <c:pt idx="419">
                        <c:v>0.53800000000000003</c:v>
                      </c:pt>
                      <c:pt idx="420">
                        <c:v>0.54700000000000004</c:v>
                      </c:pt>
                      <c:pt idx="421">
                        <c:v>0.55400000000000005</c:v>
                      </c:pt>
                      <c:pt idx="422">
                        <c:v>0.56100000000000005</c:v>
                      </c:pt>
                      <c:pt idx="423">
                        <c:v>0.56699999999999995</c:v>
                      </c:pt>
                      <c:pt idx="424">
                        <c:v>0.57199999999999995</c:v>
                      </c:pt>
                      <c:pt idx="425">
                        <c:v>0.57499999999999996</c:v>
                      </c:pt>
                      <c:pt idx="426">
                        <c:v>0.57799999999999996</c:v>
                      </c:pt>
                      <c:pt idx="427">
                        <c:v>0.57999999999999996</c:v>
                      </c:pt>
                      <c:pt idx="428">
                        <c:v>0.58099999999999996</c:v>
                      </c:pt>
                      <c:pt idx="429">
                        <c:v>0.58099999999999996</c:v>
                      </c:pt>
                      <c:pt idx="430">
                        <c:v>0.58099999999999996</c:v>
                      </c:pt>
                      <c:pt idx="431">
                        <c:v>0.57999999999999996</c:v>
                      </c:pt>
                      <c:pt idx="432">
                        <c:v>0.57899999999999996</c:v>
                      </c:pt>
                      <c:pt idx="433">
                        <c:v>0.57799999999999996</c:v>
                      </c:pt>
                      <c:pt idx="434">
                        <c:v>0.57699999999999996</c:v>
                      </c:pt>
                      <c:pt idx="435">
                        <c:v>0.57499999999999996</c:v>
                      </c:pt>
                      <c:pt idx="436">
                        <c:v>0.57299999999999995</c:v>
                      </c:pt>
                      <c:pt idx="437">
                        <c:v>0.57099999999999995</c:v>
                      </c:pt>
                      <c:pt idx="438">
                        <c:v>0.56899999999999995</c:v>
                      </c:pt>
                      <c:pt idx="439">
                        <c:v>0.56599999999999995</c:v>
                      </c:pt>
                      <c:pt idx="440">
                        <c:v>0.56299999999999994</c:v>
                      </c:pt>
                      <c:pt idx="441">
                        <c:v>0.56000000000000005</c:v>
                      </c:pt>
                      <c:pt idx="442">
                        <c:v>0.55600000000000005</c:v>
                      </c:pt>
                      <c:pt idx="443">
                        <c:v>0.55200000000000005</c:v>
                      </c:pt>
                      <c:pt idx="444">
                        <c:v>0.54600000000000004</c:v>
                      </c:pt>
                      <c:pt idx="445">
                        <c:v>0.54100000000000004</c:v>
                      </c:pt>
                      <c:pt idx="446">
                        <c:v>0.53500000000000003</c:v>
                      </c:pt>
                      <c:pt idx="447">
                        <c:v>0.52800000000000002</c:v>
                      </c:pt>
                      <c:pt idx="448">
                        <c:v>0.52100000000000002</c:v>
                      </c:pt>
                      <c:pt idx="449">
                        <c:v>0.51400000000000001</c:v>
                      </c:pt>
                      <c:pt idx="450">
                        <c:v>0.50700000000000001</c:v>
                      </c:pt>
                      <c:pt idx="451">
                        <c:v>0.5</c:v>
                      </c:pt>
                      <c:pt idx="452">
                        <c:v>0.49399999999999999</c:v>
                      </c:pt>
                      <c:pt idx="453">
                        <c:v>0.48899999999999999</c:v>
                      </c:pt>
                      <c:pt idx="454">
                        <c:v>0.48599999999999999</c:v>
                      </c:pt>
                      <c:pt idx="455">
                        <c:v>0.48299999999999998</c:v>
                      </c:pt>
                      <c:pt idx="456">
                        <c:v>0.48199999999999998</c:v>
                      </c:pt>
                      <c:pt idx="457">
                        <c:v>0.48299999999999998</c:v>
                      </c:pt>
                      <c:pt idx="458">
                        <c:v>0.48499999999999999</c:v>
                      </c:pt>
                      <c:pt idx="459">
                        <c:v>0.48899999999999999</c:v>
                      </c:pt>
                      <c:pt idx="460">
                        <c:v>0.495</c:v>
                      </c:pt>
                      <c:pt idx="461">
                        <c:v>0.503</c:v>
                      </c:pt>
                      <c:pt idx="462">
                        <c:v>0.51300000000000001</c:v>
                      </c:pt>
                      <c:pt idx="463">
                        <c:v>0.52500000000000002</c:v>
                      </c:pt>
                      <c:pt idx="464">
                        <c:v>0.53900000000000003</c:v>
                      </c:pt>
                      <c:pt idx="465">
                        <c:v>0.55500000000000005</c:v>
                      </c:pt>
                      <c:pt idx="466">
                        <c:v>0.57399999999999995</c:v>
                      </c:pt>
                      <c:pt idx="467">
                        <c:v>0.59599999999999997</c:v>
                      </c:pt>
                      <c:pt idx="468">
                        <c:v>0.622</c:v>
                      </c:pt>
                      <c:pt idx="469">
                        <c:v>0.65300000000000002</c:v>
                      </c:pt>
                      <c:pt idx="470">
                        <c:v>0.68700000000000006</c:v>
                      </c:pt>
                      <c:pt idx="471">
                        <c:v>0.72799999999999998</c:v>
                      </c:pt>
                      <c:pt idx="472">
                        <c:v>0.77500000000000002</c:v>
                      </c:pt>
                      <c:pt idx="473">
                        <c:v>0.83</c:v>
                      </c:pt>
                      <c:pt idx="474">
                        <c:v>0.89400000000000002</c:v>
                      </c:pt>
                      <c:pt idx="475">
                        <c:v>0.96499999999999997</c:v>
                      </c:pt>
                      <c:pt idx="476">
                        <c:v>1.044</c:v>
                      </c:pt>
                      <c:pt idx="477">
                        <c:v>1.1299999999999999</c:v>
                      </c:pt>
                      <c:pt idx="478">
                        <c:v>1.2250000000000001</c:v>
                      </c:pt>
                      <c:pt idx="479">
                        <c:v>1.3009999999999999</c:v>
                      </c:pt>
                      <c:pt idx="480">
                        <c:v>1.37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484E-4AD9-A9AA-15FEB2A4FBA8}"/>
                  </c:ext>
                </c:extLst>
              </c15:ser>
            </c15:filteredScatterSeries>
          </c:ext>
        </c:extLst>
      </c:scatterChart>
      <c:valAx>
        <c:axId val="1507404447"/>
        <c:scaling>
          <c:orientation val="minMax"/>
          <c:max val="700"/>
          <c:min val="22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507405279"/>
        <c:crosses val="autoZero"/>
        <c:crossBetween val="midCat"/>
        <c:majorUnit val="80"/>
      </c:valAx>
      <c:valAx>
        <c:axId val="1507405279"/>
        <c:scaling>
          <c:orientation val="minMax"/>
          <c:max val="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507404447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5500684969839431"/>
          <c:y val="4.8807886713692017E-2"/>
          <c:w val="0.40781660490177235"/>
          <c:h val="0.263091972948302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5358705161854769E-2"/>
          <c:y val="5.0925925925925923E-2"/>
          <c:w val="0.93464129483814529"/>
          <c:h val="0.8648228346456693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31B-4012-BD0E-60E00DA0AE34}"/>
              </c:ext>
            </c:extLst>
          </c:dPt>
          <c:dPt>
            <c:idx val="1"/>
            <c:invertIfNegative val="0"/>
            <c:bubble3D val="0"/>
            <c:spPr>
              <a:solidFill>
                <a:srgbClr val="ED7D3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31B-4012-BD0E-60E00DA0AE34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31B-4012-BD0E-60E00DA0AE34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31B-4012-BD0E-60E00DA0AE34}"/>
              </c:ext>
            </c:extLst>
          </c:dPt>
          <c:errBars>
            <c:errBarType val="both"/>
            <c:errValType val="cust"/>
            <c:noEndCap val="1"/>
            <c:plus>
              <c:numRef>
                <c:f>鲜重!$R$40:$T$40</c:f>
                <c:numCache>
                  <c:formatCode>General</c:formatCode>
                  <c:ptCount val="3"/>
                  <c:pt idx="0">
                    <c:v>9.2137907179368803E-2</c:v>
                  </c:pt>
                  <c:pt idx="1">
                    <c:v>0.1219472714997714</c:v>
                  </c:pt>
                  <c:pt idx="2">
                    <c:v>9.9136211034073121E-2</c:v>
                  </c:pt>
                </c:numCache>
              </c:numRef>
            </c:plus>
            <c:minus>
              <c:numRef>
                <c:f>鲜重!$R$40:$T$40</c:f>
                <c:numCache>
                  <c:formatCode>General</c:formatCode>
                  <c:ptCount val="3"/>
                  <c:pt idx="0">
                    <c:v>9.2137907179368803E-2</c:v>
                  </c:pt>
                  <c:pt idx="1">
                    <c:v>0.1219472714997714</c:v>
                  </c:pt>
                  <c:pt idx="2">
                    <c:v>9.9136211034073121E-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鲜重!$R$38:$T$38</c:f>
              <c:strCache>
                <c:ptCount val="3"/>
                <c:pt idx="0">
                  <c:v>Control</c:v>
                </c:pt>
                <c:pt idx="1">
                  <c:v>CeCl3</c:v>
                </c:pt>
                <c:pt idx="2">
                  <c:v>MnCl2</c:v>
                </c:pt>
              </c:strCache>
            </c:strRef>
          </c:cat>
          <c:val>
            <c:numRef>
              <c:f>鲜重!$R$39:$T$39</c:f>
              <c:numCache>
                <c:formatCode>General</c:formatCode>
                <c:ptCount val="3"/>
                <c:pt idx="0">
                  <c:v>1.75</c:v>
                </c:pt>
                <c:pt idx="1">
                  <c:v>1.7914285714285716</c:v>
                </c:pt>
                <c:pt idx="2">
                  <c:v>1.85571428571428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31B-4012-BD0E-60E00DA0AE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86278256"/>
        <c:axId val="186279504"/>
      </c:barChart>
      <c:catAx>
        <c:axId val="186278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9504"/>
        <c:crosses val="autoZero"/>
        <c:auto val="1"/>
        <c:lblAlgn val="ctr"/>
        <c:lblOffset val="100"/>
        <c:noMultiLvlLbl val="0"/>
      </c:catAx>
      <c:valAx>
        <c:axId val="18627950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8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5358705161854769E-2"/>
          <c:y val="5.0925925925925923E-2"/>
          <c:w val="0.93464129483814529"/>
          <c:h val="0.8648228346456693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EF0-4CD9-A81F-200912C6977D}"/>
              </c:ext>
            </c:extLst>
          </c:dPt>
          <c:dPt>
            <c:idx val="1"/>
            <c:invertIfNegative val="0"/>
            <c:bubble3D val="0"/>
            <c:spPr>
              <a:solidFill>
                <a:srgbClr val="ED7D3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EF0-4CD9-A81F-200912C6977D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EF0-4CD9-A81F-200912C6977D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EF0-4CD9-A81F-200912C6977D}"/>
              </c:ext>
            </c:extLst>
          </c:dPt>
          <c:errBars>
            <c:errBarType val="both"/>
            <c:errValType val="cust"/>
            <c:noEndCap val="1"/>
            <c:plus>
              <c:numRef>
                <c:f>'Sheet1 (2)'!$D$41:$F$41</c:f>
                <c:numCache>
                  <c:formatCode>General</c:formatCode>
                  <c:ptCount val="3"/>
                  <c:pt idx="0">
                    <c:v>1.196847180924961</c:v>
                  </c:pt>
                  <c:pt idx="1">
                    <c:v>3.8973343027840079</c:v>
                  </c:pt>
                  <c:pt idx="2">
                    <c:v>2.3743620757855091</c:v>
                  </c:pt>
                </c:numCache>
              </c:numRef>
            </c:plus>
            <c:minus>
              <c:numRef>
                <c:f>'Sheet1 (2)'!$D$41:$F$41</c:f>
                <c:numCache>
                  <c:formatCode>General</c:formatCode>
                  <c:ptCount val="3"/>
                  <c:pt idx="0">
                    <c:v>1.196847180924961</c:v>
                  </c:pt>
                  <c:pt idx="1">
                    <c:v>3.8973343027840079</c:v>
                  </c:pt>
                  <c:pt idx="2">
                    <c:v>2.3743620757855091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Sheet1 (2)'!$D$39:$F$39</c:f>
              <c:strCache>
                <c:ptCount val="3"/>
                <c:pt idx="0">
                  <c:v>Control</c:v>
                </c:pt>
                <c:pt idx="1">
                  <c:v>CeCl3</c:v>
                </c:pt>
                <c:pt idx="2">
                  <c:v>MnCl2</c:v>
                </c:pt>
              </c:strCache>
            </c:strRef>
          </c:cat>
          <c:val>
            <c:numRef>
              <c:f>'Sheet1 (2)'!$D$40:$F$40</c:f>
              <c:numCache>
                <c:formatCode>General</c:formatCode>
                <c:ptCount val="3"/>
                <c:pt idx="0">
                  <c:v>9.5619104989371557</c:v>
                </c:pt>
                <c:pt idx="1">
                  <c:v>12.758888144236856</c:v>
                </c:pt>
                <c:pt idx="2">
                  <c:v>10.2308192153754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EF0-4CD9-A81F-200912C697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86278256"/>
        <c:axId val="186279504"/>
      </c:barChart>
      <c:catAx>
        <c:axId val="186278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9504"/>
        <c:crosses val="autoZero"/>
        <c:auto val="1"/>
        <c:lblAlgn val="ctr"/>
        <c:lblOffset val="100"/>
        <c:noMultiLvlLbl val="0"/>
      </c:catAx>
      <c:valAx>
        <c:axId val="186279504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8256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5358705161854769E-2"/>
          <c:y val="5.0925925925925923E-2"/>
          <c:w val="0.93464129483814529"/>
          <c:h val="0.864822834645669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AB-COMBINE'!$N$21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F39-43FC-B90D-E99C69E27469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5F39-43FC-B90D-E99C69E27469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5F39-43FC-B90D-E99C69E27469}"/>
              </c:ext>
            </c:extLst>
          </c:dPt>
          <c:errBars>
            <c:errBarType val="both"/>
            <c:errValType val="cust"/>
            <c:noEndCap val="1"/>
            <c:plus>
              <c:numRef>
                <c:f>'DAB-COMBINE'!$N$28:$N$29</c:f>
                <c:numCache>
                  <c:formatCode>General</c:formatCode>
                  <c:ptCount val="2"/>
                  <c:pt idx="0">
                    <c:v>13.378777146164387</c:v>
                  </c:pt>
                  <c:pt idx="1">
                    <c:v>2.638476038929666</c:v>
                  </c:pt>
                </c:numCache>
              </c:numRef>
            </c:plus>
            <c:minus>
              <c:numRef>
                <c:f>'DAB-COMBINE'!$N$28:$N$29</c:f>
                <c:numCache>
                  <c:formatCode>General</c:formatCode>
                  <c:ptCount val="2"/>
                  <c:pt idx="0">
                    <c:v>13.378777146164387</c:v>
                  </c:pt>
                  <c:pt idx="1">
                    <c:v>2.638476038929666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DAB-COMBINE'!$M$22:$M$23</c:f>
              <c:strCache>
                <c:ptCount val="2"/>
                <c:pt idx="0">
                  <c:v>DAB dye</c:v>
                </c:pt>
                <c:pt idx="1">
                  <c:v>NBT dye</c:v>
                </c:pt>
              </c:strCache>
            </c:strRef>
          </c:cat>
          <c:val>
            <c:numRef>
              <c:f>'DAB-COMBINE'!$N$22:$N$23</c:f>
              <c:numCache>
                <c:formatCode>General</c:formatCode>
                <c:ptCount val="2"/>
                <c:pt idx="0">
                  <c:v>84.66699620128756</c:v>
                </c:pt>
                <c:pt idx="1">
                  <c:v>43.8902853443687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F39-43FC-B90D-E99C69E27469}"/>
            </c:ext>
          </c:extLst>
        </c:ser>
        <c:ser>
          <c:idx val="1"/>
          <c:order val="1"/>
          <c:tx>
            <c:strRef>
              <c:f>'DAB-COMBINE'!$O$21</c:f>
              <c:strCache>
                <c:ptCount val="1"/>
                <c:pt idx="0">
                  <c:v>CeCl3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ED7D3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860F-4D86-8B55-2318782A25BA}"/>
              </c:ext>
            </c:extLst>
          </c:dPt>
          <c:errBars>
            <c:errBarType val="both"/>
            <c:errValType val="cust"/>
            <c:noEndCap val="1"/>
            <c:plus>
              <c:numRef>
                <c:f>'DAB-COMBINE'!$O$28:$O$29</c:f>
                <c:numCache>
                  <c:formatCode>General</c:formatCode>
                  <c:ptCount val="2"/>
                  <c:pt idx="0">
                    <c:v>13.990017230497607</c:v>
                  </c:pt>
                  <c:pt idx="1">
                    <c:v>8.8615590178325352</c:v>
                  </c:pt>
                </c:numCache>
              </c:numRef>
            </c:plus>
            <c:minus>
              <c:numRef>
                <c:f>'DAB-COMBINE'!$O$28:$O$29</c:f>
                <c:numCache>
                  <c:formatCode>General</c:formatCode>
                  <c:ptCount val="2"/>
                  <c:pt idx="0">
                    <c:v>13.990017230497607</c:v>
                  </c:pt>
                  <c:pt idx="1">
                    <c:v>8.861559017832535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DAB-COMBINE'!$M$22:$M$23</c:f>
              <c:strCache>
                <c:ptCount val="2"/>
                <c:pt idx="0">
                  <c:v>DAB dye</c:v>
                </c:pt>
                <c:pt idx="1">
                  <c:v>NBT dye</c:v>
                </c:pt>
              </c:strCache>
            </c:strRef>
          </c:cat>
          <c:val>
            <c:numRef>
              <c:f>'DAB-COMBINE'!$O$22:$O$23</c:f>
              <c:numCache>
                <c:formatCode>General</c:formatCode>
                <c:ptCount val="2"/>
                <c:pt idx="0">
                  <c:v>57.114057832285177</c:v>
                </c:pt>
                <c:pt idx="1">
                  <c:v>54.8697291963605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F39-43FC-B90D-E99C69E27469}"/>
            </c:ext>
          </c:extLst>
        </c:ser>
        <c:ser>
          <c:idx val="2"/>
          <c:order val="2"/>
          <c:tx>
            <c:strRef>
              <c:f>'DAB-COMBINE'!$P$21</c:f>
              <c:strCache>
                <c:ptCount val="1"/>
                <c:pt idx="0">
                  <c:v>MnCl2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DAB-COMBINE'!$P$28:$P$29</c:f>
                <c:numCache>
                  <c:formatCode>General</c:formatCode>
                  <c:ptCount val="2"/>
                  <c:pt idx="0">
                    <c:v>12.12862205983931</c:v>
                  </c:pt>
                  <c:pt idx="1">
                    <c:v>8.5566374507634588</c:v>
                  </c:pt>
                </c:numCache>
              </c:numRef>
            </c:plus>
            <c:minus>
              <c:numRef>
                <c:f>'DAB-COMBINE'!$P$28:$P$29</c:f>
                <c:numCache>
                  <c:formatCode>General</c:formatCode>
                  <c:ptCount val="2"/>
                  <c:pt idx="0">
                    <c:v>12.12862205983931</c:v>
                  </c:pt>
                  <c:pt idx="1">
                    <c:v>8.5566374507634588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DAB-COMBINE'!$M$22:$M$23</c:f>
              <c:strCache>
                <c:ptCount val="2"/>
                <c:pt idx="0">
                  <c:v>DAB dye</c:v>
                </c:pt>
                <c:pt idx="1">
                  <c:v>NBT dye</c:v>
                </c:pt>
              </c:strCache>
            </c:strRef>
          </c:cat>
          <c:val>
            <c:numRef>
              <c:f>'DAB-COMBINE'!$P$22:$P$23</c:f>
              <c:numCache>
                <c:formatCode>General</c:formatCode>
                <c:ptCount val="2"/>
                <c:pt idx="0">
                  <c:v>67.632999999999996</c:v>
                </c:pt>
                <c:pt idx="1">
                  <c:v>38.310439933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F39-43FC-B90D-E99C69E274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86278256"/>
        <c:axId val="186279504"/>
      </c:barChart>
      <c:catAx>
        <c:axId val="186278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9504"/>
        <c:crosses val="autoZero"/>
        <c:auto val="1"/>
        <c:lblAlgn val="ctr"/>
        <c:lblOffset val="100"/>
        <c:noMultiLvlLbl val="0"/>
      </c:catAx>
      <c:valAx>
        <c:axId val="186279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82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4716618441615201"/>
          <c:y val="0.11215751307265515"/>
          <c:w val="0.2238562666344355"/>
          <c:h val="0.2573437646344948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5358705161854769E-2"/>
          <c:y val="5.0925925925925923E-2"/>
          <c:w val="0.93464129483814529"/>
          <c:h val="0.8648228346456693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68E-4628-A79E-B6C531717D3B}"/>
              </c:ext>
            </c:extLst>
          </c:dPt>
          <c:dPt>
            <c:idx val="1"/>
            <c:invertIfNegative val="0"/>
            <c:bubble3D val="0"/>
            <c:spPr>
              <a:solidFill>
                <a:srgbClr val="ED7D31"/>
              </a:solidFill>
              <a:ln w="12700">
                <a:solidFill>
                  <a:srgbClr val="ED7D3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68E-4628-A79E-B6C531717D3B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4075-43D2-A945-2F5BF861A438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68E-4628-A79E-B6C531717D3B}"/>
              </c:ext>
            </c:extLst>
          </c:dPt>
          <c:errBars>
            <c:errBarType val="both"/>
            <c:errValType val="cust"/>
            <c:noEndCap val="1"/>
            <c:plus>
              <c:numRef>
                <c:f>整合!$O$37:$Q$37</c:f>
                <c:numCache>
                  <c:formatCode>General</c:formatCode>
                  <c:ptCount val="3"/>
                  <c:pt idx="0">
                    <c:v>0.35253112184291013</c:v>
                  </c:pt>
                  <c:pt idx="1">
                    <c:v>0.28750452785556996</c:v>
                  </c:pt>
                  <c:pt idx="2">
                    <c:v>0.41493417609622368</c:v>
                  </c:pt>
                </c:numCache>
              </c:numRef>
            </c:plus>
            <c:minus>
              <c:numRef>
                <c:f>整合!$O$37:$Q$37</c:f>
                <c:numCache>
                  <c:formatCode>General</c:formatCode>
                  <c:ptCount val="3"/>
                  <c:pt idx="0">
                    <c:v>0.35253112184291013</c:v>
                  </c:pt>
                  <c:pt idx="1">
                    <c:v>0.28750452785556996</c:v>
                  </c:pt>
                  <c:pt idx="2">
                    <c:v>0.41493417609622368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整合!$O$35:$Q$35</c:f>
              <c:strCache>
                <c:ptCount val="3"/>
                <c:pt idx="0">
                  <c:v>Control</c:v>
                </c:pt>
                <c:pt idx="1">
                  <c:v>CeCl3</c:v>
                </c:pt>
                <c:pt idx="2">
                  <c:v>MnCl2</c:v>
                </c:pt>
              </c:strCache>
            </c:strRef>
          </c:cat>
          <c:val>
            <c:numRef>
              <c:f>整合!$O$36:$Q$36</c:f>
              <c:numCache>
                <c:formatCode>General</c:formatCode>
                <c:ptCount val="3"/>
                <c:pt idx="0">
                  <c:v>3.8052695374257359</c:v>
                </c:pt>
                <c:pt idx="1">
                  <c:v>3.3518458549222796</c:v>
                </c:pt>
                <c:pt idx="2">
                  <c:v>3.1009141494435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68E-4628-A79E-B6C531717D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86278256"/>
        <c:axId val="186279504"/>
      </c:barChart>
      <c:catAx>
        <c:axId val="186278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9504"/>
        <c:crosses val="autoZero"/>
        <c:auto val="1"/>
        <c:lblAlgn val="ctr"/>
        <c:lblOffset val="100"/>
        <c:noMultiLvlLbl val="0"/>
      </c:catAx>
      <c:valAx>
        <c:axId val="186279504"/>
        <c:scaling>
          <c:orientation val="minMax"/>
          <c:max val="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825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5358705161854769E-2"/>
          <c:y val="5.0925925925925923E-2"/>
          <c:w val="0.93464129483814529"/>
          <c:h val="0.8648228346456693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BE6-44E9-BDE7-F8F7DB6EB0C0}"/>
              </c:ext>
            </c:extLst>
          </c:dPt>
          <c:dPt>
            <c:idx val="1"/>
            <c:invertIfNegative val="0"/>
            <c:bubble3D val="0"/>
            <c:spPr>
              <a:solidFill>
                <a:srgbClr val="ED7D3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BE6-44E9-BDE7-F8F7DB6EB0C0}"/>
              </c:ext>
            </c:extLst>
          </c:dPt>
          <c:dPt>
            <c:idx val="2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DC8C-4E42-A0D9-78C58CBD1BA9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BE6-44E9-BDE7-F8F7DB6EB0C0}"/>
              </c:ext>
            </c:extLst>
          </c:dPt>
          <c:errBars>
            <c:errBarType val="both"/>
            <c:errValType val="cust"/>
            <c:noEndCap val="1"/>
            <c:plus>
              <c:numRef>
                <c:f>超氧阴离子整合!$M$19:$O$19</c:f>
                <c:numCache>
                  <c:formatCode>General</c:formatCode>
                  <c:ptCount val="3"/>
                  <c:pt idx="0">
                    <c:v>2.8146109467500731</c:v>
                  </c:pt>
                  <c:pt idx="1">
                    <c:v>2.5623317197393431</c:v>
                  </c:pt>
                  <c:pt idx="2">
                    <c:v>1.2083819473106037</c:v>
                  </c:pt>
                </c:numCache>
              </c:numRef>
            </c:plus>
            <c:minus>
              <c:numRef>
                <c:f>超氧阴离子整合!$M$19:$O$19</c:f>
                <c:numCache>
                  <c:formatCode>General</c:formatCode>
                  <c:ptCount val="3"/>
                  <c:pt idx="0">
                    <c:v>2.8146109467500731</c:v>
                  </c:pt>
                  <c:pt idx="1">
                    <c:v>2.5623317197393431</c:v>
                  </c:pt>
                  <c:pt idx="2">
                    <c:v>1.2083819473106037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超氧阴离子整合!$M$17:$O$17</c:f>
              <c:strCache>
                <c:ptCount val="3"/>
                <c:pt idx="0">
                  <c:v>Control</c:v>
                </c:pt>
                <c:pt idx="1">
                  <c:v>CeCl3</c:v>
                </c:pt>
                <c:pt idx="2">
                  <c:v>MnCl2</c:v>
                </c:pt>
              </c:strCache>
            </c:strRef>
          </c:cat>
          <c:val>
            <c:numRef>
              <c:f>超氧阴离子整合!$M$18:$O$18</c:f>
              <c:numCache>
                <c:formatCode>General</c:formatCode>
                <c:ptCount val="3"/>
                <c:pt idx="0">
                  <c:v>42.620683654785047</c:v>
                </c:pt>
                <c:pt idx="1">
                  <c:v>43.327216704174546</c:v>
                </c:pt>
                <c:pt idx="2">
                  <c:v>38.2805161932352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BE6-44E9-BDE7-F8F7DB6EB0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86278256"/>
        <c:axId val="186279504"/>
      </c:barChart>
      <c:catAx>
        <c:axId val="186278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9504"/>
        <c:crosses val="autoZero"/>
        <c:auto val="1"/>
        <c:lblAlgn val="ctr"/>
        <c:lblOffset val="100"/>
        <c:noMultiLvlLbl val="0"/>
      </c:catAx>
      <c:valAx>
        <c:axId val="186279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8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5358705161854769E-2"/>
          <c:y val="5.0925925925925923E-2"/>
          <c:w val="0.93464129483814529"/>
          <c:h val="0.8648228346456693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DFA-475F-8641-8F04221B7C90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DFA-475F-8641-8F04221B7C90}"/>
              </c:ext>
            </c:extLst>
          </c:dPt>
          <c:dPt>
            <c:idx val="2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FDFA-475F-8641-8F04221B7C90}"/>
              </c:ext>
            </c:extLst>
          </c:dPt>
          <c:dPt>
            <c:idx val="3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FDFA-475F-8641-8F04221B7C90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8-6293-4CD0-A5A8-2AC5347E96F6}"/>
              </c:ext>
            </c:extLst>
          </c:dPt>
          <c:errBars>
            <c:errBarType val="both"/>
            <c:errValType val="cust"/>
            <c:noEndCap val="1"/>
            <c:plus>
              <c:numRef>
                <c:f>鲜重!$E$32:$I$32</c:f>
                <c:numCache>
                  <c:formatCode>General</c:formatCode>
                  <c:ptCount val="5"/>
                  <c:pt idx="0">
                    <c:v>0.36570644471174385</c:v>
                  </c:pt>
                  <c:pt idx="1">
                    <c:v>0.59333333333333516</c:v>
                  </c:pt>
                  <c:pt idx="2">
                    <c:v>0.63283313580894196</c:v>
                  </c:pt>
                  <c:pt idx="3">
                    <c:v>1.0436953578511319</c:v>
                  </c:pt>
                  <c:pt idx="4">
                    <c:v>0.41780677352097095</c:v>
                  </c:pt>
                </c:numCache>
              </c:numRef>
            </c:plus>
            <c:minus>
              <c:numRef>
                <c:f>鲜重!$E$32:$I$32</c:f>
                <c:numCache>
                  <c:formatCode>General</c:formatCode>
                  <c:ptCount val="5"/>
                  <c:pt idx="0">
                    <c:v>0.36570644471174385</c:v>
                  </c:pt>
                  <c:pt idx="1">
                    <c:v>0.59333333333333516</c:v>
                  </c:pt>
                  <c:pt idx="2">
                    <c:v>0.63283313580894196</c:v>
                  </c:pt>
                  <c:pt idx="3">
                    <c:v>1.0436953578511319</c:v>
                  </c:pt>
                  <c:pt idx="4">
                    <c:v>0.41780677352097095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鲜重!$H$37:$L$37</c:f>
              <c:strCache>
                <c:ptCount val="5"/>
                <c:pt idx="0">
                  <c:v>Control</c:v>
                </c:pt>
                <c:pt idx="1">
                  <c:v>PNC</c:v>
                </c:pt>
                <c:pt idx="2">
                  <c:v>PMO</c:v>
                </c:pt>
                <c:pt idx="3">
                  <c:v>CeCl3</c:v>
                </c:pt>
                <c:pt idx="4">
                  <c:v>MnCl2</c:v>
                </c:pt>
              </c:strCache>
            </c:strRef>
          </c:cat>
          <c:val>
            <c:numRef>
              <c:f>鲜重!$H$38:$L$38</c:f>
              <c:numCache>
                <c:formatCode>General</c:formatCode>
                <c:ptCount val="5"/>
                <c:pt idx="0">
                  <c:v>4.8983333333333334</c:v>
                </c:pt>
                <c:pt idx="1">
                  <c:v>5.4633333333333338</c:v>
                </c:pt>
                <c:pt idx="2">
                  <c:v>4.1633333333333331</c:v>
                </c:pt>
                <c:pt idx="3">
                  <c:v>5.43</c:v>
                </c:pt>
                <c:pt idx="4">
                  <c:v>4.234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DFA-475F-8641-8F04221B7C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86278256"/>
        <c:axId val="186279504"/>
      </c:barChart>
      <c:catAx>
        <c:axId val="186278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9504"/>
        <c:crosses val="autoZero"/>
        <c:auto val="1"/>
        <c:lblAlgn val="ctr"/>
        <c:lblOffset val="100"/>
        <c:noMultiLvlLbl val="0"/>
      </c:catAx>
      <c:valAx>
        <c:axId val="186279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8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5358705161854769E-2"/>
          <c:y val="5.0925925925925923E-2"/>
          <c:w val="0.93464129483814529"/>
          <c:h val="0.864822834645669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yelvsu '!$G$1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4B0-471F-A327-51A72F89CDAA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44B0-471F-A327-51A72F89CDAA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44B0-471F-A327-51A72F89CDAA}"/>
              </c:ext>
            </c:extLst>
          </c:dPt>
          <c:errBars>
            <c:errBarType val="both"/>
            <c:errValType val="cust"/>
            <c:noEndCap val="1"/>
            <c:plus>
              <c:numRef>
                <c:f>'yelvsu '!$G$25:$G$26</c:f>
                <c:numCache>
                  <c:formatCode>General</c:formatCode>
                  <c:ptCount val="2"/>
                  <c:pt idx="0">
                    <c:v>0.61919096848946287</c:v>
                  </c:pt>
                  <c:pt idx="1">
                    <c:v>0.24421847757881904</c:v>
                  </c:pt>
                </c:numCache>
              </c:numRef>
            </c:plus>
            <c:minus>
              <c:numRef>
                <c:f>'yelvsu '!$G$25:$G$26</c:f>
                <c:numCache>
                  <c:formatCode>General</c:formatCode>
                  <c:ptCount val="2"/>
                  <c:pt idx="0">
                    <c:v>0.61919096848946287</c:v>
                  </c:pt>
                  <c:pt idx="1">
                    <c:v>0.24421847757881904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yelvsu '!$F$19:$F$20</c:f>
              <c:strCache>
                <c:ptCount val="2"/>
                <c:pt idx="0">
                  <c:v>Chl.a</c:v>
                </c:pt>
                <c:pt idx="1">
                  <c:v>Chl.b</c:v>
                </c:pt>
              </c:strCache>
            </c:strRef>
          </c:cat>
          <c:val>
            <c:numRef>
              <c:f>'yelvsu '!$G$19:$G$20</c:f>
              <c:numCache>
                <c:formatCode>General</c:formatCode>
                <c:ptCount val="2"/>
                <c:pt idx="0">
                  <c:v>6.3795605000000002</c:v>
                </c:pt>
                <c:pt idx="1">
                  <c:v>2.1713734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4B0-471F-A327-51A72F89CDAA}"/>
            </c:ext>
          </c:extLst>
        </c:ser>
        <c:ser>
          <c:idx val="1"/>
          <c:order val="1"/>
          <c:tx>
            <c:strRef>
              <c:f>'yelvsu '!$H$18</c:f>
              <c:strCache>
                <c:ptCount val="1"/>
                <c:pt idx="0">
                  <c:v>PNC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yelvsu '!$H$25:$H$26</c:f>
                <c:numCache>
                  <c:formatCode>General</c:formatCode>
                  <c:ptCount val="2"/>
                  <c:pt idx="0">
                    <c:v>0.20676981897363772</c:v>
                  </c:pt>
                  <c:pt idx="1">
                    <c:v>0.18397395866189412</c:v>
                  </c:pt>
                </c:numCache>
              </c:numRef>
            </c:plus>
            <c:minus>
              <c:numRef>
                <c:f>'yelvsu '!$H$25:$H$26</c:f>
                <c:numCache>
                  <c:formatCode>General</c:formatCode>
                  <c:ptCount val="2"/>
                  <c:pt idx="0">
                    <c:v>0.20676981897363772</c:v>
                  </c:pt>
                  <c:pt idx="1">
                    <c:v>0.1839739586618941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yelvsu '!$F$19:$F$20</c:f>
              <c:strCache>
                <c:ptCount val="2"/>
                <c:pt idx="0">
                  <c:v>Chl.a</c:v>
                </c:pt>
                <c:pt idx="1">
                  <c:v>Chl.b</c:v>
                </c:pt>
              </c:strCache>
            </c:strRef>
          </c:cat>
          <c:val>
            <c:numRef>
              <c:f>'yelvsu '!$H$19:$H$20</c:f>
              <c:numCache>
                <c:formatCode>General</c:formatCode>
                <c:ptCount val="2"/>
                <c:pt idx="0">
                  <c:v>6.0737587992501076</c:v>
                </c:pt>
                <c:pt idx="1">
                  <c:v>2.37264756825861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44B0-471F-A327-51A72F89CDAA}"/>
            </c:ext>
          </c:extLst>
        </c:ser>
        <c:ser>
          <c:idx val="2"/>
          <c:order val="2"/>
          <c:tx>
            <c:strRef>
              <c:f>'yelvsu '!$I$18</c:f>
              <c:strCache>
                <c:ptCount val="1"/>
                <c:pt idx="0">
                  <c:v>PMO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yelvsu '!$I$25:$I$26</c:f>
                <c:numCache>
                  <c:formatCode>General</c:formatCode>
                  <c:ptCount val="2"/>
                  <c:pt idx="0">
                    <c:v>0.66290547257807686</c:v>
                  </c:pt>
                  <c:pt idx="1">
                    <c:v>0.1468429131659493</c:v>
                  </c:pt>
                </c:numCache>
              </c:numRef>
            </c:plus>
            <c:minus>
              <c:numRef>
                <c:f>'yelvsu '!$I$25:$I$26</c:f>
                <c:numCache>
                  <c:formatCode>General</c:formatCode>
                  <c:ptCount val="2"/>
                  <c:pt idx="0">
                    <c:v>0.66290547257807686</c:v>
                  </c:pt>
                  <c:pt idx="1">
                    <c:v>0.1468429131659493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yelvsu '!$F$19:$F$20</c:f>
              <c:strCache>
                <c:ptCount val="2"/>
                <c:pt idx="0">
                  <c:v>Chl.a</c:v>
                </c:pt>
                <c:pt idx="1">
                  <c:v>Chl.b</c:v>
                </c:pt>
              </c:strCache>
            </c:strRef>
          </c:cat>
          <c:val>
            <c:numRef>
              <c:f>'yelvsu '!$I$19:$I$20</c:f>
              <c:numCache>
                <c:formatCode>General</c:formatCode>
                <c:ptCount val="2"/>
                <c:pt idx="0">
                  <c:v>6.7598543333333332</c:v>
                </c:pt>
                <c:pt idx="1">
                  <c:v>2.29715624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4B0-471F-A327-51A72F89CDAA}"/>
            </c:ext>
          </c:extLst>
        </c:ser>
        <c:ser>
          <c:idx val="3"/>
          <c:order val="3"/>
          <c:tx>
            <c:strRef>
              <c:f>'yelvsu '!$J$18</c:f>
              <c:strCache>
                <c:ptCount val="1"/>
                <c:pt idx="0">
                  <c:v>CeCl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yelvsu '!$J$25:$J$26</c:f>
                <c:numCache>
                  <c:formatCode>General</c:formatCode>
                  <c:ptCount val="2"/>
                  <c:pt idx="0">
                    <c:v>0.77509547499870701</c:v>
                  </c:pt>
                  <c:pt idx="1">
                    <c:v>0.23801351398251389</c:v>
                  </c:pt>
                </c:numCache>
              </c:numRef>
            </c:plus>
            <c:minus>
              <c:numRef>
                <c:f>'yelvsu '!$J$25:$J$26</c:f>
                <c:numCache>
                  <c:formatCode>General</c:formatCode>
                  <c:ptCount val="2"/>
                  <c:pt idx="0">
                    <c:v>0.77509547499870701</c:v>
                  </c:pt>
                  <c:pt idx="1">
                    <c:v>0.23801351398251389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yelvsu '!$F$19:$F$20</c:f>
              <c:strCache>
                <c:ptCount val="2"/>
                <c:pt idx="0">
                  <c:v>Chl.a</c:v>
                </c:pt>
                <c:pt idx="1">
                  <c:v>Chl.b</c:v>
                </c:pt>
              </c:strCache>
            </c:strRef>
          </c:cat>
          <c:val>
            <c:numRef>
              <c:f>'yelvsu '!$J$19:$J$20</c:f>
              <c:numCache>
                <c:formatCode>General</c:formatCode>
                <c:ptCount val="2"/>
                <c:pt idx="0">
                  <c:v>6.9221364281545643</c:v>
                </c:pt>
                <c:pt idx="1">
                  <c:v>2.7221024580636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44B0-471F-A327-51A72F89CDAA}"/>
            </c:ext>
          </c:extLst>
        </c:ser>
        <c:ser>
          <c:idx val="4"/>
          <c:order val="4"/>
          <c:tx>
            <c:strRef>
              <c:f>'yelvsu '!$K$18</c:f>
              <c:strCache>
                <c:ptCount val="1"/>
                <c:pt idx="0">
                  <c:v>MnCl2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yelvsu '!$K$25:$K$26</c:f>
                <c:numCache>
                  <c:formatCode>General</c:formatCode>
                  <c:ptCount val="2"/>
                  <c:pt idx="0">
                    <c:v>0.42458128489092417</c:v>
                  </c:pt>
                  <c:pt idx="1">
                    <c:v>9.3118255468516903E-2</c:v>
                  </c:pt>
                </c:numCache>
              </c:numRef>
            </c:plus>
            <c:minus>
              <c:numRef>
                <c:f>'yelvsu '!$K$25:$K$26</c:f>
                <c:numCache>
                  <c:formatCode>General</c:formatCode>
                  <c:ptCount val="2"/>
                  <c:pt idx="0">
                    <c:v>0.42458128489092417</c:v>
                  </c:pt>
                  <c:pt idx="1">
                    <c:v>9.3118255468516903E-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yelvsu '!$F$19:$F$20</c:f>
              <c:strCache>
                <c:ptCount val="2"/>
                <c:pt idx="0">
                  <c:v>Chl.a</c:v>
                </c:pt>
                <c:pt idx="1">
                  <c:v>Chl.b</c:v>
                </c:pt>
              </c:strCache>
            </c:strRef>
          </c:cat>
          <c:val>
            <c:numRef>
              <c:f>'yelvsu '!$K$19:$K$20</c:f>
              <c:numCache>
                <c:formatCode>General</c:formatCode>
                <c:ptCount val="2"/>
                <c:pt idx="0">
                  <c:v>6.1907606666666668</c:v>
                </c:pt>
                <c:pt idx="1">
                  <c:v>2.195434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4B0-471F-A327-51A72F89CD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86278256"/>
        <c:axId val="186279504"/>
      </c:barChart>
      <c:catAx>
        <c:axId val="186278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9504"/>
        <c:crosses val="autoZero"/>
        <c:auto val="1"/>
        <c:lblAlgn val="ctr"/>
        <c:lblOffset val="100"/>
        <c:noMultiLvlLbl val="0"/>
      </c:catAx>
      <c:valAx>
        <c:axId val="186279504"/>
        <c:scaling>
          <c:orientation val="minMax"/>
          <c:max val="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6278256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8907754471462421"/>
          <c:y val="1.7965350807659115E-2"/>
          <c:w val="0.18475466909611504"/>
          <c:h val="0.4771596293751871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BFB851-6D85-46ED-B7CD-AFF12A241C1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3FF2EA-5A2E-4366-A357-5888E7ADAB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37306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3980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8241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9118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8461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1336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1887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1513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701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5255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9807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915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07117-0913-43EF-A59C-3D449EEB3877}" type="datetimeFigureOut">
              <a:rPr lang="zh-CN" altLang="en-US" smtClean="0"/>
              <a:t>2022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67AFD-EB6C-4DDE-8845-522EC8DE47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4625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chart" Target="../charts/chart6.xml"/><Relationship Id="rId7" Type="http://schemas.openxmlformats.org/officeDocument/2006/relationships/image" Target="../media/image7.png"/><Relationship Id="rId12" Type="http://schemas.openxmlformats.org/officeDocument/2006/relationships/image" Target="../media/image10.jpg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g"/><Relationship Id="rId11" Type="http://schemas.microsoft.com/office/2007/relationships/hdphoto" Target="../media/hdphoto2.wdp"/><Relationship Id="rId5" Type="http://schemas.openxmlformats.org/officeDocument/2006/relationships/image" Target="../media/image5.jpg"/><Relationship Id="rId10" Type="http://schemas.openxmlformats.org/officeDocument/2006/relationships/image" Target="../media/image9.png"/><Relationship Id="rId4" Type="http://schemas.openxmlformats.org/officeDocument/2006/relationships/chart" Target="../charts/chart7.xml"/><Relationship Id="rId9" Type="http://schemas.openxmlformats.org/officeDocument/2006/relationships/image" Target="../media/image8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F7A6959D-0733-4761-A612-F4D666C94875}"/>
              </a:ext>
            </a:extLst>
          </p:cNvPr>
          <p:cNvGraphicFramePr>
            <a:graphicFrameLocks noGrp="1"/>
          </p:cNvGraphicFramePr>
          <p:nvPr/>
        </p:nvGraphicFramePr>
        <p:xfrm>
          <a:off x="677228" y="4347659"/>
          <a:ext cx="5915025" cy="1541200"/>
        </p:xfrm>
        <a:graphic>
          <a:graphicData uri="http://schemas.openxmlformats.org/drawingml/2006/table">
            <a:tbl>
              <a:tblPr/>
              <a:tblGrid>
                <a:gridCol w="942317">
                  <a:extLst>
                    <a:ext uri="{9D8B030D-6E8A-4147-A177-3AD203B41FA5}">
                      <a16:colId xmlns:a16="http://schemas.microsoft.com/office/drawing/2014/main" val="28396283"/>
                    </a:ext>
                  </a:extLst>
                </a:gridCol>
                <a:gridCol w="2577180">
                  <a:extLst>
                    <a:ext uri="{9D8B030D-6E8A-4147-A177-3AD203B41FA5}">
                      <a16:colId xmlns:a16="http://schemas.microsoft.com/office/drawing/2014/main" val="705667844"/>
                    </a:ext>
                  </a:extLst>
                </a:gridCol>
                <a:gridCol w="2395528">
                  <a:extLst>
                    <a:ext uri="{9D8B030D-6E8A-4147-A177-3AD203B41FA5}">
                      <a16:colId xmlns:a16="http://schemas.microsoft.com/office/drawing/2014/main" val="2189350192"/>
                    </a:ext>
                  </a:extLst>
                </a:gridCol>
              </a:tblGrid>
              <a:tr h="26396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ene name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orward Primer Sequence (5'-3')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everse Primer Sequence (5'-3')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5762131"/>
                  </a:ext>
                </a:extLst>
              </a:tr>
              <a:tr h="2128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naGORK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AGATGGAACAGAAGACCTTG 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CGAGGATGTTGGAGAAAGAC 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1662602"/>
                  </a:ext>
                </a:extLst>
              </a:tr>
              <a:tr h="2128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naHKT1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TCGGTGGTTCTTGGTTATC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AGTGGAGACCGTTGTGAAG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9190587"/>
                  </a:ext>
                </a:extLst>
              </a:tr>
              <a:tr h="2128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naNHX1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ATGCAGGGTTTCAAGT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TCAAAGGTCCCAATGTC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3376992"/>
                  </a:ext>
                </a:extLst>
              </a:tr>
              <a:tr h="2128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naHAK5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CGAGGATGTTGGAGAAAGAC 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CGAGGATGTTGGAGAAAGAC 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3809469"/>
                  </a:ext>
                </a:extLst>
              </a:tr>
              <a:tr h="2128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naSOS1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AAGGAGGAAGTACAGAGATGG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ACTGTAGGCCAGTCAGC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1546840"/>
                  </a:ext>
                </a:extLst>
              </a:tr>
              <a:tr h="2128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tin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GACCGTATGAGCAAAG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ACCGAACCAGAAGGCAG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50077"/>
                  </a:ext>
                </a:extLst>
              </a:tr>
            </a:tbl>
          </a:graphicData>
        </a:graphic>
      </p:graphicFrame>
      <p:sp>
        <p:nvSpPr>
          <p:cNvPr id="3" name="文本框 33">
            <a:extLst>
              <a:ext uri="{FF2B5EF4-FFF2-40B4-BE49-F238E27FC236}">
                <a16:creationId xmlns:a16="http://schemas.microsoft.com/office/drawing/2014/main" id="{60A595FA-D33A-40DB-8B18-CDC021B9BA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7228" y="3994460"/>
            <a:ext cx="452342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Table S1. Primers for quantitative real-time PCR (</a:t>
            </a:r>
            <a:r>
              <a:rPr kumimoji="0" lang="en-US" altLang="zh-CN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qRT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Arial" panose="020B0604020202020204" pitchFamily="34" charset="0"/>
              </a:rPr>
              <a:t>-PCR) analysis.</a:t>
            </a:r>
          </a:p>
        </p:txBody>
      </p:sp>
      <p:sp>
        <p:nvSpPr>
          <p:cNvPr id="4" name="文本框 33">
            <a:extLst>
              <a:ext uri="{FF2B5EF4-FFF2-40B4-BE49-F238E27FC236}">
                <a16:creationId xmlns:a16="http://schemas.microsoft.com/office/drawing/2014/main" id="{C4044BDB-B21F-48D3-9A69-C6DECB5838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9241" y="337972"/>
            <a:ext cx="8230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42341654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33">
            <a:extLst>
              <a:ext uri="{FF2B5EF4-FFF2-40B4-BE49-F238E27FC236}">
                <a16:creationId xmlns:a16="http://schemas.microsoft.com/office/drawing/2014/main" id="{53D53DCE-71C4-4A5D-BB43-C05EC17746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19413" y="1200616"/>
            <a:ext cx="8230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kumimoji="0" lang="en-US" altLang="zh-CN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</a:t>
            </a:r>
            <a:endParaRPr kumimoji="0" lang="en-US" altLang="zh-CN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A0D946C0-3755-8B39-F444-1C3263890795}"/>
              </a:ext>
            </a:extLst>
          </p:cNvPr>
          <p:cNvGrpSpPr/>
          <p:nvPr/>
        </p:nvGrpSpPr>
        <p:grpSpPr>
          <a:xfrm>
            <a:off x="1006357" y="2611609"/>
            <a:ext cx="4438301" cy="4171607"/>
            <a:chOff x="1006357" y="2611609"/>
            <a:chExt cx="4438301" cy="4171607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75A7E711-13EF-33BB-3A1D-E74B7293B53C}"/>
                </a:ext>
              </a:extLst>
            </p:cNvPr>
            <p:cNvGrpSpPr/>
            <p:nvPr/>
          </p:nvGrpSpPr>
          <p:grpSpPr>
            <a:xfrm>
              <a:off x="1006357" y="2611609"/>
              <a:ext cx="4438301" cy="4171607"/>
              <a:chOff x="1189237" y="2709145"/>
              <a:chExt cx="4438301" cy="4171607"/>
            </a:xfrm>
          </p:grpSpPr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B4C50AB0-1B87-46B8-A84D-60EE518F42CF}"/>
                  </a:ext>
                </a:extLst>
              </p:cNvPr>
              <p:cNvSpPr txBox="1"/>
              <p:nvPr/>
            </p:nvSpPr>
            <p:spPr>
              <a:xfrm rot="10800000">
                <a:off x="1194835" y="2882197"/>
                <a:ext cx="338554" cy="12259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bsorbance (</a:t>
                </a:r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.u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.)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6" name="图表 5"/>
              <p:cNvGraphicFramePr>
                <a:graphicFrameLocks/>
              </p:cNvGraphicFramePr>
              <p:nvPr/>
            </p:nvGraphicFramePr>
            <p:xfrm>
              <a:off x="1453356" y="2748445"/>
              <a:ext cx="2465802" cy="187895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pic>
            <p:nvPicPr>
              <p:cNvPr id="11" name="图片 2" descr="469de47449f8694d124fd03c935d5ff">
                <a:extLst>
                  <a:ext uri="{FF2B5EF4-FFF2-40B4-BE49-F238E27FC236}">
                    <a16:creationId xmlns:a16="http://schemas.microsoft.com/office/drawing/2014/main" id="{1B89BD6D-1D5C-42D8-8C85-A1BA930D55C8}"/>
                  </a:ext>
                </a:extLst>
              </p:cNvPr>
              <p:cNvPicPr>
                <a:picLocks noChangeArrowheads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681" t="2353" r="29227" b="14856"/>
              <a:stretch>
                <a:fillRect/>
              </a:stretch>
            </p:blipFill>
            <p:spPr bwMode="auto">
              <a:xfrm>
                <a:off x="4008402" y="2956789"/>
                <a:ext cx="724929" cy="12339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19B3FBF9-7DD6-4DA0-A3F0-7B744FA07766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039" t="2805" r="35762" b="18430"/>
              <a:stretch/>
            </p:blipFill>
            <p:spPr>
              <a:xfrm>
                <a:off x="4777363" y="2956789"/>
                <a:ext cx="769085" cy="1233958"/>
              </a:xfrm>
              <a:prstGeom prst="rect">
                <a:avLst/>
              </a:prstGeom>
            </p:spPr>
          </p:pic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BF6D0F9A-7B22-4099-8191-397303382A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75937" y="5058003"/>
                <a:ext cx="1426356" cy="1531363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7A20D765-46A1-44B9-A2CF-55C6950A7138}"/>
                  </a:ext>
                </a:extLst>
              </p:cNvPr>
              <p:cNvSpPr txBox="1"/>
              <p:nvPr/>
            </p:nvSpPr>
            <p:spPr>
              <a:xfrm rot="16200000">
                <a:off x="4221176" y="4101459"/>
                <a:ext cx="338554" cy="42554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NC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BCD605CB-0CD2-478A-BCE9-1BC7B03BEEEC}"/>
                  </a:ext>
                </a:extLst>
              </p:cNvPr>
              <p:cNvSpPr txBox="1"/>
              <p:nvPr/>
            </p:nvSpPr>
            <p:spPr>
              <a:xfrm rot="16200000">
                <a:off x="5095796" y="3945826"/>
                <a:ext cx="338554" cy="72493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iI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PNC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18" name="图表 17"/>
              <p:cNvGraphicFramePr>
                <a:graphicFrameLocks/>
              </p:cNvGraphicFramePr>
              <p:nvPr/>
            </p:nvGraphicFramePr>
            <p:xfrm>
              <a:off x="1453356" y="5032116"/>
              <a:ext cx="2465802" cy="184269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5B2F1008-76F1-59C0-233F-D379814D065F}"/>
                  </a:ext>
                </a:extLst>
              </p:cNvPr>
              <p:cNvSpPr txBox="1"/>
              <p:nvPr/>
            </p:nvSpPr>
            <p:spPr>
              <a:xfrm>
                <a:off x="1752264" y="2748445"/>
                <a:ext cx="420455" cy="244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B2D80D28-2A5A-2AF4-3876-C3BE1826C02B}"/>
                  </a:ext>
                </a:extLst>
              </p:cNvPr>
              <p:cNvSpPr txBox="1"/>
              <p:nvPr/>
            </p:nvSpPr>
            <p:spPr>
              <a:xfrm>
                <a:off x="3844965" y="2709145"/>
                <a:ext cx="420455" cy="244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D8217312-D023-F65D-1411-5FCA733415D8}"/>
                  </a:ext>
                </a:extLst>
              </p:cNvPr>
              <p:cNvSpPr txBox="1"/>
              <p:nvPr/>
            </p:nvSpPr>
            <p:spPr>
              <a:xfrm rot="10800000">
                <a:off x="1189237" y="5184805"/>
                <a:ext cx="338554" cy="12259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bsorbance (</a:t>
                </a:r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.u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.)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EFEC6585-C917-642D-CE04-F2DFFC23A57E}"/>
                  </a:ext>
                </a:extLst>
              </p:cNvPr>
              <p:cNvSpPr txBox="1"/>
              <p:nvPr/>
            </p:nvSpPr>
            <p:spPr>
              <a:xfrm>
                <a:off x="1717477" y="5049851"/>
                <a:ext cx="420455" cy="244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940F0CCD-256A-16CA-E051-3E705F67A672}"/>
                  </a:ext>
                </a:extLst>
              </p:cNvPr>
              <p:cNvSpPr txBox="1"/>
              <p:nvPr/>
            </p:nvSpPr>
            <p:spPr>
              <a:xfrm rot="16200000">
                <a:off x="4290324" y="6498701"/>
                <a:ext cx="338554" cy="42554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NO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AD24A4B3-608B-B9A4-C7CB-2F80E22C0DB8}"/>
                  </a:ext>
                </a:extLst>
              </p:cNvPr>
              <p:cNvSpPr txBox="1"/>
              <p:nvPr/>
            </p:nvSpPr>
            <p:spPr>
              <a:xfrm rot="16200000">
                <a:off x="5041582" y="6343068"/>
                <a:ext cx="338554" cy="72493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iI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PNO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8292CACE-1C3C-5579-ACD2-329D0C5BD041}"/>
                  </a:ext>
                </a:extLst>
              </p:cNvPr>
              <p:cNvSpPr txBox="1"/>
              <p:nvPr/>
            </p:nvSpPr>
            <p:spPr>
              <a:xfrm>
                <a:off x="3787320" y="4927476"/>
                <a:ext cx="420455" cy="244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d)</a:t>
                </a:r>
              </a:p>
            </p:txBody>
          </p:sp>
        </p:grp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B6ECBA4-01AB-6F39-EAB0-DDCF66055D55}"/>
                </a:ext>
              </a:extLst>
            </p:cNvPr>
            <p:cNvSpPr txBox="1"/>
            <p:nvPr/>
          </p:nvSpPr>
          <p:spPr>
            <a:xfrm rot="16200000">
              <a:off x="2585810" y="5507471"/>
              <a:ext cx="338554" cy="5314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17 nm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383CE4D-6BBA-8CC9-8555-0B1FD35D0D5F}"/>
                </a:ext>
              </a:extLst>
            </p:cNvPr>
            <p:cNvSpPr txBox="1"/>
            <p:nvPr/>
          </p:nvSpPr>
          <p:spPr>
            <a:xfrm rot="16200000">
              <a:off x="3053869" y="5507471"/>
              <a:ext cx="338554" cy="5314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7 nm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ABF27B9F-DC7F-48D7-AFBE-7E6286D59821}"/>
                </a:ext>
              </a:extLst>
            </p:cNvPr>
            <p:cNvSpPr txBox="1"/>
            <p:nvPr/>
          </p:nvSpPr>
          <p:spPr>
            <a:xfrm rot="16200000">
              <a:off x="1785775" y="3002158"/>
              <a:ext cx="338554" cy="5314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71 nm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6D2FFB17-6D02-918E-A7AD-98486DCE9F5A}"/>
                </a:ext>
              </a:extLst>
            </p:cNvPr>
            <p:cNvSpPr txBox="1"/>
            <p:nvPr/>
          </p:nvSpPr>
          <p:spPr>
            <a:xfrm rot="16200000">
              <a:off x="2502920" y="3383503"/>
              <a:ext cx="338554" cy="5314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17 nm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52220D39-0BD3-A0E6-55F0-9A9CE49B862F}"/>
                </a:ext>
              </a:extLst>
            </p:cNvPr>
            <p:cNvSpPr txBox="1"/>
            <p:nvPr/>
          </p:nvSpPr>
          <p:spPr>
            <a:xfrm rot="16200000">
              <a:off x="2975346" y="3331182"/>
              <a:ext cx="338554" cy="5314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7 nm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直接箭头连接符 3">
              <a:extLst>
                <a:ext uri="{FF2B5EF4-FFF2-40B4-BE49-F238E27FC236}">
                  <a16:creationId xmlns:a16="http://schemas.microsoft.com/office/drawing/2014/main" id="{2AFC0555-76D7-00CE-C5EE-D6CB7D7FFB5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09583" y="3320220"/>
              <a:ext cx="60744" cy="16425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箭头连接符 29">
              <a:extLst>
                <a:ext uri="{FF2B5EF4-FFF2-40B4-BE49-F238E27FC236}">
                  <a16:creationId xmlns:a16="http://schemas.microsoft.com/office/drawing/2014/main" id="{C2D813D5-53D6-D73A-9973-5F191CA86F2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773629" y="3699380"/>
              <a:ext cx="17798" cy="16927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箭头连接符 30">
              <a:extLst>
                <a:ext uri="{FF2B5EF4-FFF2-40B4-BE49-F238E27FC236}">
                  <a16:creationId xmlns:a16="http://schemas.microsoft.com/office/drawing/2014/main" id="{BF282B32-4D6B-589B-C6B1-44FD52FBA46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11812" y="3649244"/>
              <a:ext cx="30742" cy="18727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箭头连接符 31">
              <a:extLst>
                <a:ext uri="{FF2B5EF4-FFF2-40B4-BE49-F238E27FC236}">
                  <a16:creationId xmlns:a16="http://schemas.microsoft.com/office/drawing/2014/main" id="{E817C9B8-A49C-6D02-05E2-F9B37EF515A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777434" y="5825533"/>
              <a:ext cx="17798" cy="16927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箭头连接符 32">
              <a:extLst>
                <a:ext uri="{FF2B5EF4-FFF2-40B4-BE49-F238E27FC236}">
                  <a16:creationId xmlns:a16="http://schemas.microsoft.com/office/drawing/2014/main" id="{3137730A-259F-E7CD-971F-E42534A606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14298" y="5816251"/>
              <a:ext cx="64180" cy="1524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88842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513AF64C-442E-E6D8-4010-3BB745F5EC59}"/>
              </a:ext>
            </a:extLst>
          </p:cNvPr>
          <p:cNvGrpSpPr/>
          <p:nvPr/>
        </p:nvGrpSpPr>
        <p:grpSpPr>
          <a:xfrm>
            <a:off x="1763500" y="1450685"/>
            <a:ext cx="2836118" cy="6580307"/>
            <a:chOff x="1763500" y="1718909"/>
            <a:chExt cx="2836118" cy="6580307"/>
          </a:xfrm>
        </p:grpSpPr>
        <p:graphicFrame>
          <p:nvGraphicFramePr>
            <p:cNvPr id="9" name="图表 8">
              <a:extLst>
                <a:ext uri="{FF2B5EF4-FFF2-40B4-BE49-F238E27FC236}">
                  <a16:creationId xmlns:a16="http://schemas.microsoft.com/office/drawing/2014/main" id="{BF10E3B6-692C-3D78-E27D-F8400AC4A052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032216" y="5952237"/>
            <a:ext cx="2567402" cy="21038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4494F010-A5D9-9A5A-236A-D35234BFEFC9}"/>
                </a:ext>
              </a:extLst>
            </p:cNvPr>
            <p:cNvSpPr txBox="1"/>
            <p:nvPr/>
          </p:nvSpPr>
          <p:spPr>
            <a:xfrm rot="10800000">
              <a:off x="1763500" y="6287382"/>
              <a:ext cx="338554" cy="110887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resh weight (g)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7" name="图表 16">
              <a:extLst>
                <a:ext uri="{FF2B5EF4-FFF2-40B4-BE49-F238E27FC236}">
                  <a16:creationId xmlns:a16="http://schemas.microsoft.com/office/drawing/2014/main" id="{2926C96A-3168-154B-80D9-2805B855253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046580" y="3783476"/>
            <a:ext cx="2530027" cy="19910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05B22C29-3BD1-8137-29B7-89D6496EF63E}"/>
                </a:ext>
              </a:extLst>
            </p:cNvPr>
            <p:cNvGrpSpPr/>
            <p:nvPr/>
          </p:nvGrpSpPr>
          <p:grpSpPr>
            <a:xfrm>
              <a:off x="1767877" y="1718909"/>
              <a:ext cx="2831740" cy="1991022"/>
              <a:chOff x="1713873" y="1477732"/>
              <a:chExt cx="2906895" cy="2043864"/>
            </a:xfrm>
          </p:grpSpPr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AD30F3EC-6EA0-BD14-D104-788B97298B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175" t="21445" r="21614" b="6075"/>
              <a:stretch/>
            </p:blipFill>
            <p:spPr>
              <a:xfrm>
                <a:off x="2046580" y="1477732"/>
                <a:ext cx="2530027" cy="1965078"/>
              </a:xfrm>
              <a:prstGeom prst="rect">
                <a:avLst/>
              </a:prstGeom>
            </p:spPr>
          </p:pic>
          <p:cxnSp>
            <p:nvCxnSpPr>
              <p:cNvPr id="14" name="直接连接符 13">
                <a:extLst>
                  <a:ext uri="{FF2B5EF4-FFF2-40B4-BE49-F238E27FC236}">
                    <a16:creationId xmlns:a16="http://schemas.microsoft.com/office/drawing/2014/main" id="{8BA41A08-279D-D842-84D7-4647EB78A88C}"/>
                  </a:ext>
                </a:extLst>
              </p:cNvPr>
              <p:cNvCxnSpPr/>
              <p:nvPr/>
            </p:nvCxnSpPr>
            <p:spPr>
              <a:xfrm>
                <a:off x="4143655" y="3113443"/>
                <a:ext cx="175167" cy="0"/>
              </a:xfrm>
              <a:prstGeom prst="line">
                <a:avLst/>
              </a:prstGeom>
              <a:ln w="254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89341706-7C45-FD8A-7315-842B65CC8CE8}"/>
                  </a:ext>
                </a:extLst>
              </p:cNvPr>
              <p:cNvSpPr txBox="1"/>
              <p:nvPr/>
            </p:nvSpPr>
            <p:spPr>
              <a:xfrm rot="16200000">
                <a:off x="4180945" y="2992557"/>
                <a:ext cx="338554" cy="54109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 cm</a:t>
                </a:r>
                <a:endParaRPr lang="zh-CN" alt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8C7DFC8F-8489-2792-F26E-1877D344161D}"/>
                  </a:ext>
                </a:extLst>
              </p:cNvPr>
              <p:cNvSpPr txBox="1"/>
              <p:nvPr/>
            </p:nvSpPr>
            <p:spPr>
              <a:xfrm>
                <a:off x="2002419" y="1494557"/>
                <a:ext cx="5853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622113E2-312B-829B-0107-9314A4589496}"/>
                  </a:ext>
                </a:extLst>
              </p:cNvPr>
              <p:cNvSpPr txBox="1"/>
              <p:nvPr/>
            </p:nvSpPr>
            <p:spPr>
              <a:xfrm rot="16200000">
                <a:off x="2442834" y="2940812"/>
                <a:ext cx="338554" cy="82301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1AE8066B-9216-38ED-3036-9A6E2E89DC7A}"/>
                  </a:ext>
                </a:extLst>
              </p:cNvPr>
              <p:cNvSpPr txBox="1"/>
              <p:nvPr/>
            </p:nvSpPr>
            <p:spPr>
              <a:xfrm rot="16200000">
                <a:off x="3011622" y="3081772"/>
                <a:ext cx="338554" cy="54109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Cl</a:t>
                </a:r>
                <a:r>
                  <a:rPr lang="en-US" altLang="zh-CN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0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4F2C2935-BD1C-C0CB-CC47-CECDA1157367}"/>
                  </a:ext>
                </a:extLst>
              </p:cNvPr>
              <p:cNvSpPr txBox="1"/>
              <p:nvPr/>
            </p:nvSpPr>
            <p:spPr>
              <a:xfrm rot="10800000">
                <a:off x="1713873" y="1722165"/>
                <a:ext cx="338554" cy="113792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0 mM NaCl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9C4CD0EA-0DA0-8580-8178-3B7C502FAB76}"/>
                  </a:ext>
                </a:extLst>
              </p:cNvPr>
              <p:cNvSpPr txBox="1"/>
              <p:nvPr/>
            </p:nvSpPr>
            <p:spPr>
              <a:xfrm rot="16200000">
                <a:off x="3713022" y="3074717"/>
                <a:ext cx="338554" cy="54109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nCl</a:t>
                </a:r>
                <a:r>
                  <a:rPr lang="en-US" altLang="zh-CN" sz="1000" baseline="-25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0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86DE82D3-94F4-0EE0-D70C-D7703EC0E1E0}"/>
                </a:ext>
              </a:extLst>
            </p:cNvPr>
            <p:cNvSpPr txBox="1"/>
            <p:nvPr/>
          </p:nvSpPr>
          <p:spPr>
            <a:xfrm rot="16200000">
              <a:off x="3426878" y="5296065"/>
              <a:ext cx="300450" cy="113792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00 mM NaCl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7582423D-4757-E8B0-A70D-10F02455749F}"/>
                </a:ext>
              </a:extLst>
            </p:cNvPr>
            <p:cNvCxnSpPr/>
            <p:nvPr/>
          </p:nvCxnSpPr>
          <p:spPr>
            <a:xfrm>
              <a:off x="2612111" y="5775170"/>
              <a:ext cx="159293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24B02EE5-6E04-50B8-68FF-5768488B2AC9}"/>
                </a:ext>
              </a:extLst>
            </p:cNvPr>
            <p:cNvSpPr txBox="1"/>
            <p:nvPr/>
          </p:nvSpPr>
          <p:spPr>
            <a:xfrm rot="10800000">
              <a:off x="1780920" y="3845390"/>
              <a:ext cx="338554" cy="166212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The 2</a:t>
              </a:r>
              <a:r>
                <a:rPr lang="en-US" altLang="zh-CN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r>
                <a: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true leaf area(cm</a:t>
              </a:r>
              <a:r>
                <a:rPr lang="en-US" altLang="zh-CN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C0D4EE6D-8A21-A759-7DD2-43CE7D286AE8}"/>
                </a:ext>
              </a:extLst>
            </p:cNvPr>
            <p:cNvSpPr txBox="1"/>
            <p:nvPr/>
          </p:nvSpPr>
          <p:spPr>
            <a:xfrm>
              <a:off x="2251548" y="3828347"/>
              <a:ext cx="5701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32A13C58-9B0F-6EB2-8FC1-5FCD128582CD}"/>
                </a:ext>
              </a:extLst>
            </p:cNvPr>
            <p:cNvSpPr txBox="1"/>
            <p:nvPr/>
          </p:nvSpPr>
          <p:spPr>
            <a:xfrm rot="16200000">
              <a:off x="3500596" y="7580030"/>
              <a:ext cx="300450" cy="113792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00 mM NaCl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2F6BB6B5-387E-8C04-B012-B10802D87062}"/>
                </a:ext>
              </a:extLst>
            </p:cNvPr>
            <p:cNvCxnSpPr/>
            <p:nvPr/>
          </p:nvCxnSpPr>
          <p:spPr>
            <a:xfrm>
              <a:off x="2685829" y="8059135"/>
              <a:ext cx="159293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EF8CEFA1-AEF1-4C85-E585-27876314F144}"/>
                </a:ext>
              </a:extLst>
            </p:cNvPr>
            <p:cNvSpPr txBox="1"/>
            <p:nvPr/>
          </p:nvSpPr>
          <p:spPr>
            <a:xfrm>
              <a:off x="2269496" y="6009210"/>
              <a:ext cx="5701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</p:grpSp>
      <p:sp>
        <p:nvSpPr>
          <p:cNvPr id="36" name="文本框 33">
            <a:extLst>
              <a:ext uri="{FF2B5EF4-FFF2-40B4-BE49-F238E27FC236}">
                <a16:creationId xmlns:a16="http://schemas.microsoft.com/office/drawing/2014/main" id="{0787C6CE-9BDD-3AB1-08DC-885C27C8AA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5717" y="703030"/>
            <a:ext cx="8230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kumimoji="0" lang="en-US" altLang="zh-CN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2</a:t>
            </a:r>
            <a:endParaRPr kumimoji="0" lang="en-US" altLang="zh-CN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45949C2-6450-6F96-846D-27D14A43EC77}"/>
              </a:ext>
            </a:extLst>
          </p:cNvPr>
          <p:cNvSpPr txBox="1"/>
          <p:nvPr/>
        </p:nvSpPr>
        <p:spPr>
          <a:xfrm rot="16200000">
            <a:off x="3350443" y="3534297"/>
            <a:ext cx="338554" cy="4162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6038336-CFCF-D9A4-D67D-58EC0495EF36}"/>
              </a:ext>
            </a:extLst>
          </p:cNvPr>
          <p:cNvSpPr txBox="1"/>
          <p:nvPr/>
        </p:nvSpPr>
        <p:spPr>
          <a:xfrm rot="16200000">
            <a:off x="3363140" y="5750104"/>
            <a:ext cx="338554" cy="4162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08947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4545B2F0-0857-9ED1-74F6-207A8FB60792}"/>
              </a:ext>
            </a:extLst>
          </p:cNvPr>
          <p:cNvGrpSpPr/>
          <p:nvPr/>
        </p:nvGrpSpPr>
        <p:grpSpPr>
          <a:xfrm>
            <a:off x="1453157" y="1271018"/>
            <a:ext cx="3720246" cy="7120194"/>
            <a:chOff x="1542057" y="648718"/>
            <a:chExt cx="3720246" cy="7120194"/>
          </a:xfrm>
        </p:grpSpPr>
        <p:graphicFrame>
          <p:nvGraphicFramePr>
            <p:cNvPr id="31" name="图表 30">
              <a:extLst>
                <a:ext uri="{FF2B5EF4-FFF2-40B4-BE49-F238E27FC236}">
                  <a16:creationId xmlns:a16="http://schemas.microsoft.com/office/drawing/2014/main" id="{9C5833E0-7ABE-4015-99A4-B3F0F9E45384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868487" y="3710964"/>
            <a:ext cx="3262827" cy="22239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2" name="图表 31">
              <a:extLst>
                <a:ext uri="{FF2B5EF4-FFF2-40B4-BE49-F238E27FC236}">
                  <a16:creationId xmlns:a16="http://schemas.microsoft.com/office/drawing/2014/main" id="{B10B81CB-38E1-72D8-884D-EBEB905180C0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002587" y="5988856"/>
            <a:ext cx="1451284" cy="14879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33" name="图表 32">
              <a:extLst>
                <a:ext uri="{FF2B5EF4-FFF2-40B4-BE49-F238E27FC236}">
                  <a16:creationId xmlns:a16="http://schemas.microsoft.com/office/drawing/2014/main" id="{658B5755-16E1-41A7-CF6D-ACCBF4E91DEC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629230" y="6013450"/>
            <a:ext cx="1502084" cy="14633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3" name="文本框 55">
              <a:extLst>
                <a:ext uri="{FF2B5EF4-FFF2-40B4-BE49-F238E27FC236}">
                  <a16:creationId xmlns:a16="http://schemas.microsoft.com/office/drawing/2014/main" id="{E3EE1298-C032-F0A0-1F35-02AE5C7D1F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1696029" y="5664100"/>
              <a:ext cx="338554" cy="17800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fr-FR" altLang="zh-CN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fr-FR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fr-FR" altLang="zh-CN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fr-FR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ent (</a:t>
              </a:r>
              <a:r>
                <a:rPr lang="pl-PL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M / g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W)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5">
              <a:extLst>
                <a:ext uri="{FF2B5EF4-FFF2-40B4-BE49-F238E27FC236}">
                  <a16:creationId xmlns:a16="http://schemas.microsoft.com/office/drawing/2014/main" id="{43B8D5AB-C6B8-0033-1823-6B24C30E94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3385101" y="5678070"/>
              <a:ext cx="338554" cy="17800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·</a:t>
              </a:r>
              <a:r>
                <a:rPr lang="fr-FR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fr-FR" altLang="zh-CN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fr-FR" altLang="zh-CN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fr-FR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ent (μ</a:t>
              </a:r>
              <a:r>
                <a:rPr lang="pl-PL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 / g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W)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23">
              <a:extLst>
                <a:ext uri="{FF2B5EF4-FFF2-40B4-BE49-F238E27FC236}">
                  <a16:creationId xmlns:a16="http://schemas.microsoft.com/office/drawing/2014/main" id="{D789FB30-27DC-3118-A11D-F80A59236B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1578217" y="3831230"/>
              <a:ext cx="338554" cy="18137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Dye intensity (</a:t>
              </a:r>
              <a:r>
                <a:rPr lang="en-US" altLang="zh-CN" sz="10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a.u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.)</a:t>
              </a: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B75B496B-7B3F-B977-6759-7C1531303223}"/>
                </a:ext>
              </a:extLst>
            </p:cNvPr>
            <p:cNvSpPr txBox="1"/>
            <p:nvPr/>
          </p:nvSpPr>
          <p:spPr>
            <a:xfrm rot="16200000">
              <a:off x="4560186" y="3366253"/>
              <a:ext cx="338554" cy="102356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00 mM NaCl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CD128CBA-89DD-5D52-3E00-4FDD0E2CA2D6}"/>
                </a:ext>
              </a:extLst>
            </p:cNvPr>
            <p:cNvSpPr txBox="1"/>
            <p:nvPr/>
          </p:nvSpPr>
          <p:spPr>
            <a:xfrm rot="16200000">
              <a:off x="2888614" y="7030674"/>
              <a:ext cx="338554" cy="113792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00 mM NaCl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E9CCEA90-C2CA-BE89-D639-37CC7DD0B039}"/>
                </a:ext>
              </a:extLst>
            </p:cNvPr>
            <p:cNvCxnSpPr/>
            <p:nvPr/>
          </p:nvCxnSpPr>
          <p:spPr>
            <a:xfrm>
              <a:off x="2332816" y="7483526"/>
              <a:ext cx="1013207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503F3A10-407F-66AE-2AED-A5A1017BAA98}"/>
                </a:ext>
              </a:extLst>
            </p:cNvPr>
            <p:cNvGrpSpPr/>
            <p:nvPr/>
          </p:nvGrpSpPr>
          <p:grpSpPr>
            <a:xfrm>
              <a:off x="1542057" y="648718"/>
              <a:ext cx="3635737" cy="3201130"/>
              <a:chOff x="1583963" y="639854"/>
              <a:chExt cx="3100587" cy="2729951"/>
            </a:xfrm>
          </p:grpSpPr>
          <p:grpSp>
            <p:nvGrpSpPr>
              <p:cNvPr id="29" name="组合 28">
                <a:extLst>
                  <a:ext uri="{FF2B5EF4-FFF2-40B4-BE49-F238E27FC236}">
                    <a16:creationId xmlns:a16="http://schemas.microsoft.com/office/drawing/2014/main" id="{76E0BFA2-31E4-5B70-430F-6C1BE18327A6}"/>
                  </a:ext>
                </a:extLst>
              </p:cNvPr>
              <p:cNvGrpSpPr/>
              <p:nvPr/>
            </p:nvGrpSpPr>
            <p:grpSpPr>
              <a:xfrm>
                <a:off x="1872492" y="804873"/>
                <a:ext cx="2812058" cy="2122136"/>
                <a:chOff x="1888572" y="2549024"/>
                <a:chExt cx="2812058" cy="2122136"/>
              </a:xfrm>
            </p:grpSpPr>
            <p:grpSp>
              <p:nvGrpSpPr>
                <p:cNvPr id="26" name="组合 25">
                  <a:extLst>
                    <a:ext uri="{FF2B5EF4-FFF2-40B4-BE49-F238E27FC236}">
                      <a16:creationId xmlns:a16="http://schemas.microsoft.com/office/drawing/2014/main" id="{B505CCE0-ADF5-D4B3-D87A-A5D486A88E15}"/>
                    </a:ext>
                  </a:extLst>
                </p:cNvPr>
                <p:cNvGrpSpPr/>
                <p:nvPr/>
              </p:nvGrpSpPr>
              <p:grpSpPr>
                <a:xfrm>
                  <a:off x="1888572" y="2549024"/>
                  <a:ext cx="2812058" cy="2122136"/>
                  <a:chOff x="3161747" y="3872999"/>
                  <a:chExt cx="2812058" cy="2122136"/>
                </a:xfrm>
              </p:grpSpPr>
              <p:grpSp>
                <p:nvGrpSpPr>
                  <p:cNvPr id="21" name="组合 20">
                    <a:extLst>
                      <a:ext uri="{FF2B5EF4-FFF2-40B4-BE49-F238E27FC236}">
                        <a16:creationId xmlns:a16="http://schemas.microsoft.com/office/drawing/2014/main" id="{477DE193-6F01-A8DF-7255-6C60DA980BF6}"/>
                      </a:ext>
                    </a:extLst>
                  </p:cNvPr>
                  <p:cNvGrpSpPr/>
                  <p:nvPr/>
                </p:nvGrpSpPr>
                <p:grpSpPr>
                  <a:xfrm>
                    <a:off x="3161747" y="4858384"/>
                    <a:ext cx="2812058" cy="1136751"/>
                    <a:chOff x="1819276" y="4122983"/>
                    <a:chExt cx="3025946" cy="1223213"/>
                  </a:xfrm>
                </p:grpSpPr>
                <p:pic>
                  <p:nvPicPr>
                    <p:cNvPr id="6" name="图片 5">
                      <a:extLst>
                        <a:ext uri="{FF2B5EF4-FFF2-40B4-BE49-F238E27FC236}">
                          <a16:creationId xmlns:a16="http://schemas.microsoft.com/office/drawing/2014/main" id="{F8933ECE-7744-0447-2964-32828CA497C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8736" t="27714" r="30429" b="24302"/>
                    <a:stretch/>
                  </p:blipFill>
                  <p:spPr>
                    <a:xfrm>
                      <a:off x="1819276" y="4189869"/>
                      <a:ext cx="966691" cy="1070623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11" name="组合 10">
                      <a:extLst>
                        <a:ext uri="{FF2B5EF4-FFF2-40B4-BE49-F238E27FC236}">
                          <a16:creationId xmlns:a16="http://schemas.microsoft.com/office/drawing/2014/main" id="{58B16625-5058-E324-52E1-7B459F2A0EE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837748" y="4122983"/>
                      <a:ext cx="1007474" cy="1187205"/>
                      <a:chOff x="1462586" y="548469"/>
                      <a:chExt cx="2408763" cy="2690069"/>
                    </a:xfrm>
                  </p:grpSpPr>
                  <p:pic>
                    <p:nvPicPr>
                      <p:cNvPr id="8" name="图片 7">
                        <a:extLst>
                          <a:ext uri="{FF2B5EF4-FFF2-40B4-BE49-F238E27FC236}">
                            <a16:creationId xmlns:a16="http://schemas.microsoft.com/office/drawing/2014/main" id="{3E3F27A0-4E6A-ED57-0867-0C69D027A2D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9005" t="28152" r="62990" b="27832"/>
                      <a:stretch/>
                    </p:blipFill>
                    <p:spPr>
                      <a:xfrm>
                        <a:off x="1462586" y="703894"/>
                        <a:ext cx="2311255" cy="2438497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0" name="图片 9">
                        <a:extLst>
                          <a:ext uri="{FF2B5EF4-FFF2-40B4-BE49-F238E27FC236}">
                            <a16:creationId xmlns:a16="http://schemas.microsoft.com/office/drawing/2014/main" id="{137824E8-E401-CF61-B0A6-53B044E84F86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7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8">
                                <a14:imgEffect>
                                  <a14:backgroundRemoval t="10000" b="90000" l="10000" r="9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5044" t="10301" r="16533" b="10696"/>
                      <a:stretch/>
                    </p:blipFill>
                    <p:spPr>
                      <a:xfrm>
                        <a:off x="1560096" y="548469"/>
                        <a:ext cx="2311253" cy="2690069"/>
                      </a:xfrm>
                      <a:prstGeom prst="rect">
                        <a:avLst/>
                      </a:prstGeom>
                    </p:spPr>
                  </p:pic>
                </p:grpSp>
                <p:pic>
                  <p:nvPicPr>
                    <p:cNvPr id="5" name="图片 4">
                      <a:extLst>
                        <a:ext uri="{FF2B5EF4-FFF2-40B4-BE49-F238E27FC236}">
                          <a16:creationId xmlns:a16="http://schemas.microsoft.com/office/drawing/2014/main" id="{A101E837-26F6-CD18-6F05-0B18DB1E1D2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5947" t="30805" r="40556" b="36116"/>
                    <a:stretch/>
                  </p:blipFill>
                  <p:spPr>
                    <a:xfrm>
                      <a:off x="2832146" y="4191577"/>
                      <a:ext cx="964819" cy="1070611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19" name="直接连接符 18">
                      <a:extLst>
                        <a:ext uri="{FF2B5EF4-FFF2-40B4-BE49-F238E27FC236}">
                          <a16:creationId xmlns:a16="http://schemas.microsoft.com/office/drawing/2014/main" id="{5D013E6E-5AAE-DDDD-0EFD-31DA78FCBBF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563566" y="5063040"/>
                      <a:ext cx="190800" cy="0"/>
                    </a:xfrm>
                    <a:prstGeom prst="line">
                      <a:avLst/>
                    </a:prstGeom>
                    <a:ln w="254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0" name="文本框 19">
                      <a:extLst>
                        <a:ext uri="{FF2B5EF4-FFF2-40B4-BE49-F238E27FC236}">
                          <a16:creationId xmlns:a16="http://schemas.microsoft.com/office/drawing/2014/main" id="{FE4EB6EA-B03E-F566-EDDE-C2F4FD07CAB7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2450671" y="4929334"/>
                      <a:ext cx="364305" cy="469419"/>
                    </a:xfrm>
                    <a:prstGeom prst="rect">
                      <a:avLst/>
                    </a:prstGeom>
                    <a:noFill/>
                  </p:spPr>
                  <p:txBody>
                    <a:bodyPr vert="eaVert" wrap="square" rtlCol="0">
                      <a:spAutoFit/>
                    </a:bodyPr>
                    <a:lstStyle/>
                    <a:p>
                      <a:r>
                        <a:rPr lang="en-US" altLang="zh-CN" sz="10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cm</a:t>
                      </a:r>
                      <a:endParaRPr lang="zh-CN" altLang="en-US" sz="10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22" name="图片 21">
                    <a:extLst>
                      <a:ext uri="{FF2B5EF4-FFF2-40B4-BE49-F238E27FC236}">
                        <a16:creationId xmlns:a16="http://schemas.microsoft.com/office/drawing/2014/main" id="{688C2665-26E0-80CD-2EB7-2EA45143209B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9" cstate="hq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4444" t="37778" r="25926" b="33472"/>
                  <a:stretch/>
                </p:blipFill>
                <p:spPr>
                  <a:xfrm rot="16200000">
                    <a:off x="3109530" y="3925217"/>
                    <a:ext cx="1004433" cy="900000"/>
                  </a:xfrm>
                  <a:prstGeom prst="rect">
                    <a:avLst/>
                  </a:prstGeom>
                </p:spPr>
              </p:pic>
              <p:pic>
                <p:nvPicPr>
                  <p:cNvPr id="25" name="图片 24">
                    <a:extLst>
                      <a:ext uri="{FF2B5EF4-FFF2-40B4-BE49-F238E27FC236}">
                        <a16:creationId xmlns:a16="http://schemas.microsoft.com/office/drawing/2014/main" id="{A7775DED-93FA-0367-8D41-2CBF4C28CDE0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10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1">
                            <a14:imgEffect>
                              <a14:colorTemperature colorTemp="88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1574" t="38577" r="30906" b="30197"/>
                  <a:stretch/>
                </p:blipFill>
                <p:spPr>
                  <a:xfrm>
                    <a:off x="5037544" y="3872999"/>
                    <a:ext cx="896622" cy="1009696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28" name="图片 27">
                  <a:extLst>
                    <a:ext uri="{FF2B5EF4-FFF2-40B4-BE49-F238E27FC236}">
                      <a16:creationId xmlns:a16="http://schemas.microsoft.com/office/drawing/2014/main" id="{0DC7F23C-276A-3A93-4C4E-952C28F60CBA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2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306" t="37346" r="18002" b="32042"/>
                <a:stretch/>
              </p:blipFill>
              <p:spPr>
                <a:xfrm rot="16200000">
                  <a:off x="2775945" y="2602930"/>
                  <a:ext cx="1004432" cy="896621"/>
                </a:xfrm>
                <a:prstGeom prst="rect">
                  <a:avLst/>
                </a:prstGeom>
              </p:spPr>
            </p:pic>
          </p:grp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99C11582-B026-037C-D376-BD16419BB403}"/>
                  </a:ext>
                </a:extLst>
              </p:cNvPr>
              <p:cNvSpPr txBox="1"/>
              <p:nvPr/>
            </p:nvSpPr>
            <p:spPr>
              <a:xfrm rot="16200000">
                <a:off x="3221269" y="2631567"/>
                <a:ext cx="338554" cy="113792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0 mM NaCl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5">
                <a:extLst>
                  <a:ext uri="{FF2B5EF4-FFF2-40B4-BE49-F238E27FC236}">
                    <a16:creationId xmlns:a16="http://schemas.microsoft.com/office/drawing/2014/main" id="{585C72C9-FA62-8B82-EA18-C29F106378F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0800000">
                <a:off x="1583963" y="1757494"/>
                <a:ext cx="338554" cy="10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000" dirty="0">
                    <a:cs typeface="Arial" panose="020B0604020202020204" pitchFamily="34" charset="0"/>
                  </a:rPr>
                  <a:t>NBT staining</a:t>
                </a: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55B9FA9C-CCD4-7407-BEE8-B46AB2F28AFD}"/>
                  </a:ext>
                </a:extLst>
              </p:cNvPr>
              <p:cNvSpPr txBox="1"/>
              <p:nvPr/>
            </p:nvSpPr>
            <p:spPr>
              <a:xfrm rot="10800000">
                <a:off x="1585909" y="639854"/>
                <a:ext cx="338554" cy="1104443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AB staining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F60D1B88-4149-6705-7C21-54836262D0D2}"/>
                  </a:ext>
                </a:extLst>
              </p:cNvPr>
              <p:cNvSpPr txBox="1"/>
              <p:nvPr/>
            </p:nvSpPr>
            <p:spPr>
              <a:xfrm rot="16200000">
                <a:off x="2222188" y="2598852"/>
                <a:ext cx="338554" cy="72097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9" name="直接连接符 48">
                <a:extLst>
                  <a:ext uri="{FF2B5EF4-FFF2-40B4-BE49-F238E27FC236}">
                    <a16:creationId xmlns:a16="http://schemas.microsoft.com/office/drawing/2014/main" id="{77365D75-49B6-3F5B-2C8B-9C461371BB2A}"/>
                  </a:ext>
                </a:extLst>
              </p:cNvPr>
              <p:cNvCxnSpPr/>
              <p:nvPr/>
            </p:nvCxnSpPr>
            <p:spPr>
              <a:xfrm>
                <a:off x="2195700" y="3071513"/>
                <a:ext cx="2171901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9DB418F3-3975-2614-4F4C-2E3216D6F809}"/>
                  </a:ext>
                </a:extLst>
              </p:cNvPr>
              <p:cNvSpPr txBox="1"/>
              <p:nvPr/>
            </p:nvSpPr>
            <p:spPr>
              <a:xfrm>
                <a:off x="1592750" y="644045"/>
                <a:ext cx="5391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8FC7BF44-A7C4-29FA-EEAC-9CAFF583FD2C}"/>
                  </a:ext>
                </a:extLst>
              </p:cNvPr>
              <p:cNvSpPr txBox="1"/>
              <p:nvPr/>
            </p:nvSpPr>
            <p:spPr>
              <a:xfrm rot="16200000">
                <a:off x="3126994" y="2696106"/>
                <a:ext cx="338554" cy="52710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eCl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931F7766-1995-DA45-7077-9006D2CDA28C}"/>
                  </a:ext>
                </a:extLst>
              </p:cNvPr>
              <p:cNvSpPr txBox="1"/>
              <p:nvPr/>
            </p:nvSpPr>
            <p:spPr>
              <a:xfrm rot="16200000">
                <a:off x="4083812" y="2689174"/>
                <a:ext cx="338554" cy="52710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nCl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51E0F782-F74F-3D62-DD1C-1790EE826ABA}"/>
                </a:ext>
              </a:extLst>
            </p:cNvPr>
            <p:cNvSpPr txBox="1"/>
            <p:nvPr/>
          </p:nvSpPr>
          <p:spPr>
            <a:xfrm>
              <a:off x="2163153" y="3733674"/>
              <a:ext cx="5282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0EAF7569-0AE6-AC60-4908-8ED19950A9BA}"/>
                </a:ext>
              </a:extLst>
            </p:cNvPr>
            <p:cNvSpPr txBox="1"/>
            <p:nvPr/>
          </p:nvSpPr>
          <p:spPr>
            <a:xfrm rot="16200000">
              <a:off x="4524065" y="7029106"/>
              <a:ext cx="338554" cy="113792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00 mM NaCl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651BC2B4-5288-7FCE-8B1E-F275B1DC7E2F}"/>
                </a:ext>
              </a:extLst>
            </p:cNvPr>
            <p:cNvCxnSpPr/>
            <p:nvPr/>
          </p:nvCxnSpPr>
          <p:spPr>
            <a:xfrm>
              <a:off x="3968267" y="7481958"/>
              <a:ext cx="1013207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04276EAF-A869-0E68-B647-924ADCC53990}"/>
                </a:ext>
              </a:extLst>
            </p:cNvPr>
            <p:cNvSpPr txBox="1"/>
            <p:nvPr/>
          </p:nvSpPr>
          <p:spPr>
            <a:xfrm>
              <a:off x="2158190" y="5982118"/>
              <a:ext cx="5282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7EA5F35C-4D7A-0273-7EC2-6052AD21337F}"/>
                </a:ext>
              </a:extLst>
            </p:cNvPr>
            <p:cNvSpPr txBox="1"/>
            <p:nvPr/>
          </p:nvSpPr>
          <p:spPr>
            <a:xfrm>
              <a:off x="3834530" y="6006747"/>
              <a:ext cx="5282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</a:p>
          </p:txBody>
        </p:sp>
      </p:grpSp>
      <p:sp>
        <p:nvSpPr>
          <p:cNvPr id="61" name="文本框 33">
            <a:extLst>
              <a:ext uri="{FF2B5EF4-FFF2-40B4-BE49-F238E27FC236}">
                <a16:creationId xmlns:a16="http://schemas.microsoft.com/office/drawing/2014/main" id="{6D529264-1DBC-11B4-E931-80298D2013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19413" y="800566"/>
            <a:ext cx="8230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kumimoji="0" lang="en-US" altLang="zh-CN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3</a:t>
            </a:r>
            <a:endParaRPr kumimoji="0" lang="en-US" altLang="zh-CN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00DBBE8-0F9A-8ADC-A3FC-3352FB14D0F2}"/>
              </a:ext>
            </a:extLst>
          </p:cNvPr>
          <p:cNvSpPr txBox="1"/>
          <p:nvPr/>
        </p:nvSpPr>
        <p:spPr>
          <a:xfrm rot="16200000">
            <a:off x="2789369" y="4726040"/>
            <a:ext cx="338554" cy="4162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348394E-68A3-5071-3D60-33747D82D89A}"/>
              </a:ext>
            </a:extLst>
          </p:cNvPr>
          <p:cNvSpPr txBox="1"/>
          <p:nvPr/>
        </p:nvSpPr>
        <p:spPr>
          <a:xfrm rot="16200000">
            <a:off x="4201875" y="5021870"/>
            <a:ext cx="338554" cy="4162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BF899AE-A271-58F9-6CFB-CA4772553B0A}"/>
              </a:ext>
            </a:extLst>
          </p:cNvPr>
          <p:cNvSpPr txBox="1"/>
          <p:nvPr/>
        </p:nvSpPr>
        <p:spPr>
          <a:xfrm rot="16200000">
            <a:off x="2672577" y="6684573"/>
            <a:ext cx="338554" cy="4162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9D19798-92DB-29B8-5A23-95EEFFC7E894}"/>
              </a:ext>
            </a:extLst>
          </p:cNvPr>
          <p:cNvSpPr txBox="1"/>
          <p:nvPr/>
        </p:nvSpPr>
        <p:spPr>
          <a:xfrm rot="16200000">
            <a:off x="4330222" y="6525034"/>
            <a:ext cx="338554" cy="4162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06628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3">
            <a:extLst>
              <a:ext uri="{FF2B5EF4-FFF2-40B4-BE49-F238E27FC236}">
                <a16:creationId xmlns:a16="http://schemas.microsoft.com/office/drawing/2014/main" id="{0D91508D-9113-46C9-9959-5F60B3A0E4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3716" y="862228"/>
            <a:ext cx="8230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kumimoji="0" lang="en-US" altLang="zh-CN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4</a:t>
            </a:r>
            <a:endParaRPr kumimoji="0" lang="en-US" altLang="zh-CN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AC44D4D3-BA0A-A17E-3CAD-16F874479F44}"/>
              </a:ext>
            </a:extLst>
          </p:cNvPr>
          <p:cNvGrpSpPr/>
          <p:nvPr/>
        </p:nvGrpSpPr>
        <p:grpSpPr>
          <a:xfrm>
            <a:off x="1554867" y="1787173"/>
            <a:ext cx="3641062" cy="6717049"/>
            <a:chOff x="1554867" y="1787173"/>
            <a:chExt cx="3641062" cy="6717049"/>
          </a:xfrm>
        </p:grpSpPr>
        <p:graphicFrame>
          <p:nvGraphicFramePr>
            <p:cNvPr id="13" name="图表 12">
              <a:extLst>
                <a:ext uri="{FF2B5EF4-FFF2-40B4-BE49-F238E27FC236}">
                  <a16:creationId xmlns:a16="http://schemas.microsoft.com/office/drawing/2014/main" id="{B40F3BAC-5B88-0692-044B-62DBC1A8AC4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812036" y="6111542"/>
            <a:ext cx="3233928" cy="23926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6C8D3E31-B8ED-1851-F255-A2595EB90BF9}"/>
                </a:ext>
              </a:extLst>
            </p:cNvPr>
            <p:cNvSpPr txBox="1"/>
            <p:nvPr/>
          </p:nvSpPr>
          <p:spPr>
            <a:xfrm rot="10800000">
              <a:off x="1554867" y="6753447"/>
              <a:ext cx="338554" cy="110887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resh weight (g)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5" name="图表 14">
              <a:extLst>
                <a:ext uri="{FF2B5EF4-FFF2-40B4-BE49-F238E27FC236}">
                  <a16:creationId xmlns:a16="http://schemas.microsoft.com/office/drawing/2014/main" id="{9FF0318B-6841-04F1-671A-D3A9351F4BB2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769364" y="3840782"/>
            <a:ext cx="3319272" cy="22707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FCC222E4-A67F-23E2-AC18-A84A93CA4C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1554867" y="3876337"/>
              <a:ext cx="338554" cy="17653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defPPr>
                <a:defRPr lang="en-US"/>
              </a:defPPr>
              <a:lvl1pPr>
                <a:defRPr sz="1000" b="1"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zh-CN" altLang="en-US" b="0" dirty="0">
                  <a:cs typeface="Arial" panose="020B0604020202020204" pitchFamily="34" charset="0"/>
                </a:rPr>
                <a:t>Chlorophyll content </a:t>
              </a:r>
              <a:r>
                <a:rPr lang="en-US" altLang="zh-CN" b="0" dirty="0">
                  <a:cs typeface="Arial" panose="020B0604020202020204" pitchFamily="34" charset="0"/>
                </a:rPr>
                <a:t>(</a:t>
              </a:r>
              <a:r>
                <a:rPr lang="en-US" altLang="zh-CN" b="0" dirty="0" err="1">
                  <a:cs typeface="Arial" panose="020B0604020202020204" pitchFamily="34" charset="0"/>
                </a:rPr>
                <a:t>a.u</a:t>
              </a:r>
              <a:r>
                <a:rPr lang="en-US" altLang="zh-CN" b="0" dirty="0">
                  <a:cs typeface="Arial" panose="020B0604020202020204" pitchFamily="34" charset="0"/>
                </a:rPr>
                <a:t>.)</a:t>
              </a: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218A0D4C-FBAE-C25B-ABBB-CC0EFCDA0A11}"/>
                </a:ext>
              </a:extLst>
            </p:cNvPr>
            <p:cNvSpPr txBox="1"/>
            <p:nvPr/>
          </p:nvSpPr>
          <p:spPr>
            <a:xfrm>
              <a:off x="2048256" y="3921916"/>
              <a:ext cx="3385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F19E4477-CFA6-6A5E-0B5B-5739C0D9DA78}"/>
                </a:ext>
              </a:extLst>
            </p:cNvPr>
            <p:cNvSpPr txBox="1"/>
            <p:nvPr/>
          </p:nvSpPr>
          <p:spPr>
            <a:xfrm>
              <a:off x="2048255" y="6186273"/>
              <a:ext cx="3385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791672AF-9856-E369-626E-253B93DD66D4}"/>
                </a:ext>
              </a:extLst>
            </p:cNvPr>
            <p:cNvGrpSpPr/>
            <p:nvPr/>
          </p:nvGrpSpPr>
          <p:grpSpPr>
            <a:xfrm>
              <a:off x="1876657" y="1952896"/>
              <a:ext cx="3319272" cy="1771360"/>
              <a:chOff x="1893421" y="1769054"/>
              <a:chExt cx="3319272" cy="1771360"/>
            </a:xfrm>
          </p:grpSpPr>
          <p:grpSp>
            <p:nvGrpSpPr>
              <p:cNvPr id="9" name="组合 8">
                <a:extLst>
                  <a:ext uri="{FF2B5EF4-FFF2-40B4-BE49-F238E27FC236}">
                    <a16:creationId xmlns:a16="http://schemas.microsoft.com/office/drawing/2014/main" id="{FE123BCF-DC73-DD29-8DE2-A9DB9FDC702A}"/>
                  </a:ext>
                </a:extLst>
              </p:cNvPr>
              <p:cNvGrpSpPr/>
              <p:nvPr/>
            </p:nvGrpSpPr>
            <p:grpSpPr>
              <a:xfrm>
                <a:off x="1893421" y="1769054"/>
                <a:ext cx="3319272" cy="1494345"/>
                <a:chOff x="-964833" y="1858584"/>
                <a:chExt cx="8796147" cy="3689313"/>
              </a:xfrm>
            </p:grpSpPr>
            <p:pic>
              <p:nvPicPr>
                <p:cNvPr id="19" name="图片 18">
                  <a:extLst>
                    <a:ext uri="{FF2B5EF4-FFF2-40B4-BE49-F238E27FC236}">
                      <a16:creationId xmlns:a16="http://schemas.microsoft.com/office/drawing/2014/main" id="{91EF740E-2E56-507A-D86D-AD18E0595CC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315" t="19306" r="17286"/>
                <a:stretch/>
              </p:blipFill>
              <p:spPr>
                <a:xfrm>
                  <a:off x="4512042" y="1858584"/>
                  <a:ext cx="3319272" cy="3689313"/>
                </a:xfrm>
                <a:prstGeom prst="rect">
                  <a:avLst/>
                </a:prstGeom>
              </p:spPr>
            </p:pic>
            <p:pic>
              <p:nvPicPr>
                <p:cNvPr id="21" name="图片 20">
                  <a:extLst>
                    <a:ext uri="{FF2B5EF4-FFF2-40B4-BE49-F238E27FC236}">
                      <a16:creationId xmlns:a16="http://schemas.microsoft.com/office/drawing/2014/main" id="{8404EDF5-6B47-1D0E-9B1E-DC023F258FD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239" t="14023" r="15900" b="5284"/>
                <a:stretch/>
              </p:blipFill>
              <p:spPr>
                <a:xfrm>
                  <a:off x="-964833" y="1858584"/>
                  <a:ext cx="5476875" cy="3689313"/>
                </a:xfrm>
                <a:prstGeom prst="rect">
                  <a:avLst/>
                </a:prstGeom>
              </p:spPr>
            </p:pic>
            <p:cxnSp>
              <p:nvCxnSpPr>
                <p:cNvPr id="22" name="直接连接符 21">
                  <a:extLst>
                    <a:ext uri="{FF2B5EF4-FFF2-40B4-BE49-F238E27FC236}">
                      <a16:creationId xmlns:a16="http://schemas.microsoft.com/office/drawing/2014/main" id="{ABF27BE1-CA7F-C1D7-6B3F-BEE6225E4161}"/>
                    </a:ext>
                  </a:extLst>
                </p:cNvPr>
                <p:cNvCxnSpPr/>
                <p:nvPr/>
              </p:nvCxnSpPr>
              <p:spPr>
                <a:xfrm>
                  <a:off x="-523824" y="5009471"/>
                  <a:ext cx="356235" cy="0"/>
                </a:xfrm>
                <a:prstGeom prst="line">
                  <a:avLst/>
                </a:prstGeom>
                <a:ln w="254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BDFE952B-E88E-6A6A-C0A7-CD2E8ADF4D12}"/>
                  </a:ext>
                </a:extLst>
              </p:cNvPr>
              <p:cNvSpPr txBox="1"/>
              <p:nvPr/>
            </p:nvSpPr>
            <p:spPr>
              <a:xfrm rot="16200000">
                <a:off x="2266815" y="3039370"/>
                <a:ext cx="338554" cy="61808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C0C75C05-BFE7-DE79-9DFB-5876762365DC}"/>
                  </a:ext>
                </a:extLst>
              </p:cNvPr>
              <p:cNvSpPr txBox="1"/>
              <p:nvPr/>
            </p:nvSpPr>
            <p:spPr>
              <a:xfrm rot="16200000">
                <a:off x="2847367" y="3059113"/>
                <a:ext cx="338554" cy="61808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NC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B29EF9EC-947D-9683-F4B0-4730BD887DA4}"/>
                  </a:ext>
                </a:extLst>
              </p:cNvPr>
              <p:cNvSpPr txBox="1"/>
              <p:nvPr/>
            </p:nvSpPr>
            <p:spPr>
              <a:xfrm rot="16200000">
                <a:off x="3427920" y="3059113"/>
                <a:ext cx="338554" cy="61808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MO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A41F8B07-DE16-561A-7770-C101BE31E080}"/>
                  </a:ext>
                </a:extLst>
              </p:cNvPr>
              <p:cNvSpPr txBox="1"/>
              <p:nvPr/>
            </p:nvSpPr>
            <p:spPr>
              <a:xfrm rot="16200000">
                <a:off x="4134184" y="3057312"/>
                <a:ext cx="338554" cy="61808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eCl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D0793E0F-5CAF-BA62-4E22-01F6E043614E}"/>
                  </a:ext>
                </a:extLst>
              </p:cNvPr>
              <p:cNvSpPr txBox="1"/>
              <p:nvPr/>
            </p:nvSpPr>
            <p:spPr>
              <a:xfrm rot="16200000">
                <a:off x="4696845" y="3062096"/>
                <a:ext cx="338554" cy="61808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nCl</a:t>
                </a:r>
                <a:r>
                  <a:rPr lang="en-US" altLang="zh-CN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0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17A6F05C-DBEE-948D-96E5-24DA30A74A48}"/>
                  </a:ext>
                </a:extLst>
              </p:cNvPr>
              <p:cNvSpPr txBox="1"/>
              <p:nvPr/>
            </p:nvSpPr>
            <p:spPr>
              <a:xfrm rot="16200000">
                <a:off x="2112471" y="2827693"/>
                <a:ext cx="338554" cy="61808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 cm</a:t>
                </a:r>
                <a:endParaRPr lang="zh-CN" altLang="en-US" sz="10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FA09F96C-E508-D40B-617C-7062315BEF6F}"/>
                </a:ext>
              </a:extLst>
            </p:cNvPr>
            <p:cNvSpPr txBox="1"/>
            <p:nvPr/>
          </p:nvSpPr>
          <p:spPr>
            <a:xfrm rot="10800000">
              <a:off x="1573824" y="1872804"/>
              <a:ext cx="338554" cy="141013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Non stress condition</a:t>
              </a:r>
              <a:endParaRPr lang="zh-CN" altLang="en-US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5CB29F7C-F513-0F3A-3733-A1DA43318D1C}"/>
                </a:ext>
              </a:extLst>
            </p:cNvPr>
            <p:cNvSpPr txBox="1"/>
            <p:nvPr/>
          </p:nvSpPr>
          <p:spPr>
            <a:xfrm>
              <a:off x="1627733" y="1787173"/>
              <a:ext cx="3385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F9C6B0DD-DE07-A3CF-5CD1-099202156AE1}"/>
              </a:ext>
            </a:extLst>
          </p:cNvPr>
          <p:cNvSpPr txBox="1"/>
          <p:nvPr/>
        </p:nvSpPr>
        <p:spPr>
          <a:xfrm rot="16200000">
            <a:off x="2658805" y="4129287"/>
            <a:ext cx="338554" cy="4162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BCF7C2F-34A1-50CC-2557-1E6838A03BD8}"/>
              </a:ext>
            </a:extLst>
          </p:cNvPr>
          <p:cNvSpPr txBox="1"/>
          <p:nvPr/>
        </p:nvSpPr>
        <p:spPr>
          <a:xfrm rot="16200000">
            <a:off x="4218335" y="5075574"/>
            <a:ext cx="338554" cy="4162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F56329F-BB71-442F-6BE7-96143EDCBB8D}"/>
              </a:ext>
            </a:extLst>
          </p:cNvPr>
          <p:cNvSpPr txBox="1"/>
          <p:nvPr/>
        </p:nvSpPr>
        <p:spPr>
          <a:xfrm rot="16200000">
            <a:off x="3347771" y="6269317"/>
            <a:ext cx="338554" cy="4162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8852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</TotalTime>
  <Words>237</Words>
  <Application>Microsoft Office PowerPoint</Application>
  <PresentationFormat>A4 Paper (210x297 mm)</PresentationFormat>
  <Paragraphs>9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3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yanhui@webmail.hzau.edu.cn</dc:creator>
  <cp:lastModifiedBy>Hong</cp:lastModifiedBy>
  <cp:revision>5</cp:revision>
  <dcterms:created xsi:type="dcterms:W3CDTF">2022-09-16T13:44:30Z</dcterms:created>
  <dcterms:modified xsi:type="dcterms:W3CDTF">2022-09-17T15:38:14Z</dcterms:modified>
</cp:coreProperties>
</file>